
<file path=[Content_Types].xml><?xml version="1.0" encoding="utf-8"?>
<Types xmlns="http://schemas.openxmlformats.org/package/2006/content-types">
  <Default Extension="jpeg" ContentType="image/jpeg"/>
  <Default Extension="m4a" ContentType="audio/mp4"/>
  <Default Extension="mp4" ContentType="video/mp4"/>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ink/ink1.xml" ContentType="application/inkml+xml"/>
  <Override PartName="/ppt/ink/ink2.xml" ContentType="application/inkml+xml"/>
  <Override PartName="/ppt/ink/ink3.xml" ContentType="application/inkml+xml"/>
  <Override PartName="/ppt/ink/ink4.xml" ContentType="application/inkml+xml"/>
  <Override PartName="/ppt/ink/ink5.xml" ContentType="application/inkml+xml"/>
  <Override PartName="/ppt/ink/ink6.xml" ContentType="application/inkml+xml"/>
  <Override PartName="/ppt/ink/ink7.xml" ContentType="application/inkml+xml"/>
  <Override PartName="/ppt/ink/ink8.xml" ContentType="application/inkml+xml"/>
  <Override PartName="/ppt/ink/ink9.xml" ContentType="application/inkml+xml"/>
  <Override PartName="/ppt/ink/ink10.xml" ContentType="application/inkml+xml"/>
  <Override PartName="/ppt/ink/ink11.xml" ContentType="application/inkml+xml"/>
  <Override PartName="/ppt/ink/ink12.xml" ContentType="application/inkml+xml"/>
  <Override PartName="/ppt/ink/ink13.xml" ContentType="application/inkml+xml"/>
  <Override PartName="/ppt/ink/ink14.xml" ContentType="application/inkml+xml"/>
  <Override PartName="/ppt/ink/ink15.xml" ContentType="application/inkml+xml"/>
  <Override PartName="/ppt/ink/ink16.xml" ContentType="application/inkml+xml"/>
  <Override PartName="/ppt/ink/ink17.xml" ContentType="application/inkml+xml"/>
  <Override PartName="/ppt/ink/ink18.xml" ContentType="application/inkml+xml"/>
  <Override PartName="/ppt/ink/ink19.xml" ContentType="application/inkml+xml"/>
  <Override PartName="/ppt/ink/ink20.xml" ContentType="application/inkml+xml"/>
  <Override PartName="/ppt/ink/ink21.xml" ContentType="application/inkml+xml"/>
  <Override PartName="/ppt/ink/ink22.xml" ContentType="application/inkml+xml"/>
  <Override PartName="/ppt/ink/ink23.xml" ContentType="application/inkml+xml"/>
  <Override PartName="/ppt/ink/ink24.xml" ContentType="application/inkml+xml"/>
  <Override PartName="/ppt/ink/ink25.xml" ContentType="application/inkml+xml"/>
  <Override PartName="/ppt/ink/ink26.xml" ContentType="application/inkml+xml"/>
  <Override PartName="/ppt/ink/ink27.xml" ContentType="application/inkml+xml"/>
  <Override PartName="/ppt/ink/ink28.xml" ContentType="application/inkml+xml"/>
  <Override PartName="/ppt/ink/ink29.xml" ContentType="application/inkml+xml"/>
  <Override PartName="/ppt/ink/ink30.xml" ContentType="application/inkml+xml"/>
  <Override PartName="/ppt/ink/ink31.xml" ContentType="application/inkml+xml"/>
  <Override PartName="/ppt/ink/ink32.xml" ContentType="application/inkml+xml"/>
  <Override PartName="/ppt/ink/ink33.xml" ContentType="application/inkml+xml"/>
  <Override PartName="/ppt/ink/ink34.xml" ContentType="application/inkml+xml"/>
  <Override PartName="/ppt/notesSlides/notesSlide5.xml" ContentType="application/vnd.openxmlformats-officedocument.presentationml.notesSlide+xml"/>
  <Override PartName="/ppt/ink/ink35.xml" ContentType="application/inkml+xml"/>
  <Override PartName="/ppt/ink/ink36.xml" ContentType="application/inkml+xml"/>
  <Override PartName="/ppt/ink/ink37.xml" ContentType="application/inkml+xml"/>
  <Override PartName="/ppt/ink/ink38.xml" ContentType="application/inkml+xml"/>
  <Override PartName="/ppt/ink/ink39.xml" ContentType="application/inkml+xml"/>
  <Override PartName="/ppt/ink/ink40.xml" ContentType="application/inkml+xml"/>
  <Override PartName="/ppt/ink/ink41.xml" ContentType="application/inkml+xml"/>
  <Override PartName="/ppt/ink/ink42.xml" ContentType="application/inkml+xml"/>
  <Override PartName="/ppt/ink/ink43.xml" ContentType="application/inkml+xml"/>
  <Override PartName="/ppt/ink/ink44.xml" ContentType="application/inkml+xml"/>
  <Override PartName="/ppt/ink/ink45.xml" ContentType="application/inkml+xml"/>
  <Override PartName="/ppt/ink/ink46.xml" ContentType="application/inkml+xml"/>
  <Override PartName="/ppt/ink/ink47.xml" ContentType="application/inkml+xml"/>
  <Override PartName="/ppt/ink/ink48.xml" ContentType="application/inkml+xml"/>
  <Override PartName="/ppt/ink/ink49.xml" ContentType="application/inkml+xml"/>
  <Override PartName="/ppt/ink/ink50.xml" ContentType="application/inkml+xml"/>
  <Override PartName="/ppt/ink/ink51.xml" ContentType="application/inkml+xml"/>
  <Override PartName="/ppt/ink/ink52.xml" ContentType="application/inkml+xml"/>
  <Override PartName="/ppt/ink/ink53.xml" ContentType="application/inkml+xml"/>
  <Override PartName="/ppt/ink/ink54.xml" ContentType="application/inkml+xml"/>
  <Override PartName="/ppt/ink/ink55.xml" ContentType="application/inkml+xml"/>
  <Override PartName="/ppt/ink/ink56.xml" ContentType="application/inkml+xml"/>
  <Override PartName="/ppt/ink/ink57.xml" ContentType="application/inkml+xml"/>
  <Override PartName="/ppt/ink/ink58.xml" ContentType="application/inkml+xml"/>
  <Override PartName="/ppt/ink/ink59.xml" ContentType="application/inkml+xml"/>
  <Override PartName="/ppt/ink/ink60.xml" ContentType="application/inkml+xml"/>
  <Override PartName="/ppt/ink/ink61.xml" ContentType="application/inkml+xml"/>
  <Override PartName="/ppt/ink/ink62.xml" ContentType="application/inkml+xml"/>
  <Override PartName="/ppt/ink/ink63.xml" ContentType="application/inkml+xml"/>
  <Override PartName="/ppt/ink/ink64.xml" ContentType="application/inkml+xml"/>
  <Override PartName="/ppt/ink/ink65.xml" ContentType="application/inkml+xml"/>
  <Override PartName="/ppt/ink/ink66.xml" ContentType="application/inkml+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ink/ink67.xml" ContentType="application/inkml+xml"/>
  <Override PartName="/ppt/ink/ink68.xml" ContentType="application/inkml+xml"/>
  <Override PartName="/ppt/ink/ink69.xml" ContentType="application/inkml+xml"/>
  <Override PartName="/ppt/ink/ink70.xml" ContentType="application/inkml+xml"/>
  <Override PartName="/ppt/ink/ink71.xml" ContentType="application/inkml+xml"/>
  <Override PartName="/ppt/ink/ink72.xml" ContentType="application/inkml+xml"/>
  <Override PartName="/ppt/ink/ink73.xml" ContentType="application/inkml+xml"/>
  <Override PartName="/ppt/ink/ink74.xml" ContentType="application/inkml+xml"/>
  <Override PartName="/ppt/ink/ink75.xml" ContentType="application/inkml+xml"/>
  <Override PartName="/ppt/ink/ink76.xml" ContentType="application/inkml+xml"/>
  <Override PartName="/ppt/ink/ink77.xml" ContentType="application/inkml+xml"/>
  <Override PartName="/ppt/ink/ink78.xml" ContentType="application/inkml+xml"/>
  <Override PartName="/ppt/ink/ink79.xml" ContentType="application/inkml+xml"/>
  <Override PartName="/ppt/ink/ink80.xml" ContentType="application/inkml+xml"/>
  <Override PartName="/ppt/ink/ink81.xml" ContentType="application/inkml+xml"/>
  <Override PartName="/ppt/ink/ink82.xml" ContentType="application/inkml+xml"/>
  <Override PartName="/ppt/ink/ink83.xml" ContentType="application/inkml+xml"/>
  <Override PartName="/ppt/ink/ink84.xml" ContentType="application/inkml+xml"/>
  <Override PartName="/ppt/ink/ink85.xml" ContentType="application/inkml+xml"/>
  <Override PartName="/ppt/ink/ink86.xml" ContentType="application/inkml+xml"/>
  <Override PartName="/ppt/ink/ink87.xml" ContentType="application/inkml+xml"/>
  <Override PartName="/ppt/ink/ink88.xml" ContentType="application/inkml+xml"/>
  <Override PartName="/ppt/ink/ink89.xml" ContentType="application/inkml+xml"/>
  <Override PartName="/ppt/ink/ink90.xml" ContentType="application/inkml+xml"/>
  <Override PartName="/ppt/ink/ink91.xml" ContentType="application/inkml+xml"/>
  <Override PartName="/ppt/ink/ink92.xml" ContentType="application/inkml+xml"/>
  <Override PartName="/ppt/ink/ink93.xml" ContentType="application/inkml+xml"/>
  <Override PartName="/ppt/ink/ink94.xml" ContentType="application/inkml+xml"/>
  <Override PartName="/ppt/ink/ink95.xml" ContentType="application/inkml+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5"/>
  </p:notesMasterIdLst>
  <p:sldIdLst>
    <p:sldId id="1237" r:id="rId5"/>
    <p:sldId id="1240" r:id="rId6"/>
    <p:sldId id="1234" r:id="rId7"/>
    <p:sldId id="1254" r:id="rId8"/>
    <p:sldId id="1255" r:id="rId9"/>
    <p:sldId id="1260" r:id="rId10"/>
    <p:sldId id="1258" r:id="rId11"/>
    <p:sldId id="1257" r:id="rId12"/>
    <p:sldId id="1261" r:id="rId13"/>
    <p:sldId id="1243"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5B51031F-77DF-4B55-909D-3FAC178A864A}">
          <p14:sldIdLst>
            <p14:sldId id="1237"/>
            <p14:sldId id="1240"/>
            <p14:sldId id="1234"/>
            <p14:sldId id="1254"/>
            <p14:sldId id="1255"/>
            <p14:sldId id="1260"/>
            <p14:sldId id="1258"/>
            <p14:sldId id="1257"/>
            <p14:sldId id="1261"/>
            <p14:sldId id="1243"/>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owell, Tracy B" initials="PB" lastIdx="1" clrIdx="0">
    <p:extLst>
      <p:ext uri="{19B8F6BF-5375-455C-9EA6-DF929625EA0E}">
        <p15:presenceInfo xmlns:p15="http://schemas.microsoft.com/office/powerpoint/2012/main" userId="S::tlp29@psu.edu::3a23670c-8d59-42b6-baec-5df9e25afc5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E31A0"/>
    <a:srgbClr val="5135A0"/>
    <a:srgbClr val="9A70B5"/>
    <a:srgbClr val="F6630C"/>
    <a:srgbClr val="F9E691"/>
    <a:srgbClr val="F7D9D8"/>
    <a:srgbClr val="009CDE"/>
    <a:srgbClr val="1E407C"/>
    <a:srgbClr val="001E4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906"/>
    <p:restoredTop sz="74125" autoAdjust="0"/>
  </p:normalViewPr>
  <p:slideViewPr>
    <p:cSldViewPr snapToGrid="0">
      <p:cViewPr varScale="1">
        <p:scale>
          <a:sx n="78" d="100"/>
          <a:sy n="78" d="100"/>
        </p:scale>
        <p:origin x="203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41:18.319"/>
    </inkml:context>
    <inkml:brush xml:id="br0">
      <inkml:brushProperty name="width" value="0.1" units="cm"/>
      <inkml:brushProperty name="height" value="0.1" units="cm"/>
      <inkml:brushProperty name="color" value="#66CC00"/>
    </inkml:brush>
  </inkml:definitions>
  <inkml:trace contextRef="#ctx0" brushRef="#br0">1439 295 24575,'-15'-5'0,"2"1"0,-3-4 0,5 1 0,-4 1 0,-1-4 0,0 2 0,-2 0 0,-2-3 0,5 7 0,-7-7 0,10 7 0,-5-3 0,5 2 0,2 0 0,3 0 0,-2 0 0,2 2 0,-4-3 0,5 5 0,-5-6 0,7 4 0,-7-2 0,10 0 0,-6-2 0,4 4 0,1-4 0,-1 5 0,1-5 0,2 1 0,-3-1 0,1 3 0,0-6 0,-1 4 0,-6-8 0,5 8 0,-7-5 0,5 5 0,-3-1 0,1 5 0,3-3 0,-1 5 0,1-2 0,-1 0 0,-1 1 0,3-1 0,-1 2 0,0 0 0,0 0 0,0 0 0,0 0 0,1 0 0,-1 0 0,0 0 0,0-2 0,0 1 0,1-1 0,-1 2 0,0 0 0,0 0 0,0 0 0,0 0 0,0 0 0,1 0 0,-1 0 0,0 0 0,0 0 0,0 0 0,0 0 0,0 0 0,-3 0 0,3 0 0,-3 0 0,3 0 0,0-2 0,-3 1 0,3-1 0,-3 2 0,3-2 0,0 1 0,0-1 0,-3 2 0,3 0 0,-3 0 0,1 0 0,1 0 0,-4 0 0,4 0 0,-4 0 0,1 0 0,-2 0 0,3 0 0,-2 0 0,1 0 0,-2 0 0,3 0 0,-2 0 0,1 0 0,1 0 0,-2 0 0,4 0 0,-4 0 0,4 0 0,-1 0 0,2 0 0,0 0 0,0 0 0,-3 0 0,2 0 0,-1 0 0,2 0 0,0 0 0,0 0 0,3-2 0,-3 1 0,3-1 0,-3 0 0,0 2 0,3-5 0,-3 5 0,3-3 0,-3 1 0,0 2 0,0-2 0,1 2 0,-1 0 0,0 0 0,0 0 0,0 0 0,0 0 0,0 0 0,0 0 0,-2 0 0,1 0 0,-4 0 0,4 0 0,-4 0 0,4 0 0,-4 0 0,1 0 0,1 0 0,-2 0 0,4 0 0,-4 0 0,4 0 0,-4 0 0,2 0 0,-1 0 0,-1 0 0,2 0 0,-1 0 0,-1 0 0,2 0 0,-1 0 0,-1 0 0,2 0 0,-1 0 0,-1 2 0,4-1 0,-1 3 0,-1-3 0,3 3 0,-3-1 0,0 2 0,3 0 0,-3 1 0,-2 1 0,1-1 0,-1 4 0,-1-4 0,3 4 0,-1-1 0,-1 2 0,1-2 0,1 1 0,-3-1 0,5 1 0,-4 1 0,4-2 0,-5 1 0,6-2 0,-3 1 0,2 1 0,-1-4 0,3 2 0,-3-3 0,4 0 0,-2 0 0,0 0 0,0 0 0,0 0 0,1-3 0,1 3 0,-1-5 0,1 2 0,0 1 0,-1-3 0,1 4 0,-2-3 0,1 3 0,-1-3 0,2 3 0,-1-3 0,1 3 0,-2-4 0,2 5 0,-1-2 0,4 1 0,-2 1 0,2 0 0,0 0 0,0-1 0,0 1 0,0 0 0,0 0 0,0 0 0,0 3 0,0 0 0,0 0 0,0 3 0,0-3 0,0 0 0,0 3 0,0-6 0,0 3 0,0-3 0,0 0 0,0 2 0,0-1 0,0 2 0,0-3 0,0 0 0,0 0 0,0 0 0,0-1 0,0 1 0,0 0 0,0 0 0,0 0 0,0 0 0,0 0 0,0 0 0,0 0 0,0 0 0,0 0 0,0 0 0,2 0 0,-2 0 0,3 0 0,-3 0 0,2 0 0,-2 3 0,5-3 0,-5 3 0,5 2 0,-3-4 0,4 6 0,-4-6 0,3 2 0,-2-3 0,2 0 0,0 0 0,0 0 0,0 0 0,0 0 0,0-1 0,0 1 0,0 0 0,2 1 0,-1-4 0,2 3 0,-1-4 0,-1 3 0,4-3 0,-4 1 0,1 0 0,-2-1 0,0 1 0,0-2 0,0 0 0,2 0 0,-1 0 0,1 0 0,-2 0 0,-1 2 0,1-1 0,0 1 0,0-2 0,2 2 0,-2 1 0,2-1 0,-2 0 0,0 1 0,0-3 0,2 4 0,-2-3 0,7 5 0,-6-2 0,13 8 0,-12-6 0,18 6 0,-18-6 0,14 3 0,-14-5 0,9 5 0,-10-8 0,8 5 0,-8-5 0,3 3 0,-4-1 0,0 2 0,0-2 0,0 3 0,0-5 0,-1 8 0,-1-6 0,1 4 0,-1-2 0,0 2 0,1-4 0,-1 8 0,0-7 0,1 8 0,-3-7 0,3 4 0,-4-3 0,2 1 0,-2-3 0,3 1 0,-3 0 0,2 0 0,-2-1 0,3-1 0,-3 1 0,4-3 0,-3 3 0,6 1 0,-4 0 0,8 7 0,-5-6 0,8 8 0,-7-6 0,0 2 0,-3-2 0,-1-3 0,0 0 0,1 0 0,-3 0 0,1-1 0,0-1 0,-1 1 0,1-1 0,-2 2 0,0 0 0,2-1 0,-2 1 0,5-2 0,-5 1 0,4-4 0,-3 5 0,3-5 0,-1 5 0,2-3 0,0 3 0,0 0 0,3 0 0,-3-2 0,6 2 0,-3-2 0,3 3 0,3-1 0,-2 1 0,2 0 0,-3-1 0,0-2 0,0 2 0,0-4 0,-3 3 0,3-3 0,-6 1 0,3-2 0,-3 0 0,0 2 0,0-1 0,0 1 0,0-2 0,0 0 0,-1 0 0,1 0 0,0 0 0,0 0 0,0 0 0,0 0 0,0 0 0,0 2 0,0-1 0,2 1 0,-1 0 0,4-1 0,-2 3 0,3 0 0,0 1 0,0 1 0,4-1 0,-4 1 0,4 0 0,-1-1 0,-2 1 0,2 2 0,-3-2 0,0 5 0,-3-6 0,2 3 0,-4 0 0,2-2 0,-3 2 0,0-3 0,0-1 0,-2 4 0,-1-2 0,0 1 0,-1-2 0,1 0 0,-2 0 0,0 0 0,0 0 0,0 0 0,0 0 0,0-1 0,0 1 0,0 0 0,0 0 0,2 0 0,-1 0 0,1 0 0,-2 3 0,0-3 0,2 6 0,-1-6 0,1 6 0,1-6 0,-3 6 0,5-3 0,-5 0 0,5 3 0,-4-3 0,1 3 0,1-3 0,-3 3 0,5-6 0,-5 3 0,5-1 0,-5-1 0,5 2 0,-4-3 0,3 0 0,-3 0 0,3 0 0,-3 0 0,3 0 0,-1-3 0,2 3 0,0-3 0,0 3 0,0 0 0,-3 0 0,3 0 0,-3 0 0,3 0 0,0 0 0,0 0 0,0 0 0,0 0 0,-2 0 0,1 0 0,-1 0 0,0 0 0,-1 0 0,0 0 0,-1 3 0,1-3 0,-2 3 0,0 0 0,2-3 0,-1 5 0,1-1 0,-2 2 0,0 0 0,0 0 0,0-3 0,0 2 0,0-1 0,0-1 0,0 2 0,0-4 0,0 4 0,0-4 0,0 4 0,0-4 0,0 4 0,0-4 0,0 2 0,0-1 0,0-1 0,0 2 0,0-4 0,0 1 0,0 0 0,0 3 0,0-3 0,2 0 0,-1-1 0,3-3 0,-3 3 0,3-3 0,-1 3 0,2-4 0,0 5 0,-1-5 0,1 5 0,0-5 0,0 5 0,3-2 0,-2 2 0,4 0 0,-2 0 0,1 1 0,1-1 0,-2 0 0,1 1 0,1 1 0,-5-1 0,3 2 0,-3-3 0,0 0 0,0 0 0,0 0 0,0-3 0,0 1 0,-2-1 0,-1 0 0,-2 3 0,0 0 0,0-1 0,0 1 0,0 0 0,0 0 0,0 0 0,0 0 0,0-1 0,0 1 0,2-2 0,1 1 0,1-1 0,1 2 0,3 0 0,-2 0 0,4 1 0,-4-1 0,4 0 0,-5 0 0,6 1 0,-6-1 0,6 0 0,-6 0 0,6 0 0,-6 0 0,6 1 0,-6-1 0,6 0 0,-6 0 0,6 1 0,-3-1 0,0 0 0,3 1 0,-6-1 0,3 0 0,-3 0 0,0-2 0,0 1 0,0-3 0,0 3 0,0-1 0,0 0 0,0 1 0,0-1 0,0 0 0,0 1 0,-3-1 0,3 2 0,-3 0 0,3-3 0,0 3 0,0-2 0,0 2 0,0 0 0,0 0 0,0-1 0,3 2 0,-2-1 0,1 0 0,1 0 0,-3 0 0,6 1 0,-6-1 0,6 0 0,-3 3 0,0-2 0,3 2 0,-3-3 0,3 0 0,-3 1 0,3-1 0,-6 0 0,3 0 0,-3 0 0,0 0 0,0-2 0,0-1 0,0-2 0,-1 0 0,-1-2 0,1-1 0,-3-1 0,1-1 0,-2 0 0,0-3 0,2 2 0,-1-4 0,1 2 0,-2-1 0,0-1 0,0 2 0,2-1 0,-1-1 0,1 2 0,-2-1 0,0-1 0,0 2 0,0-1 0,2-1 0,-1 2 0,1-3 0,1 0 0,-3 0 0,5 0 0,-4 3 0,4-3 0,-5 6 0,3-3 0,-1 3 0,-1 0 0,3-3 0,-3 3 0,4-3 0,-5 3 0,5 0 0,-3 0 0,1 0 0,-1 0 0,0 1 0,-1-1 0,3 2 0,-3-2 0,3 3 0,-3-3 0,1 0 0,0 2 0,-1-1 0,1 1 0,0-2 0,-2 0 0,3 0 0,-1 1 0,-2-1 0,2 0 0,-2 1 0,0-1 0,0 0 0,2 0 0,-1 0 0,1 0 0,-2 0 0,0-2 0,0 1 0,2-1 0,-1 2 0,1 0 0,-2 0 0,0-3 0,2 2 0,-1-4 0,1 4 0,-2-4 0,0 4 0,0-4 0,0 4 0,0-4 0,2 5 0,-1-6 0,1 6 0,-2-6 0,0 6 0,0-3 0,0 0 0,3 0 0,-3 0 0,3 0 0,-3 0 0,0 3 0,0-3 0,0 3 0,0-3 0,0 3 0,0-3 0,2 3 0,-2-2 0,3 1 0,-3-2 0,0 3 0,0 0 0,0 0 0,0 0 0,0 0 0,0 1 0,0-1 0,0 0 0,0 0 0,0 0 0,0 0 0,0 0 0,0 1 0,0-1 0,0 0 0,2 0 0,-2 0 0,2 0 0,-2 0 0,0 0 0,3 1 0,-3-1 0,2 0 0,-2 0 0,2 0 0,-1 0 0,1 0 0,0 0 0,-1 0 0,1 0 0,-2 0 0,2 0 0,-1 0 0,3 1 0,-3-1 0,1 0 0,-2 0 0,0 0 0,0 0 0,0 0 0,0 0 0,0 1 0,0-1 0,0 0 0,0 0 0,0-3 0,0 2 0,0-1 0,0 2 0,0 0 0,0-3 0,0 2 0,0-1 0,0-1 0,0 3 0,0-6 0,0 6 0,0-6 0,0 3 0,0 0 0,0-3 0,0 6 0,0-6 0,0 3 0,0 0 0,0-3 0,0 3 0,0 0 0,0-6 0,0 8 0,2-8 0,-1 6 0,1-3 0,-2 0 0,3 0 0,-3 0 0,3 0 0,-1 0 0,-1 0 0,1 0 0,1 0 0,-3 0 0,3 3 0,-3 0 0,0 3 0,0 0 0,0 0 0,0 0 0,0 0 0,0 0 0,0 1 0,0-1 0,0 0 0,0 1 0,0-1 0,-2 0 0,-1 0 0,0 1 0,-1-1 0,1 0 0,0 0 0,-1 0 0,4-2 0,-5 1 0,5-1 0,-5 2 0,5 0 0,-3-3 0,1 3 0,2-3 0,-3 3 0,1 0 0,2 0 0,-3 0 0,3 0 0,-2 0 0,2 0 0,-2 0 0,-1-2 0,2 1 0,-1-2 0,0 3 0,1 0 0,-3 1 0,3-1 0,-1 0 0,2 0 0,-2 2 0,2-1 0,-3 1 0,1 0 0,-1-1 0,1 1 0,-3-2 0,5 0 0,-5 0 0,2 0 0,1 0 0,-3 0 0,3 0 0,-1 0 0,-2 0 0,5 0 0,-5 0 0,3 0 0,-3 1 0,2-1 0,1 0 0,0 0 0,-1 2 0,0-1 0,-1 1 0,3-2 0,-3 0 0,3 0 0,-3 0 0,1 0 0,1 1 0,-3 1 0,5-1 0,-3 1 0,1-2 0,2 0 0,-2 1 0,0 1 0,1-1 0,-1 1 0,2-2 0,-2 0 0,1 0 0,-1 1 0,0-1 0,1 0 0,-1 0 0,0 2 0,1-1 0,-1 1 0,2-2 0,0 0 0,-2 2 0,1-1 0,-1 1 0,0-2 0,1 0 0,-3 0 0,3 0 0,-3 0 0,3 0 0,-1 0 0,0 3 0,1-3 0,-1 3 0,2-3 0,0 0 0,-2 0 0,1 0 0,-1 0 0,0 2 0,1-1 0,-1 1 0,2-2 0,-2 0 0,1 0 0,-3 0 0,4 0 0,-3 0 0,1 0 0,2 0 0,-5 0 0,5 0 0,-2 0 0,-1 3 0,3-3 0,-2 2 0,-1-1 0,3-1 0,-5 0 0,5 0 0,-2 0 0,-1 0 0,1 0 0,-1 0 0,-2 0 0,5 0 0,-4 0 0,1 0 0,0 0 0,-1 0 0,1 0 0,-2 0 0,2 0 0,-1 3 0,1-3 0,0 2 0,-1 1 0,1-3 0,-2 5 0,0-5 0,0 3 0,1-1 0,-1 1 0,2 0 0,-1 1 0,1-1 0,-2 0 0,0 1 0,0-1 0,0 2 0,3-2 0,-2 1 0,1-1 0,-2 2 0,0 0 0,1-2 0,-1-1 0,0 1 0,3-3 0,-2 5 0,3-5 0,-3 5 0,4-4 0,-5 3 0,3-3 0,-3 3 0,0-3 0,0 1 0,0 1 0,0 0 0,2-1 0,-1 3 0,3-5 0,-3 5 0,1-5 0,-2 5 0,1-4 0,1 3 0,1-1 0</inkml:trace>
</inkml:ink>
</file>

<file path=ppt/ink/ink1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5"/>
    </inkml:context>
    <inkml:brush xml:id="br0">
      <inkml:brushProperty name="width" value="0.28222" units="cm"/>
      <inkml:brushProperty name="height" value="0.28222" units="cm"/>
      <inkml:brushProperty name="color" value="#FFFFFF"/>
    </inkml:brush>
  </inkml:definitions>
  <inkml:trace contextRef="#ctx0" brushRef="#br0">0 1418 24575,'29'0'0,"-4"0"0,-6 0 0,-1 0 0,4 0 0,-1 0 0,0 0 0,25 8 0,-24-4 0,21 7 0,-25-6 0,-6 0 0,5 1 0,-6-2 0,4 2 0,-4-1 0,0 1 0,-2-3 0,1 1 0,-1-1 0,1 0 0,1 2 0,-2-3 0,1 1 0,-4 0 0,4 0 0,-4 2 0,2-3 0,-1 3 0,2-4 0,-1 3 0,2-1 0,-1-1 0,-1 3 0,3-4 0,-3 1 0,2 0 0,0-1 0,-1 3 0,0-4 0,2 5 0,3-4 0,-2 4 0,3-3 0,-2 0 0,-1 3 0,3-3 0,-1 4 0,-3-3 0,4 2 0,-4-4 0,3 1 0,-2 0 0,3-1 0,-1 1 0,6-2 0,-4 0 0,3 2 0,-5-1 0,-2 1 0,3-2 0,-5 0 0,1 0 0,1 0 0,2 0 0,-2 0 0,2 0 0,0 0 0,-2 0 0,2 0 0,0 0 0,2 0 0,-2 0 0,3 0 0,-5 0 0,2 0 0,1 0 0,-4 0 0,7 0 0,-6 0 0,3 0 0,-5 0 0,1 0 0,0 0 0,0 0 0,1 0 0,-2 0 0,6 0 0,-4 0 0,3 0 0,-6 0 0,-2 0 0,2 0 0,-3 0 0,2 0 0,-1-2 0,-1 1 0,2-1 0,0 2 0,0-2 0,0 1 0,1-3 0,-2 3 0,-2-3 0,6 3 0,-5-1 0,4 0 0,-4 0 0,1-1 0,1-2 0,-2 4 0,4-2 0,-1 0 0,-2-2 0,5 0 0,-5 0 0,5 0 0,2 0 0,-2-1 0,7-2 0,-6 3 0,5-3 0,-6 4 0,2 0 0,-3 0 0,1 1 0,-2-2 0,2 1 0,-4 0 0,2 2 0,-4-3 0,4-1 0,-5 4 0,6-2 0,-5 1 0,2-2 0,0 1 0,-4-1 0,8 2 0,-7-1 0,6 1 0,-5-1 0,3-2 0,-2 1 0,2 1 0,0-3 0,1 1 0,-1-1 0,1 3 0,-5-1 0,6 0 0,-3 0 0,0-2 0,4 1 0,-5-1 0,2 1 0,1 1 0,-1 0 0,-1 1 0,3-1 0,-6 1 0,6-2 0,-4 1 0,6 0 0,-3 0 0,2 0 0,-2-1 0,1 1 0,1 2 0,-2-1 0,4 1 0,3-4 0,2 1 0,-2-2 0,-3 3 0,-3 0 0,3-1 0,-1 1 0,0-1 0,-1 1 0,-1 1 0,-1-2 0,2-1 0,-1 2 0,0-3 0,0 3 0,0 0 0,0 1 0,-3 0 0,3 2 0,-5-3 0,3-2 0,-2 4 0,3-4 0,-5 4 0,6-2 0,-6 0 0,7 0 0,-5 1 0,5-2 0,-1 3 0,-1-1 0,-1-2 0,1 2 0,-1-4 0,2 3 0,1-1 0,-2-1 0,2 1 0,4-6 0,-4 6 0,4-5 0,-5 5 0,0-2 0,0 3 0,1-2 0,-2 1 0,1-2 0,-2 3 0,1 0 0,-2-1 0,3 0 0,1-2 0,-4 1 0,3 2 0,-3-6 0,3 6 0,-3-5 0,3 5 0,-5-4 0,5 2 0,-5-2 0,1 4 0,-1-3 0,1 3 0,-1 0 0,2-1 0,-3 3 0,0-4 0,1 4 0,-2-2 0,1 0 0,1 1 0,-2 0 0,4-1 0,-3 0 0,-1 0 0,3 1 0,-5-1 0,4 2 0,-2-2 0,0 0 0,3 0 0,-4 1 0,1-1 0,2-1 0,-1 0 0,0-1 0,0 0 0,0 3 0,0-6 0,1 2 0,-1 0 0,1-1 0,1 0 0,0-1 0,1 1 0,-1 1 0,-1-2 0,5 4 0,-5-4 0,2 5 0,-3-2 0,0 3 0,0-1 0,0 0 0,-1 1 0,2-3 0,-3 2 0,1-1 0,-2-1 0,1 2 0,1-1 0,-3 0 0,1 1 0,1-2 0,-3 0 0,4 0 0,-3-3 0,1 2 0,1-2 0,-2 6 0,1-6 0,1 5 0,-3-5 0,5 2 0,-5 0 0,5-1 0,-4 3 0,3-2 0,-1 2 0,1-4 0,0 5 0,-4-2 0,5-1 0,-4 3 0,3-2 0,-3 0 0,3 2 0,-3-2 0,3 2 0,-3-1 0,1 0 0,1-3 0,-3 4 0,3-1 0,-1-3 0,-1 3 0,0-3 0,1 4 0,-2 1 0,3-3 0,-1 1 0,-1-1 0,1 2 0,-2 0 0,0-4 0,0 4 0,0-2 0,0 1 0,0 0 0,0-3 0,0 4 0,0 0 0,0-2 0,0 1 0,0-5 0,0 5 0,0-3 0,0 4 0,0-2 0,0 1 0,0-1 0,0 0 0,0 0 0,0 2 0,0-4 0,0 4 0,0-2 0,0 1 0,0 2 0,0-5 0,0 3 0,0 0 0,0-1 0,0 2 0,-5-4 0,1 4 0,-1-1 0,2 2 0,-3-4 0,3 3 0,-1-2 0,1 2 0,-2 1 0,2-3 0,-1 4 0,-1-5 0,0 4 0,0-1 0,1 0 0,-1 1 0,0 0 0,2-3 0,1 0 0</inkml:trace>
</inkml:ink>
</file>

<file path=ppt/ink/ink1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6"/>
    </inkml:context>
    <inkml:brush xml:id="br0">
      <inkml:brushProperty name="width" value="0.28222" units="cm"/>
      <inkml:brushProperty name="height" value="0.28222" units="cm"/>
      <inkml:brushProperty name="color" value="#FFFFFF"/>
    </inkml:brush>
  </inkml:definitions>
  <inkml:trace contextRef="#ctx0" brushRef="#br0">0 1121 24575,'22'16'0,"-5"-1"0,-6-7 0,-3-1 0,3 0 0,1 1 0,-2 1 0,21 12 0,-15-13 0,25 18 0,-28-20 0,8 7 0,-7-8 0,-2 0 0,2 0 0,-3 0 0,0 0 0,1 0 0,7 3 0,-7-2 0,7 2 0,-7-3 0,-4-1 0,2 2 0,-1-2 0,2 1 0,-3 0 0,3 0 0,-3 0 0,1 1 0,1-2 0,-2 1 0,1 0 0,1 0 0,-2 1 0,4-3 0,-5 2 0,5 1 0,-2-2 0,1 2 0,3-3 0,-3 1 0,-3-2 0,3 1 0,-4 2 0,2-2 0,1 1 0,-1 2 0,-1-3 0,3 0 0,-3 0 0,1 2 0,0-2 0,0 1 0,2-1 0,0 0 0,1 2 0,-1-5 0,-1 5 0,1-4 0,5 3 0,-3-3 0,3 3 0,-5-3 0,3 4 0,-2-5 0,2 3 0,0-1 0,-2-1 0,6 3 0,-7-3 0,3 1 0,0 1 0,-1-2 0,1 3 0,-4-3 0,2 1 0,-1 1 0,1-3 0,-2 5 0,1-5 0,-2 3 0,0-1 0,1-1 0,0 1 0,2-2 0,-4 2 0,2-2 0,-1 2 0,0-2 0,0 3 0,1-3 0,0 3 0,-2-3 0,3 2 0,-5-1 0,4 1 0,-4-2 0,4 0 0,-1 0 0,1 0 0,-1 0 0,1 0 0,-2 0 0,4 0 0,-2 2 0,2-1 0,-1 1 0,5-2 0,-3 0 0,-1 0 0,-2 0 0,-1 0 0,4 0 0,-1 0 0,-1 0 0,-2 0 0,-2 0 0,3 0 0,-5 0 0,6 0 0,-6 0 0,7 0 0,-8 2 0,4-1 0,1 1 0,-5-2 0,5 0 0,-3 0 0,0 0 0,6 0 0,-6 0 0,5 0 0,-2 0 0,-2 0 0,3 0 0,-5 0 0,2 0 0,-1 0 0,2 0 0,-1 0 0,-1 0 0,2 0 0,-1 0 0,-1 0 0,4 0 0,-1 0 0,1 0 0,2 0 0,-1 0 0,3 0 0,-2 0 0,3 0 0,-5 0 0,4-3 0,-4 3 0,3-3 0,-4 1 0,2 1 0,-1-3 0,0 3 0,-1-3 0,0 3 0,7-4 0,-4 2 0,4 1 0,-7-3 0,1 5 0,-2-5 0,1 4 0,1-3 0,-4 4 0,6-5 0,-3 2 0,2 0 0,-4 0 0,1 2 0,-2-3 0,2 3 0,-1-3 0,-1 3 0,4-3 0,-4 3 0,2-3 0,0 3 0,-4-3 0,5 3 0,-4-3 0,5 2 0,-4-1 0,4-1 0,-5 1 0,0 0 0,2-1 0,-1 1 0,2 0 0,-1 0 0,-1 0 0,2-2 0,-1 3 0,-1-2 0,5 1 0,-6-2 0,6 0 0,-5 0 0,3 0 0,0 0 0,2 0 0,-2 0 0,0 1 0,0-1 0,2-1 0,0 1 0,1 2 0,-4-1 0,2 2 0,0-6 0,-1 3 0,4-3 0,-7 4 0,4-1 0,-4 3 0,4-3 0,-4 2 0,4-1 0,-4 1 0,2-2 0,-1 2 0,-1-1 0,2-1 0,-3 0 0,2 0 0,-1 0 0,0 1 0,0 0 0,-1 0 0,2 1 0,-1-1 0,2 1 0,-4-2 0,2 1 0,-1-1 0,-1 0 0,2 0 0,-1 1 0,2 0 0,-2-1 0,3 0 0,-3 1 0,-1-1 0,2-2 0,-1 2 0,0-2 0,0 2 0,0 0 0,1 0 0,-2 1 0,1-1 0,1 1 0,-2 0 0,1-1 0,0 0 0,1-2 0,-2 4 0,2-6 0,-1 5 0,2-3 0,0 2 0,1 0 0,-1 1 0,-1 0 0,1-1 0,-2 2 0,0-1 0,2 1 0,-1-1 0,1-1 0,1 0 0,-2 2 0,2-1 0,-4 1 0,1-1 0,1-1 0,-1 1 0,2-1 0,-1 1 0,1-2 0,1 1 0,-2 1 0,4-4 0,-4 3 0,1-2 0,2 2 0,-3-2 0,3 1 0,-2 0 0,0 0 0,-2 2 0,1-1 0,-2 1 0,1-1 0,1 0 0,-2 0 0,1 0 0,1-1 0,-1 1 0,-1-2 0,2 2 0,-1 0 0,2 0 0,-1 1 0,2-1 0,-3 0 0,-1 0 0,2 1 0,-1-3 0,-1 3 0,2-3 0,-1 2 0,0 1 0,0-1 0,0 0 0,0 0 0,-1 0 0,1 1 0,1-1 0,-1 0 0,-1-1 0,2 1 0,0-3 0,-2 4 0,1 2 0,2-5 0,-1 4 0,1-4 0,-1 2 0,-1 1 0,-2 0 0,3 0 0,-1-1 0,0 0 0,0 0 0,0 1 0,1-1 0,-2 0 0,0 1 0,2-1 0,-1-2 0,0 4 0,0-3 0,0 2 0,0-1 0,-1-1 0,-1 1 0,2 0 0,0-2 0,0 2 0,3-2 0,-3 2 0,0-2 0,0 0 0,1-3 0,-1 0 0,1-1 0,0 1 0,-2 1 0,2 1 0,-1 2 0,1-3 0,-2 3 0,2-1 0,-1 3 0,-1 1 0,2-4 0,-1 3 0,0-3 0,-3 0 0,1 3 0,-2-3 0,2 3 0,3-3 0,-3 1 0,-1 1 0,-1-2 0,4 0 0,-4 3 0,3-2 0,-3-1 0,0 2 0,2-3 0,-3 3 0,2-2 0,-2 1 0,0 1 0,2-3 0,-1 3 0,1-2 0,-2 0 0,2 3 0,-2-5 0,3 3 0,-3-1 0,0 1 0,0-1 0,0 0 0,0 0 0,0 0 0,0 2 0,2-4 0,-1 3 0,1-1 0,-2 2 0,2 0 0,0-3 0,1 2 0,0-1 0,-3 1 0,2 1 0,-2-2 0,3 0 0,-3 2 0,2 0 0,-2-2 0,3 1 0,-3-2 0,0 3 0,0-1 0,0-1 0,0 2 0,0-3 0,1 3 0,0-2 0,1 0 0,-2 2 0,0-4 0,0 4 0,2-2 0,-1 1 0,1 1 0,-2-3 0,0 3 0,0-2 0,0 0 0,3 2 0,-3-3 0,3 3 0,-3-2 0,0 2 0,0 0 0,0-4 0,0 4 0,0-1 0,2 0 0,-1 1 0,0-3 0,-1 3 0,0-1 0,0 0 0,0 1 0,0-3 0,0 3 0,0-1 0</inkml:trace>
</inkml:ink>
</file>

<file path=ppt/ink/ink1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7"/>
    </inkml:context>
    <inkml:brush xml:id="br0">
      <inkml:brushProperty name="width" value="0.28222" units="cm"/>
      <inkml:brushProperty name="height" value="0.28222" units="cm"/>
      <inkml:brushProperty name="color" value="#FFFFFF"/>
    </inkml:brush>
  </inkml:definitions>
  <inkml:trace contextRef="#ctx0" brushRef="#br0">2380 1126 24575,'-20'-5'0,"1"4"0,13-4 0,-3 3 0,-1 2 0,0-5 0,1 4 0,-9-3 0,1 2 0,1-1 0,-3 1 0,14 2 0,-5 0 0,-3 0 0,1 0 0,-6 0 0,6 0 0,1 0 0,0 0 0,6 0 0,-3 0 0,0 0 0,4 0 0,-6 0 0,5 0 0,-3 0 0,0 0 0,4 0 0,-6 0 0,5 0 0,-3 0 0,1-2 0,2 1 0,-4-1 0,2 2 0,1 0 0,-5 0 0,6 0 0,-6 0 0,7 0 0,-4 0 0,2 0 0,-4 0 0,1 0 0,-1 0 0,1-2 0,-1 2 0,1-2 0,-6-1 0,4 3 0,-3-3 0,3 1 0,0 1 0,0-4 0,-1 5 0,2-2 0,-2 0 0,2 1 0,-1-2 0,-1 3 0,5 0 0,-5-2 0,7 1 0,-5-1 0,3 2 0,1-2 0,-3 2 0,4-2 0,-2 2 0,-4-2 0,5 1 0,-6-1 0,6 0 0,-5 2 0,6-2 0,-3 2 0,1-2 0,1 1 0,-5-1 0,6 2 0,-3 0 0,1-2 0,1 1 0,-2-1 0,0-1 0,3 3 0,-6-5 0,5 5 0,-3-2 0,2-1 0,0 3 0,-1-2 0,3 0 0,-5 1 0,1-1 0,-2-1 0,-1 3 0,2-2 0,-4-1 0,2 2 0,-6-4 0,6 3 0,-5-2 0,-3 0 0,1 1 0,-5 0 0,3-2 0,2 4 0,-3-4 0,4 4 0,-1-4 0,1 2 0,0 0 0,0-2 0,3 2 0,-2 0 0,4-1 0,0 0 0,4 1 0,-1-1 0,4 2 0,-4-1 0,4-1 0,-4 3 0,4-3 0,-1 4 0,-1-4 0,2 1 0,-4-2 0,1 2 0,-2-1 0,1 1 0,0-3 0,1 2 0,0-2 0,-5 1 0,2 1 0,-7-1 0,3-1 0,0 1 0,1-1 0,1 1 0,3 2 0,-5-2 0,2 2 0,3 0 0,-3-2 0,2 2 0,2-2 0,-5 1 0,3 0 0,-2-1 0,3 3 0,0-3 0,1 0 0,-3-1 0,3 1 0,-1 0 0,0-1 0,0 4 0,-1-3 0,2 2 0,2-1 0,-8-3 0,10 1 0,-10-1 0,7 2 0,1 0 0,-2 0 0,3 0 0,-2 0 0,3 0 0,-4 2 0,4 0 0,-5 0 0,3-1 0,0-4 0,-3 2 0,3-1 0,-4 1 0,1 1 0,3 1 0,-3-2 0,3 1 0,-3 1 0,3 1 0,-2-2 0,1 3 0,1-3 0,-2-1 0,1 2 0,1-2 0,-3 1 0,5 1 0,-4-2 0,4 3 0,-4 0 0,-1-2 0,0-1 0,0-1 0,1 2 0,5-2 0,-7 1 0,6-1 0,-4 1 0,4 1 0,-1 2 0,-1-4 0,3 1 0,-3-1 0,3 2 0,-1-2 0,2 2 0,-2-3 0,1 4 0,-2-1 0,0-1 0,0 0 0,2-1 0,-1 0 0,1-1 0,1 0 0,-5-2 0,3 3 0,-1 0 0,-2-4 0,4 4 0,-3-1 0,2-2 0,-4 0 0,3 0 0,-3 0 0,4 0 0,1 4 0,1-3 0,-2 3 0,0-3 0,2 4 0,-2-2 0,1 0 0,2 1 0,-1-1 0,4 3 0,-5-3 0,4 2 0,-1-2 0,2 1 0,0 1 0,2-4 0,1 5 0,2-1 0,2-1 0,-1 2 0,0-5 0,0 4 0,0-2 0,-2 3 0,1-1 0,0 0 0,0 1 0,0-1 0,0 0 0,0-1 0,1 0 0,-4-1 0,2 3 0,0-2 0,-1 1 0,1-2 0,-2 2 0,1 1 0,4-3 0,-4 1 0,4 0 0,-4 1 0,2 0 0,0 0 0,-2-1 0,4 0 0,-4 1 0,1 0 0,1-2 0,0 2 0,-2-1 0,2 1 0,-3 1 0,2-1 0,2 1 0,-1-1 0,0 1 0,-1 0 0,1-1 0,0 1 0,1 1 0,0 1 0,4 2 0,-6 0 0,4 0 0,-1 0 0,-1 0 0</inkml:trace>
</inkml:ink>
</file>

<file path=ppt/ink/ink1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8"/>
    </inkml:context>
    <inkml:brush xml:id="br0">
      <inkml:brushProperty name="width" value="0.28222" units="cm"/>
      <inkml:brushProperty name="height" value="0.28222" units="cm"/>
      <inkml:brushProperty name="color" value="#FFFFFF"/>
    </inkml:brush>
  </inkml:definitions>
  <inkml:trace contextRef="#ctx0" brushRef="#br0">2596 1298 24575,'-23'0'0,"3"0"0,8 0 0,2 0 0,-5 0 0,3 0 0,-5 0 0,-11-5 0,-11-1 0,6-1 0,-3 1 0,20 2 0,-3 2 0,2-1 0,4 3 0,-2-2 0,4 1 0,-4-1 0,4 0 0,0 1 0,0-4 0,0 4 0,2-1 0,-1 2 0,4 0 0,-4 0 0,4-2 0,-2 2 0,1-2 0,-4 2 0,3 0 0,-5 0 0,7 0 0,-2-2 0,1 1 0,-2-1 0,1 2 0,0-2 0,1 1 0,1-1 0,-5 2 0,6 0 0,-3 0 0,1 0 0,-2 0 0,1 0 0,-3 0 0,6 0 0,-6 0 0,3 0 0,0 0 0,-3 0 0,4 0 0,-3 0 0,1 0 0,0-2 0,-2 1 0,2-1 0,-1 2 0,4 0 0,-4 0 0,-3 0 0,3 0 0,-5 0 0,6 0 0,1 0 0,-2 0 0,1 0 0,-1 0 0,1-2 0,-1 2 0,1-3 0,-2 3 0,0 0 0,3 0 0,-3-2 0,3 1 0,-4-1 0,2 0 0,0 2 0,-3-2 0,3 2 0,1 0 0,-1-2 0,1 1 0,-2-1 0,1 2 0,-2 0 0,4-2 0,-2 1 0,1-1 0,-6-1 0,2 3 0,-3-4 0,5 3 0,-3-4 0,2 4 0,-3-3 0,1 3 0,2-4 0,-5 4 0,5-3 0,-2 1 0,0 0 0,-1-2 0,0 5 0,-3-5 0,7 3 0,-6-1 0,2-2 0,-4 2 0,1-1 0,0 0 0,2 1 0,-4-1 0,3 0 0,-4 0 0,3-1 0,3-1 0,-3 3 0,3-2 0,-8 3 0,6-4 0,-1 1 0,6 2 0,2-2 0,-2 5 0,1-4 0,1 3 0,-2-4 0,1 4 0,0-3 0,0 1 0,1 0 0,-3-2 0,3 5 0,-2-4 0,2 0 0,-4 2 0,2-2 0,-3 3 0,5-3 0,-2 1 0,1 0 0,1-2 0,-5 2 0,3 0 0,-2-2 0,3 2 0,0 1 0,0-3 0,-3 2 0,1-2 0,0-1 0,2 2 0,-6-4 0,2 2 0,-2-1 0,3 1 0,3-1 0,0 1 0,-1-4 0,1 3 0,-3-1 0,3-2 0,-3 2 0,2 0 0,-2-2 0,3 3 0,-6-2 0,4 3 0,-5-2 0,7 2 0,-3-1 0,0 1 0,-2-2 0,2 3 0,-3-1 0,5 2 0,-6-2 0,6-2 0,-2 2 0,-1-1 0,4 1 0,-4 1 0,4 0 0,1 0 0,-2 2 0,1-1 0,-1-1 0,-1-1 0,0-1 0,4 4 0,0-2 0,0 0 0,0 0 0,-1-3 0,5 4 0,-3-2 0,3 0 0,-1 1 0,1-3 0,0 4 0,0 0 0,1-1 0,-2-3 0,3 3 0,-1-2 0,1 1 0,-3-2 0,1-3 0,-1 1 0,1 0 0,1 2 0,-1-1 0,3 1 0,-1-2 0,-3-1 0,6 3 0,-5-1 0,4 0 0,-3-2 0,3 2 0,-1-2 0,-1 3 0,2 0 0,-1-2 0,2 3 0,-2-3 0,1 2 0,-2-2 0,3 5 0,0-2 0,0 0 0,0 2 0,0-2 0,0 0 0,0 1 0,-2-3 0,2 3 0,-3-1 0,3 0 0,0 2 0,0-2 0,0 0 0,0 2 0,-2-3 0,1-1 0,-1 3 0,2-3 0,0 4 0,0-1 0,0 1 0,0-5 0,0 5 0,0-3 0,0 1 0,0 2 0,0-5 0,0 5 0,0-4 0,0 3 0,0-1 0,0 1 0,2 0 0,-1-1 0,1 1 0,-2 0 0,3 0 0,-3 0 0,2 0 0,-2-1 0,2 0 0,-1 1 0,1-1 0,0-2 0,-1 4 0,4-5 0,-5 6 0,3-1 0,-2-1 0,2 0 0,0-1 0,2 0 0,-5 3 0,5-2 0,-3-1 0,3 2 0,-2-2 0,1 3 0,-1 0 0,1-1 0,1 0 0,-2-1 0,2 1 0,-5-2 0,5 2 0,-5 0 0,4-1 0,-1-1 0,2 4 0,0-1 0</inkml:trace>
</inkml:ink>
</file>

<file path=ppt/ink/ink1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9"/>
    </inkml:context>
    <inkml:brush xml:id="br0">
      <inkml:brushProperty name="width" value="0.28222" units="cm"/>
      <inkml:brushProperty name="height" value="0.28222" units="cm"/>
      <inkml:brushProperty name="color" value="#FFFFFF"/>
    </inkml:brush>
  </inkml:definitions>
  <inkml:trace contextRef="#ctx0" brushRef="#br0">3002 1547 24575,'-23'0'0,"-1"0"0,13 0 0,-11 0 0,10 0 0,-10 0 0,7 0 0,-32 0 0,21 0 0,-21 0 0,28 0 0,-2 0 0,2 0 0,-3 0 0,0 0 0,3 0 0,-4 0 0,1 0 0,4 0 0,0 0 0,0 0 0,2 0 0,-2 0 0,0 0 0,3 0 0,-2 0 0,2 0 0,0 0 0,-2 0 0,2 0 0,-1 0 0,-1 0 0,2 0 0,-4 0 0,1 0 0,0 0 0,-4 0 0,3 0 0,-1 0 0,-2 0 0,3 0 0,-3 0 0,3 0 0,1 0 0,0 0 0,0 0 0,3 0 0,-3 0 0,7 0 0,-4 0 0,4 0 0,-5 0 0,3 0 0,-2 0 0,3 0 0,2 0 0,2 0 0,-3 0 0,5 0 0,-4 0 0,2 0 0,-1 0 0,-1 0 0,4 0 0,-4 0 0,4 0 0,-4 0 0,4 0 0,-3 0 0,2 0 0,-3 0 0,5 0 0,-6 0 0,3 0 0,-4 0 0,2 0 0,2 0 0,-6 0 0,5 0 0,-5 0 0,2 0 0,2 0 0,-3 0 0,-5 0 0,5 0 0,-7 0 0,7 0 0,1 0 0,-3 0 0,1 0 0,3 0 0,-7 0 0,6 0 0,-6 0 0,4 0 0,-1 0 0,-3 0 0,3-3 0,-3 2 0,3-4 0,-1 2 0,0-2 0,-2 2 0,2-2 0,-1 2 0,3-3 0,-5 0 0,1 1 0,0 0 0,-1-1 0,-2 1 0,-2-4 0,-3 2 0,-1-3 0,1 4 0,-1-2 0,1 2 0,-17-7 0,13 6 0,-13-1 0,21 1 0,-4 1 0,7-2 0,-6 2 0,5-2 0,-1 2 0,3 1 0,0-2 0,0 2 0,2 0 0,-2-1 0,7 1 0,-6 1 0,6 0 0,-7 2 0,5-4 0,-1 1 0,0-3 0,2 2 0,-2-2 0,3 3 0,-3-3 0,1 2 0,0-1 0,1-1 0,1 3 0,1-5 0,-6-1 0,3 2 0,-3-1 0,5 2 0,0 0 0,0-3 0,0 4 0,0-4 0,3 2 0,-4 0 0,4 0 0,0 3 0,-2-4 0,4 3 0,-5-1 0,5 1 0,-1 0 0,-1 1 0,1-1 0,0 0 0,2 1 0,-1-1 0,2 0 0,-5 2 0,3-5 0,-1 2 0,-2-2 0,4 0 0,-6 2 0,5-3 0,-2 5 0,-1-5 0,2-1 0,-2 1 0,1-2 0,0 4 0,3-2 0,-4 3 0,3-1 0,2 1 0,-2 0 0,0-2 0,1 3 0,-2-1 0,0-1 0,0 0 0,1 2 0,1-3 0,0 5 0,-1-4 0,1 3 0,-1-3 0,-1 0 0,1 2 0,-1-3 0,-2 2 0,3 1 0,-4-3 0,3 0 0,-2-1 0,-1-8 0,2 6 0,-3-3 0,7 3 0,-3 2 0,4 2 0,-2-1 0,1 2 0,-1-2 0,5 5 0,-3-5 0,1 0 0,1 0 0,-1 0 0,0 0 0,2 2 0,-3-2 0,3 1 0,0 1 0,0-2 0,0 2 0,0 0 0,0 1 0,0 0 0,-2 2 0,1-5 0,-1 6 0,2-7 0,0 4 0,0-1 0,0-2 0,0 2 0,0 1 0,0-3 0,0 3 0,0-1 0,0-2 0,0 0 0,0 3 0,0-5 0,0 4 0,0 0 0,0-2 0,0 3 0,0-2 0,0 1 0,0 0 0,0-3 0,0 1 0,0 2 0,0-2 0,0 6 0,0-6 0,0 5 0,0-2 0,0 0 0,0 1 0,0-1 0,0-3 0,0 5 0,0-4 0,0 2 0,0 2 0,0-3 0,0 1 0,0 2 0,0-2 0,0-1 0,0 4 0,0-3 0,0-3 0,2 0 0,1-1 0,0 2 0,-1 5 0,0-3 0,-1 2 0,3-2 0,-3-1 0,1 3 0,1-2 0,-3 0 0,4 1 0,-3-1 0,3 4 0,-3-5 0,6 3 0,-6-2 0,8 4 0,-4 1 0,3 2 0,1 0 0,-2 4 0,-2-3 0,-3 4 0</inkml:trace>
</inkml:ink>
</file>

<file path=ppt/ink/ink1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0"/>
    </inkml:context>
    <inkml:brush xml:id="br0">
      <inkml:brushProperty name="width" value="0.28222" units="cm"/>
      <inkml:brushProperty name="height" value="0.28222" units="cm"/>
      <inkml:brushProperty name="color" value="#FFFFFF"/>
    </inkml:brush>
  </inkml:definitions>
  <inkml:trace contextRef="#ctx0" brushRef="#br0">3133 998 24575,'-13'7'0,"-2"2"0,9-8 0,-3 4 0,0-3 0,1 1 0,-18 7 0,10-6 0,-12 5 0,9-7 0,8 3 0,-3-3 0,3 2 0,-1 0 0,-3 1 0,3-1 0,-4 3 0,7-5 0,-1 4 0,2-4 0,-1 3 0,-1-3 0,1 4 0,1-2 0,-2-2 0,4 2 0,-5-1 0,3 0 0,-1 2 0,-1-3 0,4 3 0,-3 0 0,0-2 0,1 1 0,-3-1 0,3 2 0,0-2 0,-3 1 0,5-2 0,-3 3 0,-1-2 0,3 1 0,-9-1 0,9 2 0,-8 0 0,7-2 0,-3 1 0,-1-1 0,2 0 0,0 1 0,1-1 0,0 0 0,1 2 0,-2-3 0,1 0 0,0 2 0,-1-3 0,4 3 0,-3-1 0,-1-1 0,3 3 0,-4-2 0,3 0 0,-3 1 0,0-1 0,0 2 0,0 0 0,0 1 0,0-4 0,-1 3 0,2-3 0,-2 3 0,1-2 0,-3 2 0,-3 0 0,-1 1 0,-2 0 0,5-1 0,-2-3 0,4 4 0,-4-1 0,0 3 0,-2-5 0,3 4 0,-1-4 0,5 2 0,-3 0 0,5-2 0,-2 2 0,-2-2 0,2 0 0,-2 2 0,5-3 0,-1 1 0,1 2 0,-1-4 0,1 1 0,-1 0 0,2-2 0,-1 4 0,1-3 0,1 3 0,1-3 0,-4 1 0,1-2 0,1 2 0,-3-2 0,1 2 0,-2-2 0,-1 0 0,5 0 0,-3 3 0,4-3 0,-5 3 0,-4-3 0,4 0 0,-4 2 0,4-1 0,-3 1 0,3-2 0,-4 0 0,4 0 0,1 0 0,1 0 0,-2 0 0,2 2 0,-5-1 0,3 1 0,-2-2 0,3 0 0,-1 0 0,2 0 0,-2 0 0,2 0 0,-1 0 0,-1 0 0,4 0 0,-5 0 0,5 0 0,-6 0 0,6 0 0,-3 0 0,3 0 0,0 0 0,-3 0 0,4 0 0,-6 0 0,3 0 0,1 0 0,-1 0 0,2 0 0,-3 0 0,2 0 0,-1 0 0,1 0 0,-1 0 0,-1 0 0,2 0 0,-1 0 0,1 0 0,-1 0 0,1 0 0,-1 0 0,1 0 0,1-2 0,-3 1 0,7-1 0,-8 0 0,5 2 0,-3-2 0,1-1 0,0 2 0,1-3 0,-3 3 0,3-3 0,-4 1 0,5 0 0,-8-3 0,4 5 0,-5-6 0,6 4 0,-2-2 0,2 0 0,-2 2 0,1-2 0,1 2 0,0-1 0,1-2 0,0 3 0,-2-1 0,0 1 0,-1-1 0,2 1 0,-2-1 0,2 0 0,-2-1 0,1 0 0,1 0 0,-2 2 0,1-2 0,0 2 0,-5-4 0,4 1 0,-4 0 0,7 0 0,-1 2 0,1-1 0,-1-1 0,-1-1 0,0 1 0,-1-2 0,1 4 0,0-2 0,3 2 0,-2-1 0,1 0 0,1 0 0,-2 0 0,1 0 0,1 0 0,-3 0 0,5 0 0,-4 0 0,4 0 0,-1 0 0,-1 1 0,2-3 0,-4 1 0,4-1 0,-2 2 0,1 0 0,1-2 0,-2 1 0,0-1 0,3 3 0,-8-3 0,7 1 0,-5-1 0,4 1 0,-2-1 0,2 1 0,-4-2 0,3 3 0,-1-5 0,-1 5 0,1-3 0,-2 1 0,2 1 0,-1-1 0,2 2 0,0-2 0,-4 1 0,5-3 0,-5 1 0,1-2 0,1-1 0,-2 0 0,1 2 0,0 1 0,3-1 0,-3 0 0,5-2 0,-2 1 0,0 1 0,1-1 0,0-1 0,2 1 0,-2-1 0,2 3 0,0-2 0,0 4 0,-1-6 0,2 6 0,1-1 0,-3 2 0,4 1 0,-3-3 0,0 2 0,2-1 0,-1 1 0,1 1 0,-2-1 0,1-1 0,-2 0 0,1-1 0,1 3 0,-2-1 0,1 1 0,1-1 0,-2-2 0,1 2 0,0-5 0,0 5 0,-3-5 0,2 5 0,-2-5 0,3 3 0,-3-1 0,2-1 0,-2 3 0,1-4 0,1 4 0,-3-3 0,5 2 0,-2-1 0,0-1 0,-1 0 0,1 2 0,-2-3 0,5 4 0,-1-1 0,0 1 0,-1 0 0,3 0 0,-3-2 0,4 3 0,-2-2 0,1-3 0,2 4 0,-5-2 0,5 1 0,-3 1 0,2 0 0,0-1 0,-4-1 0,5 0 0,-3 1 0,3 4 0,-3-7 0,3 5 0,-5-5 0,5 5 0,-4-2 0,3 1 0,-4-3 0,4 4 0,-1-2 0,-1 0 0,3 1 0,-2-3 0,-1 1 0,2 0 0,-3-1 0,3 2 0,-2-4 0,1 0 0,1 1 0,-1 0 0,2 2 0,0-1 0,0 1 0,0-2 0,0 2 0,0-2 0,0 5 0,0-4 0,0 2 0,0-2 0,0 2 0,0 0 0,0 2 0,-2-4 0,2 4 0,-3-2 0,3 1 0,0 2 0,0-5 0,0 3 0,0-1 0,0 1 0,0 1 0,0-5 0,-2 6 0,1-2 0,-1-1 0,2 1 0,0-2 0,0 3 0,0-2 0,0 0 0,0 2 0,0-3 0,0 2 0,0 0 0,0-1 0,0 0 0</inkml:trace>
</inkml:ink>
</file>

<file path=ppt/ink/ink1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1"/>
    </inkml:context>
    <inkml:brush xml:id="br0">
      <inkml:brushProperty name="width" value="0.28222" units="cm"/>
      <inkml:brushProperty name="height" value="0.28222" units="cm"/>
      <inkml:brushProperty name="color" value="#FFFFFF"/>
    </inkml:brush>
  </inkml:definitions>
  <inkml:trace contextRef="#ctx0" brushRef="#br0">3453 623 24575,'-29'0'0,"4"0"0,10 0 0,2 2 0,5 3 0,-3-1 0,2 2 0,-14 6 0,12-5 0,-14 9 0,18-8 0,-5 0 0,5 0 0,-3-4 0,4 1 0,0-1 0,-1 3 0,0-1 0,2 1 0,-9 0 0,6 1 0,-3 0 0,4-1 0,-2-3 0,1 4 0,0-3 0,-3 3 0,3-4 0,0 4 0,-3-2 0,6 1 0,-7 0 0,7-2 0,-2 2 0,0 0 0,1-1 0,0 1 0,-5 1 0,5-3 0,-4 5 0,2-5 0,-1 2 0,2-3 0,-1 4 0,3-3 0,-6 3 0,5-4 0,-2 3 0,3-1 0,-2 1 0,1-3 0,-3 4 0,5-3 0,-5 2 0,3 1 0,-6-1 0,6 4 0,-7-4 0,7 0 0,-2-2 0,3 0 0,-2 2 0,1-2 0,-2 3 0,3-4 0,0 1 0,0 0 0,0 1 0,-2-1 0,0 2 0,1-2 0,0 0 0,1-1 0,0 1 0,-3 0 0,2 0 0,0 0 0,-3-1 0,3 1 0,-4 0 0,4 1 0,-4 0 0,4 2 0,-4-3 0,4 0 0,-4 0 0,1 0 0,2-1 0,-5 2 0,6-2 0,-4 0 0,4 1 0,-3 1 0,2-2 0,-2-1 0,0 2 0,-2-2 0,0 1 0,2 2 0,-1-1 0,2 0 0,-3 0 0,0-1 0,2 1 0,-1 1 0,2-2 0,-4-1 0,2 2 0,0-2 0,1 2 0,0 0 0,1 0 0,-3 0 0,3 0 0,-1-1 0,-1-2 0,4 3 0,-3-2 0,3 2 0,-5-1 0,6 1 0,-6 1 0,3 0 0,-3 0 0,3 1 0,-2-2 0,4-1 0,-4 1 0,1 0 0,1 0 0,-3-2 0,3 1 0,0-1 0,-2 2 0,1 0 0,1-2 0,-2 1 0,1 0 0,-2 0 0,3 1 0,-3 0 0,3-3 0,0 3 0,-3-5 0,3 5 0,-3-4 0,-1 3 0,2-4 0,1 5 0,-4-4 0,4 3 0,-6-3 0,4 1 0,1-2 0,-2 2 0,1-2 0,0 3 0,0-3 0,0 0 0,-1 0 0,2 0 0,-2 0 0,4 0 0,-2 0 0,4 0 0,-4 0 0,5 0 0,-7 0 0,8 0 0,-8 0 0,7 0 0,-2 0 0,-2 0 0,2 0 0,-2 0 0,-1 0 0,4 0 0,-4 0 0,4 0 0,-4 0 0,4 0 0,-5 0 0,6 0 0,-6 0 0,6 0 0,-3 0 0,1 0 0,-5 0 0,4 0 0,-5 0 0,8 0 0,-3 0 0,0 0 0,3 0 0,-4 0 0,3 0 0,0 0 0,-3 0 0,3 0 0,-1 0 0,0 0 0,-4 0 0,3 0 0,-6 0 0,4 0 0,1 0 0,-1 0 0,1 0 0,-2 0 0,1 0 0,-2 0 0,1 0 0,0 0 0,3 0 0,-3 0 0,3 0 0,-3 0 0,0-3 0,0 3 0,2-4 0,-1 3 0,1-3 0,-1 3 0,-2-4 0,-2 5 0,2-4 0,-1 3 0,-2-4 0,3 4 0,-5-4 0,5 2 0,-6 0 0,6 0 0,-5 2 0,6-4 0,-4 5 0,4-5 0,0 5 0,0-5 0,0 4 0,0-3 0,2 3 0,-1-3 0,1 0 0,2 2 0,-4-3 0,6 4 0,-6-3 0,6 3 0,-9-3 0,9 1 0,-8-2 0,7 3 0,-1-2 0,-2 1 0,4-2 0,-2 2 0,-1-1 0,2 2 0,-6-6 0,2 3 0,1 0 0,0 0 0,2 2 0,1-1 0,-5-1 0,7 0 0,-8-2 0,5 1 0,-3-3 0,0 3 0,1-4 0,-2 4 0,0-2 0,0 1 0,0-2 0,-3 3 0,2-4 0,-2 4 0,3-4 0,-4 3 0,0-2 0,-3-1 0,0 1 0,0-3 0,-5 0 0,5 2 0,-3-2 0,2 3 0,1-2 0,2 5 0,2-2 0,4 3 0,0 1 0,4-1 0,-3 0 0,4 0 0,-2 0 0,1 1 0,1-1 0,1 0 0,-4 0 0,2 1 0,-1-1 0,3 1 0,-2 0 0,0 0 0,0-1 0,-1 2 0,2-1 0,0-1 0,0 3 0,0-5 0,0 5 0,0-3 0,-2 0 0,1 0 0,-3-1 0,2 0 0,-2-2 0,1 1 0,-3-1 0,3 0 0,-4-2 0,2 2 0,-1 1 0,-1-3 0,2 2 0,-2-2 0,1-4 0,0 4 0,-5-7 0,4 5 0,-3-5 0,4 7 0,-1-3 0,1 3 0,-1-1 0,5 3 0,-4-2 0,5 5 0,-2-4 0,1 4 0,0-5 0,-2 2 0,2 0 0,-1-2 0,4 5 0,-5-2 0,3 0 0,-1 1 0,1-3 0,0 3 0,4-1 0,-2 3 0,1-1 0,-3-2 0,3 3 0,0-3 0,0 2 0,0-2 0,-1 0 0,1-2 0,0 3 0,-1 1 0,1-2 0,0 3 0,-2-3 0,2 1 0,1-3 0,-2 3 0,3-2 0,-4 1 0,4 1 0,-4-2 0,5 2 0,-4-3 0,1 3 0,-3-3 0,3 3 0,-2-3 0,2 2 0,0-2 0,-2 0 0,2 1 0,1 0 0,-4-1 0,6 3 0,-3-1 0,0 1 0,2 0 0,-1-1 0,0-3 0,0 5 0,-1-7 0,-2 7 0,4-2 0,-1-2 0,2 3 0,-2-3 0,1 4 0,-1 0 0,0-2 0,2 2 0,-3-3 0,1 3 0,1-1 0,-1 0 0,2-1 0,0 1 0,0-1 0,0 0 0,0 2 0,0-5 0,0 6 0,0-3 0,0 0 0,0 1 0,0-1 0,0-2 0,0 3 0,0-3 0,0 5 0,0-3 0,0 1 0,0-1 0,0 1 0,0-3 0,0 2 0,0 0 0,0 2 0,0-3 0,0 2 0,0-3 0,0 1 0,0 3 0,0-2 0,0-1 0,0 3 0,0-1 0,0-1 0,0 2 0,5-1 0,-1 1 0</inkml:trace>
</inkml:ink>
</file>

<file path=ppt/ink/ink1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2"/>
    </inkml:context>
    <inkml:brush xml:id="br0">
      <inkml:brushProperty name="width" value="0.28222" units="cm"/>
      <inkml:brushProperty name="height" value="0.28222" units="cm"/>
      <inkml:brushProperty name="color" value="#FFFFFF"/>
    </inkml:brush>
  </inkml:definitions>
  <inkml:trace contextRef="#ctx0" brushRef="#br0">2107 1 24575,'-18'5'0,"-1"0"0,12 3 0,-3-3 0,1 4 0,-1-1 0,1 0 0,-11 13 0,8-10 0,-7 8 0,13-10 0,-5 0 0,4-1 0,-2 1 0,2-1 0,-3 2 0,2 0 0,-1 1 0,-2-1 0,6 0 0,-4 0 0,2-2 0,0 2 0,-1-2 0,3 0 0,-3 1 0,2-3 0,-2 3 0,3-4 0,0 2 0,0 1 0,0-4 0,-1 7 0,2-7 0,-2 7 0,1-7 0,-3 6 0,2-5 0,-2 5 0,4-3 0,-5 4 0,3-3 0,-4 0 0,1 0 0,1 0 0,-2 2 0,2-3 0,-1 4 0,-2-1 0,3-2 0,-6 2 0,2-2 0,-2 3 0,2-1 0,1 0 0,-4 5 0,-1-3 0,-1 3 0,3-4 0,3-4 0,0 3 0,-1-2 0,2 3 0,1-1 0,-1 0 0,1-1 0,1 1 0,-3 1 0,3-2 0,-1 0 0,-1-1 0,3 1 0,-3 2 0,4 0 0,-4-1 0,3 0 0,-3 0 0,1 0 0,1 0 0,-3 4 0,2-3 0,-3 2 0,1 0 0,0 1 0,-2 3 0,-5 11 0,4-5 0,-5 8 0,3-5 0,1-2 0,-4-1 0,5 0 0,-2-4 0,-1 6 0,5-11 0,-8 7 0,7-6 0,-2 2 0,3-3 0,1-1 0,0-2 0,-1 1 0,1-1 0,2 2 0,-2-2 0,2-1 0,-1 0 0,2-1 0,-3-1 0,5 0 0,-4 3 0,4-4 0,-5 3 0,5-4 0,-1 2 0,2 0 0,-4 0 0,4 2 0,-3-2 0,-3 7 0,4-4 0,-6 1 0,7 1 0,-4-4 0,3 5 0,-3-5 0,3 1 0,-3 1 0,4-1 0,-5 0 0,5 1 0,-2-4 0,1 2 0,0 0 0,-2 1 0,3 0 0,-3 0 0,2 0 0,0 0 0,-3 1 0,3 0 0,0-1 0,-2-2 0,3 0 0,-1 1 0,-1 1 0,1-2 0,-1 2 0,1-2 0,-2 6 0,-2-5 0,3 6 0,-1-7 0,2 2 0,0-1 0,-3 1 0,4-1 0,-4 0 0,1-1 0,1 0 0,0 1 0,-1-1 0,4 0 0,-5 1 0,5-3 0,-6 3 0,5 0 0,-5 0 0,5 1 0,-4 1 0,4-1 0,-5 0 0,5 3 0,-5-2 0,5 2 0,-5 0 0,5-1 0,-5 3 0,4 0 0,-1-2 0,-1 4 0,0-4 0,-1 4 0,-6 5 0,7-5 0,-6 2 0,9-2 0,-6-6 0,4 1 0,-1-2 0,-1 1 0,3-1 0,0 1 0,-1-4 0,1 3 0,-3-2 0,4-1 0,-1 1 0,-1-1 0,2 1 0,-5-1 0,5 0 0,-4 1 0,4-1 0,-4 2 0,4 0 0,-5-3 0,5 3 0,-2-3 0,0 4 0,2-5 0,-1 4 0,-1-3 0,0 8 0,-1-7 0,1 6 0,3-4 0,-1 1 0,1 0 0,0 1 0,-2-2 0,1 5 0,2-3 0,-3 5 0,2-5 0,0 2 0,-1 0 0,-1-2 0,4 6 0,-1-7 0,0 3 0,1-3 0,-2 0 0,5 1 0,-5-4 0,5 3 0,-3-5 0,1 2 0,1 0 0,-1 0 0</inkml:trace>
</inkml:ink>
</file>

<file path=ppt/ink/ink1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3"/>
    </inkml:context>
    <inkml:brush xml:id="br0">
      <inkml:brushProperty name="width" value="0.28222" units="cm"/>
      <inkml:brushProperty name="height" value="0.28222" units="cm"/>
      <inkml:brushProperty name="color" value="#FFFFFF"/>
    </inkml:brush>
  </inkml:definitions>
  <inkml:trace contextRef="#ctx0" brushRef="#br0">1371 0 24575,'-2'18'0,"-3"-4"0,-1-1 0,0-7 0,-2 9 0,0-6 0,-12 24 0,4-13 0,-4 10 0,7-15 0,8-4 0,-4-1 0,3-1 0,-1-1 0,1 2 0,-2-2 0,2 3 0,1-3 0,-1 0 0,1-2 0,0 4 0,0-5 0,-3 7 0,2-4 0,-1 2 0,1-4 0,4-1 0,-3 0 0,2 2 0,0-1 0,-1 0 0,1-1 0,0 3 0,-2-3 0,5 4 0,-4-4 0,1 5 0,0-5 0,-2 5 0,2-2 0,0 0 0,-2 2 0,2-4 0,0 5 0,-2-1 0,2-2 0,-2 2 0,1-3 0,0 1 0,1 1 0,0-1 0,-2 0 0,2 2 0,0-5 0,-1 9 0,1-8 0,-2 8 0,2-8 0,-3 4 0,6-5 0,-4 2 0,3 1 0,-1-5 0,-1 8 0,3-6 0,-6 5 0,6-5 0,-5 5 0,4-3 0,-3 0 0,4 3 0,-5-5 0,5 5 0,-5-5 0,4 6 0,-3-4 0,4 5 0,-6-4 0,6 4 0,-5-4 0,2-1 0,0 4 0,-1-5 0,3 2 0,-4 2 0,2-5 0,0 5 0,-1-5 0,4 3 0,-6-1 0,6-3 0,-5 4 0,2-1 0,-1-2 0,1 2 0,-3 1 0,3-3 0,0 5 0,0-5 0,0 1 0,-3-1 0,3 2 0,-1-1 0,2 1 0,-3-3 0,-1 4 0,3-3 0,-1 2 0,1 0 0,-2-2 0,-1 5 0,1-5 0,0 2 0,0 0 0,-1-1 0,2 1 0,-1-2 0,-2 1 0,3-1 0,-1 2 0,-1-2 0,4 3 0,-2-3 0,1 2 0,-3 0 0,1-1 0,1 0 0,-2 1 0,1-1 0,-1 3 0,1-3 0,0 4 0,0-3 0,0 0 0,-1 0 0,1 1 0,0-3 0,0 5 0,-1-5 0,1 2 0,2 1 0,-1-3 0,1 1 0,-2-1 0,-1-1 0,2 4 0,-1-3 0,2 2 0,-2-2 0,3 0 0,-3-1 0,-1 3 0,1-2 0,1 2 0,-1-3 0,2 1 0,-4 1 0,4 0 0,-4 0 0,1-3 0,2 1 0,-4 1 0,3-2 0,1 3 0,-4-4 0,5 0 0,-7 1 0,4-1 0,-2-2 0,-1 2 0,2-2 0,-2 0 0,0 0 0,4 0 0,-2 0 0,-2 0 0,4 2 0,-2-1 0,-3 1 0,3-2 0,-2 0 0,4 0 0,-6 0 0,6 0 0,-9 0 0,10 0 0,-5 0 0,3 0 0,0 0 0,-4 0 0,5 0 0,-3 0 0,1 0 0,1 0 0,-5 0 0,7 0 0,-4 0 0,0 0 0,2-2 0,-1 1 0,-3-1 0,4 0 0,-4 2 0,5-2 0,-1-1 0,0 1 0,0 0 0,-2 0 0,1 1 0,4-2 0,-6-2 0,6 2 0,-4-1 0,1 1 0,0-1 0,0-1 0,-1 3 0,2-3 0,0 3 0,0-3 0,0 1 0,0-3 0,0 2 0,-1-4 0,2 4 0,-2-3 0,3 1 0,-2-1 0,3 0 0,-3-1 0,-1 2 0,0-1 0,2-2 0,1 5 0,-3-2 0,4 2 0,-1 0 0,-3-2 0,2 3 0,-1-2 0,-1 1 0,5 0 0,-6-2 0,4 3 0,-3-2 0,2 1 0,1 0 0,-2-2 0,2 2 0,-1-1 0,-1 2 0,2-3 0,-1 2 0,1-1 0,1 0 0,-3 0 0,2-1 0,0 2 0,-2-1 0,2 1 0,0 1 0,-3-3 0,3 1 0,1 0 0,0-1 0,0 2 0,-1-2 0,-2 1 0,3 2 0,-1-3 0,0 0 0,1 2 0,0-2 0,-3 1 0,2 0 0,0 0 0,3-1 0,-2 2 0,1-1 0,-1 0 0,1 0 0,-2-2 0,-2 1 0</inkml:trace>
</inkml:ink>
</file>

<file path=ppt/ink/ink1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4"/>
    </inkml:context>
    <inkml:brush xml:id="br0">
      <inkml:brushProperty name="width" value="0.28222" units="cm"/>
      <inkml:brushProperty name="height" value="0.28222" units="cm"/>
      <inkml:brushProperty name="color" value="#FFFFFF"/>
    </inkml:brush>
  </inkml:definitions>
  <inkml:trace contextRef="#ctx0" brushRef="#br0">1183 674 24575,'-19'13'0,"1"0"0,7-3 0,-3 0 0,2 1 0,-2 0 0,0 0 0,-7 3 0,-7 3 0,8-4 0,0-1 0,11-7 0,-2 0 0,-2 2 0,2-2 0,-5 5 0,7-5 0,-3 2 0,3-2 0,1 0 0,-3 0 0,3-2 0,-1 1 0,0-3 0,-1 1 0,-3 0 0,2-2 0,-4 3 0,4-3 0,-3 2 0,2-1 0,-3 2 0,5-1 0,-1-2 0,2 3 0,-1-3 0,1 0 0,-1 0 0,-2 0 0,1 0 0,0 0 0,0 0 0,0 0 0,-5 0 0,3-3 0,-6 1 0,10-4 0,-7 1 0,6 1 0,-4-2 0,4-1 0,-2 1 0,1-2 0,0 4 0,0-2 0,1 1 0,0 2 0,1-2 0,0 2 0,-2 2 0,3-3 0,-3 0 0,3-1 0,0 1 0,-3 1 0,3-2 0,-1 2 0,-1 1 0,4-2 0,-1 1 0,-1 0 0,2-1 0,-1 1 0,-4-1 0,5 0 0,-3-1 0,3 0 0,2 0 0,-5 3 0,4-2 0,-2 1 0,1-4 0,1 2 0,1-3 0,-2 3 0,1 1 0,1 0 0,-2 0 0,1-1 0,0 0 0,0-2 0,0-1 0,-1 0 0,1-1 0,-1 0 0,1 0 0,-1-1 0,1-1 0,-1 1 0,0 0 0,2 2 0,-2-1 0,0 1 0,2 0 0,-1 1 0,-1-1 0,0 3 0,4-2 0,-2 0 0,-2 1 0,-1-5 0,3 3 0,-1 1 0,5 0 0,-5 1 0,2-3 0,-1 4 0,1-4 0,-2 3 0,4-3 0,-4 1 0,4 0 0,-3 1 0,-1 0 0,4 2 0,-4-5 0,4 3 0,-2-2 0,2 0 0,-4 1 0,2-1 0,-1 0 0,2 0 0,-1 1 0,3-3 0,-2 4 0,2-3 0,-2 3 0,1-4 0,-1-1 0,2 1 0,-3 1 0,3 1 0,-3 4 0,0-5 0,3 2 0,-4-2 0,3 2 0,-4-1 0,4 2 0,-3-4 0,3 1 0,-4 2 0,5-1 0,-3 0 0,3 3 0,-2-4 0,1 5 0,-1-3 0,2-1 0,0 3 0,0-3 0,0 4 0,0-1 0,0-1 0,0 0 0,0 0 0,0 0 0,0 2 0,0-3 0,0 2 0,0-1 0,0 2 0,0 0 0,0-3 0,0 3 0,0-2 0</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43:33.679"/>
    </inkml:context>
    <inkml:brush xml:id="br0">
      <inkml:brushProperty name="width" value="0.1" units="cm"/>
      <inkml:brushProperty name="height" value="0.1" units="cm"/>
      <inkml:brushProperty name="color" value="#F6630D"/>
    </inkml:brush>
  </inkml:definitions>
  <inkml:trace contextRef="#ctx0" brushRef="#br0">784 1984 24575,'-3'10'0,"1"-1"0,0-4 0,-1 0 0,-6 7 0,3-3 0,-6 3 0,9-5 0,-4-4 0,4 1 0,-2-3 0,3 3 0,-3-3 0,5 3 0,-5-3 0,3 3 0,-1-1 0,-2-1 0,5 3 0,-5-2 0,5 2 0,-5 0 0,3-3 0,-1 3 0,-1-2 0,3 1 0,-3 1 0,1 0 0,-2 0 0,2 0 0,-1 0 0,1-2 0,-2 1 0,2-1 0,-1 0 0,1 1 0,-2-1 0,0 2 0,0 0 0,3 0 0,-3-2 0,5 1 0,-5-1 0,3 2 0,-1 0 0,-1-1 0,3 1 0,-3-2 0,3 1 0,-1-1 0,0 2 0,1 0 0,-1 0 0,0 0 0,1 0 0,-3-1 0,4 1 0,-3 0 0,1 0 0,2 0 0,-5-2 0,5 1 0,-2-1 0,2 2 0,-3 0 0,3 0 0,-2 0 0,2 0 0,-3 0 0,3 0 0,-2 0 0,2 0 0,0 0 0,-3 0 0,3 0 0,-2 0 0,2 0 0,0 0 0,0-1 0,0 1 0,0 0 0,0 0 0,0 0 0,0 0 0,-3 0 0,3 0 0,-2 0 0,2 0 0,0 0 0,0 0 0,0-1 0,0 1 0,0 0 0,0 0 0,0 0 0,0 0 0,0 0 0,0 0 0,0 0 0,0 0 0,0 0 0,0 0 0,0 0 0,0 0 0,0 0 0,0 0 0,0 2 0,0-1 0,0 1 0,0-2 0,0 0 0,0 0 0,0 0 0,0 0 0,0 0 0,0 0 0,0 0 0,0 0 0,0 0 0,0 0 0,0 0 0,0 0 0,0 0 0,0 3 0,0-3 0,0 3 0,0-3 0,0 0 0,0 2 0,0-1 0,0 2 0,0-1 0,0-1 0,0 4 0,0-4 0,2 4 0,1-4 0,0 4 0,2-1 0,-2 2 0,2 0 0,0-3 0,1 2 0,-1-1 0,0-1 0,1 2 0,-1-2 0,0 1 0,1-2 0,-1 1 0,0-2 0,0 1 0,-2-2 0,1 3 0,-1-2 0,2 1 0,0-2 0,0 0 0,0 0 0,0 0 0,0 0 0,-2 0 0,4 2 0,-4-1 0,4 1 0,-4-2 0,1 0 0,-3 0 0,3-2 0,-1 1 0,2-4 0,-2 5 0,1-5 0,-1 5 0,1-3 0,1 1 0,0 1 0,0-3 0,0 1 0,0 0 0,0-1 0,0 1 0,-1-2 0,1 0 0,0 2 0,0-1 0,0 1 0,0-2 0,0 0 0,0 0 0,3 2 0,-2-1 0,1 1 0,1-2 0,-3 0 0,6 3 0,-6-3 0,6 3 0,-6-3 0,6 2 0,-3-1 0,3 1 0,0 1 0,0-3 0,-3 5 0,3-4 0,-3 3 0,3-3 0,-3 1 0,3-2 0,-6 3 0,6-3 0,-6 2 0,5-2 0,-4 3 0,2-3 0,-1 2 0,-1-2 0,2 0 0,-3 3 0,0-3 0,2 2 0,-2-2 0,2 0 0,-2 0 0,0 0 0,0 0 0,2 0 0,-1 0 0,8 0 0,-5 0 0,8 0 0,-6 0 0,4 0 0,-7 0 0,9-2 0,-10-1 0,12 1 0,-13-1 0,11 1 0,-11 2 0,8-5 0,-8 5 0,8-5 0,-8 2 0,7-2 0,-6 3 0,6-5 0,-7 6 0,10-8 0,-9 6 0,7-4 0,-9 4 0,2-1 0,0 3 0,-3-3 0,2 3 0,-1-3 0,3 1 0,0-2 0,-1 0 0,-2 3 0,0-1 0,0 1 0,-1 0 0,1-3 0,0 2 0,0-1 0,0 3 0,-1-3 0,1 1 0,2-2 0,-1 1 0,1-1 0,-2 2 0,0-1 0,-1 3 0,-1-3 0,2 3 0,-5-3 0,5 3 0,-5-3 0,5 3 0,-3-3 0,3 1 0,0 0 0,0-1 0,0 1 0,0-1 0,-1 1 0,1-1 0,0 3 0,0-3 0,0 1 0,0 0 0,-2-1 0,1 3 0,-1-3 0,2 1 0,0 0 0,-2-1 0,1 1 0,-1-2 0,2 0 0,0 0 0,0 0 0,0 0 0,0 0 0,0 0 0,-1 0 0,1 0 0,0 0 0,1-2 0,-1 1 0,3-2 0,-3 3 0,3 0 0,-3 0 0,2 0 0,-1 0 0,2 0 0,-3 0 0,0 0 0,0 0 0,0 2 0,-1-1 0,1 1 0,0-2 0,-2 0 0,1 2 0,-1-1 0,0 1 0,1-2 0,-1 0 0,0 1 0,1-1 0,-3 0 0,3 0 0,-1 0 0,2 0 0,-3 0 0,3 0 0,-2 0 0,2-3 0,0 3 0,-2-3 0,1 0 0,-1 3 0,3-6 0,-1 3 0,0 0 0,-2-3 0,2 6 0,-2-6 0,2 6 0,0-6 0,-2 6 0,2-5 0,-5 4 0,5-4 0,-2 4 0,0-4 0,2 4 0,-5-4 0,2 4 0,-2-4 0,3 4 0,-3-2 0,2 1 0,-2 1 0,0-4 0,0 4 0,0-4 0,0 4 0,3-4 0,-3 4 0,3-4 0,-3 4 0,0-1 0,0-1 0,0 2 0,2-4 0,-1 4 0,1-1 0,-2-1 0,0 2 0,0-4 0,0 4 0,2-1 0,-1-1 0,1 3 0,-2-3 0,0 0 0,0 3 0,3-6 0,-3 6 0,3-6 0,-3 6 0,2-6 0,-1 6 0,1-8 0,-2 7 0,0-6 0,0 6 0,0-4 0,0 4 0,0-4 0,0 4 0,3-4 0,-3 1 0,3 1 0,-3-2 0,0 1 0,0 1 0,0-2 0,0 1 0,0 1 0,2-2 0,-1 1 0,1 1 0,-2-2 0,0 4 0,3-4 0,-3 4 0,3-4 0,-3 4 0,2-4 0,-1 2 0,1-1 0,1-1 0,-3 2 0,3-1 0,-1-1 0,-1 2 0,1-3 0,-2 2 0,3-1 0,-3 2 0,3-1 0,-1-1 0,-1 2 0,1 0 0,-2-3 0,0 6 0,0-6 0,0 3 0,0-3 0,0 0 0,0 0 0,0 0 0,0 0 0,0 0 0,0 0 0,0 3 0,0-3 0,0 3 0,0-3 0,0 0 0,0 3 0,0-3 0,0 3 0,0 0 0,0-3 0,0 3 0,0 0 0,3-5 0,-3 4 0,3-1 0,-3 0 0,0 1 0,0 1 0,0-2 0,2 1 0,-1 1 0,1-2 0,-2 4 0,0-4 0,0 4 0,0-4 0,0 1 0,0 1 0,0 0 0,0 1 0,0 1 0,0-4 0,2 4 0,-1-4 0,1 4 0,-2-4 0,0 2 0,0-3 0,0 0 0,0 0 0,0 2 0,0-1 0,0 2 0,0-3 0,0 0 0,0 0 0,0 0 0,0 2 0,0-1 0,0 2 0,0-3 0,0 2 0,0-1 0,0 4 0,0-4 0,0 4 0,0-4 0,0 2 0,0 0 0,0-3 0,0 6 0,0-6 0,0 3 0,-2-3 0,1 0 0,-1 0 0,-1 0 0,3 0 0,-3 3 0,1-2 0,1 1 0,-1-2 0,2 0 0,-2 3 0,1-2 0,-1 1 0,-1-2 0,3 0 0,-5 3 0,5-2 0,-5 1 0,4 1 0,-4-2 0,2 1 0,-2 1 0,0-2 0,-1-1 0,1 0 0,-1-2 0,1 4 0,0-1 0,0 4 0,-1-4 0,3 4 0,-1-1 0,3 2 0,-3 0 0,3 0 0,-3 2 0,3-1 0,-3 1 0,3-2 0,-3 0 0,1 0 0,-2 0 0,3 0 0,-3 0 0,5 1 0,-4-1 0,1 0 0,-2 0 0,2 0 0,-1 0 0,3 0 0,-3 2 0,1-1 0,-2 1 0,2-2 0,-1 0 0,1 3 0,-2-3 0,3 2 0,-3-2 0,2 0 0,-2 0 0,0 0 0,0 1 0,0-1 0,-2-1 0,1 1 0,-1 0 0,1-3 0,1 3 0,0-3 0,0 3 0,0 0 0,0 0 0,0 0 0,0 0 0,0 0 0,0 0 0,0 0 0,0 0 0,0 1 0,1-1 0,-1 0 0,0 0 0,0 0 0,-1-3 0,-1 2 0,3-2 0,-3 3 0,4 0 0,-2-2 0,0 1 0,0-2 0,0 3 0,0 0 0,2 0 0,-1 0 0,1 3 0,0-3 0,-1 3 0,1-3 0,-2 0 0,2 0 0,-1 2 0,1-1 0,-2 3 0,2-3 0,-1 3 0,1-3 0,-2 1 0,0 0 0,1 1 0,1 0 0,-2 1 0,5-3 0,-5 3 0,3-1 0,-3 0 0,0 1 0,0-3 0,0 3 0,0-3 0,0 3 0,0-3 0,0 1 0,0 1 0,0-3 0,-3 5 0,3-5 0,-6 2 0,6-2 0,-6 0 0,3 2 0,0-2 0,-3 2 0,3-2 0,0 0 0,-2 2 0,4-2 0,-4 2 0,4-2 0,-2 0 0,1 0 0,-1-2 0,0 3 0,0-3 0,4 7 0,-1-4 0,0 3 0,0-3 0,2 1 0,-2 0 0,3-1 0,-3 3 0,2-3 0,-1 1 0,1-2 0,0 0 0,1 0 0,0 3 0,1-3 0,-1 3 0,2-3 0,-2 0 0,1 1 0,-1-1 0,0 0 0,2 0 0,-5 0 0,5 1 0,-4-1 0,1 2 0,0-1 0,-1 1 0,1 0 0,0-1 0,-1 1 0,1 0 0,-2-1 0,0 1 0,0 0 0,0-1 0,0 3 0,0-3 0,0 1 0,-2 0 0,1-1 0,-2 3 0,3-3 0,0 3 0,0-3 0,0 3 0,3-3 0,-3 3 0,2-3 0,-1 4 0,1-5 0,-1 5 0,3-5 0,-3 5 0,-1-3 0,0 3 0,-1-2 0,1 2 0,0-5 0,-3 2 0,2-2 0,-4 2 0,2-1 0,-3 1 0,0-3 0,3 1 0,-3-1 0,3 1 0,-3 2 0,0-2 0,0 4 0,3-3 0,-3 3 0,6-3 0,-6 3 0,6-3 0,-3 3 0,3-1 0,0 2 0,0 0 0,0 0 0,0 0 0,0 0 0,0 0 0,3-2 0,-3 1 0,3-1 0,-3 2 0,0 0 0,0 0 0,0 0 0,0-2 0,1 2 0,-1-3 0,0 3 0,0 0 0,1 0 0,-1 0 0,0 0 0,0 0 0,-3 0 0,3 0 0,-6-2 0,6 1 0,-6-1 0,6 2 0,-6 0 0,3 0 0,0 0 0,-3 0 0,3 0 0,-3 0 0,0 0 0,3 0 0,-3 0 0,3 0 0,-3 0 0,3 0 0,-2 0 0,4 0 0,-4 0 0,4 0 0,-2 0 0,1 2 0,1-1 0,-4 4 0,4-4 0,-2 3 0,1-3 0,1 3 0,-4-3 0,4 3 0,-1-3 0,-1 3 0,2-1 0,-1 2 0,-1-2 0,2 1 0,-1-3 0,-1 4 0,2-5 0,-6 5 0,6-2 0,-4-1 0,5 3 0,0-5 0,0 5 0,0-5 0,0 5 0,-2-5 0,1 5 0,-1-5 0,0 5 0,1-4 0,-2 3 0,3-3 0,0 3 0,0-1 0,-2 2 0,1-2 0,-1 1 0,-1-1 0,2 3 0,-1-1 0,-1 0 0,3 0 0,-6 0 0,6 0 0,-5 1 0,4-1 0,-4 0 0,4 3 0,-5-2 0,5 2 0,-4-3 0,4 3 0,-2-2 0,3 1 0,-2-1 0,1 1 0,-5-1 0,0 7 0,2-4 0,-4 2 0,5 0 0,0-5 0,-3 4 0,5-2 0,-4 1 0,4 1 0,-5-4 0,5 5 0,-4-5 0,4 2 0,-4-3 0,4 3 0,-4-2 0,4 4 0,-5-4 0,5 2 0,-4-3 0,4 3 0,-2-2 0,3 2 0,0-3 0,0 2 0,0-1 0,0 1 0,0 1 0,2-2 0,0 4 0,3-4 0,0 4 0,0-4 0,0 4 0,0 3 0,3-1 0,5 5 0,2-3 0,5-2 0,-4 6 0,1-7 0,-1 4 0,0-4 0,0 0 0,0 0 0,0-3 0,-3 0 0,3 0 0,-3-3 0,3 3 0,0-2 0,-3-1 0,2 0 0,-4 1 0,4-1 0,-4 0 0,2 0 0,-3 0 0,0 0 0,0 0 0,-1 0 0,1 0 0,0 0 0,0 0 0,0 2 0,-2-1 0,-1 1 0,1-2 0,-3 0 0,2 0 0,-2 0 0,2 0 0,-1 0 0,1-1 0,0 1 0,1 0 0,0 0 0,1 0 0,-3 0 0,3-1 0,-2 1 0,3 0 0,0 0 0,-1-1 0,1 1 0,0-2 0,-2 1 0,1-1 0,-1 0 0,0 1 0,1-4 0,-4 5 0,5-5 0,-2 5 0,2-2 0,-1-1 0,-1 3 0,1-5 0,-1 2 0,0 1 0,1-3 0,-1 2 0,2-2 0,-1 0 0,1 0 0,0 2 0,0-1 0,0 1 0,0-2 0,-1 2 0,1 1 0,0 0 0,0 1 0,0-1 0,0 2 0,0 0 0,0 0 0,0 0 0,0 0 0,0 0 0,0 0 0,0 0 0,0 0 0,0 0 0,-3-1 0,3 1 0,-5 0 0,3 0 0,-1 0 0,-2 0 0,3 0 0,-3 5 0,0-4 0,0 11 0,0-10 0,0 12 0,0-13 0,0 13 0,0-10 0,0 14 0,0-13 0,0 15 0,0-15 0,0 12 0,0-10 0,0 8 0,0-11 0,0 10 0,0-12 0,0 10 0,0-11 0,0 8 0,0-8 0,0 7 0,0-7 0,4 8 0,-3-8 0,10 11 0,-7-8 0,11 11 0,-9-11 0,8 10 0,-7-9 0,10 10 0,-8-8 0,9 8 0,-9-11 0,5 8 0,-8-8 0,8 10 0,-7-6 0,5 9 0,-8-10 0,5 10 0,-6-12 0,7 15 0,-6-15 0,3 12 0,-7-10 0,5 8 0,-2-8 0,0 6 0,1-10 0,-3 2 0,1-3 0,0 5 0,-1-3 0,1 7 0,-2-10 0,0 5 0,0-5 0,0 5 0,0-5 0,0 6 0,0-7 0,0 7 0,0-6 0,0 7 0,0-7 0,0 8 0,0-8 0,0 10 0,0-9 0,0 7 0,0-9 0,2 4 0,-1-3 0,1 1 0,-2-3 0,2 1 0,-1 0 0,1 0 0,0-1 0,-2 1 0,2 0 0,-2-20 0,0 12 0,0-15 0</inkml:trace>
</inkml:ink>
</file>

<file path=ppt/ink/ink2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5"/>
    </inkml:context>
    <inkml:brush xml:id="br0">
      <inkml:brushProperty name="width" value="0.28222" units="cm"/>
      <inkml:brushProperty name="height" value="0.28222" units="cm"/>
      <inkml:brushProperty name="color" value="#FFFFFF"/>
    </inkml:brush>
  </inkml:definitions>
  <inkml:trace contextRef="#ctx0" brushRef="#br0">2011 733 24575,'-25'0'0,"-3"0"0,9 0 0,-6 0 0,6 0 0,0 0 0,-15 0 0,1 0 0,-2 3 0,5-2 0,19 3 0,-5-1 0,3 3 0,1-1 0,-2 0 0,2-2 0,2 1 0,0-4 0,1 5 0,0-2 0,-2 2 0,3 0 0,-3-2 0,3 1 0,0-1 0,-3 2 0,6 0 0,-6 0 0,3-2 0,0 1 0,-3-1 0,3 1 0,-4 1 0,4 0 0,-7 3 0,8-3 0,-9 5 0,8-5 0,-3 3 0,0-1 0,1-2 0,-2 3 0,1-1 0,1-1 0,-3 1 0,6 1 0,-4-2 0,2 2 0,-2-2 0,0-1 0,2 3 0,0-1 0,-1-1 0,0 1 0,1-2 0,-1 1 0,2-2 0,-4 1 0,2 0 0,-2 0 0,1 1 0,1-2 0,-2 0 0,2 0 0,-2-1 0,1 0 0,-5 4 0,4-6 0,-4 6 0,1-6 0,4 1 0,-3 0 0,-1-2 0,3 3 0,-5-1 0,6-2 0,-7 3 0,6-3 0,-5 0 0,5 0 0,-2 0 0,3 2 0,0-2 0,-3 3 0,1-3 0,-1 0 0,1 0 0,2 0 0,-3 0 0,6 0 0,-3 0 0,4 0 0,-6 0 0,3 0 0,0 0 0,0 0 0,1 0 0,-1 0 0,3 0 0,-4 0 0,5 0 0,-1 0 0,-2 0 0,4-2 0,-2-1 0,1-1 0,2 0 0,-4-1 0,2 0 0,-1 0 0,1 1 0,-1-1 0,2 0 0,-4-2 0,2 1 0,1-4 0,-3 5 0,2-4 0,1 3 0,-4-1 0,4 0 0,-2 1 0,0-4 0,2 5 0,-4-4 0,1 1 0,2 1 0,-4-3 0,3 4 0,-1-3 0,-4-2 0,4 4 0,-5-4 0,6 4 0,0 1 0,0-1 0,2-1 0,-4 3 0,4-4 0,-5 3 0,6-3 0,-4 3 0,1-4 0,3 5 0,-6-5 0,6 3 0,-6-3 0,6 2 0,-6-2 0,5 2 0,-5-2 0,5-1 0,-1 2 0,-2-1 0,3 0 0,-2-1 0,3 3 0,0-1 0,-1 1 0,3 0 0,-2-1 0,3 3 0,-1-3 0,-2 3 0,1-4 0,2 6 0,-2-6 0,1 3 0,-4-2 0,2 0 0,2 1 0,-1-2 0,-2 0 0,0 2 0,1-2 0,0 5 0,2-5 0,-3 5 0,2-4 0,-1 4 0,-1-3 0,1 2 0,0 0 0,0-4 0,-1 5 0,-1-5 0,1 4 0,-2-3 0,0 0 0,2 1 0,-5-1 0,5 0 0,-4 1 0,1 1 0,1-3 0,0 2 0,0-2 0,1-1 0,-2 0 0,2 2 0,-2-2 0,5 1 0,-4-2 0,4 1 0,-3-1 0,6 2 0,-4-1 0,5 1 0,-3 2 0,1-1 0,1 4 0,-1-2 0,2 0 0,0 2 0,0-4 0,0 4 0,0-2 0,0 0 0,0 2 0,0-3 0,0 3 0,0-2 0,0 1 0,0 1 0,0-4 0,0 4 0,0-2 0,0 0 0,0 4 0,0-6 0,-2 4 0,2-2 0,-3 0 0,3 2 0,-2-3 0,1 2 0,-1-1 0,2 2 0,0 0 0,0-3 0,0 2 0,0 0 0</inkml:trace>
</inkml:ink>
</file>

<file path=ppt/ink/ink2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6"/>
    </inkml:context>
    <inkml:brush xml:id="br0">
      <inkml:brushProperty name="width" value="0.28222" units="cm"/>
      <inkml:brushProperty name="height" value="0.28222" units="cm"/>
      <inkml:brushProperty name="color" value="#FFFFFF"/>
    </inkml:brush>
  </inkml:definitions>
  <inkml:trace contextRef="#ctx0" brushRef="#br0">2786 710 24575,'-27'0'0,"3"0"0,10 0 0,3 3 0,-7 0 0,3 5 0,-1-2 0,-10 12 0,9-8 0,-9 7 0,12-8 0,3 0 0,3-1 0,-3 0 0,2 2 0,-1-5 0,0 5 0,1-4 0,2 3 0,-3-2 0,4-1 0,-2 2 0,0-2 0,2 0 0,-1 1 0,1-1 0,-2 1 0,3-2 0,-4 2 0,-3 1 0,5 0 0,-8-1 0,6-3 0,1 2 0,-3-1 0,3-1 0,-3 2 0,3-1 0,-2 0 0,1 0 0,-2 0 0,0 1 0,0-2 0,0 3 0,0-1 0,0 2 0,2-4 0,-1 2 0,1-1 0,-1-1 0,-2 2 0,1-1 0,3 0 0,-2 0 0,4-1 0,-5 1 0,6 0 0,-5 0 0,3 0 0,-2 0 0,3 0 0,-6-1 0,5 1 0,-3 0 0,2-1 0,2 1 0,-1 0 0,-1 0 0,3 0 0,-3-1 0,2-1 0,2 1 0,-4-1 0,2 0 0,0 1 0,0-2 0,1 1 0,-2 3 0,-2-4 0,1 3 0,1-3 0,2 1 0,-1 1 0,0-3 0,0 3 0,-5-3 0,6 1 0,-6-2 0,3 2 0,0-1 0,-3 1 0,3-2 0,-7 0 0,3 0 0,-1 0 0,-1 0 0,1 0 0,-5 0 0,4 0 0,-1 0 0,-2 0 0,5 0 0,-6 0 0,6 2 0,-5-2 0,5 3 0,-2-3 0,3 2 0,-1-1 0,4 1 0,-2-2 0,1 0 0,1 3 0,-3-3 0,6 2 0,-6-2 0,5 0 0,-1 0 0,-1 0 0,3 0 0,-3 0 0,0 0 0,3 0 0,-8 2 0,7-2 0,-7 2 0,8-2 0,-6 0 0,5 2 0,-4-1 0,2 1 0,-1-2 0,-1 0 0,1 0 0,-1 0 0,-2 3 0,1-3 0,1 3 0,-5-3 0,3 0 0,-2 0 0,0 0 0,1 0 0,0 0 0,-1 0 0,2 0 0,-3 0 0,1 0 0,3 0 0,-4 0 0,4 0 0,-4 0 0,4 0 0,-4 0 0,4 0 0,1 0 0,-2 0 0,-7 0 0,6 0 0,-6 0 0,8-3 0,0 3 0,0-5 0,0 2 0,-1 0 0,-2-2 0,3 2 0,-6 0 0,1-4 0,-3 3 0,1-4 0,0 2 0,0 1 0,0 0 0,0-3 0,3 2 0,-2-3 0,1 4 0,-2-3 0,3 2 0,-2-3 0,5 5 0,-6-2 0,6-2 0,-1 3 0,-3-7 0,3 5 0,-3-5 0,8 7 0,0-2 0,1 0 0,1 1 0,-2 0 0,3 1 0,1 0 0,-2 0 0,1 0 0,1-2 0,-2 3 0,0-3 0,-1 2 0,1-3 0,-2 3 0,4-3 0,-5 2 0,3 0 0,-1-1 0,-1 1 0,3 0 0,-6-4 0,3 3 0,-3-4 0,0 1 0,0 0 0,-4-1 0,0 1 0,0-1 0,-11-9 0,8 4 0,-6-3 0,5 1 0,4 7 0,-1-6 0,1 5 0,4-1 0,0 2 0,2 2 0,-1 1 0,4-2 0,-3 2 0,5 1 0,-4-4 0,1 5 0,-1-5 0,0 1 0,3 0 0,-3-1 0,1 0 0,3 2 0,-2 2 0,1-4 0,0 6 0,0-2 0,2 0 0,-2 1 0,2-2 0,-2-1 0,0-3 0,-1 1 0,1-1 0,-1 1 0,1 2 0,2-1 0,-2-1 0,5 3 0,-6-1 0,3 1 0,0-2 0,-1 0 0,1-1 0,-1 1 0,-1 0 0,2 1 0,0-2 0,-1 3 0,3-2 0,-4 2 0,5 0 0,-6-1 0,6 4 0,-2-4 0,0 3 0,1-1 0,-3 1 0,3 0 0,-1-1 0,-1 0 0,3 3 0,-3-3 0,1-2 0,0 3 0,-1-3 0,-2 5 0,5-4 0,-3 3 0,1-3 0,1 2 0,-3-1 0,3-1 0,-1 2 0,0-2 0,1 3 0,-2-3 0,0 1 0,3 3 0,-3-4 0,1 1 0,2 3 0,-2-3 0,0 0 0,1 2 0,-1-2 0,-1 0 0,3 3 0,-5-3 0,4 1 0,-1 1 0,1-2 0,1 0 0,-3 2 0,3-4 0,0 4 0,0-1 0,0-1 0,0 3 0,-2-5 0,-1 2 0</inkml:trace>
</inkml:ink>
</file>

<file path=ppt/ink/ink2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7"/>
    </inkml:context>
    <inkml:brush xml:id="br0">
      <inkml:brushProperty name="width" value="0.28222" units="cm"/>
      <inkml:brushProperty name="height" value="0.28222" units="cm"/>
      <inkml:brushProperty name="color" value="#FFFFFF"/>
    </inkml:brush>
  </inkml:definitions>
  <inkml:trace contextRef="#ctx0" brushRef="#br0">721 1 24575,'-19'7'0,"5"-3"0,6 5 0,0-6 0,2 4 0,-4 0 0,1-1 0,-11 10 0,7-6 0,-8 5 0,10-7 0,3-2 0,-3 1 0,3-2 0,-3 3 0,0-3 0,0 3 0,0-3 0,2 2 0,-2-2 0,2 3 0,2-3 0,-4 3 0,6-3 0,-6 2 0,3 1 0,-3-2 0,3 0 0,-3 1 0,3-2 0,-3 6 0,-4-5 0,4 3 0,-4-3 0,2 4 0,0-2 0,-4 3 0,5-2 0,-5 1 0,4-4 0,-1 4 0,3-5 0,0 3 0,3-3 0,-3 0 0,6 0 0,-6 0 0,4 1 0,-2 0 0,3 1 0,0-2 0,1-2 0,0 1 0,3 3 0,0-2 0,2 4 0,0-4 0,4 1 0,2 0 0,5-1 0,4 0 0,0 2 0,3-1 0,0 3 0,4-1 0,-3-1 0,3 2 0,0-3 0,-3 0 0,3-2 0,-3 2 0,-5-3 0,3 2 0,-5-4 0,3 2 0,-4-3 0,0 0 0,0 0 0,0 0 0,1 0 0,-5 0 0,4 0 0,-5 0 0,1 0 0,3 0 0,-4 0 0,4 0 0,-5 0 0,3 0 0,-4-4 0,1-2 0,-5-4 0,0 4 0,-3-7 0,1 4 0,1-4 0,-1 2 0,2 2 0,0-1 0,0-1 0,0 3 0,0-2 0,0 5 0,0-2 0,0 1 0,0-2 0,0 1 0,0-1 0,0 1 0,0 2 0,0-2 0,0 0 0,0 2 0,0-3 0,0 3 0,0-2 0,0 1 0,0 0 0,0-3 0,0 5 0,0-3 0,0 1 0,-2 0 0,1 25 0,-1-8 0,2 19 0,0-14 0,0-2 0,0 3 0,0-3 0,0-1 0,0-3 0,0 0 0,0-2 0,0 2 0,0-5 0,0 4 0,0-4 0,0 3 0,-5-1 0,1-2 0,0 1 0,0-1 0,0 0 0,-1 0 0,1-1 0,-2 0 0,2 1 0,-2 0 0,2 0 0,-1-1 0,-1 0 0,2 1 0,-1 0 0,-1 0 0,1-1 0,-2 1 0,1 0 0,-1-1 0,1 1 0,1-1 0,1 1 0,-4 2 0,2-4 0,-1 4 0,2-5 0,0 3 0,-1 0 0,2 0 0,-4-1 0,1 0 0,1 1 0,0 0 0,1-3 0,-2 4 0,1-3 0,-1 2 0,3-1 0,-1 1 0,-1-2 0,2 3 0,-1-1 0,-1 0 0,1 1 0,1-1 0,1-1 0,-4 3 0,4-1 0,-4 0 0,2-1 0,-1 0 0,2 0 0,-4-1 0,2 0 0,-1 0 0,1 1 0,1 0 0,1 0 0,-2-1 0,1 1 0,0 0 0,-1 0 0,2-1 0,-3 1 0,3-1 0,-2 1 0,-2-1 0,4 1 0,-1-1 0,0 1 0,-2-1 0,1 1 0,-2-2 0,4 1 0,-1 1 0,0-2 0,0 3 0,0-3 0,0 2 0,-3-2 0,3 2 0,-2-3 0,1 2 0,2-1 0,-1 2 0,-2 0 0,2-3 0,-3 2 0,3-1 0,-2 2 0,1 0 0,-1-1 0,3 1 0,-2-3 0,-1 3 0,4-2 0,-3 2 0,-1-5 0,0-8 0,0-3 0,5-3 0,2 5 0,0 4 0</inkml:trace>
</inkml:ink>
</file>

<file path=ppt/ink/ink2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8"/>
    </inkml:context>
    <inkml:brush xml:id="br0">
      <inkml:brushProperty name="width" value="0.28222" units="cm"/>
      <inkml:brushProperty name="height" value="0.28222" units="cm"/>
      <inkml:brushProperty name="color" value="#FFFFFF"/>
    </inkml:brush>
  </inkml:definitions>
  <inkml:trace contextRef="#ctx0" brushRef="#br0">604 1 24575,'-16'5'0,"-1"5"0,7-5 0,1 3 0,-2 1 0,5-3 0,-8 7 0,5-5 0,-7 8 0,12-9 0,-5 2 0,7-6 0,-3 1 0,-1 1 0,1-3 0,1 5 0,-1-5 0,0 3 0,-1-1 0,2 1 0,-1 0 0,-2-1 0,4 0 0,-6 0 0,6 1 0,-4-2 0,-1 2 0,3-3 0,-2 4 0,3-4 0,-2 1 0,1 3 0,-2-4 0,1 5 0,2-3 0,-1 0 0,2 0 0,-4-1 0,2 3 0,1-5 0,-2 5 0,1-1 0,1-2 0,-2 3 0,2-4 0,-3 3 0,2-2 0,-2 0 0,2 0 0,1 2 0,-4-2 0,3 2 0,-2-1 0,2-1 0,0 1 0,-1-2 0,2 3 0,-5 0 0,7-1 0,-6-1 0,0 1 0,6-2 0,-5 3 0,1-2 0,1 1 0,-2-2 0,2 2 0,0 1 0,0-1 0,0 1 0,3 1 0,-3 0 0,3 0 0,-3-1 0,0-1 0,0 1 0,1-1 0,-1 0 0,-1 0 0,2 1 0,0 0 0,-2-1 0,-1-2 0,2 3 0,-2-3 0,2 3 0,1 0 0,-2 0 0,2-1 0,-2 0 0,3 1 0,-3-2 0,1 2 0,0 0 0,1 0 0,-1-1 0,-3 0 0,4-1 0,-4 1 0,4-1 0,-1 1 0,1 3 0,1-2 0,1 0 0</inkml:trace>
</inkml:ink>
</file>

<file path=ppt/ink/ink2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49"/>
    </inkml:context>
    <inkml:brush xml:id="br0">
      <inkml:brushProperty name="width" value="0.28222" units="cm"/>
      <inkml:brushProperty name="height" value="0.28222" units="cm"/>
      <inkml:brushProperty name="color" value="#FFFFFF"/>
    </inkml:brush>
  </inkml:definitions>
  <inkml:trace contextRef="#ctx0" brushRef="#br0">0 765 24575,'10'15'0,"0"-2"0,-2-6 0,-2-1 0,2 1 0,-3 0 0,8 4 0,-4 0 0,6 6 0,-7-9 0,0 1 0,-4-5 0,1 4 0,1-3 0,-2 2 0,5 2 0,-4-3 0,2 3 0,-1-1 0,-1-4 0,-2 3 0,1-2 0,-1 0 0,2-1 0,0 3 0,0-1 0,-2 1 0,1-3 0,-1 0 0,1 1 0,1-1 0,1 1 0,-1-1 0,-1 1 0,1-1 0,0 1 0,1 0 0,-2 0 0,1-1 0,1 1 0,0-1 0,0 1 0,1-1 0,-2-1 0,0 1 0,3-2 0,-3 3 0,2 0 0,-1 0 0,-2-1 0,1 1 0,0-1 0,0 1 0,0 0 0,3 0 0,-2-1 0,1-1 0,19 16 0,-17-13 0,18 14 0,-22-16 0,-1 1 0,1-2 0,1 2 0,-2 0 0,4 2 0,-2-4 0,0 3 0,2-3 0,-2 2 0,1 0 0,-1-1 0,-1 1 0,-1 0 0,4-1 0,-2 0 0,1-1 0,-2 1 0,1-1 0,3 2 0,1 0 0,-1 0 0,2 0 0,-3 0 0,3 1 0,1-2 0,-5 1 0,5 0 0,-5-1 0,5 2 0,-4-1 0,3 0 0,-3 0 0,3 0 0,-3 0 0,3 3 0,-3-3 0,3 2 0,-2-2 0,0 0 0,-2 0 0,3 0 0,-2 0 0,1 0 0,1 0 0,-4 0 0,4 0 0,-4-1 0,4 0 0,-4-1 0,4 0 0,-1 1 0,-2 1 0,5 1 0,-5-2 0,2 2 0,1-1 0,-4-3 0,3 3 0,-3-5 0,0 4 0,4 0 0,-4-2 0,4 1 0,-4 0 0,5 3 0,-1-2 0,-1-1 0,4 1 0,-7-3 0,4 4 0,-4-3 0,4 1 0,-4 1 0,4-3 0,-1 1 0,-1 0 0,3-1 0,-3 1 0,0 0 0,2-2 0,-1 4 0,1-3 0,2 4 0,-1-4 0,0 2 0,0-3 0,0 5 0,0-2 0,0 0 0,-3 1 0,3-3 0,-4 3 0,3-3 0,5 4 0,-8-3 0,8 1 0,-9 1 0,4-3 0,-4 3 0,2-3 0,-1 3 0,2-4 0,-1 4 0,2 0 0,-1-2 0,-1 2 0,3-4 0,-6 4 0,6-3 0,-3 3 0,0-1 0,3 0 0,-3 1 0,0-4 0,3 5 0,-5-4 0,4 1 0,-4 1 0,0-3 0,3 4 0,-3-3 0,4 3 0,-4-3 0,3 4 0,-2-5 0,3 5 0,-5-4 0,8 2 0,-4-2 0,2 3 0,-4-4 0,1 5 0,-2-4 0,4 1 0,-4-2 0,2 2 0,-1-1 0,-1 1 0,1-2 0,1 2 0,-2-2 0,5 3 0,-6-1 0,5-2 0,-4 3 0,4-3 0,-1 2 0,-1-1 0,2 1 0,-3 0 0,3-2 0,0 4 0,2-3 0,-2 2 0,1-3 0,-3 0 0,1 0 0,1 2 0,-4-1 0,4 1 0,-4-2 0,4 0 0,-4 0 0,4 0 0,-4 0 0,2 0 0,-1 0 0,2 2 0,-2-1 0,5 1 0,-7-2 0,6 0 0,-5 0 0,3 0 0,-2 0 0,2 0 0,-3 0 0,4 0 0,-4 0 0,5 0 0,-3 0 0,3 0 0,1 0 0,-5 0 0,4 0 0,-3 0 0,3 0 0,1-2 0,-2-1 0,4-2 0,-3 2 0,3-2 0,-3 3 0,0-1 0,-1-2 0,2 4 0,-1-3 0,0 4 0,2-7 0,-4 5 0,4-2 0,-8 2 0,6 2 0,-5-4 0,1 3 0,-1-2 0,0 0 0,0 0 0,3-1 0,-5 2 0,1-3 0,3-1 0,-3 4 0,4-3 0,-2 3 0,-2-3 0,4 0 0,-3 0 0,1 3 0,1-3 0,-1 3 0,-1-3 0,4 0 0,-4 0 0,6 0 0,-6 1 0,4-1 0,-5 2 0,4-2 0,-4 3 0,3-1 0,-3-1 0,2 1 0,-1-2 0,2 2 0,-4 0 0,5-1 0,-4 1 0,3 0 0,-3-1 0,0 2 0,2-4 0,-1 3 0,2-1 0,-3 2 0,0-1 0,2-3 0,-2 5 0,3-6 0,-4 5 0,2-2 0,-1 0 0,3-1 0,-3 0 0,2 0 0,-2 0 0,4-3 0,-2 2 0,6-5 0,0-3 0,17-15 0,-10 7 0,10-6 0,-1 2 0,-11 13 0,23-21 0,-35 31 0,20-13 0,12-7 0,-4 2 0,3-2 0,-30 17 0,6-4 0,-7 3 0,4 1 0,-4-2 0,4 5 0,-4-2 0,2 0 0,0 0 0,-2 0 0,0 0 0,0 0 0,2-1 0,-4 0 0,5-1 0,-1 1 0,-3 0 0,6-1 0,-6-1 0,4 3 0,-2-3 0,-1 2 0,2-1 0,-1 0 0,-1 3 0,3-1 0,-5-1 0,1 0 0,1-1 0,-2 2 0,1-2 0,1 2 0,0-3 0,-2 3 0,1 2 0,2-2 0,-1 1 0,1-1 0,-4 0 0,1 0 0,1-1 0,1 2 0,-1-2 0,2 1 0,-4 0 0,4 0 0,-4 0 0,3 0 0,-2-2 0,4 2 0,-6-2 0,2 2 0,-1 1 0,2-1 0,0 1 0,0-3 0,0 2 0,-2-1 0,2 1 0,-3-2 0,1 1 0,1 0 0,-3-2 0,4 3 0,-2-5 0,1 6 0,-1-6 0,2 5 0,-1-5 0,-2 5 0,2-2 0,-1-1 0,0 3 0,2-1 0,-4-1 0,2 1 0,0-1 0,0 0 0,2 1 0,-4-1 0,3 2 0,-3-2 0,3 3 0,-4-6 0,5 5 0,-4-5 0,3 2 0,-3 0 0,3-2 0,-3 3 0,4 0 0,-4-3 0,3 2 0,-3-2 0,4 2 0,-5-2 0,4 6 0,-3-6 0,1 5 0,1-6 0,-2 7 0,1-4 0,0 1 0,-1 2 0,1-3 0,0 3 0,-2-3 0,3 1 0,-1-1 0,-1 0 0,1-2 0,1 4 0,-2-2 0,1-2 0,0 5 0,-1-5 0,0 5 0,2-6 0,-2 7 0,4-3 0,-5 0 0,2 1 0,0-1 0,-1 1 0,3 0 0,-3-1 0,1 0 0,0 3 0,-1-2 0,1-4 0,1 4 0,-3-3 0,3 5 0,-3-4 0,2 3 0,-1-4 0,0 4 0,-1-2 0,2 1 0,-1 0 0,1-3 0,-2 4 0,0-3 0,3 2 0,-3 1 0,3-4 0,-3 4 0,0-2 0,0 0 0,0 2 0,0-4 0,0 3 0,0 0 0,0 0 0,0 1 0,0-4 0,0 4 0,0-1 0,0-1 0,0 2 0,0-3 0,0 0 0,0 0 0,0-2 0,0-4 0,0 0 0,-6-6 0,4 10 0,-4-1 0</inkml:trace>
</inkml:ink>
</file>

<file path=ppt/ink/ink2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50"/>
    </inkml:context>
    <inkml:brush xml:id="br0">
      <inkml:brushProperty name="width" value="0.28222" units="cm"/>
      <inkml:brushProperty name="height" value="0.28222" units="cm"/>
      <inkml:brushProperty name="color" value="#FFFFFF"/>
    </inkml:brush>
  </inkml:definitions>
  <inkml:trace contextRef="#ctx0" brushRef="#br0">1 0 24575,'0'25'0,"2"-5"0,2-3 0,4-8 0,-5 4 0,6-7 0,-5 5 0,11 6 0,-1 0 0,12 14 0,-10-12 0,5 4 0,-12-13 0,-1 1 0,0-1 0,-2-1 0,2-1 0,-1 0 0,-1 2 0,5 1 0,-5-1 0,2 0 0,1-3 0,-4 4 0,6-6 0,-6 5 0,6-4 0,-5 3 0,2-3 0,1 3 0,-5-4 0,7 5 0,-5-5 0,2 5 0,-1-5 0,0 6 0,0-6 0,1 2 0,-2 0 0,2-1 0,0 3 0,-2-4 0,1 5 0,1-4 0,-1 4 0,5-1 0,-5 2 0,6 2 0,-8-5 0,3 2 0,1-5 0,-4 4 0,3-3 0,0 3 0,-2-1 0,2 0 0,0 2 0,-2-2 0,1 1 0,2-1 0,-3 2 0,4-2 0,-3 5 0,3-3 0,-1 4 0,2-1 0,0-2 0,-1 6 0,5-3 0,-5 3 0,6 4 0,-4-4 0,4 5 0,3 4 0,-2-4 0,1 6 0,-6-12 0,1 1 0,-1 0 0,-1-1 0,-1 1 0,1-3 0,-4 2 0,1-2 0,0-1 0,-2 1 0,2-1 0,-2-2 0,0 2 0,2-3 0,-2 1 0,2-1 0,-3 0 0,1-1 0,0 2 0,-1-1 0,3 1 0,-2 2 0,2-3 0,1 4 0,-3-4 0,2 0 0,0 4 0,-2-4 0,3 3 0,-3-2 0,2 0 0,-3 2 0,4-3 0,1 8 0,-2-7 0,1 6 0,0-5 0,-2 1 0,0-2 0,-1 2 0,2-3 0,-1 3 0,1-3 0,-3 1 0,0-3 0,4 1 0,-4-4 0,3 5 0,-3-5 0,0 5 0,0-3 0,1 2 0,-1 0 0,1-2 0,-1 1 0,3 4 0,-3-6 0,3 3 0,-3-1 0,0-4 0,1 6 0,-2-5 0,4 5 0,-2-2 0,5 2 0,-5 0 0,4 0 0,-3 0 0,3 1 0,-1-1 0,-1 0 0,3 1 0,-3-2 0,4 1 0,-2 1 0,1 0 0,1-1 0,-2 0 0,3 3 0,-2-2 0,0 6 0,1-6 0,-3 4 0,3-1 0,-4 0 0,4 3 0,-3-7 0,1 6 0,-3-5 0,5 5 0,-6-5 0,5 5 0,-4-5 0,4 6 0,-4-4 0,6 9 0,-6-7 0,4 2 0,-5-7 0,2 1 0,-3-1 0,4 1 0,-2-1 0,0 0 0,1 0 0,0 0 0,-2 1 0,1-1 0,2 0 0,-2 0 0,2 0 0,-2 1 0,0-3 0,1 2 0,-3-4 0,7 2 0,-6 2 0,4-2 0,-3 3 0,3-3 0,-4 2 0,5-3 0,-5 3 0,6 3 0,-2-2 0,1 2 0,-3-7 0,0 4 0,0-2 0,0 0 0,3 2 0,-6-3 0,7 4 0,-7-4 0,3 3 0,0-2 0,-2 0 0,2 1 0,-4-1 0,2-1 0,0 3 0,0-5 0,1 5 0,1-4 0,-3 3 0,0-3 0,1 3 0,-1-2 0,0 1 0,1 2 0,0-2 0,-1 2 0,0-2 0,1 1 0,-1-1 0,2 4 0,0-1 0,1 2 0,-3-3 0,1 3 0,-1-2 0,1 5 0,0-5 0,0 4 0,0-3 0,0 1 0,-1 0 0,0-2 0,1 2 0,-1-3 0,-2-2 0,3 2 0,-3-3 0,3 3 0,-2-2 0,5 6 0,-3-5 0,1 6 0,-1-5 0,-1-3 0,1 4 0,-1-4 0,1 1 0,-4 2 0,3-2 0,-2-1 0,2 3 0,0-3 0,1 3 0,0 1 0,-1 0 0,0-2 0,5 4 0,-5-2 0,4 3 0,-3-4 0,-1 0 0,0 0 0,2 1 0,-2-1 0,0 1 0,1-1 0,-1-1 0,1 1 0,0 1 0,-1 0 0,0-1 0,1 0 0,0 0 0,-1 0 0,1 0 0,-1 1 0,0-1 0,1 0 0,-2-2 0,1 1 0,-3-3 0,1 3 0,2-3 0,-2 3 0,2-4 0,-1 9 0,-1-7 0,3 7 0,-3-8 0,0 3 0,0-4 0,-2 5 0,4-5 0,-4 2 0,3-2 0,-3 2 0,3-2 0,-3 3 0,3-3 0,-3 0 0,3 1 0,-1 1 0,0 1 0,1-3 0,-4 5 0,5-5 0,-5 2 0,5-2 0,-4 1 0,3-1 0,-3 1 0,0 2 0,-1 3 0,0-5 0,0 1 0</inkml:trace>
</inkml:ink>
</file>

<file path=ppt/ink/ink2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51"/>
    </inkml:context>
    <inkml:brush xml:id="br0">
      <inkml:brushProperty name="width" value="0.28222" units="cm"/>
      <inkml:brushProperty name="height" value="0.28222" units="cm"/>
      <inkml:brushProperty name="color" value="#FFFFFF"/>
    </inkml:brush>
  </inkml:definitions>
  <inkml:trace contextRef="#ctx0" brushRef="#br0">0 90 24575,'14'15'0,"-2"-2"0,-8-7 0,1 0 0,1 1 0,-2-2 0,1-1 0,8 9 0,-7-6 0,8 8 0,-8-9 0,4 3 0,-6-5 0,4 3 0,-3-2 0,0 0 0,0-1 0,0 0 0,0 3 0,0-1 0,0 0 0,0-1 0,-1-1 0,2 0 0,-1 3 0,0-4 0,-1 5 0,1-7 0,1 7 0,-2-4 0,1 3 0,1-3 0,-1-1 0,2 3 0,-4-2 0,4 1 0,-4 0 0,1-1 0,4 1 0,-2 0 0,0-2 0,0 1 0,-1-2 0,-1 3 0,2 0 0,-2 0 0,3-1 0,-1 1 0,5-1 0,-6 1 0,3 0 0,-3-1 0,2-1 0,0 1 0,-1-1 0,0 2 0,2-3 0,-3 2 0,3-1 0,-3-1 0,-1 2 0,4-1 0,0 2 0,0-3 0,0 2 0,-3-1 0,0-1 0,3 2 0,-4-3 0,4 3 0,0-3 0,-3 1 0,3 0 0,-1-2 0,2 2 0,0-2 0,0 3 0,0-3 0,-1 3 0,2-1 0,-1-1 0,0 1 0,1 0 0,-4-1 0,1 3 0,1-3 0,-3 1 0,3-2 0,2 2 0,-4-1 0,5 1 0,-7-2 0,4 0 0,0 0 0,0 0 0,0 0 0,-4 0 0,3 0 0,2 0 0,-3 0 0,2 0 0,-1 0 0,-1 0 0,3 0 0,-4 0 0,3 0 0,-2 0 0,1 0 0,2 0 0,-3 0 0,1 0 0,0 0 0,-1 0 0,2-2 0,-1 2 0,-1-4 0,5 3 0,-6-3 0,3 3 0,0-1 0,-3 0 0,3 1 0,2-3 0,-4 4 0,4-5 0,-5 5 0,1-3 0,3 1 0,-3 2 0,3-4 0,-4 3 0,0-5 0,0 3 0,-1-1 0,4-2 0,-5 3 0,4-4 0,-4 2 0,2 1 0,-1-3 0,1 4 0,0-6 0,1 7 0,-4-5 0,2 2 0,-1-1 0,0 1 0,2-2 0,-2 2 0,-1 1 0,3-3 0,-4 1 0,3-1 0,-1 2 0,0 1 0,4-5 0,-6 3 0,6-3 0,-4 4 0,-1-2 0,3 1 0,-2-3 0,2 3 0,-2 0 0,1 2 0,-1-3 0,2 2 0,-1-2 0,-1 2 0,-2-2 0,1 2 0,0-2 0,2 3 0,0-2 0,-1 1 0,1-2 0,-4 1 0,5 0 0,-4 0 0,1-1 0,0 2 0,-1-3 0,1 4 0,-2-3 0,0 1 0,2 0 0,-1-2 0,1 3 0,-2-2 0,0 0 0,0 2 0,2 0 0,-1-2 0,1 1 0,-2-2 0,0 3 0,0-2 0,0 1 0,0 1 0,0-4 0,-2 5 0,-1-5 0,-5 1 0,5 3 0,-3 0 0</inkml:trace>
</inkml:ink>
</file>

<file path=ppt/ink/ink2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52"/>
    </inkml:context>
    <inkml:brush xml:id="br0">
      <inkml:brushProperty name="width" value="0.28222" units="cm"/>
      <inkml:brushProperty name="height" value="0.28222" units="cm"/>
      <inkml:brushProperty name="color" value="#FFFFFF"/>
    </inkml:brush>
  </inkml:definitions>
  <inkml:trace contextRef="#ctx0" brushRef="#br0">0 633 24575,'22'2'0,"-5"1"0,-7 0 0,-4 4 0,4-4 0,-3 1 0,3 1 0,8 3 0,-8-5 0,8 6 0,-13-8 0,-1 3 0,4-4 0,-2 4 0,1-3 0,6 3 0,-7-1 0,6 2 0,-7-3 0,0 2 0,4-2 0,-5 1 0,4 1 0,-2-3 0,-2 3 0,4-1 0,-2-1 0,0 2 0,2-3 0,-3 3 0,4-3 0,-5 3 0,3-1 0,-1-1 0,2 2 0,-2-1 0,0-1 0,2 2 0,-1-3 0,-2 1 0,2 0 0,0-1 0,-1 2 0,1-2 0,1 3 0,-2-4 0,1 3 0,4-1 0,-6 1 0,6-1 0,-4 3 0,-2-5 0,4 4 0,-2-3 0,-1 1 0,1 0 0,4-1 0,-5 1 0,4 0 0,-5-1 0,-1 1 0,4-2 0,-2 2 0,1-2 0,1 5 0,-3-5 0,2 2 0,1-2 0,-3 0 0,5 0 0,-4 2 0,0-2 0,2 2 0,-3-2 0,4 0 0,-2 0 0,-1 3 0,2-3 0,-3 1 0,4-1 0,-3 2 0,1-1 0,1 1 0,-2-2 0,3 2 0,-4-1 0,2 1 0,0-2 0,-1 0 0,2 0 0,-1 0 0,0 0 0,1 0 0,-1 0 0,4 0 0,-6 0 0,2 0 0,3 0 0,13 0 0,-7 0 0,25 0 0,-28 0 0,14 0 0,-10-2 0,-5 1 0,43-10 0,-37 5 0,28-5 0,-34 9 0,-5 0 0,2 1 0,1-1 0,-4-1 0,4 3 0,-4-2 0,4-1 0,-4 3 0,4-4 0,-4 3 0,2-2 0,-1 1 0,-1-1 0,6-1 0,-5 1 0,5 0 0,-6 0 0,1 0 0,1-1 0,-1 1 0,-1 0 0,0-1 0,2 1 0,-3-2 0,3 2 0,-3-1 0,-1 2 0,2-3 0,-1 0 0,2-1 0,-1 1 0,2-2 0,-5 3 0,2 1 0,3-3 0,-4 3 0,2-4 0,-3 0 0,2 4 0,0-5 0,-2 4 0,1-1 0,-1-2 0,0 2 0,1-2 0,-2 0 0,1 2 0,0-2 0,-1 0 0,2 0 0,-2 0 0,2 0 0,-3 0 0,4 1 0,-5-1 0,5 0 0,-4 2 0,1-5 0,0 6 0,-2-7 0,2 4 0,1-1 0,-2-2 0,3 2 0,-3 1 0,4-2 0,-4 1 0,1 0 0,0-2 0,-1 5 0,4-2 0,-5-1 0,3 3 0,-1-1 0,-1-1 0,3 2 0,-4-2 0,2 0 0,-2 2 0,3-2 0,-3 0 0,3 2 0,-3-3 0,2 3 0,-2-2 0,5 0 0,-5 3 0,3-3 0,-2 0 0,0 2 0,1-3 0,-2 4 0,0-3 0,0 0 0,0 1 0,2 0 0,-1-1 0,1 2 0,-2-4 0,0 4 0,0-8 0,0 6 0,0-7 0,0 6 0,0-2 0,0 0 0,0 0 0,0-1 0,0 4 0,0-4 0,0 4 0,0 0 0,3 0 0,-3-1 0,3 3 0,-3-2 0,0 0 0,0 2 0,0-4 0,0 2 0,0 0 0,0 0 0,2 2 0,-1-2 0,0 2 0,-1-4 0,2 4 0,-2-1 0,3-3 0,-3 4 0,0-7 0,0 9 0,0-2 0</inkml:trace>
</inkml:ink>
</file>

<file path=ppt/ink/ink2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53"/>
    </inkml:context>
    <inkml:brush xml:id="br0">
      <inkml:brushProperty name="width" value="0.28222" units="cm"/>
      <inkml:brushProperty name="height" value="0.28222" units="cm"/>
      <inkml:brushProperty name="color" value="#FFFFFF"/>
    </inkml:brush>
  </inkml:definitions>
  <inkml:trace contextRef="#ctx0" brushRef="#br0">1 291 24575,'17'18'0,"0"2"0,-8-11 0,-1 4 0,4-3 0,-4 0 0,4 4 0,5 2 0,-5 0 0,0-5 0,-3-1 0,-5-5 0,8 5 0,-7-5 0,5 8 0,-4-8 0,1 4 0,1-5 0,-3 4 0,3-3 0,-2 3 0,-1-3 0,-1-1 0,2 0 0,-1 1 0,0 0 0,0 0 0,-1-2 0,2 2 0,-2 0 0,1 0 0,1 0 0,-2-1 0,2 0 0,-1 1 0,2 0 0,-2 0 0,3 0 0,-3-1 0,-1 0 0,2 1 0,2 0 0,-3-1 0,3 1 0,-1 0 0,-1 0 0,3 2 0,-3-1 0,0 1 0,5 0 0,-5-2 0,4 3 0,-4-1 0,5-1 0,-6 1 0,3-2 0,-1 2 0,0-2 0,0 2 0,1-3 0,-2 1 0,3 1 0,-2-2 0,2 1 0,-3 0 0,5 2 0,-3-1 0,1 1 0,1-2 0,-5-1 0,8 3 0,-7-1 0,7 1 0,-7-3 0,4 2 0,-4-1 0,4-3 0,-4 2 0,4-1 0,-1 3 0,1-3 0,-1 3 0,1-1 0,-1-3 0,2 3 0,0-2 0,3 2 0,-2 1 0,2-3 0,0 1 0,-2 0 0,5 1 0,-5-2 0,5 2 0,-4-3 0,4 4 0,-2-1 0,0 0 0,-1 1 0,1-3 0,-4 1 0,3-3 0,2 4 0,-3-5 0,3 5 0,-6-4 0,2 1 0,-1 0 0,0-1 0,1 1 0,-2-2 0,1 2 0,-2-1 0,1 4 0,-1-5 0,1 4 0,-1-4 0,1 2 0,-4 1 0,4-3 0,-4 2 0,4 1 0,-4-2 0,2 3 0,-1-4 0,-1 2 0,2 0 0,-1-1 0,-1 3 0,2-3 0,-1 3 0,-1-3 0,7 3 0,-7-1 0,4-1 0,-5 2 0,1-3 0,0 1 0,0 0 0,2-1 0,-1 2 0,-1-2 0,0 1 0,2 0 0,-2-2 0,1 4 0,0-1 0,-2-1 0,2 1 0,1-1 0,-3-2 0,3 2 0,0 0 0,-3 1 0,5 0 0,-5-1 0,3 0 0,0-2 0,-3 4 0,3-3 0,-1 1 0,-1 0 0,2-1 0,0 1 0,-3 0 0,3-1 0,0 1 0,-3-2 0,6 2 0,-3-2 0,0 2 0,3-2 0,-3 0 0,1 0 0,1 0 0,-1 0 0,-1 0 0,2 0 0,-1 0 0,-1 0 0,2 0 0,-1 0 0,-1 0 0,3 0 0,-4 0 0,2 0 0,1 0 0,-1 0 0,2 0 0,-2 0 0,1 0 0,1 0 0,-3 0 0,5 0 0,-8 0 0,4 0 0,-2 0 0,-2 0 0,3 0 0,-1-2 0,0 2 0,-1-4 0,2 4 0,-2-2 0,1 0 0,1 1 0,-3-3 0,2 3 0,-2-3 0,2 1 0,-1-2 0,4 3 0,-5-2 0,4 1 0,-2 0 0,-2-1 0,4 1 0,-5-1 0,5 2 0,-4-2 0,2 4 0,-1-4 0,2 1 0,-4-2 0,5 0 0,-2 0 0,-1 2 0,4-2 0,-4 3 0,5-3 0,-6 0 0,3 2 0,-1-1 0,-1 1 0,5-1 0,-6-1 0,6 0 0,-6-2 0,6 1 0,-6-1 0,6 2 0,-4-3 0,3 3 0,-4-2 0,3 0 0,-2 1 0,3-1 0,-4 0 0,4 1 0,-4-2 0,4 4 0,-4-4 0,3 4 0,-2-6 0,-1 5 0,4-6 0,-5 7 0,8-9 0,-6 5 0,3-1 0,-2-1 0,-2 5 0,1-5 0,1 2 0,-3 1 0,4-3 0,-4 3 0,0-1 0,1-2 0,-1 5 0,1-5 0,-1 5 0,0-2 0,0 0 0,0 2 0,-2-2 0,1 3 0,-3-4 0,4 3 0,-2-3 0,-1 4 0,2-3 0,0-1 0,-1 1 0,2-3 0,-2 0 0,2 2 0,-2-4 0,2 6 0,-5 0 0,4 2 0,-3-4 0,1 3 0,0-2 0,1-3 0,0 4 0,0-5 0,0 6 0,-3-4 0,4 3 0,-3-3 0,1 3 0,0-4 0,-1 2 0,1 1 0,1 0 0,-2 0 0,2 1 0,-2-3 0,1 3 0,0-1 0,-1 1 0,2-2 0,-1 1 0,-1 0 0,1 3 0,-2-4 0,2 3 0,-1-2 0,3 0 0,-4 1 0,3 0 0,-1 0 0,-2 0 0,3 0 0,-3-1 0,2 2 0,-2-2 0,2 0 0,-2-1 0,0 2 0,3-1 0,-3 2 0,2-4 0,-2 3 0,0-3 0,0 4 0,2 0 0,-1-2 0,1 3 0,-2-4 0,0-1 0,0 2 0,2 0 0,-1 2 0,2-2 0,-3 0 0,0 0 0,0 1 0,0-1 0,0 2 0,0-4 0,2 4 0,-1-1 0,1-1 0,-2 1 0,0-1 0,0 2 0,0-2 0,0 1 0,0 0 0,0-2 0,0 3 0,0-1 0,0-1 0,0 3 0,0-6 0,0 3 0,0 1 0,0 1 0</inkml:trace>
</inkml:ink>
</file>

<file path=ppt/ink/ink2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54"/>
    </inkml:context>
    <inkml:brush xml:id="br0">
      <inkml:brushProperty name="width" value="0.28222" units="cm"/>
      <inkml:brushProperty name="height" value="0.28222" units="cm"/>
      <inkml:brushProperty name="color" value="#FFFFFF"/>
    </inkml:brush>
  </inkml:definitions>
  <inkml:trace contextRef="#ctx0" brushRef="#br0">1 330 24575,'8'19'0,"1"2"0,3-10 0,-2 3 0,6-2 0,-8-1 0,16 12 0,-8-4 0,6 5 0,-7-9 0,-3-2 0,0-2 0,-2-1 0,1-1 0,-6-4 0,6 3 0,-3-1 0,3-1 0,-2 3 0,1-3 0,-4 4 0,2-6 0,0 4 0,-3-3 0,4 0 0,-3 0 0,0 0 0,3-1 0,-5 4 0,2-3 0,-1 2 0,0-3 0,3 1 0,-2 2 0,1-1 0,2 3 0,-4-3 0,2 4 0,2-5 0,-3 4 0,4 1 0,-4-1 0,4 3 0,-4-7 0,2 5 0,-3-5 0,0 4 0,0-4 0,1 5 0,-1-5 0,0 3 0,0-1 0,0-2 0,1 2 0,-3-2 0,0-1 0,3 3 0,0-3 0,0 3 0,-3-2 0,2 0 0,0 2 0,0-2 0,2 2 0,-1-5 0,-2 2 0,4-2 0,-2 3 0,4 0 0,-4 0 0,4 0 0,-2 0 0,1 0 0,1 2 0,-2-1 0,1 1 0,1-2 0,-1-1 0,-1 1 0,3 3 0,-3-2 0,0 1 0,3-2 0,-5 0 0,3 0 0,-2-1 0,2 2 0,-3-2 0,5 0 0,-6 1 0,6 1 0,-6-4 0,7 3 0,-5-2 0,4 2 0,-2 0 0,1-2 0,-2 1 0,4-1 0,-2 2 0,2 0 0,-1 0 0,-4-2 0,9 4 0,-6-6 0,6 6 0,-8-5 0,3 1 0,-5 1 0,4-3 0,-2 3 0,0-3 0,3 3 0,-6-3 0,6 3 0,-6-3 0,3 4 0,0-5 0,0 3 0,1 0 0,-2 0 0,1 1 0,-2-3 0,4 3 0,-4-3 0,4 4 0,-4-4 0,4 3 0,-4-4 0,1 5 0,1-5 0,-2 5 0,4-5 0,-4 4 0,4-1 0,4 2 0,-5-2 0,6 2 0,-6-4 0,2 2 0,-2 2 0,1-4 0,3 5 0,-3-5 0,5 6 0,-7-4 0,1 0 0,0-1 0,-3 0 0,6-1 0,-8 3 0,8-3 0,-7 1 0,6 0 0,-4-2 0,2 3 0,1-1 0,-1-1 0,-1 1 0,3 1 0,-6-3 0,6 2 0,-3-1 0,0 0 0,2 2 0,-4-3 0,5 0 0,-3 2 0,2-2 0,2 3 0,-4-1 0,3-2 0,-4 2 0,2 0 0,-1-1 0,-1 1 0,0-2 0,0 2 0,1-1 0,-3 1 0,4 0 0,0-1 0,-2 1 0,1-2 0,-1 0 0,0 0 0,0 2 0,3-2 0,-3 2 0,2-2 0,-1 0 0,-3 2 0,6-1 0,-5 1 0,4-2 0,-1 0 0,1 0 0,1 0 0,1 0 0,-1 0 0,-1 0 0,2 0 0,-1 0 0,0 0 0,0 0 0,-1 0 0,2 0 0,-1 0 0,-3 0 0,3 0 0,-3 0 0,3 0 0,-2 0 0,0 0 0,1 0 0,-3-2 0,1 1 0,0-1 0,-3 2 0,4 0 0,-2 0 0,-2-2 0,3 2 0,-1-2 0,2-1 0,-2 3 0,2-3 0,-5 1 0,7 1 0,-5-1 0,3 0 0,-3 2 0,-2-4 0,6 1 0,-3-2 0,5 2 0,-4 0 0,4 0 0,-2-2 0,2 0 0,-1-1 0,-1 1 0,2-2 0,2 1 0,-3-4 0,7 3 0,-2-2 0,-1 1 0,2-4 0,-5 2 0,5-1 0,-2 1 0,4-5 0,-4 6 0,4-9 0,-7 12 0,3-7 0,-4 5 0,5-2 0,-3-1 0,0 4 0,-3-1 0,-4 3 0,5 1 0,-6-1 0,3 0 0,-3 0 0,2 1 0,-1-1 0,1 2 0,-2-1 0,1 1 0,-1-1 0,-1-1 0,4 0 0,-3 0 0,2 4 0,-2-4 0,2 3 0,-1-2 0,2 1 0,-4-1 0,2 1 0,-1-2 0,0 1 0,-1-1 0,3 0 0,-3 0 0,2 1 0,-3-1 0,3 2 0,-1-2 0,-1-3 0,2 3 0,0-5 0,-1 2 0,-1 1 0,3-4 0,0 5 0,1-4 0,2-1 0,0 1 0,-1-1 0,2-1 0,-3 1 0,3-3 0,-2 1 0,0 2 0,2-1 0,-4-2 0,0 3 0,2-2 0,-3 2 0,2 1 0,-3 3 0,1-3 0,-1 2 0,1 0 0,1-4 0,-1 7 0,-1-6 0,-1 5 0,-3-1 0,3 0 0,-1 1 0,0 0 0,2 1 0,-5-2 0,5 2 0,-4-2 0,2 2 0,1-4 0,-2 3 0,4-3 0,-6 1 0,5 3 0,-5-4 0,4 4 0,-3-5 0,4 5 0,-5-3 0,5 2 0,-2-3 0,-1 2 0,4-2 0,-3 3 0,0-3 0,1 0 0,-1 2 0,2-3 0,-2 3 0,2 0 0,-2-3 0,2 0 0,1-3 0,-1 2 0,0 1 0,-2 1 0,2 2 0,-2-3 0,1 2 0,0 0 0,1-2 0,-2 3 0,3-3 0,-1 0 0,0 2 0,1-2 0,-1 2 0,-2-1 0,2 0 0,-2 0 0,1 1 0,3 0 0,-4 1 0,1 0 0,-1 2 0,-1-5 0,4 5 0,-4-2 0,3-3 0,-2 5 0,2-7 0,-5 6 0,5-2 0,-2 0 0,3-2 0,-4 2 0,3 2 0,-4 1 0,5-6 0,-5 6 0,4-6 0,-5 5 0,0 2 0,0 1 0</inkml:trace>
</inkml:ink>
</file>

<file path=ppt/ink/ink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28"/>
    </inkml:context>
    <inkml:brush xml:id="br0">
      <inkml:brushProperty name="width" value="0.28222" units="cm"/>
      <inkml:brushProperty name="height" value="0.28222" units="cm"/>
      <inkml:brushProperty name="color" value="#FFFFFF"/>
    </inkml:brush>
  </inkml:definitions>
  <inkml:trace contextRef="#ctx0" brushRef="#br0">0 109 24575,'39'0'0,"0"0"0,29-3 0,-45 3 0,3-5 0,-13 5 0,2-5 0,-7 4 0,10-4 0,-2 1 0,2 1 0,-1-4 0,-5 5 0,-1-2 0,5 0 0,-4 1 0,1 1 0,-3-2 0,2 0 0,9-1 0,-5 2 0,5-1 0,-5 3 0,-6-4 0,4 5 0,-1-2 0,8-1 0,0 1 0,4-1 0,-5 0 0,3 1 0,-7 1 0,4-1 0,1 0 0,-3 1 0,2-2 0,-4 3 0,-4 0 0,-1 0 0,0 0 0,1 0 0,-2 0 0,-2 0 0,3-2 0,-3 1 0,0-1 0,3 2 0,-3 0 0,4 0 0,-5 0 0,5 0 0,-5 0 0,5 0 0,-1 0 0,3 0 0,-2 0 0,3 0 0,-5-2 0,2 1 0,2-1 0,-3 2 0,3 0 0,-2 0 0,-2 0 0,6 0 0,-3 0 0,4 0 0,-7 0 0,1 0 0,-2 0 0,0 0 0,0 0 0,0 0 0,1 0 0,-4 0 0,4 0 0,-4 0 0,4 0 0,-4 0 0,1 0 0,-2 2 0,4-1 0,-4 3 0,2-4 0,-1 3 0,-2-1 0,1-2 0,3 2 0,-3-2 0,7 0 0,-7 2 0,2-2 0,2 2 0,-4-2 0,6 0 0,-4 0 0,5 0 0,-4 2 0,7-1 0,-5 1 0,6-2 0,-5 3 0,0-3 0,0 2 0,1 0 0,-2-2 0,1 5 0,-2-4 0,1 3 0,-1-3 0,-2 3 0,4-1 0,-5 0 0,4 2 0,-1-3 0,-2 3 0,2-2 0,-2 2 0,-1-5 0,1 4 0,1-3 0,-2 3 0,1-1 0,1-1 0,-1 0 0,-1 0 0,0-2 0,-1 2 0,-1 0 0,5-2 0,-2 2 0,1 1 0,0-3 0,-4 2 0,2-2 0,-1 2 0,0-1 0,-1 1 0,1-2 0,1 0 0,-2 2 0,2-1 0,-1 1 0,0-2 0,-1 0 0,1 0 0,0 2 0,0-1 0,0 1 0,1-2 0,-1 0 0,-1 0 0,1 0 0,0 0 0,1 0 0,-2 0 0,1 0 0,4 0 0,-5 2 0,4-2 0,0 2 0,-2-2 0,2 0 0,-1 0 0,-1 0 0,2 2 0,-4-1 0,4 1 0,-2 0 0,1-1 0,-1 1 0,1 0 0,-1-1 0,2 3 0,-4-2 0,1 1 0,1 0 0,-1-2 0,0 3 0,0-1 0,-1-1 0,-1 3 0,1-5 0,-3 4 0,6-1 0,-6 2 0,6-3 0,-5 2 0,4-1 0,-1-1 0,-3 3 0,2-3 0,-3 2 0,3 1 0,-3-1 0,3-1 0,-3 1 0,2-2 0,-1 3 0,-1-1 0,2 1 0,-1 0 0,-2 0 0,0-1 0,3 0 0,-2 1 0,1 0 0,-2-1 0,2 1 0,-1 2 0,1-2 0,-2 2 0,0-2 0,0 3 0,0-4 0,0 7 0,0-7 0,0 3 0,0-2 0,0-1 0,0 3 0,0-1 0,0 0 0,0-1 0,0-1 0,-2 1 0,1 0 0,-1-1 0,0 0 0,1 1 0,-2 0 0,1 0 0,1 0 0,-2-1 0,2 0 0,-1 1 0,-1 0 0,3 2 0,-5-2 0,5 2 0,-5-3 0,5 1 0,-4 0 0,0 3 0,1-4 0,-1 4 0,1-1 0,-5-1 0,0 4 0,-3-1 0,2 3 0,2-3 0,-2 0 0,4-3 0,-2 0 0,1 1 0,1-2 0,0 3 0,-1-3 0,1-1 0,1 3 0,-2-1 0,1 1 0,1-3 0,-2 0 0,1 1 0,0 2 0,0-1 0,2 1 0,-1 0 0,0 1 0,0 0 0,-2 0 0,0 1 0,1 1 0,0-3 0,-4 3 0,3-2 0,-1 3 0,1-2 0,-1 6 0,0-3 0,-1 3 0,3-8 0,-1 2 0,1 0 0,2-2 0,-2 3 0,2-5 0,-2 3 0,0-2 0,3-1 0,-4 2 0,3-2 0,-2 0 0,3 2 0,-3-2 0,3 3 0,-3-4 0,-1 1 0,4-1 0,-3 3 0,2-2 0,-3 3 0,2-4 0,2 1 0,-4-1 0,4 1 0,-1 0 0,-1 0 0,1-1 0,-2 1 0,0 1 0,0-1 0,0 2 0,2-3 0,-2 1 0,2-2 0,1 1 0,-2-1 0,1 1 0,-2-1 0,0 1 0,3-1 0,-3 1 0,2 0 0,-2 1 0,2-1 0,-1 1 0,1 0 0,-2 0 0,0 0 0,1-1 0,-2 0 0,1 1 0,0 0 0,0 0 0,1-1 0,-2 0 0,2 1 0,-1-1 0,-1 1 0,1 0 0,1 2 0,-2-1 0,1 0 0,0-1 0,0 0 0,-3 0 0,3 1 0,-4 0 0,4 1 0,0 0 0,0-2 0,0 3 0,-1-3 0,2 2 0,-1-2 0,-1 1 0,1-1 0,1 0 0,1 0 0,-2-1 0,2-1 0,0 1 0,-1-4 0,4 4 0,-7-1 0,3 0 0,-2-1 0,1-2 0,-1 0 0,2 0 0,-8 0 0,-5 0 0,-2 0 0,-5 0 0,3 0 0,2-3 0,-7 0 0,7-3 0,-3 0 0,4 3 0,0-2 0,0 4 0,3-1 0,-3-1 0,7 3 0,-3-3 0,2 3 0,1 0 0,0 0 0,0 0 0,2 0 0,-1 0 0,4 0 0,-4 0 0,4 0 0,-1 0 0,-1 0 0,2 0 0,-1 2 0,2-1 0,0 3 0,0-3 0,0 1 0,0 0 0,0-2 0,-3 5 0,0-5 0,0 4 0,1-3 0,3 3 0,1-3 0,0 1 0,-5-2 0,2 2 0,-1-1 0,1 1 0,1 0 0,1-2 0,-1 2 0,0-2 0,0 2 0,0-1 0,-3 1 0,3 0 0,-3-2 0,2 3 0,-1-3 0,2 1 0,-4-1 0,5 2 0,-4-2 0,2 0 0,-1 2 0,-2-1 0,4 1 0,-2-2 0,1 0 0,0 0 0,-3 0 0,2 0 0,-2 0 0,1 0 0,4 0 0,-8 0 0,7 0 0,-6 0 0,6 0 0,-2 0 0,-2 0 0,4 0 0,-3 0 0,3 0 0,1 0 0,-2 0 0,1 0 0,0 0 0,1 0 0,-4 0 0,2 0 0,-2 0 0,4 0 0,-2 0 0,2 0 0,-1 0 0,-1 0 0,2 0 0,-2 0 0,-1 0 0,2 0 0,-2 0 0,2 0 0,-1 0 0,2 0 0,-2 0 0,2 0 0,0 0 0,0-2 0,0 1 0,4-4 0,-3 2 0,3-4 0,0 3 0,0-1 0,0-3 0,-2 4 0,2-4 0,-3 3 0,3-2 0,-2 2 0,2-1 0,-5-2 0,4 3 0,-4-2 0,2-1 0,0 3 0,-3-7 0,4 7 0,-5-4 0,7 4 0,-4 1 0,1-1 0,0 0 0,-2 2 0,2-1 0,-1 2 0,2-3 0,-3 1 0,2-1 0,0 0 0,-2 3 0,3-2 0,-1 2 0,-1-3 0,1 0 0,-1 0 0,1 1 0,2-1 0,-3 1 0,0-1 0,2 0 0,-2 0 0,1 3 0,0-2 0,-1 2 0,3-5 0,-6 0 0,6-2 0,-5 3 0,3 1 0,-3-2 0,1 1 0,1-1 0,-2 1 0,1 1 0,0-3 0,0 1 0,-1-1 0,1 1 0,-3-3 0,2 3 0,-2-4 0,0 1 0,2 0 0,-3-4 0,1 3 0,3-2 0,-4 3 0,3 0 0,1-1 0,0 1 0,-1 1 0,1-2 0,-1 1 0,3 2 0,-2-2 0,0-4 0,-2 1 0,0-5 0,0 8 0,4-1 0,-2 5 0,2-4 0,1 2 0,-3 0 0,2-4 0,0 7 0,-1-7 0,3 7 0,-3-2 0,4 2 0,-3-2 0,0 1 0,3-1 0,-2 3 0,-1-4 0,2 3 0,-1-1 0,1 1 0,0 0 0,-4 1 0,4-3 0,-1 1 0,0-1 0,1 2 0,-1-2 0,2 2 0,-3-2 0,3 0 0,-2 2 0,2-2 0,0-3 0,-2 5 0,2-5 0,-2 4 0,2 1 0,0-3 0,0 1 0,0 2 0,0-5 0,0 4 0,0-3 0,0 3 0,0 0 0,0-1 0,0 2 0,0-2 0,0 2 0,0 0 0,0 0 0,0 1 0,0-1 0,0-2 0,0 3 0,0-3 0,0 2 0,0 0 0,0-2 0,0 1 0,0-3 0,0 3 0,0-3 0,0 4 0,0-2 0,0 2 0,0 0 0,0 1 0,0-1 0,0 1 0,0-1 0,0 0 0,0 1 0,0-1 0,0 2 0,1 0 0,4 1 0,0 2 0,2 0 0,-2-1 0,-3-2 0,0-2 0,0 3 0,-1-2 0,1 2 0,-2-3 0,3 0 0,-3 0 0,5 3 0,-4 0 0,4 2 0,0 0 0,-3 2 0,1 2 0,-1-1 0,-1 3 0,0-4 0,1 1 0,-2 2 0,5-4 0,-4 5 0,1-3 0,-2 1 0,0-1 0</inkml:trace>
</inkml:ink>
</file>

<file path=ppt/ink/ink3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55"/>
    </inkml:context>
    <inkml:brush xml:id="br0">
      <inkml:brushProperty name="width" value="0.28222" units="cm"/>
      <inkml:brushProperty name="height" value="0.28222" units="cm"/>
      <inkml:brushProperty name="color" value="#FFFFFF"/>
    </inkml:brush>
  </inkml:definitions>
  <inkml:trace contextRef="#ctx0" brushRef="#br0">846 866 24575,'-20'0'0,"2"0"0,8-2 0,-1-2 0,2-3 0,-4 1 0,3 1 0,-11-9 0,6 7 0,-1-6 0,7 6 0,1 2 0,1-2 0,-3 2 0,1-2 0,3 2 0,-3 0 0,3 1 0,-3-1 0,3-2 0,-6-1 0,4 0 0,-3 1 0,7 2 0,-2 0 0,1-1 0,0 1 0,0-2 0,-1 0 0,1 1 0,1-4 0,-2 5 0,3-2 0,-2-1 0,2 2 0,-2-2 0,-1-2 0,3 5 0,-1-5 0,1 2 0,-2 1 0,1-3 0,-1 3 0,3-1 0,-3-2 0,2 2 0,-3 0 0,3-2 0,-1 4 0,-1-3 0,-2 0 0,3 1 0,1-2 0,-2 1 0,-1-4 0,3 7 0,-4-8 0,6 8 0,-4-4 0,4 5 0,-3-2 0,4 0 0,-5 2 0,2-2 0,0-1 0,-2 3 0,5-5 0,-4 5 0,3-5 0,-3 5 0,3-4 0,-4 4 0,5-3 0,-5 2 0,5 0 0,-5-3 0,5 3 0,-6-3 0,6 4 0,-3-2 0,0-1 0,3 3 0,-2-2 0,0-1 0,1 1 0,-4-1 0,4 3 0,-1 0 0,0-5 0,-2 5 0,3-5 0,-1 3 0,0 2 0,1-2 0,-4 3 0,5-3 0,-5 2 0,4-2 0,-2 1 0,2 0 0,-4-1 0,4 0 0,-3 2 0,3-1 0,-3 2 0,1-1 0,-2 1 0,0-1 0,0-2 0,1 1 0,-2 0 0,1 1 0,2 0 0,-3-2 0,2 4 0,-3-2 0,2 1 0,0 1 0,-2-2 0,2 2 0,-6-1 0,6 4 0,-5-5 0,3 4 0,-2-4 0,0 5 0,1-4 0,-3 3 0,6-1 0,-6 2 0,6-2 0,-3 1 0,0-1 0,3 2 0,-5 0 0,5 0 0,-5 0 0,4 0 0,-3 0 0,2 0 0,0 0 0,-1 0 0,2 0 0,-1 0 0,-1 0 0,3 0 0,-5 0 0,5 0 0,-2 0 0,0 0 0,3-5 0,1 0 0,1-2 0,1-1 0,-1 5 0,0-6 0,8 25 0,-6-10 0,9 18 0,-6-14 0,0-2 0,3 2 0,-4-2 0,1 1 0,2-1 0,-2 2 0,2-5 0,0 5 0,1-4 0,-1 3 0,0-2 0,1 4 0,0-1 0,-2 0 0,2 1 0,3-1 0,-4-3 0,3 3 0,0 0 0,-2-2 0,1 4 0,-2-7 0,-2 2 0,2-2 0,-3 1 0,1-1 0,2 2 0,-5 0 0,4-2 0,-3 1 0,4-1 0,-2 0 0,0 1 0,0-2 0,-2 3 0,4-2 0,-5 2 0,4-2 0,-3 2 0,1-1 0,-2-1 0,-8-23 0,6 14 0,-6-20 0</inkml:trace>
</inkml:ink>
</file>

<file path=ppt/ink/ink3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8:01.061"/>
    </inkml:context>
    <inkml:brush xml:id="br0">
      <inkml:brushProperty name="width" value="0.35" units="cm"/>
      <inkml:brushProperty name="height" value="0.35" units="cm"/>
      <inkml:brushProperty name="color" value="#FFFFFF"/>
    </inkml:brush>
  </inkml:definitions>
  <inkml:trace contextRef="#ctx0" brushRef="#br0">1074 354 24575,'-51'59'0,"-13"13"0,70-73 0,-1-10 0,35-42 0,-6 1 0,-19 43 0,-5-9 0,5 4 0,-1 0 0,-3-3 0,8 7 0,-8-7 0,3 3 0,-4 0 0,4-3 0,-3 7 0,3-6 0,0 2 0,-4 0 0,5 1 0,-6 0 0,0 5 0,0-5 0,1 5 0,-2-1 0,2 1 0,-2 0 0,-2 1 0,-22 2 0,7 2 0,-20 3 0,18 0 0,-7 0 0,3 0 0,-5 0 0,0 0 0,-5 0 0,-3 0 0,-5 0 0,7 0 0,-6-5 0,11 4 0,-11-3 0,6-1 0,-2 4 0,3-7 0,-1 7 0,5-4 0,-4 5 0,5 0 0,0-4 0,0 3 0,5-3 0,-4 4 0,4 0 0,-5 0 0,0 0 0,0 0 0,0 0 0,0 0 0,0-4 0,0 3 0,0-2 0,0 3 0,-5-5 0,3 4 0,-3-3 0,5 4 0,0 0 0,-6 0 0,4 0 0,-3 0 0,5 0 0,0 0 0,0 0 0,0 0 0,5 0 0,-3 0 0,3-4 0,0 3 0,-4-3 0,8 4 0,-2 0 0,-1 0 0,3-4 0,-2 3 0,4-3 0,0 4 0,-4 0 0,3 0 0,-3 0 0,4 0 0,0 0 0,-3 0 0,1 0 0,-2 0 0,4 0 0,1 0 0,7 14 0,6-7 0,5 11 0,2-10 0,-2 0 0,-2 5 0,3 1 0,-2 3 0,2 2 0,-2-1 0,2 0 0,-2 0 0,2 1 0,-2-2 0,1-3 0,0 4 0,-1-4 0,1 3 0,0 1 0,0 1 0,0-2 0,0 2 0,4-1 0,-3 0 0,4 0 0,-1 1 0,-3-6 0,3 4 0,0-3 0,-3 5 0,3-2 0,-3 1 0,3-3 0,-3 1 0,3-1 0,1 3 0,-4 0 0,8-4 0,-9 3 0,6-2 0,-7-2 0,5 0 0,-3 0 0,3-3 0,-5 3 0,0-6 0,0 1 0,0 1 0,0-1 0,0-3 0,0 2 0,0-6 0,0 3 0,4-4 0,-3 0 0,3 0 0,-4 0 0,0-4 0,5-1 0,-4-8 0,9-1 0,-3 0 0,4-3 0,0 3 0,-5 0 0,3-3 0,-3 3 0,1 0 0,-2-3 0,-5 4 0,5-1 0,-2-4 0,2 4 0,1-9 0,-3 3 0,8-8 0,-8 8 0,3-8 0,-5 8 0,1-3 0,-2 5 0,2 4 0,-2-3 0,1 8 0,-6-3 0,5-1 0,-8 3 0,4-2 0,-5-1 0,0 4 0,0-3 0,0 4 0,0-1 0,-8-3 0,2 7 0,-7-1 0,5 6 0,-7 0 0,5 0 0,-9 0 0,5 0 0,-6 0 0,-1 0 0,1 0 0,0 0 0,1 0 0,-6 0 0,3 3 0,-4-2 0,6 7 0,5-3 0,-3 0 0,3 3 0,-5-3 0,0 4 0,0-4 0,0 3 0,0-3 0,1 0 0,-1 3 0,0-7 0,5 7 0,-4-7 0,4 2 0,-5 1 0,4-2 0,-2 2 0,8-4 0,-9 0 0,9 0 0,-9 0 0,9 0 0,-4 0 0,0 0 0,4 0 0,-4 0 0,6 0 0,-2 0 0,-3 0 0,3 0 0,-3 0 0,5 0 0,-2 0 0,-3 0 0,3 0 0,-3-4 0,4-1 0,1 1 0,-2-4 0,2 4 0,-2-1 0,2-2 0,-1 3 0,4-4 0,5 28 0,5-13 0,0 23 0,4-18 0,-5-3 0,2 9 0,3-4 0,-8 3 0,7 2 0,-6-1 0,2 0 0,-4 0 0,5 1 0,-5-2 0,5 1 0,-5 1 0,4-1 0,-2-5 0,6 5 0,-7-4 0,8 3 0,-2 7 0,3 1 0,0-1 0,1 5 0,-1-5 0,2 7 0,-2-2 0,1 2 0,1-2 0,-2-4 0,1 3 0,-1-3 0,1-1 0,-6 5 0,5-5 0,-4 7 0,5-2 0,0 1 0,-5 0 0,3 0 0,-7-1 0,8 8 0,-8-6 0,7 4 0,-7-4 0,3-2 0,-5 1 0,0 6 0,0-4 0,0 3 0,0 1 0,0-4 0,0 3 0,0-5 0,0 0 0,0 0 0,-5 0 0,3-5 0,-7-3 0,8-3 0,-3-1 0,-1 0 0,4 0 0,-8 5 0,8-3 0,-4 4 0,5-1 0,-5-4 0,4 9 0,-3-5 0,4 1 0,-5 2 0,4-1 0,-4 4 0,5 2 0,0-2 0,0-4 0,0 3 0,0-8 0,0 8 0,0-3 0,0 0 0,0 3 0,0-8 0,0 8 0,0-8 0,0 8 0,0-8 0,-5 4 0,4-1 0,-3-4 0,4 4 0,-5 1 0,4-5 0,-4 4 0,5-4 0,-4-1 0,3-1 0,-4 2 0,0-1 0,4 0 0,-3 5 0,0-3 0,3 3 0,-4 1 0,5-5 0,0 10 0,0-9 0,-5 8 0,4-9 0,-4 10 0,5-4 0,-4-1 0,3 5 0,-4-5 0,0 1 0,4 3 0,-2-3 0,-3 5 0,5 0 0,-4 8 0,5-6 0,-5 6 0,5-13 0,-6 3 0,6-9 0,0 9 0,-4-8 0,3 4 0,-4-1 0,5-3 0,0 8 0,0-9 0,0 4 0,0 1 0,-4-4 0,3 2 0,-4-3 0,5-1 0,0 0 0,-4 0 0,3 1 0,-4-2 0,5 2 0,0-1 0,0 5 0,-4-3 0,3 4 0,-4-7 0,5 2 0,0-1 0,0 0 0,0 8 0,0-10 0,0 9 0,0-11 0,0 4 0,0 0 0,0 0 0,0 1 0,0-2 0,0 1 0,0 1 0,0-2 0,0-3 0,0 4 0,0-5 0,0 0 0,0 5 0,0-4 0,0 0 0,5 2 0,0-6 0,5 7 0,-5-3 0,3-1 0,-3 0 0,4-5 0,0 0 0,0 1 0,-4-2 0,4 1 0,-5-3 0,5 2 0,0-6 0,0 3 0,9-4 0,-7 0 0,7 0 0,-9 0 0,5 0 0,-3 0 0,7 0 0,-8 0 0,9-4 0,-4-1 0,0-4 0,3-3 0,-3 2 0,1-3 0,3 4 0,-9 0 0,8 0 0,-8 2 0,5-2 0,-7 1 0,2-1 0,-2 1 0,2 0 0,3-1 0,-3 1 0,5 0 0,-7 3 0,2-2 0,-2 2 0,2 0 0,-2-2 0,2 3 0,-2-1 0,1 1 0,-1 2 0,-3-6 0,-1-1 0,-4-2 0,0 4 0,0-1 0,0-3 0,0 3 0,0-3 0,0 3 0,0 0 0,0-4 0,0 3 0,0-6 0,0 5 0,0-3 0,0 5 0,0 0 0,0-3 0,0 2 0,0-3 0,0 4 0,0 0 0,0-3 0,0 3 0,0-3 0,0 3 0,0 0 0,0-3 0,0 2 0,0-1 0,0 2 0,0 0 0,0-4 0,0 3 0,0-7 0,0 7 0,0-4 0,0 0 0,0 3 0,0-1 0,0-2 0,0 3 0,0-7 0,0 7 0,0-6 0,0 7 0,0-4 0,0 0 0,0 4 0,0-3 0,0-1 0,0 3 0,0-2 0,0 0 0,0 2 0,0-3 0,0 5 0,0-5 0,0 4 0,0-3 0,0 4 0,0-1 0,0-7 0,0 5 0,0-4 0,-4 6 0,3 1 0,-3 0 0,4-5 0,0 4 0,-5-3 0,4-1 0,-2 3 0,3-3 0,0 2 0,0 1 0,0-3 0,0 0 0,0 4 0,0-6 0,0 5 0,-5-6 0,4 2 0,-3-3 0,4-2 0,0 1 0,0 0 0,-5 0 0,5-1 0,-5 2 0,0-7 0,4 4 0,-4-3 0,5 0 0,-4 4 0,3-10 0,-9 9 0,9-8 0,-7 8 0,7-3 0,-4 5 0,0-1 0,4 2 0,-2-2 0,-2 1 0,4 1 0,-4-2 0,5 1 0,0-1 0,0 6 0,-5-4 0,4 3 0,-3-4 0,4 0 0,0-1 0,0 2 0,0 3 0,0-3 0,0 3 0,-4-4 0,3 0 0,-4-1 0,5 2 0,0-2 0,0 1 0,0 0 0,0 0 0,0 0 0,0 0 0,0 0 0,0-1 0,0 2 0,0 3 0,0-9 0,0 8 0,0-8 0,0-1 0,0 5 0,0-10 0,0 9 0,0-2 0,0-2 0,0 5 0,0-5 0,0 1 0,0 4 0,0-5 0,0 6 0,0-5 0,0 3 0,0-3 0,0 5 0,0-6 0,0 5 0,0-4 0,0 4 0,0 2 0,0-2 0,0 1 0,0 5 0,0-5 0,0-1 0,0 5 0,0-9 0,0 9 0,0-3 0,0-2 0,0 1 0,0-1 0,0 2 0,0-2 0,0 5 0,-5-2 0,5 2 0,-5 0 0,5-3 0,0 4 0,0-6 0,-4 1 0,3 0 0,-4 4 0,5-3 0,0 3 0,0-3 0,0-2 0,0 1 0,0 5 0,0-5 0,0 4 0,-4-3 0,3-2 0,-4 1 0,5-1 0,0-3 0,-4 2 0,3-8 0,-8 8 0,8-3 0,-4 5 0,1-1 0,3-3 0,-8 2 0,8 0 0,-4 4 0,1 2 0,3 0 0,-3-3 0,0 7 0,3-1 0,-8 6 0,8 29 0,-2-3 0,3 23 0,0-7 0,0 0 0,0 13 0,0 2 0,-6 6 0,4 1 0,-10 25 0,10-26 0,-5 30 0,1-27 0,5 15 0,-6-9 0,1 7 0,4-5 0,-3-1 0,5 5 0,0-12 0,-6 5 0,4-7 0,-4 7 0,6-5 0,0 5 0,0-7 0,0-1 0,0 1 0,0 0 0,0-1 0,0 0 0,0-5 0,0 4 0,0-6 0,0 1 0,0-2 0,0-7 0,0 0 0,0 2 0,0-2 0,0 0 0,0 0 0,0 0 0,0 1 0,0 6 0,0-5 0,0 11 0,0-4 0,0 7 0,0-7 0,0 4 0,0-11 0,0 5 0,0-6 0,0 0 0,0-1 0,0-5 0,0-3 0,0-5 0,0 0 0,0-1 0,0-3 0,0-4 0,-4-3 0,3-5 0,-3 3 0,4-8 0,0 3 0,0-3 0,0-1 0,0 4 0,0-4 0,0 3 0,0-3 0,0-1 0,4 5 0,0-7 0,5 2 0,3-7 0,-1 0 0,1 0 0,-3-4 0,0-5 0,1-5 0,0-4 0,-1 0 0,2 0 0,-2-1 0,1 6 0,-4-4 0,2 3 0,-7 0 0,8 2 0,-9 4 0,4-5 0,-4 4 0,5-8 0,-4 8 0,4-8 0,-5 7 0,0-7 0,0 4 0,0-6 0,0 1 0,0 0 0,0 0 0,0 4 0,0-2 0,4 2 0,-3-5 0,3 1 0,-4 0 0,5 0 0,-4 4 0,4-2 0,-1 2 0,-3-10 0,3 5 0,1-5 0,-4 6 0,3 0 0,1-8 0,-4 5 0,8-4 0,-8 11 0,3-4 0,-4 10 0,0-10 0,0 9 0,0-8 0,0 4 0,0-1 0,0-4 0,0 4 0,0-3 0,0-2 0,0 5 0,0-2 0,0 7 0,-4-9 0,3 9 0,-8-16 0,8 14 0,-4-15 0,1 13 0,3-5 0,-4 4 0,1-3 0,3 4 0,-3-6 0,4 1 0,-5 0 0,4 4 0,-4-3 0,5 3 0,0-4 0,0 4 0,-4-3 0,3 4 0,-3-5 0,4-1 0,0 5 0,0-2 0,0 2 0,0-5 0,0 2 0,0-2 0,0 5 0,0-3 0,0 4 0,0-5 0,0-4 0,0 3 0,0 1 0,-5 1 0,4 8 0,-4-3 0,5-1 0,0 4 0,0-4 0,0 4 0,0 2 0,0-5 0,0 3 0,0-3 0,0 3 0,-4 1 0,4-3 0,-4 2 0,4-3 0,0 4 0,-4-1 0,3 1 0,-4 1 0,5-5 0,0 3 0,10 29 0,-4-10 0,9 34 0,-5-21 0,6 7 0,-5 0 0,6 0 0,-6-1 0,-1 2 0,1-7 0,-1 0 0,1-7 0,-6 2 0,-1-1 0,-4-4 0,0 2 0,0-6 0,0 3 0,0-5 0,0 0 0,0 3 0,0-1 0,0 2 0,0-4 0,0 0 0,-4 1 0,3-2 0,-7 6 0,7-4 0,-8 9 0,8-9 0,-8 8 0,8-8 0,-7 8 0,6-7 0,-7 6 0,8-2 0,-4 0 0,2 4 0,1 0 0,-2-3 0,4 8 0,-5-5 0,-1-3 0,-4 8 0,1-10 0,3 5 0,-7-3 0,6 1 0,-6-6 0,-2 3 0,0-4 0,-5 0 0,-6 1 0,5-2 0,-5-2 0,1 3 0,3-4 0,-4 0 0,7 4 0,-1-4 0,-4 4 0,8-1 0,-2 0 0,9 1 0,0-5 0,0 4 0,0-4 0,0 5 0,4-1 0,-3 0 0,3-4 0,0 7 0,-3-5 0,3 6 0,-3-4 0,2 0 0,-1-1 0,2 2 0,0-1 0,-3 1 0,3-5 0,-5 7 0,6-5 0,-4 5 0,3-3 0,0 0 0,1 0 0,0 1 0,3-2 0,-3 5 0,4-4 0,0 3 0,0-3 0,0 0 0,0 4 0,4-3 0,1 1 0,4-1 0,-4-1 0,3 0 0,-8 0 0,12-4 0,-6-24 0,-4-5 0,-3-11 0,-5 15 0,1 14 0</inkml:trace>
</inkml:ink>
</file>

<file path=ppt/ink/ink3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9:00.423"/>
    </inkml:context>
    <inkml:brush xml:id="br0">
      <inkml:brushProperty name="width" value="0.35" units="cm"/>
      <inkml:brushProperty name="height" value="0.35" units="cm"/>
      <inkml:brushProperty name="color" value="#FFFFFF"/>
    </inkml:brush>
  </inkml:definitions>
  <inkml:trace contextRef="#ctx0" brushRef="#br0">375 180 24575,'-21'-4'0,"2"-1"0,11-5 0,0 1 0,0 0 0,0 0 0,-3-5 0,1 4 0,3-4 0,-1 5 0,5 0 0,-6 0 0,5-1 0,-3 5 0,3-7 0,-5 6 0,2-3 0,3 1 0,-4 3 0,1-1 0,1-2 0,17 33 0,-2-15 0,13 22 0,-14-17 0,1-1 0,-2-4 0,7 10 0,-6-9 0,5 7 0,-5-7 0,1 9 0,-1-10 0,1 9 0,-2-8 0,7 8 0,-5-4 0,7 6 0,-6 0 0,7-1 0,-4-4 0,1 4 0,8-9 0,-7 9 0,8-8 0,-6 3 0,6-5 0,0 1 0,7 1 0,-1-1 0,0 1 0,0-2 0,0 1 0,-5 0 0,3 1 0,-8-2 0,4-3 0,-5 1 0,-1-7 0,1 4 0,-4-1 0,2-3 0,-7 3 0,3 0 0,1-3 0,-5 4 0,5-5 0,-5 0 0,0 0 0,3 0 0,-1 0 0,1 0 0,-3 0 0,-1 0 0,5 0 0,-3 0 0,2 0 0,-3 0 0,0 0 0,4 0 0,-4 0 0,4 0 0,-5 4 0,2 1 0,-5 4 0,3 4 0,-7-3 0,4 4 0,-4-5 0,0 1 0,4-1 0,-3-1 0,3 2 0,-4 4 0,0-3 0,0 8 0,0-9 0,3 10 0,-2-9 0,3 7 0,-4-7 0,4 9 0,-3-5 0,6 0 0,-6 5 0,7-4 0,-7 10 0,6-4 0,-1 10 0,-1-3 0,3-2 0,-3 6 0,0-6 0,4 8 0,-4-8 0,0 6 0,3-11 0,-3 4 0,0 0 0,2-3 0,-2 3 0,1-5 0,1 0 0,-6 4 0,7-2 0,-7 3 0,6-5 0,-6 0 0,8-1 0,-8 1 0,6-1 0,-6 0 0,7 6 0,-7-5 0,3 4 0,-4-9 0,4 2 0,-4-2 0,4 5 0,-4-1 0,0 1 0,0 0 0,0-1 0,0 1 0,0-1 0,0 0 0,0 1 0,0-1 0,0-4 0,0 10 0,0-10 0,0 11 0,0-6 0,0-1 0,0 1 0,0-1 0,0 1 0,0-5 0,0 11 0,0-14 0,-4 11 0,4-10 0,-4-3 0,0 8 0,3-8 0,-3 8 0,0-9 0,3 10 0,-1-9 0,-2 7 0,3-7 0,-4 9 0,5-10 0,-4 9 0,3-8 0,-2 8 0,3-4 0,0 1 0,0 4 0,0-4 0,0 4 0,0 0 0,-4 0 0,3 1 0,-3 6 0,4-5 0,-4 5 0,3-7 0,-2 1 0,-2 5 0,4-4 0,-4 5 0,1-1 0,3-4 0,-7 13 0,7-5 0,-7 0 0,7-3 0,-7-7 0,7 7 0,-3-5 0,0 4 0,3-5 0,-6-1 0,6-4 0,-3 4 0,-1-5 0,4 1 0,-2 3 0,0-8 0,2 8 0,-7-9 0,7 10 0,-3-5 0,2 1 0,1 3 0,-3-8 0,4 8 0,0-4 0,-4 1 0,3 7 0,-5-6 0,5 3 0,-4-1 0,5-9 0,-4 10 0,3-4 0,-3 4 0,4-4 0,0 3 0,-3-4 0,2 6 0,-3 0 0,0-6 0,3 4 0,-3-3 0,4 4 0,-3-4 0,2 4 0,-2-6 0,3 2 0,-4 4 0,3-4 0,-3-1 0,4 4 0,-4-3 0,3-1 0,-3 4 0,4-8 0,0 4 0,0-7 0,0 2 0,0 3 0,0-2 0,0-41 0,0 11 0,0-38 0,0 22 0,0 2 0,0-8 0,0-2 0,0-6 0,0 0 0,0 0 0,0 0 0,0-8 0,0 13 0,0-11 0,0 19 0,0-4 0,0 6 0,0 0 0,0 1 0,0 4 0,0-3 0,0 10 0,0-10 0,0 9 0,0-12 0,0 6 0,0-2 0,0 4 0,0 7 0,0 0 0,0-6 0,0 3 0,0-9 0,0 4 0,0-6 0,0 0 0,0 0 0,0 0 0,0-6 0,0 4 0,0-5 0,0 1 0,0 5 0,0-6 0,0 7 0,0 0 0,0 6 0,-4-4 0,3 9 0,-4-8 0,5 8 0,-4-9 0,2 10 0,-1-4 0,-2-1 0,4 4 0,-3-2 0,0 4 0,3 1 0,-3-1 0,4 0 0,0 1 0,-4-1 0,3 0 0,-3 1 0,4-1 0,0 1 0,0-7 0,-4 5 0,3-4 0,-2 5 0,3-5 0,0 4 0,0-4 0,-5-1 0,4 4 0,-3-2 0,-1 4 0,5 1 0,-4-7 0,0 4 0,3-3 0,-7 5 0,3-4 0,-4 2 0,0-3 0,0 0 0,0 3 0,-1-3 0,-7-9 0,2 10 0,-8-16 0,5 19 0,0-4 0,0 5 0,-5-1 0,4-4 0,-10-5 0,4 2 0,0 1 0,-4 0 0,10 5 0,-10-5 0,9 0 0,-8 5 0,13 1 0,-7 2 0,9 5 0,-4-2 0,-1-2 0,4 8 0,-2-8 0,3 8 0,-1-9 0,-3 9 0,8-3 0,-8-1 0,0-1 0,3 2 0,-1 0 0,6 4 0,1 1 0,0-1 0,0 1 0,1 0 0,-2 4 0,2-3 0,-2 2 0,2-3 0,-1 4 0,-1-4 0,5 4 0,-7-3 0,7 2 0,-8-2 0,5 3 0,-1-4 0,-1 4 0,2 1 0,-1 0 0,0-2 0,0 2 0,1-4 0,-2 2 0,1-3 0,0 4 0,0-4 0,1 4 0,-2-4 0,2 0 0,-6-1 0,4 1 0,-3-1 0,8 0 0,-4 5 0,4-3 0,-4 3 0,0-4 0,1 0 0,2 0 0,-2 0 0,6 1 0,-1-4 0,-2 2 0,3-3 0,-2 4 0,-1 0 0,3 0 0,-5 1 0,5-1 0,-6 0 0,25 20 0,-12-11 0,17 19 0,-18-14 0,2 4 0,-3 1 0,4-5 0,0 3 0,-4-2 0,4 2 0,-4 1 0,4 1 0,0-1 0,-3 1 0,1-5 0,-1 3 0,3-3 0,-4 4 0,7 1 0,-6-5 0,3 3 0,0-2 0,-5 3 0,6-4 0,-2 3 0,2-3 0,-5 4 0,6 1 0,-4-1 0,5 0 0,-3 1 0,-1-6 0,-3 4 0,4-3 0,-4 4 0,4-4 0,0 4 0,-1-4 0,1 0 0,-19-35 0,11 22 0,-16-25 0</inkml:trace>
</inkml:ink>
</file>

<file path=ppt/ink/ink3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46:00.616"/>
    </inkml:context>
    <inkml:brush xml:id="br0">
      <inkml:brushProperty name="width" value="0.1" units="cm"/>
      <inkml:brushProperty name="height" value="0.1" units="cm"/>
      <inkml:brushProperty name="color" value="#F6630D"/>
    </inkml:brush>
  </inkml:definitions>
  <inkml:trace contextRef="#ctx0" brushRef="#br0">2561 30 24575,'-26'0'0,"4"0"0,-5 0 0,4 0 0,-6 0 0,1 4 0,-19 11 0,8 1 0,-33 14 0,26-8 0,-13 3 0,17-5 0,1-4 0,5 3 0,2-8 0,6 3 0,-1 0 0,6-4 0,1 3 0,4-4 0,1 3 0,0-2 0,0 2 0,4-4 0,-4 1 0,4-1 0,-8 4 0,8-3 0,-3 3 0,4 0 0,3-3 0,-3 3 0,4-4 0,-3 0 0,2 0 0,-4 4 0,5-3 0,-4 3 0,3 0 0,-7-2 0,6 6 0,-6-6 0,2 6 0,-3-2 0,0 3 0,0 0 0,-6 1 0,5 0 0,-9-4 0,8 3 0,-8-3 0,8 0 0,-3 3 0,5-8 0,-5 9 0,3-9 0,-3 8 0,5-7 0,-1 6 0,1-6 0,4 6 0,-4-6 0,8 6 0,-8-6 0,8 6 0,-8-6 0,8 6 0,-4-3 0,1 1 0,2 2 0,-2-7 0,4 8 0,-5-8 0,4 7 0,-3-7 0,4 3 0,-1 0 0,1-3 0,0 3 0,0 0 0,0-3 0,0 3 0,0 0 0,0-3 0,-1 7 0,2-7 0,-2 7 0,1-7 0,0 7 0,-1-2 0,-3 3 0,2 0 0,-2 0 0,3 1 0,0-1 0,1 0 0,-5 0 0,4 1 0,-4-1 0,1 0 0,2 1 0,-6-1 0,6 0 0,-6 0 0,2 5 0,0-3 0,-3 3 0,4-5 0,-1 1 0,-2-1 0,3 0 0,-1 1 0,-2-1 0,-5 8 0,5-6 0,-8 6 0,15-12 0,-7 3 0,7-3 0,-4 5 0,5-5 0,-4 3 0,2-3 0,-2 0 0,4 3 0,0-7 0,-1 7 0,1-7 0,4 7 0,-4-2 0,4-1 0,-5 3 0,1-3 0,3 0 0,-2 3 0,2-3 0,0 4 0,-2-3 0,2 2 0,-3-3 0,-1 4 0,4 0 0,-2 1 0,2-1 0,-4 0 0,1 0 0,-1-3 0,-3 9 0,7-8 0,-7 10 0,7-7 0,-3-1 0,-1-4 0,1 3 0,0-3 0,-1 5 0,-4-1 0,8-4 0,-7 3 0,3-7 0,4 8 0,-6-8 0,6 3 0,-3 0 0,0-3 0,0 7 0,0-7 0,-1 7 0,1-7 0,0 3 0,4 0 0,-3-3 0,2 7 0,-3-7 0,0 7 0,0-3 0,-1 0 0,1 3 0,3-3 0,-2 5 0,2-1 0,0-4 0,-3 3 0,7-3 0,-6 0 0,6 4 0,-2-4 0,-1 4 0,3-4 0,-7 3 0,7-3 0,-6 0 0,6 3 0,-2-7 0,-1 7 0,3-7 0,-3 8 0,4-9 0,0 9 0,0-4 0,0 4 0,0 0 0,0 0 0,0 1 0,0 3 0,0-2 0,0 8 0,0-9 0,0 5 0,0-6 0,0 0 0,0-4 0,0 3 0,3-7 0,2 3 0,3-4 0,-1 0 0,1 0 0,4 0 0,-3 0 0,7 0 0,1 1 0,1-5 0,3 0 0,-8-4 0,8 0 0,-7 0 0,9 0 0,-1 0 0,-4 0 0,5 0 0,-6 0 0,5 0 0,-3 0 0,7 0 0,-2 0 0,-1 0 0,4-4 0,-8-1 0,8 0 0,-4-3 0,6 7 0,-6-7 0,4 3 0,-3 0 0,-1-3 0,5 7 0,-10-7 0,9 7 0,-8-7 0,8 7 0,-4-7 0,1 7 0,3-7 0,-8 3 0,8 0 0,-4-3 0,1 7 0,-2-7 0,0 7 0,-3-7 0,3 3 0,0-4 0,-3 1 0,8-2 0,-3 1 0,4 0 0,0-1 0,1 1 0,-1-1 0,0 1 0,1-1 0,-1 1 0,1-1 0,5 0 0,-4 1 0,9 3 0,10-7 0,-5 7 0,4-9 0,-8 10 0,-10-4 0,4 4 0,-6 0 0,1-4 0,-6 4 0,5 0 0,-10-2 0,4 6 0,-4-7 0,-1 3 0,0 0 0,0-2 0,1 6 0,-1-3 0,0 0 0,1 3 0,-1-3 0,0 0 0,-4 3 0,3-6 0,-3 6 0,5-7 0,-1 7 0,0-7 0,1 8 0,-5-8 0,3 7 0,-3-6 0,4 6 0,1-7 0,-1 7 0,0-6 0,0 6 0,1-7 0,-1 3 0,5 1 0,-3-4 0,3 7 0,-5-3 0,0 0 0,0 3 0,1-6 0,-1 6 0,0-3 0,0 0 0,-4 3 0,4-7 0,-4 4 0,0-5 0,3 5 0,-3-4 0,0 4 0,3-1 0,-7-2 0,7 3 0,-7-1 0,7-2 0,-7 6 0,7-7 0,-3 3 0,1 0 0,2-2 0,-3 6 0,0-7 0,3 7 0,-3-6 0,4 6 0,1-6 0,-1 6 0,0-3 0,9-1 0,-7 4 0,7-3 0,-9 0 0,0 3 0,1-6 0,-1 6 0,0-7 0,0 7 0,1-3 0,-1 1 0,0 2 0,4-11 0,-3 11 0,3-11 0,-4 8 0,16-13 0,-12 7 0,35-14 0,-33 13 0,28-9 0,-31 15 0,20-10 0,-20 13 0,19-13 0,-23 13 0,27-18 0,-30 18 0,34-18 0,-35 15 0,41-11 0,-35 6 0,36-10 0,-33 14 0,27-17 0,-27 16 0,31-21 0,-30 20 0,25-18 0,-27 19 0,15-16 0,-20 14 0,15-14 0,-19 13 0,8-5 0,-8 4 0,8-12 0,-5 8 0,1-27 0,-11 25 0,-4-57 0,-5 35 0,-4-29 0,-2-4 0,-3 14 0,-2-15 0,3 1 0,6 21 0,-2-4 0,0 1 0,2 11 0,-7-42 0,5 51 0,0-25 0,0 33 0,-4-22 0,4 27 0,-7-28 0,10 28 0,-17-36 0,16 34 0,-25-33 0,21 35 0,-29-27 0,23 27 0,-36-28 0,26 27 0,-46-41 0,36 31 0,-24-29 0,29 29 0,-7-20 0,13 27 0,-12-28 0,19 36 0,-10-28 0,11 29 0,-9-22 0,12 26 0,-11-13 0,17 16 0,-21-6 0,18 9 0,-26-8 0,22 8 0,-20-9 0,17 9 0,-12-8 0,17 8 0,-21-5 0,24 3 0,-40-4 0,32 3 0,-28-6 0,28 5 0,-8-1 0,13 6 0,-4 2 0,9 3 0,-9 0 0,9 0 0,-6 0 0,7 0 0,4 0 0,1 0 0</inkml:trace>
</inkml:ink>
</file>

<file path=ppt/ink/ink3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47:47.839"/>
    </inkml:context>
    <inkml:brush xml:id="br0">
      <inkml:brushProperty name="width" value="0.1" units="cm"/>
      <inkml:brushProperty name="height" value="0.1" units="cm"/>
      <inkml:brushProperty name="color" value="#66CC00"/>
    </inkml:brush>
  </inkml:definitions>
  <inkml:trace contextRef="#ctx0" brushRef="#br0">1609 3020 24575,'27'-71'0,"7"16"0,3 2 0,-6 7 0,28-25 0,-45 35 0,-12 19 0,16-20 0,-16 25 0,8 0 0,-6 5 0,1-1 0,2 0 0,-7 0 0,7 0 0,-2 0 0,2 1 0,-2-1 0,2 0 0,-3 4 0,4-3 0,0 2 0,-4-2 0,3-1 0,-3 4 0,4-3 0,-4 2 0,3 1 0,-2-3 0,-1 3 0,3-4 0,-3 4 0,4-3 0,0 2 0,0-3 0,0 4 0,-1-3 0,1 3 0,-4-4 0,3 0 0,-2 0 0,3 1 0,-1 2 0,1-2 0,0 3 0,0-4 0,0 0 0,-1 4 0,-2-3 0,2 3 0,-3-4 0,0 0 0,3 0 0,-2 4 0,2-3 0,-2 3 0,2-4 0,-3 0 0,4 0 0,-4 1 0,3-1 0,-3 0 0,4 0 0,-3 0 0,2 1 0,-3-1 0,0-4 0,3 3 0,1-11 0,1 6 0,3-2 0,-4 4 0,1 0 0,-2 3 0,2-7 0,-5 7 0,4-3 0,-4 0 0,4 3 0,0-3 0,1 0 0,-1 3 0,0-3 0,-4 4 0,3-4 0,-2 3 0,3-3 0,0 4 0,0 1 0,0-5 0,0 3 0,0-3 0,0 4 0,-4 0 0,3 0 0,-3 1 0,4-1 0,0 0 0,-4 0 0,3 4 0,-3-3 0,1 2 0,2-2 0,-3-1 0,0 0 0,3 0 0,-2 0 0,2 1 0,-2-1 0,2 0 0,-3 0 0,0 0 0,3 1 0,-2-5 0,3 3 0,-3-3 0,2 4 0,-3 0 0,4 0 0,0 1 0,-4-1 0,3-4 0,-2 3 0,3-3 0,0 4 0,0-4 0,0 3 0,0-3 0,0 0 0,0 3 0,0-3 0,0 0 0,0 3 0,1-7 0,-1 7 0,4-3 0,-3 1 0,7 1 0,-7-1 0,3-1 0,0 3 0,-3-3 0,3 3 0,0-3 0,-3 3 0,3-3 0,-4 5 0,0-1 0,0 0 0,-1 0 0,5 0 0,-2-4 0,2 3 0,-4-3 0,0 4 0,0 0 0,0-4 0,0 3 0,3-6 0,-2 6 0,2-2 0,-3 3 0,0 0 0,0 0 0,-1 1 0,1-1 0,0 0 0,0 0 0,0 0 0,-1 1 0,1-1 0,-3 0 0,2 0 0,-3 0 0,4 1 0,-1-1 0,1 0 0,0 4 0,-4-3 0,3 3 0,-6-4 0,6 4 0,-3-3 0,4 3 0,-4-4 0,3 4 0,-3-3 0,4 2 0,0 1 0,-1-3 0,1 3 0,0-4 0,0 0 0,0 0 0,-1 1 0,1 2 0,0-2 0,-4 3 0,3-4 0,-2 0 0,3 4 0,-1-3 0,1 3 0,0-4 0,0 0 0,0 4 0,-4-3 0,3 3 0,-3-4 0,4 0 0,-1 0 0,1 1 0,-4-1 0,3 4 0,-2-3 0,-1 2 0,3-2 0,-3-1 0,1 0 0,-2 0 0,1 4 0,-4-3 0,7 2 0,-6-2 0,3-1 0,-4 0 0,3 0 0,-2 0 0,3 1 0,-4-1 0,3 0 0,-2 0 0,2 0 0,1-3 0,-3 2 0,2-2 0,-3 3 0,0-4 0,0 4 0,0-9 0,0 4 0,0 0 0,0-3 0,0 3 0,0 0 0,0-3 0,0 2 0,0-3 0,0 4 0,0-3 0,0 3 0,0 0 0,0-3 0,0 7 0,0-3 0,0 0 0,0 3 0,0-3 0,0 0 0,0 3 0,0-3 0,0-4 0,0 7 0,0-11 0,-3 11 0,-2-3 0,1 0 0,-3 3 0,3-3 0,-1 0 0,-1 3 0,1-7 0,-3 7 0,0-3 0,0 4 0,0-4 0,0 4 0,0-4 0,4 4 0,-3 0 0,2 0 0,-3-4 0,0 3 0,0-3 0,4 5 0,-3-1 0,2 0 0,-2 0 0,-1 0 0,0 1 0,0-1 0,0 3 0,1-2 0,-5 3 0,7-4 0,-5 4 0,5-3 0,-2 6 0,-1-6 0,0 6 0,0-6 0,0 7 0,1-4 0,-1 1 0,-4 2 0,3-6 0,-3 6 0,0-6 0,3 2 0,-3 1 0,0-4 0,3 7 0,-7-6 0,3 6 0,0-7 0,-3 8 0,3-8 0,-5 7 0,-4-7 0,4 7 0,-5-7 0,6 7 0,-5-3 0,3 4 0,-3-4 0,-8 4 0,10-4 0,-15 4 0,11 0 0,1 0 0,-4 0 0,3 0 0,1 0 0,1 0 0,0 0 0,3 0 0,-3 0 0,9 0 0,-3 0 0,3 0 0,0 0 0,1 3 0,-1-2 0,5 2 0,-4 1 0,4-3 0,0 2 0,0 1 0,0-3 0,1 2 0,-1-3 0,0 0 0,0 0 0,0 0 0,1 0 0,-5 0 0,3 0 0,-3 0 0,0 0 0,3 0 0,-7 0 0,3 0 0,-5 0 0,1 0 0,0 0 0,-1 0 0,-4 0 0,4 0 0,-10 0 0,5 0 0,-6 0 0,1 0 0,0 0 0,-1 0 0,1 0 0,-1 4 0,1-3 0,4 4 0,-3-5 0,9 3 0,-9-2 0,0 7 0,-2-7 0,3 3 0,-1-4 0,8 4 0,-8-3 0,4 3 0,-6 0 0,-5-3 0,4 3 0,-4-4 0,0 0 0,4 4 0,-10-3 0,10 3 0,-10-4 0,11 5 0,-6 0 0,1 0 0,4 4 0,-4-4 0,0 5 0,4-1 0,-4 1 0,6 0 0,4-1 0,-3 0 0,4 4 0,-1 1 0,2 4 0,0 1 0,3-2 0,-12 14 0,11-6 0,-6 6 0,12-4 0,-3-3 0,6 4 0,-2-4 0,-1 3 0,4-4 0,-3 6 0,7-6 0,-2 4 0,3-3 0,-8-1 0,7 0 0,-11-1 0,11-4 0,-11 5 0,4-6 0,0-4 0,-3 3 0,-2-2 0,-1 3 0,-3-3 0,5 3 0,-6-3 0,5 0 0,-4 3 0,0-3 0,7-1 0,-6 4 0,8-8 0,-4 4 0,3-1 0,-5 1 0,4 4 0,-1-4 0,4-1 0,4 0 0,0-3 0,-1 3 0,1 0 0,0-3 0,0 7 0,3-7 0,-2 3 0,2 0 0,-3-3 0,4 3 0,-4 0 0,4-3 0,-5 7 0,5-7 0,-4 7 0,4-7 0,-1 7 0,-2-3 0,6 0 0,-7 3 0,7-2 0,-6 3 0,6 0 0,-3 0 0,0 1 0,3 12 0,-7-5 0,7 6 0,-3-4 0,0-3 0,3 4 0,-8-4 0,9 3 0,-9-4 0,8 1 0,-7 3 0,7-8 0,-3 3 0,0-5 0,3-4 0,-3 3 0,1-7 0,2 8 0,-3-9 0,4 9 0,0-9 0,0 9 0,0-4 0,0 0 0,0 2 0,0-2 0,0 8 0,0-2 0,0 3 0,0 0 0,0 2 0,0-1 0,0 4 0,0-8 0,0 8 0,0-8 0,0 8 0,4-9 0,1 10 0,4-5 0,0 1 0,1 3 0,-1-4 0,0 1 0,0 3 0,1-4 0,-1 1 0,4 3 0,-3-8 0,7 3 0,-7-5 0,7 5 0,-7-3 0,7 3 0,-4-5 0,1 1 0,-2-5 0,0 3 0,-3-3 0,3 0 0,1 0 0,-4-1 0,3-3 0,-4 3 0,0-4 0,0-1 0,0-2 0,-1 2 0,1-6 0,0 6 0,0-7 0,0 4 0,4 0 0,-3-3 0,3 3 0,0-1 0,-4-2 0,4 7 0,0-7 0,2 6 0,-1-6 0,3 6 0,-7-2 0,7 3 0,-3 1 0,4-1 0,-4 1 0,3-1 0,-7 0 0,8 1 0,-4-1 0,0 0 0,3 4 0,-7-3 0,7 4 0,-7-5 0,7 0 0,1 4 0,-3-3 0,5 3 0,-10-4 0,3 0 0,-4 0 0,4 0 0,-3-3 0,3 2 0,-4-6 0,-1 6 0,1-6 0,0 2 0,0 0 0,0-2 0,4 7 0,-3-7 0,3 6 0,-5-6 0,1 2 0,0-3 0,0 0 0,0 0 0,4 4 0,-4-3 0,4 3 0,-4-4 0,0 0 0,0 3 0,0-2 0,-1 6 0,1-6 0,4 6 0,-4-6 0,3 6 0,-3-6 0,0 6 0,0-7 0,4 8 0,-3-7 0,3 6 0,-4-6 0,-1 6 0,1-6 0,0 6 0,0-7 0,0 7 0,-1-6 0,1 6 0,4-6 0,-3 3 0,3-1 0,-4-2 0,0 6 0,4-6 0,-3 2 0,3 1 0,-5-4 0,1 7 0,0-6 0,0 6 0,0-6 0,-1 3 0,1-1 0,0-2 0,0 2 0,3 1 0,-2-3 0,2 2 0,-7 1 0,3-4 0,-3 4 0,1-1 0,1-2 0,-2 2 0,0 1 0,0 0 0,-4 0 0,0-1 0</inkml:trace>
</inkml:ink>
</file>

<file path=ppt/ink/ink3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20.972"/>
    </inkml:context>
    <inkml:brush xml:id="br0">
      <inkml:brushProperty name="width" value="0.2" units="cm"/>
      <inkml:brushProperty name="height" value="0.2" units="cm"/>
      <inkml:brushProperty name="color" value="#FFFFFF"/>
    </inkml:brush>
  </inkml:definitions>
  <inkml:trace contextRef="#ctx0" brushRef="#br0">0 162 24575,'54'0'0,"-1"0"0,41-4 0,-62 4 0,4-7 0,-19 6 0,5-6 0,-11 6 0,14-6 0,-2 0 0,1 2 0,0-5 0,-9 6 0,1-1 0,6-1 0,-6 2 0,2 0 0,-3-2 0,0 1 0,14-2 0,-6 2 0,7-1 0,-10 5 0,-5-6 0,5 6 0,-4-2 0,15-1 0,-2-1 0,5 1 0,-7 0 0,4 1 0,-9 2 0,6-3 0,2 1 0,-5 2 0,3-3 0,-6 4 0,-6 0 0,-1 0 0,0 0 0,1 0 0,-1 0 0,-4 0 0,4-3 0,-4 2 0,1-3 0,2 4 0,-2 0 0,3 0 0,-4 0 0,4 0 0,-4 0 0,5 0 0,-1 0 0,5 0 0,-4 0 0,4 0 0,-5-3 0,0 2 0,5-2 0,-4 3 0,4 0 0,-5 0 0,0 0 0,7 0 0,-5 0 0,6 0 0,-8 0 0,0 0 0,-3 0 0,2 0 0,-3 0 0,1 0 0,2 0 0,-6 0 0,7 0 0,-8 0 0,8 0 0,-7 0 0,2 0 0,-3 3 0,4-2 0,-3 5 0,2-6 0,-3 4 0,0-1 0,0-3 0,3 3 0,-2-3 0,7 0 0,-8 3 0,4-2 0,0 2 0,-3-3 0,6 0 0,-3 0 0,5 0 0,-5 3 0,10-2 0,-7 2 0,8-3 0,-7 4 0,0-4 0,1 4 0,-1-1 0,0-2 0,0 6 0,-3-6 0,2 5 0,-2-5 0,-1 6 0,3-3 0,-6 0 0,6 3 0,-2-3 0,-1 3 0,0-3 0,0 3 0,-3-7 0,2 7 0,1-6 0,-3 5 0,2-2 0,1 0 0,-3-1 0,2 0 0,-3-3 0,0 3 0,0 1 0,4-4 0,0 3 0,0 0 0,-1-2 0,-3 2 0,0-3 0,0 3 0,-1-2 0,1 2 0,0-3 0,0 0 0,0 3 0,0-2 0,0 2 0,0-3 0,-1 0 0,1 0 0,0 3 0,0-2 0,0 2 0,0-3 0,0 0 0,0 0 0,-1 0 0,1 0 0,0 0 0,0 0 0,0 0 0,4 0 0,-4 3 0,4-2 0,0 2 0,-3-3 0,2 0 0,1 0 0,-3 0 0,2 3 0,-3-2 0,4 2 0,-3 0 0,2-2 0,-3 2 0,4 0 0,-3-2 0,2 5 0,-3-2 0,0 0 0,0 2 0,0-5 0,0 5 0,0-2 0,-1 0 0,-2 2 0,2-5 0,-5 5 0,8-2 0,-7 3 0,7-4 0,-5 3 0,3-2 0,0 0 0,-4 2 0,3-2 0,-5 2 0,5 1 0,-5 0 0,5-3 0,-5 2 0,2-2 0,0 2 0,0 1 0,1 0 0,-1 0 0,-3 0 0,0 0 0,3-1 0,-2 1 0,2 0 0,-3 0 0,3 0 0,-2 4 0,2-4 0,-3 4 0,0-4 0,0 4 0,0-4 0,0 8 0,0-7 0,0 2 0,0-3 0,0 0 0,0 3 0,0-2 0,0 2 0,0-3 0,0-1 0,-3 1 0,2 0 0,-2 0 0,0 0 0,2 0 0,-2 0 0,0 0 0,2 0 0,-5 0 0,5-1 0,-2 1 0,0 0 0,2 4 0,-5-3 0,6 2 0,-7-3 0,7 0 0,-6 0 0,1 4 0,1-4 0,-2 4 0,2 0 0,-7-3 0,0 9 0,-5-4 0,5 5 0,0-6 0,0 2 0,3-6 0,-2 3 0,2-1 0,1-2 0,0 3 0,0-4 0,0-1 0,0 5 0,0-3 0,0 3 0,0-5 0,0 1 0,0 0 0,0 4 0,0-3 0,3 2 0,-2 1 0,1 0 0,-2 1 0,0 2 0,-1-2 0,1 3 0,-1-4 0,-3 4 0,3-4 0,-3 5 0,4-1 0,-4 7 0,2-5 0,-2 5 0,4-10 0,-1 2 0,1-2 0,3-1 0,-3 3 0,3-6 0,-3 3 0,-1-1 0,5-2 0,-4 3 0,3-4 0,-3 0 0,4 3 0,-4-2 0,4 3 0,-4-4 0,0 0 0,3-1 0,-3 5 0,4-3 0,-5 3 0,1-5 0,4 1 0,-4 0 0,4 0 0,-1 0 0,-2 0 0,2 0 0,-3 0 0,0 3 0,0-3 0,0 3 0,3-3 0,-2 0 0,2-3 0,1 2 0,-4-2 0,4 3 0,-4-3 0,0 2 0,3-2 0,-2 2 0,2 1 0,-3 0 0,3 0 0,-2 0 0,2 0 0,-2 0 0,-1 0 0,0-1 0,0 1 0,0 0 0,0 0 0,0 0 0,1 0 0,-1 0 0,0 0 0,0-1 0,0 1 0,0 0 0,0 4 0,0-3 0,0 2 0,0-3 0,0 0 0,-4 0 0,3 4 0,-3-3 0,4 3 0,0-1 0,0-2 0,0 3 0,0-4 0,0 3 0,0-2 0,-1 3 0,1-4 0,1 0 0,2 0 0,-2-1 0,2-2 0,0 2 0,-2-5 0,5 5 0,-8-2 0,4 0 0,-4-1 0,2-3 0,0 0 0,0 0 0,-8 0 0,-9 0 0,-3 0 0,-5 0 0,2 0 0,4-4 0,-10-1 0,10-3 0,-4-1 0,5 4 0,0-2 0,0 6 0,4-3 0,-3 0 0,8 4 0,-4-4 0,5 4 0,-1 0 0,1 0 0,0 0 0,3 0 0,-2 0 0,6 0 0,-6 0 0,6 0 0,-3 0 0,1 0 0,2 0 0,-3 3 0,5-2 0,-1 5 0,0-5 0,0 2 0,0 0 0,0-3 0,-4 7 0,0-6 0,0 5 0,1-5 0,6 5 0,-2-5 0,2 2 0,-6-3 0,2 3 0,-3-2 0,4 2 0,0 0 0,1-2 0,-1 2 0,0-3 0,0 3 0,0-2 0,-4 2 0,4 0 0,-4-3 0,4 4 0,-4-4 0,4 3 0,-4-3 0,4 3 0,-4-3 0,4 0 0,-4 3 0,0-2 0,3 2 0,-2-3 0,3 0 0,-3 0 0,-1 0 0,0 0 0,0 0 0,0 0 0,4 0 0,-8 0 0,7 0 0,-6 0 0,6 0 0,-2 0 0,-1 0 0,3 0 0,-2 0 0,3 0 0,0 0 0,0 0 0,0 0 0,0 0 0,1 0 0,-5 0 0,3 0 0,-3 0 0,5 0 0,-1 0 0,0 0 0,0 0 0,0 0 0,0 0 0,0 0 0,-3 0 0,3 0 0,-3 0 0,3 0 0,0 0 0,0 0 0,0 0 0,1 0 0,-1 0 0,3-3 0,-2 2 0,6-8 0,-4 5 0,4-6 0,0 3 0,0 0 0,0-4 0,-3 4 0,3-4 0,-3 4 0,3-4 0,-4 4 0,4-4 0,-7 0 0,6 3 0,-5-2 0,2-1 0,0 3 0,-6-9 0,8 8 0,-7-4 0,8 6 0,-5 0 0,2 0 0,0 0 0,-2 3 0,2-2 0,-3 2 0,4-3 0,-3 1 0,2-1 0,0 0 0,-2 3 0,2-2 0,0 2 0,-2-3 0,2 0 0,0 0 0,-2 1 0,5-1 0,-5 0 0,2 0 0,1 0 0,-3 0 0,2 3 0,0-2 0,-2 2 0,5-6 0,-8-1 0,7-1 0,-7 2 0,5 3 0,-3-3 0,0 2 0,0-3 0,0 1 0,0 2 0,-1-3 0,1 1 0,0-2 0,-1 1 0,-3-4 0,3 4 0,-3-5 0,0 1 0,3 0 0,-4-5 0,1 4 0,3-4 0,-4 5 0,5 0 0,-1-1 0,1 1 0,-1 0 0,0 0 0,1-1 0,2 5 0,-1-4 0,-2-7 0,-1 3 0,-2-7 0,3 11 0,4-1 0,-3 5 0,3-3 0,0 2 0,-2 1 0,2-7 0,0 10 0,-2-10 0,5 10 0,-6-2 0,7 3 0,-3-4 0,-1 3 0,4-2 0,-3 3 0,-1-4 0,3 3 0,-2-2 0,0 3 0,2 0 0,-5 0 0,5-3 0,-2 2 0,0-3 0,2 4 0,-2-3 0,3 2 0,-3-3 0,2 0 0,-2 4 0,3-4 0,0-3 0,-3 6 0,3-6 0,-3 3 0,3 4 0,0-4 0,0 0 0,0 4 0,0-8 0,0 7 0,0-6 0,0 6 0,0-2 0,0-1 0,0 3 0,0-2 0,0 3 0,0 0 0,0 0 0,0 0 0,0 0 0,0-3 0,0 2 0,0-2 0,0 3 0,0 0 0,0-4 0,0 3 0,0-6 0,0 6 0,0-6 0,0 6 0,0-3 0,0 4 0,0 0 0,0 1 0,0-1 0,0 0 0,0 0 0,0 0 0,0 1 0,0-1 0,0 1 0,2 2 0,5 1 0,0 3 0,2 0 0,-3-2 0,-2-2 0,-1-3 0,0 4 0,-2-4 0,2 4 0,-3-4 0,3 0 0,-3 0 0,7 4 0,-4 0 0,4 3 0,-1 0 0,-3 3 0,0 3 0,0-2 0,-2 5 0,2-6 0,-1 1 0,-1 4 0,5-7 0,-5 8 0,2-5 0,-3 2 0,0 0 0</inkml:trace>
</inkml:ink>
</file>

<file path=ppt/ink/ink3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25.266"/>
    </inkml:context>
    <inkml:brush xml:id="br0">
      <inkml:brushProperty name="width" value="0.2" units="cm"/>
      <inkml:brushProperty name="height" value="0.2" units="cm"/>
      <inkml:brushProperty name="color" value="#FFFFFF"/>
    </inkml:brush>
  </inkml:definitions>
  <inkml:trace contextRef="#ctx0" brushRef="#br0">263 1 24575,'0'22'0,"0"1"0,0-15 0,0 7 0,0-4 0,0 4 0,0 1 0,0 13 0,0-1 0,0 4 0,0-7 0,0-7 0,0-2 0,0-1 0,0-1 0,0-3 0,0 0 0,0-1 0,-3-3 0,2 0 0,-2 0 0,3 0 0,0 0 0,0 3 0,0-2 0,0 3 0,0-4 0,0 0 0,0-1 0,0 1 0,0 4 0,0-3 0,0 6 0,0-6 0,0 2 0,0 1 0,0 0 0,0 1 0,0 2 0,0-6 0,0 6 0,0-2 0,-3 3 0,2 1 0,-2-1 0,3 0 0,0 0 0,-4 7 0,3-5 0,-2 10 0,3-11 0,-4 8 0,3-7 0,-2 7 0,-1-8 0,3 8 0,-2-8 0,-1 9 0,3-9 0,-2 4 0,-1-5 0,3 0 0,-2 5 0,3-8 0,-4 11 0,3-10 0,-2 3 0,3 3 0,0-7 0,0 8 0,-4-5 0,3 1 0,-2-1 0,3 0 0,0 0 0,0 1 0,0-1 0,0 0 0,0 1 0,0 6 0,0-5 0,0 1 0,0-4 0,-3-2 0,2 3 0,-3-3 0,4 2 0,0-3 0,0 5 0,0 3 0,0-2 0,0 2 0,0 1 0,-3-4 0,2 8 0,-2-3 0,-1 4 0,3 0 0,-6-4 0,6 8 0,-6-7 0,6 8 0,-6-4 0,6-1 0,-7 0 0,7 5 0,-6-3 0,6 8 0,-3-9 0,0 21 0,3-13 0,-3 9 0,4-8 0,0-9 0,0 4 0,0 0 0,0-3 0,-4 8 0,3-9 0,-3 4 0,4 0 0,0-3 0,0 3 0,0-5 0,0 0 0,-4 0 0,3-4 0,-2 3 0,-1-7 0,3 7 0,-2-8 0,-1 4 0,4-9 0,-4 4 0,1-4 0,2 4 0,-2 1 0,-1-1 0,3 0 0,-2 0 0,0 1 0,2 10 0,-6-3 0,6 4 0,-3-3 0,4-3 0,0 9 0,-4-4 0,3 10 0,-2-10 0,3 9 0,0-3 0,0 4 0,0 6 0,0-4 0,0 4 0,0-5 0,0-1 0,0 0 0,0 1 0,0-1 0,0-5 0,0 5 0,0-10 0,0 4 0,0 1 0,0-5 0,0 4 0,0-5 0,0 0 0,0 1 0,0-6 0,0 4 0,0-3 0,0 4 0,0 0 0,0 1 0,0-1 0,0-5 0,0 4 0,0-7 0,0 7 0,0-8 0,0 8 0,0-7 0,0 2 0,0 1 0,0-4 0,0 8 0,0-7 0,0 7 0,-4-8 0,3 8 0,-2-8 0,0 4 0,2-5 0,-3 5 0,1-4 0,2 4 0,-2-5 0,-1 0 0,3 0 0,-2 1 0,0-1 0,2 0 0,-3-3 0,4 2 0,-3-2 0,2 6 0,-2-6 0,3 6 0,0-7 0,0 5 0,0-5 0,0 3 0,0-2 0,0 3 0,0 1 0,0 3 0,0-2 0,0 7 0,0-8 0,0 4 0,0-1 0,3-3 0,2 8 0,2-8 0,1 4 0,0-5 0,-1-3 0,1 2 0,-1-6 0,1 6 0,-1-6 0,3 6 0,-2-3 0,2 0 0,-3 0 0,4-4 0,-3 4 0,6-3 0,-2 3 0,0 0 0,2-2 0,-5 2 0,5-4 0,-6 0 0,6 1 0,-2 2 0,-1-2 0,4 3 0,-8-4 0,4 1 0,0 2 0,-4-2 0,8 3 0,-7 0 0,6-3 0,-5 6 0,5-5 0,-6 5 0,7-5 0,-7 5 0,7-5 0,0 9 0,-2-6 0,1 3 0,-7 0 0,4-7 0,-3 2 0,3 1 0,-4-3 0,0 3 0,-3 0 0,2-4 0,-5 4 0,2 0 0,1 0 0,-3 4 0,2 1 0,1 3 0,-3-2 0,2 2 0,-3-3 0,0-1 0,4 0 0,-3-3 0,2-2 0,-3-3 0,0 0 0,0 0 0,0 0 0,0 0 0,0 0 0,3 0 0,-2-1 0,2 1 0,-3 0 0,0 0 0,0 0 0,0 3 0,0-2 0,0 2 0,0-4 0,3 1 0,-2 0 0,2 0 0,-3 0 0,0-1 0</inkml:trace>
</inkml:ink>
</file>

<file path=ppt/ink/ink3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30.472"/>
    </inkml:context>
    <inkml:brush xml:id="br0">
      <inkml:brushProperty name="width" value="0.2" units="cm"/>
      <inkml:brushProperty name="height" value="0.2" units="cm"/>
      <inkml:brushProperty name="color" value="#FFFFFF"/>
    </inkml:brush>
  </inkml:definitions>
  <inkml:trace contextRef="#ctx0" brushRef="#br0">1 5447 24575,'0'21'0,"0"-4"0,0-3 0,0-6 0,0 7 0,0-8 0,0 18 0,0-12 0,3 18 0,-2-18 0,2 6 0,-3-11 0,0 2 0,3-3 0,-2 3 0,2-2 0,-3 3 0,3-4 0,-3 0 0,3 0 0,-3-1 0,4 1 0,-4 0 0,3 0 0,0 0 0,-2 0 0,2 0 0,0-3 0,-2 2 0,2-2 0,0 2 0,-2 1 0,2 0 0,0-3 0,1 5 0,0-4 0,2 2 0,-5-1 0,2-2 0,0 3 0,-2 0 0,5-1 0,-6 1 0,6 0 0,-5 0 0,2-1 0,0 1 0,-2 0 0,5-3 0,-6 2 0,4-2 0,-1 3 0,-3 0 0,6 0 0,-5-1 0,5 1 0,-5 0 0,2 0 0,0 0 0,-2 0 0,5-1 0,-5 1 0,5 0 0,-6 0 0,4 0 0,-1 0 0,-3 0 0,7 0 0,-7-1 0,6 1 0,-5 0 0,5-3 0,-5 2 0,5-2 0,-5 3 0,5 0 0,-2-1 0,2-2 0,1-1 0,-1-3 0,1 0 0,0 0 0,0 0 0,-1 0 0,1 0 0,0 0 0,0 0 0,0 0 0,-1 0 0,1 0 0,0 0 0,0 0 0,-4-3 0,4-1 0,-4-3 0,1 0 0,2 1 0,-5-1 0,5 0 0,-5 0 0,2 0 0,-3 1 0,3-1 0,-2 0 0,2 0 0,-3 0 0,3 3 0,-3-2 0,4-2 0,-4 1 0,0-4 0,0 4 0,3 0 0,-3 0 0,3-3 0,-3 2 0,4-10 0,-4 10 0,6-6 0,-5 4 0,2 2 0,0-3 0,-2 4 0,5-3 0,-5 3 0,2-3 0,-3 3 0,0 0 0,0 0 0,0 0 0,0 0 0,0 0 0,0 0 0,0 0 0,0 1 0,0-1 0,0 0 0,0 0 0,3-4 0,-2 3 0,6-6 0,-6 3 0,6-5 0,-3 5 0,3-4 0,-3 4 0,3-4 0,-6-1 0,5 5 0,-2-7 0,4 6 0,-1-3 0,0 5 0,-3-1 0,6-3 0,-5-3 0,5 3 0,-3-1 0,-3 8 0,3-8 0,-3 7 0,0-6 0,2 6 0,-2-2 0,0 3 0,3-4 0,-4 3 0,2-2 0,-2 3 0,0 0 0,-2 0 0,2 0 0,0 0 0,-3 0 0,3 0 0,1 0 0,-4 1 0,3-1 0,0-3 0,-2 2 0,2-2 0,0 3 0,-2 0 0,5 1 0,-5-1 0,5 0 0,-5 0 0,5-4 0,-5 4 0,6-4 0,-7 4 0,7 0 0,-4 0 0,1 0 0,2 0 0,-2 1 0,0-1 0,2 0 0,-2 0 0,3 0 0,0 3 0,0-2 0,0 2 0,0-3 0,-1 3 0,1-2 0,0 6 0,0-7 0,0 4 0,0-1 0,0-2 0,0 5 0,-1-5 0,1 5 0,0-2 0,0 0 0,0 2 0,0-2 0,0 0 0,-1 3 0,1-4 0,0 1 0,0 3 0,0-3 0,0 0 0,0 2 0,-3-5 0,2 5 0,-2-2 0,2 0 0,1-1 0,0 0 0,0-2 0,0 2 0,0 0 0,0-2 0,0 2 0,-3-3 0,2 4 0,1-7 0,-3 6 0,5-6 0,-5 6 0,3-2 0,-3 2 0,2-3 0,-5 0 0,5 0 0,-2 0 0,3 1 0,-3-1 0,2 0 0,-2 0 0,2 0 0,-2-4 0,2 4 0,-2-4 0,4 0 0,-5 3 0,4-2 0,-3 3 0,0 0 0,-1 0 0,0 0 0,-3 0 0,4 0 0,-1 1 0,-3-1 0,3 0 0,0 0 0,-2-4 0,2 3 0,1-6 0,-3-1 0,5-1 0,-5 2 0,3-1 0,-1 4 0,-2-1 0,2-2 0,-3 2 0,0 1 0,4-10 0,-4 11 0,4-11 0,-4 10 0,3-5 0,-2 1 0,2 0 0,1 0 0,-3-1 0,2 1 0,-3 3 0,0-2 0,3 3 0,-2-1 0,3-2 0,-1 2 0,-2-3 0,5 3 0,-5-2 0,6 2 0,-7-3 0,7 0 0,-3-7 0,1 5 0,1-2 0,-5 5 0,5 2 0,-5-3 0,6 0 0,-3 0 0,1 0 0,1-1 0,-1 1 0,-1-4 0,3 2 0,-3-2 0,0-1 0,3 4 0,-3-8 0,4 8 0,0-8 0,-4 8 0,4-8 0,-3 3 0,3-4 0,-3 0 0,2 0 0,-6-1 0,6 1 0,-6 0 0,3 0 0,-4-5 0,0 3 0,0-3 0,0 0 0,0 3 0,0-19 0,0 17 0,0-17 0,0 14 0,0 1 0,0-4 0,0 9 0,0-4 0,0 0 0,0 4 0,0-5 0,0 7 0,0-2 0,0 2 0,0-1 0,0 0 0,0 4 0,0-3 0,0 3 0,0 0 0,0 2 0,0-1 0,0 4 0,0-8 0,0 7 0,0-7 0,-4 3 0,3-4 0,-6-11 0,2 8 0,-3-13 0,-1 14 0,0-8 0,0-2 0,0-1 0,-1-4 0,1 6 0,4-6 0,-3-2 0,3 0 0,-1 2 0,-2 6 0,7-6 0,-7 4 0,7-5 0,-3 7 0,4 0 0,-4-1 0,3 6 0,-3-5 0,4 5 0,0-1 0,-4-3 0,3 9 0,-3-9 0,4 3 0,0-4 0,0 4 0,0-3 0,0 3 0,0-10 0,0 9 0,0-3 0,0 15 0,0-3 0,0 7 0,0-2 0,0 3 0,0-3 0,0 2 0,0-7 0,0-7 0,0 3 0,0-8 0,0 6 0,0-2 0,0-4 0,0 4 0,0-3 0,0 4 0,0-6 0,0 6 0,0-5 0,0 5 0,0 0 0,0 0 0,0 6 0,0 0 0,0 0 0,0 0 0,0 0 0,0-17 0,0 13 0,0-17 0,0 19 0,0-3 0,0 5 0,0 0 0,0 0 0,0 0 0,0-1 0,0 1 0,0 0 0,0 4 0,0 2 0,0 4 0,0-5 0,0 3 0,0 2 0,0 0 0,-4 4 0,4-1 0,-4 2 0,4-1 0,-3 3 0,2-2 0,-2 3 0,3 0 0,-3 0 0,2-4 0,-2 3 0,0-2 0,3 3 0,-3-4 0,-1 4 0,4-7 0,-3 6 0,3-6 0,-3 7 0,2-8 0,-2 4 0,3-4 0,0 3 0,-4-2 0,3 2 0,-2 1 0,3 0 0,0 4 0,-3 0 0,2 0 0,-2 0 0,0 4 0,2-4 0,-5 4 0,6-4 0,-6 3 0,2 2 0,-2 2 0,-1 0 0,1 0 0,-1 0 0</inkml:trace>
</inkml:ink>
</file>

<file path=ppt/ink/ink3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40.462"/>
    </inkml:context>
    <inkml:brush xml:id="br0">
      <inkml:brushProperty name="width" value="0.35" units="cm"/>
      <inkml:brushProperty name="height" value="0.35" units="cm"/>
      <inkml:brushProperty name="color" value="#FFFFFF"/>
    </inkml:brush>
  </inkml:definitions>
  <inkml:trace contextRef="#ctx0" brushRef="#br0">461 2003 24575,'31'0'0,"-2"0"0,-17 0 0,-1 0 0,0 0 0,-4 0 0,4 0 0,6-7 0,0 6 0,0-6 0,-6 7 0,-5 0 0,4-3 0,-2 2 0,2-2 0,0 3 0,-2-3 0,2 2 0,-1-2 0,-1 0 0,2 2 0,-1-2 0,-1 0 0,2 2 0,-1-2 0,-1 0 0,2 2 0,0-2 0,-3 3 0,6-3 0,-5 3 0,2-4 0,0 1 0,-2 3 0,1-3 0,1 0 0,-2 2 0,2-2 0,0 0 0,1-2 0,0 2 0,0-1 0,0 4 0,-4-3 0,4 2 0,-4-5 0,4 5 0,-4-2 0,4 0 0,-1 3 0,-2-7 0,5 7 0,-5-3 0,3-1 0,-1 4 0,-3-6 0,3 5 0,-3-5 0,4 5 0,-3-5 0,2 5 0,1-5 0,0 1 0,1 1 0,2-3 0,-6 6 0,3-5 0,-1 5 0,-2-5 0,3 5 0,0-5 0,-4 5 0,4-2 0,0-1 0,-4 3 0,4-5 0,3 5 0,-6-5 0,6 5 0,-7-2 0,0 0 0,3 2 0,-2-5 0,1 5 0,1-5 0,-2 6 0,6-4 0,-6 1 0,2 3 0,1-7 0,-3 6 0,2-5 0,1 5 0,-3-5 0,2 5 0,1-5 0,-3 5 0,6-6 0,-6 6 0,6-6 0,-6 7 0,7-7 0,-8 6 0,8-6 0,-7 6 0,2-5 0,1 2 0,-3 0 0,2-3 0,1 7 0,-3-7 0,2 4 0,1-1 0,-3-2 0,6 2 0,-6 0 0,3-3 0,-5 3 0,5 0 0,-3-2 0,3 6 0,-5-7 0,1 4 0,3-4 0,2-1 0,-1 5 0,-1-4 0,-3 6 0,0-5 0,3 2 0,-2-3 0,2 4 0,-3-4 0,-1 4 0,5-1 0,-3-2 0,3 5 0,-5-5 0,1 2 0,4 0 0,-3-2 0,2 2 0,-3 0 0,0-2 0,3 2 0,2-3 0,-2 3 0,5-3 0,-7 3 0,2-3 0,1 0 0,0 3 0,1-2 0,2 1 0,-6-1 0,3-2 0,-1 1 0,-2 3 0,3-2 0,-4 2 0,3-3 0,-2 0 0,3 2 0,-4-1 0,0 2 0,3-2 0,-3 2 0,3-2 0,-3 2 0,0-3 0,-1 1 0,1-1 0,-1 1 0,1-1 0,-3-3 0,5 3 0,-8-3 0,8 3 0,-5 0 0,3 0 0,0-2 0,-4 1 0,0-1 0,0 0 0,-2 1 0,2-8 0,-3 8 0,0-10 0,0 7 0,0-4 0,0-1 0,0 1 0,0 0 0,0-1 0,-4 1 0,4 4 0,-4-4 0,1 4 0,2-5 0,-2 1 0,3 4 0,-4-4 0,3 7 0,-5-2 0,5-1 0,-2 3 0,0-2 0,-1 0 0,0 2 0,-2-2 0,2 0 0,1 3 0,-3-3 0,2 0 0,0 2 0,-2-2 0,2 4 0,-3-1 0,1 0 0,-1 0 0,0 0 0,0 0 0,0 0 0,0 0 0,0 1 0,-3-2 0,2 1 0,-3 0 0,1 0 0,2 0 0,-7-1 0,8 1 0,-4 0 0,0 0 0,3 0 0,-2 0 0,-1 0 0,3 0 0,-6-1 0,6 1 0,-2 0 0,-1 0 0,3 0 0,-6-1 0,6 1 0,-3 0 0,5 0 0,-1 0 0,0 0 0,0 0 0,-12-9 0,0-2 0,-11-6 0,3 1 0,2 5 0,7 8 0,-30-16 0,-8-2 0,-10-4 0,12 6 0,-2 0 0,-25-13 0,58 32 0,-29-13 0,38 14 0,-1 5 0,2-2 0,5 3 0,-6-3 0,6 2 0,-7-2 0,8 3 0,-4-3 0,0 2 0,3-5 0,-2 5 0,-1-5 0,3 5 0,-2-3 0,-1 1 0,3 2 0,-2-2 0,-1-1 0,0 3 0,-4-5 0,4 5 0,-3-3 0,6 1 0,-6 3 0,6-4 0,-7 1 0,8 2 0,-8-6 0,4 7 0,-1-4 0,-2 1 0,6 2 0,-6-6 0,2 6 0,-3-5 0,0 5 0,3-6 0,-2 3 0,2 0 0,-3 1 0,0-1 0,3 4 0,-9-7 0,8 3 0,-6-1 0,5-1 0,2 5 0,1-6 0,-3 3 0,2 0 0,1-2 0,-4 5 0,7-2 0,-6 3 0,6-3 0,-6 2 0,6-5 0,-6 5 0,2-5 0,1 5 0,-4-6 0,4 3 0,-4-1 0,3-1 0,-2 5 0,2-5 0,-3 5 0,3-6 0,-2 7 0,2-7 0,1 6 0,-4-5 0,8 5 0,-8-6 0,7 6 0,-6-2 0,-1-1 0,-1 0 0,2 0 0,-1-3 0,4 6 0,-1-2 0,-2-1 0,6 4 0,-6-4 0,6 4 0,-6 0 0,6-3 0,-3 2 0,0-2 0,4 3 0,-4 0 0,1-3 0,3 2 0,-6-2 0,5 0 0,-2 3 0,0-4 0,3 4 0,-3-3 0,0 3 0,2-7 0,-2 7 0,3-6 0,-2 2 0,1 0 0,-1-2 0,-1 5 0,3-5 0,-3 3 0</inkml:trace>
</inkml:ink>
</file>

<file path=ppt/ink/ink3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43.758"/>
    </inkml:context>
    <inkml:brush xml:id="br0">
      <inkml:brushProperty name="width" value="0.35" units="cm"/>
      <inkml:brushProperty name="height" value="0.35" units="cm"/>
      <inkml:brushProperty name="color" value="#FFFFFF"/>
    </inkml:brush>
  </inkml:definitions>
  <inkml:trace contextRef="#ctx0" brushRef="#br0">1801 1994 24575,'-40'0'0,"-6"0"0,-4 0 0,-7 0 0,11 0 0,-7 0 0,-7 0 0,20 0 0,-28 0 0,-2 0 0,29 0 0,-22 1 0,3-2 0,31-7 0,-13 3 0,17-7 0,0 3 0,0 1 0,0 0 0,4 3 0,-3-2 0,8 2 0,-8-3 0,8 0 0,-4 0 0,0 0 0,4 1 0,-3-1 0,-1-4 0,4 4 0,-8-4 0,7 4 0,-2 0 0,4-3 0,-1 2 0,4-5 0,-2 5 0,2-2 0,-3 4 0,3-1 0,-6-6 0,6 5 0,-3-5 0,1 6 0,2 1 0,1 0 0,-4-4 0,4 3 0,-4-3 0,-1 0 0,1 2 0,0-2 0,3 4 0,-2-4 0,2 3 0,1-3 0,-4 0 0,4 3 0,-1-3 0,2 4 0,-1 0 0,3 0 0,-2 0 0,-1-1 0,3 1 0,-2 0 0,-1 0 0,3 0 0,-2 0 0,-1 0 0,3 0 0,-6-1 0,6 1 0,-3-4 0,-3 0 0,5-1 0,-4 2 0,5 0 0,-2 1 0,5-1 0,-5 2 0,6 2 0,-3-1 0,0 0 0,0 0 0,0 0 0,0 0 0,1-3 0,2 3 0,-2-3 0,2 0 0,0 2 0,-2-2 0,2 0 0,0 2 0,1-2 0,0 0 0,2 3 0,-2-3 0,0 0 0,2 2 0,-2-2 0,3-3 0,0 4 0,0-5 0,0 4 0,0 2 0,0-3 0,0 1 0,0 2 0,0-3 0,0 0 0,0 4 0,0-4 0,0 1 0,3 2 0,1-2 0,3 4 0,0-1 0,4-4 0,0 3 0,1-7 0,2 7 0,-2-3 0,4 3 0,-1-3 0,0 3 0,5-4 0,-4 5 0,4-5 0,0 3 0,-4-2 0,8-1 0,4-4 0,-6 3 0,5-2 0,-8 3 0,-3 3 0,4-2 0,-5 3 0,0 1 0,0-4 0,1 2 0,-1-2 0,0 0 0,0-1 0,0 1 0,-3-4 0,3 3 0,-4 0 0,5-2 0,-4 2 0,2-3 0,-2 0 0,3-1 0,-3 1 0,3 0 0,-4-1 0,1 1 0,3 3 0,-3-2 0,0 2 0,2-3 0,1-4 0,1 3 0,3 1 0,-4 0 0,0 7 0,1-7 0,-1 7 0,0-3 0,0 3 0,5 1 0,-4-1 0,3-3 0,-3 6 0,-1-6 0,4 7 0,-2-4 0,2 0 0,-4 1 0,5-1 0,-4 0 0,9 0 0,-9 0 0,4 0 0,-5 0 0,4 0 0,-2 4 0,3-3 0,-1-1 0,-2-1 0,2-3 0,1 4 0,-4 1 0,8-5 0,-7 3 0,23-11 0,-15 6 0,16-3 0,-16 5 0,6-1 0,-5 4 0,4-4 0,-5 5 0,-4 0 0,3-1 0,-8 2 0,4 2 0,-5-2 0,0 7 0,1-7 0,-1 6 0,0-6 0,-3 3 0,2 0 0,-2-2 0,3 5 0,-4-6 0,4 7 0,-4-4 0,1 1 0,2 3 0,-2-3 0,-1 3 0,7-4 0,-10 3 0,10-5 0,-10 5 0,2-3 0,0 4 0,-2 0 0,2-3 0,0 2 0,-3-2 0,6 3 0,-5 0 0,6 0 0,-6 0 0,2 0 0,1 0 0,-3 0 0,2 0 0,0 0 0,2 0 0,-1 0 0,-1 0 0,1 0 0,-3 0 0,6 0 0,-6 0 0,2 0 0,0 7 0,1 0 0</inkml:trace>
</inkml:ink>
</file>

<file path=ppt/ink/ink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29"/>
    </inkml:context>
    <inkml:brush xml:id="br0">
      <inkml:brushProperty name="width" value="0.28222" units="cm"/>
      <inkml:brushProperty name="height" value="0.28222" units="cm"/>
      <inkml:brushProperty name="color" value="#FFFFFF"/>
    </inkml:brush>
  </inkml:definitions>
  <inkml:trace contextRef="#ctx0" brushRef="#br0">191 1 24575,'0'15'0,"0"0"0,0-10 0,0 5 0,0-2 0,0 2 0,0 1 0,0 8 0,0 0 0,0 3 0,0-6 0,0-4 0,0-1 0,0-1 0,0 0 0,0-4 0,0 2 0,0-2 0,-2-1 0,1 0 0,-1 0 0,2 0 0,0-1 0,0 3 0,0-1 0,0 0 0,0-1 0,0 0 0,0-1 0,0 0 0,0 4 0,0-3 0,0 5 0,0-5 0,0 2 0,0 0 0,0 0 0,0 1 0,0 2 0,0-5 0,0 5 0,0-2 0,-2 1 0,1 2 0,-1 0 0,2-1 0,0 0 0,-4 4 0,4-2 0,-3 6 0,3-7 0,-2 4 0,2-3 0,-3 4 0,0-5 0,2 4 0,-1-4 0,-1 6 0,2-6 0,-1 3 0,0-5 0,1 1 0,-1 4 0,2-6 0,-3 8 0,2-8 0,-1 3 0,2 2 0,0-5 0,0 5 0,-3-3 0,2 1 0,-1-1 0,2 0 0,0 0 0,0 1 0,0-2 0,0 2 0,0-1 0,0 5 0,0-3 0,0-1 0,0-1 0,-3-2 0,3 2 0,-2-2 0,2 2 0,0-3 0,0 3 0,0 3 0,0-1 0,0 1 0,0 0 0,-3-3 0,3 7 0,-3-3 0,0 2 0,2 1 0,-4-2 0,4 3 0,-3-3 0,3 6 0,-4-5 0,4 2 0,-5-1 0,5 3 0,-3-3 0,3 7 0,-2-7 0,0 15 0,2-9 0,-2 6 0,3-6 0,0-6 0,0 4 0,0-1 0,0-3 0,-3 7 0,3-6 0,-3 1 0,3 2 0,0-3 0,0 2 0,0-3 0,0 0 0,-3-1 0,2-2 0,-1 3 0,-1-6 0,2 4 0,-1-4 0,-1 3 0,3-6 0,-2 2 0,0-4 0,1 4 0,-1 1 0,-1 0 0,2-1 0,-2 0 0,1 0 0,1 8 0,-3-3 0,3 3 0,-2-2 0,3-2 0,0 7 0,-3-4 0,2 7 0,-1-7 0,2 7 0,0-2 0,0 1 0,0 6 0,0-4 0,0 3 0,0-4 0,0 1 0,0 0 0,0-1 0,0 0 0,0-4 0,0 5 0,0-7 0,0 1 0,0 2 0,0-3 0,0 1 0,0-1 0,0-1 0,0-1 0,0-2 0,0 2 0,0-1 0,0 1 0,0 1 0,0 0 0,0-1 0,0-2 0,0 2 0,0-4 0,0 3 0,0-4 0,0 6 0,0-6 0,0 1 0,0 2 0,0-3 0,0 5 0,0-4 0,0 3 0,-3-4 0,2 5 0,-1-5 0,1 2 0,0-3 0,-2 4 0,1-3 0,1 1 0,-1-2 0,-1 1 0,2-1 0,-2 1 0,2-1 0,0-1 0,-2-1 0,3 2 0,-2-2 0,1 4 0,-1-3 0,2 2 0,0-4 0,0 4 0,0-3 0,0 1 0,0 0 0,0 0 0,0 2 0,0 2 0,0-2 0,0 6 0,0-8 0,0 5 0,0-1 0,2-2 0,2 4 0,0-4 0,3 3 0,-1-4 0,-2-2 0,2 2 0,0-6 0,0 6 0,-2-5 0,4 5 0,-2-3 0,0 1 0,0-1 0,1-2 0,-1 2 0,5-2 0,-3 3 0,1-1 0,1-1 0,-3 2 0,3-4 0,-4 1 0,3 1 0,1-1 0,-3 1 0,4 1 0,-6-2 0,3 1 0,1 0 0,-5 0 0,7 1 0,-5 1 0,4-4 0,-4 6 0,5-4 0,-5 4 0,4-4 0,-4 3 0,5-3 0,-1 6 0,0-4 0,0 2 0,-5 0 0,4-4 0,-4 1 0,3 0 0,-2-2 0,-2 2 0,-1 1 0,2-4 0,-5 4 0,3-1 0,0 1 0,-2 2 0,0 0 0,2 3 0,-2-2 0,1 2 0,-2-2 0,0-1 0,3 0 0,-2-2 0,1-1 0,-2-2 0,0-1 0,0 1 0,0 0 0,0 0 0,0-2 0,2 2 0,-1-1 0,1 1 0,-2 0 0,0 0 0,0-1 0,0 3 0,0-1 0,0 0 0,0-1 0,2-2 0,-2 2 0,3 0 0,-3 0 0,0-1 0</inkml:trace>
</inkml:ink>
</file>

<file path=ppt/ink/ink4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47.533"/>
    </inkml:context>
    <inkml:brush xml:id="br0">
      <inkml:brushProperty name="width" value="0.35" units="cm"/>
      <inkml:brushProperty name="height" value="0.35" units="cm"/>
      <inkml:brushProperty name="color" value="#FFFFFF"/>
    </inkml:brush>
  </inkml:definitions>
  <inkml:trace contextRef="#ctx0" brushRef="#br0">1 1837 24575,'32'0'0,"-2"0"0,-15 0 0,0 0 0,0 0 0,5 0 0,1 0 0,0 0 0,52 0 0,-35 0 0,38 0 0,-40 0 0,11 0 0,-11 0 0,15 0 0,-24 0 0,3 0 0,-5 0 0,0-8 0,-4 6 0,3-5 0,-3 3 0,-1 3 0,0-3 0,-5 1 0,1 2 0,3-6 0,-2 6 0,2-6 0,-3 6 0,10-6 0,-8 6 0,13-6 0,-15 6 0,4-6 0,-1 6 0,-2-6 0,6 2 0,-6 1 0,7-3 0,-8 6 0,8-7 0,-8 7 0,8-6 0,-3 6 0,-1-6 0,0 6 0,0-6 0,-4 6 0,4-6 0,-5 3 0,0 0 0,0 0 0,1 1 0,-1-1 0,0-1 0,1-1 0,-1 5 0,0-6 0,-3 6 0,9-6 0,-8 6 0,9-5 0,-2 5 0,-4-3 0,4 1 0,0 2 0,7-6 0,-4 3 0,3 0 0,-11 1 0,5-1 0,-4 3 0,4-6 0,-5 6 0,1-6 0,-1 3 0,0 0 0,5 0 0,-4 1 0,8-2 0,-7 1 0,2-3 0,1 2 0,-4 1 0,8-4 0,-7 4 0,2-4 0,-3 4 0,-1-3 0,0 6 0,0-6 0,1 7 0,-1-7 0,-3 6 0,2-6 0,-3 6 0,1-5 0,2 5 0,-2-5 0,-1 5 0,3-6 0,-2 6 0,3-5 0,-3 2 0,2 0 0,-2-3 0,3 3 0,0 0 0,0-3 0,1 6 0,-1-6 0,0 3 0,1-4 0,3 0 0,-2 1 0,7-2 0,-8 2 0,4-1 0,-1 0 0,-2 0 0,2 0 0,1 0 0,-4-3 0,11-1 0,-6 0 0,-1 1 0,-2 3 0,-6 1 0,3-1 0,0 0 0,-3 1 0,2-1 0,-2-2 0,-1 2 0,4-3 0,-7 4 0,6-1 0,-6 1 0,6 0 0,-6 0 0,3-1 0,-5 1 0,5 4 0,-3-4 0,6 3 0,-6-3 0,6 0 0,-5-4 0,5 3 0,-2-3 0,-1 3 0,4 1 0,-4-1 0,8-6 0,-7 5 0,5-5 0,-9 7 0,3 0 0,3-7 0,-6 6 0,10-6 0,-10 3 0,6 3 0,-2-3 0,0 0 0,2-1 0,-2 0 0,4 1 0,-5 0 0,0 3 0,0-3 0,-3 0 0,3 3 0,-4-3 0,0 4 0,0 0 0,0 1 0,-3-4 0,1 2 0,-4-2 0,8 0 0,-4 3 0,2-7 0,-1 6 0,-5-3 0,5 1 0,-2 2 0,3-3 0,-3 1 0,2 2 0,-5-3 0,6 1 0,-3 2 0,0-3 0,-1 1 0,0 2 0,-2-3 0,2 1 0,0-1 0,-2 0 0,2 0 0,-3 4 0,0-3 0,0 2 0,4-6 0,-3 6 0,2-7 0,-3 4 0,0-4 0,0 3 0,0-2 0,0 2 0,0-3 0,0 0 0,0 3 0,0-2 0,0 6 0,0-6 0,0 6 0,0-10 0,0 6 0,0-3 0,0 5 0,0-1 0,0 3 0,0-2 0,0-1 0,0 3 0,0-2 0,-3 0 0,-1 2 0,0-6 0,-2 7 0,2-4 0,-3 4 0,0-4 0,3 4 0,-2-4 0,2 0 0,-3 3 0,-1-2 0,1 3 0,-3-7 0,-1 5 0,-1-4 0,2 5 0,3 1 0,0 4 0,-3-7 0,2 9 0,-2-8 0,0 5 0,3-3 0,-7 3 0,6-2 0,-2 2 0,3-3 0,-4 3 0,3-2 0,-2 2 0,3 1 0,0-4 0,-4 7 0,3-6 0,-6 5 0,3-6 0,-5 3 0,1 0 0,0-3 0,3 6 0,-2-6 0,6 7 0,-9-4 0,4 1 0,-1 2 0,3-2 0,4 3 0,1 0 0</inkml:trace>
</inkml:ink>
</file>

<file path=ppt/ink/ink4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51.411"/>
    </inkml:context>
    <inkml:brush xml:id="br0">
      <inkml:brushProperty name="width" value="0.35" units="cm"/>
      <inkml:brushProperty name="height" value="0.35" units="cm"/>
      <inkml:brushProperty name="color" value="#FFFFFF"/>
    </inkml:brush>
  </inkml:definitions>
  <inkml:trace contextRef="#ctx0" brushRef="#br0">0 2036 24575,'45'0'0,"-5"0"0,-15 0 0,11 0 0,-8 0 0,18 0 0,48 0 0,-42 0 0,1 0 0,-4 0 0,-22 0 0,14 0 0,-14 0 0,8 0 0,-8 0 0,3 0 0,-5 0 0,-4 0 0,3-7 0,-4 5 0,1-5 0,-1 7 0,-5-4 0,0 3 0,0-2 0,1 0 0,-1 2 0,0-6 0,0 6 0,0-6 0,5 7 0,-4-7 0,4 2 0,-1 1 0,-2-3 0,2 7 0,1-8 0,1 8 0,0-8 0,3 4 0,-8-4 0,8 4 0,-3-4 0,0 4 0,3-4 0,-4 0 0,1 3 0,3-2 0,-3 2 0,11-3 0,-10 0 0,9 0 0,-14 0 0,7 0 0,-8-3 0,8 2 0,-8-6 0,8 6 0,-3-6 0,-1 6 0,4-6 0,-3 2 0,3 0 0,-3-2 0,3 6 0,8-10 0,-4 9 0,8-10 0,-11 11 0,0-3 0,-4 4 0,3-4 0,-7 3 0,7-3 0,-8 5 0,4-1 0,-1 0 0,-6 0 0,10 0 0,-14 1 0,14-1 0,-10 0 0,7 0 0,-5 1 0,0-4 0,0 2 0,1-2 0,-1 0 0,0 3 0,0-3 0,1 3 0,-1-3 0,0 2 0,1-2 0,-1 4 0,-4-1 0,4 1 0,-4 0 0,1-1 0,2 1 0,-2-1 0,-1 1 0,4 3 0,-7-2 0,6 2 0,-6 0 0,6-3 0,-2 3 0,-1-1 0,10-5 0,-7 9 0,4-9 0,-4 6 0,-2 0 0,3-3 0,-3 3 0,2-3 0,-3-1 0,4 4 0,1-3 0,-1 3 0,0-4 0,5 0 0,-7 1 0,5-1 0,-6 1 0,3-1 0,0 1 0,-3-4 0,3 2 0,-3-2 0,-1 4 0,0-1 0,-1 1 0,-2 0 0,3 0 0,-4 0 0,0 3 0,3-5 0,-3 4 0,3-1 0,-3-1 0,0 4 0,0-4 0,0 0 0,0-3 0,0 2 0,0-2 0,-1 3 0,1 0 0,0 1 0,0-1 0,0 0 0,0 0 0,0 0 0,0 0 0,0 0 0,6 0 0,-4 0 0,8 3 0,-9-2 0,7 1 0,-4 2 0,4-4 0,1 3 0,-1-4 0,0 0 0,-3 1 0,2 3 0,-2-3 0,3 6 0,-4-5 0,4 2 0,-7 0 0,2 1 0,-3-1 0,3 4 0,-2-6 0,2 5 0,0-5 0,-3 5 0,3-2 0,0 0 0,-2 2 0,2-5 0,0 5 0,-2-5 0,1 5 0,-2-5 0,0 2 0,0-3 0,3 0 0,-2 1 0,1-1 0,-2 3 0,0-2 0,0-1 0,0-1 0,0-2 0,0 6 0,0-5 0,0 5 0,-3-6 0,2 3 0,-3 0 0,4-3 0,-3 2 0,2-2 0,-2 3 0,3 0 0,0-3 0,0-1 0,0 0 0,0 0 0,0 5 0,-3-1 0,5-3 0,-4 2 0,2-2 0,-1 4 0,-3-1 0,1-4 0,2 3 0,-5-2 0,5 3 0,-2-3 0,0 2 0,2-2 0,-5-1 0,2 4 0,0-8 0,-2 7 0,3-6 0,-1 6 0,-3-6 0,7 6 0,-7-3 0,7-2 0,-6 4 0,2-5 0,-3 4 0,3 2 0,-2-3 0,2 1 0,-3 2 0,0-3 0,3 1 0,-2 2 0,3-3 0,-4-3 0,3 6 0,-3-6 0,3 4 0,1 2 0,-4-7 0,3 8 0,-3-8 0,0 4 0,0-1 0,0-2 0,0 2 0,0-3 0,0 0 0,0 3 0,0-2 0,0 6 0,0-3 0,0 1 0,0 3 0,0-6 0,0 5 0,0-2 0,0 1 0,0 1 0,0-4 0,0 5 0,0-3 0,-2 1 0,-2 2 0,-3-3 0</inkml:trace>
</inkml:ink>
</file>

<file path=ppt/ink/ink4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56.332"/>
    </inkml:context>
    <inkml:brush xml:id="br0">
      <inkml:brushProperty name="width" value="0.35" units="cm"/>
      <inkml:brushProperty name="height" value="0.35" units="cm"/>
      <inkml:brushProperty name="color" value="#FFFFFF"/>
    </inkml:brush>
  </inkml:definitions>
  <inkml:trace contextRef="#ctx0" brushRef="#br0">0 2117 24575,'41'0'0,"-7"0"0,-8 0 0,-2 0 0,7 0 0,-3 0 0,3 0 0,32 11 0,-33-4 0,30 8 0,-36-6 0,-8-2 0,8 2 0,-8-2 0,4 1 0,-5 0 0,1 0 0,-5-4 0,4 3 0,-4-3 0,4 0 0,1 3 0,-5-3 0,4 0 0,-8 2 0,8-2 0,-7 3 0,2-3 0,1 3 0,0-6 0,1 5 0,2-2 0,-2 0 0,-1 3 0,4-6 0,-4 2 0,4 0 0,-3-2 0,2 6 0,-2-7 0,3 7 0,5-6 0,-4 6 0,4-3 0,-1 0 0,-2 3 0,2-3 0,1 4 0,-4-3 0,4 2 0,-5-6 0,5 2 0,-4 0 0,4-2 0,0 3 0,7-4 0,-4 0 0,3 3 0,-6-2 0,-4 2 0,4-3 0,-5 0 0,0 0 0,1 0 0,3 0 0,-2 0 0,2 0 0,1 0 0,-4 0 0,4 0 0,-1 0 0,2 0 0,-1 0 0,4 0 0,-7 0 0,2 0 0,1 0 0,-4 0 0,9 0 0,-9 0 0,4 0 0,-5 0 0,0 0 0,0 0 0,1 0 0,-1 0 0,0 0 0,7 0 0,-5 0 0,2 0 0,-5 0 0,-6 0 0,6 0 0,-6 0 0,3 0 0,-1-3 0,-2 2 0,3-2 0,-1 3 0,2-4 0,-1 3 0,0-5 0,0 5 0,-4-5 0,8 5 0,-7-2 0,6 0 0,-6-1 0,2 0 0,1-3 0,-3 6 0,6-5 0,-2 1 0,-1-2 0,4-1 0,-4 1 0,5 0 0,3-1 0,-2 0 0,9-4 0,-9 4 0,9-3 0,-9 3 0,2 3 0,-3-1 0,-1 1 0,0-2 0,0 2 0,-3-1 0,2 2 0,-6-3 0,6-1 0,-6 5 0,6-4 0,-6 3 0,3-3 0,0-1 0,-4 1 0,8 3 0,-7-2 0,6 2 0,-6-3 0,6-1 0,-6 1 0,6 0 0,-3-3 0,4 1 0,-4-1 0,4 3 0,-8 0 0,8-1 0,-4 1 0,1-4 0,3 3 0,-4-3 0,1 3 0,2 1 0,-2-1 0,-1 1 0,4 0 0,-8 0 0,8-1 0,-4 1 0,5-1 0,-1 1 0,0-1 0,0 0 0,0 1 0,1 2 0,-1-1 0,5 1 0,3-6 0,3 2 0,-3-2 0,-4 3 0,-3 0 0,3 0 0,-2 0 0,2 0 0,-3 1 0,-1-1 0,0 0 0,1-3 0,-1 3 0,0-3 0,0 3 0,1 1 0,-1 2 0,-4-1 0,4 2 0,-7-3 0,6-4 0,-6 6 0,6-5 0,-6 6 0,6-4 0,-6 1 0,7 0 0,-4 0 0,4-1 0,1 4 0,-1-3 0,-3-1 0,2 0 0,-2-3 0,3 3 0,1 0 0,-1-3 0,0 3 0,7-10 0,-5 9 0,5-9 0,-6 9 0,-1-2 0,0 4 0,1-4 0,-1 2 0,0-2 0,-3 4 0,2-1 0,-3-2 0,5 1 0,-1-2 0,-3 0 0,2 3 0,-2-7 0,3 7 0,-3-7 0,2 7 0,-5-6 0,5 5 0,-5-5 0,1 6 0,-2-3 0,2 4 0,-2 0 0,3-4 0,-4 6 0,0-5 0,0 6 0,0-3 0,0 0 0,0 1 0,0-1 0,3 0 0,-3 0 0,0 0 0,2 0 0,-7 1 0,6-1 0,-1 0 0,-2 0 0,4 0 0,-5 0 0,3 1 0,0-4 0,0 2 0,0-2 0,0-1 0,0 4 0,0-8 0,1 4 0,-1-1 0,1-2 0,2 2 0,-1-3 0,2 0 0,0 3 0,-3-3 0,7 7 0,-7-7 0,3 7 0,-4-2 0,0 3 0,0 0 0,0 0 0,-1 0 0,1-2 0,-3 1 0,2-1 0,-3-1 0,1 3 0,2-2 0,-5-1 0,2 2 0,0-2 0,-2 0 0,5-1 0,-5-4 0,2 4 0,1-3 0,-3 6 0,2-7 0,0 8 0,-2-8 0,5 4 0,-5-1 0,6-2 0,-6 6 0,5-6 0,-2 6 0,1-7 0,1 8 0,-6-4 0,7 0 0,-6 3 0,5-2 0,-5-1 0,5 3 0,-5-2 0,5 3 0,-5-3 0,2 2 0,0-5 0,-2 6 0,2-3 0,0-4 0,-2 5 0,2-4 0,0 6 0,-3 0 0,3-3 0,0 2 0,-2-2 0,2 1 0,-3 1 0,0-5 0,0 5 0,0-2 0,0 1 0,0 1 0,0-5 0,0 5 0,0-1 0,0-1 0,0 2 0,0-9 0,0 9 0,0-6 0,0 7 0,0-3 0,0 0 0,0-1 0,0 1 0,0 0 0,0 2 0,0-5 0,0 6 0,0-3 0,0 0 0,0 3 0,0-6 0,0 5 0,0-2 0,0 0 0,0 3 0,-6-6 0,1 6 0,-4-3 0,5 3 0,-3-4 0,3 3 0,-3-2 0,3 3 0,-2 0 0,2-3 0,-2 6 0,-1-8 0,0 7 0,1-4 0,-1 2 0,0 1 0,1-1 0,2-2 0,1-2 0</inkml:trace>
</inkml:ink>
</file>

<file path=ppt/ink/ink4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03.180"/>
    </inkml:context>
    <inkml:brush xml:id="br0">
      <inkml:brushProperty name="width" value="0.35" units="cm"/>
      <inkml:brushProperty name="height" value="0.35" units="cm"/>
      <inkml:brushProperty name="color" value="#FFFFFF"/>
    </inkml:brush>
  </inkml:definitions>
  <inkml:trace contextRef="#ctx0" brushRef="#br0">0 1674 24575,'30'23'0,"-6"-1"0,-9-10 0,-4-1 0,5 0 0,-1 1 0,0 0 0,28 19 0,-21-18 0,34 25 0,-37-28 0,9 8 0,-8-10 0,-4 0 0,4 0 0,-5-1 0,0 1 0,1-1 0,10 5 0,-8-4 0,8 4 0,-11-5 0,-3 0 0,2 1 0,-2-1 0,3 1 0,-3-1 0,2 1 0,-2-1 0,-1 1 0,4-1 0,-4 0 0,1 1 0,2-1 0,-2 1 0,3-1 0,-4 0 0,4 1 0,-1-1 0,2 1 0,3-4 0,-4 2 0,-3-2 0,2 0 0,-3 3 0,1-3 0,2 3 0,-2 1 0,-1-4 0,4 3 0,-4-3 0,1 3 0,2-3 0,-2 3 0,3-3 0,0 0 0,1 3 0,-1-6 0,0 6 0,0-6 0,7 5 0,-5-5 0,5 6 0,-6-6 0,3 6 0,-2-6 0,2 3 0,1-1 0,-4-2 0,8 7 0,-8-7 0,4 2 0,0 1 0,-4-3 0,4 6 0,-5-6 0,0 2 0,1 1 0,-1-3 0,0 5 0,1-5 0,-5 3 0,3-1 0,-2-2 0,3 2 0,1-3 0,-5 3 0,3-2 0,-2 2 0,0-3 0,2 4 0,-2-4 0,3 4 0,-4-4 0,4 3 0,-7-2 0,6 3 0,-6-4 0,6 0 0,-2 0 0,3 0 0,-4 0 0,4 0 0,-4 0 0,5 0 0,-1 3 0,0-2 0,1 2 0,6-3 0,-5 0 0,1 0 0,-4 0 0,-2 0 0,6 0 0,-2 0 0,-1 0 0,-1 0 0,-6 0 0,6 0 0,-6 0 0,6 0 0,-6 0 0,7 0 0,-8 3 0,4-2 0,0 2 0,-4-3 0,4 0 0,-1 0 0,-2 0 0,8 0 0,-7 0 0,5 0 0,-1 0 0,-4 0 0,5 0 0,-7 0 0,3 0 0,-2 0 0,3 0 0,-1 0 0,-2 0 0,3 0 0,-1 0 0,-2 0 0,6 0 0,-2 0 0,3 0 0,1 0 0,-1 0 0,4 0 0,-2 0 0,3 0 0,-5 0 0,4-4 0,-6 3 0,6-2 0,-8-1 0,5 3 0,-1-5 0,-3 5 0,2-6 0,-3 6 0,12-6 0,-6 3 0,5 0 0,-11-3 0,4 7 0,-4-7 0,1 6 0,2-5 0,-6 5 0,9-6 0,-5 3 0,3 0 0,-4-3 0,-1 6 0,-2-5 0,3 5 0,-1-5 0,-2 5 0,6-6 0,-6 6 0,3-5 0,0 5 0,-4-5 0,4 5 0,-4-5 0,7 2 0,-6 0 0,6-2 0,-7 2 0,0 0 0,3-2 0,-2 2 0,3-1 0,-1-1 0,-2 2 0,3-3 0,-1 3 0,-2-2 0,7 2 0,-8-3 0,8-1 0,-7 1 0,6 0 0,-3-1 0,5 1 0,-5 0 0,3-1 0,-2 1 0,3-1 0,0 0 0,1 4 0,-5-2 0,4 2 0,-1-7 0,-2 3 0,6-3 0,-10 5 0,6-2 0,-6 4 0,6-3 0,-6 3 0,6-3 0,-6 3 0,3-3 0,-1 3 0,-2-3 0,3 0 0,-4 0 0,3 0 0,-3 0 0,3 1 0,-3-1 0,0 0 0,4 3 0,-3-2 0,2 2 0,-3-3 0,0 0 0,0 0 0,0 0 0,0 0 0,0 1 0,3-1 0,-3 0 0,3 0 0,-3 0 0,0 0 0,0-4 0,0 4 0,0-4 0,0 4 0,0 0 0,0 0 0,0 0 0,0 0 0,0 1 0,0-1 0,0 0 0,-1 0 0,2-4 0,-1 7 0,0-10 0,0 9 0,4-6 0,-3 4 0,3 0 0,-1 0 0,-2 0 0,3 0 0,-4 3 0,-1-2 0,4 2 0,-2-3 0,2 0 0,1 0 0,-3 3 0,2-3 0,-3 4 0,0-4 0,0 0 0,0 0 0,3 0 0,-2 0 0,3-1 0,-1 1 0,-2 0 0,7-4 0,-8 3 0,4-2 0,0 3 0,-3-4 0,6 2 0,-6-1 0,3 2 0,-4 2 0,0-1 0,0 0 0,0 0 0,0 0 0,-1 0 0,1 0 0,1-3 0,-1 2 0,0-3 0,0 4 0,0 0 0,3 0 0,-2 0 0,3 0 0,-4 0 0,-1 0 0,1 0 0,0-3 0,0 3 0,0-3 0,0 3 0,0 0 0,0 0 0,0 0 0,0 0 0,-1 0 0,1 0 0,0 0 0,0 0 0,0-3 0,0 2 0,1-3 0,-1 4 0,-1 4 0,4-7 0,-2 6 0,2-6 0,-3 3 0,0 0 0,-1 1 0,1-1 0,0 0 0,0 0 0,0 0 0,0 0 0,0 0 0,0 0 0,-1 1 0,1-1 0,0-3 0,0 5 0,0-4 0,0 2 0,0 0 0,-1-3 0,-2 3 0,2 0 0,1-3 0,1 2 0,2-2 0,-3 3 0,0-3 0,0-2 0,1-3 0,0 0 0,-1-1 0,1 1 0,-1 3 0,1-2 0,-1 6 0,0-6 0,0 6 0,1-3 0,-2 5 0,1 2 0,0-6 0,0 3 0,0-4 0,-3 1 0,-1 4 0,-1-4 0,2 3 0,3-3 0,-3 1 0,1 2 0,-4-3 0,5 0 0,-5 3 0,5-3 0,-5 0 0,1 3 0,1-5 0,-2 5 0,2-3 0,-3 1 0,0 1 0,3-5 0,-2 6 0,2-3 0,-3 0 0,3 3 0,-3-6 0,3 5 0,-3-2 0,0 0 0,0-1 0,0 0 0,0 1 0,0 0 0,0 2 0,3-5 0,-2 5 0,2-2 0,-3 1 0,3 1 0,1-4 0,0 4 0,-1-2 0,-3 0 0,3 3 0,-3-3 0,4 0 0,-4 2 0,3-1 0,-3-1 0,3 2 0,-3-4 0,0 5 0,0-3 0,0 0 0,0 3 0,0-6 0,3 5 0,-2-2 0,2 0 0,-3 3 0,0-6 0,0 5 0,3-2 0,-2 1 0,2 1 0,-3-5 0,0 6 0,0-3 0,0 0 0,3 3 0,-2-6 0,2 6 0,-3-3 0,0 1 0,0 2 0,0-6 0,0 6 0,0-2 0,3 0 0,-2 1 0,2-4 0,-3 5 0,0-2 0,0-1 0,0 3 0,0-5 0,0 5 0,0-2 0</inkml:trace>
</inkml:ink>
</file>

<file path=ppt/ink/ink4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09.098"/>
    </inkml:context>
    <inkml:brush xml:id="br0">
      <inkml:brushProperty name="width" value="0.35" units="cm"/>
      <inkml:brushProperty name="height" value="0.35" units="cm"/>
      <inkml:brushProperty name="color" value="#FFFFFF"/>
    </inkml:brush>
  </inkml:definitions>
  <inkml:trace contextRef="#ctx0" brushRef="#br0">3285 1680 24575,'-27'-6'0,"1"4"0,18-5 0,-6 4 0,2 2 0,-3-6 0,3 6 0,-12-6 0,0 4 0,1-2 0,-2 2 0,17 3 0,-6 0 0,-4 0 0,1 0 0,-8 0 0,9 0 0,1 0 0,1 0 0,6 0 0,-3 0 0,1 0 0,3 0 0,-6 0 0,5 0 0,-2 0 0,0 0 0,3 0 0,-6 0 0,5 0 0,-2 0 0,0-3 0,3 2 0,-6-2 0,5 3 0,-2 0 0,-4 0 0,6 0 0,-6 0 0,7 0 0,-3 0 0,2 0 0,-7 0 0,4 0 0,-4 0 0,3-3 0,-2 3 0,2-3 0,-8-1 0,4 3 0,-4-3 0,5 1 0,0 2 0,0-6 0,-1 6 0,1-2 0,0 0 0,0 2 0,-1-3 0,1 4 0,4 0 0,-4-3 0,7 2 0,-6-2 0,6 3 0,-2-3 0,-1 2 0,3-2 0,-2 3 0,-4-3 0,5 2 0,-8-2 0,9 0 0,-6 2 0,6-2 0,-3 3 0,1-3 0,2 2 0,-6-3 0,6 4 0,-3 0 0,1-3 0,2 2 0,-3-2 0,0-1 0,4 4 0,-8-7 0,7 6 0,-6-2 0,6-1 0,-2 4 0,-1-3 0,4 0 0,-8 2 0,4-2 0,-5-1 0,1 3 0,0-2 0,-5-1 0,4 3 0,-8-6 0,7 3 0,-7-1 0,-3-2 0,0 2 0,-5 1 0,2-4 0,3 7 0,-3-7 0,5 7 0,0-6 0,0 2 0,0 0 0,0-2 0,4 3 0,-3-1 0,8-1 0,-3 1 0,7 1 0,-2-3 0,6 3 0,-6 0 0,6-2 0,-7 5 0,8-5 0,-4 5 0,0-5 0,4 2 0,-8-3 0,4 3 0,-5-3 0,1 3 0,3-4 0,-2 1 0,3-1 0,-9 0 0,4 1 0,-11-1 0,6 0 0,-2 0 0,3 0 0,0 0 0,4 4 0,-4-3 0,0 2 0,4 1 0,-4-3 0,5 2 0,0-2 0,-5-1 0,4 3 0,-4-2 0,5 3 0,0-3 0,0-1 0,-1 0 0,1 1 0,0-1 0,0 0 0,-1 4 0,1-3 0,0 3 0,3-3 0,-9-4 0,12 3 0,-13-3 0,11 4 0,-1-1 0,-2 1 0,6 0 0,-6-1 0,6 1 0,-6 3 0,6-2 0,-7 2 0,4-3 0,-1-4 0,-2 2 0,2-2 0,-4 3 0,1 1 0,4 0 0,-4-1 0,4 1 0,-4-1 0,3 4 0,-2-3 0,2 3 0,1-3 0,-4-1 0,4 1 0,-1-1 0,-2 1 0,6 0 0,-6-1 0,6 4 0,-7-2 0,1-2 0,-2 0 0,1-3 0,1 4 0,6-4 0,-7 3 0,7-3 0,-6 3 0,6 1 0,-3 0 0,1-3 0,2 2 0,-3-3 0,5 4 0,-2-3 0,1 2 0,0-3 0,0 4 0,-3 0 0,1-3 0,-1 1 0,3-1 0,-1-1 0,1 0 0,0-1 0,-4-2 0,3 2 0,-3 1 0,0-4 0,3 4 0,-3-1 0,3-2 0,-6-1 0,5-1 0,-5 1 0,6 0 0,1 7 0,0-6 0,0 6 0,-1-6 0,1 6 0,0-3 0,0 1 0,3 2 0,-3-3 0,7 5 0,-6-4 0,5 2 0,-2-2 0,3 0 0,0 3 0,3-6 0,1 6 0,3 0 0,3-2 0,-3 4 0,3-8 0,-3 5 0,1-3 0,-1 4 0,-1 0 0,1 0 0,0 1 0,0-1 0,0 0 0,0-3 0,0 2 0,-3-2 0,2 3 0,-2-3 0,0 3 0,2-3 0,-2 3 0,-1 0 0,7-3 0,-6 2 0,6-2 0,-6 3 0,2 0 0,1-2 0,-2 1 0,4-2 0,-5 3 0,2 0 0,1-3 0,0 3 0,-3-3 0,2 3 0,-3 1 0,4-1 0,0 0 0,0 0 0,0 0 0,-1 1 0,1-1 0,-1 1 0,4 2 0,-3 1 0,6 3 0,-6 0 0,3 0 0,-1 0 0,1 0 0</inkml:trace>
</inkml:ink>
</file>

<file path=ppt/ink/ink4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13.367"/>
    </inkml:context>
    <inkml:brush xml:id="br0">
      <inkml:brushProperty name="width" value="0.35" units="cm"/>
      <inkml:brushProperty name="height" value="0.35" units="cm"/>
      <inkml:brushProperty name="color" value="#FFFFFF"/>
    </inkml:brush>
  </inkml:definitions>
  <inkml:trace contextRef="#ctx0" brushRef="#br0">3583 1938 24575,'-31'0'0,"3"0"0,12 0 0,1 0 0,-5 0 0,4 0 0,-8 0 0,-15-7 0,-15-3 0,9 1 0,-4-2 0,26 6 0,-3 1 0,3 0 0,4 4 0,-1-3 0,4 2 0,-4-3 0,5 1 0,-1 2 0,1-6 0,0 6 0,3-2 0,-2 3 0,6 0 0,-6 0 0,6-3 0,-3 2 0,1-2 0,-5 3 0,3 0 0,-6 0 0,10 0 0,-2-3 0,-1 2 0,0-2 0,-1 3 0,1-3 0,1 2 0,2-2 0,-6 3 0,6 0 0,-3 0 0,1 0 0,-2 0 0,1 0 0,-4 0 0,8 0 0,-8 0 0,4 0 0,-1 0 0,-2 0 0,3 0 0,-1 0 0,-2 0 0,2-3 0,-3 2 0,3-3 0,-2 4 0,6 0 0,-6 0 0,-5 0 0,6 0 0,-8 0 0,9 0 0,1 0 0,-3 0 0,2 0 0,-3 0 0,3-3 0,-2 3 0,2-3 0,-3 3 0,0 0 0,3 0 0,-2-4 0,2 3 0,-3-2 0,0 0 0,0 2 0,-1-3 0,1 4 0,3 0 0,-2-3 0,2 2 0,-3-2 0,0 3 0,0 0 0,3-3 0,-2 2 0,2-2 0,-10-1 0,5 4 0,-5-7 0,7 6 0,-5-6 0,4 6 0,-4-6 0,0 6 0,4-6 0,-8 6 0,8-6 0,-4 3 0,0 0 0,0-3 0,-1 6 0,-3-6 0,8 2 0,-8 1 0,3-3 0,-4 2 0,0 0 0,0-2 0,4 3 0,-8-1 0,7-2 0,-8 2 0,5-3 0,4 0 0,-3 3 0,3-2 0,-11 2 0,10-3 0,-5 0 0,12 4 0,0-3 0,0 6 0,-1-5 0,1 5 0,0-6 0,-1 6 0,1-6 0,0 3 0,0 0 0,-1-3 0,1 6 0,0-5 0,0 1 0,-5 1 0,4-3 0,-4 6 0,5-5 0,0 1 0,-1 1 0,1-3 0,-5 3 0,4-1 0,-4-2 0,5 3 0,0 0 0,0-3 0,-5 2 0,3-2 0,-2-1 0,4 0 0,-8-3 0,2 2 0,-2-2 0,3 3 0,5-3 0,0 3 0,-1-7 0,1 3 0,-4 0 0,2-2 0,-2 2 0,3 0 0,-3-3 0,3 6 0,-8-7 0,7 8 0,-7-4 0,8 4 0,-4-3 0,1 2 0,-2-2 0,1 3 0,-4-1 0,7 2 0,-7-2 0,8-2 0,-4 2 0,0-2 0,4 3 0,-4 0 0,5 1 0,0-1 0,-1 4 0,1-3 0,-3 0 0,2-2 0,-3-2 0,8 7 0,-3-3 0,2 0 0,0-1 0,-2-3 0,6 4 0,-2-1 0,2-2 0,1 2 0,0-3 0,0 5 0,0-1 0,1 0 0,-2-4 0,4 3 0,-2-2 0,2-1 0,-4 0 0,1-5 0,-1 1 0,1 0 0,2 3 0,-2-2 0,3 2 0,0-3 0,-3 0 0,6 3 0,-5-2 0,5 2 0,-6-6 0,6 5 0,-2-4 0,-1 6 0,3-1 0,-2-2 0,3 2 0,-3-3 0,2 3 0,-3-2 0,4 6 0,0-2 0,0-1 0,0 3 0,0-2 0,0-1 0,0 3 0,-3-6 0,2 6 0,-2-3 0,3 1 0,0 2 0,0-3 0,0 1 0,0 2 0,-3-3 0,2-2 0,-2 4 0,3-5 0,0 7 0,0-3 0,0 2 0,0-6 0,0 6 0,0-3 0,0 0 0,0 4 0,0-8 0,0 7 0,0-6 0,0 6 0,0-2 0,0 0 0,3 2 0,-2-2 0,2 0 0,-3 2 0,3-2 0,-2 0 0,2 2 0,-3-3 0,3 1 0,-2 2 0,2-3 0,0-2 0,-2 4 0,5-5 0,-5 8 0,2-1 0,0-3 0,1 2 0,0-2 0,2 0 0,-6 3 0,7-3 0,-4 0 0,4 3 0,-3-3 0,2 3 0,-2 1 0,2-1 0,1 0 0,-3-2 0,2 2 0,-6-3 0,6 1 0,-5 1 0,5-1 0,-2-1 0,3 6 0,-1-2 0</inkml:trace>
</inkml:ink>
</file>

<file path=ppt/ink/ink4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17.156"/>
    </inkml:context>
    <inkml:brush xml:id="br0">
      <inkml:brushProperty name="width" value="0.35" units="cm"/>
      <inkml:brushProperty name="height" value="0.35" units="cm"/>
      <inkml:brushProperty name="color" value="#FFFFFF"/>
    </inkml:brush>
  </inkml:definitions>
  <inkml:trace contextRef="#ctx0" brushRef="#br0">4143 2308 24575,'-31'0'0,"-2"0"0,17 0 0,-13 0 0,11 0 0,-11 0 0,8 0 0,-44 0 0,29 0 0,-29 0 0,40 0 0,-5 0 0,3 0 0,-3 0 0,0 0 0,4 0 0,-5 0 0,1 0 0,4 0 0,0 0 0,2 0 0,3 0 0,-4 0 0,0 0 0,4 0 0,-3 0 0,3 0 0,1 0 0,-4 0 0,3 0 0,0 0 0,-3 0 0,3 0 0,-4 0 0,0 0 0,0 0 0,-5 0 0,4 0 0,-4 0 0,0 0 0,4 0 0,-4 0 0,4 0 0,1 0 0,0 0 0,0 0 0,4 0 0,-3 0 0,8 0 0,-4 0 0,5 0 0,-7 0 0,5 0 0,-5 0 0,6 0 0,1 0 0,4 0 0,-4 0 0,7 0 0,-6 0 0,3 0 0,-1 0 0,-2 0 0,6 0 0,-6 0 0,6 0 0,-6 0 0,6 0 0,-6 0 0,6 0 0,-6 0 0,6 0 0,-6 0 0,2 0 0,-3 0 0,0 0 0,3 0 0,-6 0 0,5 0 0,-7 0 0,5 0 0,0 0 0,-1 0 0,-10 0 0,8 0 0,-9 0 0,8 0 0,2 0 0,-2 0 0,-1 0 0,4 0 0,-8 0 0,7 0 0,-7 0 0,4 0 0,-1 0 0,-3 0 0,3-4 0,-4 3 0,4-6 0,-2 2 0,2-3 0,-4 4 0,4-3 0,-3 2 0,4-3 0,-6-1 0,1 1 0,0 0 0,0-1 0,-5 1 0,-2-5 0,-4 3 0,-1-4 0,1 5 0,-1-4 0,1 3 0,-23-8 0,17 8 0,-16-3 0,27 4 0,-5 0 0,10-3 0,-9 2 0,8-2 0,-3 3 0,5 1 0,0-1 0,0 1 0,4 0 0,-3 0 0,8 0 0,-8 3 0,8-2 0,-8 3 0,7-4 0,-3 0 0,1-4 0,2 4 0,-2-4 0,3 4 0,-3-3 0,2 2 0,-2-3 0,3 1 0,1 3 0,0-7 0,-7 0 0,5 2 0,-5-4 0,7 5 0,-1 0 0,1-3 0,0 4 0,0-5 0,3 1 0,-3 3 0,3-2 0,1 6 0,-3-7 0,6 4 0,-7-1 0,7 2 0,-3-1 0,1 2 0,1-1 0,-2-1 0,5 3 0,-2-3 0,1 1 0,-4 2 0,3-7 0,-3 3 0,0-3 0,2 0 0,-5 3 0,5-3 0,-2 4 0,0-5 0,0-2 0,-1 2 0,1-3 0,0 4 0,3 0 0,-3 3 0,3-2 0,1 3 0,0-1 0,-1-2 0,1 2 0,-4 0 0,3-2 0,-3 2 0,3 1 0,1-4 0,0 8 0,-1-8 0,1 7 0,0-6 0,-4 2 0,3 1 0,-3-3 0,0 2 0,3 0 0,-6-2 0,5-2 0,-5 0 0,1-11 0,1 6 0,-2-2 0,8 4 0,-4 3 0,6 1 0,-4 0 0,4 3 0,-3-2 0,7 6 0,-4-6 0,1-1 0,2-1 0,-2 1 0,0 1 0,2 2 0,-2-3 0,3 0 0,0 3 0,0-2 0,0 2 0,0 1 0,0 0 0,0 1 0,-3 2 0,2-7 0,-2 8 0,3-8 0,0 4 0,0-1 0,0-2 0,0 2 0,0 1 0,0-4 0,0 4 0,0-1 0,0-2 0,0-1 0,0 3 0,0-5 0,0 5 0,0 0 0,0-2 0,0 3 0,0-1 0,0-2 0,0 2 0,0-3 0,0 0 0,0 3 0,0-2 0,0 6 0,0-6 0,0 6 0,0-3 0,0 1 0,0 2 0,0-3 0,0-3 0,0 6 0,0-6 0,0 3 0,0 4 0,0-4 0,0 0 0,0 4 0,0-4 0,0 0 0,0 3 0,0-2 0,0-4 0,3-1 0,1-1 0,-1 3 0,1 6 0,-1-4 0,-2 3 0,5-2 0,-5-1 0,2 3 0,0-2 0,-2-1 0,5 3 0,-5-2 0,5 3 0,-5-4 0,8 3 0,-8-2 0,12 6 0,-6 1 0,4 3 0,2 0 0,-5 6 0,0-4 0,-5 5 0</inkml:trace>
</inkml:ink>
</file>

<file path=ppt/ink/ink4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22.635"/>
    </inkml:context>
    <inkml:brush xml:id="br0">
      <inkml:brushProperty name="width" value="0.35" units="cm"/>
      <inkml:brushProperty name="height" value="0.35" units="cm"/>
      <inkml:brushProperty name="color" value="#FFFFFF"/>
    </inkml:brush>
  </inkml:definitions>
  <inkml:trace contextRef="#ctx0" brushRef="#br0">4326 1490 24575,'-19'11'0,"-1"2"0,12-12 0,-6 6 0,3-3 0,-1 0 0,-23 10 0,12-8 0,-14 8 0,10-10 0,11 3 0,-3-3 0,3 1 0,1 1 0,-7 2 0,5-3 0,-5 5 0,10-6 0,-2 4 0,3-4 0,-1 2 0,-2-2 0,2 4 0,1-1 0,-4-3 0,8 2 0,-8-2 0,4 0 0,-1 3 0,-2-3 0,6 3 0,-6 0 0,3-3 0,-1 3 0,-2-3 0,2 3 0,1-3 0,-4 3 0,7-3 0,-6 4 0,2-4 0,1 2 0,-10-2 0,11 3 0,-11 1 0,10-4 0,-5 2 0,1-1 0,0-1 0,3 2 0,-2-2 0,2 0 0,1 3 0,-4-3 0,4 0 0,-1 2 0,-2-5 0,6 5 0,-6-2 0,2 0 0,1 3 0,-4-3 0,4 0 0,-4 3 0,-1-3 0,1 3 0,0 1 0,0 0 0,-1-4 0,1 3 0,0-3 0,-1 4 0,1-4 0,-5 3 0,-3 1 0,-3 1 0,-1-1 0,6-1 0,-3-3 0,8 4 0,-8 0 0,1 3 0,-3-5 0,3 4 0,-1-5 0,8 2 0,-4 1 0,5-4 0,-1 3 0,-3-2 0,2-1 0,-2 3 0,7-3 0,-2 0 0,2 3 0,-3-6 0,3 2 0,-2 0 0,2-2 0,1 6 0,0-6 0,1 5 0,2-5 0,-7 2 0,4-3 0,-1 3 0,-2-2 0,-1 2 0,-1-3 0,-2 0 0,6 0 0,-2 4 0,3-4 0,-5 4 0,-6-4 0,5 0 0,-5 3 0,7-2 0,-7 2 0,5-3 0,-5 0 0,7 0 0,-1 0 0,1 0 0,0 0 0,0 4 0,-5-3 0,4 2 0,-4-3 0,5 0 0,-1 0 0,1 0 0,0 0 0,0 0 0,-1 0 0,1 0 0,3 0 0,-5 0 0,5 0 0,-7 0 0,8 0 0,-4 0 0,4 0 0,-1 0 0,-2 0 0,3 0 0,-5 0 0,1 0 0,3 0 0,-2 0 0,3 0 0,-5 0 0,5 0 0,-4 0 0,4 0 0,-4 0 0,-1 0 0,5 0 0,-4 0 0,4 0 0,-4 0 0,3 0 0,-2 0 0,2 0 0,1-3 0,-4 2 0,8-2 0,-8 0 0,4 2 0,-1-2 0,-2-1 0,2 3 0,1-5 0,-4 5 0,4-5 0,-5 1 0,5 1 0,-10-6 0,7 8 0,-8-8 0,7 6 0,0-4 0,0 0 0,-1 4 0,1-3 0,0 3 0,3-3 0,-2-1 0,2 4 0,-3-2 0,0 1 0,-1-2 0,1 3 0,0-3 0,0 2 0,-1-2 0,1-1 0,0 1 0,-1 2 0,1-2 0,0 3 0,-7-7 0,5 3 0,-5-3 0,10 3 0,-2 1 0,2 0 0,-3-1 0,0-3 0,0 2 0,-1-2 0,1 4 0,0-1 0,3 1 0,-2-1 0,2 1 0,1 0 0,-4-1 0,4 1 0,-1 0 0,-2-1 0,6 1 0,-6-1 0,6 1 0,-3 0 0,1 0 0,2-4 0,-7 3 0,7-3 0,-3 4 0,1 0 0,2-4 0,-3 3 0,0-3 0,3 4 0,-9-4 0,8 3 0,-5-2 0,4 0 0,-2 1 0,1-1 0,-3-1 0,2 3 0,0-7 0,-2 7 0,2-3 0,-3 0 0,3 3 0,-2-3 0,3 4 0,-1-4 0,-3 2 0,4-5 0,-5 2 0,1-3 0,0-1 0,-1 1 0,1 0 0,0 3 0,3-2 0,-2 2 0,5-4 0,-2 1 0,0 0 0,2 0 0,-2-1 0,4 1 0,-1 0 0,1 3 0,-1-5 0,1 8 0,0-8 0,0 9 0,3-3 0,-3 4 0,4 1 0,-4-4 0,0 2 0,3-2 0,-2 3 0,2 1 0,-2-1 0,-1-3 0,0 2 0,0-2 0,0 3 0,0 1 0,0-1 0,1 0 0,-2-4 0,1 3 0,0-6 0,0 6 0,-4-6 0,3 6 0,-3-6 0,4 2 0,-4 0 0,2-2 0,-1 6 0,-1-7 0,3 7 0,-3-6 0,4 3 0,-1-1 0,1-2 0,-4 2 0,3 1 0,-3-4 0,7 7 0,-2-2 0,1-1 0,-2 3 0,3-2 0,-2-1 0,5 3 0,-3-2 0,1-4 0,3 5 0,-6-4 0,5 2 0,-2 3 0,0-2 0,2 0 0,-6-2 0,7 1 0,-4 1 0,4 3 0,-3-7 0,2 6 0,-5-6 0,5 7 0,-5-4 0,5 3 0,-6-6 0,6 6 0,-2-2 0,0-1 0,2 3 0,-3-6 0,1 2 0,2 1 0,-5-3 0,5 2 0,-3-3 0,1-1 0,2 1 0,-2 0 0,3 3 0,0-2 0,0 2 0,0-3 0,0 4 0,0-4 0,0 7 0,0-6 0,0 3 0,0-1 0,0 1 0,0 1 0,0 3 0,-3-6 0,2 5 0,-2-2 0,3 0 0,0 3 0,0-6 0,0 5 0,0-2 0,0 0 0,0 3 0,0-7 0,-3 7 0,2-3 0,-2 0 0,3 2 0,0-5 0,0 6 0,0-3 0,0 0 0,0 2 0,0-5 0,0 5 0,0-2 0,0 1 0,0-2 0</inkml:trace>
</inkml:ink>
</file>

<file path=ppt/ink/ink4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28.783"/>
    </inkml:context>
    <inkml:brush xml:id="br0">
      <inkml:brushProperty name="width" value="0.35" units="cm"/>
      <inkml:brushProperty name="height" value="0.35" units="cm"/>
      <inkml:brushProperty name="color" value="#FFFFFF"/>
    </inkml:brush>
  </inkml:definitions>
  <inkml:trace contextRef="#ctx0" brushRef="#br0">4766 929 24575,'-39'0'0,"4"0"0,15 0 0,2 3 0,6 5 0,-3-3 0,3 5 0,-20 8 0,16-7 0,-18 13 0,25-13 0,-8 1 0,8-1 0,-5-4 0,6 0 0,-2 0 0,2 4 0,-2-3 0,2 3 0,-10-1 0,6 2 0,-3-1 0,5 0 0,-1-4 0,-1 4 0,1-3 0,-4 3 0,4-4 0,-1 4 0,-2-2 0,6 1 0,-7 1 0,7-3 0,-2 3 0,2-1 0,-2-2 0,2 3 0,-7 0 0,7-3 0,-6 6 0,3-6 0,-1 3 0,2-4 0,-1 4 0,3-3 0,-6 3 0,6-4 0,-3 3 0,4-2 0,-4 3 0,3-4 0,-3 4 0,4-3 0,-4 3 0,3 0 0,-9 0 0,7 4 0,-7-3 0,9-1 0,-3-4 0,4 0 0,-3 3 0,2-2 0,-3 3 0,4-4 0,0 0 0,1 0 0,-1 3 0,-4-2 0,3 2 0,-2-3 0,3 0 0,0 0 0,0-1 0,-4 2 0,3-1 0,-2 0 0,-1 0 0,3 0 0,-6 1 0,6 2 0,-7-1 0,7 2 0,-6-4 0,6 0 0,-6 1 0,2-1 0,1 0 0,-4 1 0,7-1 0,-6 0 0,6 0 0,-6 1 0,6-1 0,-6-3 0,2 3 0,-3-3 0,0 3 0,3 1 0,-2-1 0,2 1 0,-3-1 0,0 1 0,3-1 0,-2 1 0,2-1 0,-3-3 0,0 3 0,3-3 0,-2 4 0,2-1 0,1 0 0,-4 1 0,4-1 0,-1 0 0,-2-3 0,6 3 0,-6-3 0,6 3 0,-7 0 0,8 0 0,-8 1 0,4 2 0,-4-2 0,4 2 0,-3-2 0,6-1 0,-6 0 0,2 1 0,1-1 0,-4-3 0,4 3 0,-1-3 0,-2 3 0,2 0 0,1-2 0,-3 1 0,2-1 0,-3 2 0,3 1 0,-2-1 0,2-3 0,1 3 0,-4-7 0,4 7 0,-4-6 0,-1 5 0,1-5 0,3 6 0,-6-6 0,5 5 0,-7-5 0,5 2 0,0-3 0,0 4 0,-1-4 0,1 4 0,0-4 0,-1 0 0,1 0 0,0 0 0,0 0 0,3 0 0,-2 0 0,6 0 0,-6 0 0,6 0 0,-7 0 0,8 0 0,-8 0 0,8 0 0,-4 0 0,0 0 0,0 0 0,-1 0 0,-2 0 0,6 0 0,-6 0 0,6 0 0,-6 0 0,6 0 0,-7 0 0,8 0 0,-8 0 0,7 0 0,-2 0 0,-1 0 0,-4 0 0,3 0 0,-5 0 0,9 0 0,-3 0 0,1 0 0,2 0 0,-3 0 0,1 0 0,2 0 0,-3 0 0,1 0 0,2 0 0,-3 0 0,-3 0 0,2 0 0,-6 0 0,3 0 0,3 0 0,-2 0 0,2 0 0,-3 0 0,0 0 0,-1 0 0,1 0 0,0 0 0,3 0 0,-2 0 0,2 0 0,-3 0 0,0-4 0,-1 4 0,5-7 0,-4 6 0,4-5 0,-4 5 0,-1-6 0,-3 7 0,2-7 0,-2 6 0,-1-6 0,4 6 0,-8-7 0,7 4 0,-7 0 0,8-3 0,-8 6 0,8-6 0,-4 6 0,5-6 0,0 7 0,-1-7 0,1 6 0,0-6 0,3 6 0,-2-5 0,2 1 0,1 1 0,-3-3 0,6 6 0,-7-5 0,8 5 0,-11-6 0,10 3 0,-10-3 0,10 3 0,-2-3 0,-1 3 0,3-3 0,-2 3 0,-1-3 0,3 4 0,-9-8 0,4 3 0,-1 1 0,3 0 0,1 3 0,2-3 0,-7-1 0,8 1 0,-8-4 0,4 3 0,-1-6 0,-3 5 0,3-5 0,-3 5 0,0-5 0,0 5 0,-1-5 0,-3 5 0,2-5 0,-2 5 0,3-6 0,-3 3 0,-2 0 0,-4-4 0,0 3 0,0-4 0,-6-1 0,5 2 0,-4-2 0,5 5 0,-1-3 0,6 7 0,0-2 0,5 3 0,3 1 0,2-1 0,-1 1 0,3 0 0,-2 0 0,3 0 0,0 0 0,0 0 0,-3 0 0,2 1 0,-2-1 0,4 0 0,-1 0 0,-3 1 0,3-1 0,-3 3 0,3-2 0,0-1 0,0 3 0,0-6 0,0 7 0,1-4 0,-5 0 0,3 0 0,-3-4 0,0 2 0,0-2 0,-1 0 0,-3-1 0,3 1 0,-3-4 0,0 3 0,0 0 0,-1-2 0,1 2 0,0-3 0,-1-5 0,0 4 0,-5-9 0,4 8 0,-4-8 0,6 9 0,-1-4 0,0 5 0,1-1 0,4 5 0,-4-4 0,7 8 0,-3-8 0,1 7 0,1-6 0,-5 2 0,6 0 0,-3-2 0,4 6 0,-4-3 0,3 0 0,-3 3 0,3-6 0,1 6 0,3-3 0,-2 5 0,2-1 0,-3-3 0,3 2 0,-2-2 0,3 3 0,-1-3 0,-2-1 0,2-1 0,0 2 0,-2 3 0,2-3 0,0 3 0,-2-3 0,2 0 0,0-2 0,-2 2 0,5-1 0,-5 0 0,5 3 0,-6-6 0,6 6 0,-5-6 0,2 6 0,-4-6 0,4 6 0,-3-6 0,3 2 0,0 0 0,-3-2 0,3 2 0,0 1 0,-3-3 0,6 6 0,-2-3 0,-1 1 0,3 2 0,-2-3 0,0-3 0,-1 6 0,0-10 0,-2 11 0,5-4 0,-2-3 0,3 6 0,-3-6 0,2 7 0,-2 0 0,0-3 0,2 2 0,-2-3 0,0 1 0,2 2 0,-2-1 0,3-2 0,0 3 0,0-3 0,0 2 0,0 1 0,0-6 0,0 6 0,0-2 0,0-1 0,0 3 0,0-2 0,0-4 0,0 5 0,0-4 0,0 6 0,0-4 0,0 3 0,0-2 0,0 0 0,0-2 0,0 1 0,0 1 0,0 3 0,0-7 0,0 6 0,0-6 0,0 3 0,0 3 0,0-2 0,0-1 0,0 3 0,0-2 0,0 0 0,0 2 0,6-1 0,1 2 0</inkml:trace>
</inkml:ink>
</file>

<file path=ppt/ink/ink4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32.822"/>
    </inkml:context>
    <inkml:brush xml:id="br0">
      <inkml:brushProperty name="width" value="0.35" units="cm"/>
      <inkml:brushProperty name="height" value="0.35" units="cm"/>
      <inkml:brushProperty name="color" value="#FFFFFF"/>
    </inkml:brush>
  </inkml:definitions>
  <inkml:trace contextRef="#ctx0" brushRef="#br0">2908 1 24575,'-24'7'0,"-2"1"0,17 3 0,-6-3 0,3 6 0,-2-2 0,2 0 0,-17 19 0,14-15 0,-12 13 0,18-15 0,-5-2 0,5 0 0,-5 2 0,6-2 0,-7 3 0,4 0 0,-1 1 0,-3-1 0,7 0 0,-3 0 0,0-3 0,2 3 0,-2-3 0,4-1 0,-4 3 0,3-6 0,-3 7 0,4-8 0,0 4 0,0 0 0,0-4 0,-1 8 0,1-8 0,0 8 0,0-7 0,-4 6 0,3-6 0,-3 6 0,4-3 0,-4 5 0,3-5 0,-6 3 0,2-2 0,0 0 0,-2 2 0,3-3 0,-1 5 0,-3-1 0,3-3 0,-7 3 0,2-3 0,-2 4 0,3-1 0,1 1 0,-7 6 0,1-5 0,-3 5 0,5-6 0,4-4 0,-1 3 0,1-4 0,0 5 0,3-1 0,-2 0 0,2 0 0,0 0 0,-2 1 0,2-4 0,0 2 0,-2-2 0,5 3 0,-5 0 0,5 1 0,-5-1 0,5 0 0,-5 1 0,2-1 0,0 0 0,-3 5 0,3-4 0,-4 4 0,0-1 0,0 2 0,-1 4 0,-8 17 0,6-8 0,-7 14 0,3-11 0,3 0 0,-7-3 0,8 1 0,-3-7 0,-1 8 0,6-13 0,-10 8 0,9-10 0,-3 5 0,5-5 0,0-2 0,1-3 0,-1 3 0,0-2 0,4 2 0,-3-3 0,3-1 0,-3 0 0,4-3 0,-4 2 0,7-2 0,-6 3 0,6-4 0,-7 4 0,7-7 0,-3 6 0,4-2 0,-4-1 0,3 4 0,-3-3 0,-4 10 0,6-5 0,-9 1 0,9 1 0,-5-6 0,5 7 0,-6-5 0,7 0 0,-7 1 0,7-1 0,-6 0 0,5 1 0,-2-5 0,1 3 0,1-2 0,-5 3 0,6 0 0,-3 0 0,0 1 0,2-1 0,-5 0 0,5 1 0,-2-1 0,0-3 0,3 2 0,-3-2 0,0 3 0,2-3 0,-2 2 0,1-2 0,-2 10 0,-3-9 0,3 9 0,1-10 0,0 3 0,2 0 0,-5 0 0,6-3 0,-7 2 0,4-2 0,-1-1 0,1 4 0,0-4 0,3 1 0,-6 2 0,6-6 0,-6 6 0,6-2 0,-7 3 0,7 0 0,-7 1 0,7-1 0,-7 0 0,7 5 0,-7-4 0,6 4 0,-6-1 0,7-2 0,-8 7 0,7-3 0,-3-1 0,0 4 0,-1-3 0,0 4 0,-9 7 0,11-5 0,-11 1 0,13-4 0,-6-8 0,3 4 0,0-5 0,-2 0 0,5 0 0,-2 1 0,0-4 0,3 2 0,-7-2 0,7-1 0,-3 0 0,1 0 0,2 0 0,-7 1 0,7-1 0,-6 0 0,6 0 0,-7 1 0,7 2 0,-7-5 0,7 5 0,-3-5 0,0 5 0,3-6 0,-3 6 0,1-6 0,-2 13 0,0-11 0,1 11 0,4-9 0,-1 3 0,1 0 0,-1 1 0,0-1 0,0 5 0,1-4 0,-2 8 0,2-7 0,-1 2 0,0 1 0,0-4 0,3 8 0,-1-7 0,1 2 0,1-4 0,-3 0 0,7 1 0,-7-5 0,6 4 0,-2-8 0,0 4 0,2-1 0,-2 0 0</inkml:trace>
</inkml:ink>
</file>

<file path=ppt/ink/ink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0"/>
    </inkml:context>
    <inkml:brush xml:id="br0">
      <inkml:brushProperty name="width" value="0.28222" units="cm"/>
      <inkml:brushProperty name="height" value="0.28222" units="cm"/>
      <inkml:brushProperty name="color" value="#FFFFFF"/>
    </inkml:brush>
  </inkml:definitions>
  <inkml:trace contextRef="#ctx0" brushRef="#br0">1 3649 24575,'0'14'0,"0"-3"0,0-1 0,0-5 0,0 6 0,0-7 0,0 12 0,0-7 0,2 12 0,-1-12 0,1 3 0,-2-6 0,0 0 0,3-1 0,-3 2 0,2-1 0,-2 1 0,2-2 0,-2 0 0,2-1 0,-2-1 0,3 2 0,-3 0 0,3 0 0,-1 0 0,-1-1 0,1 1 0,0-2 0,-2 1 0,2-1 0,1 1 0,-3 0 0,3 1 0,-1-2 0,1 2 0,0-2 0,1 2 0,-4-1 0,3-1 0,-1 2 0,-1 0 0,3-1 0,-4 0 0,5 1 0,-4 0 0,0-1 0,1 1 0,-1-1 0,4-2 0,-5 2 0,3-1 0,-1 2 0,-2 0 0,5 0 0,-5-1 0,4 0 0,-3 1 0,1 0 0,0 0 0,-1-1 0,4 0 0,-5 0 0,4 1 0,-4 0 0,3 0 0,-1-1 0,-2 1 0,6 0 0,-6-1 0,4 1 0,-3 0 0,3-3 0,-4 2 0,5-2 0,-4 3 0,3 0 0,-1-1 0,1-1 0,1-1 0,0-2 0,0 0 0,0 0 0,0 0 0,0 0 0,-1 0 0,1 0 0,1 0 0,-1 0 0,-1 0 0,1 0 0,0 0 0,1 0 0,-5-2 0,4-1 0,-2-2 0,0 0 0,1 1 0,-3 0 0,3 0 0,-4-1 0,3 0 0,-3 1 0,2-1 0,-1 0 0,1 1 0,-2-1 0,2 2 0,-2-1 0,3-1 0,-3 1 0,0-4 0,0 4 0,3-1 0,-3 0 0,1-2 0,-1 2 0,3-8 0,-3 8 0,4-4 0,-3 3 0,2 0 0,-1-1 0,-1 2 0,2-2 0,-2 2 0,1-1 0,-2 1 0,0 0 0,0 1 0,0-1 0,0 1 0,0-1 0,0 0 0,0 0 0,0 1 0,0 0 0,0-1 0,0 0 0,3-3 0,-3 4 0,6-6 0,-6 3 0,6-4 0,-4 4 0,3-4 0,-2 4 0,3-2 0,-6-2 0,4 3 0,-1-4 0,3 4 0,-1-2 0,0 4 0,-2-2 0,5-1 0,-5-3 0,4 3 0,-2-2 0,-2 8 0,2-8 0,-2 6 0,0-5 0,1 5 0,-1-2 0,1 2 0,0-2 0,-2 1 0,2 1 0,-2 0 0,1 0 0,-3 0 0,3 0 0,-2 1 0,-1-1 0,2 0 0,1 0 0,-3 1 0,3-1 0,-1 0 0,-1-1 0,1-1 0,0 3 0,-1-1 0,3 1 0,-4-1 0,5 0 0,-4 0 0,3-2 0,-3 2 0,4-1 0,-5 1 0,5 0 0,-3 0 0,1 1 0,2-1 0,-2 1 0,-1-1 0,2 0 0,-1 0 0,3 1 0,-2 1 0,1 0 0,1 0 0,-1-2 0,-1 3 0,1-3 0,0 5 0,1-4 0,-2 2 0,2-1 0,-1-1 0,-1 3 0,1-3 0,0 3 0,1-1 0,-2 0 0,1 2 0,1-2 0,-2 0 0,0 2 0,2-3 0,-1 1 0,0 2 0,0-2 0,0 0 0,1 1 0,-4-3 0,2 3 0,-1 0 0,2-1 0,0-1 0,0 1 0,0-2 0,0 1 0,0 0 0,0-1 0,0 1 0,-2-1 0,1 2 0,1-5 0,-2 4 0,4-4 0,-5 4 0,4-1 0,-3 3 0,1-4 0,-3 0 0,3 0 0,-1 1 0,2-1 0,-2 1 0,2-1 0,-3 0 0,2 0 0,-1-2 0,2 2 0,-2-1 0,2-2 0,-3 3 0,4-2 0,-3 2 0,0 0 0,-1 0 0,0 1 0,-2-1 0,3 0 0,-1 2 0,-2-2 0,2 1 0,0-1 0,-1-3 0,2 3 0,0-5 0,-3 0 0,4 0 0,-3 1 0,2-2 0,-1 4 0,-1-1 0,1-2 0,-2 2 0,0 1 0,3-7 0,-3 7 0,3-7 0,-3 7 0,1-4 0,0 1 0,2 0 0,0 0 0,-3-1 0,3 1 0,-3 3 0,0-3 0,2 3 0,-1-2 0,2 0 0,-2 1 0,0-3 0,3 4 0,-3-2 0,5 1 0,-6-3 0,5 1 0,-3-4 0,2 3 0,0-2 0,-3 3 0,4 2 0,-5-2 0,5 0 0,-2 0 0,1 0 0,0-1 0,0 1 0,-2-2 0,4 0 0,-3-1 0,0 0 0,2 2 0,-3-5 0,4 6 0,0-7 0,-3 6 0,2-4 0,-1 1 0,2-3 0,-2-1 0,1 2 0,-5-1 0,6 0 0,-6 1 0,3-1 0,-3-4 0,0 4 0,0-4 0,0 1 0,0 2 0,0-13 0,0 12 0,0-12 0,0 9 0,0 2 0,0-4 0,0 7 0,0-3 0,0 0 0,0 3 0,0-4 0,0 4 0,0 1 0,0-1 0,0 0 0,0 0 0,0 4 0,0-4 0,0 3 0,0 0 0,0 2 0,0-2 0,0 3 0,0-5 0,0 5 0,0-5 0,-3 2 0,3-3 0,-6-7 0,2 5 0,-1-8 0,-2 9 0,1-6 0,0 0 0,-1-2 0,0-2 0,0 4 0,4-4 0,-3-2 0,3 1 0,-2 0 0,-1 6 0,5-6 0,-4 4 0,4-4 0,-2 5 0,3 0 0,-3-1 0,2 4 0,-2-3 0,3 4 0,0-2 0,-3-2 0,2 7 0,-1-6 0,2 1 0,0-2 0,0 2 0,0-1 0,0 2 0,0-7 0,0 6 0,0-3 0,0 12 0,0-4 0,0 6 0,0-2 0,0 2 0,0-1 0,0 0 0,0-4 0,0-4 0,0 1 0,0-6 0,0 6 0,0-3 0,0-3 0,0 5 0,0-4 0,0 4 0,0-6 0,0 5 0,0-2 0,0 2 0,0 0 0,0 0 0,0 4 0,0 1 0,0-1 0,0 0 0,0 0 0,0-11 0,0 9 0,0-12 0,0 13 0,0-1 0,0 1 0,0 1 0,0 0 0,0 1 0,0-1 0,0 0 0,0 1 0,0 1 0,0 2 0,0 3 0,0-4 0,0 4 0,0 0 0,0-1 0,-3 4 0,3-1 0,-3 1 0,3 0 0,-2 2 0,1-2 0,-1 2 0,2 1 0,-2-1 0,1-3 0,-1 3 0,0-2 0,2 2 0,-2-1 0,-1 1 0,3-5 0,-2 5 0,2-5 0,-3 6 0,3-7 0,-3 4 0,3-2 0,0 1 0,-3-2 0,2 2 0,0 0 0,1 1 0,0 2 0,-2 1 0,1-1 0,-1 1 0,0 2 0,1-3 0,-4 3 0,5-3 0,-4 2 0,2 2 0,-3 1 0,0 0 0,0 0 0,1 0 0</inkml:trace>
</inkml:ink>
</file>

<file path=ppt/ink/ink5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36.468"/>
    </inkml:context>
    <inkml:brush xml:id="br0">
      <inkml:brushProperty name="width" value="0.35" units="cm"/>
      <inkml:brushProperty name="height" value="0.35" units="cm"/>
      <inkml:brushProperty name="color" value="#FFFFFF"/>
    </inkml:brush>
  </inkml:definitions>
  <inkml:trace contextRef="#ctx0" brushRef="#br0">1893 0 24575,'-4'27'0,"-2"-6"0,-3-2 0,1-10 0,-3 14 0,0-10 0,-16 36 0,5-20 0,-6 17 0,10-24 0,10-6 0,-3-1 0,3 0 0,-3-3 0,3 2 0,-3-2 0,3 4 0,1-5 0,-1 3 0,1-6 0,0 7 0,0-8 0,-4 11 0,3-6 0,-2 3 0,2-5 0,5-3 0,-4 0 0,3 4 0,0-3 0,-2 2 0,2-3 0,0 4 0,-2-3 0,5 6 0,-5-6 0,2 6 0,0-6 0,-3 6 0,3-2 0,0 0 0,-3 2 0,3-3 0,0 5 0,-3-1 0,3-3 0,-4 2 0,4-3 0,-2 1 0,2 2 0,0-2 0,-3-1 0,3 4 0,0-7 0,-2 13 0,2-12 0,-4 12 0,4-13 0,-3 7 0,7-8 0,-7 4 0,6 0 0,-2-4 0,0 8 0,2-7 0,-6 6 0,6-6 0,-5 6 0,5-3 0,-6 1 0,7 2 0,-7-6 0,7 6 0,-6-6 0,5 7 0,-6-4 0,7 8 0,-7-7 0,6 5 0,-5-5 0,2-1 0,0 4 0,-3-4 0,6 1 0,-5 2 0,2-6 0,0 6 0,-3-6 0,7 3 0,-7-1 0,6-2 0,-5 3 0,2 0 0,-3-4 0,3 4 0,-3 0 0,3-4 0,0 8 0,-2-7 0,2 2 0,-3-3 0,3 4 0,-2-3 0,2 2 0,-2-3 0,-2 4 0,4-3 0,-2 2 0,2 1 0,-3-3 0,-1 6 0,1-6 0,0 2 0,0 1 0,0-3 0,0 2 0,0-3 0,-1 4 0,1-3 0,0 2 0,0-3 0,4 4 0,-4-3 0,4 2 0,-5 1 0,1-3 0,0 3 0,0-1 0,0-2 0,-1 6 0,1-6 0,0 7 0,0-4 0,-1 1 0,1-2 0,0 1 0,0-3 0,-1 6 0,1-6 0,0 2 0,3 1 0,-2-3 0,2 3 0,-3-5 0,0 1 0,0 4 0,0-3 0,3 2 0,-2-3 0,2 0 0,-3 0 0,0 3 0,0-2 0,0 2 0,1-3 0,2 0 0,-5 2 0,4-1 0,-5 2 0,3-6 0,0 2 0,-3 1 0,3-2 0,0 4 0,-3-5 0,6-1 0,-10 1 0,6-1 0,-2-3 0,-4 3 0,5-3 0,-4 0 0,2 0 0,3 0 0,-2 0 0,-1 0 0,3 3 0,-2-2 0,-4 2 0,5-3 0,-4 0 0,6 0 0,-7 0 0,6 0 0,-10 0 0,11 0 0,-4 0 0,1 0 0,3 0 0,-7 0 0,6 0 0,-2 0 0,0 0 0,2 0 0,-6 0 0,7 0 0,-4 0 0,0 0 0,3-3 0,-2 2 0,-4-2 0,6 0 0,-6 3 0,7-3 0,0-1 0,-3 1 0,2-1 0,-2 1 0,0 0 0,6-1 0,-8-3 0,7 3 0,-5-2 0,3 2 0,-3-3 0,3 0 0,-3 4 0,3-4 0,0 4 0,0-4 0,0 0 0,0-3 0,0 2 0,0-6 0,0 7 0,0-4 0,3 0 0,-3 0 0,4-1 0,-5-2 0,1 2 0,-1 1 0,1-4 0,3 8 0,-3-4 0,4 4 0,-1 0 0,-5-3 0,4 3 0,-2-3 0,-2 3 0,7 0 0,-7-4 0,5 6 0,-3-4 0,0 2 0,3-1 0,-2-2 0,2 3 0,-3-3 0,0 3 0,4-3 0,-3 3 0,2-2 0,0 1 0,-2-2 0,2 0 0,0 3 0,-2-3 0,2 3 0,-2 0 0,-1-3 0,3 2 0,1-1 0,0-1 0,-1 2 0,0-2 0,-2 1 0,3 1 0,-1-2 0,1 0 0,0 3 0,-1-3 0,-3 0 0,3 2 0,1-1 0,3-1 0,-3 2 0,2-2 0,-2 1 0,0 1 0,0-4 0,-4 2 0</inkml:trace>
</inkml:ink>
</file>

<file path=ppt/ink/ink5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39.536"/>
    </inkml:context>
    <inkml:brush xml:id="br0">
      <inkml:brushProperty name="width" value="0.35" units="cm"/>
      <inkml:brushProperty name="height" value="0.35" units="cm"/>
      <inkml:brushProperty name="color" value="#FFFFFF"/>
    </inkml:brush>
  </inkml:definitions>
  <inkml:trace contextRef="#ctx0" brushRef="#br0">1632 1007 24575,'-26'19'0,"2"0"0,9-4 0,-5 1 0,4-1 0,-4 1 0,1 0 0,-11 6 0,-7 3 0,9-5 0,0-3 0,16-9 0,-3-1 0,-3 4 0,2-3 0,-6 6 0,10-6 0,-5 3 0,5-4 0,1 0 0,-4 1 0,4-4 0,-1 2 0,-2-5 0,2 2 0,-7 1 0,3-3 0,-4 3 0,5-4 0,-5 3 0,4-2 0,-4 3 0,5-1 0,0-2 0,3 3 0,-2-4 0,2 0 0,-3 0 0,0 0 0,-1 0 0,1 0 0,0 0 0,-1 0 0,-6 0 0,5-4 0,-9 0 0,13-4 0,-10 0 0,11 1 0,-8-1 0,5-3 0,-1 2 0,1-2 0,0 4 0,0-1 0,0 0 0,3 4 0,-2-3 0,2 3 0,-3 0 0,4-2 0,-4 1 0,4-2 0,-1 0 0,-2 3 0,2-3 0,1 3 0,-4 0 0,7-2 0,-2 2 0,-1 0 0,3-2 0,-2 2 0,-4-3 0,5 0 0,-4 0 0,6 0 0,0 0 0,-4 3 0,4-2 0,-4 2 0,4-6 0,0 2 0,0-3 0,0 4 0,0 0 0,0 0 0,0 1 0,0-1 0,0 0 0,0-4 0,0 0 0,-1-1 0,1-2 0,-1 2 0,1-3 0,-1 0 0,1-1 0,-1 1 0,0 0 0,1 3 0,-1-2 0,1 2 0,0 1 0,0 0 0,-1 0 0,1 4 0,3-4 0,-2 0 0,-1 1 0,-2-6 0,2 5 0,1 1 0,5-1 0,-5 3 0,2-6 0,-3 6 0,3-6 0,-2 6 0,5-6 0,-6 2 0,4 1 0,-2 0 0,-1 0 0,5 4 0,-6-8 0,6 4 0,-5-1 0,5-2 0,-5 2 0,1-3 0,1 3 0,1-2 0,-1 2 0,4-3 0,-4 4 0,4-4 0,-3 4 0,2-5 0,-2-2 0,3 2 0,-4 1 0,4 1 0,-3 6 0,-1-6 0,3 2 0,-5-3 0,5 4 0,-6-3 0,6 2 0,-5-3 0,5-1 0,-6 5 0,6-3 0,-2 2 0,3 1 0,-3-4 0,2 8 0,-2-4 0,3-3 0,0 6 0,0-6 0,0 7 0,0-3 0,0 0 0,0-1 0,0 1 0,0 0 0,0 3 0,0-6 0,0 5 0,0-2 0,0 1 0,0 1 0,0-4 0,0 5 0,0-3 0</inkml:trace>
</inkml:ink>
</file>

<file path=ppt/ink/ink5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43.641"/>
    </inkml:context>
    <inkml:brush xml:id="br0">
      <inkml:brushProperty name="width" value="0.35" units="cm"/>
      <inkml:brushProperty name="height" value="0.35" units="cm"/>
      <inkml:brushProperty name="color" value="#FFFFFF"/>
    </inkml:brush>
  </inkml:definitions>
  <inkml:trace contextRef="#ctx0" brushRef="#br0">2776 1095 24575,'-35'0'0,"-3"0"0,12 0 0,-10 0 0,10 0 0,0 0 0,-21 0 0,3 0 0,-5 4 0,7-3 0,26 5 0,-4-1 0,1 3 0,2-1 0,-3 1 0,5-3 0,0 1 0,3-5 0,-2 6 0,2-3 0,-3 4 0,4-1 0,-4-3 0,4 3 0,-1-3 0,-2 3 0,6 0 0,-6 1 0,2-4 0,1 2 0,-4-2 0,4 4 0,-5-1 0,5 1 0,-10 3 0,11-4 0,-11 8 0,9-7 0,-3 3 0,0 0 0,0-3 0,-1 4 0,1-1 0,0-3 0,-1 3 0,5 0 0,-4-2 0,3 2 0,-3 0 0,0-3 0,3 3 0,-2 0 0,2-3 0,-3 3 0,3-4 0,-2 1 0,3-1 0,-5 1 0,1-1 0,0 1 0,-1 0 0,1-1 0,0-2 0,0 1 0,-1-1 0,1-1 0,-7 6 0,5-8 0,-5 8 0,2-9 0,4 2 0,-4 1 0,1-4 0,2 4 0,-7 0 0,8-4 0,-8 4 0,8-4 0,-8 0 0,7 0 0,-2 0 0,4 4 0,-1-4 0,-3 4 0,2-4 0,-2 0 0,0 0 0,3 0 0,-2 0 0,6 0 0,-2 0 0,3 0 0,-5 0 0,1 0 0,0 0 0,3 0 0,-2 0 0,2 0 0,1 0 0,-4 0 0,7 0 0,-2 0 0,-1 0 0,3-3 0,-2-1 0,3-3 0,0 0 0,-4 0 0,4 0 0,-4 0 0,4 0 0,-3 0 0,2 0 0,-3-4 0,0 3 0,3-7 0,-3 7 0,0-6 0,3 6 0,-6-3 0,6 1 0,-3 1 0,0-5 0,3 6 0,-6-6 0,2 2 0,1 1 0,-3-4 0,2 7 0,0-6 0,-6-2 0,6 4 0,-7-3 0,7 4 0,1 3 0,0-3 0,3 0 0,-6 3 0,5-6 0,-5 5 0,6-5 0,-3 6 0,0-7 0,3 7 0,-6-6 0,6 3 0,-7-5 0,7 5 0,-6-4 0,6 4 0,-7-4 0,7-1 0,-3 1 0,0 0 0,2 0 0,-2-1 0,4 5 0,-1-4 0,1 4 0,3-1 0,-3-2 0,3 6 0,0-6 0,-2 6 0,1-7 0,2 8 0,-4-8 0,3 4 0,-4-1 0,1-2 0,3 2 0,-3-3 0,-1 0 0,0 3 0,1-2 0,0 6 0,3-6 0,-3 6 0,0-6 0,0 6 0,0-3 0,-1 1 0,1 2 0,0-7 0,0 8 0,-4-8 0,3 4 0,-3-1 0,0-2 0,3 2 0,-7 0 0,7-2 0,-6 2 0,2 0 0,0-2 0,1 2 0,0-3 0,2-1 0,-5 1 0,5 0 0,-2-1 0,4 1 0,-4-3 0,6 2 0,-5-3 0,9 4 0,-6 0 0,7 0 0,-4 3 0,1-2 0,2 6 0,-2-3 0,3 1 0,0 3 0,0-6 0,0 5 0,0-2 0,0 0 0,0 3 0,0-6 0,0 5 0,0-2 0,0 1 0,0 1 0,0-5 0,0 6 0,0-3 0,0 0 0,0 3 0,0-5 0,-4 4 0,4-2 0,-3 0 0,3 3 0,-3-6 0,2 5 0,-2-2 0,3 1 0,0 1 0,0-4 0,0 4 0,0-1 0</inkml:trace>
</inkml:ink>
</file>

<file path=ppt/ink/ink5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47.496"/>
    </inkml:context>
    <inkml:brush xml:id="br0">
      <inkml:brushProperty name="width" value="0.35" units="cm"/>
      <inkml:brushProperty name="height" value="0.35" units="cm"/>
      <inkml:brushProperty name="color" value="#FFFFFF"/>
    </inkml:brush>
  </inkml:definitions>
  <inkml:trace contextRef="#ctx0" brushRef="#br0">3845 1061 24575,'-37'0'0,"5"0"0,12 0 0,4 4 0,-8 0 0,3 8 0,0-3 0,-16 17 0,13-11 0,-11 11 0,16-13 0,3 1 0,5-2 0,-4 0 0,3 2 0,-3-5 0,3 5 0,-2-5 0,5 5 0,-5-5 0,6 1 0,-3 1 0,0-2 0,3 1 0,-3 1 0,4-3 0,-4 3 0,3-4 0,-3 4 0,-6 0 0,7 1 0,-11-1 0,9-4 0,1 1 0,-4-1 0,4 0 0,-5 1 0,5-1 0,-3 1 0,2-1 0,-3 1 0,0 0 0,-1-1 0,1 4 0,0-2 0,0 2 0,3-4 0,-2 1 0,2-1 0,-3 0 0,0 1 0,-1 0 0,5-1 0,-3 1 0,6-1 0,-7 0 0,8 0 0,-8 1 0,7-1 0,-6 0 0,6 0 0,-9 0 0,8 0 0,-5 0 0,4 0 0,2 0 0,-3 1 0,1-1 0,2 0 0,-3 0 0,4-3 0,1 2 0,-5-2 0,3 0 0,-2 3 0,3-4 0,0 1 0,-3 5 0,-2-7 0,2 7 0,-1-5 0,4 0 0,0 2 0,-3-5 0,2 5 0,-7-5 0,8 2 0,-8-3 0,4 3 0,-1-2 0,-2 2 0,2-3 0,-7 0 0,2 0 0,-2 0 0,-1 0 0,3 0 0,-7 0 0,4 0 0,-1 0 0,-3 0 0,8 0 0,-8 0 0,7 4 0,-7-4 0,8 4 0,-4-4 0,5 3 0,-1-2 0,5 3 0,-3-4 0,2 0 0,0 3 0,-2-3 0,6 3 0,-6-3 0,6 0 0,-3 0 0,1 0 0,2 0 0,-3 0 0,1 0 0,2 0 0,-10 3 0,10-2 0,-10 2 0,11-3 0,-8 0 0,7 3 0,-6-2 0,3 2 0,-1-3 0,-2 0 0,2 0 0,-3 0 0,-1 4 0,1-4 0,0 4 0,-5-4 0,4 0 0,-4 0 0,1 0 0,2 0 0,-2 0 0,-1 0 0,4 0 0,-4 0 0,0 0 0,4 0 0,-4 0 0,5 0 0,-5 0 0,4 0 0,-4 0 0,5 0 0,0 0 0,-1 0 0,-10 0 0,8 0 0,-9 0 0,12-4 0,0 4 0,0-7 0,-1 3 0,1-1 0,-5-2 0,4 3 0,-8-1 0,3-5 0,-4 4 0,0-6 0,0 3 0,0 1 0,0 0 0,0-4 0,4 3 0,-3-3 0,3 4 0,-4-4 0,4 3 0,-3-3 0,8 4 0,-8-1 0,7-2 0,-2 3 0,-3-10 0,5 8 0,-5-7 0,10 8 0,1-1 0,1-1 0,2 3 0,-3-2 0,4 3 0,1 0 0,-1 0 0,0 0 0,0-4 0,0 4 0,-1-4 0,-2 4 0,2-4 0,-3 3 0,4-3 0,-4 1 0,3 2 0,-2-3 0,-1 1 0,3 2 0,-6-7 0,2 4 0,-3-4 0,0-1 0,0 1 0,-5-1 0,-1 0 0,0 0 0,-15-13 0,11 5 0,-8-5 0,7 3 0,5 9 0,-1-9 0,2 9 0,4-2 0,1 3 0,3 1 0,-3 3 0,7-2 0,-3 2 0,4 1 0,-4-4 0,2 4 0,-2-5 0,0 1 0,3 0 0,-3 0 0,3-1 0,1 1 0,-1 4 0,1-4 0,0 7 0,0-2 0,3-1 0,-2 3 0,2-6 0,-4 2 0,1-6 0,-1 2 0,1-2 0,-1 2 0,1 1 0,3 0 0,-3 0 0,6 3 0,-6-2 0,3 2 0,0-3 0,-3 0 0,3-1 0,-1 1 0,-1 0 0,1 0 0,1-1 0,-2 5 0,5-4 0,-6 4 0,7-1 0,-7-2 0,6 6 0,-2-6 0,0 6 0,2-2 0,-5 0 0,5 2 0,-2-2 0,0 0 0,2 2 0,-2-2 0,0-3 0,-1 4 0,0-5 0,-3 8 0,7-5 0,-3 3 0,0-3 0,2 1 0,-6-1 0,6 0 0,-2 1 0,0-1 0,2 3 0,-3-3 0,1 1 0,2 2 0,-2-3 0,0 1 0,2 3 0,-2-3 0,0 0 0,2 2 0,-2-2 0,0 0 0,2 3 0,-5-3 0,5 0 0,-2 3 0,0-3 0,3 0 0,-3 2 0,3-5 0,0 6 0,0-3 0,0 0 0,0 3 0,-3-5 0,-1 1 0</inkml:trace>
</inkml:ink>
</file>

<file path=ppt/ink/ink5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51.446"/>
    </inkml:context>
    <inkml:brush xml:id="br0">
      <inkml:brushProperty name="width" value="0.35" units="cm"/>
      <inkml:brushProperty name="height" value="0.35" units="cm"/>
      <inkml:brushProperty name="color" value="#FFFFFF"/>
    </inkml:brush>
  </inkml:definitions>
  <inkml:trace contextRef="#ctx0" brushRef="#br0">995 1 24575,'-26'11'0,"6"-6"0,9 8 0,0-8 0,3 6 0,-6 0 0,2-3 0,-16 16 0,10-10 0,-10 8 0,12-8 0,5-6 0,-4 3 0,4-3 0,-4 3 0,-1-3 0,1 3 0,0-3 0,3 3 0,-3-3 0,3 3 0,1-3 0,-3 3 0,6-3 0,-7 2 0,4 1 0,-4-2 0,3 1 0,-2 1 0,2-3 0,-3 7 0,-5-6 0,4 5 0,-4-5 0,1 6 0,2-3 0,-7 5 0,8-5 0,-8 3 0,7-6 0,-2 6 0,3-6 0,1 2 0,4-4 0,-4 1 0,7-1 0,-6 0 0,3 3 0,0-2 0,1 2 0,3-3 0,0 0 0,0-1 0,4 4 0,0-3 0,3 6 0,0-6 0,6 3 0,3-2 0,6-1 0,5 1 0,1 4 0,4-3 0,0 4 0,5-1 0,-4-2 0,5 3 0,-1-5 0,-4 1 0,4-1 0,-4 1 0,-6-5 0,4 4 0,-7-7 0,2 3 0,-3-4 0,-1 0 0,0 0 0,1 0 0,-1 0 0,-4 0 0,4 0 0,-7 0 0,2 0 0,4 0 0,-6 0 0,6 0 0,-7 0 0,3 0 0,-3-6 0,0-3 0,-7-5 0,-1 3 0,-3-8 0,1 6 0,2-6 0,-2 3 0,3 1 0,0 0 0,0-1 0,0 5 0,0-4 0,0 8 0,0-4 0,0 1 0,0-1 0,0 0 0,0 0 0,0 1 0,0 2 0,0-3 0,0 1 0,0 2 0,0-4 0,0 4 0,0-2 0,0 1 0,0 1 0,0-5 0,0 6 0,0-3 0,0 0 0,-3 2 0,2 36 0,-2-11 0,3 27 0,0-20 0,0-3 0,0 4 0,0-4 0,0-1 0,0-5 0,0 0 0,0-3 0,0 2 0,0-6 0,0 6 0,0-6 0,0 3 0,-6-1 0,1-3 0,-2 3 0,1-3 0,2 0 0,-3 0 0,0 0 0,0 0 0,1 0 0,-1 0 0,0 0 0,0-1 0,0 1 0,0 0 0,0 0 0,0 0 0,0 0 0,-3 0 0,2 0 0,-3 0 0,4 0 0,0 0 0,1 0 0,-5 3 0,3-5 0,-2 5 0,3-7 0,0 4 0,0 0 0,0 0 0,-4 0 0,3 0 0,-2 0 0,3 0 0,0-3 0,-3 5 0,2-5 0,-2 3 0,4-1 0,-1 1 0,0-2 0,0 4 0,0-2 0,0 1 0,0 2 0,0-3 0,3-1 0,-5 4 0,5-2 0,-6 2 0,3-3 0,0 0 0,0 0 0,-4 0 0,4 0 0,-4-1 0,4 1 0,0 0 0,0 0 0,0 0 0,0 0 0,0 0 0,-2 0 0,4 0 0,-4-1 0,2 1 0,-1 0 0,-2 0 0,3 0 0,1 0 0,-1 0 0,-3-1 0,2 1 0,-2-3 0,3 2 0,0 1 0,1-2 0,-1 4 0,0-5 0,0 3 0,-3 0 0,2 0 0,-2-4 0,3 3 0,0-2 0,1 3 0,-4 0 0,2-3 0,-2 2 0,3-2 0,-3 3 0,2 0 0,-1-1 0,2 1 0,0-3 0,-2 5 0,4-5 0,-4 3 0,0-7 0,0-12 0,-1-5 0,7-4 0,3 8 0,0 6 0</inkml:trace>
</inkml:ink>
</file>

<file path=ppt/ink/ink5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01.468"/>
    </inkml:context>
    <inkml:brush xml:id="br0">
      <inkml:brushProperty name="width" value="0.35" units="cm"/>
      <inkml:brushProperty name="height" value="0.35" units="cm"/>
      <inkml:brushProperty name="color" value="#FFFFFF"/>
    </inkml:brush>
  </inkml:definitions>
  <inkml:trace contextRef="#ctx0" brushRef="#br0">833 1 24575,'-22'8'0,"-1"6"0,9-6 0,1 4 0,-1 2 0,4-6 0,-8 12 0,5-8 0,-9 11 0,17-11 0,-7 1 0,8-9 0,-3 2 0,0 1 0,0-3 0,0 5 0,1-5 0,-1 3 0,0-1 0,0 1 0,1 0 0,-4 0 0,5-1 0,-7 1 0,8 0 0,-6-3 0,0 4 0,3-6 0,-3 7 0,4-6 0,-1 1 0,-2 5 0,1-5 0,-1 6 0,5-4 0,-4 1 0,3-1 0,-4-2 0,2 5 0,1-8 0,-1 8 0,0-2 0,0-2 0,0 4 0,1-6 0,-4 4 0,3-3 0,-2 1 0,3-1 0,-1 3 0,-3 0 0,3-1 0,-3 1 0,3-3 0,1 2 0,-4-3 0,5 4 0,-7 0 0,8 0 0,-6-4 0,0 3 0,5-2 0,-4 3 0,2-3 0,0 2 0,-3-2 0,3 3 0,0-1 0,0 1 0,0 0 0,4 2 0,-3-1 0,2 2 0,-3-4 0,1 1 0,-1 0 0,1-1 0,-1 1 0,0-1 0,1 1 0,-1 0 0,0 0 0,-2-4 0,1 4 0,-2-4 0,4 4 0,-1 0 0,0 0 0,1-1 0,-1 1 0,1-1 0,-1 1 0,0 0 0,1 0 0,-1 0 0,0 0 0,-3-1 0,3-2 0,-3 2 0,4-2 0,-1 2 0,1 4 0,2-3 0,2 2 0</inkml:trace>
</inkml:ink>
</file>

<file path=ppt/ink/ink5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08.697"/>
    </inkml:context>
    <inkml:brush xml:id="br0">
      <inkml:brushProperty name="width" value="0.35" units="cm"/>
      <inkml:brushProperty name="height" value="0.35" units="cm"/>
      <inkml:brushProperty name="color" value="#FFFFFF"/>
    </inkml:brush>
  </inkml:definitions>
  <inkml:trace contextRef="#ctx0" brushRef="#br0">0 1141 24575,'15'23'0,"-2"-4"0,-2-8 0,-3-3 0,2 2 0,-2 1 0,9 7 0,-4-2 0,8 9 0,-10-13 0,-1 1 0,-3-6 0,0 4 0,0-3 0,0 2 0,4 4 0,-4-5 0,4 4 0,-4-2 0,0-3 0,-3 2 0,2-3 0,-2 0 0,3 0 0,0 3 0,0-2 0,-3 2 0,2-4 0,-2 1 0,2 0 0,1 0 0,0 0 0,0-1 0,-1 1 0,1 0 0,0 0 0,0 0 0,0 0 0,0 0 0,0 0 0,3-1 0,-3 1 0,3 0 0,-3-3 0,0 2 0,3-2 0,-2 3 0,2 0 0,-3 0 0,0 0 0,-1 0 0,1-1 0,0 1 0,0 0 0,4 1 0,-3-2 0,2-1 0,25 23 0,-21-19 0,22 20 0,-30-23 0,1 1 0,0 0 0,0 0 0,0 0 0,3 3 0,-2-5 0,2 4 0,0-5 0,-2 3 0,3 0 0,-4 0 0,0 0 0,-1 0 0,5 0 0,-3 0 0,2-3 0,-3 2 0,0-2 0,7 3 0,-2 1 0,2-1 0,1 1 0,-4-1 0,5 1 0,-1-1 0,-4 0 0,4 1 0,-4-1 0,5 1 0,-5-1 0,4 1 0,-4-1 0,4 1 0,-3-1 0,2 4 0,-2-3 0,3 3 0,-3-3 0,2-1 0,-6 0 0,6 1 0,-2-1 0,-1 0 0,4 1 0,-7-1 0,6 0 0,-6 0 0,6-2 0,-6 1 0,6-2 0,-2 3 0,-1 0 0,4 1 0,-4-1 0,1 1 0,2-1 0,-6-3 0,3 3 0,-1-7 0,-2 6 0,6-1 0,-6-2 0,6 4 0,-6-3 0,7 4 0,-1-1 0,-1-3 0,4 2 0,-9-5 0,6 6 0,-6-3 0,6 0 0,-6 2 0,7-5 0,-4 2 0,1 0 0,2-2 0,-2 2 0,-1 0 0,3-2 0,-2 5 0,3-5 0,0 6 0,1-6 0,-1 5 0,0-5 0,0 6 0,1-3 0,-1 1 0,-3 1 0,2-5 0,-3 5 0,1-5 0,9 6 0,-11-3 0,11 0 0,-13 2 0,6-5 0,-6 5 0,3-5 0,-1 5 0,2-5 0,-1 5 0,4-1 0,-4-1 0,1 2 0,2-5 0,-6 5 0,6-5 0,-2 5 0,-1-2 0,4 0 0,-4 3 0,1-7 0,2 7 0,-6-6 0,6 2 0,-6 1 0,2-4 0,1 7 0,-3-6 0,6 5 0,-6-5 0,6 6 0,-6-6 0,7 6 0,-8-6 0,11 5 0,-6-5 0,3 6 0,-5-7 0,1 7 0,-3-6 0,6 2 0,-6-3 0,3 3 0,-1-2 0,-2 2 0,3-3 0,-1 3 0,-2-2 0,7 3 0,-8-1 0,8-3 0,-7 4 0,6-4 0,-3 3 0,1-2 0,2 2 0,-6 0 0,7-2 0,-1 5 0,2-5 0,-1 3 0,-1-4 0,-2 0 0,-1 0 0,4 3 0,-8-2 0,8 2 0,-7-3 0,6 0 0,-6 0 0,6 0 0,-6 0 0,3 0 0,-1 0 0,2 4 0,-1-3 0,4 2 0,-7-3 0,6 0 0,-6 0 0,6 0 0,-6 0 0,6 0 0,-6 0 0,6 0 0,-6 0 0,7 0 0,-4 0 0,5 0 0,-1 0 0,-4 0 0,3 0 0,-2 0 0,3 0 0,1-3 0,-1-2 0,3-2 0,-2 3 0,3-3 0,-4 3 0,0 0 0,0-3 0,1 6 0,-1-5 0,0 5 0,3-9 0,-5 8 0,4-4 0,-9 3 0,6 2 0,-6-5 0,3 5 0,-4-5 0,3 2 0,-2 0 0,3-3 0,-4 4 0,0-4 0,3-1 0,-2 5 0,3-4 0,-1 3 0,-2-3 0,3 0 0,-1 0 0,-2 3 0,3-3 0,-1 3 0,-2-3 0,7-1 0,-8 1 0,11 0 0,-10 0 0,6 0 0,-7 3 0,4-3 0,-3 3 0,2 0 0,-3-2 0,4 2 0,-4-3 0,4 0 0,-4 3 0,4-2 0,-4 2 0,4-1 0,-4-1 0,0 3 0,3-5 0,-2 4 0,3-2 0,-4 2 0,0 0 0,3-5 0,-3 8 0,3-9 0,-3 7 0,0-4 0,0 0 0,3 0 0,-2 0 0,2 0 0,-4 0 0,7-6 0,-4 5 0,10-8 0,-1-7 0,22-19 0,-11 9 0,12-9 0,0 3 0,-16 20 0,31-32 0,-49 47 0,30-21 0,16-8 0,-7 2 0,6-5 0,-43 28 0,9-7 0,-10 5 0,6 1 0,-6-2 0,7 4 0,-7 0 0,2 0 0,1-1 0,-3 1 0,2 0 0,-3 0 0,4-3 0,-4 2 0,4-3 0,0 1 0,-4 2 0,8-3 0,-7 0 0,3 3 0,0-3 0,-3 1 0,2 1 0,1-2 0,-3 4 0,3 0 0,-4-3 0,0 2 0,0-3 0,0 4 0,0-3 0,0 2 0,1-3 0,-1 4 0,-1 0 0,4 0 0,-2 1 0,2-1 0,-6 0 0,2 0 0,1-3 0,1 5 0,-2-4 0,4 2 0,-6 0 0,6-3 0,-6 3 0,5 0 0,-4-3 0,5 2 0,-6-2 0,2 3 0,-3 1 0,4-1 0,0 0 0,0-3 0,0 2 0,-3-2 0,2 3 0,-2-3 0,0 2 0,2-2 0,-5-1 0,5 4 0,-2-8 0,3 8 0,-3-8 0,2 7 0,-1-6 0,-2 6 0,4-2 0,-3-1 0,0 3 0,2-2 0,-5-1 0,5 3 0,-2-3 0,0 1 0,2 2 0,-5-3 0,5 4 0,-5-3 0,5 2 0,-5-6 0,5 6 0,-5-7 0,5 4 0,-5-1 0,6-2 0,-6 2 0,5 1 0,-5-3 0,5 2 0,-5-3 0,6 3 0,-7-2 0,6 6 0,-5-6 0,2 6 0,1-7 0,-3 8 0,2-4 0,0 1 0,-2 2 0,2-5 0,0 5 0,-2-3 0,2 1 0,0-2 0,-2 0 0,2-2 0,1 3 0,-3-1 0,2-2 0,0 6 0,-2-6 0,2 6 0,0-7 0,-2 8 0,6-4 0,-7 0 0,3 3 0,0-2 0,-2 0 0,5 2 0,-5-2 0,2 0 0,0 3 0,-2-3 0,2-4 0,0 5 0,-2-4 0,2 6 0,-3-4 0,3 3 0,-2-5 0,2 5 0,-3-2 0,3 0 0,-2 2 0,2-5 0,-3 5 0,0-3 0,3 1 0,-2 3 0,2-7 0,-3 6 0,0-2 0,0 0 0,0 2 0,0-5 0,0 5 0,0-2 0,0 0 0,0 3 0,0-6 0,0 6 0,0-3 0,0 1 0,0 1 0,0-4 0,0 1 0,0-3 0,0-1 0,0-5 0,0-1 0,-8-9 0,6 15 0,-7-1 0</inkml:trace>
</inkml:ink>
</file>

<file path=ppt/ink/ink5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13.551"/>
    </inkml:context>
    <inkml:brush xml:id="br0">
      <inkml:brushProperty name="width" value="0.35" units="cm"/>
      <inkml:brushProperty name="height" value="0.35" units="cm"/>
      <inkml:brushProperty name="color" value="#FFFFFF"/>
    </inkml:brush>
  </inkml:definitions>
  <inkml:trace contextRef="#ctx0" brushRef="#br0">1 0 24575,'0'37'0,"3"-6"0,2-7 0,6-11 0,-6 6 0,6-8 0,-4 5 0,12 9 0,1 0 0,17 22 0,-15-19 0,7 7 0,-17-20 0,-1 1 0,0-1 0,-3-3 0,3 2 0,-1-3 0,-1 5 0,5-1 0,-5 0 0,2 0 0,0-3 0,-3 3 0,7-7 0,-7 7 0,6-7 0,-5 6 0,2-5 0,0 5 0,-4-6 0,8 6 0,-7-6 0,3 6 0,-1-6 0,-1 7 0,1-7 0,1 3 0,-2 0 0,1-3 0,1 6 0,-3-6 0,3 6 0,0-5 0,-3 5 0,10 1 0,-9 1 0,9 3 0,-10-7 0,3 2 0,0-6 0,-3 7 0,3-7 0,0 6 0,-3-2 0,3-1 0,0 4 0,-3-4 0,3 4 0,0-3 0,-3 2 0,7-2 0,-6 8 0,5-4 0,-2 4 0,4-1 0,0-2 0,-3 7 0,7-2 0,-6 3 0,8 6 0,-5-4 0,5 4 0,4 10 0,-2-10 0,0 10 0,-7-16 0,0 0 0,0 0 0,-1 0 0,-3 0 0,3-4 0,-7 3 0,2-3 0,0-1 0,-2 0 0,2-1 0,-3-2 0,0 2 0,3-4 0,-2 1 0,2-1 0,-4 0 0,1 0 0,-1 0 0,1 1 0,3-1 0,-2 5 0,2-4 0,0 4 0,-2-5 0,2 0 0,1 5 0,-4-4 0,4 4 0,-4-5 0,3 1 0,-3 3 0,4-2 0,2 9 0,-4-9 0,4 9 0,-3-9 0,-2 2 0,2-3 0,-3 3 0,3-2 0,-2 2 0,2-4 0,-3 1 0,-1-5 0,4 3 0,-3-6 0,3 7 0,-4-8 0,0 8 0,0-4 0,1 1 0,-1 2 0,1-2 0,-1-1 0,4 7 0,-4-10 0,4 6 0,-4-3 0,0-4 0,0 8 0,0-7 0,4 6 0,-3-2 0,7 3 0,-7 0 0,7 0 0,-7 1 0,7-1 0,-3 0 0,-1 0 0,4 1 0,-3-1 0,3 0 0,0 1 0,1-1 0,-1 0 0,0 0 0,1 5 0,0-3 0,0 7 0,0-8 0,-3 8 0,2-3 0,-3 0 0,5 3 0,-5-8 0,3 8 0,-6-8 0,7 8 0,-7-7 0,6 7 0,-6-8 0,7 8 0,-7-3 0,10 11 0,-10-10 0,6 5 0,-7-12 0,3 1 0,-3-1 0,3 0 0,0 0 0,-2 1 0,2-1 0,0 0 0,-3 0 0,3 1 0,0-1 0,-2 0 0,5 0 0,-5 1 0,1-5 0,1 4 0,-3-4 0,7 1 0,-7 2 0,7-2 0,-7 4 0,7-5 0,-7 4 0,7-3 0,-7 3 0,10 4 0,-5-3 0,2 3 0,-4-8 0,0 3 0,0-2 0,1 0 0,2 2 0,-6-3 0,7 5 0,-7-5 0,3 4 0,-1-4 0,-1 1 0,2 2 0,-4-2 0,0-1 0,1 3 0,2-6 0,-1 7 0,1-7 0,-2 6 0,-1-6 0,0 6 0,1-2 0,-1-1 0,1 4 0,-1-4 0,1 5 0,-1-5 0,0 3 0,1-2 0,2 6 0,-1-2 0,2 3 0,-4-4 0,1 5 0,0-4 0,0 8 0,0-8 0,0 8 0,0-7 0,0 2 0,0 1 0,-1-4 0,1 4 0,0-5 0,-4-4 0,3 4 0,-3-4 0,4 5 0,-1-5 0,4 10 0,-3-8 0,3 9 0,-3-6 0,-1-5 0,1 4 0,-1-4 0,0 1 0,-2 2 0,1-2 0,-2-1 0,3 4 0,1-4 0,-1 4 0,1 1 0,0-1 0,-1 0 0,5 5 0,-3-4 0,2 4 0,-3-5 0,0 1 0,-1-1 0,1 0 0,0 0 0,-1 1 0,1-1 0,0 0 0,-1 0 0,1 1 0,-1-1 0,1 0 0,0 1 0,-1-1 0,1 0 0,0 0 0,-1 1 0,1-1 0,0 0 0,-4-3 0,3 2 0,-4-6 0,2 6 0,1-6 0,-2 7 0,3-8 0,0 14 0,-3-11 0,3 11 0,-3-13 0,0 6 0,2-6 0,-5 7 0,5-8 0,-5 4 0,5-4 0,-5 3 0,5-2 0,-5 3 0,5-4 0,-5 3 0,5-2 0,-2 3 0,0 0 0,2-4 0,-6 8 0,7-7 0,-7 2 0,6-3 0,-5 3 0,5-2 0,-5 1 0,2 2 0,-3 5 0,0-7 0,0 2 0</inkml:trace>
</inkml:ink>
</file>

<file path=ppt/ink/ink5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16.939"/>
    </inkml:context>
    <inkml:brush xml:id="br0">
      <inkml:brushProperty name="width" value="0.35" units="cm"/>
      <inkml:brushProperty name="height" value="0.35" units="cm"/>
      <inkml:brushProperty name="color" value="#FFFFFF"/>
    </inkml:brush>
  </inkml:definitions>
  <inkml:trace contextRef="#ctx0" brushRef="#br0">0 134 24575,'19'22'0,"-3"-3"0,-9-9 0,0-2 0,0 3 0,0-4 0,0 0 0,9 12 0,-6-8 0,9 11 0,-11-14 0,5 5 0,-6-5 0,3 2 0,-3-3 0,0 0 0,0-1 0,0 1 0,0 3 0,0-2 0,0 2 0,-1-3 0,1-1 0,0 1 0,0 3 0,0-6 0,-1 9 0,1-12 0,0 11 0,0-7 0,0 5 0,0-3 0,0-3 0,3 5 0,-6-4 0,6 5 0,-7-4 0,4 1 0,3 0 0,-2 0 0,2-3 0,-3 2 0,0-2 0,0 3 0,0 0 0,-1 0 0,4 0 0,-2-1 0,6 2 0,-6-1 0,2 0 0,-3 0 0,4-3 0,-3 2 0,2-2 0,-3 3 0,4-4 0,-3 3 0,2-2 0,-3 0 0,0 2 0,3-2 0,1 3 0,0-3 0,0 3 0,-4-3 0,0-1 0,3 3 0,-3-5 0,3 5 0,1-5 0,-3 2 0,2 0 0,1-2 0,0 2 0,1-3 0,2 4 0,-2-4 0,-1 4 0,4-1 0,-4-2 0,1 2 0,2 1 0,-6-3 0,3 5 0,-1-5 0,-2 2 0,3-3 0,2 3 0,-4-2 0,5 3 0,-7-4 0,3 0 0,1 0 0,0 0 0,0 0 0,-5 0 0,4 0 0,1 0 0,-1 0 0,0 0 0,0 0 0,-2 0 0,5 0 0,-6 0 0,3 0 0,0 0 0,-2 0 0,5 0 0,-5 0 0,2 0 0,0 0 0,-2 0 0,3-3 0,-1 2 0,-2-5 0,7 5 0,-8-5 0,4 5 0,0-2 0,-4 0 0,4 2 0,3-5 0,-6 5 0,6-6 0,-7 7 0,0-4 0,6 1 0,-5 3 0,5-6 0,-6 5 0,0-8 0,0 4 0,-1-1 0,4-3 0,-5 4 0,4-5 0,-5 3 0,3 0 0,0-3 0,-1 6 0,1-9 0,0 9 0,-3-6 0,2 3 0,-2-3 0,0 2 0,2-2 0,-2 3 0,0 1 0,2-5 0,-5 3 0,5-3 0,-2 5 0,0-1 0,6-7 0,-9 5 0,9-4 0,-6 6 0,0-4 0,2 3 0,-2-6 0,3 6 0,-3-3 0,2 5 0,-2-4 0,3 2 0,-3-2 0,2 3 0,-5-3 0,2 2 0,0-2 0,1 4 0,2-4 0,-2 2 0,2-1 0,-5-1 0,5 2 0,-5-1 0,2-1 0,0 3 0,-2-6 0,2 6 0,-3-3 0,0 1 0,3 1 0,-2-4 0,2 4 0,-3-2 0,0 0 0,0 3 0,3-3 0,-2 0 0,2 2 0,-3-4 0,0 4 0,0-2 0,0 1 0,0 2 0,0-6 0,-3 6 0,-1-6 0,-7 1 0,6 4 0,-2 1 0</inkml:trace>
</inkml:ink>
</file>

<file path=ppt/ink/ink5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21.416"/>
    </inkml:context>
    <inkml:brush xml:id="br0">
      <inkml:brushProperty name="width" value="0.35" units="cm"/>
      <inkml:brushProperty name="height" value="0.35" units="cm"/>
      <inkml:brushProperty name="color" value="#FFFFFF"/>
    </inkml:brush>
  </inkml:definitions>
  <inkml:trace contextRef="#ctx0" brushRef="#br0">0 944 24575,'30'4'0,"-6"0"0,-10 1 0,-6 4 0,6-3 0,-5 1 0,5 0 0,10 4 0,-9-6 0,9 8 0,-17-12 0,0 5 0,3-5 0,-2 5 0,2-5 0,7 5 0,-7-2 0,6 3 0,-9-3 0,0 2 0,4-2 0,-4 0 0,4 2 0,-4-5 0,0 5 0,3-2 0,-2 0 0,1 2 0,2-5 0,-3 5 0,3-5 0,-5 5 0,4-2 0,-2-1 0,2 4 0,0-4 0,-2 1 0,2 2 0,0-5 0,-3 2 0,3 0 0,0-2 0,-2 5 0,2-5 0,0 5 0,-2-5 0,3 3 0,3-1 0,-6 1 0,6-1 0,-3 4 0,-4-6 0,4 5 0,0-5 0,-4 2 0,4 0 0,3-2 0,-6 2 0,6 0 0,-7-2 0,0 2 0,3-3 0,-2 3 0,3-2 0,-1 5 0,-3-5 0,3 2 0,0-3 0,-2 0 0,5 0 0,-5 3 0,2-3 0,0 3 0,-3-3 0,6 0 0,-5 0 0,2 4 0,0-4 0,-3 3 0,6-3 0,-5 3 0,2-2 0,0 2 0,-2-3 0,5 3 0,-6-2 0,3 2 0,0-3 0,-2 0 0,4 0 0,-4 0 0,2 0 0,2 0 0,-4 0 0,8 0 0,-9 0 0,3 0 0,3 0 0,19 0 0,-10 0 0,34 0 0,-37 0 0,19 0 0,-15-3 0,-7 2 0,60-17 0,-51 10 0,39-8 0,-49 12 0,-4 1 0,1 2 0,2-2 0,-6-1 0,6 4 0,-6-3 0,6-1 0,-6 3 0,7-5 0,-8 5 0,4-3 0,0 1 0,-4-1 0,11-3 0,-10 3 0,10-2 0,-10 2 0,2-1 0,1-1 0,-3 2 0,2 0 0,-3-2 0,4 2 0,-3-3 0,2 2 0,-3-1 0,0 3 0,0-4 0,0 0 0,3-3 0,-2 2 0,2-2 0,-4 3 0,1 3 0,3-5 0,-5 5 0,4-6 0,-5 0 0,3 5 0,0-7 0,-3 7 0,2-5 0,-2 0 0,-1 3 0,4-3 0,-4 0 0,1 2 0,-1-2 0,0 0 0,2-1 0,-2 0 0,4 1 0,-6-1 0,5 3 0,-5-3 0,5 1 0,-5 2 0,2-6 0,0 6 0,-2-7 0,2 4 0,0-1 0,-2-2 0,5 2 0,-5 1 0,6-3 0,-6 2 0,2 0 0,1-2 0,-3 6 0,5-2 0,-5-1 0,2 3 0,0-2 0,-2 0 0,5 2 0,-5-2 0,2 0 0,-3 2 0,3-2 0,-3 0 0,4 3 0,-4-6 0,3 5 0,-3-2 0,6 0 0,-5 3 0,2-3 0,0 0 0,-2 3 0,2-6 0,-3 6 0,0-3 0,0 0 0,0 2 0,3-2 0,-2 0 0,2 3 0,-3-6 0,0 5 0,0-12 0,0 10 0,0-11 0,0 9 0,0-3 0,0 0 0,0 0 0,0-1 0,0 5 0,0-4 0,0 4 0,0-1 0,3 2 0,-2-1 0,2 3 0,-3-2 0,0 0 0,0 2 0,0-5 0,0 1 0,0 2 0,0-1 0,3 4 0,-2-3 0,2 2 0,-3-4 0,3 4 0,-3-1 0,3-5 0,-3 6 0,0-9 0,0 12 0,0-2 0</inkml:trace>
</inkml:ink>
</file>

<file path=ppt/ink/ink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1"/>
    </inkml:context>
    <inkml:brush xml:id="br0">
      <inkml:brushProperty name="width" value="0.28222" units="cm"/>
      <inkml:brushProperty name="height" value="0.28222" units="cm"/>
      <inkml:brushProperty name="color" value="#FFFFFF"/>
    </inkml:brush>
  </inkml:definitions>
  <inkml:trace contextRef="#ctx0" brushRef="#br0">335 1342 24575,'21'0'0,"0"0"0,-11 0 0,-3 0 0,1 0 0,-2 0 0,1 0 0,5-5 0,1 4 0,-1-3 0,-3 4 0,-6 0 0,5-2 0,-2 2 0,1-2 0,0 2 0,-1-2 0,1 1 0,0-1 0,-1 0 0,1 1 0,-1-1 0,0 0 0,1 1 0,0-1 0,-2 0 0,3 2 0,-1-2 0,-2 2 0,5-2 0,-5 2 0,3-3 0,-1 1 0,-2 2 0,2-2 0,1 0 0,-3 1 0,3-1 0,-2 0 0,3-1 0,-1 1 0,-1-1 0,2 3 0,-5-2 0,5 1 0,-4-3 0,2 3 0,-1 0 0,2-1 0,-1 2 0,-1-5 0,3 5 0,-3-2 0,2 0 0,-1 2 0,-2-4 0,2 3 0,-2-3 0,4 3 0,-4-3 0,2 3 0,2-3 0,-2 1 0,2 0 0,1-2 0,-4 5 0,2-4 0,-1 3 0,-1-3 0,2 3 0,0-3 0,-3 3 0,3 0 0,0-1 0,-3 1 0,3-3 0,2 3 0,-4-3 0,4 3 0,-5-1 0,0 0 0,2 2 0,-1-5 0,1 5 0,0-4 0,-1 4 0,4-3 0,-4 1 0,1 2 0,1-5 0,-2 4 0,1-3 0,1 4 0,-2-4 0,1 3 0,1-3 0,-2 3 0,4-4 0,-4 5 0,4-4 0,-4 4 0,4-5 0,-4 4 0,5-3 0,-6 3 0,3-3 0,-1 1 0,-1 0 0,2-1 0,-1 4 0,-1-5 0,1 3 0,1-1 0,-1-1 0,2 1 0,-3 1 0,2-3 0,-4 2 0,5 1 0,-4-2 0,3 4 0,-3-4 0,-1 2 0,4-3 0,1-1 0,-2 4 0,1-3 0,-4 5 0,2-4 0,1 1 0,-1-2 0,1 3 0,-1-3 0,-2 3 0,4 0 0,-2-2 0,1 3 0,-2-2 0,0 0 0,2 0 0,0-1 0,0 1 0,-2 1 0,0-2 0,3 1 0,0-2 0,-1 2 0,4-1 0,-5 1 0,1-2 0,1 0 0,0 3 0,1-2 0,1 1 0,-5-1 0,4-1 0,-3 0 0,1 2 0,1-1 0,-4 1 0,4-1 0,-2-1 0,1 1 0,-1 0 0,-1 2 0,2-3 0,-2 3 0,3-2 0,-4 2 0,2-3 0,-2 1 0,1-1 0,-1 1 0,1-1 0,-2-1 0,3 1 0,-5-2 0,6 2 0,-4 0 0,2 1 0,0-1 0,-3-1 0,0 0 0,1 0 0,-3 0 0,3-5 0,-3 6 0,0-7 0,0 5 0,0-3 0,0-1 0,0 1 0,0 0 0,0 0 0,-3 0 0,3 2 0,-3-2 0,0 2 0,2-3 0,-1 2 0,2 2 0,-2-4 0,1 6 0,-3-2 0,3 0 0,-1 1 0,-1-1 0,0 1 0,0 1 0,0-2 0,0 1 0,0 1 0,-1-2 0,1 0 0,1 2 0,-3-2 0,2 3 0,-2 0 0,0-1 0,1 0 0,-2 1 0,1-1 0,1 0 0,-2 0 0,1 1 0,-2-1 0,1 0 0,-2 0 0,1 0 0,1 2 0,-4-3 0,4 1 0,-2 1 0,0-1 0,2 0 0,-1 0 0,-1 1 0,2-1 0,-4-1 0,4 2 0,0-1 0,-3 1 0,3-1 0,-4 0 0,4 0 0,-1 0 0,2 1 0,0-1 0,0 0 0,0 0 0,-9-6 0,0 0 0,-8-5 0,3 0 0,1 4 0,5 5 0,-22-10 0,-6-2 0,-6-2 0,8 4 0,-2-1 0,-17-8 0,41 21 0,-20-8 0,26 9 0,0 3 0,2-1 0,3 2 0,-4-2 0,4 1 0,-5-1 0,6 2 0,-3-2 0,0 2 0,3-5 0,-3 5 0,0-4 0,3 3 0,-3-2 0,1 1 0,1 2 0,-2-2 0,0-1 0,0 3 0,-2-4 0,1 3 0,0-1 0,2 0 0,-2 2 0,3-3 0,-5 1 0,6 1 0,-7-4 0,5 5 0,-2-2 0,-1 0 0,4 1 0,-4-4 0,1 4 0,-1-3 0,-2 4 0,4-5 0,-2 2 0,1 0 0,-1 1 0,-2 0 0,4 2 0,-8-5 0,7 3 0,-5-1 0,4-1 0,2 3 0,-1-4 0,-1 2 0,1 1 0,2-2 0,-5 3 0,7-1 0,-5 2 0,4-2 0,-4 1 0,4-3 0,-4 3 0,1-3 0,1 4 0,-3-5 0,4 2 0,-4 0 0,2-1 0,-1 3 0,1-2 0,-1 2 0,0-4 0,1 5 0,0-4 0,1 3 0,-3-3 0,5 3 0,-4-4 0,4 5 0,-4-2 0,0-1 0,-3 0 0,4 1 0,-3-3 0,5 4 0,-2-1 0,-1-1 0,4 3 0,-4-2 0,4 2 0,-4 0 0,4-2 0,-2 1 0,0-1 0,3 2 0,-3 0 0,1-2 0,2 1 0,-4-1 0,3 0 0,-2 2 0,1-2 0,2 2 0,-3-2 0,2 2 0,-1-5 0,1 5 0,1-4 0,-2 2 0,2-1 0,-2-1 0,-1 3 0,4-3 0,-4 2 0</inkml:trace>
</inkml:ink>
</file>

<file path=ppt/ink/ink6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26.228"/>
    </inkml:context>
    <inkml:brush xml:id="br0">
      <inkml:brushProperty name="width" value="0.35" units="cm"/>
      <inkml:brushProperty name="height" value="0.35" units="cm"/>
      <inkml:brushProperty name="color" value="#FFFFFF"/>
    </inkml:brush>
  </inkml:definitions>
  <inkml:trace contextRef="#ctx0" brushRef="#br0">1 434 24575,'23'27'0,"1"3"0,-12-17 0,0 7 0,3-5 0,-3 0 0,5 6 0,6 3 0,-7-1 0,2-5 0,-7-4 0,-4-6 0,8 7 0,-7-8 0,6 11 0,-7-10 0,4 6 0,-1-7 0,-2 4 0,3-3 0,-4 3 0,0-4 0,0 0 0,0-1 0,0 1 0,0 0 0,0 0 0,-1 0 0,1 0 0,0 0 0,0 0 0,0 0 0,0-1 0,0 1 0,0 0 0,3 0 0,-3 0 0,3 0 0,-3 0 0,0 0 0,0 0 0,4 0 0,-3 0 0,2 0 0,1 0 0,-3 0 0,3 4 0,-1-3 0,-2 3 0,7 0 0,-7-3 0,6 3 0,-6 0 0,6-3 0,-5 3 0,1-4 0,1 4 0,-3-4 0,2 4 0,1-4 0,-3 0 0,6 1 0,-6-1 0,6 0 0,-6 0 0,6 4 0,-2-3 0,-1 3 0,4-4 0,-8 0 0,11 4 0,-10-3 0,10 2 0,-10-3 0,6 1 0,-6-1 0,6-3 0,-6 2 0,6-2 0,-2 4 0,3-1 0,-3 1 0,2-1 0,-2-3 0,3 3 0,0-3 0,5 4 0,-4 0 0,4-4 0,-1 3 0,-2-2 0,6 3 0,-6-4 0,7 4 0,-8-4 0,8 4 0,-3 0 0,0 0 0,-2 0 0,1-3 0,-4 1 0,4-5 0,2 6 0,-5-6 0,5 6 0,-7-6 0,1 2 0,-1 0 0,0-2 0,1 3 0,-1-4 0,0 3 0,-3-2 0,2 6 0,-2-7 0,3 7 0,-4-6 0,4 2 0,-7 1 0,6-4 0,-6 3 0,6 1 0,-6-3 0,3 5 0,-1-5 0,-2 2 0,3 0 0,-1-2 0,-2 5 0,3-5 0,-1 5 0,-2-5 0,10 5 0,-10-2 0,6 0 0,-7 2 0,0-5 0,3 2 0,-2 0 0,3-2 0,-1 5 0,-3-5 0,3 2 0,0 0 0,-2-2 0,2 5 0,0-2 0,-3-1 0,3 1 0,0-1 0,-2-3 0,2 3 0,0 0 0,-2 1 0,5 0 0,-5-1 0,3 0 0,-1-2 0,-2 5 0,3-5 0,-1 2 0,-2 0 0,3-2 0,0 2 0,-4 0 0,4-2 0,0 2 0,-4-3 0,8 3 0,-4-2 0,1 2 0,2-3 0,-2 0 0,-1 0 0,4 0 0,-4 0 0,1 0 0,2 0 0,-2 0 0,-1 0 0,4 0 0,-4 0 0,1 0 0,2 0 0,-3 0 0,1 0 0,2 0 0,-2 0 0,3 0 0,-3 0 0,2 0 0,1 0 0,-3 0 0,6 0 0,-11 0 0,4 0 0,0 0 0,-4 0 0,4 0 0,-1-3 0,-2 3 0,2-7 0,0 7 0,-2-3 0,3 0 0,-1 2 0,-3-5 0,3 5 0,-3-5 0,3 2 0,-2-3 0,5 3 0,-5-2 0,3 2 0,0 0 0,-4-2 0,4 2 0,-4-2 0,4 2 0,-4-2 0,4 5 0,-4-5 0,4 2 0,-4-3 0,4-1 0,0 1 0,-4 3 0,8-3 0,-7 3 0,6-3 0,-6 0 0,2 3 0,1-3 0,-3 3 0,6-3 0,-6 0 0,6-1 0,-5-2 0,5 1 0,-6-2 0,6 4 0,-5-4 0,5 3 0,-6-3 0,6 0 0,-6 3 0,7-3 0,-7 1 0,6 1 0,-6-2 0,7 4 0,-7-4 0,3 3 0,-1-6 0,-2 6 0,7-7 0,-8 8 0,11-11 0,-9 6 0,5-3 0,-3 1 0,-4 6 0,4-6 0,0 2 0,-3 1 0,3-4 0,-4 4 0,1-1 0,-1-2 0,0 6 0,1-6 0,-1 6 0,0-2 0,0-1 0,0 3 0,-3-3 0,2 5 0,-5-5 0,5 3 0,-2-3 0,0 5 0,2-5 0,-1-1 0,-1 1 0,3-4 0,-3 1 0,3 2 0,-3-6 0,3 10 0,-7-2 0,6 3 0,-5-4 0,2 3 0,0-2 0,1-4 0,0 5 0,0-8 0,-1 9 0,-2-6 0,5 6 0,-5-6 0,2 6 0,0-7 0,-2 4 0,2-1 0,0 2 0,-2-1 0,5 3 0,-5-6 0,2 6 0,0-3 0,-2 2 0,2-3 0,0 1 0,-2 1 0,2 3 0,-3-4 0,3 3 0,-2-2 0,5 0 0,-5 2 0,2-2 0,0 0 0,-3 2 0,4-2 0,-4 0 0,3 3 0,-3-3 0,3 0 0,-3-2 0,0 2 0,3-1 0,-2 4 0,2-7 0,-3 6 0,0-6 0,0 7 0,3 0 0,-2-3 0,2 3 0,-3-6 0,0 1 0,0 1 0,3 1 0,-2 3 0,2-3 0,-3-1 0,0 0 0,0 1 0,0 0 0,0 3 0,0-6 0,3 5 0,-2-1 0,2-1 0,-3 2 0,0-4 0,0 4 0,0-2 0,0 1 0,0 1 0,0-4 0,0 5 0,0-3 0,0 1 0,0 1 0,0-6 0,0 3 0,0 2 0,0 2 0</inkml:trace>
</inkml:ink>
</file>

<file path=ppt/ink/ink6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31.090"/>
    </inkml:context>
    <inkml:brush xml:id="br0">
      <inkml:brushProperty name="width" value="0.35" units="cm"/>
      <inkml:brushProperty name="height" value="0.35" units="cm"/>
      <inkml:brushProperty name="color" value="#FFFFFF"/>
    </inkml:brush>
  </inkml:definitions>
  <inkml:trace contextRef="#ctx0" brushRef="#br0">1 493 24575,'11'28'0,"1"3"0,5-15 0,-3 5 0,8-3 0,-10-2 0,20 19 0,-9-7 0,7 9 0,-9-15 0,-5-3 0,0-3 0,-1-1 0,-1-1 0,-6-6 0,6 3 0,-2 0 0,3-3 0,-3 6 0,2-5 0,-5 5 0,1-6 0,1 3 0,-3-4 0,3 1 0,-1-1 0,-2 0 0,3 0 0,-4 4 0,0-4 0,0 4 0,0-4 0,4 0 0,-3 4 0,3-3 0,0 6 0,-4-6 0,4 7 0,0-7 0,-2 6 0,5 1 0,-6-2 0,6 4 0,-6-9 0,3 6 0,-4-6 0,0 6 0,0-6 0,1 7 0,-1-8 0,0 4 0,0 0 0,0-4 0,0 4 0,-3-4 0,2 0 0,1 3 0,1-3 0,2 3 0,-7-3 0,4 0 0,-1 3 0,2-2 0,2 2 0,-3-7 0,0 4 0,4-3 0,-4 3 0,8 0 0,-7 0 0,6 1 0,-3-1 0,1 0 0,2 4 0,-2-2 0,-1 1 0,4-2 0,-4-1 0,1 0 0,2 4 0,-2-2 0,-1 1 0,4-2 0,-7-1 0,6 0 0,-6 0 0,6 1 0,-6-1 0,6 0 0,-6 0 0,6 1 0,-6-4 0,7 3 0,-4-3 0,4 3 0,-3 1 0,2-4 0,-2 2 0,3-1 0,0 2 0,1 1 0,-1 0 0,-4-4 0,11 6 0,-9-8 0,9 8 0,-11-6 0,4 0 0,-7 2 0,6-5 0,-3 5 0,1-5 0,2 6 0,-6-6 0,6 5 0,-6-5 0,3 6 0,-1-7 0,2 7 0,-1-3 0,0 0 0,0 2 0,-4-5 0,8 6 0,-7-6 0,6 6 0,-6-6 0,6 5 0,-6-5 0,3 6 0,-1-7 0,-2 7 0,6-7 0,-6 6 0,7-1 0,3 2 0,-5-3 0,8 3 0,-9-3 0,3 0 0,-3 3 0,2-6 0,5 9 0,-6-9 0,8 9 0,-10-5 0,1-1 0,2-1 0,-6 0 0,7-2 0,-8 5 0,8-5 0,-7 2 0,6 1 0,-3-4 0,1 4 0,2-1 0,-2-2 0,0 2 0,2 1 0,-6-3 0,6 2 0,-2 0 0,-1-2 0,3 3 0,-6-4 0,6 0 0,-2 3 0,3-2 0,0 2 0,-3 0 0,2-2 0,-3 2 0,1 0 0,-1-2 0,-1 2 0,-2-3 0,3 3 0,-1-2 0,-3 2 0,6 0 0,-1-2 0,-1 2 0,-1-3 0,1 0 0,-3 0 0,2 3 0,4-2 0,-5 2 0,4-3 0,-2 0 0,-3 3 0,6-2 0,-6 2 0,6-3 0,-2 0 0,3 0 0,0 0 0,1 0 0,-1 0 0,0 0 0,0 0 0,1 0 0,-1 0 0,0 0 0,0 0 0,1 0 0,-1 0 0,-4 0 0,4 0 0,-4 0 0,4 0 0,-3 0 0,2 0 0,-2 0 0,-1-3 0,0 2 0,0-2 0,-4 3 0,4 0 0,0 0 0,-4-3 0,4 2 0,-1-2 0,1-1 0,0 4 0,0-4 0,-4 1 0,7 2 0,-6-2 0,6 0 0,-7 2 0,0-5 0,6 2 0,-4-3 0,8 3 0,-5-2 0,3 1 0,0-2 0,1-1 0,-1 0 0,0 1 0,0-4 0,5 2 0,-4-6 0,9 6 0,-5-6 0,1 3 0,3-5 0,-7 2 0,7-2 0,-4 1 0,6-5 0,-5 7 0,6-12 0,-11 17 0,5-11 0,-6 8 0,7-3 0,-5-1 0,1 5 0,-3 0 0,-7 4 0,6-1 0,-6 1 0,2 0 0,-3 0 0,4 0 0,-3 0 0,2 3 0,-3-2 0,0 2 0,0-3 0,0 0 0,3 0 0,-3 0 0,3 4 0,-3-4 0,3 4 0,-2-4 0,2 3 0,-3-2 0,0 2 0,0-3 0,0 0 0,-1 0 0,4 0 0,-5 0 0,4 0 0,-5 1 0,3-1 0,0 0 0,0-4 0,0 3 0,1-6 0,-1 2 0,0 1 0,1-4 0,2 4 0,2-4 0,0-1 0,3 1 0,-3 0 0,3-5 0,-3 4 0,3-4 0,-2 1 0,-1 2 0,3-2 0,-6-1 0,2 4 0,0-4 0,-2 5 0,2-1 0,-4 5 0,1-4 0,-1 4 0,1-1 0,2-5 0,-2 8 0,-1-8 0,-1 9 0,-5-3 0,5 1 0,-2 2 0,0-2 0,3 3 0,-7-4 0,6 3 0,-5-2 0,5 3 0,-1-7 0,-2 5 0,4-4 0,-6 2 0,5 3 0,-5-6 0,5 6 0,-5-6 0,5 6 0,-6-3 0,7 1 0,-3-2 0,0 1 0,3-4 0,-3 7 0,0-6 0,3 2 0,-3 1 0,3-3 0,-3 2 0,2 1 0,-1-4 0,2 1 0,0-5 0,0 3 0,1-1 0,-4 5 0,2 1 0,-2-4 0,3 4 0,-2-1 0,2-2 0,-3 2 0,3-3 0,1 0 0,-1 3 0,1-2 0,-1 2 0,-3-3 0,3 3 0,-3-2 0,3 2 0,1 1 0,-4 0 0,2 1 0,-2 2 0,0-7 0,3 8 0,-4-4 0,4-3 0,-3 6 0,3-10 0,-7 10 0,7-6 0,-3 3 0,4-4 0,-4 4 0,2 1 0,-5 3 0,8-9 0,-8 7 0,6-7 0,-7 7 0,0 4 0,0 0 0</inkml:trace>
</inkml:ink>
</file>

<file path=ppt/ink/ink6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35.212"/>
    </inkml:context>
    <inkml:brush xml:id="br0">
      <inkml:brushProperty name="width" value="0.35" units="cm"/>
      <inkml:brushProperty name="height" value="0.35" units="cm"/>
      <inkml:brushProperty name="color" value="#FFFFFF"/>
    </inkml:brush>
  </inkml:definitions>
  <inkml:trace contextRef="#ctx0" brushRef="#br0">1168 1292 24575,'-27'0'0,"2"0"0,10-3 0,0-2 0,3-6 0,-7 3 0,6 0 0,-16-12 0,9 10 0,-2-11 0,8 11 0,4 2 0,-1-2 0,-1 2 0,-1-2 0,5 3 0,-6 0 0,6 0 0,-3-1 0,1-2 0,-5-2 0,3 1 0,-2 0 0,7 4 0,0 0 0,0-3 0,0 2 0,0-3 0,-1 1 0,1 2 0,0-7 0,0 8 0,3-4 0,-3 0 0,3 0 0,-3-1 0,-1-2 0,4 6 0,-3-6 0,3 2 0,-3 1 0,3-4 0,-3 4 0,3-1 0,-3-2 0,3 2 0,-3 1 0,3-4 0,-3 4 0,0-1 0,-1-2 0,1 2 0,3-3 0,-3 3 0,-1-9 0,4 12 0,-6-12 0,9 13 0,-6-7 0,6 8 0,-5-4 0,5 0 0,-5 4 0,2-4 0,0 0 0,-2 3 0,5-6 0,-5 6 0,5-6 0,-5 6 0,5-6 0,-5 6 0,6-3 0,-7 1 0,6 2 0,-6-6 0,7 6 0,-7-7 0,6 8 0,-2-4 0,-1 0 0,3 3 0,-2-2 0,0-1 0,2 0 0,-6 0 0,6 1 0,-2 3 0,0-7 0,-1 6 0,1-6 0,0 3 0,0 4 0,2-4 0,-5 4 0,5-3 0,-5 3 0,5-3 0,-5 0 0,5 2 0,-5-2 0,5 0 0,-5 2 0,5-2 0,-5 4 0,2-1 0,-3 0 0,0 0 0,1-3 0,-1 2 0,0-2 0,0 3 0,3 0 0,-5-3 0,4 3 0,-5 0 0,3 1 0,0 2 0,-2-3 0,1 3 0,-6-2 0,6 5 0,-6-6 0,6 6 0,-6-6 0,2 7 0,1-7 0,-4 6 0,8-2 0,-8 3 0,7-3 0,-2 2 0,0-2 0,2 3 0,-5 0 0,5 0 0,-5 0 0,5 0 0,-6 0 0,6 0 0,-3 0 0,0 0 0,4 0 0,-4 0 0,1 0 0,2 0 0,-5 0 0,6 0 0,-3 0 0,0 0 0,6-8 0,-2 0 0,3-3 0,2-1 0,-2 8 0,1-9 0,10 37 0,-8-16 0,13 29 0,-9-22 0,0-3 0,3 2 0,-3-2 0,0 3 0,3-4 0,-3 4 0,3-8 0,1 8 0,-1-7 0,0 6 0,0-2 0,1 3 0,0 0 0,-1 0 0,1 1 0,3-1 0,-3-3 0,3 2 0,0 1 0,-3-3 0,2 5 0,-3-9 0,-3 3 0,3-4 0,-4 3 0,1-3 0,2 3 0,-5 0 0,5-3 0,-5 3 0,5-3 0,-2 0 0,0 3 0,2-3 0,-5 3 0,5-3 0,-6 3 0,6-2 0,-5 2 0,2-1 0,-3-2 0,-11-34 0,8 21 0,-8-28 0</inkml:trace>
</inkml:ink>
</file>

<file path=ppt/ink/ink6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58:42.244"/>
    </inkml:context>
    <inkml:brush xml:id="br0">
      <inkml:brushProperty name="width" value="0.1" units="cm"/>
      <inkml:brushProperty name="height" value="0.1" units="cm"/>
      <inkml:brushProperty name="color" value="#66CC00"/>
    </inkml:brush>
  </inkml:definitions>
  <inkml:trace contextRef="#ctx0" brushRef="#br0">2666 85 24575,'-28'0'0,"9"0"0,-16 0 0,11 0 0,-17 0 0,-14 4 0,14 1 0,-8 7 0,31-3 0,1 3 0,-11 12 0,5 7 0,-8 2 0,10-1 0,5-14 0,6-1 0,-6 0 0,6-4 0,-2 3 0,8-2 0,-4-2 0,4 5 0,-4-4 0,-1 4 0,0 0 0,5 0 0,-4 0 0,3 6 0,-4-5 0,0 4 0,0-4 0,1-1 0,3 5 0,-7-3 0,11 3 0,-16 0 0,11-3 0,-7 3 0,4 0 0,-3-3 0,2 3 0,-3 0 0,4-3 0,-8 11 0,3-11 0,-3 6 0,4-8 0,1 0 0,2 1 0,-6-1 0,6 0 0,-2 1 0,-1-1 0,4-4 0,-7 3 0,7-7 0,-7 3 0,7-4 0,-3 4 0,4-3 0,0 3 0,0-4 0,0 4 0,0-3 0,0 3 0,0-4 0,0-1 0,4 1 0,-3 0 0,3 0 0,-4 0 0,0-1 0,4 1 0,-7 4 0,6-4 0,-6 3 0,3-3 0,0 0 0,0 0 0,1 0 0,-1-1 0,0 1 0,0 0 0,0 0 0,0 4 0,-4-3 0,3 7 0,-8-6 0,4 6 0,0-7 0,-3 4 0,3-1 0,-9-2 0,3 2 0,-3-3 0,0 0 0,-2 0 0,1 1 0,-5-1 0,5 0 0,-6 1 0,1-5 0,0 3 0,-1-2 0,1 3 0,4 0 0,-3 0 0,-4 4 0,5-3 0,-4 3 0,13-4 0,0 0 0,0-1 0,0 1 0,-1-1 0,1 1 0,0 0 0,4-1 0,-3 0 0,3 1 0,-4-1 0,-1 1 0,5-1 0,-3 1 0,3-1 0,0 0 0,-3 1 0,3-1 0,-5 1 0,5-1 0,-3 0 0,3 1 0,-4-1 0,-1 1 0,1 0 0,0-1 0,0 1 0,-8 3 0,5-2 0,-5 2 0,8-3 0,0 0 0,0-1 0,3 5 0,-2-4 0,3 4 0,-4-5 0,-1 5 0,5-4 0,-3 3 0,3 1 0,0-4 0,-3 3 0,7-4 0,-3 0 0,4 0 0,0 0 0,0 0 0,1-1 0,-1 1 0,0 0 0,0 0 0,0 0 0,4-1 0,-3-2 0,3 2 0,-4-3 0,4 3 0,-3 1 0,6-1 0,-6 1 0,7 0 0,-7 0 0,6-1 0,-3 1 0,1 0 0,2 0 0,-6 0 0,2 4 0,1-4 0,-4 9 0,4-8 0,-5 7 0,1-3 0,-5 4 0,4-4 0,-3 3 0,4-3 0,-1 5 0,0-1 0,-3 0 0,2 1 0,2-1 0,0 0 0,3 0 0,-4 1 0,5-5 0,-4 3 0,7-7 0,-3 3 0,4 0 0,0 4 0,0-2 0,0 2 0,0-4 0,0-3 0,0 7 0,0-7 0,0 7 0,0-7 0,0 3 0,0 0 0,0-4 0,0 9 0,0-8 0,0 7 0,0-7 0,0 3 0,0 0 0,0-4 0,0 9 0,0-9 0,0 9 0,0-8 0,0 3 0,0 0 0,0-4 0,0 9 0,0-9 0,0 9 0,0-8 0,0 7 0,0-7 0,4 10 0,0-9 0,0 6 0,4-4 0,-7-4 0,2 4 0,1 0 0,-3-3 0,6 3 0,-6 0 0,6-3 0,-6 7 0,3-7 0,-1 3 0,-2 0 0,2-3 0,1 3 0,-3-4 0,6-1 0,-7 1 0,4 0 0,-1 0 0,-2 4 0,6-3 0,-6 3 0,6-5 0,-6 5 0,6-3 0,-3 3 0,4 0 0,0-3 0,1 7 0,3 1 0,-3-3 0,7 2 0,-7-4 0,3-3 0,0 7 0,-3-7 0,3 3 0,0-4 0,-3 4 0,3-2 0,-3 2 0,3-4 0,-4 0 0,4 0 0,-4 0 0,0-1 0,0 1 0,0 0 0,-1 0 0,1 0 0,0-1 0,0 1 0,0-4 0,-1 3 0,1-2 0,0 3 0,0-4 0,-4 3 0,3-3 0,-3 4 0,4-4 0,0 7 0,0-6 0,0 3 0,-4-1 0,3-3 0,-3 4 0,4-4 0,-1 3 0,-2-3 0,2 0 0,-3 3 0,4-6 0,0 6 0,-1-6 0,1 6 0,4-6 0,-3 6 0,7-6 0,-3 2 0,0-3 0,4 4 0,-4-3 0,4 3 0,0-1 0,1-2 0,-1 3 0,0-4 0,0 4 0,1-3 0,4 3 0,-4 0 0,5-3 0,-6 3 0,5-4 0,-3 3 0,3-2 0,-5 3 0,1 0 0,-5-3 0,3 3 0,-3-4 0,0 0 0,3 0 0,-7 0 0,3 0 0,0 0 0,-3 0 0,3 0 0,0 0 0,-3 0 0,3 0 0,0 0 0,-3 0 0,3 0 0,0 0 0,1-4 0,0 0 0,3-9 0,-3 4 0,9-4 0,-3 1 0,8 1 0,-9-5 0,5 2 0,-1 0 0,-4 2 0,5-1 0,2-4 0,-6-2 0,2-2 0,-5 4 0,-6 0 0,6-1 0,-6 1 0,2 0 0,-4 4 0,1-3 0,-1 2 0,1-3 0,0 0 0,-1 0 0,1-1 0,0 1 0,-5 0 0,4-5 0,-3 3 0,4-3 0,0 5 0,-1 3 0,1-2 0,-5 3 0,4 0 0,-4-3 0,4 7 0,1-7 0,-1 7 0,0-3 0,0 0 0,0 3 0,0-7 0,0 7 0,0-3 0,1 0 0,-2 3 0,2-3 0,-1 0 0,0 3 0,0-7 0,0 7 0,1-7 0,3 3 0,1-1 0,1-2 0,2 3 0,-6-5 0,6 1 0,-3 0 0,1 0 0,2-1 0,-2 1 0,-1 0 0,3-1 0,-2 1 0,-1 4 0,3-3 0,-7 3 0,8-4 0,-8-1 0,7 1 0,-6 0 0,3-1 0,-1 1 0,-3 4 0,3-3 0,-3 3 0,3-4 0,-2 0 0,2 4 0,-4-4 0,1 4 0,-1-4 0,1 0 0,3 3 0,-2-2 0,2 3 0,-3 0 0,-1-3 0,0 3 0,1-5 0,-1 5 0,1-3 0,-1 7 0,0-7 0,0 7 0,1-7 0,-1 3 0,4-8 0,-2 3 0,2-3 0,-4 8 0,0-3 0,1 3 0,-4-5 0,2 1 0,-2 4 0,3-3 0,0 3 0,-3 0 0,3-3 0,-3 3 0,-1-5 0,4 5 0,-4-3 0,5 3 0,-4-4 0,2-1 0,-2 1 0,4 0 0,0-5 0,-1 3 0,1-3 0,0 0 0,0 3 0,4-3 0,-3 0 0,6 3 0,-6-3 0,7 5 0,-8 0 0,7-1 0,-6 1 0,2 0 0,-3 0 0,0-1 0,7-7 0,-5 6 0,5-2 0,-8 5 0,0 3 0,1-4 0,0 0 0,-1 0 0,1-1 0,-1 1 0,1 0 0,0 0 0,-1 0 0,1-1 0,-1 1 0,-3-5 0,3 3 0,-7-3 0,6 5 0,-6 0 0,7-1 0,-7 1 0,7 0 0,-7 0 0,6 3 0,-6-2 0,6 3 0,-6-4 0,6 4 0,-6-3 0,6 7 0,-6-7 0,3-1 0,-1 3 0,-2-1 0,2 7 0,-3-4 0,0 3 0,0-3 0,0 0 0,0 3 0,0-3 0,0 0 0,0 3 0,0-7 0,0 7 0,0-7 0,0 3 0,0-4 0,0 4 0,0-3 0,0 3 0,0-5 0,0 1 0,0 0 0,0-1 0,0 1 0,0 0 0,0 0 0,0-1 0,0 1 0,0 0 0,0-1 0,0 1 0,0 0 0,0 0 0,0-1 0,0 1 0,0 0 0,0 4 0,0-3 0,0 7 0,0-8 0,0 9 0,0-9 0,0 9 0,-3-4 0,2 4 0,-2 0 0,3 0 0,0-4 0,0 3 0,-4-3 0,3 4 0,-2 1 0,-1-1 0,3 0 0,-6 1 0,3-1 0,0 0 0,-3 0 0,3 1 0,-4-1 0,1 1 0,-1-1 0,0 4 0,0-3 0,1 2 0,-1 1 0,0-3 0,0 3 0,0-1 0,0-2 0,-4 3 0,4-1 0,-4-2 0,4 3 0,-4-5 0,3 2 0,-3 2 0,4-2 0,0 3 0,1-4 0,-1 3 0,3-1 0,-2 5 0,7-6 0,-7 6 0,6-6 0,-6 6 0,3-6 0,-4 6 0,4-2 0,1 3 0</inkml:trace>
</inkml:ink>
</file>

<file path=ppt/ink/ink6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59:23.991"/>
    </inkml:context>
    <inkml:brush xml:id="br0">
      <inkml:brushProperty name="width" value="0.1" units="cm"/>
      <inkml:brushProperty name="height" value="0.1" units="cm"/>
      <inkml:brushProperty name="color" value="#F6630D"/>
    </inkml:brush>
  </inkml:definitions>
  <inkml:trace contextRef="#ctx0" brushRef="#br0">0 0 24575,'0'0'0</inkml:trace>
</inkml:ink>
</file>

<file path=ppt/ink/ink6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59:40.940"/>
    </inkml:context>
    <inkml:brush xml:id="br0">
      <inkml:brushProperty name="width" value="0.1" units="cm"/>
      <inkml:brushProperty name="height" value="0.1" units="cm"/>
      <inkml:brushProperty name="color" value="#F6630D"/>
    </inkml:brush>
  </inkml:definitions>
  <inkml:trace contextRef="#ctx0" brushRef="#br0">2608 2394 24575,'0'-17'0,"0"-2"0,0 6 0,0-5 0,0 1 0,0 0 0,0-5 0,0-2 0,0 5 0,0-7 0,0 12 0,0-14 0,0 10 0,0-4 0,0-1 0,0 5 0,0-4 0,0 9 0,0-4 0,0 9 0,0-9 0,0 8 0,0-7 0,0 7 0,0-3 0,0-3 0,0 1 0,0-3 0,0 1 0,0 7 0,0-7 0,0 7 0,0-3 0,0 0 0,0 3 0,0-7 0,0 7 0,0-3 0,0 0 0,0 3 0,0-2 0,0-1 0,0 3 0,0-8 0,0 9 0,0-4 0,0 0 0,0 3 0,-3-8 0,2 9 0,-3-9 0,4 4 0,0 0 0,-4-3 0,3 3 0,-3-4 0,0-1 0,-1-7 0,1 6 0,-4-6 0,7 12 0,-3-3 0,0 3 0,3 0 0,-6-3 0,6 3 0,-6 0 0,6-3 0,-3 3 0,1 0 0,2 1 0,-3 0 0,1 3 0,2-3 0,-6 0 0,6 3 0,-3-3 0,1 4 0,2 0 0,-3 0 0,1 1 0,2-5 0,-6 3 0,3-3 0,-1 0 0,-1 3 0,5-3 0,-6 4 0,6 1 0,-6-1 0,3 0 0,-1 0 0,-2-4 0,3 3 0,-1-3 0,-2 0 0,2 4 0,-7-5 0,3 1 0,-3 3 0,3-7 0,1 3 0,-5-1 0,4-2 0,-4 3 0,1-1 0,2-2 0,-6 6 0,3-6 0,-1 2 0,-2 1 0,2-3 0,1 6 0,-3-6 0,3 3 0,0 0 0,-3-3 0,7 7 0,-7-7 0,2 6 0,1-6 0,1 7 0,0-3 0,2-1 0,-2 4 0,0-3 0,3 4 0,-3-4 0,-1 2 0,4-2 0,-7 4 0,7 0 0,-3 0 0,4-4 0,-4 6 0,3-5 0,-3 7 0,4-4 0,0-4 0,0 3 0,0-3 0,0 4 0,0 0 0,0 1 0,-4-2 0,3 2 0,-3-2 0,4 2 0,1-1 0,-1 0 0,0 0 0,-4 0 0,3 0 0,-3 0 0,4 0 0,-7-8 0,1 6 0,-3-6 0,5 8 0,0 0 0,3 0 0,-3 0 0,0 0 0,3 0 0,-3 0 0,4 0 0,-4 3 0,3-1 0,-3 1 0,4 1 0,-4-3 0,4 2 0,-4 0 0,0-2 0,3 6 0,-7-6 0,7 2 0,-8-3 0,4 3 0,0-2 0,-3 6 0,7-6 0,-7 2 0,3 1 0,-4-4 0,4 4 0,-4-1 0,4-2 0,0 2 0,-3-3 0,3 3 0,-8-6 0,3 6 0,-3-8 0,4 9 0,4-4 0,-3 4 0,3-5 0,0 5 0,-4-4 0,4 3 0,0-3 0,-3 3 0,7-2 0,-7 3 0,3-5 0,0 5 0,-3-4 0,3 3 0,-5-4 0,1 5 0,0-4 0,0 3 0,-1-3 0,-4 3 0,4-3 0,-10 3 0,10 0 0,-4-3 0,-1 7 0,5-7 0,-4 7 0,-1-3 0,5 4 0,-4 0 0,1 0 0,3 0 0,-3 0 0,4 0 0,4 0 0,-4 0 0,4 0 0,0 0 0,-3 0 0,3 0 0,-4 0 0,4 0 0,-3 0 0,2 4 0,-3 1 0,4 3 0,-3-3 0,3 2 0,-4-2 0,-1 4 0,1-1 0,0 1 0,0 0 0,-1-1 0,1 1 0,0 0 0,-1-1 0,1 1 0,4-1 0,-3 5 0,3-4 0,-5 3 0,1 1 0,4-4 0,-3 7 0,7-7 0,-7 7 0,3-7 0,-1 8 0,-2-4 0,3 1 0,-1 2 0,2-3 0,-1 1 0,4 2 0,-4-3 0,5 5 0,3-5 0,-3 3 0,7-3 0,-6 4 0,6 1 0,-3-1 0,0-4 0,4 3 0,-4-3 0,4 5 0,0-1 0,0 0 0,0 0 0,0 8 0,0-5 0,0 5 0,0-8 0,0 0 0,0 0 0,0 1 0,0-1 0,0 0 0,0-4 0,0 3 0,0-3 0,0 4 0,4 1 0,1-1 0,3 0 0,-3 0 0,3 0 0,-3 6 0,3-5 0,1 4 0,0-4 0,0-1 0,-1 0 0,1 0 0,0 1 0,-1-1 0,1 0 0,0 1 0,4 4 0,9 9 0,-2-6 0,7 10 0,-9-11 0,0-1 0,1 4 0,-2-8 0,2 8 0,3-8 0,-2 8 0,2-8 0,2 9 0,0-8 0,1 8 0,2-8 0,-7 8 0,8-8 0,-3 8 0,-2-9 0,1 4 0,-1 1 0,-4-6 0,4 6 0,-6-7 0,1 0 0,4 1 0,-7 0 0,6-4 0,-8 2 0,10-1 0,-5 2 0,4 1 0,-5-5 0,6 5 0,-5-5 0,9 6 0,-3-1 0,4 1 0,1 0 0,-6-1 0,5 1 0,-5-1 0,5 1 0,1 0 0,-1-4 0,1 3 0,-1-3 0,1-1 0,-1 4 0,0-7 0,1 6 0,5-1 0,-4-1 0,4 4 0,-6-5 0,6 6 0,-4-5 0,4 4 0,-5-5 0,-1 1 0,1-1 0,-6-1 0,4-3 0,-8 3 0,3-4 0,-5-1 0,1 1 0,-5-1 0,3 1 0,-3-1 0,8 0 0,-7 0 0,5-3 0,-6 2 0,0-6 0,4 3 0,-9-4 0,4 3 0,0-2 0,-3 3 0,7-1 0,-7-2 0,7 3 0,-7-4 0,7 0 0,-2 0 0,3 4 0,0-3 0,0 3 0,1-4 0,-1 0 0,0 0 0,0 4 0,1-3 0,-1 3 0,0-4 0,-4 0 0,4 0 0,-4 0 0,4 0 0,-4 0 0,3 0 0,-3 0 0,-1 0 0,4 0 0,-7 0 0,3 0 0,-4 0 0,-1 0 0,1 0 0,0 0 0,0 0 0,-1 0 0,1 0 0,-1 0 0,1 0 0,-1 0 0,0 0 0,1 0 0,-4-4 0,3 3 0,-3-2 0,4-1 0,-1 4 0,-2-7 0,1 6 0,-1-2 0,2-1 0,1 3 0,0-2 0,-1 0 0,1 2 0,-1-2 0,1 0 0,-4-1 0,-1-4 0,-3 1 0,0 0 0,0-1 0,0 1 0,0-1 0,0 0 0,0 1 0,0-1 0,0 1 0,0-1 0,0 4 0,0 1 0</inkml:trace>
</inkml:ink>
</file>

<file path=ppt/ink/ink6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7T00:04:41.013"/>
    </inkml:context>
    <inkml:brush xml:id="br0">
      <inkml:brushProperty name="width" value="0.2" units="cm"/>
      <inkml:brushProperty name="height" value="0.2" units="cm"/>
      <inkml:brushProperty name="color" value="#E71224"/>
    </inkml:brush>
  </inkml:definitions>
  <inkml:trace contextRef="#ctx0" brushRef="#br0">962 0 24575,'-20'4'0,"5"-1"0,3-3 0,0 0 0,3 0 0,-3 0 0,1 0 0,-2 0 0,-3 0 0,3 0 0,-2 0 0,6 0 0,-3 0 0,0 0 0,3 0 0,-7 0 0,7 0 0,-3 0 0,0 0 0,3 0 0,-15 0 0,13 0 0,-12 0 0,14 0 0,-7 0 0,7 0 0,-7 0 0,3 0 0,1 0 0,0 0 0,-4 0 0,7 0 0,-7 0 0,8 0 0,0 0 0,1 0 0,-1 0 0,0 0 0,1 0 0,-1 0 0,0 0 0,0 0 0,0 0 0,-4 0 0,4 0 0,-4 0 0,4 0 0,0 0 0,0 0 0,0 0 0,1 0 0,-5 0 0,3 0 0,-3 0 0,4 0 0,0 0 0,0 0 0,-4 0 0,3 0 0,-3 0 0,0 0 0,4 0 0,-4 0 0,4 0 0,0 0 0,-7 0 0,5 0 0,-6 0 0,9 0 0,-1 0 0,0 0 0,0 0 0,0 4 0,1-3 0,-1 2 0,0 1 0,0-4 0,1 7 0,-1-3 0,0 1 0,1 1 0,-1-5 0,0 3 0,4-1 0,-3-2 0,6 6 0,-6-6 0,3 6 0,-4-3 0,1 0 0,3 3 0,1-3 0,3 3 0,0 0 0,3 0 0,1 1 0,4-4 0,-4 3 0,3-3 0,-3 0 0,4 3 0,-4-2 0,3 2 0,-2-2 0,-1 2 0,3-3 0,-3 4 0,0 0 0,3-1 0,-6 1 0,6-4 0,-6 3 0,6-2 0,-3 2 0,0 1 0,3 0 0,-6-1 0,6 1 0,-3 0 0,0-1 0,3 1 0,-6 0 0,6 0 0,-6-1 0,2 1 0,1 0 0,-3 0 0,2 0 0,-3-1 0,0 1 0,0 0 0,0 0 0,0 0 0,0-1 0,0 5 0,0-3 0,0 3 0,0-4 0,0 4 0,0-3 0,0 7 0,0-7 0,0 7 0,0-3 0,0 0 0,0 4 0,0-9 0,0 9 0,0-4 0,0 0 0,0-1 0,0-4 0,0 4 0,0-3 0,0 3 0,0-5 0,0 1 0,0 0 0,0 0 0,0 0 0,0-1 0,3-3 0,2 0 0,2-4 0,1 0 0,0 0 0,-1 0 0,1 0 0,0 0 0,0-4 0,0 0 0,0-8 0,0-1 0,5-9 0,-3 3 0,8-8 0,-8 8 0,8-8 0,-4 4 0,0-1 0,4-3 0,-4 9 0,0-10 0,3 10 0,-4-4 0,5 4 0,3-7 0,-3 6 0,15-13 0,-18 17 0,28-16 0,-26 20 0,17-12 0,-20 18 0,12-13 0,-16 15 0,9-11 0,-7 2 0,11-8 0,-3-3 0,10 0 0,-16 10 0,1 6 0,-7 0 0,-1 2 0,-3-2 0,0 0 0,-4-1 0,-3 4 0,-5 1 0,0 7 0,-8 0 0,3 5 0,-4-5 0,-1 4 0,-4-3 0,4 0 0,-5 3 0,6-3 0,-5 0 0,3 3 0,-3-8 0,5 8 0,-5-3 0,3 0 0,-3-1 0,5 0 0,-1-3 0,1 3 0,4-4 0,-3 4 0,3-3 0,-4 3 0,-1-4 0,1 0 0,4 3 0,-14 2 0,11-1 0,-9 3 0,6-3 0,1 4 0,-3 0 0,-7 4 0,13-3 0,-15 6 0,20-9 0,-16 8 0,16-12 0,-4 8 0,6-9 0,1 3 0,3-1 0,1 1 0,6 3 0,1 1 0,1 0 0,2 0 0,-3 0 0,4-1 0,0 5 0,-4 1 0,4 5 0,-3-1 0,4 0 0,-1 0 0,1 1 0,-4-1 0,2 0 0,-6-4 0,7 4 0,-7-9 0,7 9 0,-7-8 0,2 3 0,-3-5 0,4 5 0,-3-3 0,3 3 0,-4-4 0,0 0 0,3-1 0,-2 1 0,2 0 0,1-1 0,-3 1 0,2 4 0,0-3 0,-2 3 0,3-4 0,-4 4 0,0-3 0,3 3 0,-2-5 0,3 1 0,-4 0 0,0 0 0,0 0 0,0-1 0,0 1 0,0 0 0,0 0 0,0-1 0,-4-2 0,-4-10 0,-1 0 0,-3-11 0,4 7 0,0-7 0,-1 2 0,1 1 0,3-3 0,-2 3 0,6-4 0,-6 4 0,6-3 0,-6 2 0,6 1 0,-3-3 0,0 7 0,3-3 0,-2 0 0,3 3 0,-4-7 0,3 7 0,-6-3 0,6 5 0,-6-6 0,2 5 0,1-4 0,-3 4 0,2 0 0,-2 0 0,-1 0 0,3 1 0,-6-2 0,6 2 0,-7-2 0,4 2 0,-3-5 0,2 4 0,-6-11 0,10 10 0,-5-9 0,5 13 0,1-9 0,1 9 0,3-10 0,0 7 0,0-7 0,0 7 0,0-3 0,3 7 0,1 1 0,8 3 0,-3 0 0,7 0 0,-3 0 0,4 0 0,0 0 0,1 0 0,-1 0 0,-4 0 0,3 0 0,-3 0 0,0 0 0,-1 0 0,0 0 0,-3 0 0,3 0 0,-4 0 0,0 0 0,0-8 0,4 2 0,-2-10 0,6 3 0,-2-1 0,-1-2 0,3 2 0,-2 1 0,-1-3 0,4 6 0,-4-3 0,0 9 0,3-4 0,-7 4 0,7-1 0,-7 1 0,3 4 0,-4 0 0,4 0 0,-3 0 0,3 0 0,-4 0 0,0 0 0,-1 0 0,1 0 0,0 0 0,-14 11 0,3-5 0,-12 12 0,7-9 0,0 8 0,0-4 0,-5 0 0,4 3 0,-4-2 0,5-1 0,-1 3 0,1-3 0,-1 4 0,1-3 0,0 2 0,-1-3 0,1 4 0,3 0 0,-3 1 0,7-5 0,-3 8 0,1-11 0,2 11 0,-2-8 0,3 5 0,0-1 0,0 0 0,0 0 0,0 1 0,0-1 0,0 0 0,0 1 0,0-1 0,0-4 0,0 3 0,0-3 0,0 0 0,0 3 0,0-7 0,0 8 0,0-9 0,0 4 0,0 4 0,0-6 0,0 16 0,0-16 0,0 15 0,0-15 0,0 4 0,0-6 0,0 0 0,0 0 0,0 0 0,-4-4 0,3 3 0,-2-3 0,-1 0 0,3 3 0,-5-3 0,5 4 0,-6-4 0,6 3 0,-6-3 0,7 4 0,-4-1 0,1-3 0,2 3 0,-2-3 0,3 4 0,0-1 0,0 1 0,0 0 0,0 0 0,0-1 0,0 1 0,0 0 0,0-1 0,0 1 0,0 0 0,0 0 0,0 0 0,0-1 0,0 1 0,0 0 0,0 0 0,0 0 0,0-1 0,0 1 0,0 0 0,0-1 0,3-2 0,-2 2 0,2-3 0,1 4 0,-4-1 0,4 1 0,-1-1 0,-2 4 0,9 18 0,-5-13 0,13 45 0,-13-45 0,9 25 0,-6-7 0,4-5 0,-4 9 0,2-13 0,-5-17 0,2 7 0,-2-7 0,1 7 0,-1-6 0,3 6 0,-4-7 0,3 7 0,-3-6 0,4 9 0,0-9 0,0 13 0,-1-12 0,1 11 0,0-11 0,-4 8 0,3-9 0,-3 2 0,1-3 0,1-1 0,-5 1 0,6-1 0,-6 1 0,6 0 0,-6-1 0,6-2 0,-6 1 0,5-1 0,-5 2 0,6 1 0,-6 0 0,6-4 0,-6 3 0,2-3 0,1 1 0,-3 2 0,6-6 0,-6 6 0,6-3 0,-7 3 0,7 1 0,-3 0 0,1-1 0,2-2 0,-7 2 0,7-3 0,-3 3 0,1 1 0,2-4 0,-7 3 0,7-2 0,-2-1 0,-1 3 0,3-3 0,-6 4 0,6-4 0,-3 3 0,0-2 0,3-1 0,-6 3 0,6-3 0,-3 4 0,4 0 0,-1-1 0,-2 1 0,2 0 0,-3-1 0,0 1 0,3 0 0,-3-4 0,1 3 0,2-2 0,-3 2 0,0 1 0,3-4 0,-6 3 0,6-2 0,-2-1 0,-1 3 0,3-6 0,-6 6 0,5-3 0,-2 0 0,1 3 0,1-6 0,-1 6 0,2-7 0,-3 7 0,3-6 0,-2 3 0,2-1 0,1 1 0,0 0 0,-1 0 0,1-1 0,0-2 0,-4 6 0,3-6 0,-2 2 0,3 1 0,-1-3 0,-2 6 0,2-7 0,-3 4 0,4-1 0,0-2 0,-4 6 0,3-6 0,-3 6 0,4-6 0,0 2 0,-4 1 0,3-3 0,-3 2 0,0 1 0,3-4 0,-3 7 0,4-6 0,0 2 0,-4 1 0,3-3 0,-3 2 0,4 1 0,-1-4 0,1 7 0,-1-6 0,1 2 0,-1-3 0,1 4 0,0-3 0,-1 2 0,1-3 0,-1 0 0,1 0 0,-1 3 0,1-2 0,0 3 0,-1-4 0,1 0 0,-1 0 0,1 0 0,-1 0 0,1 0 0,0 0 0,-1 0 0,1 0 0,0 0 0,-1 0 0,1 0 0,0 0 0,-1 0 0,1 0 0,0 0 0,0 0 0,-1 0 0,1 0 0,0 0 0,-1 0 0,1 0 0,0 0 0,0 0 0,0 0 0,-1 0 0,1-4 0,0 3 0,0-2 0,0 3 0,-1-4 0,1 3 0,0-2 0,0-1 0,0 4 0,-1-4 0,1 4 0,0 0 0,0-3 0,3 2 0,-2-6 0,2 6 0,-3-2 0,-4-1 0,3 3 0,-3-6 0,4 7 0,-4-7 0,3 6 0,-3-6 0,4 3 0,0-4 0,-1 4 0,1-3 0,0 6 0,0-6 0,0 3 0,-1-4 0,1 4 0,0-3 0,-1 6 0,1-6 0,0 7 0,0-4 0,-1 1 0,1 2 0,-4-6 0,3 6 0,-3-2 0,4 3 0,-4-4 0,3 3 0,-3-2 0,0-1 0,3 3 0,-3-2 0,4 0 0,0 2 0,-4-6 0,2 6 0,-1-6 0,2 7 0,-2-7 0,1 6 0,-1-2 0,2-1 0,1 0 0,0 0 0,-4-3 0,3 3 0,-3-4 0,4 3 0,0-2 0,-1 3 0,1-4 0,0 1 0,0-1 0,4 0 0,1-5 0,0 4 0,3-3 0,-3 4 0,1-5 0,2 3 0,-7-2 0,7 4 0,-2 0 0,-1-1 0,3-3 0,-7 3 0,7-3 0,-7 4 0,3-5 0,0 4 0,-2-3 0,2 4 0,-5 0 0,1 0 0,4 0 0,-3 0 0,3 0 0,-4 0 0,0 0 0,-1 4 0,1-3 0,-3 3 0,2-4 0,-3 0 0,4 0 0,-1 1 0,-2-1 0,1 0 0,-2 1 0,1-1 0,2 0 0,-3 4 0,0-3 0,0 3 0,-1-4 0,-2 0 0,6 4 0,-6-3 0,6 3 0,-6-4 0,6 0 0,-7 0 0,7 4 0,-6-3 0,6 3 0,-6-4 0,6 0 0,-6 0 0,6 0 0,-3 1 0,0-1 0,3 0 0,-6 0 0,6 1 0,-6-1 0,6 0 0,-7 0 0,7 0 0,-2 1 0,-1-1 0,3 0 0,-6 0 0,6 0 0,-3 1 0,0-1 0,3 0 0,-6 1 0,6-1 0,-6 0 0,6 0 0,-3 1 0,0-1 0,3 0 0,-6 0 0,6 1 0,-3 2 0,0-2 0,0 3 0,-1-4 0,1 1 0,1-1 0,1 0 0,-5 1 0,6-1 0,-7 1 0,7-1 0,-6 1 0,6 2 0,-6-1 0,2 2 0,1-1 0,-3-1 0,2 1 0,0 1 0,-2-2 0,3 2 0</inkml:trace>
</inkml:ink>
</file>

<file path=ppt/ink/ink6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20.972"/>
    </inkml:context>
    <inkml:brush xml:id="br0">
      <inkml:brushProperty name="width" value="0.2" units="cm"/>
      <inkml:brushProperty name="height" value="0.2" units="cm"/>
      <inkml:brushProperty name="color" value="#FFFFFF"/>
    </inkml:brush>
  </inkml:definitions>
  <inkml:trace contextRef="#ctx0" brushRef="#br0">0 162 24575,'54'0'0,"-1"0"0,41-4 0,-62 4 0,4-7 0,-19 6 0,5-6 0,-11 6 0,14-6 0,-2 0 0,1 2 0,0-5 0,-9 6 0,1-1 0,6-1 0,-6 2 0,2 0 0,-3-2 0,0 1 0,14-2 0,-6 2 0,7-1 0,-10 5 0,-5-6 0,5 6 0,-4-2 0,15-1 0,-2-1 0,5 1 0,-7 0 0,4 1 0,-9 2 0,6-3 0,2 1 0,-5 2 0,3-3 0,-6 4 0,-6 0 0,-1 0 0,0 0 0,1 0 0,-1 0 0,-4 0 0,4-3 0,-4 2 0,1-3 0,2 4 0,-2 0 0,3 0 0,-4 0 0,4 0 0,-4 0 0,5 0 0,-1 0 0,5 0 0,-4 0 0,4 0 0,-5-3 0,0 2 0,5-2 0,-4 3 0,4 0 0,-5 0 0,0 0 0,7 0 0,-5 0 0,6 0 0,-8 0 0,0 0 0,-3 0 0,2 0 0,-3 0 0,1 0 0,2 0 0,-6 0 0,7 0 0,-8 0 0,8 0 0,-7 0 0,2 0 0,-3 3 0,4-2 0,-3 5 0,2-6 0,-3 4 0,0-1 0,0-3 0,3 3 0,-2-3 0,7 0 0,-8 3 0,4-2 0,0 2 0,-3-3 0,6 0 0,-3 0 0,5 0 0,-5 3 0,10-2 0,-7 2 0,8-3 0,-7 4 0,0-4 0,1 4 0,-1-1 0,0-2 0,0 6 0,-3-6 0,2 5 0,-2-5 0,-1 6 0,3-3 0,-6 0 0,6 3 0,-2-3 0,-1 3 0,0-3 0,0 3 0,-3-7 0,2 7 0,1-6 0,-3 5 0,2-2 0,1 0 0,-3-1 0,2 0 0,-3-3 0,0 3 0,0 1 0,4-4 0,0 3 0,0 0 0,-1-2 0,-3 2 0,0-3 0,0 3 0,-1-2 0,1 2 0,0-3 0,0 0 0,0 3 0,0-2 0,0 2 0,0-3 0,-1 0 0,1 0 0,0 3 0,0-2 0,0 2 0,0-3 0,0 0 0,0 0 0,-1 0 0,1 0 0,0 0 0,0 0 0,0 0 0,4 0 0,-4 3 0,4-2 0,0 2 0,-3-3 0,2 0 0,1 0 0,-3 0 0,2 3 0,-3-2 0,4 2 0,-3 0 0,2-2 0,-3 2 0,4 0 0,-3-2 0,2 5 0,-3-2 0,0 0 0,0 2 0,0-5 0,0 5 0,0-2 0,-1 0 0,-2 2 0,2-5 0,-5 5 0,8-2 0,-7 3 0,7-4 0,-5 3 0,3-2 0,0 0 0,-4 2 0,3-2 0,-5 2 0,5 1 0,-5 0 0,5-3 0,-5 2 0,2-2 0,0 2 0,0 1 0,1 0 0,-1 0 0,-3 0 0,0 0 0,3-1 0,-2 1 0,2 0 0,-3 0 0,3 0 0,-2 4 0,2-4 0,-3 4 0,0-4 0,0 4 0,0-4 0,0 8 0,0-7 0,0 2 0,0-3 0,0 0 0,0 3 0,0-2 0,0 2 0,0-3 0,0-1 0,-3 1 0,2 0 0,-2 0 0,0 0 0,2 0 0,-2 0 0,0 0 0,2 0 0,-5 0 0,5-1 0,-2 1 0,0 0 0,2 4 0,-5-3 0,6 2 0,-7-3 0,7 0 0,-6 0 0,1 4 0,1-4 0,-2 4 0,2 0 0,-7-3 0,0 9 0,-5-4 0,5 5 0,0-6 0,0 2 0,3-6 0,-2 3 0,2-1 0,1-2 0,0 3 0,0-4 0,0-1 0,0 5 0,0-3 0,0 3 0,0-5 0,0 1 0,0 0 0,0 4 0,0-3 0,3 2 0,-2 1 0,1 0 0,-2 1 0,0 2 0,-1-2 0,1 3 0,-1-4 0,-3 4 0,3-4 0,-3 5 0,4-1 0,-4 7 0,2-5 0,-2 5 0,4-10 0,-1 2 0,1-2 0,3-1 0,-3 3 0,3-6 0,-3 3 0,-1-1 0,5-2 0,-4 3 0,3-4 0,-3 0 0,4 3 0,-4-2 0,4 3 0,-4-4 0,0 0 0,3-1 0,-3 5 0,4-3 0,-5 3 0,1-5 0,4 1 0,-4 0 0,4 0 0,-1 0 0,-2 0 0,2 0 0,-3 0 0,0 3 0,0-3 0,0 3 0,3-3 0,-2 0 0,2-3 0,1 2 0,-4-2 0,4 3 0,-4-3 0,0 2 0,3-2 0,-2 2 0,2 1 0,-3 0 0,3 0 0,-2 0 0,2 0 0,-2 0 0,-1 0 0,0-1 0,0 1 0,0 0 0,0 0 0,0 0 0,1 0 0,-1 0 0,0 0 0,0-1 0,0 1 0,0 0 0,0 4 0,0-3 0,0 2 0,0-3 0,0 0 0,-4 0 0,3 4 0,-3-3 0,4 3 0,0-1 0,0-2 0,0 3 0,0-4 0,0 3 0,0-2 0,-1 3 0,1-4 0,1 0 0,2 0 0,-2-1 0,2-2 0,0 2 0,-2-5 0,5 5 0,-8-2 0,4 0 0,-4-1 0,2-3 0,0 0 0,0 0 0,-8 0 0,-9 0 0,-3 0 0,-5 0 0,2 0 0,4-4 0,-10-1 0,10-3 0,-4-1 0,5 4 0,0-2 0,0 6 0,4-3 0,-3 0 0,8 4 0,-4-4 0,5 4 0,-1 0 0,1 0 0,0 0 0,3 0 0,-2 0 0,6 0 0,-6 0 0,6 0 0,-3 0 0,1 0 0,2 0 0,-3 3 0,5-2 0,-1 5 0,0-5 0,0 2 0,0 0 0,0-3 0,-4 7 0,0-6 0,0 5 0,1-5 0,6 5 0,-2-5 0,2 2 0,-6-3 0,2 3 0,-3-2 0,4 2 0,0 0 0,1-2 0,-1 2 0,0-3 0,0 3 0,0-2 0,-4 2 0,4 0 0,-4-3 0,4 4 0,-4-4 0,4 3 0,-4-3 0,4 3 0,-4-3 0,4 0 0,-4 3 0,0-2 0,3 2 0,-2-3 0,3 0 0,-3 0 0,-1 0 0,0 0 0,0 0 0,0 0 0,4 0 0,-8 0 0,7 0 0,-6 0 0,6 0 0,-2 0 0,-1 0 0,3 0 0,-2 0 0,3 0 0,0 0 0,0 0 0,0 0 0,0 0 0,1 0 0,-5 0 0,3 0 0,-3 0 0,5 0 0,-1 0 0,0 0 0,0 0 0,0 0 0,0 0 0,0 0 0,-3 0 0,3 0 0,-3 0 0,3 0 0,0 0 0,0 0 0,0 0 0,1 0 0,-1 0 0,3-3 0,-2 2 0,6-8 0,-4 5 0,4-6 0,0 3 0,0 0 0,0-4 0,-3 4 0,3-4 0,-3 4 0,3-4 0,-4 4 0,4-4 0,-7 0 0,6 3 0,-5-2 0,2-1 0,0 3 0,-6-9 0,8 8 0,-7-4 0,8 6 0,-5 0 0,2 0 0,0 0 0,-2 3 0,2-2 0,-3 2 0,4-3 0,-3 1 0,2-1 0,0 0 0,-2 3 0,2-2 0,0 2 0,-2-3 0,2 0 0,0 0 0,-2 1 0,5-1 0,-5 0 0,2 0 0,1 0 0,-3 0 0,2 3 0,0-2 0,-2 2 0,5-6 0,-8-1 0,7-1 0,-7 2 0,5 3 0,-3-3 0,0 2 0,0-3 0,0 1 0,0 2 0,-1-3 0,1 1 0,0-2 0,-1 1 0,-3-4 0,3 4 0,-3-5 0,0 1 0,3 0 0,-4-5 0,1 4 0,3-4 0,-4 5 0,5 0 0,-1-1 0,1 1 0,-1 0 0,0 0 0,1-1 0,2 5 0,-1-4 0,-2-7 0,-1 3 0,-2-7 0,3 11 0,4-1 0,-3 5 0,3-3 0,0 2 0,-2 1 0,2-7 0,0 10 0,-2-10 0,5 10 0,-6-2 0,7 3 0,-3-4 0,-1 3 0,4-2 0,-3 3 0,-1-4 0,3 3 0,-2-2 0,0 3 0,2 0 0,-5 0 0,5-3 0,-2 2 0,0-3 0,2 4 0,-2-3 0,3 2 0,-3-3 0,2 0 0,-2 4 0,3-4 0,0-3 0,-3 6 0,3-6 0,-3 3 0,3 4 0,0-4 0,0 0 0,0 4 0,0-8 0,0 7 0,0-6 0,0 6 0,0-2 0,0-1 0,0 3 0,0-2 0,0 3 0,0 0 0,0 0 0,0 0 0,0 0 0,0-3 0,0 2 0,0-2 0,0 3 0,0 0 0,0-4 0,0 3 0,0-6 0,0 6 0,0-6 0,0 6 0,0-3 0,0 4 0,0 0 0,0 1 0,0-1 0,0 0 0,0 0 0,0 0 0,0 1 0,0-1 0,0 1 0,2 2 0,5 1 0,0 3 0,2 0 0,-3-2 0,-2-2 0,-1-3 0,0 4 0,-2-4 0,2 4 0,-3-4 0,3 0 0,-3 0 0,7 4 0,-4 0 0,4 3 0,-1 0 0,-3 3 0,0 3 0,0-2 0,-2 5 0,2-6 0,-1 1 0,-1 4 0,5-7 0,-5 8 0,2-5 0,-3 2 0,0 0 0</inkml:trace>
</inkml:ink>
</file>

<file path=ppt/ink/ink6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25.266"/>
    </inkml:context>
    <inkml:brush xml:id="br0">
      <inkml:brushProperty name="width" value="0.2" units="cm"/>
      <inkml:brushProperty name="height" value="0.2" units="cm"/>
      <inkml:brushProperty name="color" value="#FFFFFF"/>
    </inkml:brush>
  </inkml:definitions>
  <inkml:trace contextRef="#ctx0" brushRef="#br0">263 1 24575,'0'22'0,"0"1"0,0-15 0,0 7 0,0-4 0,0 4 0,0 1 0,0 13 0,0-1 0,0 4 0,0-7 0,0-7 0,0-2 0,0-1 0,0-1 0,0-3 0,0 0 0,0-1 0,-3-3 0,2 0 0,-2 0 0,3 0 0,0 0 0,0 3 0,0-2 0,0 3 0,0-4 0,0 0 0,0-1 0,0 1 0,0 4 0,0-3 0,0 6 0,0-6 0,0 2 0,0 1 0,0 0 0,0 1 0,0 2 0,0-6 0,0 6 0,0-2 0,-3 3 0,2 1 0,-2-1 0,3 0 0,0 0 0,-4 7 0,3-5 0,-2 10 0,3-11 0,-4 8 0,3-7 0,-2 7 0,-1-8 0,3 8 0,-2-8 0,-1 9 0,3-9 0,-2 4 0,-1-5 0,3 0 0,-2 5 0,3-8 0,-4 11 0,3-10 0,-2 3 0,3 3 0,0-7 0,0 8 0,-4-5 0,3 1 0,-2-1 0,3 0 0,0 0 0,0 1 0,0-1 0,0 0 0,0 1 0,0 6 0,0-5 0,0 1 0,0-4 0,-3-2 0,2 3 0,-3-3 0,4 2 0,0-3 0,0 5 0,0 3 0,0-2 0,0 2 0,0 1 0,-3-4 0,2 8 0,-2-3 0,-1 4 0,3 0 0,-6-4 0,6 8 0,-6-7 0,6 8 0,-6-4 0,6-1 0,-7 0 0,7 5 0,-6-3 0,6 8 0,-3-9 0,0 21 0,3-13 0,-3 9 0,4-8 0,0-9 0,0 4 0,0 0 0,0-3 0,-4 8 0,3-9 0,-3 4 0,4 0 0,0-3 0,0 3 0,0-5 0,0 0 0,-4 0 0,3-4 0,-2 3 0,-1-7 0,3 7 0,-2-8 0,-1 4 0,4-9 0,-4 4 0,1-4 0,2 4 0,-2 1 0,-1-1 0,3 0 0,-2 0 0,0 1 0,2 10 0,-6-3 0,6 4 0,-3-3 0,4-3 0,0 9 0,-4-4 0,3 10 0,-2-10 0,3 9 0,0-3 0,0 4 0,0 6 0,0-4 0,0 4 0,0-5 0,0-1 0,0 0 0,0 1 0,0-1 0,0-5 0,0 5 0,0-10 0,0 4 0,0 1 0,0-5 0,0 4 0,0-5 0,0 0 0,0 1 0,0-6 0,0 4 0,0-3 0,0 4 0,0 0 0,0 1 0,0-1 0,0-5 0,0 4 0,0-7 0,0 7 0,0-8 0,0 8 0,0-7 0,0 2 0,0 1 0,0-4 0,0 8 0,0-7 0,0 7 0,-4-8 0,3 8 0,-2-8 0,0 4 0,2-5 0,-3 5 0,1-4 0,2 4 0,-2-5 0,-1 0 0,3 0 0,-2 1 0,0-1 0,2 0 0,-3-3 0,4 2 0,-3-2 0,2 6 0,-2-6 0,3 6 0,0-7 0,0 5 0,0-5 0,0 3 0,0-2 0,0 3 0,0 1 0,0 3 0,0-2 0,0 7 0,0-8 0,0 4 0,0-1 0,3-3 0,2 8 0,2-8 0,1 4 0,0-5 0,-1-3 0,1 2 0,-1-6 0,1 6 0,-1-6 0,3 6 0,-2-3 0,2 0 0,-3 0 0,4-4 0,-3 4 0,6-3 0,-2 3 0,0 0 0,2-2 0,-5 2 0,5-4 0,-6 0 0,6 1 0,-2 2 0,-1-2 0,4 3 0,-8-4 0,4 1 0,0 2 0,-4-2 0,8 3 0,-7 0 0,6-3 0,-5 6 0,5-5 0,-6 5 0,7-5 0,-7 5 0,7-5 0,0 9 0,-2-6 0,1 3 0,-7 0 0,4-7 0,-3 2 0,3 1 0,-4-3 0,0 3 0,-3 0 0,2-4 0,-5 4 0,2 0 0,1 0 0,-3 4 0,2 1 0,1 3 0,-3-2 0,2 2 0,-3-3 0,0-1 0,4 0 0,-3-3 0,2-2 0,-3-3 0,0 0 0,0 0 0,0 0 0,0 0 0,0 0 0,3 0 0,-2-1 0,2 1 0,-3 0 0,0 0 0,0 0 0,0 3 0,0-2 0,0 2 0,0-4 0,3 1 0,-2 0 0,2 0 0,-3 0 0,0-1 0</inkml:trace>
</inkml:ink>
</file>

<file path=ppt/ink/ink6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30.472"/>
    </inkml:context>
    <inkml:brush xml:id="br0">
      <inkml:brushProperty name="width" value="0.2" units="cm"/>
      <inkml:brushProperty name="height" value="0.2" units="cm"/>
      <inkml:brushProperty name="color" value="#FFFFFF"/>
    </inkml:brush>
  </inkml:definitions>
  <inkml:trace contextRef="#ctx0" brushRef="#br0">1 5447 24575,'0'21'0,"0"-4"0,0-3 0,0-6 0,0 7 0,0-8 0,0 18 0,0-12 0,3 18 0,-2-18 0,2 6 0,-3-11 0,0 2 0,3-3 0,-2 3 0,2-2 0,-3 3 0,3-4 0,-3 0 0,3 0 0,-3-1 0,4 1 0,-4 0 0,3 0 0,0 0 0,-2 0 0,2 0 0,0-3 0,-2 2 0,2-2 0,0 2 0,-2 1 0,2 0 0,0-3 0,1 5 0,0-4 0,2 2 0,-5-1 0,2-2 0,0 3 0,-2 0 0,5-1 0,-6 1 0,6 0 0,-5 0 0,2-1 0,0 1 0,-2 0 0,5-3 0,-6 2 0,4-2 0,-1 3 0,-3 0 0,6 0 0,-5-1 0,5 1 0,-5 0 0,2 0 0,0 0 0,-2 0 0,5-1 0,-5 1 0,5 0 0,-6 0 0,4 0 0,-1 0 0,-3 0 0,7 0 0,-7-1 0,6 1 0,-5 0 0,5-3 0,-5 2 0,5-2 0,-5 3 0,5 0 0,-2-1 0,2-2 0,1-1 0,-1-3 0,1 0 0,0 0 0,0 0 0,-1 0 0,1 0 0,0 0 0,0 0 0,0 0 0,-1 0 0,1 0 0,0 0 0,0 0 0,-4-3 0,4-1 0,-4-3 0,1 0 0,2 1 0,-5-1 0,5 0 0,-5 0 0,2 0 0,-3 1 0,3-1 0,-2 0 0,2 0 0,-3 0 0,3 3 0,-3-2 0,4-2 0,-4 1 0,0-4 0,0 4 0,3 0 0,-3 0 0,3-3 0,-3 2 0,4-10 0,-4 10 0,6-6 0,-5 4 0,2 2 0,0-3 0,-2 4 0,5-3 0,-5 3 0,2-3 0,-3 3 0,0 0 0,0 0 0,0 0 0,0 0 0,0 0 0,0 0 0,0 0 0,0 1 0,0-1 0,0 0 0,0 0 0,3-4 0,-2 3 0,6-6 0,-6 3 0,6-5 0,-3 5 0,3-4 0,-3 4 0,3-4 0,-6-1 0,5 5 0,-2-7 0,4 6 0,-1-3 0,0 5 0,-3-1 0,6-3 0,-5-3 0,5 3 0,-3-1 0,-3 8 0,3-8 0,-3 7 0,0-6 0,2 6 0,-2-2 0,0 3 0,3-4 0,-4 3 0,2-2 0,-2 3 0,0 0 0,-2 0 0,2 0 0,0 0 0,-3 0 0,3 0 0,1 0 0,-4 1 0,3-1 0,0-3 0,-2 2 0,2-2 0,0 3 0,-2 0 0,5 1 0,-5-1 0,5 0 0,-5 0 0,5-4 0,-5 4 0,6-4 0,-7 4 0,7 0 0,-4 0 0,1 0 0,2 0 0,-2 1 0,0-1 0,2 0 0,-2 0 0,3 0 0,0 3 0,0-2 0,0 2 0,0-3 0,-1 3 0,1-2 0,0 6 0,0-7 0,0 4 0,0-1 0,0-2 0,0 5 0,-1-5 0,1 5 0,0-2 0,0 0 0,0 2 0,0-2 0,0 0 0,-1 3 0,1-4 0,0 1 0,0 3 0,0-3 0,0 0 0,0 2 0,-3-5 0,2 5 0,-2-2 0,2 0 0,1-1 0,0 0 0,0-2 0,0 2 0,0 0 0,0-2 0,0 2 0,-3-3 0,2 4 0,1-7 0,-3 6 0,5-6 0,-5 6 0,3-2 0,-3 2 0,2-3 0,-5 0 0,5 0 0,-2 0 0,3 1 0,-3-1 0,2 0 0,-2 0 0,2 0 0,-2-4 0,2 4 0,-2-4 0,4 0 0,-5 3 0,4-2 0,-3 3 0,0 0 0,-1 0 0,0 0 0,-3 0 0,4 0 0,-1 1 0,-3-1 0,3 0 0,0 0 0,-2-4 0,2 3 0,1-6 0,-3-1 0,5-1 0,-5 2 0,3-1 0,-1 4 0,-2-1 0,2-2 0,-3 2 0,0 1 0,4-10 0,-4 11 0,4-11 0,-4 10 0,3-5 0,-2 1 0,2 0 0,1 0 0,-3-1 0,2 1 0,-3 3 0,0-2 0,3 3 0,-2-1 0,3-2 0,-1 2 0,-2-3 0,5 3 0,-5-2 0,6 2 0,-7-3 0,7 0 0,-3-7 0,1 5 0,1-2 0,-5 5 0,5 2 0,-5-3 0,6 0 0,-3 0 0,1 0 0,1-1 0,-1 1 0,-1-4 0,3 2 0,-3-2 0,0-1 0,3 4 0,-3-8 0,4 8 0,0-8 0,-4 8 0,4-8 0,-3 3 0,3-4 0,-3 0 0,2 0 0,-6-1 0,6 1 0,-6 0 0,3 0 0,-4-5 0,0 3 0,0-3 0,0 0 0,0 3 0,0-19 0,0 17 0,0-17 0,0 14 0,0 1 0,0-4 0,0 9 0,0-4 0,0 0 0,0 4 0,0-5 0,0 7 0,0-2 0,0 2 0,0-1 0,0 0 0,0 4 0,0-3 0,0 3 0,0 0 0,0 2 0,0-1 0,0 4 0,0-8 0,0 7 0,0-7 0,-4 3 0,3-4 0,-6-11 0,2 8 0,-3-13 0,-1 14 0,0-8 0,0-2 0,0-1 0,-1-4 0,1 6 0,4-6 0,-3-2 0,3 0 0,-1 2 0,-2 6 0,7-6 0,-7 4 0,7-5 0,-3 7 0,4 0 0,-4-1 0,3 6 0,-3-5 0,4 5 0,0-1 0,-4-3 0,3 9 0,-3-9 0,4 3 0,0-4 0,0 4 0,0-3 0,0 3 0,0-10 0,0 9 0,0-3 0,0 15 0,0-3 0,0 7 0,0-2 0,0 3 0,0-3 0,0 2 0,0-7 0,0-7 0,0 3 0,0-8 0,0 6 0,0-2 0,0-4 0,0 4 0,0-3 0,0 4 0,0-6 0,0 6 0,0-5 0,0 5 0,0 0 0,0 0 0,0 6 0,0 0 0,0 0 0,0 0 0,0 0 0,0-17 0,0 13 0,0-17 0,0 19 0,0-3 0,0 5 0,0 0 0,0 0 0,0 0 0,0-1 0,0 1 0,0 0 0,0 4 0,0 2 0,0 4 0,0-5 0,0 3 0,0 2 0,0 0 0,-4 4 0,4-1 0,-4 2 0,4-1 0,-3 3 0,2-2 0,-2 3 0,3 0 0,-3 0 0,2-4 0,-2 3 0,0-2 0,3 3 0,-3-4 0,-1 4 0,4-7 0,-3 6 0,3-6 0,-3 7 0,2-8 0,-2 4 0,3-4 0,0 3 0,-4-2 0,3 2 0,-2 1 0,3 0 0,0 4 0,-3 0 0,2 0 0,-2 0 0,0 4 0,2-4 0,-5 4 0,6-4 0,-6 3 0,2 2 0,-2 2 0,-1 0 0,1 0 0,-1 0 0</inkml:trace>
</inkml:ink>
</file>

<file path=ppt/ink/ink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2"/>
    </inkml:context>
    <inkml:brush xml:id="br0">
      <inkml:brushProperty name="width" value="0.28222" units="cm"/>
      <inkml:brushProperty name="height" value="0.28222" units="cm"/>
      <inkml:brushProperty name="color" value="#FFFFFF"/>
    </inkml:brush>
  </inkml:definitions>
  <inkml:trace contextRef="#ctx0" brushRef="#br0">1304 1335 24575,'-28'0'0,"-5"0"0,-4 0 0,-4 0 0,8 0 0,-6 0 0,-5 0 0,16 0 0,-22 0 0,-1 0 0,22 0 0,-17 1 0,3-2 0,22-3 0,-9 0 0,12-4 0,0 2 0,-1 1 0,1-1 0,2 3 0,-1-2 0,6 2 0,-7-3 0,7 1 0,-4-1 0,1 2 0,2-1 0,-1 0 0,-2-4 0,3 4 0,-5-3 0,5 2 0,-2 1 0,3-3 0,0 3 0,2-4 0,-1 3 0,1-2 0,-2 3 0,2 0 0,-4-5 0,5 4 0,-3-2 0,1 2 0,1 1 0,1 1 0,-3-4 0,4 3 0,-5-3 0,1 1 0,-1 1 0,2-1 0,2 2 0,-3-2 0,3 1 0,-1-1 0,-1-1 0,2 3 0,-1-3 0,2 4 0,-2 0 0,4-1 0,-2 0 0,-1 0 0,2 0 0,-2 0 0,1 0 0,1 1 0,-2-1 0,1 0 0,1 0 0,-4 0 0,4 1 0,-2-3 0,-2-1 0,3 0 0,-2 1 0,3 0 0,-1 1 0,3-1 0,-3 3 0,4 0 0,-2-1 0,0 0 0,0 1 0,0-1 0,0 0 0,0-2 0,2 2 0,-1-1 0,2-1 0,-1 2 0,-2-1 0,2-1 0,0 1 0,1-1 0,0 1 0,2 1 0,-3-2 0,1 0 0,1 2 0,-1-1 0,2-3 0,0 3 0,0-4 0,0 4 0,0 0 0,0-1 0,0 1 0,0 0 0,0-1 0,0-1 0,0 4 0,0-4 0,0 1 0,2 2 0,1-2 0,2 3 0,0 0 0,3-3 0,0 1 0,1-4 0,1 5 0,-1-3 0,2 3 0,1-3 0,-2 3 0,4-3 0,-2 4 0,3-5 0,-1 3 0,-3-1 0,7-1 0,2-3 0,-4 3 0,4-2 0,-7 1 0,-1 3 0,3-1 0,-5 1 0,2 2 0,-2-4 0,2 3 0,-1-3 0,-1 1 0,2-1 0,-2 0 0,-1-2 0,2 2 0,-3 1 0,3-3 0,-1 2 0,-1-2 0,0 0 0,2-1 0,-3 1 0,3 0 0,-3-1 0,1 1 0,2 2 0,-2-2 0,-1 3 0,3-3 0,-1-3 0,2 2 0,2 1 0,-4 1 0,2 3 0,-1-4 0,-1 4 0,2-1 0,-2 2 0,5 0 0,-3-1 0,1-1 0,-1 3 0,-1-2 0,3 3 0,-2-2 0,2-1 0,-3 1 0,3 0 0,-2 0 0,6-1 0,-7 1 0,4-1 0,-5 1 0,5 0 0,-3 3 0,2-3 0,0-1 0,-2 0 0,2-2 0,0 3 0,-1 0 0,4-3 0,-5 2 0,16-7 0,-9 3 0,11-1 0,-12 3 0,4-1 0,-3 3 0,2-2 0,-2 2 0,-4 1 0,2-1 0,-5 1 0,2 1 0,-3 0 0,0 4 0,1-5 0,-1 4 0,0-4 0,-2 3 0,0-1 0,0 0 0,2 2 0,-4-4 0,5 5 0,-5-2 0,3 0 0,-1 2 0,0-2 0,-1 2 0,6-3 0,-9 2 0,8-3 0,-7 3 0,1-1 0,1 2 0,-3 0 0,3-2 0,-2 1 0,0-1 0,4 2 0,-5 0 0,5 0 0,-5 0 0,3 0 0,1 0 0,-4 0 0,2 0 0,0 0 0,2 0 0,-1 0 0,-1 0 0,2 0 0,-4 0 0,5 0 0,-4 0 0,1 0 0,1 5 0,-1 0 0</inkml:trace>
</inkml:ink>
</file>

<file path=ppt/ink/ink7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40.462"/>
    </inkml:context>
    <inkml:brush xml:id="br0">
      <inkml:brushProperty name="width" value="0.35" units="cm"/>
      <inkml:brushProperty name="height" value="0.35" units="cm"/>
      <inkml:brushProperty name="color" value="#FFFFFF"/>
    </inkml:brush>
  </inkml:definitions>
  <inkml:trace contextRef="#ctx0" brushRef="#br0">461 2003 24575,'31'0'0,"-2"0"0,-17 0 0,-1 0 0,0 0 0,-4 0 0,4 0 0,6-7 0,0 6 0,0-6 0,-6 7 0,-5 0 0,4-3 0,-2 2 0,2-2 0,0 3 0,-2-3 0,2 2 0,-1-2 0,-1 0 0,2 2 0,-1-2 0,-1 0 0,2 2 0,-1-2 0,-1 0 0,2 2 0,0-2 0,-3 3 0,6-3 0,-5 3 0,2-4 0,0 1 0,-2 3 0,1-3 0,1 0 0,-2 2 0,2-2 0,0 0 0,1-2 0,0 2 0,0-1 0,0 4 0,-4-3 0,4 2 0,-4-5 0,4 5 0,-4-2 0,4 0 0,-1 3 0,-2-7 0,5 7 0,-5-3 0,3-1 0,-1 4 0,-3-6 0,3 5 0,-3-5 0,4 5 0,-3-5 0,2 5 0,1-5 0,0 1 0,1 1 0,2-3 0,-6 6 0,3-5 0,-1 5 0,-2-5 0,3 5 0,0-5 0,-4 5 0,4-2 0,0-1 0,-4 3 0,4-5 0,3 5 0,-6-5 0,6 5 0,-7-2 0,0 0 0,3 2 0,-2-5 0,1 5 0,1-5 0,-2 6 0,6-4 0,-6 1 0,2 3 0,1-7 0,-3 6 0,2-5 0,1 5 0,-3-5 0,2 5 0,1-5 0,-3 5 0,6-6 0,-6 6 0,6-6 0,-6 7 0,7-7 0,-8 6 0,8-6 0,-7 6 0,2-5 0,1 2 0,-3 0 0,2-3 0,1 7 0,-3-7 0,2 4 0,1-1 0,-3-2 0,6 2 0,-6 0 0,3-3 0,-5 3 0,5 0 0,-3-2 0,3 6 0,-5-7 0,1 4 0,3-4 0,2-1 0,-1 5 0,-1-4 0,-3 6 0,0-5 0,3 2 0,-2-3 0,2 4 0,-3-4 0,-1 4 0,5-1 0,-3-2 0,3 5 0,-5-5 0,1 2 0,4 0 0,-3-2 0,2 2 0,-3 0 0,0-2 0,3 2 0,2-3 0,-2 3 0,5-3 0,-7 3 0,2-3 0,1 0 0,0 3 0,1-2 0,2 1 0,-6-1 0,3-2 0,-1 1 0,-2 3 0,3-2 0,-4 2 0,3-3 0,-2 0 0,3 2 0,-4-1 0,0 2 0,3-2 0,-3 2 0,3-2 0,-3 2 0,0-3 0,-1 1 0,1-1 0,-1 1 0,1-1 0,-3-3 0,5 3 0,-8-3 0,8 3 0,-5 0 0,3 0 0,0-2 0,-4 1 0,0-1 0,0 0 0,-2 1 0,2-8 0,-3 8 0,0-10 0,0 7 0,0-4 0,0-1 0,0 1 0,0 0 0,0-1 0,-4 1 0,4 4 0,-4-4 0,1 4 0,2-5 0,-2 1 0,3 4 0,-4-4 0,3 7 0,-5-2 0,5-1 0,-2 3 0,0-2 0,-1 0 0,0 2 0,-2-2 0,2 0 0,1 3 0,-3-3 0,2 0 0,0 2 0,-2-2 0,2 4 0,-3-1 0,1 0 0,-1 0 0,0 0 0,0 0 0,0 0 0,0 0 0,0 1 0,-3-2 0,2 1 0,-3 0 0,1 0 0,2 0 0,-7-1 0,8 1 0,-4 0 0,0 0 0,3 0 0,-2 0 0,-1 0 0,3 0 0,-6-1 0,6 1 0,-2 0 0,-1 0 0,3 0 0,-6-1 0,6 1 0,-3 0 0,5 0 0,-1 0 0,0 0 0,0 0 0,-12-9 0,0-2 0,-11-6 0,3 1 0,2 5 0,7 8 0,-30-16 0,-8-2 0,-10-4 0,12 6 0,-2 0 0,-25-13 0,58 32 0,-29-13 0,38 14 0,-1 5 0,2-2 0,5 3 0,-6-3 0,6 2 0,-7-2 0,8 3 0,-4-3 0,0 2 0,3-5 0,-2 5 0,-1-5 0,3 5 0,-2-3 0,-1 1 0,3 2 0,-2-2 0,-1-1 0,0 3 0,-4-5 0,4 5 0,-3-3 0,6 1 0,-6 3 0,6-4 0,-7 1 0,8 2 0,-8-6 0,4 7 0,-1-4 0,-2 1 0,6 2 0,-6-6 0,2 6 0,-3-5 0,0 5 0,3-6 0,-2 3 0,2 0 0,-3 1 0,0-1 0,3 4 0,-9-7 0,8 3 0,-6-1 0,5-1 0,2 5 0,1-6 0,-3 3 0,2 0 0,1-2 0,-4 5 0,7-2 0,-6 3 0,6-3 0,-6 2 0,6-5 0,-6 5 0,2-5 0,1 5 0,-4-6 0,4 3 0,-4-1 0,3-1 0,-2 5 0,2-5 0,-3 5 0,3-6 0,-2 7 0,2-7 0,1 6 0,-4-5 0,8 5 0,-8-6 0,7 6 0,-6-2 0,-1-1 0,-1 0 0,2 0 0,-1-3 0,4 6 0,-1-2 0,-2-1 0,6 4 0,-6-4 0,6 4 0,-6 0 0,6-3 0,-3 2 0,0-2 0,4 3 0,-4 0 0,1-3 0,3 2 0,-6-2 0,5 0 0,-2 3 0,0-4 0,3 4 0,-3-3 0,0 3 0,2-7 0,-2 7 0,3-6 0,-2 2 0,1 0 0,-1-2 0,-1 5 0,3-5 0,-3 3 0</inkml:trace>
</inkml:ink>
</file>

<file path=ppt/ink/ink7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43.758"/>
    </inkml:context>
    <inkml:brush xml:id="br0">
      <inkml:brushProperty name="width" value="0.35" units="cm"/>
      <inkml:brushProperty name="height" value="0.35" units="cm"/>
      <inkml:brushProperty name="color" value="#FFFFFF"/>
    </inkml:brush>
  </inkml:definitions>
  <inkml:trace contextRef="#ctx0" brushRef="#br0">1801 1994 24575,'-40'0'0,"-6"0"0,-4 0 0,-7 0 0,11 0 0,-7 0 0,-7 0 0,20 0 0,-28 0 0,-2 0 0,29 0 0,-22 1 0,3-2 0,31-7 0,-13 3 0,17-7 0,0 3 0,0 1 0,0 0 0,4 3 0,-3-2 0,8 2 0,-8-3 0,8 0 0,-4 0 0,0 0 0,4 1 0,-3-1 0,-1-4 0,4 4 0,-8-4 0,7 4 0,-2 0 0,4-3 0,-1 2 0,4-5 0,-2 5 0,2-2 0,-3 4 0,3-1 0,-6-6 0,6 5 0,-3-5 0,1 6 0,2 1 0,1 0 0,-4-4 0,4 3 0,-4-3 0,-1 0 0,1 2 0,0-2 0,3 4 0,-2-4 0,2 3 0,1-3 0,-4 0 0,4 3 0,-1-3 0,2 4 0,-1 0 0,3 0 0,-2 0 0,-1-1 0,3 1 0,-2 0 0,-1 0 0,3 0 0,-2 0 0,-1 0 0,3 0 0,-6-1 0,6 1 0,-3-4 0,-3 0 0,5-1 0,-4 2 0,5 0 0,-2 1 0,5-1 0,-5 2 0,6 2 0,-3-1 0,0 0 0,0 0 0,0 0 0,0 0 0,1-3 0,2 3 0,-2-3 0,2 0 0,0 2 0,-2-2 0,2 0 0,0 2 0,1-2 0,0 0 0,2 3 0,-2-3 0,0 0 0,2 2 0,-2-2 0,3-3 0,0 4 0,0-5 0,0 4 0,0 2 0,0-3 0,0 1 0,0 2 0,0-3 0,0 0 0,0 4 0,0-4 0,0 1 0,3 2 0,1-2 0,3 4 0,0-1 0,4-4 0,0 3 0,1-7 0,2 7 0,-2-3 0,4 3 0,-1-3 0,0 3 0,5-4 0,-4 5 0,4-5 0,0 3 0,-4-2 0,8-1 0,4-4 0,-6 3 0,5-2 0,-8 3 0,-3 3 0,4-2 0,-5 3 0,0 1 0,0-4 0,1 2 0,-1-2 0,0 0 0,0-1 0,0 1 0,-3-4 0,3 3 0,-4 0 0,5-2 0,-4 2 0,2-3 0,-2 0 0,3-1 0,-3 1 0,3 0 0,-4-1 0,1 1 0,3 3 0,-3-2 0,0 2 0,2-3 0,1-4 0,1 3 0,3 1 0,-4 0 0,0 7 0,1-7 0,-1 7 0,0-3 0,0 3 0,5 1 0,-4-1 0,3-3 0,-3 6 0,-1-6 0,4 7 0,-2-4 0,2 0 0,-4 1 0,5-1 0,-4 0 0,9 0 0,-9 0 0,4 0 0,-5 0 0,4 0 0,-2 4 0,3-3 0,-1-1 0,-2-1 0,2-3 0,1 4 0,-4 1 0,8-5 0,-7 3 0,23-11 0,-15 6 0,16-3 0,-16 5 0,6-1 0,-5 4 0,4-4 0,-5 5 0,-4 0 0,3-1 0,-8 2 0,4 2 0,-5-2 0,0 7 0,1-7 0,-1 6 0,0-6 0,-3 3 0,2 0 0,-2-2 0,3 5 0,-4-6 0,4 7 0,-4-4 0,1 1 0,2 3 0,-2-3 0,-1 3 0,7-4 0,-10 3 0,10-5 0,-10 5 0,2-3 0,0 4 0,-2 0 0,2-3 0,0 2 0,-3-2 0,6 3 0,-5 0 0,6 0 0,-6 0 0,2 0 0,1 0 0,-3 0 0,2 0 0,0 0 0,2 0 0,-1 0 0,-1 0 0,1 0 0,-3 0 0,6 0 0,-6 0 0,2 0 0,0 7 0,1 0 0</inkml:trace>
</inkml:ink>
</file>

<file path=ppt/ink/ink7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47.533"/>
    </inkml:context>
    <inkml:brush xml:id="br0">
      <inkml:brushProperty name="width" value="0.35" units="cm"/>
      <inkml:brushProperty name="height" value="0.35" units="cm"/>
      <inkml:brushProperty name="color" value="#FFFFFF"/>
    </inkml:brush>
  </inkml:definitions>
  <inkml:trace contextRef="#ctx0" brushRef="#br0">1 1837 24575,'32'0'0,"-2"0"0,-15 0 0,0 0 0,0 0 0,5 0 0,1 0 0,0 0 0,52 0 0,-35 0 0,38 0 0,-40 0 0,11 0 0,-11 0 0,15 0 0,-24 0 0,3 0 0,-5 0 0,0-8 0,-4 6 0,3-5 0,-3 3 0,-1 3 0,0-3 0,-5 1 0,1 2 0,3-6 0,-2 6 0,2-6 0,-3 6 0,10-6 0,-8 6 0,13-6 0,-15 6 0,4-6 0,-1 6 0,-2-6 0,6 2 0,-6 1 0,7-3 0,-8 6 0,8-7 0,-8 7 0,8-6 0,-3 6 0,-1-6 0,0 6 0,0-6 0,-4 6 0,4-6 0,-5 3 0,0 0 0,0 0 0,1 1 0,-1-1 0,0-1 0,1-1 0,-1 5 0,0-6 0,-3 6 0,9-6 0,-8 6 0,9-5 0,-2 5 0,-4-3 0,4 1 0,0 2 0,7-6 0,-4 3 0,3 0 0,-11 1 0,5-1 0,-4 3 0,4-6 0,-5 6 0,1-6 0,-1 3 0,0 0 0,5 0 0,-4 1 0,8-2 0,-7 1 0,2-3 0,1 2 0,-4 1 0,8-4 0,-7 4 0,2-4 0,-3 4 0,-1-3 0,0 6 0,0-6 0,1 7 0,-1-7 0,-3 6 0,2-6 0,-3 6 0,1-5 0,2 5 0,-2-5 0,-1 5 0,3-6 0,-2 6 0,3-5 0,-3 2 0,2 0 0,-2-3 0,3 3 0,0 0 0,0-3 0,1 6 0,-1-6 0,0 3 0,1-4 0,3 0 0,-2 1 0,7-2 0,-8 2 0,4-1 0,-1 0 0,-2 0 0,2 0 0,1 0 0,-4-3 0,11-1 0,-6 0 0,-1 1 0,-2 3 0,-6 1 0,3-1 0,0 0 0,-3 1 0,2-1 0,-2-2 0,-1 2 0,4-3 0,-7 4 0,6-1 0,-6 1 0,6 0 0,-6 0 0,3-1 0,-5 1 0,5 4 0,-3-4 0,6 3 0,-6-3 0,6 0 0,-5-4 0,5 3 0,-2-3 0,-1 3 0,4 1 0,-4-1 0,8-6 0,-7 5 0,5-5 0,-9 7 0,3 0 0,3-7 0,-6 6 0,10-6 0,-10 3 0,6 3 0,-2-3 0,0 0 0,2-1 0,-2 0 0,4 1 0,-5 0 0,0 3 0,0-3 0,-3 0 0,3 3 0,-4-3 0,0 4 0,0 0 0,0 1 0,-3-4 0,1 2 0,-4-2 0,8 0 0,-4 3 0,2-7 0,-1 6 0,-5-3 0,5 1 0,-2 2 0,3-3 0,-3 1 0,2 2 0,-5-3 0,6 1 0,-3 2 0,0-3 0,-1 1 0,0 2 0,-2-3 0,2 1 0,0-1 0,-2 0 0,2 0 0,-3 4 0,0-3 0,0 2 0,4-6 0,-3 6 0,2-7 0,-3 4 0,0-4 0,0 3 0,0-2 0,0 2 0,0-3 0,0 0 0,0 3 0,0-2 0,0 6 0,0-6 0,0 6 0,0-10 0,0 6 0,0-3 0,0 5 0,0-1 0,0 3 0,0-2 0,0-1 0,0 3 0,0-2 0,-3 0 0,-1 2 0,0-6 0,-2 7 0,2-4 0,-3 4 0,0-4 0,3 4 0,-2-4 0,2 0 0,-3 3 0,-1-2 0,1 3 0,-3-7 0,-1 5 0,-1-4 0,2 5 0,3 1 0,0 4 0,-3-7 0,2 9 0,-2-8 0,0 5 0,3-3 0,-7 3 0,6-2 0,-2 2 0,3-3 0,-4 3 0,3-2 0,-2 2 0,3 1 0,0-4 0,-4 7 0,3-6 0,-6 5 0,3-6 0,-5 3 0,1 0 0,0-3 0,3 6 0,-2-6 0,6 7 0,-9-4 0,4 1 0,-1 2 0,3-2 0,4 3 0,1 0 0</inkml:trace>
</inkml:ink>
</file>

<file path=ppt/ink/ink7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51.411"/>
    </inkml:context>
    <inkml:brush xml:id="br0">
      <inkml:brushProperty name="width" value="0.35" units="cm"/>
      <inkml:brushProperty name="height" value="0.35" units="cm"/>
      <inkml:brushProperty name="color" value="#FFFFFF"/>
    </inkml:brush>
  </inkml:definitions>
  <inkml:trace contextRef="#ctx0" brushRef="#br0">0 2036 24575,'45'0'0,"-5"0"0,-15 0 0,11 0 0,-8 0 0,18 0 0,48 0 0,-42 0 0,1 0 0,-4 0 0,-22 0 0,14 0 0,-14 0 0,8 0 0,-8 0 0,3 0 0,-5 0 0,-4 0 0,3-7 0,-4 5 0,1-5 0,-1 7 0,-5-4 0,0 3 0,0-2 0,1 0 0,-1 2 0,0-6 0,0 6 0,0-6 0,5 7 0,-4-7 0,4 2 0,-1 1 0,-2-3 0,2 7 0,1-8 0,1 8 0,0-8 0,3 4 0,-8-4 0,8 4 0,-3-4 0,0 4 0,3-4 0,-4 0 0,1 3 0,3-2 0,-3 2 0,11-3 0,-10 0 0,9 0 0,-14 0 0,7 0 0,-8-3 0,8 2 0,-8-6 0,8 6 0,-3-6 0,-1 6 0,4-6 0,-3 2 0,3 0 0,-3-2 0,3 6 0,8-10 0,-4 9 0,8-10 0,-11 11 0,0-3 0,-4 4 0,3-4 0,-7 3 0,7-3 0,-8 5 0,4-1 0,-1 0 0,-6 0 0,10 0 0,-14 1 0,14-1 0,-10 0 0,7 0 0,-5 1 0,0-4 0,0 2 0,1-2 0,-1 0 0,0 3 0,0-3 0,1 3 0,-1-3 0,0 2 0,1-2 0,-1 4 0,-4-1 0,4 1 0,-4 0 0,1-1 0,2 1 0,-2-1 0,-1 1 0,4 3 0,-7-2 0,6 2 0,-6 0 0,6-3 0,-2 3 0,-1-1 0,10-5 0,-7 9 0,4-9 0,-4 6 0,-2 0 0,3-3 0,-3 3 0,2-3 0,-3-1 0,4 4 0,1-3 0,-1 3 0,0-4 0,5 0 0,-7 1 0,5-1 0,-6 1 0,3-1 0,0 1 0,-3-4 0,3 2 0,-3-2 0,-1 4 0,0-1 0,-1 1 0,-2 0 0,3 0 0,-4 0 0,0 3 0,3-5 0,-3 4 0,3-1 0,-3-1 0,0 4 0,0-4 0,0 0 0,0-3 0,0 2 0,0-2 0,-1 3 0,1 0 0,0 1 0,0-1 0,0 0 0,0 0 0,0 0 0,0 0 0,0 0 0,6 0 0,-4 0 0,8 3 0,-9-2 0,7 1 0,-4 2 0,4-4 0,1 3 0,-1-4 0,0 0 0,-3 1 0,2 3 0,-2-3 0,3 6 0,-4-5 0,4 2 0,-7 0 0,2 1 0,-3-1 0,3 4 0,-2-6 0,2 5 0,0-5 0,-3 5 0,3-2 0,0 0 0,-2 2 0,2-5 0,0 5 0,-2-5 0,1 5 0,-2-5 0,0 2 0,0-3 0,3 0 0,-2 1 0,1-1 0,-2 3 0,0-2 0,0-1 0,0-1 0,0-2 0,0 6 0,0-5 0,0 5 0,-3-6 0,2 3 0,-3 0 0,4-3 0,-3 2 0,2-2 0,-2 3 0,3 0 0,0-3 0,0-1 0,0 0 0,0 0 0,0 5 0,-3-1 0,5-3 0,-4 2 0,2-2 0,-1 4 0,-3-1 0,1-4 0,2 3 0,-5-2 0,5 3 0,-2-3 0,0 2 0,2-2 0,-5-1 0,2 4 0,0-8 0,-2 7 0,3-6 0,-1 6 0,-3-6 0,7 6 0,-7-3 0,7-2 0,-6 4 0,2-5 0,-3 4 0,3 2 0,-2-3 0,2 1 0,-3 2 0,0-3 0,3 1 0,-2 2 0,3-3 0,-4-3 0,3 6 0,-3-6 0,3 4 0,1 2 0,-4-7 0,3 8 0,-3-8 0,0 4 0,0-1 0,0-2 0,0 2 0,0-3 0,0 0 0,0 3 0,0-2 0,0 6 0,0-3 0,0 1 0,0 3 0,0-6 0,0 5 0,0-2 0,0 1 0,0 1 0,0-4 0,0 5 0,0-3 0,-2 1 0,-2 2 0,-3-3 0</inkml:trace>
</inkml:ink>
</file>

<file path=ppt/ink/ink7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3:56.332"/>
    </inkml:context>
    <inkml:brush xml:id="br0">
      <inkml:brushProperty name="width" value="0.35" units="cm"/>
      <inkml:brushProperty name="height" value="0.35" units="cm"/>
      <inkml:brushProperty name="color" value="#FFFFFF"/>
    </inkml:brush>
  </inkml:definitions>
  <inkml:trace contextRef="#ctx0" brushRef="#br0">0 2117 24575,'41'0'0,"-7"0"0,-8 0 0,-2 0 0,7 0 0,-3 0 0,3 0 0,32 11 0,-33-4 0,30 8 0,-36-6 0,-8-2 0,8 2 0,-8-2 0,4 1 0,-5 0 0,1 0 0,-5-4 0,4 3 0,-4-3 0,4 0 0,1 3 0,-5-3 0,4 0 0,-8 2 0,8-2 0,-7 3 0,2-3 0,1 3 0,0-6 0,1 5 0,2-2 0,-2 0 0,-1 3 0,4-6 0,-4 2 0,4 0 0,-3-2 0,2 6 0,-2-7 0,3 7 0,5-6 0,-4 6 0,4-3 0,-1 0 0,-2 3 0,2-3 0,1 4 0,-4-3 0,4 2 0,-5-6 0,5 2 0,-4 0 0,4-2 0,0 3 0,7-4 0,-4 0 0,3 3 0,-6-2 0,-4 2 0,4-3 0,-5 0 0,0 0 0,1 0 0,3 0 0,-2 0 0,2 0 0,1 0 0,-4 0 0,4 0 0,-1 0 0,2 0 0,-1 0 0,4 0 0,-7 0 0,2 0 0,1 0 0,-4 0 0,9 0 0,-9 0 0,4 0 0,-5 0 0,0 0 0,0 0 0,1 0 0,-1 0 0,0 0 0,7 0 0,-5 0 0,2 0 0,-5 0 0,-6 0 0,6 0 0,-6 0 0,3 0 0,-1-3 0,-2 2 0,3-2 0,-1 3 0,2-4 0,-1 3 0,0-5 0,0 5 0,-4-5 0,8 5 0,-7-2 0,6 0 0,-6-1 0,2 0 0,1-3 0,-3 6 0,6-5 0,-2 1 0,-1-2 0,4-1 0,-4 1 0,5 0 0,3-1 0,-2 0 0,9-4 0,-9 4 0,9-3 0,-9 3 0,2 3 0,-3-1 0,-1 1 0,0-2 0,0 2 0,-3-1 0,2 2 0,-6-3 0,6-1 0,-6 5 0,6-4 0,-6 3 0,3-3 0,0-1 0,-4 1 0,8 3 0,-7-2 0,6 2 0,-6-3 0,6-1 0,-6 1 0,6 0 0,-3-3 0,4 1 0,-4-1 0,4 3 0,-8 0 0,8-1 0,-4 1 0,1-4 0,3 3 0,-4-3 0,1 3 0,2 1 0,-2-1 0,-1 1 0,4 0 0,-8 0 0,8-1 0,-4 1 0,5-1 0,-1 1 0,0-1 0,0 0 0,0 1 0,1 2 0,-1-1 0,5 1 0,3-6 0,3 2 0,-3-2 0,-4 3 0,-3 0 0,3 0 0,-2 0 0,2 0 0,-3 1 0,-1-1 0,0 0 0,1-3 0,-1 3 0,0-3 0,0 3 0,1 1 0,-1 2 0,-4-1 0,4 2 0,-7-3 0,6-4 0,-6 6 0,6-5 0,-6 6 0,6-4 0,-6 1 0,7 0 0,-4 0 0,4-1 0,1 4 0,-1-3 0,-3-1 0,2 0 0,-2-3 0,3 3 0,1 0 0,-1-3 0,0 3 0,7-10 0,-5 9 0,5-9 0,-6 9 0,-1-2 0,0 4 0,1-4 0,-1 2 0,0-2 0,-3 4 0,2-1 0,-3-2 0,5 1 0,-1-2 0,-3 0 0,2 3 0,-2-7 0,3 7 0,-3-7 0,2 7 0,-5-6 0,5 5 0,-5-5 0,1 6 0,-2-3 0,2 4 0,-2 0 0,3-4 0,-4 6 0,0-5 0,0 6 0,0-3 0,0 0 0,0 1 0,0-1 0,3 0 0,-3 0 0,0 0 0,2 0 0,-7 1 0,6-1 0,-1 0 0,-2 0 0,4 0 0,-5 0 0,3 1 0,0-4 0,0 2 0,0-2 0,0-1 0,0 4 0,0-8 0,1 4 0,-1-1 0,1-2 0,2 2 0,-1-3 0,2 0 0,0 3 0,-3-3 0,7 7 0,-7-7 0,3 7 0,-4-2 0,0 3 0,0 0 0,0 0 0,-1 0 0,1-2 0,-3 1 0,2-1 0,-3-1 0,1 3 0,2-2 0,-5-1 0,2 2 0,0-2 0,-2 0 0,5-1 0,-5-4 0,2 4 0,1-3 0,-3 6 0,2-7 0,0 8 0,-2-8 0,5 4 0,-5-1 0,6-2 0,-6 6 0,5-6 0,-2 6 0,1-7 0,1 8 0,-6-4 0,7 0 0,-6 3 0,5-2 0,-5-1 0,5 3 0,-5-2 0,5 3 0,-5-3 0,2 2 0,0-5 0,-2 6 0,2-3 0,0-4 0,-2 5 0,2-4 0,0 6 0,-3 0 0,3-3 0,0 2 0,-2-2 0,2 1 0,-3 1 0,0-5 0,0 5 0,0-2 0,0 1 0,0 1 0,0-5 0,0 5 0,0-1 0,0-1 0,0 2 0,0-9 0,0 9 0,0-6 0,0 7 0,0-3 0,0 0 0,0-1 0,0 1 0,0 0 0,0 2 0,0-5 0,0 6 0,0-3 0,0 0 0,0 3 0,0-6 0,0 5 0,0-2 0,0 0 0,0 3 0,-6-6 0,1 6 0,-4-3 0,5 3 0,-3-4 0,3 3 0,-3-2 0,3 3 0,-2 0 0,2-3 0,-2 6 0,-1-8 0,0 7 0,1-4 0,-1 2 0,0 1 0,1-1 0,2-2 0,1-2 0</inkml:trace>
</inkml:ink>
</file>

<file path=ppt/ink/ink7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03.180"/>
    </inkml:context>
    <inkml:brush xml:id="br0">
      <inkml:brushProperty name="width" value="0.35" units="cm"/>
      <inkml:brushProperty name="height" value="0.35" units="cm"/>
      <inkml:brushProperty name="color" value="#FFFFFF"/>
    </inkml:brush>
  </inkml:definitions>
  <inkml:trace contextRef="#ctx0" brushRef="#br0">0 1674 24575,'30'23'0,"-6"-1"0,-9-10 0,-4-1 0,5 0 0,-1 1 0,0 0 0,28 19 0,-21-18 0,34 25 0,-37-28 0,9 8 0,-8-10 0,-4 0 0,4 0 0,-5-1 0,0 1 0,1-1 0,10 5 0,-8-4 0,8 4 0,-11-5 0,-3 0 0,2 1 0,-2-1 0,3 1 0,-3-1 0,2 1 0,-2-1 0,-1 1 0,4-1 0,-4 0 0,1 1 0,2-1 0,-2 1 0,3-1 0,-4 0 0,4 1 0,-1-1 0,2 1 0,3-4 0,-4 2 0,-3-2 0,2 0 0,-3 3 0,1-3 0,2 3 0,-2 1 0,-1-4 0,4 3 0,-4-3 0,1 3 0,2-3 0,-2 3 0,3-3 0,0 0 0,1 3 0,-1-6 0,0 6 0,0-6 0,7 5 0,-5-5 0,5 6 0,-6-6 0,3 6 0,-2-6 0,2 3 0,1-1 0,-4-2 0,8 7 0,-8-7 0,4 2 0,0 1 0,-4-3 0,4 6 0,-5-6 0,0 2 0,1 1 0,-1-3 0,0 5 0,1-5 0,-5 3 0,3-1 0,-2-2 0,3 2 0,1-3 0,-5 3 0,3-2 0,-2 2 0,0-3 0,2 4 0,-2-4 0,3 4 0,-4-4 0,4 3 0,-7-2 0,6 3 0,-6-4 0,6 0 0,-2 0 0,3 0 0,-4 0 0,4 0 0,-4 0 0,5 0 0,-1 3 0,0-2 0,1 2 0,6-3 0,-5 0 0,1 0 0,-4 0 0,-2 0 0,6 0 0,-2 0 0,-1 0 0,-1 0 0,-6 0 0,6 0 0,-6 0 0,6 0 0,-6 0 0,7 0 0,-8 3 0,4-2 0,0 2 0,-4-3 0,4 0 0,-1 0 0,-2 0 0,8 0 0,-7 0 0,5 0 0,-1 0 0,-4 0 0,5 0 0,-7 0 0,3 0 0,-2 0 0,3 0 0,-1 0 0,-2 0 0,3 0 0,-1 0 0,-2 0 0,6 0 0,-2 0 0,3 0 0,1 0 0,-1 0 0,4 0 0,-2 0 0,3 0 0,-5 0 0,4-4 0,-6 3 0,6-2 0,-8-1 0,5 3 0,-1-5 0,-3 5 0,2-6 0,-3 6 0,12-6 0,-6 3 0,5 0 0,-11-3 0,4 7 0,-4-7 0,1 6 0,2-5 0,-6 5 0,9-6 0,-5 3 0,3 0 0,-4-3 0,-1 6 0,-2-5 0,3 5 0,-1-5 0,-2 5 0,6-6 0,-6 6 0,3-5 0,0 5 0,-4-5 0,4 5 0,-4-5 0,7 2 0,-6 0 0,6-2 0,-7 2 0,0 0 0,3-2 0,-2 2 0,3-1 0,-1-1 0,-2 2 0,3-3 0,-1 3 0,-2-2 0,7 2 0,-8-3 0,8-1 0,-7 1 0,6 0 0,-3-1 0,5 1 0,-5 0 0,3-1 0,-2 1 0,3-1 0,0 0 0,1 4 0,-5-2 0,4 2 0,-1-7 0,-2 3 0,6-3 0,-10 5 0,6-2 0,-6 4 0,6-3 0,-6 3 0,6-3 0,-6 3 0,3-3 0,-1 3 0,-2-3 0,3 0 0,-4 0 0,3 0 0,-3 0 0,3 1 0,-3-1 0,0 0 0,4 3 0,-3-2 0,2 2 0,-3-3 0,0 0 0,0 0 0,0 0 0,0 0 0,0 1 0,3-1 0,-3 0 0,3 0 0,-3 0 0,0 0 0,0-4 0,0 4 0,0-4 0,0 4 0,0 0 0,0 0 0,0 0 0,0 0 0,0 1 0,0-1 0,0 0 0,-1 0 0,2-4 0,-1 7 0,0-10 0,0 9 0,4-6 0,-3 4 0,3 0 0,-1 0 0,-2 0 0,3 0 0,-4 3 0,-1-2 0,4 2 0,-2-3 0,2 0 0,1 0 0,-3 3 0,2-3 0,-3 4 0,0-4 0,0 0 0,0 0 0,3 0 0,-2 0 0,3-1 0,-1 1 0,-2 0 0,7-4 0,-8 3 0,4-2 0,0 3 0,-3-4 0,6 2 0,-6-1 0,3 2 0,-4 2 0,0-1 0,0 0 0,0 0 0,0 0 0,-1 0 0,1 0 0,1-3 0,-1 2 0,0-3 0,0 4 0,0 0 0,3 0 0,-2 0 0,3 0 0,-4 0 0,-1 0 0,1 0 0,0-3 0,0 3 0,0-3 0,0 3 0,0 0 0,0 0 0,0 0 0,0 0 0,-1 0 0,1 0 0,0 0 0,0 0 0,0-3 0,0 2 0,1-3 0,-1 4 0,-1 4 0,4-7 0,-2 6 0,2-6 0,-3 3 0,0 0 0,-1 1 0,1-1 0,0 0 0,0 0 0,0 0 0,0 0 0,0 0 0,0 0 0,-1 1 0,1-1 0,0-3 0,0 5 0,0-4 0,0 2 0,0 0 0,-1-3 0,-2 3 0,2 0 0,1-3 0,1 2 0,2-2 0,-3 3 0,0-3 0,0-2 0,1-3 0,0 0 0,-1-1 0,1 1 0,-1 3 0,1-2 0,-1 6 0,0-6 0,0 6 0,1-3 0,-2 5 0,1 2 0,0-6 0,0 3 0,0-4 0,-3 1 0,-1 4 0,-1-4 0,2 3 0,3-3 0,-3 1 0,1 2 0,-4-3 0,5 0 0,-5 3 0,5-3 0,-5 0 0,1 3 0,1-5 0,-2 5 0,2-3 0,-3 1 0,0 1 0,3-5 0,-2 6 0,2-3 0,-3 0 0,3 3 0,-3-6 0,3 5 0,-3-2 0,0 0 0,0-1 0,0 0 0,0 1 0,0 0 0,0 2 0,3-5 0,-2 5 0,2-2 0,-3 1 0,3 1 0,1-4 0,0 4 0,-1-2 0,-3 0 0,3 3 0,-3-3 0,4 0 0,-4 2 0,3-1 0,-3-1 0,3 2 0,-3-4 0,0 5 0,0-3 0,0 0 0,0 3 0,0-6 0,3 5 0,-2-2 0,2 0 0,-3 3 0,0-6 0,0 5 0,3-2 0,-2 1 0,2 1 0,-3-5 0,0 6 0,0-3 0,0 0 0,3 3 0,-2-6 0,2 6 0,-3-3 0,0 1 0,0 2 0,0-6 0,0 6 0,0-2 0,3 0 0,-2 1 0,2-4 0,-3 5 0,0-2 0,0-1 0,0 3 0,0-5 0,0 5 0,0-2 0</inkml:trace>
</inkml:ink>
</file>

<file path=ppt/ink/ink7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09.098"/>
    </inkml:context>
    <inkml:brush xml:id="br0">
      <inkml:brushProperty name="width" value="0.35" units="cm"/>
      <inkml:brushProperty name="height" value="0.35" units="cm"/>
      <inkml:brushProperty name="color" value="#FFFFFF"/>
    </inkml:brush>
  </inkml:definitions>
  <inkml:trace contextRef="#ctx0" brushRef="#br0">3285 1680 24575,'-27'-6'0,"1"4"0,18-5 0,-6 4 0,2 2 0,-3-6 0,3 6 0,-12-6 0,0 4 0,1-2 0,-2 2 0,17 3 0,-6 0 0,-4 0 0,1 0 0,-8 0 0,9 0 0,1 0 0,1 0 0,6 0 0,-3 0 0,1 0 0,3 0 0,-6 0 0,5 0 0,-2 0 0,0 0 0,3 0 0,-6 0 0,5 0 0,-2 0 0,0-3 0,3 2 0,-6-2 0,5 3 0,-2 0 0,-4 0 0,6 0 0,-6 0 0,7 0 0,-3 0 0,2 0 0,-7 0 0,4 0 0,-4 0 0,3-3 0,-2 3 0,2-3 0,-8-1 0,4 3 0,-4-3 0,5 1 0,0 2 0,0-6 0,-1 6 0,1-2 0,0 0 0,0 2 0,-1-3 0,1 4 0,4 0 0,-4-3 0,7 2 0,-6-2 0,6 3 0,-2-3 0,-1 2 0,3-2 0,-2 3 0,-4-3 0,5 2 0,-8-2 0,9 0 0,-6 2 0,6-2 0,-3 3 0,1-3 0,2 2 0,-6-3 0,6 4 0,-3 0 0,1-3 0,2 2 0,-3-2 0,0-1 0,4 4 0,-8-7 0,7 6 0,-6-2 0,6-1 0,-2 4 0,-1-3 0,4 0 0,-8 2 0,4-2 0,-5-1 0,1 3 0,0-2 0,-5-1 0,4 3 0,-8-6 0,7 3 0,-7-1 0,-3-2 0,0 2 0,-5 1 0,2-4 0,3 7 0,-3-7 0,5 7 0,0-6 0,0 2 0,0 0 0,0-2 0,4 3 0,-3-1 0,8-1 0,-3 1 0,7 1 0,-2-3 0,6 3 0,-6 0 0,6-2 0,-7 5 0,8-5 0,-4 5 0,0-5 0,4 2 0,-8-3 0,4 3 0,-5-3 0,1 3 0,3-4 0,-2 1 0,3-1 0,-9 0 0,4 1 0,-11-1 0,6 0 0,-2 0 0,3 0 0,0 0 0,4 4 0,-4-3 0,0 2 0,4 1 0,-4-3 0,5 2 0,0-2 0,-5-1 0,4 3 0,-4-2 0,5 3 0,0-3 0,0-1 0,-1 0 0,1 1 0,0-1 0,0 0 0,-1 4 0,1-3 0,0 3 0,3-3 0,-9-4 0,12 3 0,-13-3 0,11 4 0,-1-1 0,-2 1 0,6 0 0,-6-1 0,6 1 0,-6 3 0,6-2 0,-7 2 0,4-3 0,-1-4 0,-2 2 0,2-2 0,-4 3 0,1 1 0,4 0 0,-4-1 0,4 1 0,-4-1 0,3 4 0,-2-3 0,2 3 0,1-3 0,-4-1 0,4 1 0,-1-1 0,-2 1 0,6 0 0,-6-1 0,6 4 0,-7-2 0,1-2 0,-2 0 0,1-3 0,1 4 0,6-4 0,-7 3 0,7-3 0,-6 3 0,6 1 0,-3 0 0,1-3 0,2 2 0,-3-3 0,5 4 0,-2-3 0,1 2 0,0-3 0,0 4 0,-3 0 0,1-3 0,-1 1 0,3-1 0,-1-1 0,1 0 0,0-1 0,-4-2 0,3 2 0,-3 1 0,0-4 0,3 4 0,-3-1 0,3-2 0,-6-1 0,5-1 0,-5 1 0,6 0 0,1 7 0,0-6 0,0 6 0,-1-6 0,1 6 0,0-3 0,0 1 0,3 2 0,-3-3 0,7 5 0,-6-4 0,5 2 0,-2-2 0,3 0 0,0 3 0,3-6 0,1 6 0,3 0 0,3-2 0,-3 4 0,3-8 0,-3 5 0,1-3 0,-1 4 0,-1 0 0,1 0 0,0 1 0,0-1 0,0 0 0,0-3 0,0 2 0,-3-2 0,2 3 0,-2-3 0,0 3 0,2-3 0,-2 3 0,-1 0 0,7-3 0,-6 2 0,6-2 0,-6 3 0,2 0 0,1-2 0,-2 1 0,4-2 0,-5 3 0,2 0 0,1-3 0,0 3 0,-3-3 0,2 3 0,-3 1 0,4-1 0,0 0 0,0 0 0,0 0 0,-1 1 0,1-1 0,-1 1 0,4 2 0,-3 1 0,6 3 0,-6 0 0,3 0 0,-1 0 0,1 0 0</inkml:trace>
</inkml:ink>
</file>

<file path=ppt/ink/ink7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13.367"/>
    </inkml:context>
    <inkml:brush xml:id="br0">
      <inkml:brushProperty name="width" value="0.35" units="cm"/>
      <inkml:brushProperty name="height" value="0.35" units="cm"/>
      <inkml:brushProperty name="color" value="#FFFFFF"/>
    </inkml:brush>
  </inkml:definitions>
  <inkml:trace contextRef="#ctx0" brushRef="#br0">3583 1938 24575,'-31'0'0,"3"0"0,12 0 0,1 0 0,-5 0 0,4 0 0,-8 0 0,-15-7 0,-15-3 0,9 1 0,-4-2 0,26 6 0,-3 1 0,3 0 0,4 4 0,-1-3 0,4 2 0,-4-3 0,5 1 0,-1 2 0,1-6 0,0 6 0,3-2 0,-2 3 0,6 0 0,-6 0 0,6-3 0,-3 2 0,1-2 0,-5 3 0,3 0 0,-6 0 0,10 0 0,-2-3 0,-1 2 0,0-2 0,-1 3 0,1-3 0,1 2 0,2-2 0,-6 3 0,6 0 0,-3 0 0,1 0 0,-2 0 0,1 0 0,-4 0 0,8 0 0,-8 0 0,4 0 0,-1 0 0,-2 0 0,3 0 0,-1 0 0,-2 0 0,2-3 0,-3 2 0,3-3 0,-2 4 0,6 0 0,-6 0 0,-5 0 0,6 0 0,-8 0 0,9 0 0,1 0 0,-3 0 0,2 0 0,-3 0 0,3-3 0,-2 3 0,2-3 0,-3 3 0,0 0 0,3 0 0,-2-4 0,2 3 0,-3-2 0,0 0 0,0 2 0,-1-3 0,1 4 0,3 0 0,-2-3 0,2 2 0,-3-2 0,0 3 0,0 0 0,3-3 0,-2 2 0,2-2 0,-10-1 0,5 4 0,-5-7 0,7 6 0,-5-6 0,4 6 0,-4-6 0,0 6 0,4-6 0,-8 6 0,8-6 0,-4 3 0,0 0 0,0-3 0,-1 6 0,-3-6 0,8 2 0,-8 1 0,3-3 0,-4 2 0,0 0 0,0-2 0,4 3 0,-8-1 0,7-2 0,-8 2 0,5-3 0,4 0 0,-3 3 0,3-2 0,-11 2 0,10-3 0,-5 0 0,12 4 0,0-3 0,0 6 0,-1-5 0,1 5 0,0-6 0,-1 6 0,1-6 0,0 3 0,0 0 0,-1-3 0,1 6 0,0-5 0,0 1 0,-5 1 0,4-3 0,-4 6 0,5-5 0,0 1 0,-1 1 0,1-3 0,-5 3 0,4-1 0,-4-2 0,5 3 0,0 0 0,0-3 0,-5 2 0,3-2 0,-2-1 0,4 0 0,-8-3 0,2 2 0,-2-2 0,3 3 0,5-3 0,0 3 0,-1-7 0,1 3 0,-4 0 0,2-2 0,-2 2 0,3 0 0,-3-3 0,3 6 0,-8-7 0,7 8 0,-7-4 0,8 4 0,-4-3 0,1 2 0,-2-2 0,1 3 0,-4-1 0,7 2 0,-7-2 0,8-2 0,-4 2 0,0-2 0,4 3 0,-4 0 0,5 1 0,0-1 0,-1 4 0,1-3 0,-3 0 0,2-2 0,-3-2 0,8 7 0,-3-3 0,2 0 0,0-1 0,-2-3 0,6 4 0,-2-1 0,2-2 0,1 2 0,0-3 0,0 5 0,0-1 0,1 0 0,-2-4 0,4 3 0,-2-2 0,2-1 0,-4 0 0,1-5 0,-1 1 0,1 0 0,2 3 0,-2-2 0,3 2 0,0-3 0,-3 0 0,6 3 0,-5-2 0,5 2 0,-6-6 0,6 5 0,-2-4 0,-1 6 0,3-1 0,-2-2 0,3 2 0,-3-3 0,2 3 0,-3-2 0,4 6 0,0-2 0,0-1 0,0 3 0,0-2 0,0-1 0,0 3 0,-3-6 0,2 6 0,-2-3 0,3 1 0,0 2 0,0-3 0,0 1 0,0 2 0,-3-3 0,2-2 0,-2 4 0,3-5 0,0 7 0,0-3 0,0 2 0,0-6 0,0 6 0,0-3 0,0 0 0,0 4 0,0-8 0,0 7 0,0-6 0,0 6 0,0-2 0,0 0 0,3 2 0,-2-2 0,2 0 0,-3 2 0,3-2 0,-2 0 0,2 2 0,-3-3 0,3 1 0,-2 2 0,2-3 0,0-2 0,-2 4 0,5-5 0,-5 8 0,2-1 0,0-3 0,1 2 0,0-2 0,2 0 0,-6 3 0,7-3 0,-4 0 0,4 3 0,-3-3 0,2 3 0,-2 1 0,2-1 0,1 0 0,-3-2 0,2 2 0,-6-3 0,6 1 0,-5 1 0,5-1 0,-2-1 0,3 6 0,-1-2 0</inkml:trace>
</inkml:ink>
</file>

<file path=ppt/ink/ink7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17.156"/>
    </inkml:context>
    <inkml:brush xml:id="br0">
      <inkml:brushProperty name="width" value="0.35" units="cm"/>
      <inkml:brushProperty name="height" value="0.35" units="cm"/>
      <inkml:brushProperty name="color" value="#FFFFFF"/>
    </inkml:brush>
  </inkml:definitions>
  <inkml:trace contextRef="#ctx0" brushRef="#br0">4143 2308 24575,'-31'0'0,"-2"0"0,17 0 0,-13 0 0,11 0 0,-11 0 0,8 0 0,-44 0 0,29 0 0,-29 0 0,40 0 0,-5 0 0,3 0 0,-3 0 0,0 0 0,4 0 0,-5 0 0,1 0 0,4 0 0,0 0 0,2 0 0,3 0 0,-4 0 0,0 0 0,4 0 0,-3 0 0,3 0 0,1 0 0,-4 0 0,3 0 0,0 0 0,-3 0 0,3 0 0,-4 0 0,0 0 0,0 0 0,-5 0 0,4 0 0,-4 0 0,0 0 0,4 0 0,-4 0 0,4 0 0,1 0 0,0 0 0,0 0 0,4 0 0,-3 0 0,8 0 0,-4 0 0,5 0 0,-7 0 0,5 0 0,-5 0 0,6 0 0,1 0 0,4 0 0,-4 0 0,7 0 0,-6 0 0,3 0 0,-1 0 0,-2 0 0,6 0 0,-6 0 0,6 0 0,-6 0 0,6 0 0,-6 0 0,6 0 0,-6 0 0,6 0 0,-6 0 0,2 0 0,-3 0 0,0 0 0,3 0 0,-6 0 0,5 0 0,-7 0 0,5 0 0,0 0 0,-1 0 0,-10 0 0,8 0 0,-9 0 0,8 0 0,2 0 0,-2 0 0,-1 0 0,4 0 0,-8 0 0,7 0 0,-7 0 0,4 0 0,-1 0 0,-3 0 0,3-4 0,-4 3 0,4-6 0,-2 2 0,2-3 0,-4 4 0,4-3 0,-3 2 0,4-3 0,-6-1 0,1 1 0,0 0 0,0-1 0,-5 1 0,-2-5 0,-4 3 0,-1-4 0,1 5 0,-1-4 0,1 3 0,-23-8 0,17 8 0,-16-3 0,27 4 0,-5 0 0,10-3 0,-9 2 0,8-2 0,-3 3 0,5 1 0,0-1 0,0 1 0,4 0 0,-3 0 0,8 0 0,-8 3 0,8-2 0,-8 3 0,7-4 0,-3 0 0,1-4 0,2 4 0,-2-4 0,3 4 0,-3-3 0,2 2 0,-2-3 0,3 1 0,1 3 0,0-7 0,-7 0 0,5 2 0,-5-4 0,7 5 0,-1 0 0,1-3 0,0 4 0,0-5 0,3 1 0,-3 3 0,3-2 0,1 6 0,-3-7 0,6 4 0,-7-1 0,7 2 0,-3-1 0,1 2 0,1-1 0,-2-1 0,5 3 0,-2-3 0,1 1 0,-4 2 0,3-7 0,-3 3 0,0-3 0,2 0 0,-5 3 0,5-3 0,-2 4 0,0-5 0,0-2 0,-1 2 0,1-3 0,0 4 0,3 0 0,-3 3 0,3-2 0,1 3 0,0-1 0,-1-2 0,1 2 0,-4 0 0,3-2 0,-3 2 0,3 1 0,1-4 0,0 8 0,-1-8 0,1 7 0,0-6 0,-4 2 0,3 1 0,-3-3 0,0 2 0,3 0 0,-6-2 0,5-2 0,-5 0 0,1-11 0,1 6 0,-2-2 0,8 4 0,-4 3 0,6 1 0,-4 0 0,4 3 0,-3-2 0,7 6 0,-4-6 0,1-1 0,2-1 0,-2 1 0,0 1 0,2 2 0,-2-3 0,3 0 0,0 3 0,0-2 0,0 2 0,0 1 0,0 0 0,0 1 0,-3 2 0,2-7 0,-2 8 0,3-8 0,0 4 0,0-1 0,0-2 0,0 2 0,0 1 0,0-4 0,0 4 0,0-1 0,0-2 0,0-1 0,0 3 0,0-5 0,0 5 0,0 0 0,0-2 0,0 3 0,0-1 0,0-2 0,0 2 0,0-3 0,0 0 0,0 3 0,0-2 0,0 6 0,0-6 0,0 6 0,0-3 0,0 1 0,0 2 0,0-3 0,0-3 0,0 6 0,0-6 0,0 3 0,0 4 0,0-4 0,0 0 0,0 4 0,0-4 0,0 0 0,0 3 0,0-2 0,0-4 0,3-1 0,1-1 0,-1 3 0,1 6 0,-1-4 0,-2 3 0,5-2 0,-5-1 0,2 3 0,0-2 0,-2-1 0,5 3 0,-5-2 0,5 3 0,-5-4 0,8 3 0,-8-2 0,12 6 0,-6 1 0,4 3 0,2 0 0,-5 6 0,0-4 0,-5 5 0</inkml:trace>
</inkml:ink>
</file>

<file path=ppt/ink/ink7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22.635"/>
    </inkml:context>
    <inkml:brush xml:id="br0">
      <inkml:brushProperty name="width" value="0.35" units="cm"/>
      <inkml:brushProperty name="height" value="0.35" units="cm"/>
      <inkml:brushProperty name="color" value="#FFFFFF"/>
    </inkml:brush>
  </inkml:definitions>
  <inkml:trace contextRef="#ctx0" brushRef="#br0">4326 1490 24575,'-19'11'0,"-1"2"0,12-12 0,-6 6 0,3-3 0,-1 0 0,-23 10 0,12-8 0,-14 8 0,10-10 0,11 3 0,-3-3 0,3 1 0,1 1 0,-7 2 0,5-3 0,-5 5 0,10-6 0,-2 4 0,3-4 0,-1 2 0,-2-2 0,2 4 0,1-1 0,-4-3 0,8 2 0,-8-2 0,4 0 0,-1 3 0,-2-3 0,6 3 0,-6 0 0,3-3 0,-1 3 0,-2-3 0,2 3 0,1-3 0,-4 3 0,7-3 0,-6 4 0,2-4 0,1 2 0,-10-2 0,11 3 0,-11 1 0,10-4 0,-5 2 0,1-1 0,0-1 0,3 2 0,-2-2 0,2 0 0,1 3 0,-4-3 0,4 0 0,-1 2 0,-2-5 0,6 5 0,-6-2 0,2 0 0,1 3 0,-4-3 0,4 0 0,-4 3 0,-1-3 0,1 3 0,0 1 0,0 0 0,-1-4 0,1 3 0,0-3 0,-1 4 0,1-4 0,-5 3 0,-3 1 0,-3 1 0,-1-1 0,6-1 0,-3-3 0,8 4 0,-8 0 0,1 3 0,-3-5 0,3 4 0,-1-5 0,8 2 0,-4 1 0,5-4 0,-1 3 0,-3-2 0,2-1 0,-2 3 0,7-3 0,-2 0 0,2 3 0,-3-6 0,3 2 0,-2 0 0,2-2 0,1 6 0,0-6 0,1 5 0,2-5 0,-7 2 0,4-3 0,-1 3 0,-2-2 0,-1 2 0,-1-3 0,-2 0 0,6 0 0,-2 4 0,3-4 0,-5 4 0,-6-4 0,5 0 0,-5 3 0,7-2 0,-7 2 0,5-3 0,-5 0 0,7 0 0,-1 0 0,1 0 0,0 0 0,0 4 0,-5-3 0,4 2 0,-4-3 0,5 0 0,-1 0 0,1 0 0,0 0 0,0 0 0,-1 0 0,1 0 0,3 0 0,-5 0 0,5 0 0,-7 0 0,8 0 0,-4 0 0,4 0 0,-1 0 0,-2 0 0,3 0 0,-5 0 0,1 0 0,3 0 0,-2 0 0,3 0 0,-5 0 0,5 0 0,-4 0 0,4 0 0,-4 0 0,-1 0 0,5 0 0,-4 0 0,4 0 0,-4 0 0,3 0 0,-2 0 0,2 0 0,1-3 0,-4 2 0,8-2 0,-8 0 0,4 2 0,-1-2 0,-2-1 0,2 3 0,1-5 0,-4 5 0,4-5 0,-5 1 0,5 1 0,-10-6 0,7 8 0,-8-8 0,7 6 0,0-4 0,0 0 0,-1 4 0,1-3 0,0 3 0,3-3 0,-2-1 0,2 4 0,-3-2 0,0 1 0,-1-2 0,1 3 0,0-3 0,0 2 0,-1-2 0,1-1 0,0 1 0,-1 2 0,1-2 0,0 3 0,-7-7 0,5 3 0,-5-3 0,10 3 0,-2 1 0,2 0 0,-3-1 0,0-3 0,0 2 0,-1-2 0,1 4 0,0-1 0,3 1 0,-2-1 0,2 1 0,1 0 0,-4-1 0,4 1 0,-1 0 0,-2-1 0,6 1 0,-6-1 0,6 1 0,-3 0 0,1 0 0,2-4 0,-7 3 0,7-3 0,-3 4 0,1 0 0,2-4 0,-3 3 0,0-3 0,3 4 0,-9-4 0,8 3 0,-5-2 0,4 0 0,-2 1 0,1-1 0,-3-1 0,2 3 0,0-7 0,-2 7 0,2-3 0,-3 0 0,3 3 0,-2-3 0,3 4 0,-1-4 0,-3 2 0,4-5 0,-5 2 0,1-3 0,0-1 0,-1 1 0,1 0 0,0 3 0,3-2 0,-2 2 0,5-4 0,-2 1 0,0 0 0,2 0 0,-2-1 0,4 1 0,-1 0 0,1 3 0,-1-5 0,1 8 0,0-8 0,0 9 0,3-3 0,-3 4 0,4 1 0,-4-4 0,0 2 0,3-2 0,-2 3 0,2 1 0,-2-1 0,-1-3 0,0 2 0,0-2 0,0 3 0,0 1 0,0-1 0,1 0 0,-2-4 0,1 3 0,0-6 0,0 6 0,-4-6 0,3 6 0,-3-6 0,4 2 0,-4 0 0,2-2 0,-1 6 0,-1-7 0,3 7 0,-3-6 0,4 3 0,-1-1 0,1-2 0,-4 2 0,3 1 0,-3-4 0,7 7 0,-2-2 0,1-1 0,-2 3 0,3-2 0,-2-1 0,5 3 0,-3-2 0,1-4 0,3 5 0,-6-4 0,5 2 0,-2 3 0,0-2 0,2 0 0,-6-2 0,7 1 0,-4 1 0,4 3 0,-3-7 0,2 6 0,-5-6 0,5 7 0,-5-4 0,5 3 0,-6-6 0,6 6 0,-2-2 0,0-1 0,2 3 0,-3-6 0,1 2 0,2 1 0,-5-3 0,5 2 0,-3-3 0,1-1 0,2 1 0,-2 0 0,3 3 0,0-2 0,0 2 0,0-3 0,0 4 0,0-4 0,0 7 0,0-6 0,0 3 0,0-1 0,0 1 0,0 1 0,0 3 0,-3-6 0,2 5 0,-2-2 0,3 0 0,0 3 0,0-6 0,0 5 0,0-2 0,0 0 0,0 3 0,0-7 0,-3 7 0,2-3 0,-2 0 0,3 2 0,0-5 0,0 6 0,0-3 0,0 0 0,0 2 0,0-5 0,0 5 0,0-2 0,0 1 0,0-2 0</inkml:trace>
</inkml:ink>
</file>

<file path=ppt/ink/ink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3"/>
    </inkml:context>
    <inkml:brush xml:id="br0">
      <inkml:brushProperty name="width" value="0.28222" units="cm"/>
      <inkml:brushProperty name="height" value="0.28222" units="cm"/>
      <inkml:brushProperty name="color" value="#FFFFFF"/>
    </inkml:brush>
  </inkml:definitions>
  <inkml:trace contextRef="#ctx0" brushRef="#br0">1 1231 24575,'23'0'0,"-1"0"0,-11 0 0,-1 0 0,2 0 0,2 0 0,1 0 0,0 0 0,38 0 0,-25 0 0,27 0 0,-29 0 0,8 0 0,-8 0 0,11 0 0,-17 0 0,2 0 0,-4 0 0,0-6 0,-3 5 0,2-4 0,-2 3 0,0 2 0,-1-3 0,-3 1 0,0 1 0,3-4 0,-1 5 0,1-5 0,-3 4 0,8-4 0,-6 5 0,9-5 0,-10 4 0,3-3 0,-2 3 0,0-4 0,4 2 0,-5 0 0,5-2 0,-6 4 0,7-4 0,-6 5 0,5-4 0,-2 3 0,0-4 0,-1 4 0,1-3 0,-4 3 0,4-4 0,-4 2 0,0 1 0,-1-1 0,2 1 0,-1-1 0,0 0 0,0-1 0,0 3 0,0-4 0,-3 5 0,8-5 0,-7 4 0,7-2 0,-1 2 0,-4-1 0,4 0 0,-1 1 0,6-4 0,-3 2 0,1 1 0,-7 0 0,3-1 0,-2 2 0,3-3 0,-5 3 0,2-4 0,-1 2 0,0 1 0,4-1 0,-4 1 0,6-2 0,-4 2 0,1-3 0,0 2 0,-3 1 0,7-4 0,-5 4 0,0-4 0,-2 3 0,1-1 0,-2 3 0,1-4 0,1 5 0,-2-5 0,0 5 0,-1-5 0,0 4 0,-1-3 0,3 4 0,-3-5 0,0 5 0,2-5 0,-1 4 0,1-2 0,0 0 0,-1 1 0,0-3 0,2 2 0,-1 1 0,2-3 0,-1 4 0,1-4 0,-2 3 0,1-4 0,4 1 0,-3 0 0,5-1 0,-6 1 0,5 1 0,-3-2 0,-1 1 0,2-1 0,1 1 0,-4-3 0,9 0 0,-5 0 0,-1 0 0,-1 4 0,-4-1 0,2 0 0,0-1 0,-3 1 0,3 0 0,-3-2 0,0 2 0,3-3 0,-5 3 0,4 1 0,-4-1 0,4 0 0,-4 1 0,2-2 0,-4 1 0,4 3 0,-2-2 0,4 1 0,-4-2 0,4 0 0,-3-2 0,2 2 0,0-2 0,-1 1 0,3 2 0,-3-2 0,6-3 0,-6 3 0,5-4 0,-7 5 0,2 1 0,2-5 0,-4 3 0,7-3 0,-7 1 0,3 3 0,0-2 0,0-1 0,1 1 0,-1-1 0,3 0 0,-5 1 0,2 1 0,-2-1 0,-1-1 0,3 3 0,-5-2 0,1 2 0,1 1 0,-2 0 0,-1-3 0,1 1 0,-3 0 0,5-1 0,-2 2 0,1-4 0,-1 4 0,-3-3 0,4 2 0,-2 0 0,1-1 0,-1 0 0,2 1 0,-5-1 0,6 1 0,-4 1 0,1-3 0,-1 1 0,0 2 0,-1-3 0,1 2 0,1-2 0,-2 1 0,1 0 0,-2 2 0,0-2 0,0 2 0,2-5 0,-1 5 0,1-5 0,-2 2 0,0-1 0,0 1 0,0-2 0,0 2 0,0-2 0,0 0 0,0 3 0,0-3 0,0 5 0,0-5 0,0 5 0,0-8 0,0 5 0,0-1 0,0 2 0,0 0 0,0 1 0,0-1 0,0 0 0,0 1 0,0 0 0,-2 0 0,-1 0 0,1-3 0,-3 4 0,2-3 0,-2 4 0,0-4 0,2 3 0,-1-2 0,0 0 0,-1 2 0,0-2 0,0 2 0,-3-4 0,1 3 0,-3-3 0,4 3 0,0 2 0,1 3 0,-2-6 0,1 6 0,-1-5 0,0 3 0,2-2 0,-5 3 0,4-2 0,-2 1 0,4-2 0,-5 2 0,3-1 0,0 2 0,0-1 0,1-1 0,-2 4 0,1-4 0,-4 4 0,1-5 0,-2 2 0,0 1 0,0-3 0,2 4 0,-1-4 0,4 5 0,-6-2 0,3 0 0,-1 1 0,2-1 0,3 2 0,0 0 0</inkml:trace>
</inkml:ink>
</file>

<file path=ppt/ink/ink8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28.783"/>
    </inkml:context>
    <inkml:brush xml:id="br0">
      <inkml:brushProperty name="width" value="0.35" units="cm"/>
      <inkml:brushProperty name="height" value="0.35" units="cm"/>
      <inkml:brushProperty name="color" value="#FFFFFF"/>
    </inkml:brush>
  </inkml:definitions>
  <inkml:trace contextRef="#ctx0" brushRef="#br0">4766 929 24575,'-39'0'0,"4"0"0,15 0 0,2 3 0,6 5 0,-3-3 0,3 5 0,-20 8 0,16-7 0,-18 13 0,25-13 0,-8 1 0,8-1 0,-5-4 0,6 0 0,-2 0 0,2 4 0,-2-3 0,2 3 0,-10-1 0,6 2 0,-3-1 0,5 0 0,-1-4 0,-1 4 0,1-3 0,-4 3 0,4-4 0,-1 4 0,-2-2 0,6 1 0,-7 1 0,7-3 0,-2 3 0,2-1 0,-2-2 0,2 3 0,-7 0 0,7-3 0,-6 6 0,3-6 0,-1 3 0,2-4 0,-1 4 0,3-3 0,-6 3 0,6-4 0,-3 3 0,4-2 0,-4 3 0,3-4 0,-3 4 0,4-3 0,-4 3 0,3 0 0,-9 0 0,7 4 0,-7-3 0,9-1 0,-3-4 0,4 0 0,-3 3 0,2-2 0,-3 3 0,4-4 0,0 0 0,1 0 0,-1 3 0,-4-2 0,3 2 0,-2-3 0,3 0 0,0 0 0,0-1 0,-4 2 0,3-1 0,-2 0 0,-1 0 0,3 0 0,-6 1 0,6 2 0,-7-1 0,7 2 0,-6-4 0,6 0 0,-6 1 0,2-1 0,1 0 0,-4 1 0,7-1 0,-6 0 0,6 0 0,-6 1 0,6-1 0,-6-3 0,2 3 0,-3-3 0,0 3 0,3 1 0,-2-1 0,2 1 0,-3-1 0,0 1 0,3-1 0,-2 1 0,2-1 0,-3-3 0,0 3 0,3-3 0,-2 4 0,2-1 0,1 0 0,-4 1 0,4-1 0,-1 0 0,-2-3 0,6 3 0,-6-3 0,6 3 0,-7 0 0,8 0 0,-8 1 0,4 2 0,-4-2 0,4 2 0,-3-2 0,6-1 0,-6 0 0,2 1 0,1-1 0,-4-3 0,4 3 0,-1-3 0,-2 3 0,2 0 0,1-2 0,-3 1 0,2-1 0,-3 2 0,3 1 0,-2-1 0,2-3 0,1 3 0,-4-7 0,4 7 0,-4-6 0,-1 5 0,1-5 0,3 6 0,-6-6 0,5 5 0,-7-5 0,5 2 0,0-3 0,0 4 0,-1-4 0,1 4 0,0-4 0,-1 0 0,1 0 0,0 0 0,0 0 0,3 0 0,-2 0 0,6 0 0,-6 0 0,6 0 0,-7 0 0,8 0 0,-8 0 0,8 0 0,-4 0 0,0 0 0,0 0 0,-1 0 0,-2 0 0,6 0 0,-6 0 0,6 0 0,-6 0 0,6 0 0,-7 0 0,8 0 0,-8 0 0,7 0 0,-2 0 0,-1 0 0,-4 0 0,3 0 0,-5 0 0,9 0 0,-3 0 0,1 0 0,2 0 0,-3 0 0,1 0 0,2 0 0,-3 0 0,1 0 0,2 0 0,-3 0 0,-3 0 0,2 0 0,-6 0 0,3 0 0,3 0 0,-2 0 0,2 0 0,-3 0 0,0 0 0,-1 0 0,1 0 0,0 0 0,3 0 0,-2 0 0,2 0 0,-3 0 0,0-4 0,-1 4 0,5-7 0,-4 6 0,4-5 0,-4 5 0,-1-6 0,-3 7 0,2-7 0,-2 6 0,-1-6 0,4 6 0,-8-7 0,7 4 0,-7 0 0,8-3 0,-8 6 0,8-6 0,-4 6 0,5-6 0,0 7 0,-1-7 0,1 6 0,0-6 0,3 6 0,-2-5 0,2 1 0,1 1 0,-3-3 0,6 6 0,-7-5 0,8 5 0,-11-6 0,10 3 0,-10-3 0,10 3 0,-2-3 0,-1 3 0,3-3 0,-2 3 0,-1-3 0,3 4 0,-9-8 0,4 3 0,-1 1 0,3 0 0,1 3 0,2-3 0,-7-1 0,8 1 0,-8-4 0,4 3 0,-1-6 0,-3 5 0,3-5 0,-3 5 0,0-5 0,0 5 0,-1-5 0,-3 5 0,2-5 0,-2 5 0,3-6 0,-3 3 0,-2 0 0,-4-4 0,0 3 0,0-4 0,-6-1 0,5 2 0,-4-2 0,5 5 0,-1-3 0,6 7 0,0-2 0,5 3 0,3 1 0,2-1 0,-1 1 0,3 0 0,-2 0 0,3 0 0,0 0 0,0 0 0,-3 0 0,2 1 0,-2-1 0,4 0 0,-1 0 0,-3 1 0,3-1 0,-3 3 0,3-2 0,0-1 0,0 3 0,0-6 0,0 7 0,1-4 0,-5 0 0,3 0 0,-3-4 0,0 2 0,0-2 0,-1 0 0,-3-1 0,3 1 0,-3-4 0,0 3 0,0 0 0,-1-2 0,1 2 0,0-3 0,-1-5 0,0 4 0,-5-9 0,4 8 0,-4-8 0,6 9 0,-1-4 0,0 5 0,1-1 0,4 5 0,-4-4 0,7 8 0,-3-8 0,1 7 0,1-6 0,-5 2 0,6 0 0,-3-2 0,4 6 0,-4-3 0,3 0 0,-3 3 0,3-6 0,1 6 0,3-3 0,-2 5 0,2-1 0,-3-3 0,3 2 0,-2-2 0,3 3 0,-1-3 0,-2-1 0,2-1 0,0 2 0,-2 3 0,2-3 0,0 3 0,-2-3 0,2 0 0,0-2 0,-2 2 0,5-1 0,-5 0 0,5 3 0,-6-6 0,6 6 0,-5-6 0,2 6 0,-4-6 0,4 6 0,-3-6 0,3 2 0,0 0 0,-3-2 0,3 2 0,0 1 0,-3-3 0,6 6 0,-2-3 0,-1 1 0,3 2 0,-2-3 0,0-3 0,-1 6 0,0-10 0,-2 11 0,5-4 0,-2-3 0,3 6 0,-3-6 0,2 7 0,-2 0 0,0-3 0,2 2 0,-2-3 0,0 1 0,2 2 0,-2-1 0,3-2 0,0 3 0,0-3 0,0 2 0,0 1 0,0-6 0,0 6 0,0-2 0,0-1 0,0 3 0,0-2 0,0-4 0,0 5 0,0-4 0,0 6 0,0-4 0,0 3 0,0-2 0,0 0 0,0-2 0,0 1 0,0 1 0,0 3 0,0-7 0,0 6 0,0-6 0,0 3 0,0 3 0,0-2 0,0-1 0,0 3 0,0-2 0,0 0 0,0 2 0,6-1 0,1 2 0</inkml:trace>
</inkml:ink>
</file>

<file path=ppt/ink/ink8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32.822"/>
    </inkml:context>
    <inkml:brush xml:id="br0">
      <inkml:brushProperty name="width" value="0.35" units="cm"/>
      <inkml:brushProperty name="height" value="0.35" units="cm"/>
      <inkml:brushProperty name="color" value="#FFFFFF"/>
    </inkml:brush>
  </inkml:definitions>
  <inkml:trace contextRef="#ctx0" brushRef="#br0">2908 1 24575,'-24'7'0,"-2"1"0,17 3 0,-6-3 0,3 6 0,-2-2 0,2 0 0,-17 19 0,14-15 0,-12 13 0,18-15 0,-5-2 0,5 0 0,-5 2 0,6-2 0,-7 3 0,4 0 0,-1 1 0,-3-1 0,7 0 0,-3 0 0,0-3 0,2 3 0,-2-3 0,4-1 0,-4 3 0,3-6 0,-3 7 0,4-8 0,0 4 0,0 0 0,0-4 0,-1 8 0,1-8 0,0 8 0,0-7 0,-4 6 0,3-6 0,-3 6 0,4-3 0,-4 5 0,3-5 0,-6 3 0,2-2 0,0 0 0,-2 2 0,3-3 0,-1 5 0,-3-1 0,3-3 0,-7 3 0,2-3 0,-2 4 0,3-1 0,1 1 0,-7 6 0,1-5 0,-3 5 0,5-6 0,4-4 0,-1 3 0,1-4 0,0 5 0,3-1 0,-2 0 0,2 0 0,0 0 0,-2 1 0,2-4 0,0 2 0,-2-2 0,5 3 0,-5 0 0,5 1 0,-5-1 0,5 0 0,-5 1 0,2-1 0,0 0 0,-3 5 0,3-4 0,-4 4 0,0-1 0,0 2 0,-1 4 0,-8 17 0,6-8 0,-7 14 0,3-11 0,3 0 0,-7-3 0,8 1 0,-3-7 0,-1 8 0,6-13 0,-10 8 0,9-10 0,-3 5 0,5-5 0,0-2 0,1-3 0,-1 3 0,0-2 0,4 2 0,-3-3 0,3-1 0,-3 0 0,4-3 0,-4 2 0,7-2 0,-6 3 0,6-4 0,-7 4 0,7-7 0,-3 6 0,4-2 0,-4-1 0,3 4 0,-3-3 0,-4 10 0,6-5 0,-9 1 0,9 1 0,-5-6 0,5 7 0,-6-5 0,7 0 0,-7 1 0,7-1 0,-6 0 0,5 1 0,-2-5 0,1 3 0,1-2 0,-5 3 0,6 0 0,-3 0 0,0 1 0,2-1 0,-5 0 0,5 1 0,-2-1 0,0-3 0,3 2 0,-3-2 0,0 3 0,2-3 0,-2 2 0,1-2 0,-2 10 0,-3-9 0,3 9 0,1-10 0,0 3 0,2 0 0,-5 0 0,6-3 0,-7 2 0,4-2 0,-1-1 0,1 4 0,0-4 0,3 1 0,-6 2 0,6-6 0,-6 6 0,6-2 0,-7 3 0,7 0 0,-7 1 0,7-1 0,-7 0 0,7 5 0,-7-4 0,6 4 0,-6-1 0,7-2 0,-8 7 0,7-3 0,-3-1 0,0 4 0,-1-3 0,0 4 0,-9 7 0,11-5 0,-11 1 0,13-4 0,-6-8 0,3 4 0,0-5 0,-2 0 0,5 0 0,-2 1 0,0-4 0,3 2 0,-7-2 0,7-1 0,-3 0 0,1 0 0,2 0 0,-7 1 0,7-1 0,-6 0 0,6 0 0,-7 1 0,7 2 0,-7-5 0,7 5 0,-3-5 0,0 5 0,3-6 0,-3 6 0,1-6 0,-2 13 0,0-11 0,1 11 0,4-9 0,-1 3 0,1 0 0,-1 1 0,0-1 0,0 5 0,1-4 0,-2 8 0,2-7 0,-1 2 0,0 1 0,0-4 0,3 8 0,-1-7 0,1 2 0,1-4 0,-3 0 0,7 1 0,-7-5 0,6 4 0,-2-8 0,0 4 0,2-1 0,-2 0 0</inkml:trace>
</inkml:ink>
</file>

<file path=ppt/ink/ink8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36.468"/>
    </inkml:context>
    <inkml:brush xml:id="br0">
      <inkml:brushProperty name="width" value="0.35" units="cm"/>
      <inkml:brushProperty name="height" value="0.35" units="cm"/>
      <inkml:brushProperty name="color" value="#FFFFFF"/>
    </inkml:brush>
  </inkml:definitions>
  <inkml:trace contextRef="#ctx0" brushRef="#br0">1893 0 24575,'-4'27'0,"-2"-6"0,-3-2 0,1-10 0,-3 14 0,0-10 0,-16 36 0,5-20 0,-6 17 0,10-24 0,10-6 0,-3-1 0,3 0 0,-3-3 0,3 2 0,-3-2 0,3 4 0,1-5 0,-1 3 0,1-6 0,0 7 0,0-8 0,-4 11 0,3-6 0,-2 3 0,2-5 0,5-3 0,-4 0 0,3 4 0,0-3 0,-2 2 0,2-3 0,0 4 0,-2-3 0,5 6 0,-5-6 0,2 6 0,0-6 0,-3 6 0,3-2 0,0 0 0,-3 2 0,3-3 0,0 5 0,-3-1 0,3-3 0,-4 2 0,4-3 0,-2 1 0,2 2 0,0-2 0,-3-1 0,3 4 0,0-7 0,-2 13 0,2-12 0,-4 12 0,4-13 0,-3 7 0,7-8 0,-7 4 0,6 0 0,-2-4 0,0 8 0,2-7 0,-6 6 0,6-6 0,-5 6 0,5-3 0,-6 1 0,7 2 0,-7-6 0,7 6 0,-6-6 0,5 7 0,-6-4 0,7 8 0,-7-7 0,6 5 0,-5-5 0,2-1 0,0 4 0,-3-4 0,6 1 0,-5 2 0,2-6 0,0 6 0,-3-6 0,7 3 0,-7-1 0,6-2 0,-5 3 0,2 0 0,-3-4 0,3 4 0,-3 0 0,3-4 0,0 8 0,-2-7 0,2 2 0,-3-3 0,3 4 0,-2-3 0,2 2 0,-2-3 0,-2 4 0,4-3 0,-2 2 0,2 1 0,-3-3 0,-1 6 0,1-6 0,0 2 0,0 1 0,0-3 0,0 2 0,0-3 0,-1 4 0,1-3 0,0 2 0,0-3 0,4 4 0,-4-3 0,4 2 0,-5 1 0,1-3 0,0 3 0,0-1 0,0-2 0,-1 6 0,1-6 0,0 7 0,0-4 0,-1 1 0,1-2 0,0 1 0,0-3 0,-1 6 0,1-6 0,0 2 0,3 1 0,-2-3 0,2 3 0,-3-5 0,0 1 0,0 4 0,0-3 0,3 2 0,-2-3 0,2 0 0,-3 0 0,0 3 0,0-2 0,0 2 0,1-3 0,2 0 0,-5 2 0,4-1 0,-5 2 0,3-6 0,0 2 0,-3 1 0,3-2 0,0 4 0,-3-5 0,6-1 0,-10 1 0,6-1 0,-2-3 0,-4 3 0,5-3 0,-4 0 0,2 0 0,3 0 0,-2 0 0,-1 0 0,3 3 0,-2-2 0,-4 2 0,5-3 0,-4 0 0,6 0 0,-7 0 0,6 0 0,-10 0 0,11 0 0,-4 0 0,1 0 0,3 0 0,-7 0 0,6 0 0,-2 0 0,0 0 0,2 0 0,-6 0 0,7 0 0,-4 0 0,0 0 0,3-3 0,-2 2 0,-4-2 0,6 0 0,-6 3 0,7-3 0,0-1 0,-3 1 0,2-1 0,-2 1 0,0 0 0,6-1 0,-8-3 0,7 3 0,-5-2 0,3 2 0,-3-3 0,3 0 0,-3 4 0,3-4 0,0 4 0,0-4 0,0 0 0,0-3 0,0 2 0,0-6 0,0 7 0,0-4 0,3 0 0,-3 0 0,4-1 0,-5-2 0,1 2 0,-1 1 0,1-4 0,3 8 0,-3-4 0,4 4 0,-1 0 0,-5-3 0,4 3 0,-2-3 0,-2 3 0,7 0 0,-7-4 0,5 6 0,-3-4 0,0 2 0,3-1 0,-2-2 0,2 3 0,-3-3 0,0 3 0,4-3 0,-3 3 0,2-2 0,0 1 0,-2-2 0,2 0 0,0 3 0,-2-3 0,2 3 0,-2 0 0,-1-3 0,3 2 0,1-1 0,0-1 0,-1 2 0,0-2 0,-2 1 0,3 1 0,-1-2 0,1 0 0,0 3 0,-1-3 0,-3 0 0,3 2 0,1-1 0,3-1 0,-3 2 0,2-2 0,-2 1 0,0 1 0,0-4 0,-4 2 0</inkml:trace>
</inkml:ink>
</file>

<file path=ppt/ink/ink8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39.536"/>
    </inkml:context>
    <inkml:brush xml:id="br0">
      <inkml:brushProperty name="width" value="0.35" units="cm"/>
      <inkml:brushProperty name="height" value="0.35" units="cm"/>
      <inkml:brushProperty name="color" value="#FFFFFF"/>
    </inkml:brush>
  </inkml:definitions>
  <inkml:trace contextRef="#ctx0" brushRef="#br0">1632 1007 24575,'-26'19'0,"2"0"0,9-4 0,-5 1 0,4-1 0,-4 1 0,1 0 0,-11 6 0,-7 3 0,9-5 0,0-3 0,16-9 0,-3-1 0,-3 4 0,2-3 0,-6 6 0,10-6 0,-5 3 0,5-4 0,1 0 0,-4 1 0,4-4 0,-1 2 0,-2-5 0,2 2 0,-7 1 0,3-3 0,-4 3 0,5-4 0,-5 3 0,4-2 0,-4 3 0,5-1 0,0-2 0,3 3 0,-2-4 0,2 0 0,-3 0 0,0 0 0,-1 0 0,1 0 0,0 0 0,-1 0 0,-6 0 0,5-4 0,-9 0 0,13-4 0,-10 0 0,11 1 0,-8-1 0,5-3 0,-1 2 0,1-2 0,0 4 0,0-1 0,0 0 0,3 4 0,-2-3 0,2 3 0,-3 0 0,4-2 0,-4 1 0,4-2 0,-1 0 0,-2 3 0,2-3 0,1 3 0,-4 0 0,7-2 0,-2 2 0,-1 0 0,3-2 0,-2 2 0,-4-3 0,5 0 0,-4 0 0,6 0 0,0 0 0,-4 3 0,4-2 0,-4 2 0,4-6 0,0 2 0,0-3 0,0 4 0,0 0 0,0 0 0,0 1 0,0-1 0,0 0 0,0-4 0,0 0 0,-1-1 0,1-2 0,-1 2 0,1-3 0,-1 0 0,1-1 0,-1 1 0,0 0 0,1 3 0,-1-2 0,1 2 0,0 1 0,0 0 0,-1 0 0,1 4 0,3-4 0,-2 0 0,-1 1 0,-2-6 0,2 5 0,1 1 0,5-1 0,-5 3 0,2-6 0,-3 6 0,3-6 0,-2 6 0,5-6 0,-6 2 0,4 1 0,-2 0 0,-1 0 0,5 4 0,-6-8 0,6 4 0,-5-1 0,5-2 0,-5 2 0,1-3 0,1 3 0,1-2 0,-1 2 0,4-3 0,-4 4 0,4-4 0,-3 4 0,2-5 0,-2-2 0,3 2 0,-4 1 0,4 1 0,-3 6 0,-1-6 0,3 2 0,-5-3 0,5 4 0,-6-3 0,6 2 0,-5-3 0,5-1 0,-6 5 0,6-3 0,-2 2 0,3 1 0,-3-4 0,2 8 0,-2-4 0,3-3 0,0 6 0,0-6 0,0 7 0,0-3 0,0 0 0,0-1 0,0 1 0,0 0 0,0 3 0,0-6 0,0 5 0,0-2 0,0 1 0,0 1 0,0-4 0,0 5 0,0-3 0</inkml:trace>
</inkml:ink>
</file>

<file path=ppt/ink/ink8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43.641"/>
    </inkml:context>
    <inkml:brush xml:id="br0">
      <inkml:brushProperty name="width" value="0.35" units="cm"/>
      <inkml:brushProperty name="height" value="0.35" units="cm"/>
      <inkml:brushProperty name="color" value="#FFFFFF"/>
    </inkml:brush>
  </inkml:definitions>
  <inkml:trace contextRef="#ctx0" brushRef="#br0">2776 1095 24575,'-35'0'0,"-3"0"0,12 0 0,-10 0 0,10 0 0,0 0 0,-21 0 0,3 0 0,-5 4 0,7-3 0,26 5 0,-4-1 0,1 3 0,2-1 0,-3 1 0,5-3 0,0 1 0,3-5 0,-2 6 0,2-3 0,-3 4 0,4-1 0,-4-3 0,4 3 0,-1-3 0,-2 3 0,6 0 0,-6 1 0,2-4 0,1 2 0,-4-2 0,4 4 0,-5-1 0,5 1 0,-10 3 0,11-4 0,-11 8 0,9-7 0,-3 3 0,0 0 0,0-3 0,-1 4 0,1-1 0,0-3 0,-1 3 0,5 0 0,-4-2 0,3 2 0,-3 0 0,0-3 0,3 3 0,-2 0 0,2-3 0,-3 3 0,3-4 0,-2 1 0,3-1 0,-5 1 0,1-1 0,0 1 0,-1 0 0,1-1 0,0-2 0,0 1 0,-1-1 0,1-1 0,-7 6 0,5-8 0,-5 8 0,2-9 0,4 2 0,-4 1 0,1-4 0,2 4 0,-7 0 0,8-4 0,-8 4 0,8-4 0,-8 0 0,7 0 0,-2 0 0,4 4 0,-1-4 0,-3 4 0,2-4 0,-2 0 0,0 0 0,3 0 0,-2 0 0,6 0 0,-2 0 0,3 0 0,-5 0 0,1 0 0,0 0 0,3 0 0,-2 0 0,2 0 0,1 0 0,-4 0 0,7 0 0,-2 0 0,-1 0 0,3-3 0,-2-1 0,3-3 0,0 0 0,-4 0 0,4 0 0,-4 0 0,4 0 0,-3 0 0,2 0 0,-3-4 0,0 3 0,3-7 0,-3 7 0,0-6 0,3 6 0,-6-3 0,6 1 0,-3 1 0,0-5 0,3 6 0,-6-6 0,2 2 0,1 1 0,-3-4 0,2 7 0,0-6 0,-6-2 0,6 4 0,-7-3 0,7 4 0,1 3 0,0-3 0,3 0 0,-6 3 0,5-6 0,-5 5 0,6-5 0,-3 6 0,0-7 0,3 7 0,-6-6 0,6 3 0,-7-5 0,7 5 0,-6-4 0,6 4 0,-7-4 0,7-1 0,-3 1 0,0 0 0,2 0 0,-2-1 0,4 5 0,-1-4 0,1 4 0,3-1 0,-3-2 0,3 6 0,0-6 0,-2 6 0,1-7 0,2 8 0,-4-8 0,3 4 0,-4-1 0,1-2 0,3 2 0,-3-3 0,-1 0 0,0 3 0,1-2 0,0 6 0,3-6 0,-3 6 0,0-6 0,0 6 0,0-3 0,-1 1 0,1 2 0,0-7 0,0 8 0,-4-8 0,3 4 0,-3-1 0,0-2 0,3 2 0,-7 0 0,7-2 0,-6 2 0,2 0 0,0-2 0,1 2 0,0-3 0,2-1 0,-5 1 0,5 0 0,-2-1 0,4 1 0,-4-3 0,6 2 0,-5-3 0,9 4 0,-6 0 0,7 0 0,-4 3 0,1-2 0,2 6 0,-2-3 0,3 1 0,0 3 0,0-6 0,0 5 0,0-2 0,0 0 0,0 3 0,0-6 0,0 5 0,0-2 0,0 1 0,0 1 0,0-5 0,0 6 0,0-3 0,0 0 0,0 3 0,0-5 0,-4 4 0,4-2 0,-3 0 0,3 3 0,-3-6 0,2 5 0,-2-2 0,3 1 0,0 1 0,0-4 0,0 4 0,0-1 0</inkml:trace>
</inkml:ink>
</file>

<file path=ppt/ink/ink8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47.496"/>
    </inkml:context>
    <inkml:brush xml:id="br0">
      <inkml:brushProperty name="width" value="0.35" units="cm"/>
      <inkml:brushProperty name="height" value="0.35" units="cm"/>
      <inkml:brushProperty name="color" value="#FFFFFF"/>
    </inkml:brush>
  </inkml:definitions>
  <inkml:trace contextRef="#ctx0" brushRef="#br0">3845 1061 24575,'-37'0'0,"5"0"0,12 0 0,4 4 0,-8 0 0,3 8 0,0-3 0,-16 17 0,13-11 0,-11 11 0,16-13 0,3 1 0,5-2 0,-4 0 0,3 2 0,-3-5 0,3 5 0,-2-5 0,5 5 0,-5-5 0,6 1 0,-3 1 0,0-2 0,3 1 0,-3 1 0,4-3 0,-4 3 0,3-4 0,-3 4 0,-6 0 0,7 1 0,-11-1 0,9-4 0,1 1 0,-4-1 0,4 0 0,-5 1 0,5-1 0,-3 1 0,2-1 0,-3 1 0,0 0 0,-1-1 0,1 4 0,0-2 0,0 2 0,3-4 0,-2 1 0,2-1 0,-3 0 0,0 1 0,-1 0 0,5-1 0,-3 1 0,6-1 0,-7 0 0,8 0 0,-8 1 0,7-1 0,-6 0 0,6 0 0,-9 0 0,8 0 0,-5 0 0,4 0 0,2 0 0,-3 1 0,1-1 0,2 0 0,-3 0 0,4-3 0,1 2 0,-5-2 0,3 0 0,-2 3 0,3-4 0,0 1 0,-3 5 0,-2-7 0,2 7 0,-1-5 0,4 0 0,0 2 0,-3-5 0,2 5 0,-7-5 0,8 2 0,-8-3 0,4 3 0,-1-2 0,-2 2 0,2-3 0,-7 0 0,2 0 0,-2 0 0,-1 0 0,3 0 0,-7 0 0,4 0 0,-1 0 0,-3 0 0,8 0 0,-8 0 0,7 4 0,-7-4 0,8 4 0,-4-4 0,5 3 0,-1-2 0,5 3 0,-3-4 0,2 0 0,0 3 0,-2-3 0,6 3 0,-6-3 0,6 0 0,-3 0 0,1 0 0,2 0 0,-3 0 0,1 0 0,2 0 0,-10 3 0,10-2 0,-10 2 0,11-3 0,-8 0 0,7 3 0,-6-2 0,3 2 0,-1-3 0,-2 0 0,2 0 0,-3 0 0,-1 4 0,1-4 0,0 4 0,-5-4 0,4 0 0,-4 0 0,1 0 0,2 0 0,-2 0 0,-1 0 0,4 0 0,-4 0 0,0 0 0,4 0 0,-4 0 0,5 0 0,-5 0 0,4 0 0,-4 0 0,5 0 0,0 0 0,-1 0 0,-10 0 0,8 0 0,-9 0 0,12-4 0,0 4 0,0-7 0,-1 3 0,1-1 0,-5-2 0,4 3 0,-8-1 0,3-5 0,-4 4 0,0-6 0,0 3 0,0 1 0,0 0 0,0-4 0,4 3 0,-3-3 0,3 4 0,-4-4 0,4 3 0,-3-3 0,8 4 0,-8-1 0,7-2 0,-2 3 0,-3-10 0,5 8 0,-5-7 0,10 8 0,1-1 0,1-1 0,2 3 0,-3-2 0,4 3 0,1 0 0,-1 0 0,0 0 0,0-4 0,0 4 0,-1-4 0,-2 4 0,2-4 0,-3 3 0,4-3 0,-4 1 0,3 2 0,-2-3 0,-1 1 0,3 2 0,-6-7 0,2 4 0,-3-4 0,0-1 0,0 1 0,-5-1 0,-1 0 0,0 0 0,-15-13 0,11 5 0,-8-5 0,7 3 0,5 9 0,-1-9 0,2 9 0,4-2 0,1 3 0,3 1 0,-3 3 0,7-2 0,-3 2 0,4 1 0,-4-4 0,2 4 0,-2-5 0,0 1 0,3 0 0,-3 0 0,3-1 0,1 1 0,-1 4 0,1-4 0,0 7 0,0-2 0,3-1 0,-2 3 0,2-6 0,-4 2 0,1-6 0,-1 2 0,1-2 0,-1 2 0,1 1 0,3 0 0,-3 0 0,6 3 0,-6-2 0,3 2 0,0-3 0,-3 0 0,3-1 0,-1 1 0,-1 0 0,1 0 0,1-1 0,-2 5 0,5-4 0,-6 4 0,7-1 0,-7-2 0,6 6 0,-2-6 0,0 6 0,2-2 0,-5 0 0,5 2 0,-2-2 0,0 0 0,2 2 0,-2-2 0,0-3 0,-1 4 0,0-5 0,-3 8 0,7-5 0,-3 3 0,0-3 0,2 1 0,-6-1 0,6 0 0,-2 1 0,0-1 0,2 3 0,-3-3 0,1 1 0,2 2 0,-2-3 0,0 1 0,2 3 0,-2-3 0,0 0 0,2 2 0,-2-2 0,0 0 0,2 3 0,-5-3 0,5 0 0,-2 3 0,0-3 0,3 0 0,-3 2 0,3-5 0,0 6 0,0-3 0,0 0 0,0 3 0,-3-5 0,-1 1 0</inkml:trace>
</inkml:ink>
</file>

<file path=ppt/ink/ink8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4:51.446"/>
    </inkml:context>
    <inkml:brush xml:id="br0">
      <inkml:brushProperty name="width" value="0.35" units="cm"/>
      <inkml:brushProperty name="height" value="0.35" units="cm"/>
      <inkml:brushProperty name="color" value="#FFFFFF"/>
    </inkml:brush>
  </inkml:definitions>
  <inkml:trace contextRef="#ctx0" brushRef="#br0">995 1 24575,'-26'11'0,"6"-6"0,9 8 0,0-8 0,3 6 0,-6 0 0,2-3 0,-16 16 0,10-10 0,-10 8 0,12-8 0,5-6 0,-4 3 0,4-3 0,-4 3 0,-1-3 0,1 3 0,0-3 0,3 3 0,-3-3 0,3 3 0,1-3 0,-3 3 0,6-3 0,-7 2 0,4 1 0,-4-2 0,3 1 0,-2 1 0,2-3 0,-3 7 0,-5-6 0,4 5 0,-4-5 0,1 6 0,2-3 0,-7 5 0,8-5 0,-8 3 0,7-6 0,-2 6 0,3-6 0,1 2 0,4-4 0,-4 1 0,7-1 0,-6 0 0,3 3 0,0-2 0,1 2 0,3-3 0,0 0 0,0-1 0,4 4 0,0-3 0,3 6 0,0-6 0,6 3 0,3-2 0,6-1 0,5 1 0,1 4 0,4-3 0,0 4 0,5-1 0,-4-2 0,5 3 0,-1-5 0,-4 1 0,4-1 0,-4 1 0,-6-5 0,4 4 0,-7-7 0,2 3 0,-3-4 0,-1 0 0,0 0 0,1 0 0,-1 0 0,-4 0 0,4 0 0,-7 0 0,2 0 0,4 0 0,-6 0 0,6 0 0,-7 0 0,3 0 0,-3-6 0,0-3 0,-7-5 0,-1 3 0,-3-8 0,1 6 0,2-6 0,-2 3 0,3 1 0,0 0 0,0-1 0,0 5 0,0-4 0,0 8 0,0-4 0,0 1 0,0-1 0,0 0 0,0 0 0,0 1 0,0 2 0,0-3 0,0 1 0,0 2 0,0-4 0,0 4 0,0-2 0,0 1 0,0 1 0,0-5 0,0 6 0,0-3 0,0 0 0,-3 2 0,2 36 0,-2-11 0,3 27 0,0-20 0,0-3 0,0 4 0,0-4 0,0-1 0,0-5 0,0 0 0,0-3 0,0 2 0,0-6 0,0 6 0,0-6 0,0 3 0,-6-1 0,1-3 0,-2 3 0,1-3 0,2 0 0,-3 0 0,0 0 0,0 0 0,1 0 0,-1 0 0,0 0 0,0-1 0,0 1 0,0 0 0,0 0 0,0 0 0,0 0 0,-3 0 0,2 0 0,-3 0 0,4 0 0,0 0 0,1 0 0,-5 3 0,3-5 0,-2 5 0,3-7 0,0 4 0,0 0 0,0 0 0,-4 0 0,3 0 0,-2 0 0,3 0 0,0-3 0,-3 5 0,2-5 0,-2 3 0,4-1 0,-1 1 0,0-2 0,0 4 0,0-2 0,0 1 0,0 2 0,0-3 0,3-1 0,-5 4 0,5-2 0,-6 2 0,3-3 0,0 0 0,0 0 0,-4 0 0,4 0 0,-4-1 0,4 1 0,0 0 0,0 0 0,0 0 0,0 0 0,0 0 0,-2 0 0,4 0 0,-4-1 0,2 1 0,-1 0 0,-2 0 0,3 0 0,1 0 0,-1 0 0,-3-1 0,2 1 0,-2-3 0,3 2 0,0 1 0,1-2 0,-1 4 0,0-5 0,0 3 0,-3 0 0,2 0 0,-2-4 0,3 3 0,0-2 0,1 3 0,-4 0 0,2-3 0,-2 2 0,3-2 0,-3 3 0,2 0 0,-1-1 0,2 1 0,0-3 0,-2 5 0,4-5 0,-4 3 0,0-7 0,0-12 0,-1-5 0,7-4 0,3 8 0,0 6 0</inkml:trace>
</inkml:ink>
</file>

<file path=ppt/ink/ink8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01.468"/>
    </inkml:context>
    <inkml:brush xml:id="br0">
      <inkml:brushProperty name="width" value="0.35" units="cm"/>
      <inkml:brushProperty name="height" value="0.35" units="cm"/>
      <inkml:brushProperty name="color" value="#FFFFFF"/>
    </inkml:brush>
  </inkml:definitions>
  <inkml:trace contextRef="#ctx0" brushRef="#br0">833 1 24575,'-22'8'0,"-1"6"0,9-6 0,1 4 0,-1 2 0,4-6 0,-8 12 0,5-8 0,-9 11 0,17-11 0,-7 1 0,8-9 0,-3 2 0,0 1 0,0-3 0,0 5 0,1-5 0,-1 3 0,0-1 0,0 1 0,1 0 0,-4 0 0,5-1 0,-7 1 0,8 0 0,-6-3 0,0 4 0,3-6 0,-3 7 0,4-6 0,-1 1 0,-2 5 0,1-5 0,-1 6 0,5-4 0,-4 1 0,3-1 0,-4-2 0,2 5 0,1-8 0,-1 8 0,0-2 0,0-2 0,0 4 0,1-6 0,-4 4 0,3-3 0,-2 1 0,3-1 0,-1 3 0,-3 0 0,3-1 0,-3 1 0,3-3 0,1 2 0,-4-3 0,5 4 0,-7 0 0,8 0 0,-6-4 0,0 3 0,5-2 0,-4 3 0,2-3 0,0 2 0,-3-2 0,3 3 0,0-1 0,0 1 0,0 0 0,4 2 0,-3-1 0,2 2 0,-3-4 0,1 1 0,-1 0 0,1-1 0,-1 1 0,0-1 0,1 1 0,-1 0 0,0 0 0,-2-4 0,1 4 0,-2-4 0,4 4 0,-1 0 0,0 0 0,1-1 0,-1 1 0,1-1 0,-1 1 0,0 0 0,1 0 0,-1 0 0,0 0 0,-3-1 0,3-2 0,-3 2 0,4-2 0,-1 2 0,1 4 0,2-3 0,2 2 0</inkml:trace>
</inkml:ink>
</file>

<file path=ppt/ink/ink8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08.697"/>
    </inkml:context>
    <inkml:brush xml:id="br0">
      <inkml:brushProperty name="width" value="0.35" units="cm"/>
      <inkml:brushProperty name="height" value="0.35" units="cm"/>
      <inkml:brushProperty name="color" value="#FFFFFF"/>
    </inkml:brush>
  </inkml:definitions>
  <inkml:trace contextRef="#ctx0" brushRef="#br0">0 1141 24575,'15'23'0,"-2"-4"0,-2-8 0,-3-3 0,2 2 0,-2 1 0,9 7 0,-4-2 0,8 9 0,-10-13 0,-1 1 0,-3-6 0,0 4 0,0-3 0,0 2 0,4 4 0,-4-5 0,4 4 0,-4-2 0,0-3 0,-3 2 0,2-3 0,-2 0 0,3 0 0,0 3 0,0-2 0,-3 2 0,2-4 0,-2 1 0,2 0 0,1 0 0,0 0 0,0-1 0,-1 1 0,1 0 0,0 0 0,0 0 0,0 0 0,0 0 0,0 0 0,3-1 0,-3 1 0,3 0 0,-3-3 0,0 2 0,3-2 0,-2 3 0,2 0 0,-3 0 0,0 0 0,-1 0 0,1-1 0,0 1 0,0 0 0,4 1 0,-3-2 0,2-1 0,25 23 0,-21-19 0,22 20 0,-30-23 0,1 1 0,0 0 0,0 0 0,0 0 0,3 3 0,-2-5 0,2 4 0,0-5 0,-2 3 0,3 0 0,-4 0 0,0 0 0,-1 0 0,5 0 0,-3 0 0,2-3 0,-3 2 0,0-2 0,7 3 0,-2 1 0,2-1 0,1 1 0,-4-1 0,5 1 0,-1-1 0,-4 0 0,4 1 0,-4-1 0,5 1 0,-5-1 0,4 1 0,-4-1 0,4 1 0,-3-1 0,2 4 0,-2-3 0,3 3 0,-3-3 0,2-1 0,-6 0 0,6 1 0,-2-1 0,-1 0 0,4 1 0,-7-1 0,6 0 0,-6 0 0,6-2 0,-6 1 0,6-2 0,-2 3 0,-1 0 0,4 1 0,-4-1 0,1 1 0,2-1 0,-6-3 0,3 3 0,-1-7 0,-2 6 0,6-1 0,-6-2 0,6 4 0,-6-3 0,7 4 0,-1-1 0,-1-3 0,4 2 0,-9-5 0,6 6 0,-6-3 0,6 0 0,-6 2 0,7-5 0,-4 2 0,1 0 0,2-2 0,-2 2 0,-1 0 0,3-2 0,-2 5 0,3-5 0,0 6 0,1-6 0,-1 5 0,0-5 0,0 6 0,1-3 0,-1 1 0,-3 1 0,2-5 0,-3 5 0,1-5 0,9 6 0,-11-3 0,11 0 0,-13 2 0,6-5 0,-6 5 0,3-5 0,-1 5 0,2-5 0,-1 5 0,4-1 0,-4-1 0,1 2 0,2-5 0,-6 5 0,6-5 0,-2 5 0,-1-2 0,4 0 0,-4 3 0,1-7 0,2 7 0,-6-6 0,6 2 0,-6 1 0,2-4 0,1 7 0,-3-6 0,6 5 0,-6-5 0,6 6 0,-6-6 0,7 6 0,-8-6 0,11 5 0,-6-5 0,3 6 0,-5-7 0,1 7 0,-3-6 0,6 2 0,-6-3 0,3 3 0,-1-2 0,-2 2 0,3-3 0,-1 3 0,-2-2 0,7 3 0,-8-1 0,8-3 0,-7 4 0,6-4 0,-3 3 0,1-2 0,2 2 0,-6 0 0,7-2 0,-1 5 0,2-5 0,-1 3 0,-1-4 0,-2 0 0,-1 0 0,4 3 0,-8-2 0,8 2 0,-7-3 0,6 0 0,-6 0 0,6 0 0,-6 0 0,3 0 0,-1 0 0,2 4 0,-1-3 0,4 2 0,-7-3 0,6 0 0,-6 0 0,6 0 0,-6 0 0,6 0 0,-6 0 0,6 0 0,-6 0 0,7 0 0,-4 0 0,5 0 0,-1 0 0,-4 0 0,3 0 0,-2 0 0,3 0 0,1-3 0,-1-2 0,3-2 0,-2 3 0,3-3 0,-4 3 0,0 0 0,0-3 0,1 6 0,-1-5 0,0 5 0,3-9 0,-5 8 0,4-4 0,-9 3 0,6 2 0,-6-5 0,3 5 0,-4-5 0,3 2 0,-2 0 0,3-3 0,-4 4 0,0-4 0,3-1 0,-2 5 0,3-4 0,-1 3 0,-2-3 0,3 0 0,-1 0 0,-2 3 0,3-3 0,-1 3 0,-2-3 0,7-1 0,-8 1 0,11 0 0,-10 0 0,6 0 0,-7 3 0,4-3 0,-3 3 0,2 0 0,-3-2 0,4 2 0,-4-3 0,4 0 0,-4 3 0,4-2 0,-4 2 0,4-1 0,-4-1 0,0 3 0,3-5 0,-2 4 0,3-2 0,-4 2 0,0 0 0,3-5 0,-3 8 0,3-9 0,-3 7 0,0-4 0,0 0 0,3 0 0,-2 0 0,2 0 0,-4 0 0,7-6 0,-4 5 0,10-8 0,-1-7 0,22-19 0,-11 9 0,12-9 0,0 3 0,-16 20 0,31-32 0,-49 47 0,30-21 0,16-8 0,-7 2 0,6-5 0,-43 28 0,9-7 0,-10 5 0,6 1 0,-6-2 0,7 4 0,-7 0 0,2 0 0,1-1 0,-3 1 0,2 0 0,-3 0 0,4-3 0,-4 2 0,4-3 0,0 1 0,-4 2 0,8-3 0,-7 0 0,3 3 0,0-3 0,-3 1 0,2 1 0,1-2 0,-3 4 0,3 0 0,-4-3 0,0 2 0,0-3 0,0 4 0,0-3 0,0 2 0,1-3 0,-1 4 0,-1 0 0,4 0 0,-2 1 0,2-1 0,-6 0 0,2 0 0,1-3 0,1 5 0,-2-4 0,4 2 0,-6 0 0,6-3 0,-6 3 0,5 0 0,-4-3 0,5 2 0,-6-2 0,2 3 0,-3 1 0,4-1 0,0 0 0,0-3 0,0 2 0,-3-2 0,2 3 0,-2-3 0,0 2 0,2-2 0,-5-1 0,5 4 0,-2-8 0,3 8 0,-3-8 0,2 7 0,-1-6 0,-2 6 0,4-2 0,-3-1 0,0 3 0,2-2 0,-5-1 0,5 3 0,-2-3 0,0 1 0,2 2 0,-5-3 0,5 4 0,-5-3 0,5 2 0,-5-6 0,5 6 0,-5-7 0,5 4 0,-5-1 0,6-2 0,-6 2 0,5 1 0,-5-3 0,5 2 0,-5-3 0,6 3 0,-7-2 0,6 6 0,-5-6 0,2 6 0,1-7 0,-3 8 0,2-4 0,0 1 0,-2 2 0,2-5 0,0 5 0,-2-3 0,2 1 0,0-2 0,-2 0 0,2-2 0,1 3 0,-3-1 0,2-2 0,0 6 0,-2-6 0,2 6 0,0-7 0,-2 8 0,6-4 0,-7 0 0,3 3 0,0-2 0,-2 0 0,5 2 0,-5-2 0,2 0 0,0 3 0,-2-3 0,2-4 0,0 5 0,-2-4 0,2 6 0,-3-4 0,3 3 0,-2-5 0,2 5 0,-3-2 0,3 0 0,-2 2 0,2-5 0,-3 5 0,0-3 0,3 1 0,-2 3 0,2-7 0,-3 6 0,0-2 0,0 0 0,0 2 0,0-5 0,0 5 0,0-2 0,0 0 0,0 3 0,0-6 0,0 6 0,0-3 0,0 1 0,0 1 0,0-4 0,0 1 0,0-3 0,0-1 0,0-5 0,0-1 0,-8-9 0,6 15 0,-7-1 0</inkml:trace>
</inkml:ink>
</file>

<file path=ppt/ink/ink8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13.551"/>
    </inkml:context>
    <inkml:brush xml:id="br0">
      <inkml:brushProperty name="width" value="0.35" units="cm"/>
      <inkml:brushProperty name="height" value="0.35" units="cm"/>
      <inkml:brushProperty name="color" value="#FFFFFF"/>
    </inkml:brush>
  </inkml:definitions>
  <inkml:trace contextRef="#ctx0" brushRef="#br0">1 0 24575,'0'37'0,"3"-6"0,2-7 0,6-11 0,-6 6 0,6-8 0,-4 5 0,12 9 0,1 0 0,17 22 0,-15-19 0,7 7 0,-17-20 0,-1 1 0,0-1 0,-3-3 0,3 2 0,-1-3 0,-1 5 0,5-1 0,-5 0 0,2 0 0,0-3 0,-3 3 0,7-7 0,-7 7 0,6-7 0,-5 6 0,2-5 0,0 5 0,-4-6 0,8 6 0,-7-6 0,3 6 0,-1-6 0,-1 7 0,1-7 0,1 3 0,-2 0 0,1-3 0,1 6 0,-3-6 0,3 6 0,0-5 0,-3 5 0,10 1 0,-9 1 0,9 3 0,-10-7 0,3 2 0,0-6 0,-3 7 0,3-7 0,0 6 0,-3-2 0,3-1 0,0 4 0,-3-4 0,3 4 0,0-3 0,-3 2 0,7-2 0,-6 8 0,5-4 0,-2 4 0,4-1 0,0-2 0,-3 7 0,7-2 0,-6 3 0,8 6 0,-5-4 0,5 4 0,4 10 0,-2-10 0,0 10 0,-7-16 0,0 0 0,0 0 0,-1 0 0,-3 0 0,3-4 0,-7 3 0,2-3 0,0-1 0,-2 0 0,2-1 0,-3-2 0,0 2 0,3-4 0,-2 1 0,2-1 0,-4 0 0,1 0 0,-1 0 0,1 1 0,3-1 0,-2 5 0,2-4 0,0 4 0,-2-5 0,2 0 0,1 5 0,-4-4 0,4 4 0,-4-5 0,3 1 0,-3 3 0,4-2 0,2 9 0,-4-9 0,4 9 0,-3-9 0,-2 2 0,2-3 0,-3 3 0,3-2 0,-2 2 0,2-4 0,-3 1 0,-1-5 0,4 3 0,-3-6 0,3 7 0,-4-8 0,0 8 0,0-4 0,1 1 0,-1 2 0,1-2 0,-1-1 0,4 7 0,-4-10 0,4 6 0,-4-3 0,0-4 0,0 8 0,0-7 0,4 6 0,-3-2 0,7 3 0,-7 0 0,7 0 0,-7 1 0,7-1 0,-3 0 0,-1 0 0,4 1 0,-3-1 0,3 0 0,0 1 0,1-1 0,-1 0 0,0 0 0,1 5 0,0-3 0,0 7 0,0-8 0,-3 8 0,2-3 0,-3 0 0,5 3 0,-5-8 0,3 8 0,-6-8 0,7 8 0,-7-7 0,6 7 0,-6-8 0,7 8 0,-7-3 0,10 11 0,-10-10 0,6 5 0,-7-12 0,3 1 0,-3-1 0,3 0 0,0 0 0,-2 1 0,2-1 0,0 0 0,-3 0 0,3 1 0,0-1 0,-2 0 0,5 0 0,-5 1 0,1-5 0,1 4 0,-3-4 0,7 1 0,-7 2 0,7-2 0,-7 4 0,7-5 0,-7 4 0,7-3 0,-7 3 0,10 4 0,-5-3 0,2 3 0,-4-8 0,0 3 0,0-2 0,1 0 0,2 2 0,-6-3 0,7 5 0,-7-5 0,3 4 0,-1-4 0,-1 1 0,2 2 0,-4-2 0,0-1 0,1 3 0,2-6 0,-1 7 0,1-7 0,-2 6 0,-1-6 0,0 6 0,1-2 0,-1-1 0,1 4 0,-1-4 0,1 5 0,-1-5 0,0 3 0,1-2 0,2 6 0,-1-2 0,2 3 0,-4-4 0,1 5 0,0-4 0,0 8 0,0-8 0,0 8 0,0-7 0,0 2 0,0 1 0,-1-4 0,1 4 0,0-5 0,-4-4 0,3 4 0,-3-4 0,4 5 0,-1-5 0,4 10 0,-3-8 0,3 9 0,-3-6 0,-1-5 0,1 4 0,-1-4 0,0 1 0,-2 2 0,1-2 0,-2-1 0,3 4 0,1-4 0,-1 4 0,1 1 0,0-1 0,-1 0 0,5 5 0,-3-4 0,2 4 0,-3-5 0,0 1 0,-1-1 0,1 0 0,0 0 0,-1 1 0,1-1 0,0 0 0,-1 0 0,1 1 0,-1-1 0,1 0 0,0 1 0,-1-1 0,1 0 0,0 0 0,-1 1 0,1-1 0,0 0 0,-4-3 0,3 2 0,-4-6 0,2 6 0,1-6 0,-2 7 0,3-8 0,0 14 0,-3-11 0,3 11 0,-3-13 0,0 6 0,2-6 0,-5 7 0,5-8 0,-5 4 0,5-4 0,-5 3 0,5-2 0,-5 3 0,5-4 0,-5 3 0,5-2 0,-2 3 0,0 0 0,2-4 0,-6 8 0,7-7 0,-7 2 0,6-3 0,-5 3 0,5-2 0,-5 1 0,2 2 0,-3 5 0,0-7 0,0 2 0</inkml:trace>
</inkml:ink>
</file>

<file path=ppt/ink/ink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6:38.034"/>
    </inkml:context>
    <inkml:brush xml:id="br0">
      <inkml:brushProperty name="width" value="0.28222" units="cm"/>
      <inkml:brushProperty name="height" value="0.28222" units="cm"/>
      <inkml:brushProperty name="color" value="#FFFFFF"/>
    </inkml:brush>
  </inkml:definitions>
  <inkml:trace contextRef="#ctx0" brushRef="#br0">0 1364 24575,'32'0'0,"-2"0"0,-12 0 0,8 0 0,-6 0 0,13 0 0,35 0 0,-30 0 0,0 0 0,-2 0 0,-17 0 0,12 0 0,-12 0 0,6 0 0,-5 0 0,2 0 0,-4 0 0,-3 0 0,2-5 0,-3 4 0,1-4 0,1 5 0,-6-3 0,1 3 0,0-2 0,0 0 0,1 1 0,-2-4 0,1 4 0,0-3 0,3 4 0,-2-4 0,3 0 0,-1 2 0,-2-3 0,1 5 0,2-6 0,0 6 0,0-5 0,3 2 0,-7-2 0,6 2 0,-1-2 0,-1 2 0,3-3 0,-4 1 0,1 2 0,2-1 0,-1 0 0,7-1 0,-7 0 0,6-1 0,-10 1 0,6-1 0,-6-1 0,5 1 0,-5-4 0,5 4 0,-2-4 0,-1 4 0,4-4 0,-2 1 0,1 0 0,-2 0 0,2 2 0,7-5 0,-5 5 0,8-7 0,-9 8 0,0-2 0,-3 3 0,2-3 0,-4 2 0,5-2 0,-7 3 0,3 0 0,0-1 0,-4 1 0,6-1 0,-9 2 0,10-1 0,-8 0 0,5-1 0,-3 1 0,0-2 0,0 1 0,1-2 0,-2 1 0,2 1 0,-2 0 0,1 0 0,1-1 0,-2 1 0,2-2 0,-1 3 0,-3 0 0,3 0 0,-3 0 0,0 1 0,3-1 0,-3 0 0,1 0 0,1 2 0,-4-1 0,4 1 0,-4 1 0,4-3 0,-1 2 0,-2 0 0,9-4 0,-6 6 0,3-6 0,-3 5 0,-1 0 0,2-3 0,-3 3 0,3-3 0,-4-1 0,4 4 0,1-3 0,-1 2 0,0-2 0,3-1 0,-5 1 0,5 0 0,-6 0 0,4 1 0,-2-1 0,-2-3 0,4 2 0,-4-1 0,0 2 0,0 0 0,-1 0 0,-1 0 0,2 0 0,-3 1 0,1 2 0,0-4 0,0 2 0,1 0 0,-2-1 0,0 3 0,0-2 0,1-1 0,-2-2 0,1 1 0,1 0 0,-2 1 0,1 1 0,0 0 0,0-1 0,0 0 0,0 1 0,0-1 0,1 0 0,-2 0 0,6 1 0,-4-1 0,7 2 0,-8-1 0,6 1 0,-3 1 0,3-2 0,0 1 0,1-2 0,-2-1 0,-1 1 0,1 3 0,-2-3 0,4 4 0,-5-3 0,5 1 0,-7 1 0,3 0 0,-3-1 0,2 3 0,-1-4 0,1 3 0,0-3 0,-2 3 0,3 0 0,-1-1 0,-1 2 0,0-4 0,2 3 0,-2-3 0,0 3 0,-1-3 0,1 1 0,-1-2 0,2 1 0,-1 0 0,0-1 0,-1 2 0,0-1 0,1-1 0,-2 0 0,1-1 0,1 3 0,-1-3 0,-1 3 0,0-3 0,0 1 0,-2 0 0,3-2 0,-2 2 0,1-2 0,-1 2 0,3 1 0,-2-2 0,1-2 0,1 1 0,-2-1 0,2 4 0,-3-1 0,3-2 0,-2 2 0,1-1 0,-1 2 0,-1-1 0,0-2 0,0 1 0,-2 0 0,4 1 0,-2-2 0,0 1 0,1 0 0,-3-1 0,0 2 0,2-5 0,-3 5 0,3-5 0,0 5 0,-3-5 0,5 5 0,-5-2 0,4-2 0,-3 3 0,1-3 0,-2 2 0,3 1 0,-2-1 0,1 0 0,-2 3 0,0-4 0,2 1 0,-1 2 0,2-3 0,-3-1 0,2 3 0,-2-3 0,1 3 0,3 1 0,-4-6 0,2 7 0,-2-7 0,0 4 0,0-1 0,0-1 0,0 1 0,0-2 0,0-1 0,0 3 0,0-1 0,0 3 0,0 0 0,0-1 0,0 2 0,0-4 0,0 4 0,0-2 0,0 1 0,0 0 0,0-2 0,0 5 0,0-4 0,-2 1 0,-1 1 0,-1-2 0</inkml:trace>
</inkml:ink>
</file>

<file path=ppt/ink/ink9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16.939"/>
    </inkml:context>
    <inkml:brush xml:id="br0">
      <inkml:brushProperty name="width" value="0.35" units="cm"/>
      <inkml:brushProperty name="height" value="0.35" units="cm"/>
      <inkml:brushProperty name="color" value="#FFFFFF"/>
    </inkml:brush>
  </inkml:definitions>
  <inkml:trace contextRef="#ctx0" brushRef="#br0">0 134 24575,'19'22'0,"-3"-3"0,-9-9 0,0-2 0,0 3 0,0-4 0,0 0 0,9 12 0,-6-8 0,9 11 0,-11-14 0,5 5 0,-6-5 0,3 2 0,-3-3 0,0 0 0,0-1 0,0 1 0,0 3 0,0-2 0,0 2 0,-1-3 0,1-1 0,0 1 0,0 3 0,0-6 0,-1 9 0,1-12 0,0 11 0,0-7 0,0 5 0,0-3 0,0-3 0,3 5 0,-6-4 0,6 5 0,-7-4 0,4 1 0,3 0 0,-2 0 0,2-3 0,-3 2 0,0-2 0,0 3 0,0 0 0,-1 0 0,4 0 0,-2-1 0,6 2 0,-6-1 0,2 0 0,-3 0 0,4-3 0,-3 2 0,2-2 0,-3 3 0,4-4 0,-3 3 0,2-2 0,-3 0 0,0 2 0,3-2 0,1 3 0,0-3 0,0 3 0,-4-3 0,0-1 0,3 3 0,-3-5 0,3 5 0,1-5 0,-3 2 0,2 0 0,1-2 0,0 2 0,1-3 0,2 4 0,-2-4 0,-1 4 0,4-1 0,-4-2 0,1 2 0,2 1 0,-6-3 0,3 5 0,-1-5 0,-2 2 0,3-3 0,2 3 0,-4-2 0,5 3 0,-7-4 0,3 0 0,1 0 0,0 0 0,0 0 0,-5 0 0,4 0 0,1 0 0,-1 0 0,0 0 0,0 0 0,-2 0 0,5 0 0,-6 0 0,3 0 0,0 0 0,-2 0 0,5 0 0,-5 0 0,2 0 0,0 0 0,-2 0 0,3-3 0,-1 2 0,-2-5 0,7 5 0,-8-5 0,4 5 0,0-2 0,-4 0 0,4 2 0,3-5 0,-6 5 0,6-6 0,-7 7 0,0-4 0,6 1 0,-5 3 0,5-6 0,-6 5 0,0-8 0,0 4 0,-1-1 0,4-3 0,-5 4 0,4-5 0,-5 3 0,3 0 0,0-3 0,-1 6 0,1-9 0,0 9 0,-3-6 0,2 3 0,-2-3 0,0 2 0,2-2 0,-2 3 0,0 1 0,2-5 0,-5 3 0,5-3 0,-2 5 0,0-1 0,6-7 0,-9 5 0,9-4 0,-6 6 0,0-4 0,2 3 0,-2-6 0,3 6 0,-3-3 0,2 5 0,-2-4 0,3 2 0,-3-2 0,2 3 0,-5-3 0,2 2 0,0-2 0,1 4 0,2-4 0,-2 2 0,2-1 0,-5-1 0,5 2 0,-5-1 0,2-1 0,0 3 0,-2-6 0,2 6 0,-3-3 0,0 1 0,3 1 0,-2-4 0,2 4 0,-3-2 0,0 0 0,0 3 0,3-3 0,-2 0 0,2 2 0,-3-4 0,0 4 0,0-2 0,0 1 0,0 2 0,0-6 0,-3 6 0,-1-6 0,-7 1 0,6 4 0,-2 1 0</inkml:trace>
</inkml:ink>
</file>

<file path=ppt/ink/ink9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21.416"/>
    </inkml:context>
    <inkml:brush xml:id="br0">
      <inkml:brushProperty name="width" value="0.35" units="cm"/>
      <inkml:brushProperty name="height" value="0.35" units="cm"/>
      <inkml:brushProperty name="color" value="#FFFFFF"/>
    </inkml:brush>
  </inkml:definitions>
  <inkml:trace contextRef="#ctx0" brushRef="#br0">0 944 24575,'30'4'0,"-6"0"0,-10 1 0,-6 4 0,6-3 0,-5 1 0,5 0 0,10 4 0,-9-6 0,9 8 0,-17-12 0,0 5 0,3-5 0,-2 5 0,2-5 0,7 5 0,-7-2 0,6 3 0,-9-3 0,0 2 0,4-2 0,-4 0 0,4 2 0,-4-5 0,0 5 0,3-2 0,-2 0 0,1 2 0,2-5 0,-3 5 0,3-5 0,-5 5 0,4-2 0,-2-1 0,2 4 0,0-4 0,-2 1 0,2 2 0,0-5 0,-3 2 0,3 0 0,0-2 0,-2 5 0,2-5 0,0 5 0,-2-5 0,3 3 0,3-1 0,-6 1 0,6-1 0,-3 4 0,-4-6 0,4 5 0,0-5 0,-4 2 0,4 0 0,3-2 0,-6 2 0,6 0 0,-7-2 0,0 2 0,3-3 0,-2 3 0,3-2 0,-1 5 0,-3-5 0,3 2 0,0-3 0,-2 0 0,5 0 0,-5 3 0,2-3 0,0 3 0,-3-3 0,6 0 0,-5 0 0,2 4 0,0-4 0,-3 3 0,6-3 0,-5 3 0,2-2 0,0 2 0,-2-3 0,5 3 0,-6-2 0,3 2 0,0-3 0,-2 0 0,4 0 0,-4 0 0,2 0 0,2 0 0,-4 0 0,8 0 0,-9 0 0,3 0 0,3 0 0,19 0 0,-10 0 0,34 0 0,-37 0 0,19 0 0,-15-3 0,-7 2 0,60-17 0,-51 10 0,39-8 0,-49 12 0,-4 1 0,1 2 0,2-2 0,-6-1 0,6 4 0,-6-3 0,6-1 0,-6 3 0,7-5 0,-8 5 0,4-3 0,0 1 0,-4-1 0,11-3 0,-10 3 0,10-2 0,-10 2 0,2-1 0,1-1 0,-3 2 0,2 0 0,-3-2 0,4 2 0,-3-3 0,2 2 0,-3-1 0,0 3 0,0-4 0,0 0 0,3-3 0,-2 2 0,2-2 0,-4 3 0,1 3 0,3-5 0,-5 5 0,4-6 0,-5 0 0,3 5 0,0-7 0,-3 7 0,2-5 0,-2 0 0,-1 3 0,4-3 0,-4 0 0,1 2 0,-1-2 0,0 0 0,2-1 0,-2 0 0,4 1 0,-6-1 0,5 3 0,-5-3 0,5 1 0,-5 2 0,2-6 0,0 6 0,-2-7 0,2 4 0,0-1 0,-2-2 0,5 2 0,-5 1 0,6-3 0,-6 2 0,2 0 0,1-2 0,-3 6 0,5-2 0,-5-1 0,2 3 0,0-2 0,-2 0 0,5 2 0,-5-2 0,2 0 0,-3 2 0,3-2 0,-3 0 0,4 3 0,-4-6 0,3 5 0,-3-2 0,6 0 0,-5 3 0,2-3 0,0 0 0,-2 3 0,2-6 0,-3 6 0,0-3 0,0 0 0,0 2 0,3-2 0,-2 0 0,2 3 0,-3-6 0,0 5 0,0-12 0,0 10 0,0-11 0,0 9 0,0-3 0,0 0 0,0 0 0,0-1 0,0 5 0,0-4 0,0 4 0,0-1 0,3 2 0,-2-1 0,2 3 0,-3-2 0,0 0 0,0 2 0,0-5 0,0 1 0,0 2 0,0-1 0,3 4 0,-2-3 0,2 2 0,-3-4 0,3 4 0,-3-1 0,3-5 0,-3 6 0,0-9 0,0 12 0,0-2 0</inkml:trace>
</inkml:ink>
</file>

<file path=ppt/ink/ink9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26.228"/>
    </inkml:context>
    <inkml:brush xml:id="br0">
      <inkml:brushProperty name="width" value="0.35" units="cm"/>
      <inkml:brushProperty name="height" value="0.35" units="cm"/>
      <inkml:brushProperty name="color" value="#FFFFFF"/>
    </inkml:brush>
  </inkml:definitions>
  <inkml:trace contextRef="#ctx0" brushRef="#br0">1 434 24575,'23'27'0,"1"3"0,-12-17 0,0 7 0,3-5 0,-3 0 0,5 6 0,6 3 0,-7-1 0,2-5 0,-7-4 0,-4-6 0,8 7 0,-7-8 0,6 11 0,-7-10 0,4 6 0,-1-7 0,-2 4 0,3-3 0,-4 3 0,0-4 0,0 0 0,0-1 0,0 1 0,0 0 0,0 0 0,-1 0 0,1 0 0,0 0 0,0 0 0,0 0 0,0-1 0,0 1 0,0 0 0,3 0 0,-3 0 0,3 0 0,-3 0 0,0 0 0,0 0 0,4 0 0,-3 0 0,2 0 0,1 0 0,-3 0 0,3 4 0,-1-3 0,-2 3 0,7 0 0,-7-3 0,6 3 0,-6 0 0,6-3 0,-5 3 0,1-4 0,1 4 0,-3-4 0,2 4 0,1-4 0,-3 0 0,6 1 0,-6-1 0,6 0 0,-6 0 0,6 4 0,-2-3 0,-1 3 0,4-4 0,-8 0 0,11 4 0,-10-3 0,10 2 0,-10-3 0,6 1 0,-6-1 0,6-3 0,-6 2 0,6-2 0,-2 4 0,3-1 0,-3 1 0,2-1 0,-2-3 0,3 3 0,0-3 0,5 4 0,-4 0 0,4-4 0,-1 3 0,-2-2 0,6 3 0,-6-4 0,7 4 0,-8-4 0,8 4 0,-3 0 0,0 0 0,-2 0 0,1-3 0,-4 1 0,4-5 0,2 6 0,-5-6 0,5 6 0,-7-6 0,1 2 0,-1 0 0,0-2 0,1 3 0,-1-4 0,0 3 0,-3-2 0,2 6 0,-2-7 0,3 7 0,-4-6 0,4 2 0,-7 1 0,6-4 0,-6 3 0,6 1 0,-6-3 0,3 5 0,-1-5 0,-2 2 0,3 0 0,-1-2 0,-2 5 0,3-5 0,-1 5 0,-2-5 0,10 5 0,-10-2 0,6 0 0,-7 2 0,0-5 0,3 2 0,-2 0 0,3-2 0,-1 5 0,-3-5 0,3 2 0,0 0 0,-2-2 0,2 5 0,0-2 0,-3-1 0,3 1 0,0-1 0,-2-3 0,2 3 0,0 0 0,-2 1 0,5 0 0,-5-1 0,3 0 0,-1-2 0,-2 5 0,3-5 0,-1 2 0,-2 0 0,3-2 0,0 2 0,-4 0 0,4-2 0,0 2 0,-4-3 0,8 3 0,-4-2 0,1 2 0,2-3 0,-2 0 0,-1 0 0,4 0 0,-4 0 0,1 0 0,2 0 0,-2 0 0,-1 0 0,4 0 0,-4 0 0,1 0 0,2 0 0,-3 0 0,1 0 0,2 0 0,-2 0 0,3 0 0,-3 0 0,2 0 0,1 0 0,-3 0 0,6 0 0,-11 0 0,4 0 0,0 0 0,-4 0 0,4 0 0,-1-3 0,-2 3 0,2-7 0,0 7 0,-2-3 0,3 0 0,-1 2 0,-3-5 0,3 5 0,-3-5 0,3 2 0,-2-3 0,5 3 0,-5-2 0,3 2 0,0 0 0,-4-2 0,4 2 0,-4-2 0,4 2 0,-4-2 0,4 5 0,-4-5 0,4 2 0,-4-3 0,4-1 0,0 1 0,-4 3 0,8-3 0,-7 3 0,6-3 0,-6 0 0,2 3 0,1-3 0,-3 3 0,6-3 0,-6 0 0,6-1 0,-5-2 0,5 1 0,-6-2 0,6 4 0,-5-4 0,5 3 0,-6-3 0,6 0 0,-6 3 0,7-3 0,-7 1 0,6 1 0,-6-2 0,7 4 0,-7-4 0,3 3 0,-1-6 0,-2 6 0,7-7 0,-8 8 0,11-11 0,-9 6 0,5-3 0,-3 1 0,-4 6 0,4-6 0,0 2 0,-3 1 0,3-4 0,-4 4 0,1-1 0,-1-2 0,0 6 0,1-6 0,-1 6 0,0-2 0,0-1 0,0 3 0,-3-3 0,2 5 0,-5-5 0,5 3 0,-2-3 0,0 5 0,2-5 0,-1-1 0,-1 1 0,3-4 0,-3 1 0,3 2 0,-3-6 0,3 10 0,-7-2 0,6 3 0,-5-4 0,2 3 0,0-2 0,1-4 0,0 5 0,0-8 0,-1 9 0,-2-6 0,5 6 0,-5-6 0,2 6 0,0-7 0,-2 4 0,2-1 0,0 2 0,-2-1 0,5 3 0,-5-6 0,2 6 0,0-3 0,-2 2 0,2-3 0,0 1 0,-2 1 0,2 3 0,-3-4 0,3 3 0,-2-2 0,5 0 0,-5 2 0,2-2 0,0 0 0,-3 2 0,4-2 0,-4 0 0,3 3 0,-3-3 0,3 0 0,-3-2 0,0 2 0,3-1 0,-2 4 0,2-7 0,-3 6 0,0-6 0,0 7 0,3 0 0,-2-3 0,2 3 0,-3-6 0,0 1 0,0 1 0,3 1 0,-2 3 0,2-3 0,-3-1 0,0 0 0,0 1 0,0 0 0,0 3 0,0-6 0,3 5 0,-2-1 0,2-1 0,-3 2 0,0-4 0,0 4 0,0-2 0,0 1 0,0 1 0,0-4 0,0 5 0,0-3 0,0 1 0,0 1 0,0-6 0,0 3 0,0 2 0,0 2 0</inkml:trace>
</inkml:ink>
</file>

<file path=ppt/ink/ink9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31.090"/>
    </inkml:context>
    <inkml:brush xml:id="br0">
      <inkml:brushProperty name="width" value="0.35" units="cm"/>
      <inkml:brushProperty name="height" value="0.35" units="cm"/>
      <inkml:brushProperty name="color" value="#FFFFFF"/>
    </inkml:brush>
  </inkml:definitions>
  <inkml:trace contextRef="#ctx0" brushRef="#br0">1 493 24575,'11'28'0,"1"3"0,5-15 0,-3 5 0,8-3 0,-10-2 0,20 19 0,-9-7 0,7 9 0,-9-15 0,-5-3 0,0-3 0,-1-1 0,-1-1 0,-6-6 0,6 3 0,-2 0 0,3-3 0,-3 6 0,2-5 0,-5 5 0,1-6 0,1 3 0,-3-4 0,3 1 0,-1-1 0,-2 0 0,3 0 0,-4 4 0,0-4 0,0 4 0,0-4 0,4 0 0,-3 4 0,3-3 0,0 6 0,-4-6 0,4 7 0,0-7 0,-2 6 0,5 1 0,-6-2 0,6 4 0,-6-9 0,3 6 0,-4-6 0,0 6 0,0-6 0,1 7 0,-1-8 0,0 4 0,0 0 0,0-4 0,0 4 0,-3-4 0,2 0 0,1 3 0,1-3 0,2 3 0,-7-3 0,4 0 0,-1 3 0,2-2 0,2 2 0,-3-7 0,0 4 0,4-3 0,-4 3 0,8 0 0,-7 0 0,6 1 0,-3-1 0,1 0 0,2 4 0,-2-2 0,-1 1 0,4-2 0,-4-1 0,1 0 0,2 4 0,-2-2 0,-1 1 0,4-2 0,-7-1 0,6 0 0,-6 0 0,6 1 0,-6-1 0,6 0 0,-6 0 0,6 1 0,-6-4 0,7 3 0,-4-3 0,4 3 0,-3 1 0,2-4 0,-2 2 0,3-1 0,0 2 0,1 1 0,-1 0 0,-4-4 0,11 6 0,-9-8 0,9 8 0,-11-6 0,4 0 0,-7 2 0,6-5 0,-3 5 0,1-5 0,2 6 0,-6-6 0,6 5 0,-6-5 0,3 6 0,-1-7 0,2 7 0,-1-3 0,0 0 0,0 2 0,-4-5 0,8 6 0,-7-6 0,6 6 0,-6-6 0,6 5 0,-6-5 0,3 6 0,-1-7 0,-2 7 0,6-7 0,-6 6 0,7-1 0,3 2 0,-5-3 0,8 3 0,-9-3 0,3 0 0,-3 3 0,2-6 0,5 9 0,-6-9 0,8 9 0,-10-5 0,1-1 0,2-1 0,-6 0 0,7-2 0,-8 5 0,8-5 0,-7 2 0,6 1 0,-3-4 0,1 4 0,2-1 0,-2-2 0,0 2 0,2 1 0,-6-3 0,6 2 0,-2 0 0,-1-2 0,3 3 0,-6-4 0,6 0 0,-2 3 0,3-2 0,0 2 0,-3 0 0,2-2 0,-3 2 0,1 0 0,-1-2 0,-1 2 0,-2-3 0,3 3 0,-1-2 0,-3 2 0,6 0 0,-1-2 0,-1 2 0,-1-3 0,1 0 0,-3 0 0,2 3 0,4-2 0,-5 2 0,4-3 0,-2 0 0,-3 3 0,6-2 0,-6 2 0,6-3 0,-2 0 0,3 0 0,0 0 0,1 0 0,-1 0 0,0 0 0,0 0 0,1 0 0,-1 0 0,0 0 0,0 0 0,1 0 0,-1 0 0,-4 0 0,4 0 0,-4 0 0,4 0 0,-3 0 0,2 0 0,-2 0 0,-1-3 0,0 2 0,0-2 0,-4 3 0,4 0 0,0 0 0,-4-3 0,4 2 0,-1-2 0,1-1 0,0 4 0,0-4 0,-4 1 0,7 2 0,-6-2 0,6 0 0,-7 2 0,0-5 0,6 2 0,-4-3 0,8 3 0,-5-2 0,3 1 0,0-2 0,1-1 0,-1 0 0,0 1 0,0-4 0,5 2 0,-4-6 0,9 6 0,-5-6 0,1 3 0,3-5 0,-7 2 0,7-2 0,-4 1 0,6-5 0,-5 7 0,6-12 0,-11 17 0,5-11 0,-6 8 0,7-3 0,-5-1 0,1 5 0,-3 0 0,-7 4 0,6-1 0,-6 1 0,2 0 0,-3 0 0,4 0 0,-3 0 0,2 3 0,-3-2 0,0 2 0,0-3 0,0 0 0,3 0 0,-3 0 0,3 4 0,-3-4 0,3 4 0,-2-4 0,2 3 0,-3-2 0,0 2 0,0-3 0,0 0 0,-1 0 0,4 0 0,-5 0 0,4 0 0,-5 1 0,3-1 0,0 0 0,0-4 0,0 3 0,1-6 0,-1 2 0,0 1 0,1-4 0,2 4 0,2-4 0,0-1 0,3 1 0,-3 0 0,3-5 0,-3 4 0,3-4 0,-2 1 0,-1 2 0,3-2 0,-6-1 0,2 4 0,0-4 0,-2 5 0,2-1 0,-4 5 0,1-4 0,-1 4 0,1-1 0,2-5 0,-2 8 0,-1-8 0,-1 9 0,-5-3 0,5 1 0,-2 2 0,0-2 0,3 3 0,-7-4 0,6 3 0,-5-2 0,5 3 0,-1-7 0,-2 5 0,4-4 0,-6 2 0,5 3 0,-5-6 0,5 6 0,-5-6 0,5 6 0,-6-3 0,7 1 0,-3-2 0,0 1 0,3-4 0,-3 7 0,0-6 0,3 2 0,-3 1 0,3-3 0,-3 2 0,2 1 0,-1-4 0,2 1 0,0-5 0,0 3 0,1-1 0,-4 5 0,2 1 0,-2-4 0,3 4 0,-2-1 0,2-2 0,-3 2 0,3-3 0,1 0 0,-1 3 0,1-2 0,-1 2 0,-3-3 0,3 3 0,-3-2 0,3 2 0,1 1 0,-4 0 0,2 1 0,-2 2 0,0-7 0,3 8 0,-4-4 0,4-3 0,-3 6 0,3-10 0,-7 10 0,7-6 0,-3 3 0,4-4 0,-4 4 0,2 1 0,-5 3 0,8-9 0,-8 7 0,6-7 0,-7 7 0,0 4 0,0 0 0</inkml:trace>
</inkml:ink>
</file>

<file path=ppt/ink/ink9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5T17:45:35.212"/>
    </inkml:context>
    <inkml:brush xml:id="br0">
      <inkml:brushProperty name="width" value="0.35" units="cm"/>
      <inkml:brushProperty name="height" value="0.35" units="cm"/>
      <inkml:brushProperty name="color" value="#FFFFFF"/>
    </inkml:brush>
  </inkml:definitions>
  <inkml:trace contextRef="#ctx0" brushRef="#br0">1168 1292 24575,'-27'0'0,"2"0"0,10-3 0,0-2 0,3-6 0,-7 3 0,6 0 0,-16-12 0,9 10 0,-2-11 0,8 11 0,4 2 0,-1-2 0,-1 2 0,-1-2 0,5 3 0,-6 0 0,6 0 0,-3-1 0,1-2 0,-5-2 0,3 1 0,-2 0 0,7 4 0,0 0 0,0-3 0,0 2 0,0-3 0,-1 1 0,1 2 0,0-7 0,0 8 0,3-4 0,-3 0 0,3 0 0,-3-1 0,-1-2 0,4 6 0,-3-6 0,3 2 0,-3 1 0,3-4 0,-3 4 0,3-1 0,-3-2 0,3 2 0,-3 1 0,3-4 0,-3 4 0,0-1 0,-1-2 0,1 2 0,3-3 0,-3 3 0,-1-9 0,4 12 0,-6-12 0,9 13 0,-6-7 0,6 8 0,-5-4 0,5 0 0,-5 4 0,2-4 0,0 0 0,-2 3 0,5-6 0,-5 6 0,5-6 0,-5 6 0,5-6 0,-5 6 0,6-3 0,-7 1 0,6 2 0,-6-6 0,7 6 0,-7-7 0,6 8 0,-2-4 0,-1 0 0,3 3 0,-2-2 0,0-1 0,2 0 0,-6 0 0,6 1 0,-2 3 0,0-7 0,-1 6 0,1-6 0,0 3 0,0 4 0,2-4 0,-5 4 0,5-3 0,-5 3 0,5-3 0,-5 0 0,5 2 0,-5-2 0,5 0 0,-5 2 0,5-2 0,-5 4 0,2-1 0,-3 0 0,0 0 0,1-3 0,-1 2 0,0-2 0,0 3 0,3 0 0,-5-3 0,4 3 0,-5 0 0,3 1 0,0 2 0,-2-3 0,1 3 0,-6-2 0,6 5 0,-6-6 0,6 6 0,-6-6 0,2 7 0,1-7 0,-4 6 0,8-2 0,-8 3 0,7-3 0,-2 2 0,0-2 0,2 3 0,-5 0 0,5 0 0,-5 0 0,5 0 0,-6 0 0,6 0 0,-3 0 0,0 0 0,4 0 0,-4 0 0,1 0 0,2 0 0,-5 0 0,6 0 0,-3 0 0,0 0 0,6-8 0,-2 0 0,3-3 0,2-1 0,-2 8 0,1-9 0,10 37 0,-8-16 0,13 29 0,-9-22 0,0-3 0,3 2 0,-3-2 0,0 3 0,3-4 0,-3 4 0,3-8 0,1 8 0,-1-7 0,0 6 0,0-2 0,1 3 0,0 0 0,-1 0 0,1 1 0,3-1 0,-3-3 0,3 2 0,0 1 0,-3-3 0,2 5 0,-3-9 0,-3 3 0,3-4 0,-4 3 0,1-3 0,2 3 0,-5 0 0,5-3 0,-5 3 0,5-3 0,-2 0 0,0 3 0,2-3 0,-5 3 0,5-3 0,-6 3 0,6-2 0,-5 2 0,2-1 0,-3-2 0,-11-34 0,8 21 0,-8-28 0</inkml:trace>
</inkml:ink>
</file>

<file path=ppt/ink/ink9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2-09-26T23:59:23.991"/>
    </inkml:context>
    <inkml:brush xml:id="br0">
      <inkml:brushProperty name="width" value="0.1" units="cm"/>
      <inkml:brushProperty name="height" value="0.1" units="cm"/>
      <inkml:brushProperty name="color" value="#F6630D"/>
    </inkml:brush>
  </inkml:definitions>
  <inkml:trace contextRef="#ctx0" brushRef="#br0">0 0 24575,'0'0'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822EB4B-25EF-3744-8493-62DDE0E0A39F}" type="datetimeFigureOut">
              <a:rPr lang="en-US" smtClean="0"/>
              <a:t>1/24/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6A41CE5-54C7-0243-8776-41785DD7F13A}" type="slidenum">
              <a:rPr lang="en-US" smtClean="0"/>
              <a:t>‹#›</a:t>
            </a:fld>
            <a:endParaRPr lang="en-US"/>
          </a:p>
        </p:txBody>
      </p:sp>
    </p:spTree>
    <p:extLst>
      <p:ext uri="{BB962C8B-B14F-4D97-AF65-F5344CB8AC3E}">
        <p14:creationId xmlns:p14="http://schemas.microsoft.com/office/powerpoint/2010/main" val="11352016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anatomytool.org/content/leiden-drawing-pancreas-and-neighbouring-organs-no-labels" TargetMode="External"/><Relationship Id="rId2" Type="http://schemas.openxmlformats.org/officeDocument/2006/relationships/slide" Target="../slides/slide4.xml"/><Relationship Id="rId1" Type="http://schemas.openxmlformats.org/officeDocument/2006/relationships/notesMaster" Target="../notesMasters/notesMaster1.xml"/><Relationship Id="rId5" Type="http://schemas.openxmlformats.org/officeDocument/2006/relationships/hyperlink" Target="https://creativecommons.org/licenses/by-nc-sa/4.0/" TargetMode="External"/><Relationship Id="rId4" Type="http://schemas.openxmlformats.org/officeDocument/2006/relationships/hyperlink" Target="https://nl.linkedin.com/in/ron-slagter-2905a95" TargetMode="Externa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anatomytool.org/content/leiden-drawing-cross-section-upper-abdomen-peritoneal-lining-no-labels" TargetMode="External"/><Relationship Id="rId2" Type="http://schemas.openxmlformats.org/officeDocument/2006/relationships/slide" Target="../slides/slide5.xml"/><Relationship Id="rId1" Type="http://schemas.openxmlformats.org/officeDocument/2006/relationships/notesMaster" Target="../notesMasters/notesMaster1.xml"/><Relationship Id="rId4" Type="http://schemas.openxmlformats.org/officeDocument/2006/relationships/hyperlink" Target="https://creativecommons.org/licenses/by-nc-sa/4.0/" TargetMode="Externa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 everyone and welcome to the next portion of the E-FAST exam. My name is Krista</a:t>
            </a:r>
          </a:p>
        </p:txBody>
      </p:sp>
      <p:sp>
        <p:nvSpPr>
          <p:cNvPr id="4" name="Slide Number Placeholder 3"/>
          <p:cNvSpPr>
            <a:spLocks noGrp="1"/>
          </p:cNvSpPr>
          <p:nvPr>
            <p:ph type="sldNum" sz="quarter" idx="5"/>
          </p:nvPr>
        </p:nvSpPr>
        <p:spPr/>
        <p:txBody>
          <a:bodyPr/>
          <a:lstStyle/>
          <a:p>
            <a:fld id="{F6A41CE5-54C7-0243-8776-41785DD7F13A}" type="slidenum">
              <a:rPr lang="en-US" smtClean="0"/>
              <a:t>1</a:t>
            </a:fld>
            <a:endParaRPr lang="en-US"/>
          </a:p>
        </p:txBody>
      </p:sp>
    </p:spTree>
    <p:extLst>
      <p:ext uri="{BB962C8B-B14F-4D97-AF65-F5344CB8AC3E}">
        <p14:creationId xmlns:p14="http://schemas.microsoft.com/office/powerpoint/2010/main" val="35268685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video, we will be covering the Left upper quadrant, or </a:t>
            </a:r>
            <a:r>
              <a:rPr lang="en-US" dirty="0" err="1"/>
              <a:t>perisplenic</a:t>
            </a:r>
            <a:r>
              <a:rPr lang="en-US" dirty="0"/>
              <a:t>, view. </a:t>
            </a:r>
          </a:p>
        </p:txBody>
      </p:sp>
      <p:sp>
        <p:nvSpPr>
          <p:cNvPr id="4" name="Slide Number Placeholder 3"/>
          <p:cNvSpPr>
            <a:spLocks noGrp="1"/>
          </p:cNvSpPr>
          <p:nvPr>
            <p:ph type="sldNum" sz="quarter" idx="5"/>
          </p:nvPr>
        </p:nvSpPr>
        <p:spPr/>
        <p:txBody>
          <a:bodyPr/>
          <a:lstStyle/>
          <a:p>
            <a:fld id="{F6A41CE5-54C7-0243-8776-41785DD7F13A}" type="slidenum">
              <a:rPr lang="en-US" smtClean="0"/>
              <a:t>2</a:t>
            </a:fld>
            <a:endParaRPr lang="en-US"/>
          </a:p>
        </p:txBody>
      </p:sp>
    </p:spTree>
    <p:extLst>
      <p:ext uri="{BB962C8B-B14F-4D97-AF65-F5344CB8AC3E}">
        <p14:creationId xmlns:p14="http://schemas.microsoft.com/office/powerpoint/2010/main" val="3066650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ft Upper Quadrant (LUQ) Diagram: Author Owned</a:t>
            </a:r>
          </a:p>
          <a:p>
            <a:r>
              <a:rPr lang="en-US" dirty="0"/>
              <a:t>LUQ Ultrasound (US) Clip: Author Owned</a:t>
            </a:r>
          </a:p>
          <a:p>
            <a:endParaRPr lang="en-US" dirty="0"/>
          </a:p>
          <a:p>
            <a:r>
              <a:rPr lang="en-US" dirty="0"/>
              <a:t>In the left upper quadrant view, we are examining the splenorenal recess for free fluid. The splenorenal recess is the space between the left kidney and the spleen. This view also checks for fluid below the diaphragm. In the cartoon above, you can see that the spleen is more superficial than the kidney. In the ultrasound image below, you can see that the spleen has a homogenous look similar to that of the liver, although with less visible vasculature. The left kidney is deep to the spleen. The kidney is isoechoic to the liver with a central hyperechoic region that represents the inner portion, or medulla, of the kidney.  Along the walls of both organs, there is a thin, hyperechoic line representing the pleura surrounding each. Deep to the spleen and kidney, there is a thicker, anechoic line that is the diaphragm. Deep to the diaphragm is lung space.</a:t>
            </a:r>
          </a:p>
        </p:txBody>
      </p:sp>
      <p:sp>
        <p:nvSpPr>
          <p:cNvPr id="4" name="Slide Number Placeholder 3"/>
          <p:cNvSpPr>
            <a:spLocks noGrp="1"/>
          </p:cNvSpPr>
          <p:nvPr>
            <p:ph type="sldNum" sz="quarter" idx="5"/>
          </p:nvPr>
        </p:nvSpPr>
        <p:spPr/>
        <p:txBody>
          <a:bodyPr/>
          <a:lstStyle/>
          <a:p>
            <a:fld id="{F6A41CE5-54C7-0243-8776-41785DD7F13A}" type="slidenum">
              <a:rPr lang="en-US" smtClean="0"/>
              <a:t>3</a:t>
            </a:fld>
            <a:endParaRPr lang="en-US"/>
          </a:p>
        </p:txBody>
      </p:sp>
    </p:spTree>
    <p:extLst>
      <p:ext uri="{BB962C8B-B14F-4D97-AF65-F5344CB8AC3E}">
        <p14:creationId xmlns:p14="http://schemas.microsoft.com/office/powerpoint/2010/main" val="31143978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0" dirty="0">
                <a:solidFill>
                  <a:srgbClr val="333333"/>
                </a:solidFill>
                <a:effectLst/>
                <a:latin typeface="proxima"/>
              </a:rPr>
              <a:t>Image by Ron </a:t>
            </a:r>
            <a:r>
              <a:rPr lang="en-US" b="0" i="0" dirty="0" err="1">
                <a:solidFill>
                  <a:srgbClr val="333333"/>
                </a:solidFill>
                <a:effectLst/>
                <a:latin typeface="proxima"/>
              </a:rPr>
              <a:t>Slagter</a:t>
            </a:r>
            <a:r>
              <a:rPr lang="en-US" b="0" i="0" dirty="0">
                <a:solidFill>
                  <a:srgbClr val="333333"/>
                </a:solidFill>
                <a:effectLst/>
                <a:latin typeface="proxima"/>
              </a:rPr>
              <a:t>, retrieved from: https://anatomytool.org/content/leiden-drawing-pancreas-and-neighbouring-organs-no-labels on 09/27/2022. Creative Commons License associated: https://creativecommons.org/licenses/by-nc-sa/4.0/</a:t>
            </a:r>
          </a:p>
          <a:p>
            <a:pPr marL="171450" indent="-171450">
              <a:buFont typeface="Arial" panose="020B0604020202020204" pitchFamily="34" charset="0"/>
              <a:buChar char="•"/>
            </a:pPr>
            <a:r>
              <a:rPr lang="en-US" b="0" i="0" u="none" strike="noStrike" dirty="0">
                <a:solidFill>
                  <a:srgbClr val="0275D8"/>
                </a:solidFill>
                <a:effectLst/>
                <a:latin typeface="Times New Roman" panose="02020603050405020304" pitchFamily="18" charset="0"/>
                <a:hlinkClick r:id="rId3"/>
              </a:rPr>
              <a:t>"Leiden - Drawing pancreas and neighbouring organs - no labels"</a:t>
            </a:r>
            <a:r>
              <a:rPr lang="en-US" b="0" i="0" dirty="0">
                <a:solidFill>
                  <a:srgbClr val="666666"/>
                </a:solidFill>
                <a:effectLst/>
                <a:latin typeface="Times New Roman" panose="02020603050405020304" pitchFamily="18" charset="0"/>
              </a:rPr>
              <a:t> by </a:t>
            </a:r>
            <a:r>
              <a:rPr lang="en-US" b="0" i="0" u="none" strike="noStrike" dirty="0">
                <a:solidFill>
                  <a:srgbClr val="0275D8"/>
                </a:solidFill>
                <a:effectLst/>
                <a:latin typeface="Times New Roman" panose="02020603050405020304" pitchFamily="18" charset="0"/>
                <a:hlinkClick r:id="rId4"/>
              </a:rPr>
              <a:t>Ron Slagter</a:t>
            </a:r>
            <a:r>
              <a:rPr lang="en-US" b="0" i="0" dirty="0">
                <a:solidFill>
                  <a:srgbClr val="666666"/>
                </a:solidFill>
                <a:effectLst/>
                <a:latin typeface="Times New Roman" panose="02020603050405020304" pitchFamily="18" charset="0"/>
              </a:rPr>
              <a:t>, license: </a:t>
            </a:r>
            <a:r>
              <a:rPr lang="en-US" b="0" i="0" u="none" strike="noStrike" dirty="0">
                <a:solidFill>
                  <a:srgbClr val="0275D8"/>
                </a:solidFill>
                <a:effectLst/>
                <a:latin typeface="Times New Roman" panose="02020603050405020304" pitchFamily="18" charset="0"/>
                <a:hlinkClick r:id="rId5"/>
              </a:rPr>
              <a:t>CC BY-NC-SA</a:t>
            </a:r>
            <a:endParaRPr lang="en-US" b="0" i="0" u="none" strike="noStrike" dirty="0">
              <a:solidFill>
                <a:srgbClr val="0275D8"/>
              </a:solidFill>
              <a:effectLst/>
              <a:latin typeface="Times New Roman" panose="02020603050405020304" pitchFamily="18" charset="0"/>
            </a:endParaRPr>
          </a:p>
          <a:p>
            <a:endParaRPr lang="en-US" b="0" i="0" u="none" strike="noStrike" dirty="0">
              <a:solidFill>
                <a:srgbClr val="0275D8"/>
              </a:solidFill>
              <a:effectLst/>
              <a:latin typeface="Times New Roman" panose="02020603050405020304" pitchFamily="18" charset="0"/>
            </a:endParaRPr>
          </a:p>
          <a:p>
            <a:r>
              <a:rPr lang="en-US" b="0" i="0" u="none" strike="noStrike" dirty="0">
                <a:solidFill>
                  <a:srgbClr val="0275D8"/>
                </a:solidFill>
                <a:effectLst/>
                <a:latin typeface="Times New Roman" panose="02020603050405020304" pitchFamily="18" charset="0"/>
              </a:rPr>
              <a:t>LUQ US Clip: Author Owned</a:t>
            </a:r>
          </a:p>
          <a:p>
            <a:endParaRPr lang="en-US" b="0" i="0" u="none" strike="noStrike" dirty="0">
              <a:solidFill>
                <a:srgbClr val="0275D8"/>
              </a:solidFill>
              <a:effectLst/>
              <a:latin typeface="Times New Roman" panose="02020603050405020304" pitchFamily="18" charset="0"/>
            </a:endParaRPr>
          </a:p>
          <a:p>
            <a:r>
              <a:rPr lang="en-US" b="0" i="0" u="none" strike="noStrike" dirty="0">
                <a:solidFill>
                  <a:srgbClr val="0275D8"/>
                </a:solidFill>
                <a:effectLst/>
                <a:latin typeface="Times New Roman" panose="02020603050405020304" pitchFamily="18" charset="0"/>
              </a:rPr>
              <a:t>This image demonstrates the surface anatomy that you will use to determine proper probe placement. The spleen is located in the  left upper quadrant. It is anterior and superior to the left kidney, just as the liver is to the right kidney. However, the spleen is much smaller than the liver, so it is more obscured by the rib cage on ultrasound exam. The left kidney is also more superior than the right kidney. </a:t>
            </a:r>
          </a:p>
          <a:p>
            <a:endParaRPr lang="en-US" dirty="0"/>
          </a:p>
          <a:p>
            <a:r>
              <a:rPr lang="en-US" dirty="0"/>
              <a:t>Start with the probe between the 9</a:t>
            </a:r>
            <a:r>
              <a:rPr lang="en-US" baseline="30000" dirty="0"/>
              <a:t>th</a:t>
            </a:r>
            <a:r>
              <a:rPr lang="en-US" dirty="0"/>
              <a:t> and 10</a:t>
            </a:r>
            <a:r>
              <a:rPr lang="en-US" baseline="30000" dirty="0"/>
              <a:t>th</a:t>
            </a:r>
            <a:r>
              <a:rPr lang="en-US" dirty="0"/>
              <a:t> intercostal space at the mid axillary line, with the probe indicator pointed towards the patient’s head. You will have the slid the probe down until your hand is almost touching the bed. The kidney is very posterior. Then fan anteriorly until you are able to visualize the organs. You may have to slide up or down a rib space until you find a good window to view the splenorenal space. </a:t>
            </a:r>
          </a:p>
          <a:p>
            <a:endParaRPr lang="en-US" dirty="0"/>
          </a:p>
          <a:p>
            <a:endParaRPr lang="en-US" dirty="0"/>
          </a:p>
          <a:p>
            <a:endParaRPr lang="en-US" dirty="0"/>
          </a:p>
          <a:p>
            <a:pPr algn="l">
              <a:buFont typeface="Arial" panose="020B0604020202020204" pitchFamily="34" charset="0"/>
              <a:buChar char="•"/>
            </a:pPr>
            <a:r>
              <a:rPr lang="en-US" b="0" i="0" dirty="0">
                <a:solidFill>
                  <a:srgbClr val="000000"/>
                </a:solidFill>
                <a:effectLst/>
                <a:latin typeface="Open Sans" panose="020B0606030504020204" pitchFamily="34" charset="0"/>
              </a:rPr>
              <a:t>The left kidney is located slightly more posterior and cephalad than the right kidney, so place the probe on the posterior axillary line between the 9th and 10th intercostal space with the probe orientation marker cephalad.</a:t>
            </a:r>
          </a:p>
          <a:p>
            <a:pPr algn="l">
              <a:buFont typeface="Arial" panose="020B0604020202020204" pitchFamily="34" charset="0"/>
              <a:buChar char="•"/>
            </a:pPr>
            <a:r>
              <a:rPr lang="en-US" b="0" i="0" dirty="0">
                <a:solidFill>
                  <a:srgbClr val="000000"/>
                </a:solidFill>
                <a:effectLst/>
                <a:latin typeface="Open Sans" panose="020B0606030504020204" pitchFamily="34" charset="0"/>
              </a:rPr>
              <a:t>The left upper quadrant is a mirror image of the right, with the spleen appearing at the top of the monitor, the diaphragm to the left, and the kidney to the right.</a:t>
            </a:r>
          </a:p>
          <a:p>
            <a:pPr algn="l">
              <a:buFont typeface="Arial" panose="020B0604020202020204" pitchFamily="34" charset="0"/>
              <a:buChar char="•"/>
            </a:pPr>
            <a:r>
              <a:rPr lang="en-US" b="0" i="0" dirty="0">
                <a:solidFill>
                  <a:srgbClr val="000000"/>
                </a:solidFill>
                <a:effectLst/>
                <a:latin typeface="Open Sans" panose="020B0606030504020204" pitchFamily="34" charset="0"/>
              </a:rPr>
              <a:t>Fluid is more likely to pool around the spleen than between the spleen and the kidney, and fluid in the left upper quadrant usually represents a splenic injury.</a:t>
            </a:r>
          </a:p>
          <a:p>
            <a:pPr algn="l">
              <a:buFont typeface="Arial" panose="020B0604020202020204" pitchFamily="34" charset="0"/>
              <a:buChar char="•"/>
            </a:pPr>
            <a:r>
              <a:rPr lang="en-US" b="0" i="0" dirty="0">
                <a:solidFill>
                  <a:srgbClr val="000000"/>
                </a:solidFill>
                <a:effectLst/>
                <a:latin typeface="Open Sans" panose="020B0606030504020204" pitchFamily="34" charset="0"/>
              </a:rPr>
              <a:t>Again, evaluate for hemothorax by looking for a fluid collection above the diaphragm and abnormal continuation of the spinous line.</a:t>
            </a:r>
          </a:p>
          <a:p>
            <a:endParaRPr lang="en-US" dirty="0"/>
          </a:p>
          <a:p>
            <a:r>
              <a:rPr lang="en-US" dirty="0"/>
              <a:t>https://</a:t>
            </a:r>
            <a:r>
              <a:rPr lang="en-US" dirty="0" err="1"/>
              <a:t>www.merckmanuals.com</a:t>
            </a:r>
            <a:r>
              <a:rPr lang="en-US" dirty="0"/>
              <a:t>/professional/critical-care-medicine/how-to-do-other-emergency-medicine-procedures/how-to-do-e-fast-examination#:~:text=Place%20the%20probe%20in%20the,the%20liver%2C%20called%20Morison%20pouch.</a:t>
            </a:r>
          </a:p>
        </p:txBody>
      </p:sp>
      <p:sp>
        <p:nvSpPr>
          <p:cNvPr id="4" name="Slide Number Placeholder 3"/>
          <p:cNvSpPr>
            <a:spLocks noGrp="1"/>
          </p:cNvSpPr>
          <p:nvPr>
            <p:ph type="sldNum" sz="quarter" idx="5"/>
          </p:nvPr>
        </p:nvSpPr>
        <p:spPr/>
        <p:txBody>
          <a:bodyPr/>
          <a:lstStyle/>
          <a:p>
            <a:fld id="{F6A41CE5-54C7-0243-8776-41785DD7F13A}" type="slidenum">
              <a:rPr lang="en-US" smtClean="0"/>
              <a:t>4</a:t>
            </a:fld>
            <a:endParaRPr lang="en-US"/>
          </a:p>
        </p:txBody>
      </p:sp>
    </p:spTree>
    <p:extLst>
      <p:ext uri="{BB962C8B-B14F-4D97-AF65-F5344CB8AC3E}">
        <p14:creationId xmlns:p14="http://schemas.microsoft.com/office/powerpoint/2010/main" val="12940726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0" dirty="0">
                <a:solidFill>
                  <a:srgbClr val="333333"/>
                </a:solidFill>
                <a:effectLst/>
                <a:latin typeface="proxima"/>
              </a:rPr>
              <a:t>Image by Ron </a:t>
            </a:r>
            <a:r>
              <a:rPr lang="en-US" b="0" i="0" dirty="0" err="1">
                <a:solidFill>
                  <a:srgbClr val="333333"/>
                </a:solidFill>
                <a:effectLst/>
                <a:latin typeface="proxima"/>
              </a:rPr>
              <a:t>Slagter</a:t>
            </a:r>
            <a:r>
              <a:rPr lang="en-US" b="0" i="0" dirty="0">
                <a:solidFill>
                  <a:srgbClr val="333333"/>
                </a:solidFill>
                <a:effectLst/>
                <a:latin typeface="proxima"/>
              </a:rPr>
              <a:t> retrieved from: https://anatomytool.org/content/leiden-drawing-cross-section-upper-abdomen-peritoneal-lining-no-labels on 09/27/2022. Creative Commons License associated: https://creativecommons.org/licenses/by-nc-sa/4.0/</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hlinkClick r:id="rId3"/>
              </a:rPr>
              <a:t>"Leiden - Drawing Cross-section upper abdomen with peritoneal lining - no labels"</a:t>
            </a:r>
            <a:r>
              <a:rPr lang="en-US" dirty="0"/>
              <a:t> by Ron </a:t>
            </a:r>
            <a:r>
              <a:rPr lang="en-US" dirty="0" err="1"/>
              <a:t>Slagter</a:t>
            </a:r>
            <a:r>
              <a:rPr lang="en-US" dirty="0"/>
              <a:t>, license: </a:t>
            </a:r>
            <a:r>
              <a:rPr lang="en-US" dirty="0">
                <a:hlinkClick r:id="rId4"/>
              </a:rPr>
              <a:t>CC BY-NC-SA</a:t>
            </a:r>
            <a:endParaRPr lang="en-US" dirty="0"/>
          </a:p>
          <a:p>
            <a:pPr marL="0" indent="0">
              <a:buFont typeface="Arial" panose="020B0604020202020204" pitchFamily="34" charset="0"/>
              <a:buNone/>
            </a:pPr>
            <a:endParaRPr lang="en-US" b="0" i="0" u="none" strike="noStrike" dirty="0">
              <a:solidFill>
                <a:srgbClr val="333333"/>
              </a:solidFill>
              <a:effectLst/>
              <a:latin typeface="proxima"/>
            </a:endParaRPr>
          </a:p>
          <a:p>
            <a:pPr marL="0" indent="0">
              <a:buFont typeface="Arial" panose="020B0604020202020204" pitchFamily="34" charset="0"/>
              <a:buNone/>
            </a:pPr>
            <a:endParaRPr lang="en-US" b="0" i="0" u="none" strike="noStrike" dirty="0">
              <a:solidFill>
                <a:srgbClr val="0275D8"/>
              </a:solidFill>
              <a:effectLst/>
              <a:latin typeface="Times New Roman" panose="02020603050405020304" pitchFamily="18" charset="0"/>
            </a:endParaRPr>
          </a:p>
          <a:p>
            <a:r>
              <a:rPr lang="en-US" b="0" i="0" u="none" strike="noStrike" dirty="0">
                <a:solidFill>
                  <a:srgbClr val="0275D8"/>
                </a:solidFill>
                <a:effectLst/>
                <a:latin typeface="Times New Roman" panose="02020603050405020304" pitchFamily="18" charset="0"/>
              </a:rPr>
              <a:t>This image is a sagittal cut used to demonstrate the position of the left kidney and spleen. This image is reversed, just like a CT scan, so imagine we are looking from the patient’s feet towards their head. Their left will be your right. </a:t>
            </a:r>
          </a:p>
          <a:p>
            <a:endParaRPr lang="en-US" b="0" i="0" u="none" strike="noStrike" dirty="0">
              <a:solidFill>
                <a:srgbClr val="0275D8"/>
              </a:solidFill>
              <a:effectLst/>
              <a:latin typeface="Times New Roman" panose="02020603050405020304" pitchFamily="18" charset="0"/>
            </a:endParaRPr>
          </a:p>
          <a:p>
            <a:r>
              <a:rPr lang="en-US" b="0" i="0" u="none" strike="noStrike" dirty="0">
                <a:solidFill>
                  <a:srgbClr val="0275D8"/>
                </a:solidFill>
                <a:effectLst/>
                <a:latin typeface="Times New Roman" panose="02020603050405020304" pitchFamily="18" charset="0"/>
              </a:rPr>
              <a:t>In orange, we can identify the left kidney. Note it’s proximity to the vertebra. Lateral to the kidney is the spleen in green. These organs are very posterior, which is why you will have to place the probe so close to the bed when scanning. </a:t>
            </a:r>
          </a:p>
          <a:p>
            <a:endParaRPr lang="en-US" b="0" i="0" u="none" strike="noStrike" dirty="0">
              <a:solidFill>
                <a:srgbClr val="0275D8"/>
              </a:solidFill>
              <a:effectLst/>
              <a:latin typeface="Times New Roman" panose="02020603050405020304" pitchFamily="18" charset="0"/>
            </a:endParaRPr>
          </a:p>
          <a:p>
            <a:r>
              <a:rPr lang="en-US" b="0" i="0" u="none" strike="noStrike" dirty="0">
                <a:solidFill>
                  <a:srgbClr val="0275D8"/>
                </a:solidFill>
                <a:effectLst/>
                <a:latin typeface="Times New Roman" panose="02020603050405020304" pitchFamily="18" charset="0"/>
              </a:rPr>
              <a:t>This is the space where </a:t>
            </a:r>
            <a:r>
              <a:rPr lang="en-US" b="0" i="0" u="none" strike="noStrike" dirty="0" err="1">
                <a:solidFill>
                  <a:srgbClr val="0275D8"/>
                </a:solidFill>
                <a:effectLst/>
                <a:latin typeface="Times New Roman" panose="02020603050405020304" pitchFamily="18" charset="0"/>
              </a:rPr>
              <a:t>cluid</a:t>
            </a:r>
            <a:r>
              <a:rPr lang="en-US" b="0" i="0" u="none" strike="noStrike" dirty="0">
                <a:solidFill>
                  <a:srgbClr val="0275D8"/>
                </a:solidFill>
                <a:effectLst/>
                <a:latin typeface="Times New Roman" panose="02020603050405020304" pitchFamily="18" charset="0"/>
              </a:rPr>
              <a:t> can potentially accumulate. </a:t>
            </a:r>
            <a:endParaRPr lang="en-US" dirty="0"/>
          </a:p>
        </p:txBody>
      </p:sp>
      <p:sp>
        <p:nvSpPr>
          <p:cNvPr id="4" name="Slide Number Placeholder 3"/>
          <p:cNvSpPr>
            <a:spLocks noGrp="1"/>
          </p:cNvSpPr>
          <p:nvPr>
            <p:ph type="sldNum" sz="quarter" idx="5"/>
          </p:nvPr>
        </p:nvSpPr>
        <p:spPr/>
        <p:txBody>
          <a:bodyPr/>
          <a:lstStyle/>
          <a:p>
            <a:fld id="{F6A41CE5-54C7-0243-8776-41785DD7F13A}" type="slidenum">
              <a:rPr lang="en-US" smtClean="0"/>
              <a:t>5</a:t>
            </a:fld>
            <a:endParaRPr lang="en-US"/>
          </a:p>
        </p:txBody>
      </p:sp>
    </p:spTree>
    <p:extLst>
      <p:ext uri="{BB962C8B-B14F-4D97-AF65-F5344CB8AC3E}">
        <p14:creationId xmlns:p14="http://schemas.microsoft.com/office/powerpoint/2010/main" val="196008866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UQ Ultrasound Image: Author Owne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UQ Ultrasound Image: Author Owned</a:t>
            </a:r>
          </a:p>
          <a:p>
            <a:endParaRPr lang="en-US" dirty="0"/>
          </a:p>
          <a:p>
            <a:endParaRPr lang="en-US" dirty="0"/>
          </a:p>
          <a:p>
            <a:r>
              <a:rPr lang="en-US" dirty="0"/>
              <a:t>These are ultrasound images of the RUQ and LUQ. We will compare them. </a:t>
            </a:r>
          </a:p>
          <a:p>
            <a:endParaRPr lang="en-US" dirty="0"/>
          </a:p>
          <a:p>
            <a:r>
              <a:rPr lang="en-US" dirty="0"/>
              <a:t>The spleen and liver are both superficial to the kidneys, so they will be superior on the ultrasound image. Note the similarity in texture of the spleen and liver. You can see here that the liver is much more vascular because these anechoic regions represent blood vessels traveling through the organ. In the spleen, the blood vessels are much smaller and harder to see on ultrasound, so you won’t see many like you do in the liver. </a:t>
            </a:r>
          </a:p>
          <a:p>
            <a:endParaRPr lang="en-US" dirty="0"/>
          </a:p>
          <a:p>
            <a:r>
              <a:rPr lang="en-US" dirty="0"/>
              <a:t>The kidney is nearly identical in both, with this iso/hypo echoic region surrounding the central hyperechoic region</a:t>
            </a:r>
          </a:p>
        </p:txBody>
      </p:sp>
      <p:sp>
        <p:nvSpPr>
          <p:cNvPr id="4" name="Slide Number Placeholder 3"/>
          <p:cNvSpPr>
            <a:spLocks noGrp="1"/>
          </p:cNvSpPr>
          <p:nvPr>
            <p:ph type="sldNum" sz="quarter" idx="5"/>
          </p:nvPr>
        </p:nvSpPr>
        <p:spPr/>
        <p:txBody>
          <a:bodyPr/>
          <a:lstStyle/>
          <a:p>
            <a:fld id="{F6A41CE5-54C7-0243-8776-41785DD7F13A}" type="slidenum">
              <a:rPr lang="en-US" smtClean="0"/>
              <a:t>6</a:t>
            </a:fld>
            <a:endParaRPr lang="en-US"/>
          </a:p>
        </p:txBody>
      </p:sp>
    </p:spTree>
    <p:extLst>
      <p:ext uri="{BB962C8B-B14F-4D97-AF65-F5344CB8AC3E}">
        <p14:creationId xmlns:p14="http://schemas.microsoft.com/office/powerpoint/2010/main" val="44726732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UQ Ultrasound Image: Author Owned</a:t>
            </a:r>
          </a:p>
          <a:p>
            <a:endParaRPr lang="en-US" dirty="0"/>
          </a:p>
        </p:txBody>
      </p:sp>
      <p:sp>
        <p:nvSpPr>
          <p:cNvPr id="4" name="Slide Number Placeholder 3"/>
          <p:cNvSpPr>
            <a:spLocks noGrp="1"/>
          </p:cNvSpPr>
          <p:nvPr>
            <p:ph type="sldNum" sz="quarter" idx="5"/>
          </p:nvPr>
        </p:nvSpPr>
        <p:spPr/>
        <p:txBody>
          <a:bodyPr/>
          <a:lstStyle/>
          <a:p>
            <a:fld id="{F6A41CE5-54C7-0243-8776-41785DD7F13A}" type="slidenum">
              <a:rPr lang="en-US" smtClean="0"/>
              <a:t>7</a:t>
            </a:fld>
            <a:endParaRPr lang="en-US"/>
          </a:p>
        </p:txBody>
      </p:sp>
    </p:spTree>
    <p:extLst>
      <p:ext uri="{BB962C8B-B14F-4D97-AF65-F5344CB8AC3E}">
        <p14:creationId xmlns:p14="http://schemas.microsoft.com/office/powerpoint/2010/main" val="112274190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athologic LUQ Ultrasound Image: Author Owned</a:t>
            </a:r>
          </a:p>
          <a:p>
            <a:endParaRPr lang="en-US" dirty="0"/>
          </a:p>
        </p:txBody>
      </p:sp>
      <p:sp>
        <p:nvSpPr>
          <p:cNvPr id="4" name="Slide Number Placeholder 3"/>
          <p:cNvSpPr>
            <a:spLocks noGrp="1"/>
          </p:cNvSpPr>
          <p:nvPr>
            <p:ph type="sldNum" sz="quarter" idx="5"/>
          </p:nvPr>
        </p:nvSpPr>
        <p:spPr/>
        <p:txBody>
          <a:bodyPr/>
          <a:lstStyle/>
          <a:p>
            <a:fld id="{F6A41CE5-54C7-0243-8776-41785DD7F13A}" type="slidenum">
              <a:rPr lang="en-US" smtClean="0"/>
              <a:t>8</a:t>
            </a:fld>
            <a:endParaRPr lang="en-US"/>
          </a:p>
        </p:txBody>
      </p:sp>
    </p:spTree>
    <p:extLst>
      <p:ext uri="{BB962C8B-B14F-4D97-AF65-F5344CB8AC3E}">
        <p14:creationId xmlns:p14="http://schemas.microsoft.com/office/powerpoint/2010/main" val="392605734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video, we will be covering the Left upper quadrant, or </a:t>
            </a:r>
            <a:r>
              <a:rPr lang="en-US" dirty="0" err="1"/>
              <a:t>perisplenic</a:t>
            </a:r>
            <a:r>
              <a:rPr lang="en-US" dirty="0"/>
              <a:t>, view. </a:t>
            </a:r>
          </a:p>
        </p:txBody>
      </p:sp>
      <p:sp>
        <p:nvSpPr>
          <p:cNvPr id="4" name="Slide Number Placeholder 3"/>
          <p:cNvSpPr>
            <a:spLocks noGrp="1"/>
          </p:cNvSpPr>
          <p:nvPr>
            <p:ph type="sldNum" sz="quarter" idx="5"/>
          </p:nvPr>
        </p:nvSpPr>
        <p:spPr/>
        <p:txBody>
          <a:bodyPr/>
          <a:lstStyle/>
          <a:p>
            <a:fld id="{F6A41CE5-54C7-0243-8776-41785DD7F13A}" type="slidenum">
              <a:rPr lang="en-US" smtClean="0"/>
              <a:t>9</a:t>
            </a:fld>
            <a:endParaRPr lang="en-US"/>
          </a:p>
        </p:txBody>
      </p:sp>
    </p:spTree>
    <p:extLst>
      <p:ext uri="{BB962C8B-B14F-4D97-AF65-F5344CB8AC3E}">
        <p14:creationId xmlns:p14="http://schemas.microsoft.com/office/powerpoint/2010/main" val="1494264234"/>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5A5C87FB-6C7F-6341-B3AC-7A03AC6D386F}"/>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5414" y="0"/>
            <a:ext cx="12181172" cy="6858000"/>
          </a:xfrm>
          <a:prstGeom prst="rect">
            <a:avLst/>
          </a:prstGeom>
        </p:spPr>
      </p:pic>
      <p:sp>
        <p:nvSpPr>
          <p:cNvPr id="2" name="Title 1">
            <a:extLst>
              <a:ext uri="{FF2B5EF4-FFF2-40B4-BE49-F238E27FC236}">
                <a16:creationId xmlns:a16="http://schemas.microsoft.com/office/drawing/2014/main" id="{9E4E5EF8-3F55-CC40-8877-5D48D7C0631B}"/>
              </a:ext>
            </a:extLst>
          </p:cNvPr>
          <p:cNvSpPr>
            <a:spLocks noGrp="1"/>
          </p:cNvSpPr>
          <p:nvPr>
            <p:ph type="ctrTitle"/>
          </p:nvPr>
        </p:nvSpPr>
        <p:spPr>
          <a:xfrm>
            <a:off x="1524000" y="1122363"/>
            <a:ext cx="9144000" cy="1570961"/>
          </a:xfrm>
          <a:prstGeom prst="rect">
            <a:avLst/>
          </a:prstGeom>
        </p:spPr>
        <p:txBody>
          <a:bodyPr anchor="b">
            <a:normAutofit/>
          </a:bodyPr>
          <a:lstStyle>
            <a:lvl1pPr algn="l">
              <a:defRPr sz="4400">
                <a:solidFill>
                  <a:schemeClr val="bg1"/>
                </a:solidFill>
              </a:defRPr>
            </a:lvl1pPr>
          </a:lstStyle>
          <a:p>
            <a:r>
              <a:rPr lang="en-US"/>
              <a:t>Click to edit Master title style</a:t>
            </a:r>
          </a:p>
        </p:txBody>
      </p:sp>
      <p:sp>
        <p:nvSpPr>
          <p:cNvPr id="3" name="Subtitle 2">
            <a:extLst>
              <a:ext uri="{FF2B5EF4-FFF2-40B4-BE49-F238E27FC236}">
                <a16:creationId xmlns:a16="http://schemas.microsoft.com/office/drawing/2014/main" id="{BFD648D3-80FB-6246-9942-F676252E6F93}"/>
              </a:ext>
            </a:extLst>
          </p:cNvPr>
          <p:cNvSpPr>
            <a:spLocks noGrp="1"/>
          </p:cNvSpPr>
          <p:nvPr>
            <p:ph type="subTitle" idx="1"/>
          </p:nvPr>
        </p:nvSpPr>
        <p:spPr>
          <a:xfrm>
            <a:off x="1524000" y="2693324"/>
            <a:ext cx="9144000" cy="648392"/>
          </a:xfrm>
        </p:spPr>
        <p:txBody>
          <a:bodyPr/>
          <a:lstStyle>
            <a:lvl1pPr marL="0" indent="0" algn="l">
              <a:buNone/>
              <a:defRPr sz="24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pic>
        <p:nvPicPr>
          <p:cNvPr id="9" name="Picture 8">
            <a:extLst>
              <a:ext uri="{FF2B5EF4-FFF2-40B4-BE49-F238E27FC236}">
                <a16:creationId xmlns:a16="http://schemas.microsoft.com/office/drawing/2014/main" id="{BD09F92B-E9CD-1043-ADF5-647DA2A9ECBB}"/>
              </a:ext>
            </a:extLst>
          </p:cNvPr>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343158" y="3851391"/>
            <a:ext cx="2596403" cy="1200150"/>
          </a:xfrm>
          <a:prstGeom prst="rect">
            <a:avLst/>
          </a:prstGeom>
        </p:spPr>
      </p:pic>
    </p:spTree>
    <p:extLst>
      <p:ext uri="{BB962C8B-B14F-4D97-AF65-F5344CB8AC3E}">
        <p14:creationId xmlns:p14="http://schemas.microsoft.com/office/powerpoint/2010/main" val="32577885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1">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0580087E-EAD0-9943-8A61-EC0B6D11A0DC}"/>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t="88740"/>
          <a:stretch/>
        </p:blipFill>
        <p:spPr>
          <a:xfrm>
            <a:off x="5414" y="6085754"/>
            <a:ext cx="12181172" cy="772245"/>
          </a:xfrm>
          <a:prstGeom prst="rect">
            <a:avLst/>
          </a:prstGeom>
        </p:spPr>
      </p:pic>
      <p:sp>
        <p:nvSpPr>
          <p:cNvPr id="2" name="Title 1">
            <a:extLst>
              <a:ext uri="{FF2B5EF4-FFF2-40B4-BE49-F238E27FC236}">
                <a16:creationId xmlns:a16="http://schemas.microsoft.com/office/drawing/2014/main" id="{B0115303-0D88-FC4F-A64A-0DABCD2F0B90}"/>
              </a:ext>
            </a:extLst>
          </p:cNvPr>
          <p:cNvSpPr>
            <a:spLocks noGrp="1"/>
          </p:cNvSpPr>
          <p:nvPr>
            <p:ph type="title"/>
          </p:nvPr>
        </p:nvSpPr>
        <p:spPr>
          <a:xfrm>
            <a:off x="838200" y="365125"/>
            <a:ext cx="10515600" cy="886159"/>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E5C8021D-5040-E443-B438-B5DF5DB17BBB}"/>
              </a:ext>
            </a:extLst>
          </p:cNvPr>
          <p:cNvSpPr>
            <a:spLocks noGrp="1"/>
          </p:cNvSpPr>
          <p:nvPr>
            <p:ph idx="1"/>
          </p:nvPr>
        </p:nvSpPr>
        <p:spPr>
          <a:xfrm>
            <a:off x="838200" y="1251285"/>
            <a:ext cx="10515600" cy="479263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pic>
        <p:nvPicPr>
          <p:cNvPr id="9" name="Picture 8">
            <a:extLst>
              <a:ext uri="{FF2B5EF4-FFF2-40B4-BE49-F238E27FC236}">
                <a16:creationId xmlns:a16="http://schemas.microsoft.com/office/drawing/2014/main" id="{466905F6-993F-D349-A0EA-9D639A51B81E}"/>
              </a:ext>
            </a:extLst>
          </p:cNvPr>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802050" y="6064834"/>
            <a:ext cx="1761191" cy="814085"/>
          </a:xfrm>
          <a:prstGeom prst="rect">
            <a:avLst/>
          </a:prstGeom>
        </p:spPr>
      </p:pic>
    </p:spTree>
    <p:extLst>
      <p:ext uri="{BB962C8B-B14F-4D97-AF65-F5344CB8AC3E}">
        <p14:creationId xmlns:p14="http://schemas.microsoft.com/office/powerpoint/2010/main" val="13633949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and Content 2">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66C763D1-54E7-1F4C-9A40-8033FD87C96D}"/>
              </a:ext>
            </a:extLst>
          </p:cNvPr>
          <p:cNvSpPr>
            <a:spLocks noGrp="1"/>
          </p:cNvSpPr>
          <p:nvPr>
            <p:ph type="pic" sz="quarter" idx="10"/>
          </p:nvPr>
        </p:nvSpPr>
        <p:spPr>
          <a:xfrm>
            <a:off x="6049963" y="1250950"/>
            <a:ext cx="5303837" cy="4819111"/>
          </a:xfrm>
        </p:spPr>
        <p:txBody>
          <a:bodyPr/>
          <a:lstStyle/>
          <a:p>
            <a:endParaRPr lang="en-US"/>
          </a:p>
        </p:txBody>
      </p:sp>
      <p:sp>
        <p:nvSpPr>
          <p:cNvPr id="2" name="Title 1">
            <a:extLst>
              <a:ext uri="{FF2B5EF4-FFF2-40B4-BE49-F238E27FC236}">
                <a16:creationId xmlns:a16="http://schemas.microsoft.com/office/drawing/2014/main" id="{B0115303-0D88-FC4F-A64A-0DABCD2F0B90}"/>
              </a:ext>
            </a:extLst>
          </p:cNvPr>
          <p:cNvSpPr>
            <a:spLocks noGrp="1"/>
          </p:cNvSpPr>
          <p:nvPr>
            <p:ph type="title"/>
          </p:nvPr>
        </p:nvSpPr>
        <p:spPr>
          <a:xfrm>
            <a:off x="838200" y="365125"/>
            <a:ext cx="10515600" cy="886159"/>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E5C8021D-5040-E443-B438-B5DF5DB17BBB}"/>
              </a:ext>
            </a:extLst>
          </p:cNvPr>
          <p:cNvSpPr>
            <a:spLocks noGrp="1"/>
          </p:cNvSpPr>
          <p:nvPr>
            <p:ph idx="1"/>
          </p:nvPr>
        </p:nvSpPr>
        <p:spPr>
          <a:xfrm>
            <a:off x="838200" y="1250951"/>
            <a:ext cx="5085945" cy="481911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pic>
        <p:nvPicPr>
          <p:cNvPr id="7" name="Picture 6">
            <a:extLst>
              <a:ext uri="{FF2B5EF4-FFF2-40B4-BE49-F238E27FC236}">
                <a16:creationId xmlns:a16="http://schemas.microsoft.com/office/drawing/2014/main" id="{FBD3E57B-7AA0-CB4E-84C8-14051157E7C1}"/>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t="88740"/>
          <a:stretch/>
        </p:blipFill>
        <p:spPr>
          <a:xfrm>
            <a:off x="5414" y="6085754"/>
            <a:ext cx="12181172" cy="772245"/>
          </a:xfrm>
          <a:prstGeom prst="rect">
            <a:avLst/>
          </a:prstGeom>
        </p:spPr>
      </p:pic>
      <p:pic>
        <p:nvPicPr>
          <p:cNvPr id="11" name="Picture 10">
            <a:extLst>
              <a:ext uri="{FF2B5EF4-FFF2-40B4-BE49-F238E27FC236}">
                <a16:creationId xmlns:a16="http://schemas.microsoft.com/office/drawing/2014/main" id="{C92E3011-1B8B-5640-AE26-C7ED9C07F799}"/>
              </a:ext>
            </a:extLst>
          </p:cNvPr>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802050" y="6064834"/>
            <a:ext cx="1761191" cy="814085"/>
          </a:xfrm>
          <a:prstGeom prst="rect">
            <a:avLst/>
          </a:prstGeom>
        </p:spPr>
      </p:pic>
    </p:spTree>
    <p:extLst>
      <p:ext uri="{BB962C8B-B14F-4D97-AF65-F5344CB8AC3E}">
        <p14:creationId xmlns:p14="http://schemas.microsoft.com/office/powerpoint/2010/main" val="32789695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bg>
      <p:bgPr>
        <a:solidFill>
          <a:srgbClr val="001E44"/>
        </a:solidFill>
        <a:effectLst/>
      </p:bgPr>
    </p:bg>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F5CCD73-4F4C-6E40-91EC-E9DA02F326CB}"/>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b="52440"/>
          <a:stretch/>
        </p:blipFill>
        <p:spPr>
          <a:xfrm>
            <a:off x="5414" y="0"/>
            <a:ext cx="12181172" cy="3261674"/>
          </a:xfrm>
          <a:prstGeom prst="rect">
            <a:avLst/>
          </a:prstGeom>
        </p:spPr>
      </p:pic>
      <p:sp>
        <p:nvSpPr>
          <p:cNvPr id="2" name="Title 1">
            <a:extLst>
              <a:ext uri="{FF2B5EF4-FFF2-40B4-BE49-F238E27FC236}">
                <a16:creationId xmlns:a16="http://schemas.microsoft.com/office/drawing/2014/main" id="{DFF89896-24B9-D543-BC49-89300DAB7772}"/>
              </a:ext>
            </a:extLst>
          </p:cNvPr>
          <p:cNvSpPr>
            <a:spLocks noGrp="1"/>
          </p:cNvSpPr>
          <p:nvPr>
            <p:ph type="title"/>
          </p:nvPr>
        </p:nvSpPr>
        <p:spPr>
          <a:xfrm>
            <a:off x="1527048" y="1124712"/>
            <a:ext cx="7928237" cy="1442997"/>
          </a:xfrm>
          <a:prstGeom prst="rect">
            <a:avLst/>
          </a:prstGeom>
        </p:spPr>
        <p:txBody>
          <a:bodyPr anchor="b">
            <a:normAutofit/>
          </a:bodyPr>
          <a:lstStyle>
            <a:lvl1pPr>
              <a:defRPr sz="3600">
                <a:solidFill>
                  <a:schemeClr val="bg1"/>
                </a:solidFill>
              </a:defRPr>
            </a:lvl1pPr>
          </a:lstStyle>
          <a:p>
            <a:r>
              <a:rPr lang="en-US"/>
              <a:t>Click to edit Master title style</a:t>
            </a:r>
          </a:p>
        </p:txBody>
      </p:sp>
      <p:sp>
        <p:nvSpPr>
          <p:cNvPr id="3" name="Text Placeholder 2">
            <a:extLst>
              <a:ext uri="{FF2B5EF4-FFF2-40B4-BE49-F238E27FC236}">
                <a16:creationId xmlns:a16="http://schemas.microsoft.com/office/drawing/2014/main" id="{09384264-DB8D-274D-83EB-C183729E5934}"/>
              </a:ext>
            </a:extLst>
          </p:cNvPr>
          <p:cNvSpPr>
            <a:spLocks noGrp="1"/>
          </p:cNvSpPr>
          <p:nvPr>
            <p:ph type="body" idx="1"/>
          </p:nvPr>
        </p:nvSpPr>
        <p:spPr>
          <a:xfrm>
            <a:off x="1527048" y="2495399"/>
            <a:ext cx="7928237" cy="766273"/>
          </a:xfrm>
        </p:spPr>
        <p:txBody>
          <a:bodyPr/>
          <a:lstStyle>
            <a:lvl1pPr marL="0" indent="0">
              <a:buNone/>
              <a:defRPr sz="2400">
                <a:solidFill>
                  <a:schemeClr val="accent1">
                    <a:lumMod val="20000"/>
                    <a:lumOff val="80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pic>
        <p:nvPicPr>
          <p:cNvPr id="9" name="Picture 8">
            <a:extLst>
              <a:ext uri="{FF2B5EF4-FFF2-40B4-BE49-F238E27FC236}">
                <a16:creationId xmlns:a16="http://schemas.microsoft.com/office/drawing/2014/main" id="{6C403D84-AA45-1D40-9400-B1135229D764}"/>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30019" b="25694"/>
          <a:stretch/>
        </p:blipFill>
        <p:spPr>
          <a:xfrm>
            <a:off x="0" y="3261673"/>
            <a:ext cx="12186586" cy="3596327"/>
          </a:xfrm>
          <a:prstGeom prst="rect">
            <a:avLst/>
          </a:prstGeom>
        </p:spPr>
      </p:pic>
    </p:spTree>
    <p:extLst>
      <p:ext uri="{BB962C8B-B14F-4D97-AF65-F5344CB8AC3E}">
        <p14:creationId xmlns:p14="http://schemas.microsoft.com/office/powerpoint/2010/main" val="3117373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Section Header 2">
    <p:bg>
      <p:bgPr>
        <a:solidFill>
          <a:srgbClr val="001E44"/>
        </a:solidFill>
        <a:effectLst/>
      </p:bgPr>
    </p:bg>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F5CCD73-4F4C-6E40-91EC-E9DA02F326CB}"/>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b="52440"/>
          <a:stretch/>
        </p:blipFill>
        <p:spPr>
          <a:xfrm>
            <a:off x="5414" y="0"/>
            <a:ext cx="12181172" cy="3261674"/>
          </a:xfrm>
          <a:prstGeom prst="rect">
            <a:avLst/>
          </a:prstGeom>
        </p:spPr>
      </p:pic>
      <p:sp>
        <p:nvSpPr>
          <p:cNvPr id="2" name="Title 1">
            <a:extLst>
              <a:ext uri="{FF2B5EF4-FFF2-40B4-BE49-F238E27FC236}">
                <a16:creationId xmlns:a16="http://schemas.microsoft.com/office/drawing/2014/main" id="{DFF89896-24B9-D543-BC49-89300DAB7772}"/>
              </a:ext>
            </a:extLst>
          </p:cNvPr>
          <p:cNvSpPr>
            <a:spLocks noGrp="1"/>
          </p:cNvSpPr>
          <p:nvPr>
            <p:ph type="title"/>
          </p:nvPr>
        </p:nvSpPr>
        <p:spPr>
          <a:xfrm>
            <a:off x="1527048" y="1124712"/>
            <a:ext cx="7928237" cy="1442997"/>
          </a:xfrm>
          <a:prstGeom prst="rect">
            <a:avLst/>
          </a:prstGeom>
        </p:spPr>
        <p:txBody>
          <a:bodyPr anchor="b">
            <a:normAutofit/>
          </a:bodyPr>
          <a:lstStyle>
            <a:lvl1pPr>
              <a:defRPr sz="3600">
                <a:solidFill>
                  <a:schemeClr val="bg1"/>
                </a:solidFill>
              </a:defRPr>
            </a:lvl1pPr>
          </a:lstStyle>
          <a:p>
            <a:r>
              <a:rPr lang="en-US"/>
              <a:t>Click to edit Master title style</a:t>
            </a:r>
          </a:p>
        </p:txBody>
      </p:sp>
      <p:sp>
        <p:nvSpPr>
          <p:cNvPr id="3" name="Text Placeholder 2">
            <a:extLst>
              <a:ext uri="{FF2B5EF4-FFF2-40B4-BE49-F238E27FC236}">
                <a16:creationId xmlns:a16="http://schemas.microsoft.com/office/drawing/2014/main" id="{09384264-DB8D-274D-83EB-C183729E5934}"/>
              </a:ext>
            </a:extLst>
          </p:cNvPr>
          <p:cNvSpPr>
            <a:spLocks noGrp="1"/>
          </p:cNvSpPr>
          <p:nvPr>
            <p:ph type="body" idx="1"/>
          </p:nvPr>
        </p:nvSpPr>
        <p:spPr>
          <a:xfrm>
            <a:off x="1527048" y="2495400"/>
            <a:ext cx="7928237" cy="672674"/>
          </a:xfrm>
        </p:spPr>
        <p:txBody>
          <a:bodyPr/>
          <a:lstStyle>
            <a:lvl1pPr marL="0" indent="0">
              <a:buNone/>
              <a:defRPr sz="2400">
                <a:solidFill>
                  <a:schemeClr val="accent1">
                    <a:lumMod val="20000"/>
                    <a:lumOff val="80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8" name="Picture Placeholder 7">
            <a:extLst>
              <a:ext uri="{FF2B5EF4-FFF2-40B4-BE49-F238E27FC236}">
                <a16:creationId xmlns:a16="http://schemas.microsoft.com/office/drawing/2014/main" id="{EF58B01F-C66D-C041-B01B-9D8150197C3E}"/>
              </a:ext>
            </a:extLst>
          </p:cNvPr>
          <p:cNvSpPr>
            <a:spLocks noGrp="1"/>
          </p:cNvSpPr>
          <p:nvPr>
            <p:ph type="pic" sz="quarter" idx="10"/>
          </p:nvPr>
        </p:nvSpPr>
        <p:spPr>
          <a:xfrm>
            <a:off x="0" y="3262313"/>
            <a:ext cx="12192000" cy="3595687"/>
          </a:xfrm>
        </p:spPr>
        <p:txBody>
          <a:bodyPr/>
          <a:lstStyle/>
          <a:p>
            <a:endParaRPr lang="en-US"/>
          </a:p>
        </p:txBody>
      </p:sp>
    </p:spTree>
    <p:extLst>
      <p:ext uri="{BB962C8B-B14F-4D97-AF65-F5344CB8AC3E}">
        <p14:creationId xmlns:p14="http://schemas.microsoft.com/office/powerpoint/2010/main" val="24829362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Closing ">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4851C92B-9FEA-5643-8E61-4A0757AD8E3A}"/>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5414" y="0"/>
            <a:ext cx="12181172" cy="6858000"/>
          </a:xfrm>
          <a:prstGeom prst="rect">
            <a:avLst/>
          </a:prstGeom>
        </p:spPr>
      </p:pic>
      <p:pic>
        <p:nvPicPr>
          <p:cNvPr id="9" name="Picture 8">
            <a:extLst>
              <a:ext uri="{FF2B5EF4-FFF2-40B4-BE49-F238E27FC236}">
                <a16:creationId xmlns:a16="http://schemas.microsoft.com/office/drawing/2014/main" id="{37D03306-2E4A-D447-A57E-3DFA585649E0}"/>
              </a:ext>
            </a:extLst>
          </p:cNvPr>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343158" y="5077568"/>
            <a:ext cx="2596403" cy="1200150"/>
          </a:xfrm>
          <a:prstGeom prst="rect">
            <a:avLst/>
          </a:prstGeom>
        </p:spPr>
      </p:pic>
      <p:sp>
        <p:nvSpPr>
          <p:cNvPr id="2" name="Title 1">
            <a:extLst>
              <a:ext uri="{FF2B5EF4-FFF2-40B4-BE49-F238E27FC236}">
                <a16:creationId xmlns:a16="http://schemas.microsoft.com/office/drawing/2014/main" id="{9E4E5EF8-3F55-CC40-8877-5D48D7C0631B}"/>
              </a:ext>
            </a:extLst>
          </p:cNvPr>
          <p:cNvSpPr>
            <a:spLocks noGrp="1"/>
          </p:cNvSpPr>
          <p:nvPr>
            <p:ph type="ctrTitle" hasCustomPrompt="1"/>
          </p:nvPr>
        </p:nvSpPr>
        <p:spPr>
          <a:xfrm>
            <a:off x="1524000" y="1122363"/>
            <a:ext cx="9144000" cy="1570961"/>
          </a:xfrm>
          <a:prstGeom prst="rect">
            <a:avLst/>
          </a:prstGeom>
        </p:spPr>
        <p:txBody>
          <a:bodyPr anchor="b">
            <a:normAutofit/>
          </a:bodyPr>
          <a:lstStyle>
            <a:lvl1pPr algn="l">
              <a:defRPr sz="4400">
                <a:solidFill>
                  <a:schemeClr val="bg1"/>
                </a:solidFill>
              </a:defRPr>
            </a:lvl1pPr>
          </a:lstStyle>
          <a:p>
            <a:r>
              <a:rPr lang="en-US"/>
              <a:t>Thank you.</a:t>
            </a:r>
          </a:p>
        </p:txBody>
      </p:sp>
      <p:sp>
        <p:nvSpPr>
          <p:cNvPr id="3" name="Subtitle 2">
            <a:extLst>
              <a:ext uri="{FF2B5EF4-FFF2-40B4-BE49-F238E27FC236}">
                <a16:creationId xmlns:a16="http://schemas.microsoft.com/office/drawing/2014/main" id="{BFD648D3-80FB-6246-9942-F676252E6F93}"/>
              </a:ext>
            </a:extLst>
          </p:cNvPr>
          <p:cNvSpPr>
            <a:spLocks noGrp="1"/>
          </p:cNvSpPr>
          <p:nvPr>
            <p:ph type="subTitle" idx="1" hasCustomPrompt="1"/>
          </p:nvPr>
        </p:nvSpPr>
        <p:spPr>
          <a:xfrm>
            <a:off x="1524000" y="3797665"/>
            <a:ext cx="5139447" cy="1279903"/>
          </a:xfrm>
        </p:spPr>
        <p:txBody>
          <a:bodyPr/>
          <a:lstStyle>
            <a:lvl1pPr marL="0" indent="0" algn="l">
              <a:buNone/>
              <a:defRPr sz="24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ontact information</a:t>
            </a:r>
          </a:p>
        </p:txBody>
      </p:sp>
    </p:spTree>
    <p:extLst>
      <p:ext uri="{BB962C8B-B14F-4D97-AF65-F5344CB8AC3E}">
        <p14:creationId xmlns:p14="http://schemas.microsoft.com/office/powerpoint/2010/main" val="38706628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userDrawn="1">
  <p:cSld name="Title and Content 3">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10D1FE8A-B770-A54B-BB1F-BB647AC8A8FD}"/>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9780445" y="3993267"/>
            <a:ext cx="2411555" cy="2864733"/>
          </a:xfrm>
          <a:prstGeom prst="rect">
            <a:avLst/>
          </a:prstGeom>
        </p:spPr>
      </p:pic>
      <p:sp>
        <p:nvSpPr>
          <p:cNvPr id="2" name="Title 1">
            <a:extLst>
              <a:ext uri="{FF2B5EF4-FFF2-40B4-BE49-F238E27FC236}">
                <a16:creationId xmlns:a16="http://schemas.microsoft.com/office/drawing/2014/main" id="{B0115303-0D88-FC4F-A64A-0DABCD2F0B90}"/>
              </a:ext>
            </a:extLst>
          </p:cNvPr>
          <p:cNvSpPr>
            <a:spLocks noGrp="1"/>
          </p:cNvSpPr>
          <p:nvPr>
            <p:ph type="title"/>
          </p:nvPr>
        </p:nvSpPr>
        <p:spPr>
          <a:xfrm>
            <a:off x="838200" y="365125"/>
            <a:ext cx="10515600" cy="886159"/>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E5C8021D-5040-E443-B438-B5DF5DB17BBB}"/>
              </a:ext>
            </a:extLst>
          </p:cNvPr>
          <p:cNvSpPr>
            <a:spLocks noGrp="1"/>
          </p:cNvSpPr>
          <p:nvPr>
            <p:ph idx="1"/>
          </p:nvPr>
        </p:nvSpPr>
        <p:spPr>
          <a:xfrm>
            <a:off x="838200" y="1250951"/>
            <a:ext cx="10515600" cy="428408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pic>
        <p:nvPicPr>
          <p:cNvPr id="8" name="Picture 7">
            <a:extLst>
              <a:ext uri="{FF2B5EF4-FFF2-40B4-BE49-F238E27FC236}">
                <a16:creationId xmlns:a16="http://schemas.microsoft.com/office/drawing/2014/main" id="{88728744-A790-8648-9D59-4DCBBF5298FE}"/>
              </a:ext>
            </a:extLst>
          </p:cNvPr>
          <p:cNvPicPr>
            <a:picLocks noChangeAspect="1"/>
          </p:cNvPicPr>
          <p:nvPr userDrawn="1"/>
        </p:nvPicPr>
        <p:blipFill rotWithShape="1">
          <a:blip r:embed="rId3"/>
          <a:srcRect l="5272" t="13428" r="5705" b="18819"/>
          <a:stretch/>
        </p:blipFill>
        <p:spPr>
          <a:xfrm>
            <a:off x="8032866" y="6148022"/>
            <a:ext cx="1784465" cy="621545"/>
          </a:xfrm>
          <a:prstGeom prst="rect">
            <a:avLst/>
          </a:prstGeom>
        </p:spPr>
      </p:pic>
      <p:sp>
        <p:nvSpPr>
          <p:cNvPr id="5" name="Text Placeholder 4">
            <a:extLst>
              <a:ext uri="{FF2B5EF4-FFF2-40B4-BE49-F238E27FC236}">
                <a16:creationId xmlns:a16="http://schemas.microsoft.com/office/drawing/2014/main" id="{06062243-C1CF-714B-A683-D890075FBD68}"/>
              </a:ext>
            </a:extLst>
          </p:cNvPr>
          <p:cNvSpPr>
            <a:spLocks noGrp="1"/>
          </p:cNvSpPr>
          <p:nvPr>
            <p:ph type="body" sz="quarter" idx="10"/>
          </p:nvPr>
        </p:nvSpPr>
        <p:spPr>
          <a:xfrm>
            <a:off x="838200" y="5592763"/>
            <a:ext cx="6516688" cy="836612"/>
          </a:xfrm>
        </p:spPr>
        <p:txBody>
          <a:bodyPr/>
          <a:lstStyle>
            <a:lvl1pPr>
              <a:defRPr sz="2000"/>
            </a:lvl1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1779427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3AF0656E-DA2F-C14C-BF10-2FC3587B408B}"/>
              </a:ext>
            </a:extLst>
          </p:cNvPr>
          <p:cNvSpPr>
            <a:spLocks noGrp="1"/>
          </p:cNvSpPr>
          <p:nvPr>
            <p:ph type="body" idx="1"/>
          </p:nvPr>
        </p:nvSpPr>
        <p:spPr>
          <a:xfrm>
            <a:off x="838200" y="1251284"/>
            <a:ext cx="10515600" cy="4925679"/>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55C3011-D639-B54B-9228-EB3085D04C0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FEC4368-C769-8143-B102-F97927FA2E0C}" type="datetimeFigureOut">
              <a:rPr lang="en-US" smtClean="0"/>
              <a:t>1/24/24</a:t>
            </a:fld>
            <a:endParaRPr lang="en-US"/>
          </a:p>
        </p:txBody>
      </p:sp>
      <p:sp>
        <p:nvSpPr>
          <p:cNvPr id="7" name="Title Placeholder 6">
            <a:extLst>
              <a:ext uri="{FF2B5EF4-FFF2-40B4-BE49-F238E27FC236}">
                <a16:creationId xmlns:a16="http://schemas.microsoft.com/office/drawing/2014/main" id="{A5E7B941-CE32-1D43-B287-BCB25BBF8FE2}"/>
              </a:ext>
            </a:extLst>
          </p:cNvPr>
          <p:cNvSpPr>
            <a:spLocks noGrp="1"/>
          </p:cNvSpPr>
          <p:nvPr>
            <p:ph type="title"/>
          </p:nvPr>
        </p:nvSpPr>
        <p:spPr>
          <a:xfrm>
            <a:off x="838200" y="365126"/>
            <a:ext cx="10515600" cy="753812"/>
          </a:xfrm>
          <a:prstGeom prst="rect">
            <a:avLst/>
          </a:prstGeom>
        </p:spPr>
        <p:txBody>
          <a:bodyPr vert="horz" lIns="91440" tIns="45720" rIns="91440" bIns="45720" rtlCol="0" anchor="ctr">
            <a:normAutofit/>
          </a:bodyPr>
          <a:lstStyle/>
          <a:p>
            <a:r>
              <a:rPr lang="en-US"/>
              <a:t>Click to edit Master title style</a:t>
            </a:r>
          </a:p>
        </p:txBody>
      </p:sp>
    </p:spTree>
    <p:extLst>
      <p:ext uri="{BB962C8B-B14F-4D97-AF65-F5344CB8AC3E}">
        <p14:creationId xmlns:p14="http://schemas.microsoft.com/office/powerpoint/2010/main" val="33394305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63" r:id="rId5"/>
    <p:sldLayoutId id="2147483662" r:id="rId6"/>
    <p:sldLayoutId id="2147483664" r:id="rId7"/>
  </p:sldLayoutIdLst>
  <p:txStyles>
    <p:titleStyle>
      <a:lvl1pPr algn="l" defTabSz="914400" rtl="0" eaLnBrk="1" latinLnBrk="0" hangingPunct="1">
        <a:lnSpc>
          <a:spcPct val="90000"/>
        </a:lnSpc>
        <a:spcBef>
          <a:spcPct val="0"/>
        </a:spcBef>
        <a:buNone/>
        <a:defRPr sz="3800" kern="1200" baseline="0">
          <a:solidFill>
            <a:schemeClr val="accent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6.xml"/><Relationship Id="rId2" Type="http://schemas.openxmlformats.org/officeDocument/2006/relationships/audio" Target="../media/media1.m4a"/><Relationship Id="rId1" Type="http://schemas.microsoft.com/office/2007/relationships/media" Target="../media/media1.m4a"/><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12.m4a"/><Relationship Id="rId1" Type="http://schemas.microsoft.com/office/2007/relationships/media" Target="../media/media12.m4a"/><Relationship Id="rId4" Type="http://schemas.openxmlformats.org/officeDocument/2006/relationships/image" Target="../media/image6.png"/></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6.xml"/><Relationship Id="rId2" Type="http://schemas.openxmlformats.org/officeDocument/2006/relationships/audio" Target="../media/media2.m4a"/><Relationship Id="rId1" Type="http://schemas.microsoft.com/office/2007/relationships/media" Target="../media/media2.m4a"/><Relationship Id="rId5" Type="http://schemas.openxmlformats.org/officeDocument/2006/relationships/image" Target="../media/image6.png"/><Relationship Id="rId4"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audio" Target="../media/media3.m4a"/><Relationship Id="rId1" Type="http://schemas.microsoft.com/office/2007/relationships/media" Target="../media/media3.m4a"/><Relationship Id="rId6" Type="http://schemas.openxmlformats.org/officeDocument/2006/relationships/image" Target="../media/image6.png"/><Relationship Id="rId5" Type="http://schemas.openxmlformats.org/officeDocument/2006/relationships/image" Target="../media/image8.png"/><Relationship Id="rId4"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26" Type="http://schemas.openxmlformats.org/officeDocument/2006/relationships/image" Target="../media/image16.png"/><Relationship Id="rId21" Type="http://schemas.openxmlformats.org/officeDocument/2006/relationships/customXml" Target="../ink/ink7.xml"/><Relationship Id="rId42" Type="http://schemas.openxmlformats.org/officeDocument/2006/relationships/image" Target="../media/image24.png"/><Relationship Id="rId47" Type="http://schemas.openxmlformats.org/officeDocument/2006/relationships/customXml" Target="../ink/ink20.xml"/><Relationship Id="rId63" Type="http://schemas.openxmlformats.org/officeDocument/2006/relationships/customXml" Target="../ink/ink28.xml"/><Relationship Id="rId68" Type="http://schemas.openxmlformats.org/officeDocument/2006/relationships/image" Target="../media/image37.png"/><Relationship Id="rId16" Type="http://schemas.openxmlformats.org/officeDocument/2006/relationships/image" Target="../media/image110.png"/><Relationship Id="rId11" Type="http://schemas.openxmlformats.org/officeDocument/2006/relationships/customXml" Target="../ink/ink2.xml"/><Relationship Id="rId24" Type="http://schemas.openxmlformats.org/officeDocument/2006/relationships/image" Target="../media/image15.png"/><Relationship Id="rId32" Type="http://schemas.openxmlformats.org/officeDocument/2006/relationships/image" Target="../media/image19.png"/><Relationship Id="rId37" Type="http://schemas.openxmlformats.org/officeDocument/2006/relationships/customXml" Target="../ink/ink15.xml"/><Relationship Id="rId40" Type="http://schemas.openxmlformats.org/officeDocument/2006/relationships/image" Target="../media/image23.png"/><Relationship Id="rId45" Type="http://schemas.openxmlformats.org/officeDocument/2006/relationships/customXml" Target="../ink/ink19.xml"/><Relationship Id="rId53" Type="http://schemas.openxmlformats.org/officeDocument/2006/relationships/customXml" Target="../ink/ink23.xml"/><Relationship Id="rId58" Type="http://schemas.openxmlformats.org/officeDocument/2006/relationships/image" Target="../media/image32.png"/><Relationship Id="rId66" Type="http://schemas.openxmlformats.org/officeDocument/2006/relationships/image" Target="../media/image36.png"/><Relationship Id="rId74" Type="http://schemas.openxmlformats.org/officeDocument/2006/relationships/customXml" Target="../ink/ink33.xml"/><Relationship Id="rId5" Type="http://schemas.openxmlformats.org/officeDocument/2006/relationships/image" Target="../media/image9.png"/><Relationship Id="rId61" Type="http://schemas.openxmlformats.org/officeDocument/2006/relationships/customXml" Target="../ink/ink27.xml"/><Relationship Id="rId19" Type="http://schemas.openxmlformats.org/officeDocument/2006/relationships/customXml" Target="../ink/ink6.xml"/><Relationship Id="rId14" Type="http://schemas.openxmlformats.org/officeDocument/2006/relationships/image" Target="../media/image103.png"/><Relationship Id="rId22" Type="http://schemas.openxmlformats.org/officeDocument/2006/relationships/image" Target="../media/image14.png"/><Relationship Id="rId27" Type="http://schemas.openxmlformats.org/officeDocument/2006/relationships/customXml" Target="../ink/ink10.xml"/><Relationship Id="rId30" Type="http://schemas.openxmlformats.org/officeDocument/2006/relationships/image" Target="../media/image18.png"/><Relationship Id="rId35" Type="http://schemas.openxmlformats.org/officeDocument/2006/relationships/customXml" Target="../ink/ink14.xml"/><Relationship Id="rId43" Type="http://schemas.openxmlformats.org/officeDocument/2006/relationships/customXml" Target="../ink/ink18.xml"/><Relationship Id="rId48" Type="http://schemas.openxmlformats.org/officeDocument/2006/relationships/image" Target="../media/image27.png"/><Relationship Id="rId56" Type="http://schemas.openxmlformats.org/officeDocument/2006/relationships/image" Target="../media/image31.png"/><Relationship Id="rId64" Type="http://schemas.openxmlformats.org/officeDocument/2006/relationships/image" Target="../media/image35.png"/><Relationship Id="rId69" Type="http://schemas.openxmlformats.org/officeDocument/2006/relationships/customXml" Target="../ink/ink31.xml"/><Relationship Id="rId77" Type="http://schemas.openxmlformats.org/officeDocument/2006/relationships/image" Target="../media/image41.png"/><Relationship Id="rId8" Type="http://schemas.microsoft.com/office/2007/relationships/hdphoto" Target="../media/hdphoto1.wdp"/><Relationship Id="rId51" Type="http://schemas.openxmlformats.org/officeDocument/2006/relationships/customXml" Target="../ink/ink22.xml"/><Relationship Id="rId72" Type="http://schemas.openxmlformats.org/officeDocument/2006/relationships/image" Target="../media/image39.png"/><Relationship Id="rId3" Type="http://schemas.openxmlformats.org/officeDocument/2006/relationships/slideLayout" Target="../slideLayouts/slideLayout2.xml"/><Relationship Id="rId12" Type="http://schemas.openxmlformats.org/officeDocument/2006/relationships/image" Target="../media/image111.png"/><Relationship Id="rId17" Type="http://schemas.openxmlformats.org/officeDocument/2006/relationships/customXml" Target="../ink/ink5.xml"/><Relationship Id="rId25" Type="http://schemas.openxmlformats.org/officeDocument/2006/relationships/customXml" Target="../ink/ink9.xml"/><Relationship Id="rId33" Type="http://schemas.openxmlformats.org/officeDocument/2006/relationships/customXml" Target="../ink/ink13.xml"/><Relationship Id="rId38" Type="http://schemas.openxmlformats.org/officeDocument/2006/relationships/image" Target="../media/image22.png"/><Relationship Id="rId46" Type="http://schemas.openxmlformats.org/officeDocument/2006/relationships/image" Target="../media/image26.png"/><Relationship Id="rId59" Type="http://schemas.openxmlformats.org/officeDocument/2006/relationships/customXml" Target="../ink/ink26.xml"/><Relationship Id="rId67" Type="http://schemas.openxmlformats.org/officeDocument/2006/relationships/customXml" Target="../ink/ink30.xml"/><Relationship Id="rId20" Type="http://schemas.openxmlformats.org/officeDocument/2006/relationships/image" Target="../media/image13.png"/><Relationship Id="rId41" Type="http://schemas.openxmlformats.org/officeDocument/2006/relationships/customXml" Target="../ink/ink17.xml"/><Relationship Id="rId54" Type="http://schemas.openxmlformats.org/officeDocument/2006/relationships/image" Target="../media/image30.png"/><Relationship Id="rId62" Type="http://schemas.openxmlformats.org/officeDocument/2006/relationships/image" Target="../media/image34.png"/><Relationship Id="rId70" Type="http://schemas.openxmlformats.org/officeDocument/2006/relationships/image" Target="../media/image38.png"/><Relationship Id="rId75" Type="http://schemas.openxmlformats.org/officeDocument/2006/relationships/image" Target="../media/image40.png"/><Relationship Id="rId1" Type="http://schemas.microsoft.com/office/2007/relationships/media" Target="../media/media4.m4a"/><Relationship Id="rId6" Type="http://schemas.openxmlformats.org/officeDocument/2006/relationships/image" Target="../media/image10.png"/><Relationship Id="rId15" Type="http://schemas.openxmlformats.org/officeDocument/2006/relationships/customXml" Target="../ink/ink4.xml"/><Relationship Id="rId23" Type="http://schemas.openxmlformats.org/officeDocument/2006/relationships/customXml" Target="../ink/ink8.xml"/><Relationship Id="rId28" Type="http://schemas.openxmlformats.org/officeDocument/2006/relationships/image" Target="../media/image17.png"/><Relationship Id="rId36" Type="http://schemas.openxmlformats.org/officeDocument/2006/relationships/image" Target="../media/image21.png"/><Relationship Id="rId49" Type="http://schemas.openxmlformats.org/officeDocument/2006/relationships/customXml" Target="../ink/ink21.xml"/><Relationship Id="rId57" Type="http://schemas.openxmlformats.org/officeDocument/2006/relationships/customXml" Target="../ink/ink25.xml"/><Relationship Id="rId10" Type="http://schemas.openxmlformats.org/officeDocument/2006/relationships/image" Target="../media/image102.png"/><Relationship Id="rId31" Type="http://schemas.openxmlformats.org/officeDocument/2006/relationships/customXml" Target="../ink/ink12.xml"/><Relationship Id="rId44" Type="http://schemas.openxmlformats.org/officeDocument/2006/relationships/image" Target="../media/image25.png"/><Relationship Id="rId52" Type="http://schemas.openxmlformats.org/officeDocument/2006/relationships/image" Target="../media/image29.png"/><Relationship Id="rId60" Type="http://schemas.openxmlformats.org/officeDocument/2006/relationships/image" Target="../media/image33.png"/><Relationship Id="rId65" Type="http://schemas.openxmlformats.org/officeDocument/2006/relationships/customXml" Target="../ink/ink29.xml"/><Relationship Id="rId73" Type="http://schemas.openxmlformats.org/officeDocument/2006/relationships/image" Target="../media/image8.png"/><Relationship Id="rId78" Type="http://schemas.openxmlformats.org/officeDocument/2006/relationships/image" Target="../media/image6.png"/><Relationship Id="rId4" Type="http://schemas.openxmlformats.org/officeDocument/2006/relationships/notesSlide" Target="../notesSlides/notesSlide4.xml"/><Relationship Id="rId9" Type="http://schemas.openxmlformats.org/officeDocument/2006/relationships/customXml" Target="../ink/ink1.xml"/><Relationship Id="rId13" Type="http://schemas.openxmlformats.org/officeDocument/2006/relationships/customXml" Target="../ink/ink3.xml"/><Relationship Id="rId18" Type="http://schemas.openxmlformats.org/officeDocument/2006/relationships/image" Target="../media/image12.png"/><Relationship Id="rId39" Type="http://schemas.openxmlformats.org/officeDocument/2006/relationships/customXml" Target="../ink/ink16.xml"/><Relationship Id="rId34" Type="http://schemas.openxmlformats.org/officeDocument/2006/relationships/image" Target="../media/image20.png"/><Relationship Id="rId50" Type="http://schemas.openxmlformats.org/officeDocument/2006/relationships/image" Target="../media/image28.png"/><Relationship Id="rId55" Type="http://schemas.openxmlformats.org/officeDocument/2006/relationships/customXml" Target="../ink/ink24.xml"/><Relationship Id="rId76" Type="http://schemas.openxmlformats.org/officeDocument/2006/relationships/customXml" Target="../ink/ink34.xml"/><Relationship Id="rId7" Type="http://schemas.openxmlformats.org/officeDocument/2006/relationships/image" Target="../media/image11.png"/><Relationship Id="rId71" Type="http://schemas.openxmlformats.org/officeDocument/2006/relationships/customXml" Target="../ink/ink32.xml"/><Relationship Id="rId2" Type="http://schemas.openxmlformats.org/officeDocument/2006/relationships/audio" Target="../media/media4.m4a"/><Relationship Id="rId29" Type="http://schemas.openxmlformats.org/officeDocument/2006/relationships/customXml" Target="../ink/ink11.xml"/></Relationships>
</file>

<file path=ppt/slides/_rels/slide5.xml.rels><?xml version="1.0" encoding="UTF-8" standalone="yes"?>
<Relationships xmlns="http://schemas.openxmlformats.org/package/2006/relationships"><Relationship Id="rId26" Type="http://schemas.openxmlformats.org/officeDocument/2006/relationships/image" Target="../media/image49.png"/><Relationship Id="rId21" Type="http://schemas.openxmlformats.org/officeDocument/2006/relationships/customXml" Target="../ink/ink42.xml"/><Relationship Id="rId42" Type="http://schemas.openxmlformats.org/officeDocument/2006/relationships/image" Target="../media/image57.png"/><Relationship Id="rId47" Type="http://schemas.openxmlformats.org/officeDocument/2006/relationships/customXml" Target="../ink/ink55.xml"/><Relationship Id="rId63" Type="http://schemas.openxmlformats.org/officeDocument/2006/relationships/image" Target="../media/image12.jpeg"/><Relationship Id="rId68" Type="http://schemas.openxmlformats.org/officeDocument/2006/relationships/image" Target="../media/image69.png"/><Relationship Id="rId71" Type="http://schemas.openxmlformats.org/officeDocument/2006/relationships/customXml" Target="../ink/ink66.xml"/><Relationship Id="rId2" Type="http://schemas.openxmlformats.org/officeDocument/2006/relationships/audio" Target="../media/media5.m4a"/><Relationship Id="rId16" Type="http://schemas.openxmlformats.org/officeDocument/2006/relationships/image" Target="../media/image44.png"/><Relationship Id="rId29" Type="http://schemas.openxmlformats.org/officeDocument/2006/relationships/customXml" Target="../ink/ink46.xml"/><Relationship Id="rId11" Type="http://schemas.openxmlformats.org/officeDocument/2006/relationships/customXml" Target="../ink/ink37.xml"/><Relationship Id="rId24" Type="http://schemas.openxmlformats.org/officeDocument/2006/relationships/image" Target="../media/image48.png"/><Relationship Id="rId32" Type="http://schemas.openxmlformats.org/officeDocument/2006/relationships/image" Target="../media/image52.png"/><Relationship Id="rId37" Type="http://schemas.openxmlformats.org/officeDocument/2006/relationships/customXml" Target="../ink/ink50.xml"/><Relationship Id="rId40" Type="http://schemas.openxmlformats.org/officeDocument/2006/relationships/image" Target="../media/image56.png"/><Relationship Id="rId45" Type="http://schemas.openxmlformats.org/officeDocument/2006/relationships/customXml" Target="../ink/ink54.xml"/><Relationship Id="rId53" Type="http://schemas.openxmlformats.org/officeDocument/2006/relationships/customXml" Target="../ink/ink58.xml"/><Relationship Id="rId58" Type="http://schemas.openxmlformats.org/officeDocument/2006/relationships/image" Target="../media/image65.png"/><Relationship Id="rId66" Type="http://schemas.openxmlformats.org/officeDocument/2006/relationships/image" Target="../media/image10.png"/><Relationship Id="rId5" Type="http://schemas.openxmlformats.org/officeDocument/2006/relationships/customXml" Target="../ink/ink35.xml"/><Relationship Id="rId61" Type="http://schemas.openxmlformats.org/officeDocument/2006/relationships/customXml" Target="../ink/ink62.xml"/><Relationship Id="rId19" Type="http://schemas.openxmlformats.org/officeDocument/2006/relationships/customXml" Target="../ink/ink41.xml"/><Relationship Id="rId14" Type="http://schemas.openxmlformats.org/officeDocument/2006/relationships/image" Target="../media/image43.png"/><Relationship Id="rId22" Type="http://schemas.openxmlformats.org/officeDocument/2006/relationships/image" Target="../media/image47.png"/><Relationship Id="rId27" Type="http://schemas.openxmlformats.org/officeDocument/2006/relationships/customXml" Target="../ink/ink45.xml"/><Relationship Id="rId30" Type="http://schemas.openxmlformats.org/officeDocument/2006/relationships/image" Target="../media/image51.png"/><Relationship Id="rId35" Type="http://schemas.openxmlformats.org/officeDocument/2006/relationships/customXml" Target="../ink/ink49.xml"/><Relationship Id="rId43" Type="http://schemas.openxmlformats.org/officeDocument/2006/relationships/customXml" Target="../ink/ink53.xml"/><Relationship Id="rId48" Type="http://schemas.openxmlformats.org/officeDocument/2006/relationships/image" Target="../media/image60.png"/><Relationship Id="rId56" Type="http://schemas.openxmlformats.org/officeDocument/2006/relationships/image" Target="../media/image64.png"/><Relationship Id="rId64" Type="http://schemas.openxmlformats.org/officeDocument/2006/relationships/customXml" Target="../ink/ink63.xml"/><Relationship Id="rId69" Type="http://schemas.openxmlformats.org/officeDocument/2006/relationships/customXml" Target="../ink/ink65.xml"/><Relationship Id="rId8" Type="http://schemas.openxmlformats.org/officeDocument/2006/relationships/image" Target="../media/image400.png"/><Relationship Id="rId51" Type="http://schemas.openxmlformats.org/officeDocument/2006/relationships/customXml" Target="../ink/ink57.xml"/><Relationship Id="rId72" Type="http://schemas.openxmlformats.org/officeDocument/2006/relationships/image" Target="../media/image71.png"/><Relationship Id="rId3" Type="http://schemas.openxmlformats.org/officeDocument/2006/relationships/slideLayout" Target="../slideLayouts/slideLayout2.xml"/><Relationship Id="rId12" Type="http://schemas.openxmlformats.org/officeDocument/2006/relationships/image" Target="../media/image42.png"/><Relationship Id="rId17" Type="http://schemas.openxmlformats.org/officeDocument/2006/relationships/customXml" Target="../ink/ink40.xml"/><Relationship Id="rId25" Type="http://schemas.openxmlformats.org/officeDocument/2006/relationships/customXml" Target="../ink/ink44.xml"/><Relationship Id="rId33" Type="http://schemas.openxmlformats.org/officeDocument/2006/relationships/customXml" Target="../ink/ink48.xml"/><Relationship Id="rId38" Type="http://schemas.openxmlformats.org/officeDocument/2006/relationships/image" Target="../media/image55.png"/><Relationship Id="rId46" Type="http://schemas.openxmlformats.org/officeDocument/2006/relationships/image" Target="../media/image59.png"/><Relationship Id="rId59" Type="http://schemas.openxmlformats.org/officeDocument/2006/relationships/customXml" Target="../ink/ink61.xml"/><Relationship Id="rId67" Type="http://schemas.openxmlformats.org/officeDocument/2006/relationships/customXml" Target="../ink/ink64.xml"/><Relationship Id="rId20" Type="http://schemas.openxmlformats.org/officeDocument/2006/relationships/image" Target="../media/image46.png"/><Relationship Id="rId41" Type="http://schemas.openxmlformats.org/officeDocument/2006/relationships/customXml" Target="../ink/ink52.xml"/><Relationship Id="rId54" Type="http://schemas.openxmlformats.org/officeDocument/2006/relationships/image" Target="../media/image63.png"/><Relationship Id="rId62" Type="http://schemas.openxmlformats.org/officeDocument/2006/relationships/image" Target="../media/image67.png"/><Relationship Id="rId70" Type="http://schemas.openxmlformats.org/officeDocument/2006/relationships/image" Target="../media/image70.png"/><Relationship Id="rId1" Type="http://schemas.microsoft.com/office/2007/relationships/media" Target="../media/media5.m4a"/><Relationship Id="rId15" Type="http://schemas.openxmlformats.org/officeDocument/2006/relationships/customXml" Target="../ink/ink39.xml"/><Relationship Id="rId23" Type="http://schemas.openxmlformats.org/officeDocument/2006/relationships/customXml" Target="../ink/ink43.xml"/><Relationship Id="rId28" Type="http://schemas.openxmlformats.org/officeDocument/2006/relationships/image" Target="../media/image50.png"/><Relationship Id="rId36" Type="http://schemas.openxmlformats.org/officeDocument/2006/relationships/image" Target="../media/image54.png"/><Relationship Id="rId49" Type="http://schemas.openxmlformats.org/officeDocument/2006/relationships/customXml" Target="../ink/ink56.xml"/><Relationship Id="rId57" Type="http://schemas.openxmlformats.org/officeDocument/2006/relationships/customXml" Target="../ink/ink60.xml"/><Relationship Id="rId10" Type="http://schemas.openxmlformats.org/officeDocument/2006/relationships/image" Target="../media/image410.png"/><Relationship Id="rId31" Type="http://schemas.openxmlformats.org/officeDocument/2006/relationships/customXml" Target="../ink/ink47.xml"/><Relationship Id="rId44" Type="http://schemas.openxmlformats.org/officeDocument/2006/relationships/image" Target="../media/image58.png"/><Relationship Id="rId52" Type="http://schemas.openxmlformats.org/officeDocument/2006/relationships/image" Target="../media/image62.png"/><Relationship Id="rId60" Type="http://schemas.openxmlformats.org/officeDocument/2006/relationships/image" Target="../media/image66.png"/><Relationship Id="rId65" Type="http://schemas.openxmlformats.org/officeDocument/2006/relationships/image" Target="../media/image68.png"/><Relationship Id="rId73" Type="http://schemas.openxmlformats.org/officeDocument/2006/relationships/image" Target="../media/image6.png"/><Relationship Id="rId4" Type="http://schemas.openxmlformats.org/officeDocument/2006/relationships/notesSlide" Target="../notesSlides/notesSlide5.xml"/><Relationship Id="rId9" Type="http://schemas.openxmlformats.org/officeDocument/2006/relationships/customXml" Target="../ink/ink36.xml"/><Relationship Id="rId13" Type="http://schemas.openxmlformats.org/officeDocument/2006/relationships/customXml" Target="../ink/ink38.xml"/><Relationship Id="rId18" Type="http://schemas.openxmlformats.org/officeDocument/2006/relationships/image" Target="../media/image45.png"/><Relationship Id="rId39" Type="http://schemas.openxmlformats.org/officeDocument/2006/relationships/customXml" Target="../ink/ink51.xml"/><Relationship Id="rId34" Type="http://schemas.openxmlformats.org/officeDocument/2006/relationships/image" Target="../media/image53.png"/><Relationship Id="rId50" Type="http://schemas.openxmlformats.org/officeDocument/2006/relationships/image" Target="../media/image61.png"/><Relationship Id="rId55" Type="http://schemas.openxmlformats.org/officeDocument/2006/relationships/customXml" Target="../ink/ink59.xml"/></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2.xml"/><Relationship Id="rId7" Type="http://schemas.openxmlformats.org/officeDocument/2006/relationships/image" Target="../media/image6.png"/><Relationship Id="rId2" Type="http://schemas.openxmlformats.org/officeDocument/2006/relationships/audio" Target="../media/media6.m4a"/><Relationship Id="rId1" Type="http://schemas.microsoft.com/office/2007/relationships/media" Target="../media/media6.m4a"/><Relationship Id="rId6" Type="http://schemas.openxmlformats.org/officeDocument/2006/relationships/image" Target="../media/image72.png"/><Relationship Id="rId5" Type="http://schemas.openxmlformats.org/officeDocument/2006/relationships/image" Target="../media/image8.png"/><Relationship Id="rId4"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8" Type="http://schemas.openxmlformats.org/officeDocument/2006/relationships/image" Target="../media/image6.png"/><Relationship Id="rId3" Type="http://schemas.microsoft.com/office/2007/relationships/media" Target="../media/media8.m4a"/><Relationship Id="rId7" Type="http://schemas.openxmlformats.org/officeDocument/2006/relationships/image" Target="../media/image73.png"/><Relationship Id="rId2" Type="http://schemas.openxmlformats.org/officeDocument/2006/relationships/video" Target="../media/media7.mp4"/><Relationship Id="rId1" Type="http://schemas.microsoft.com/office/2007/relationships/media" Target="../media/media7.mp4"/><Relationship Id="rId6" Type="http://schemas.openxmlformats.org/officeDocument/2006/relationships/notesSlide" Target="../notesSlides/notesSlide7.xml"/><Relationship Id="rId5" Type="http://schemas.openxmlformats.org/officeDocument/2006/relationships/slideLayout" Target="../slideLayouts/slideLayout2.xml"/><Relationship Id="rId4" Type="http://schemas.openxmlformats.org/officeDocument/2006/relationships/audio" Target="../media/media8.m4a"/></Relationships>
</file>

<file path=ppt/slides/_rels/slide8.xml.rels><?xml version="1.0" encoding="UTF-8" standalone="yes"?>
<Relationships xmlns="http://schemas.openxmlformats.org/package/2006/relationships"><Relationship Id="rId26" Type="http://schemas.openxmlformats.org/officeDocument/2006/relationships/image" Target="../media/image82.png"/><Relationship Id="rId21" Type="http://schemas.openxmlformats.org/officeDocument/2006/relationships/customXml" Target="../ink/ink74.xml"/><Relationship Id="rId34" Type="http://schemas.openxmlformats.org/officeDocument/2006/relationships/image" Target="../media/image86.png"/><Relationship Id="rId42" Type="http://schemas.openxmlformats.org/officeDocument/2006/relationships/image" Target="../media/image90.png"/><Relationship Id="rId47" Type="http://schemas.openxmlformats.org/officeDocument/2006/relationships/customXml" Target="../ink/ink87.xml"/><Relationship Id="rId50" Type="http://schemas.openxmlformats.org/officeDocument/2006/relationships/image" Target="../media/image94.png"/><Relationship Id="rId55" Type="http://schemas.openxmlformats.org/officeDocument/2006/relationships/customXml" Target="../ink/ink91.xml"/><Relationship Id="rId63" Type="http://schemas.openxmlformats.org/officeDocument/2006/relationships/customXml" Target="../ink/ink95.xml"/><Relationship Id="rId7" Type="http://schemas.openxmlformats.org/officeDocument/2006/relationships/customXml" Target="../ink/ink67.xml"/><Relationship Id="rId2" Type="http://schemas.openxmlformats.org/officeDocument/2006/relationships/video" Target="../media/media9.mp4"/><Relationship Id="rId16" Type="http://schemas.openxmlformats.org/officeDocument/2006/relationships/image" Target="../media/image77.png"/><Relationship Id="rId29" Type="http://schemas.openxmlformats.org/officeDocument/2006/relationships/customXml" Target="../ink/ink78.xml"/><Relationship Id="rId11" Type="http://schemas.openxmlformats.org/officeDocument/2006/relationships/customXml" Target="../ink/ink69.xml"/><Relationship Id="rId24" Type="http://schemas.openxmlformats.org/officeDocument/2006/relationships/image" Target="../media/image81.png"/><Relationship Id="rId32" Type="http://schemas.openxmlformats.org/officeDocument/2006/relationships/image" Target="../media/image85.png"/><Relationship Id="rId37" Type="http://schemas.openxmlformats.org/officeDocument/2006/relationships/customXml" Target="../ink/ink82.xml"/><Relationship Id="rId40" Type="http://schemas.openxmlformats.org/officeDocument/2006/relationships/image" Target="../media/image89.png"/><Relationship Id="rId45" Type="http://schemas.openxmlformats.org/officeDocument/2006/relationships/customXml" Target="../ink/ink86.xml"/><Relationship Id="rId53" Type="http://schemas.openxmlformats.org/officeDocument/2006/relationships/customXml" Target="../ink/ink90.xml"/><Relationship Id="rId58" Type="http://schemas.openxmlformats.org/officeDocument/2006/relationships/image" Target="../media/image98.png"/><Relationship Id="rId66" Type="http://schemas.openxmlformats.org/officeDocument/2006/relationships/image" Target="../media/image6.png"/><Relationship Id="rId5" Type="http://schemas.openxmlformats.org/officeDocument/2006/relationships/slideLayout" Target="../slideLayouts/slideLayout2.xml"/><Relationship Id="rId61" Type="http://schemas.openxmlformats.org/officeDocument/2006/relationships/customXml" Target="../ink/ink94.xml"/><Relationship Id="rId19" Type="http://schemas.openxmlformats.org/officeDocument/2006/relationships/customXml" Target="../ink/ink73.xml"/><Relationship Id="rId14" Type="http://schemas.openxmlformats.org/officeDocument/2006/relationships/image" Target="../media/image76.png"/><Relationship Id="rId22" Type="http://schemas.openxmlformats.org/officeDocument/2006/relationships/image" Target="../media/image80.png"/><Relationship Id="rId27" Type="http://schemas.openxmlformats.org/officeDocument/2006/relationships/customXml" Target="../ink/ink77.xml"/><Relationship Id="rId30" Type="http://schemas.openxmlformats.org/officeDocument/2006/relationships/image" Target="../media/image84.png"/><Relationship Id="rId35" Type="http://schemas.openxmlformats.org/officeDocument/2006/relationships/customXml" Target="../ink/ink81.xml"/><Relationship Id="rId43" Type="http://schemas.openxmlformats.org/officeDocument/2006/relationships/customXml" Target="../ink/ink85.xml"/><Relationship Id="rId48" Type="http://schemas.openxmlformats.org/officeDocument/2006/relationships/image" Target="../media/image93.png"/><Relationship Id="rId56" Type="http://schemas.openxmlformats.org/officeDocument/2006/relationships/image" Target="../media/image97.png"/><Relationship Id="rId64" Type="http://schemas.openxmlformats.org/officeDocument/2006/relationships/image" Target="../media/image69.png"/><Relationship Id="rId8" Type="http://schemas.openxmlformats.org/officeDocument/2006/relationships/image" Target="../media/image730.png"/><Relationship Id="rId51" Type="http://schemas.openxmlformats.org/officeDocument/2006/relationships/customXml" Target="../ink/ink89.xml"/><Relationship Id="rId3" Type="http://schemas.microsoft.com/office/2007/relationships/media" Target="../media/media10.m4a"/><Relationship Id="rId12" Type="http://schemas.openxmlformats.org/officeDocument/2006/relationships/image" Target="../media/image75.png"/><Relationship Id="rId17" Type="http://schemas.openxmlformats.org/officeDocument/2006/relationships/customXml" Target="../ink/ink72.xml"/><Relationship Id="rId25" Type="http://schemas.openxmlformats.org/officeDocument/2006/relationships/customXml" Target="../ink/ink76.xml"/><Relationship Id="rId33" Type="http://schemas.openxmlformats.org/officeDocument/2006/relationships/customXml" Target="../ink/ink80.xml"/><Relationship Id="rId38" Type="http://schemas.openxmlformats.org/officeDocument/2006/relationships/image" Target="../media/image88.png"/><Relationship Id="rId46" Type="http://schemas.openxmlformats.org/officeDocument/2006/relationships/image" Target="../media/image92.png"/><Relationship Id="rId59" Type="http://schemas.openxmlformats.org/officeDocument/2006/relationships/customXml" Target="../ink/ink93.xml"/><Relationship Id="rId20" Type="http://schemas.openxmlformats.org/officeDocument/2006/relationships/image" Target="../media/image79.png"/><Relationship Id="rId41" Type="http://schemas.openxmlformats.org/officeDocument/2006/relationships/customXml" Target="../ink/ink84.xml"/><Relationship Id="rId54" Type="http://schemas.openxmlformats.org/officeDocument/2006/relationships/image" Target="../media/image96.png"/><Relationship Id="rId62" Type="http://schemas.openxmlformats.org/officeDocument/2006/relationships/image" Target="../media/image100.png"/><Relationship Id="rId1" Type="http://schemas.microsoft.com/office/2007/relationships/media" Target="../media/media9.mp4"/><Relationship Id="rId6" Type="http://schemas.openxmlformats.org/officeDocument/2006/relationships/notesSlide" Target="../notesSlides/notesSlide8.xml"/><Relationship Id="rId15" Type="http://schemas.openxmlformats.org/officeDocument/2006/relationships/customXml" Target="../ink/ink71.xml"/><Relationship Id="rId23" Type="http://schemas.openxmlformats.org/officeDocument/2006/relationships/customXml" Target="../ink/ink75.xml"/><Relationship Id="rId28" Type="http://schemas.openxmlformats.org/officeDocument/2006/relationships/image" Target="../media/image83.png"/><Relationship Id="rId36" Type="http://schemas.openxmlformats.org/officeDocument/2006/relationships/image" Target="../media/image87.png"/><Relationship Id="rId49" Type="http://schemas.openxmlformats.org/officeDocument/2006/relationships/customXml" Target="../ink/ink88.xml"/><Relationship Id="rId57" Type="http://schemas.openxmlformats.org/officeDocument/2006/relationships/customXml" Target="../ink/ink92.xml"/><Relationship Id="rId10" Type="http://schemas.openxmlformats.org/officeDocument/2006/relationships/image" Target="../media/image74.png"/><Relationship Id="rId31" Type="http://schemas.openxmlformats.org/officeDocument/2006/relationships/customXml" Target="../ink/ink79.xml"/><Relationship Id="rId44" Type="http://schemas.openxmlformats.org/officeDocument/2006/relationships/image" Target="../media/image91.png"/><Relationship Id="rId52" Type="http://schemas.openxmlformats.org/officeDocument/2006/relationships/image" Target="../media/image95.png"/><Relationship Id="rId60" Type="http://schemas.openxmlformats.org/officeDocument/2006/relationships/image" Target="../media/image99.png"/><Relationship Id="rId65" Type="http://schemas.openxmlformats.org/officeDocument/2006/relationships/image" Target="../media/image101.png"/><Relationship Id="rId4" Type="http://schemas.openxmlformats.org/officeDocument/2006/relationships/audio" Target="../media/media10.m4a"/><Relationship Id="rId9" Type="http://schemas.openxmlformats.org/officeDocument/2006/relationships/customXml" Target="../ink/ink68.xml"/><Relationship Id="rId13" Type="http://schemas.openxmlformats.org/officeDocument/2006/relationships/customXml" Target="../ink/ink70.xml"/><Relationship Id="rId18" Type="http://schemas.openxmlformats.org/officeDocument/2006/relationships/image" Target="../media/image78.png"/><Relationship Id="rId39" Type="http://schemas.openxmlformats.org/officeDocument/2006/relationships/customXml" Target="../ink/ink83.xml"/></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6.xml"/><Relationship Id="rId2" Type="http://schemas.openxmlformats.org/officeDocument/2006/relationships/audio" Target="../media/media11.m4a"/><Relationship Id="rId1" Type="http://schemas.microsoft.com/office/2007/relationships/media" Target="../media/media11.m4a"/><Relationship Id="rId5" Type="http://schemas.openxmlformats.org/officeDocument/2006/relationships/image" Target="../media/image6.png"/><Relationship Id="rId4"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Subtitle 2">
            <a:extLst>
              <a:ext uri="{FF2B5EF4-FFF2-40B4-BE49-F238E27FC236}">
                <a16:creationId xmlns:a16="http://schemas.microsoft.com/office/drawing/2014/main" id="{2F18CB67-A57B-4FD6-B3AD-D457A1407C88}"/>
              </a:ext>
            </a:extLst>
          </p:cNvPr>
          <p:cNvSpPr>
            <a:spLocks noGrp="1"/>
          </p:cNvSpPr>
          <p:nvPr>
            <p:ph type="subTitle" idx="1"/>
          </p:nvPr>
        </p:nvSpPr>
        <p:spPr>
          <a:xfrm>
            <a:off x="1524000" y="3119386"/>
            <a:ext cx="9144000" cy="900660"/>
          </a:xfrm>
        </p:spPr>
        <p:txBody>
          <a:bodyPr vert="horz" lIns="91440" tIns="45720" rIns="91440" bIns="45720" rtlCol="0" anchor="t">
            <a:normAutofit/>
          </a:bodyPr>
          <a:lstStyle/>
          <a:p>
            <a:r>
              <a:rPr lang="en-US" i="1" dirty="0" err="1"/>
              <a:t>PennState</a:t>
            </a:r>
            <a:r>
              <a:rPr lang="en-US" i="1" dirty="0"/>
              <a:t> Hershey Medical Center</a:t>
            </a:r>
          </a:p>
          <a:p>
            <a:r>
              <a:rPr lang="en-US" i="1" dirty="0"/>
              <a:t>C. Nguyen, K. Hartmann, C. </a:t>
            </a:r>
            <a:r>
              <a:rPr lang="en-US" i="1" dirty="0" err="1"/>
              <a:t>Goodmurphy</a:t>
            </a:r>
            <a:r>
              <a:rPr lang="en-US" i="1" dirty="0"/>
              <a:t>, A. Flamm</a:t>
            </a:r>
            <a:endParaRPr lang="en-US" dirty="0"/>
          </a:p>
          <a:p>
            <a:endParaRPr lang="en-US" dirty="0"/>
          </a:p>
        </p:txBody>
      </p:sp>
      <p:sp>
        <p:nvSpPr>
          <p:cNvPr id="4" name="Title 1">
            <a:extLst>
              <a:ext uri="{FF2B5EF4-FFF2-40B4-BE49-F238E27FC236}">
                <a16:creationId xmlns:a16="http://schemas.microsoft.com/office/drawing/2014/main" id="{6BC46404-153F-844C-97C7-1591E71011B0}"/>
              </a:ext>
            </a:extLst>
          </p:cNvPr>
          <p:cNvSpPr txBox="1">
            <a:spLocks/>
          </p:cNvSpPr>
          <p:nvPr/>
        </p:nvSpPr>
        <p:spPr>
          <a:xfrm>
            <a:off x="1524000" y="1122363"/>
            <a:ext cx="9144000" cy="1570961"/>
          </a:xfrm>
          <a:prstGeom prst="rect">
            <a:avLst/>
          </a:prstGeom>
        </p:spPr>
        <p:txBody>
          <a:bodyPr vert="horz" lIns="91440" tIns="45720" rIns="91440" bIns="45720" rtlCol="0" anchor="b">
            <a:normAutofit/>
          </a:bodyPr>
          <a:lstStyle>
            <a:lvl1pPr algn="l" defTabSz="914400" rtl="0" eaLnBrk="1" latinLnBrk="0" hangingPunct="1">
              <a:lnSpc>
                <a:spcPct val="90000"/>
              </a:lnSpc>
              <a:spcBef>
                <a:spcPct val="0"/>
              </a:spcBef>
              <a:buNone/>
              <a:defRPr sz="4400" kern="1200" baseline="0">
                <a:solidFill>
                  <a:schemeClr val="bg1"/>
                </a:solidFill>
                <a:latin typeface="+mj-lt"/>
                <a:ea typeface="+mj-ea"/>
                <a:cs typeface="+mj-cs"/>
              </a:defRPr>
            </a:lvl1pPr>
          </a:lstStyle>
          <a:p>
            <a:r>
              <a:rPr lang="en-US" b="1" dirty="0" err="1"/>
              <a:t>PreHospital</a:t>
            </a:r>
            <a:r>
              <a:rPr lang="en-US" b="1" dirty="0"/>
              <a:t> Provider </a:t>
            </a:r>
            <a:r>
              <a:rPr lang="en-US" b="1"/>
              <a:t>Ultrasound </a:t>
            </a:r>
          </a:p>
          <a:p>
            <a:r>
              <a:rPr lang="en-US" b="1"/>
              <a:t>Left </a:t>
            </a:r>
            <a:r>
              <a:rPr lang="en-US" b="1" dirty="0"/>
              <a:t>Upper Quadrant View</a:t>
            </a:r>
            <a:endParaRPr lang="en-US" dirty="0"/>
          </a:p>
        </p:txBody>
      </p:sp>
      <p:pic>
        <p:nvPicPr>
          <p:cNvPr id="2" name="Audio Recording Sep 27, 2022 at 7:05:46 PM" descr="Audio Recording Sep 27, 2022 at 7:05:46 PM">
            <a:hlinkClick r:id="" action="ppaction://media"/>
            <a:extLst>
              <a:ext uri="{FF2B5EF4-FFF2-40B4-BE49-F238E27FC236}">
                <a16:creationId xmlns:a16="http://schemas.microsoft.com/office/drawing/2014/main" id="{265EAA2D-1571-D869-A848-517749BB6EB7}"/>
              </a:ext>
            </a:extLst>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10463480" y="5329237"/>
            <a:ext cx="812800" cy="812800"/>
          </a:xfrm>
          <a:prstGeom prst="rect">
            <a:avLst/>
          </a:prstGeom>
        </p:spPr>
      </p:pic>
      <p:pic>
        <p:nvPicPr>
          <p:cNvPr id="3" name="Picture 2">
            <a:extLst>
              <a:ext uri="{FF2B5EF4-FFF2-40B4-BE49-F238E27FC236}">
                <a16:creationId xmlns:a16="http://schemas.microsoft.com/office/drawing/2014/main" id="{86688279-8C48-3F0F-4E4D-5FAEE413237C}"/>
              </a:ext>
            </a:extLst>
          </p:cNvPr>
          <p:cNvPicPr>
            <a:picLocks noChangeAspect="1"/>
          </p:cNvPicPr>
          <p:nvPr/>
        </p:nvPicPr>
        <p:blipFill>
          <a:blip r:embed="rId6"/>
          <a:stretch>
            <a:fillRect/>
          </a:stretch>
        </p:blipFill>
        <p:spPr>
          <a:xfrm>
            <a:off x="10668000" y="120116"/>
            <a:ext cx="1422400" cy="482600"/>
          </a:xfrm>
          <a:prstGeom prst="rect">
            <a:avLst/>
          </a:prstGeom>
        </p:spPr>
      </p:pic>
    </p:spTree>
    <p:extLst>
      <p:ext uri="{BB962C8B-B14F-4D97-AF65-F5344CB8AC3E}">
        <p14:creationId xmlns:p14="http://schemas.microsoft.com/office/powerpoint/2010/main" val="13250550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1584"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7" fill="hold" display="0">
                  <p:stCondLst>
                    <p:cond delay="indefinite"/>
                  </p:stCondLst>
                  <p:endCondLst>
                    <p:cond evt="onStopAudio" delay="0">
                      <p:tgtEl>
                        <p:sldTgt/>
                      </p:tgtEl>
                    </p:cond>
                  </p:endCondLst>
                </p:cTn>
                <p:tgtEl>
                  <p:spTgt spid="2"/>
                </p:tgtEl>
              </p:cMediaNode>
            </p:audio>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033DE03E-AC5D-936D-B620-994926597915}"/>
              </a:ext>
            </a:extLst>
          </p:cNvPr>
          <p:cNvSpPr txBox="1"/>
          <p:nvPr/>
        </p:nvSpPr>
        <p:spPr>
          <a:xfrm>
            <a:off x="497840" y="186124"/>
            <a:ext cx="5029200" cy="5909310"/>
          </a:xfrm>
          <a:prstGeom prst="rect">
            <a:avLst/>
          </a:prstGeom>
          <a:noFill/>
        </p:spPr>
        <p:txBody>
          <a:bodyPr wrap="square" rtlCol="0">
            <a:spAutoFit/>
          </a:bodyPr>
          <a:lstStyle/>
          <a:p>
            <a:r>
              <a:rPr lang="en-US" sz="3600" b="1" dirty="0">
                <a:solidFill>
                  <a:schemeClr val="accent2"/>
                </a:solidFill>
              </a:rPr>
              <a:t>Thank You!</a:t>
            </a:r>
          </a:p>
          <a:p>
            <a:endParaRPr lang="en-US" dirty="0"/>
          </a:p>
          <a:p>
            <a:r>
              <a:rPr lang="en-US" dirty="0"/>
              <a:t>Questions?</a:t>
            </a:r>
          </a:p>
          <a:p>
            <a:endParaRPr lang="en-US" sz="1800" b="0" i="0" dirty="0">
              <a:solidFill>
                <a:srgbClr val="000000"/>
              </a:solidFill>
              <a:effectLst/>
              <a:latin typeface="Calibri" panose="020F0502020204030204" pitchFamily="34" charset="0"/>
            </a:endParaRPr>
          </a:p>
          <a:p>
            <a:r>
              <a:rPr lang="en-US" sz="1800" b="0" i="0" dirty="0">
                <a:solidFill>
                  <a:srgbClr val="000000"/>
                </a:solidFill>
                <a:effectLst/>
                <a:latin typeface="Calibri" panose="020F0502020204030204" pitchFamily="34" charset="0"/>
              </a:rPr>
              <a:t>Clever Nguyen, MS-III</a:t>
            </a:r>
          </a:p>
          <a:p>
            <a:pPr algn="l" fontAlgn="base"/>
            <a:r>
              <a:rPr lang="en-US" sz="1800" b="0" i="0" dirty="0">
                <a:solidFill>
                  <a:srgbClr val="000000"/>
                </a:solidFill>
                <a:effectLst/>
                <a:latin typeface="Calibri" panose="020F0502020204030204" pitchFamily="34" charset="0"/>
              </a:rPr>
              <a:t>MD Candidate Class of 2024</a:t>
            </a:r>
          </a:p>
          <a:p>
            <a:pPr algn="l" fontAlgn="base"/>
            <a:r>
              <a:rPr lang="en-US" sz="1800" b="0" i="0" dirty="0">
                <a:solidFill>
                  <a:srgbClr val="000000"/>
                </a:solidFill>
                <a:effectLst/>
                <a:latin typeface="Calibri" panose="020F0502020204030204" pitchFamily="34" charset="0"/>
              </a:rPr>
              <a:t>cnguyen3@pennstatehealth@psu.edu </a:t>
            </a:r>
            <a:br>
              <a:rPr lang="en-US" sz="1800" b="0" i="0" dirty="0">
                <a:solidFill>
                  <a:srgbClr val="000000"/>
                </a:solidFill>
                <a:effectLst/>
                <a:latin typeface="Calibri" panose="020F0502020204030204" pitchFamily="34" charset="0"/>
              </a:rPr>
            </a:br>
            <a:endParaRPr lang="en-US" sz="1800" b="0" i="0" dirty="0">
              <a:solidFill>
                <a:srgbClr val="000000"/>
              </a:solidFill>
              <a:effectLst/>
              <a:latin typeface="Calibri" panose="020F0502020204030204" pitchFamily="34" charset="0"/>
            </a:endParaRPr>
          </a:p>
          <a:p>
            <a:pPr algn="l" fontAlgn="base"/>
            <a:r>
              <a:rPr lang="en-US" sz="1800" b="0" i="0" dirty="0">
                <a:solidFill>
                  <a:srgbClr val="000000"/>
                </a:solidFill>
                <a:effectLst/>
                <a:latin typeface="Calibri" panose="020F0502020204030204" pitchFamily="34" charset="0"/>
              </a:rPr>
              <a:t>Dr. Avram Flamm, DO, EMT-P</a:t>
            </a:r>
          </a:p>
          <a:p>
            <a:pPr algn="l" fontAlgn="base"/>
            <a:r>
              <a:rPr lang="en-US" sz="1800" b="0" i="0" dirty="0">
                <a:solidFill>
                  <a:srgbClr val="000000"/>
                </a:solidFill>
                <a:effectLst/>
                <a:latin typeface="Calibri" panose="020F0502020204030204" pitchFamily="34" charset="0"/>
              </a:rPr>
              <a:t>Medical Director, Life Lion Critical Care Transport</a:t>
            </a:r>
          </a:p>
          <a:p>
            <a:pPr algn="l" fontAlgn="base"/>
            <a:r>
              <a:rPr lang="en-US" sz="1800" b="0" i="0" dirty="0">
                <a:solidFill>
                  <a:srgbClr val="000000"/>
                </a:solidFill>
                <a:effectLst/>
                <a:latin typeface="Calibri" panose="020F0502020204030204" pitchFamily="34" charset="0"/>
              </a:rPr>
              <a:t>aflamm1@pennstatehealth.psu.edu</a:t>
            </a:r>
            <a:br>
              <a:rPr lang="en-US" sz="1800" b="0" i="0" dirty="0">
                <a:solidFill>
                  <a:srgbClr val="000000"/>
                </a:solidFill>
                <a:effectLst/>
                <a:latin typeface="Calibri" panose="020F0502020204030204" pitchFamily="34" charset="0"/>
              </a:rPr>
            </a:br>
            <a:endParaRPr lang="en-US" sz="1800" b="0" i="0" dirty="0">
              <a:solidFill>
                <a:srgbClr val="000000"/>
              </a:solidFill>
              <a:effectLst/>
              <a:latin typeface="Calibri" panose="020F0502020204030204" pitchFamily="34" charset="0"/>
            </a:endParaRPr>
          </a:p>
          <a:p>
            <a:pPr algn="l" fontAlgn="base"/>
            <a:r>
              <a:rPr lang="en-US" sz="1800" b="0" i="0" dirty="0">
                <a:solidFill>
                  <a:srgbClr val="000000"/>
                </a:solidFill>
                <a:effectLst/>
                <a:latin typeface="Calibri" panose="020F0502020204030204" pitchFamily="34" charset="0"/>
              </a:rPr>
              <a:t>Dr. Craig </a:t>
            </a:r>
            <a:r>
              <a:rPr lang="en-US" sz="1800" b="0" i="0" dirty="0" err="1">
                <a:solidFill>
                  <a:srgbClr val="000000"/>
                </a:solidFill>
                <a:effectLst/>
                <a:latin typeface="Calibri" panose="020F0502020204030204" pitchFamily="34" charset="0"/>
              </a:rPr>
              <a:t>Goodmurphy</a:t>
            </a:r>
            <a:r>
              <a:rPr lang="en-US" sz="1800" b="0" i="0" dirty="0">
                <a:solidFill>
                  <a:srgbClr val="000000"/>
                </a:solidFill>
                <a:effectLst/>
                <a:latin typeface="Calibri" panose="020F0502020204030204" pitchFamily="34" charset="0"/>
              </a:rPr>
              <a:t>, Ph.D.</a:t>
            </a:r>
          </a:p>
          <a:p>
            <a:pPr algn="l" fontAlgn="base"/>
            <a:r>
              <a:rPr lang="en-US" sz="1800" b="0" i="0" dirty="0">
                <a:solidFill>
                  <a:srgbClr val="000000"/>
                </a:solidFill>
                <a:effectLst/>
                <a:latin typeface="Calibri" panose="020F0502020204030204" pitchFamily="34" charset="0"/>
              </a:rPr>
              <a:t>Director of Ultrasound Education</a:t>
            </a:r>
          </a:p>
          <a:p>
            <a:pPr algn="l" fontAlgn="base"/>
            <a:r>
              <a:rPr lang="en-US" sz="1800" b="0" i="0" dirty="0">
                <a:solidFill>
                  <a:srgbClr val="000000"/>
                </a:solidFill>
                <a:effectLst/>
                <a:latin typeface="Calibri" panose="020F0502020204030204" pitchFamily="34" charset="0"/>
              </a:rPr>
              <a:t>cgoodmurphy@pennstatehealth.psu.edu</a:t>
            </a:r>
            <a:br>
              <a:rPr lang="en-US" sz="1800" b="0" i="0" dirty="0">
                <a:solidFill>
                  <a:srgbClr val="000000"/>
                </a:solidFill>
                <a:effectLst/>
                <a:latin typeface="Calibri" panose="020F0502020204030204" pitchFamily="34" charset="0"/>
              </a:rPr>
            </a:br>
            <a:endParaRPr lang="en-US" sz="1800" b="0" i="0" dirty="0">
              <a:solidFill>
                <a:srgbClr val="000000"/>
              </a:solidFill>
              <a:effectLst/>
              <a:latin typeface="Calibri" panose="020F0502020204030204" pitchFamily="34" charset="0"/>
            </a:endParaRPr>
          </a:p>
          <a:p>
            <a:pPr algn="l" fontAlgn="base"/>
            <a:r>
              <a:rPr lang="en-US" sz="1800" b="0" i="0" dirty="0">
                <a:solidFill>
                  <a:srgbClr val="000000"/>
                </a:solidFill>
                <a:effectLst/>
                <a:latin typeface="Calibri" panose="020F0502020204030204" pitchFamily="34" charset="0"/>
              </a:rPr>
              <a:t>Krista Hartmann, MS-III</a:t>
            </a:r>
          </a:p>
          <a:p>
            <a:pPr algn="l" fontAlgn="base"/>
            <a:r>
              <a:rPr lang="en-US" sz="1800" b="0" i="0" dirty="0">
                <a:solidFill>
                  <a:srgbClr val="000000"/>
                </a:solidFill>
                <a:effectLst/>
                <a:latin typeface="Calibri" panose="020F0502020204030204" pitchFamily="34" charset="0"/>
              </a:rPr>
              <a:t>MD Candidate Class of 2024</a:t>
            </a:r>
          </a:p>
          <a:p>
            <a:pPr algn="l" fontAlgn="base"/>
            <a:r>
              <a:rPr lang="en-US" sz="1800" b="0" i="0" dirty="0">
                <a:solidFill>
                  <a:srgbClr val="000000"/>
                </a:solidFill>
                <a:effectLst/>
                <a:latin typeface="Calibri" panose="020F0502020204030204" pitchFamily="34" charset="0"/>
              </a:rPr>
              <a:t>khartmann1@pennstatehealth.psu.edu</a:t>
            </a:r>
          </a:p>
          <a:p>
            <a:pPr marL="285750" indent="-285750">
              <a:buFont typeface="Arial" panose="020B0604020202020204" pitchFamily="34" charset="0"/>
              <a:buChar char="•"/>
            </a:pPr>
            <a:endParaRPr lang="en-US" dirty="0"/>
          </a:p>
        </p:txBody>
      </p:sp>
      <p:sp>
        <p:nvSpPr>
          <p:cNvPr id="11" name="TextBox 10">
            <a:extLst>
              <a:ext uri="{FF2B5EF4-FFF2-40B4-BE49-F238E27FC236}">
                <a16:creationId xmlns:a16="http://schemas.microsoft.com/office/drawing/2014/main" id="{68B5BB46-39FC-543D-F4FF-C30A95C43B43}"/>
              </a:ext>
            </a:extLst>
          </p:cNvPr>
          <p:cNvSpPr txBox="1"/>
          <p:nvPr/>
        </p:nvSpPr>
        <p:spPr>
          <a:xfrm>
            <a:off x="5527040" y="986343"/>
            <a:ext cx="5273040" cy="3816429"/>
          </a:xfrm>
          <a:prstGeom prst="rect">
            <a:avLst/>
          </a:prstGeom>
          <a:noFill/>
        </p:spPr>
        <p:txBody>
          <a:bodyPr wrap="square" rtlCol="0">
            <a:spAutoFit/>
          </a:bodyPr>
          <a:lstStyle/>
          <a:p>
            <a:r>
              <a:rPr lang="en-US" sz="3200" b="1" dirty="0">
                <a:solidFill>
                  <a:schemeClr val="accent2"/>
                </a:solidFill>
              </a:rPr>
              <a:t>Will become more familiar during in-person scanning sessions!</a:t>
            </a:r>
          </a:p>
          <a:p>
            <a:endParaRPr lang="en-US" sz="3200" b="1" dirty="0">
              <a:solidFill>
                <a:schemeClr val="accent2"/>
              </a:solidFill>
            </a:endParaRPr>
          </a:p>
          <a:p>
            <a:endParaRPr lang="en-US" sz="3200" b="1" dirty="0">
              <a:solidFill>
                <a:schemeClr val="accent2"/>
              </a:solidFill>
            </a:endParaRPr>
          </a:p>
          <a:p>
            <a:r>
              <a:rPr lang="en-US" sz="3200" b="1" dirty="0">
                <a:solidFill>
                  <a:schemeClr val="accent2"/>
                </a:solidFill>
              </a:rPr>
              <a:t>See you in the next video module!</a:t>
            </a:r>
          </a:p>
          <a:p>
            <a:endParaRPr lang="en-US" dirty="0"/>
          </a:p>
        </p:txBody>
      </p:sp>
      <p:pic>
        <p:nvPicPr>
          <p:cNvPr id="2" name="Audio Recording Sep 27, 2022 at 8:07:06 PM" descr="Audio Recording Sep 27, 2022 at 8:07:06 PM">
            <a:hlinkClick r:id="" action="ppaction://media"/>
            <a:extLst>
              <a:ext uri="{FF2B5EF4-FFF2-40B4-BE49-F238E27FC236}">
                <a16:creationId xmlns:a16="http://schemas.microsoft.com/office/drawing/2014/main" id="{76D392A8-1BAE-9642-12C3-9BE03D929915}"/>
              </a:ext>
            </a:extLst>
          </p:cNvPr>
          <p:cNvPicPr>
            <a:picLocks noChangeAspect="1"/>
          </p:cNvPicPr>
          <p:nvPr>
            <a:audioFile r:link="rId2"/>
            <p:extLst>
              <p:ext uri="{DAA4B4D4-6D71-4841-9C94-3DE7FCFB9230}">
                <p14:media xmlns:p14="http://schemas.microsoft.com/office/powerpoint/2010/main" r:embed="rId1"/>
              </p:ext>
            </p:extLst>
          </p:nvPr>
        </p:nvPicPr>
        <p:blipFill>
          <a:blip r:embed="rId4"/>
          <a:stretch>
            <a:fillRect/>
          </a:stretch>
        </p:blipFill>
        <p:spPr>
          <a:xfrm>
            <a:off x="10556240" y="4802772"/>
            <a:ext cx="812800" cy="812800"/>
          </a:xfrm>
          <a:prstGeom prst="rect">
            <a:avLst/>
          </a:prstGeom>
        </p:spPr>
      </p:pic>
    </p:spTree>
    <p:extLst>
      <p:ext uri="{BB962C8B-B14F-4D97-AF65-F5344CB8AC3E}">
        <p14:creationId xmlns:p14="http://schemas.microsoft.com/office/powerpoint/2010/main" val="822818252"/>
      </p:ext>
    </p:extLst>
  </p:cSld>
  <p:clrMapOvr>
    <a:masterClrMapping/>
  </p:clrMapOvr>
  <mc:AlternateContent xmlns:mc="http://schemas.openxmlformats.org/markup-compatibility/2006" xmlns:p14="http://schemas.microsoft.com/office/powerpoint/2010/main">
    <mc:Choice Requires="p14">
      <p:transition spd="slow" p14:dur="2000" advTm="45806"/>
    </mc:Choice>
    <mc:Fallback xmlns="">
      <p:transition spd="slow" advTm="45806"/>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6064"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7" fill="hold" display="0">
                  <p:stCondLst>
                    <p:cond delay="indefinite"/>
                  </p:stCondLst>
                  <p:endCondLst>
                    <p:cond evt="onStopAudio" delay="0">
                      <p:tgtEl>
                        <p:sldTgt/>
                      </p:tgtEl>
                    </p:cond>
                  </p:endCondLst>
                </p:cTn>
                <p:tgtEl>
                  <p:spTgt spid="2"/>
                </p:tgtEl>
              </p:cMediaNode>
            </p:audio>
          </p:childTnLst>
        </p:cTn>
      </p:par>
    </p:tnLst>
  </p:timing>
  <p:extLst>
    <p:ext uri="{3A86A75C-4F4B-4683-9AE1-C65F6400EC91}">
      <p14:laserTraceLst xmlns:p14="http://schemas.microsoft.com/office/powerpoint/2010/main">
        <p14:tracePtLst>
          <p14:tracePt t="3843" x="7642225" y="4843463"/>
          <p14:tracePt t="3870" x="6634163" y="4392613"/>
          <p14:tracePt t="3874" x="6264275" y="4179888"/>
          <p14:tracePt t="3906" x="5548313" y="3835400"/>
          <p14:tracePt t="3933" x="5521325" y="3808413"/>
          <p14:tracePt t="4000" x="5521325" y="3384550"/>
          <p14:tracePt t="4037" x="5441950" y="2987675"/>
          <p14:tracePt t="4069" x="5414963" y="2960688"/>
          <p14:tracePt t="4116" x="5362575" y="2881313"/>
          <p14:tracePt t="4149" x="5335588" y="2881313"/>
          <p14:tracePt t="4176" x="5310188" y="2881313"/>
          <p14:tracePt t="4236" x="5256213" y="2881313"/>
          <p14:tracePt t="4271" x="5176838" y="2898775"/>
          <p14:tracePt t="4298" x="5018088" y="2898775"/>
          <p14:tracePt t="4330" x="4805363" y="2925763"/>
          <p14:tracePt t="4355" x="4752975" y="2925763"/>
          <p14:tracePt t="4387" x="4621213" y="2854325"/>
          <p14:tracePt t="4458" x="4594225" y="2854325"/>
          <p14:tracePt t="4524" x="4541838" y="2801938"/>
          <p14:tracePt t="4553" x="4487863" y="2722563"/>
          <p14:tracePt t="4627" x="4487863" y="2695575"/>
          <p14:tracePt t="4655" x="4460875" y="2695575"/>
          <p14:tracePt t="4685" x="4381500" y="2616200"/>
          <p14:tracePt t="4722" x="4329113" y="2616200"/>
          <p14:tracePt t="4758" x="4249738" y="2589213"/>
          <p14:tracePt t="4787" x="4249738" y="2562225"/>
          <p14:tracePt t="6307" x="4294188" y="2819400"/>
          <p14:tracePt t="6336" x="4346575" y="2978150"/>
          <p14:tracePt t="6362" x="4373563" y="3030538"/>
          <p14:tracePt t="6395" x="4373563" y="3057525"/>
          <p14:tracePt t="6425" x="4373563" y="3084513"/>
          <p14:tracePt t="6455" x="4373563" y="3270250"/>
          <p14:tracePt t="6465" x="4373563" y="3349625"/>
          <p14:tracePt t="6467" x="4373563" y="3429000"/>
          <p14:tracePt t="6500" x="4373563" y="3641725"/>
          <p14:tracePt t="6532" x="4356100" y="3800475"/>
          <p14:tracePt t="6563" x="4356100" y="4117975"/>
          <p14:tracePt t="6595" x="4249738" y="4357688"/>
          <p14:tracePt t="6625" x="4249738" y="4437063"/>
          <p14:tracePt t="6652" x="4249738" y="4462463"/>
          <p14:tracePt t="6690" x="4222750" y="4489450"/>
          <p14:tracePt t="44849" x="4319588" y="4073525"/>
          <p14:tracePt t="44876" x="4398963" y="3756025"/>
          <p14:tracePt t="44910" x="4584700" y="3357563"/>
          <p14:tracePt t="44941" x="4718050" y="2908300"/>
          <p14:tracePt t="44972" x="4903788" y="2536825"/>
          <p14:tracePt t="45004" x="5114925" y="2271713"/>
          <p14:tracePt t="45032" x="5434013" y="2165350"/>
          <p14:tracePt t="45063" x="6016625" y="1900238"/>
          <p14:tracePt t="45095" x="6467475" y="1422400"/>
          <p14:tracePt t="45128" x="7129463" y="946150"/>
          <p14:tracePt t="45159" x="7473950" y="760413"/>
          <p14:tracePt t="45191" x="7580313" y="495300"/>
          <p14:tracePt t="45224" x="7659688" y="282575"/>
          <p14:tracePt t="45260" x="7793038" y="71438"/>
        </p14:tracePtLst>
      </p14:laserTraceLst>
    </p:ext>
  </p:extLs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62C33B-CFA6-0239-4799-6A1FBFB30284}"/>
              </a:ext>
            </a:extLst>
          </p:cNvPr>
          <p:cNvSpPr>
            <a:spLocks noGrp="1"/>
          </p:cNvSpPr>
          <p:nvPr>
            <p:ph type="ctrTitle"/>
          </p:nvPr>
        </p:nvSpPr>
        <p:spPr>
          <a:xfrm>
            <a:off x="1586753" y="950258"/>
            <a:ext cx="9144000" cy="753035"/>
          </a:xfrm>
        </p:spPr>
        <p:txBody>
          <a:bodyPr>
            <a:normAutofit/>
          </a:bodyPr>
          <a:lstStyle/>
          <a:p>
            <a:r>
              <a:rPr lang="en-US" u="sng" dirty="0"/>
              <a:t>EFAST Exam Components</a:t>
            </a:r>
          </a:p>
        </p:txBody>
      </p:sp>
      <p:sp>
        <p:nvSpPr>
          <p:cNvPr id="3" name="Subtitle 2">
            <a:extLst>
              <a:ext uri="{FF2B5EF4-FFF2-40B4-BE49-F238E27FC236}">
                <a16:creationId xmlns:a16="http://schemas.microsoft.com/office/drawing/2014/main" id="{BFAC2473-7008-2500-F21B-391A8B2B175C}"/>
              </a:ext>
            </a:extLst>
          </p:cNvPr>
          <p:cNvSpPr>
            <a:spLocks noGrp="1"/>
          </p:cNvSpPr>
          <p:nvPr>
            <p:ph type="subTitle" idx="1"/>
          </p:nvPr>
        </p:nvSpPr>
        <p:spPr>
          <a:xfrm>
            <a:off x="1461247" y="2013688"/>
            <a:ext cx="9511553" cy="3616147"/>
          </a:xfrm>
        </p:spPr>
        <p:txBody>
          <a:bodyPr>
            <a:normAutofit/>
          </a:bodyPr>
          <a:lstStyle/>
          <a:p>
            <a:pPr marL="342900" indent="-342900">
              <a:buFont typeface="Arial" panose="020B0604020202020204" pitchFamily="34" charset="0"/>
              <a:buChar char="•"/>
            </a:pPr>
            <a:r>
              <a:rPr lang="en-US" sz="3200" b="1" dirty="0"/>
              <a:t>Pericardial View</a:t>
            </a:r>
          </a:p>
          <a:p>
            <a:pPr marL="342900" indent="-342900">
              <a:buFont typeface="Arial" panose="020B0604020202020204" pitchFamily="34" charset="0"/>
              <a:buChar char="•"/>
            </a:pPr>
            <a:r>
              <a:rPr lang="en-US" sz="3200" dirty="0"/>
              <a:t>Anterior Thoracic (Lung) View</a:t>
            </a:r>
          </a:p>
          <a:p>
            <a:pPr marL="342900" indent="-342900">
              <a:buFont typeface="Arial" panose="020B0604020202020204" pitchFamily="34" charset="0"/>
              <a:buChar char="•"/>
            </a:pPr>
            <a:r>
              <a:rPr lang="en-US" sz="3200" dirty="0"/>
              <a:t>View of the Right Upper Quadrant </a:t>
            </a:r>
          </a:p>
          <a:p>
            <a:pPr marL="342900" indent="-342900">
              <a:buFont typeface="Arial" panose="020B0604020202020204" pitchFamily="34" charset="0"/>
              <a:buChar char="•"/>
            </a:pPr>
            <a:r>
              <a:rPr lang="en-US" sz="4400" dirty="0"/>
              <a:t>View of the Left Upper Quadrant</a:t>
            </a:r>
          </a:p>
          <a:p>
            <a:pPr marL="342900" indent="-342900">
              <a:buFont typeface="Arial" panose="020B0604020202020204" pitchFamily="34" charset="0"/>
              <a:buChar char="•"/>
            </a:pPr>
            <a:r>
              <a:rPr lang="en-US" sz="3200" dirty="0"/>
              <a:t>Suprapubic View</a:t>
            </a:r>
          </a:p>
        </p:txBody>
      </p:sp>
      <p:pic>
        <p:nvPicPr>
          <p:cNvPr id="4" name="Audio Recording Sep 27, 2022 at 7:08:17 PM" descr="Audio Recording Sep 27, 2022 at 7:08:17 PM">
            <a:hlinkClick r:id="" action="ppaction://media"/>
            <a:extLst>
              <a:ext uri="{FF2B5EF4-FFF2-40B4-BE49-F238E27FC236}">
                <a16:creationId xmlns:a16="http://schemas.microsoft.com/office/drawing/2014/main" id="{634FF204-0DF5-285A-81A5-7F1552EA56E5}"/>
              </a:ext>
            </a:extLst>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10566400" y="5501342"/>
            <a:ext cx="812800" cy="812800"/>
          </a:xfrm>
          <a:prstGeom prst="rect">
            <a:avLst/>
          </a:prstGeom>
        </p:spPr>
      </p:pic>
    </p:spTree>
    <p:extLst>
      <p:ext uri="{BB962C8B-B14F-4D97-AF65-F5344CB8AC3E}">
        <p14:creationId xmlns:p14="http://schemas.microsoft.com/office/powerpoint/2010/main" val="12640843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8448"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7" fill="hold" display="0">
                  <p:stCondLst>
                    <p:cond delay="indefinite"/>
                  </p:stCondLst>
                  <p:endCondLst>
                    <p:cond evt="onStopAudio" delay="0">
                      <p:tgtEl>
                        <p:sldTgt/>
                      </p:tgtEl>
                    </p:cond>
                  </p:endCondLst>
                </p:cTn>
                <p:tgtEl>
                  <p:spTgt spid="4"/>
                </p:tgtEl>
              </p:cMediaNode>
            </p:audio>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58" name="Rectangle 1057">
            <a:extLst>
              <a:ext uri="{FF2B5EF4-FFF2-40B4-BE49-F238E27FC236}">
                <a16:creationId xmlns:a16="http://schemas.microsoft.com/office/drawing/2014/main" id="{826B4A43-2A34-4B22-882C-D7552FA9C7D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0" name="Rectangle 1059">
            <a:extLst>
              <a:ext uri="{FF2B5EF4-FFF2-40B4-BE49-F238E27FC236}">
                <a16:creationId xmlns:a16="http://schemas.microsoft.com/office/drawing/2014/main" id="{A5271697-90F1-4A23-8EF2-0179F2EAFAC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1"/>
            <a:ext cx="606972" cy="3233984"/>
          </a:xfrm>
          <a:prstGeom prst="rect">
            <a:avLst/>
          </a:prstGeom>
          <a:solidFill>
            <a:schemeClr val="tx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2" name="Rectangle 1061">
            <a:extLst>
              <a:ext uri="{FF2B5EF4-FFF2-40B4-BE49-F238E27FC236}">
                <a16:creationId xmlns:a16="http://schemas.microsoft.com/office/drawing/2014/main" id="{D9F5512A-48E1-4C07-B75E-3CCC517B68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3233984"/>
            <a:ext cx="606972" cy="362401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4" name="Rectangle 1063">
            <a:extLst>
              <a:ext uri="{FF2B5EF4-FFF2-40B4-BE49-F238E27FC236}">
                <a16:creationId xmlns:a16="http://schemas.microsoft.com/office/drawing/2014/main" id="{B429BAE5-B200-4FC0-BBC1-8D7C57D1D9F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06971" y="0"/>
            <a:ext cx="4565104" cy="6858000"/>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Title 1">
            <a:extLst>
              <a:ext uri="{FF2B5EF4-FFF2-40B4-BE49-F238E27FC236}">
                <a16:creationId xmlns:a16="http://schemas.microsoft.com/office/drawing/2014/main" id="{FFFC99D3-89C8-C248-904E-09B7503267E3}"/>
              </a:ext>
            </a:extLst>
          </p:cNvPr>
          <p:cNvSpPr>
            <a:spLocks noGrp="1"/>
          </p:cNvSpPr>
          <p:nvPr>
            <p:ph type="title"/>
          </p:nvPr>
        </p:nvSpPr>
        <p:spPr>
          <a:xfrm>
            <a:off x="1036685" y="1152144"/>
            <a:ext cx="3794760" cy="3072393"/>
          </a:xfrm>
        </p:spPr>
        <p:txBody>
          <a:bodyPr vert="horz" lIns="91440" tIns="45720" rIns="91440" bIns="45720" rtlCol="0" anchor="b">
            <a:normAutofit/>
          </a:bodyPr>
          <a:lstStyle/>
          <a:p>
            <a:r>
              <a:rPr lang="en-US" sz="4300" kern="1200">
                <a:solidFill>
                  <a:schemeClr val="tx1"/>
                </a:solidFill>
                <a:latin typeface="+mj-lt"/>
                <a:ea typeface="+mj-ea"/>
                <a:cs typeface="+mj-cs"/>
              </a:rPr>
              <a:t>Left Upper Quadrant View</a:t>
            </a:r>
            <a:br>
              <a:rPr lang="en-US" sz="4300" kern="1200">
                <a:solidFill>
                  <a:schemeClr val="tx1"/>
                </a:solidFill>
                <a:latin typeface="+mj-lt"/>
                <a:ea typeface="+mj-ea"/>
                <a:cs typeface="+mj-cs"/>
              </a:rPr>
            </a:br>
            <a:r>
              <a:rPr lang="en-US" sz="4300" kern="1200">
                <a:solidFill>
                  <a:schemeClr val="tx1"/>
                </a:solidFill>
                <a:latin typeface="+mj-lt"/>
                <a:ea typeface="+mj-ea"/>
                <a:cs typeface="+mj-cs"/>
              </a:rPr>
              <a:t>aka Perisplenic View</a:t>
            </a:r>
          </a:p>
        </p:txBody>
      </p:sp>
      <p:grpSp>
        <p:nvGrpSpPr>
          <p:cNvPr id="1066" name="Group 1065">
            <a:extLst>
              <a:ext uri="{FF2B5EF4-FFF2-40B4-BE49-F238E27FC236}">
                <a16:creationId xmlns:a16="http://schemas.microsoft.com/office/drawing/2014/main" id="{A9644633-5AE1-44D6-8F5F-6376DDA130C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188720" y="73152"/>
            <a:ext cx="1178966" cy="232963"/>
            <a:chOff x="7763256" y="73152"/>
            <a:chExt cx="1178966" cy="232963"/>
          </a:xfrm>
        </p:grpSpPr>
        <p:sp>
          <p:nvSpPr>
            <p:cNvPr id="1067" name="Rectangle 64">
              <a:extLst>
                <a:ext uri="{FF2B5EF4-FFF2-40B4-BE49-F238E27FC236}">
                  <a16:creationId xmlns:a16="http://schemas.microsoft.com/office/drawing/2014/main" id="{4FA74995-C5A7-4DBF-BFD1-C4831852DF1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263077"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8" name="Rectangle 66">
              <a:extLst>
                <a:ext uri="{FF2B5EF4-FFF2-40B4-BE49-F238E27FC236}">
                  <a16:creationId xmlns:a16="http://schemas.microsoft.com/office/drawing/2014/main" id="{009DC7CE-EC50-455B-AEF3-758096A62E4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263077"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9" name="Rectangle 64">
              <a:extLst>
                <a:ext uri="{FF2B5EF4-FFF2-40B4-BE49-F238E27FC236}">
                  <a16:creationId xmlns:a16="http://schemas.microsoft.com/office/drawing/2014/main" id="{680D0724-2EE2-4A8E-B7FC-994977F2A61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138122"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0" name="Rectangle 66">
              <a:extLst>
                <a:ext uri="{FF2B5EF4-FFF2-40B4-BE49-F238E27FC236}">
                  <a16:creationId xmlns:a16="http://schemas.microsoft.com/office/drawing/2014/main" id="{D7DD4A6B-2000-4A3E-BBCE-637ED6CDD25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138122"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1" name="Rectangle 64">
              <a:extLst>
                <a:ext uri="{FF2B5EF4-FFF2-40B4-BE49-F238E27FC236}">
                  <a16:creationId xmlns:a16="http://schemas.microsoft.com/office/drawing/2014/main" id="{694A6722-0FE9-4640-B93F-C2BAA895602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013167"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2" name="Rectangle 66">
              <a:extLst>
                <a:ext uri="{FF2B5EF4-FFF2-40B4-BE49-F238E27FC236}">
                  <a16:creationId xmlns:a16="http://schemas.microsoft.com/office/drawing/2014/main" id="{19F6A010-3765-4FAB-8CCA-7AC1891419D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013167"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3" name="Rectangle 64">
              <a:extLst>
                <a:ext uri="{FF2B5EF4-FFF2-40B4-BE49-F238E27FC236}">
                  <a16:creationId xmlns:a16="http://schemas.microsoft.com/office/drawing/2014/main" id="{2ED876B1-4DDC-4999-864F-EFF32EFF5CD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7888211"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4" name="Rectangle 66">
              <a:extLst>
                <a:ext uri="{FF2B5EF4-FFF2-40B4-BE49-F238E27FC236}">
                  <a16:creationId xmlns:a16="http://schemas.microsoft.com/office/drawing/2014/main" id="{2DD9B48A-E7DB-4540-8781-F434856A755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7888211"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5" name="Rectangle 64">
              <a:extLst>
                <a:ext uri="{FF2B5EF4-FFF2-40B4-BE49-F238E27FC236}">
                  <a16:creationId xmlns:a16="http://schemas.microsoft.com/office/drawing/2014/main" id="{2BEF54FF-8FAE-4B7F-ACE8-52ED70B04ED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7763256"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6" name="Rectangle 66">
              <a:extLst>
                <a:ext uri="{FF2B5EF4-FFF2-40B4-BE49-F238E27FC236}">
                  <a16:creationId xmlns:a16="http://schemas.microsoft.com/office/drawing/2014/main" id="{16F687E9-D21B-46CB-8A13-9BFDA780F6D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7763256"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7" name="Rectangle 64">
              <a:extLst>
                <a:ext uri="{FF2B5EF4-FFF2-40B4-BE49-F238E27FC236}">
                  <a16:creationId xmlns:a16="http://schemas.microsoft.com/office/drawing/2014/main" id="{49C0A7C4-BA67-480B-9F9A-E965357562B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887854"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8" name="Rectangle 66">
              <a:extLst>
                <a:ext uri="{FF2B5EF4-FFF2-40B4-BE49-F238E27FC236}">
                  <a16:creationId xmlns:a16="http://schemas.microsoft.com/office/drawing/2014/main" id="{5C27E413-D9C4-45A2-AB5A-A006127984C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887854"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9" name="Rectangle 64">
              <a:extLst>
                <a:ext uri="{FF2B5EF4-FFF2-40B4-BE49-F238E27FC236}">
                  <a16:creationId xmlns:a16="http://schemas.microsoft.com/office/drawing/2014/main" id="{76F8DD1F-1A00-4D5A-B979-33A41277C91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762899"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0" name="Rectangle 66">
              <a:extLst>
                <a:ext uri="{FF2B5EF4-FFF2-40B4-BE49-F238E27FC236}">
                  <a16:creationId xmlns:a16="http://schemas.microsoft.com/office/drawing/2014/main" id="{D16F8034-114D-4513-A6BD-F05ABF9AF47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762899"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1" name="Rectangle 64">
              <a:extLst>
                <a:ext uri="{FF2B5EF4-FFF2-40B4-BE49-F238E27FC236}">
                  <a16:creationId xmlns:a16="http://schemas.microsoft.com/office/drawing/2014/main" id="{1DAD48F0-0B0E-40E2-9ED5-E0FBB99C44F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637944"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2" name="Rectangle 66">
              <a:extLst>
                <a:ext uri="{FF2B5EF4-FFF2-40B4-BE49-F238E27FC236}">
                  <a16:creationId xmlns:a16="http://schemas.microsoft.com/office/drawing/2014/main" id="{A58F217F-BBAB-4ACB-91C0-B119DEFDC6F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637944"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3" name="Rectangle 64">
              <a:extLst>
                <a:ext uri="{FF2B5EF4-FFF2-40B4-BE49-F238E27FC236}">
                  <a16:creationId xmlns:a16="http://schemas.microsoft.com/office/drawing/2014/main" id="{17D6638B-4C45-4C73-AFE3-8C41F939A9B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512988"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4" name="Rectangle 66">
              <a:extLst>
                <a:ext uri="{FF2B5EF4-FFF2-40B4-BE49-F238E27FC236}">
                  <a16:creationId xmlns:a16="http://schemas.microsoft.com/office/drawing/2014/main" id="{31A3013F-24A0-486B-A892-92E42BD7418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512988"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5" name="Rectangle 64">
              <a:extLst>
                <a:ext uri="{FF2B5EF4-FFF2-40B4-BE49-F238E27FC236}">
                  <a16:creationId xmlns:a16="http://schemas.microsoft.com/office/drawing/2014/main" id="{F4540C9F-BC47-470D-A9C2-4AB05FB4C5B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388033" y="73152"/>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6" name="Rectangle 66">
              <a:extLst>
                <a:ext uri="{FF2B5EF4-FFF2-40B4-BE49-F238E27FC236}">
                  <a16:creationId xmlns:a16="http://schemas.microsoft.com/office/drawing/2014/main" id="{A38505B1-1AD2-47B0-8122-2EB533CBAA4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388033" y="246888"/>
              <a:ext cx="54368" cy="59227"/>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2" name="Picture 1">
            <a:extLst>
              <a:ext uri="{FF2B5EF4-FFF2-40B4-BE49-F238E27FC236}">
                <a16:creationId xmlns:a16="http://schemas.microsoft.com/office/drawing/2014/main" id="{83BC08F3-BCC9-AC88-E150-44D71D743744}"/>
              </a:ext>
            </a:extLst>
          </p:cNvPr>
          <p:cNvPicPr>
            <a:picLocks noChangeAspect="1"/>
          </p:cNvPicPr>
          <p:nvPr/>
        </p:nvPicPr>
        <p:blipFill>
          <a:blip r:embed="rId5"/>
          <a:stretch>
            <a:fillRect/>
          </a:stretch>
        </p:blipFill>
        <p:spPr>
          <a:xfrm>
            <a:off x="6235031" y="3822396"/>
            <a:ext cx="3506704" cy="2479590"/>
          </a:xfrm>
          <a:prstGeom prst="rect">
            <a:avLst/>
          </a:prstGeom>
        </p:spPr>
      </p:pic>
      <p:sp>
        <p:nvSpPr>
          <p:cNvPr id="15" name="Triangle 14">
            <a:extLst>
              <a:ext uri="{FF2B5EF4-FFF2-40B4-BE49-F238E27FC236}">
                <a16:creationId xmlns:a16="http://schemas.microsoft.com/office/drawing/2014/main" id="{DB6642E1-F7BB-97C0-43EF-E6F732E4927B}"/>
              </a:ext>
            </a:extLst>
          </p:cNvPr>
          <p:cNvSpPr/>
          <p:nvPr/>
        </p:nvSpPr>
        <p:spPr>
          <a:xfrm>
            <a:off x="6592186" y="1465561"/>
            <a:ext cx="2573079" cy="1519137"/>
          </a:xfrm>
          <a:prstGeom prst="triangle">
            <a:avLst>
              <a:gd name="adj" fmla="val 49989"/>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Chord 15">
            <a:extLst>
              <a:ext uri="{FF2B5EF4-FFF2-40B4-BE49-F238E27FC236}">
                <a16:creationId xmlns:a16="http://schemas.microsoft.com/office/drawing/2014/main" id="{F8A0B15B-4106-0965-E04A-27B3B1E343FA}"/>
              </a:ext>
            </a:extLst>
          </p:cNvPr>
          <p:cNvSpPr/>
          <p:nvPr/>
        </p:nvSpPr>
        <p:spPr>
          <a:xfrm rot="16200000">
            <a:off x="7471944" y="1686274"/>
            <a:ext cx="813565" cy="2573079"/>
          </a:xfrm>
          <a:prstGeom prst="chord">
            <a:avLst>
              <a:gd name="adj1" fmla="val 5397118"/>
              <a:gd name="adj2" fmla="val 16178863"/>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Oval 55">
            <a:extLst>
              <a:ext uri="{FF2B5EF4-FFF2-40B4-BE49-F238E27FC236}">
                <a16:creationId xmlns:a16="http://schemas.microsoft.com/office/drawing/2014/main" id="{64E67B65-2C24-F40B-34FE-8E4E0E743269}"/>
              </a:ext>
            </a:extLst>
          </p:cNvPr>
          <p:cNvSpPr/>
          <p:nvPr/>
        </p:nvSpPr>
        <p:spPr>
          <a:xfrm>
            <a:off x="7212097" y="1410736"/>
            <a:ext cx="2107334" cy="2134424"/>
          </a:xfrm>
          <a:prstGeom prst="ellips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Oval 16">
            <a:extLst>
              <a:ext uri="{FF2B5EF4-FFF2-40B4-BE49-F238E27FC236}">
                <a16:creationId xmlns:a16="http://schemas.microsoft.com/office/drawing/2014/main" id="{5F0A1829-D429-8E2A-B2CF-B5530F925E4A}"/>
              </a:ext>
            </a:extLst>
          </p:cNvPr>
          <p:cNvSpPr/>
          <p:nvPr/>
        </p:nvSpPr>
        <p:spPr>
          <a:xfrm rot="3378784">
            <a:off x="8039910" y="2014185"/>
            <a:ext cx="660919" cy="1221410"/>
          </a:xfrm>
          <a:custGeom>
            <a:avLst/>
            <a:gdLst>
              <a:gd name="connsiteX0" fmla="*/ 0 w 713696"/>
              <a:gd name="connsiteY0" fmla="*/ 707847 h 1415693"/>
              <a:gd name="connsiteX1" fmla="*/ 356848 w 713696"/>
              <a:gd name="connsiteY1" fmla="*/ 0 h 1415693"/>
              <a:gd name="connsiteX2" fmla="*/ 713696 w 713696"/>
              <a:gd name="connsiteY2" fmla="*/ 707847 h 1415693"/>
              <a:gd name="connsiteX3" fmla="*/ 356848 w 713696"/>
              <a:gd name="connsiteY3" fmla="*/ 1415694 h 1415693"/>
              <a:gd name="connsiteX4" fmla="*/ 0 w 713696"/>
              <a:gd name="connsiteY4" fmla="*/ 707847 h 1415693"/>
              <a:gd name="connsiteX0" fmla="*/ 0 w 519487"/>
              <a:gd name="connsiteY0" fmla="*/ 707893 h 1415790"/>
              <a:gd name="connsiteX1" fmla="*/ 356848 w 519487"/>
              <a:gd name="connsiteY1" fmla="*/ 46 h 1415790"/>
              <a:gd name="connsiteX2" fmla="*/ 519487 w 519487"/>
              <a:gd name="connsiteY2" fmla="*/ 734731 h 1415790"/>
              <a:gd name="connsiteX3" fmla="*/ 356848 w 519487"/>
              <a:gd name="connsiteY3" fmla="*/ 1415740 h 1415790"/>
              <a:gd name="connsiteX4" fmla="*/ 0 w 519487"/>
              <a:gd name="connsiteY4" fmla="*/ 707893 h 1415790"/>
              <a:gd name="connsiteX0" fmla="*/ 0 w 578883"/>
              <a:gd name="connsiteY0" fmla="*/ 707893 h 1415790"/>
              <a:gd name="connsiteX1" fmla="*/ 356848 w 578883"/>
              <a:gd name="connsiteY1" fmla="*/ 46 h 1415790"/>
              <a:gd name="connsiteX2" fmla="*/ 519487 w 578883"/>
              <a:gd name="connsiteY2" fmla="*/ 734731 h 1415790"/>
              <a:gd name="connsiteX3" fmla="*/ 356848 w 578883"/>
              <a:gd name="connsiteY3" fmla="*/ 1415740 h 1415790"/>
              <a:gd name="connsiteX4" fmla="*/ 0 w 578883"/>
              <a:gd name="connsiteY4" fmla="*/ 707893 h 1415790"/>
              <a:gd name="connsiteX0" fmla="*/ 0 w 578883"/>
              <a:gd name="connsiteY0" fmla="*/ 707893 h 1415792"/>
              <a:gd name="connsiteX1" fmla="*/ 356848 w 578883"/>
              <a:gd name="connsiteY1" fmla="*/ 46 h 1415792"/>
              <a:gd name="connsiteX2" fmla="*/ 519487 w 578883"/>
              <a:gd name="connsiteY2" fmla="*/ 734731 h 1415792"/>
              <a:gd name="connsiteX3" fmla="*/ 356848 w 578883"/>
              <a:gd name="connsiteY3" fmla="*/ 1415740 h 1415792"/>
              <a:gd name="connsiteX4" fmla="*/ 0 w 578883"/>
              <a:gd name="connsiteY4" fmla="*/ 707893 h 1415792"/>
              <a:gd name="connsiteX0" fmla="*/ 0 w 496946"/>
              <a:gd name="connsiteY0" fmla="*/ 707888 h 1415781"/>
              <a:gd name="connsiteX1" fmla="*/ 356848 w 496946"/>
              <a:gd name="connsiteY1" fmla="*/ 41 h 1415781"/>
              <a:gd name="connsiteX2" fmla="*/ 421472 w 496946"/>
              <a:gd name="connsiteY2" fmla="*/ 733136 h 1415781"/>
              <a:gd name="connsiteX3" fmla="*/ 356848 w 496946"/>
              <a:gd name="connsiteY3" fmla="*/ 1415735 h 1415781"/>
              <a:gd name="connsiteX4" fmla="*/ 0 w 496946"/>
              <a:gd name="connsiteY4" fmla="*/ 707888 h 1415781"/>
              <a:gd name="connsiteX0" fmla="*/ 0 w 502638"/>
              <a:gd name="connsiteY0" fmla="*/ 707915 h 1415842"/>
              <a:gd name="connsiteX1" fmla="*/ 356848 w 502638"/>
              <a:gd name="connsiteY1" fmla="*/ 68 h 1415842"/>
              <a:gd name="connsiteX2" fmla="*/ 428612 w 502638"/>
              <a:gd name="connsiteY2" fmla="*/ 740792 h 1415842"/>
              <a:gd name="connsiteX3" fmla="*/ 356848 w 502638"/>
              <a:gd name="connsiteY3" fmla="*/ 1415762 h 1415842"/>
              <a:gd name="connsiteX4" fmla="*/ 0 w 502638"/>
              <a:gd name="connsiteY4" fmla="*/ 707915 h 1415842"/>
              <a:gd name="connsiteX0" fmla="*/ 0 w 483503"/>
              <a:gd name="connsiteY0" fmla="*/ 707915 h 1415842"/>
              <a:gd name="connsiteX1" fmla="*/ 356848 w 483503"/>
              <a:gd name="connsiteY1" fmla="*/ 68 h 1415842"/>
              <a:gd name="connsiteX2" fmla="*/ 428612 w 483503"/>
              <a:gd name="connsiteY2" fmla="*/ 740792 h 1415842"/>
              <a:gd name="connsiteX3" fmla="*/ 356848 w 483503"/>
              <a:gd name="connsiteY3" fmla="*/ 1415762 h 1415842"/>
              <a:gd name="connsiteX4" fmla="*/ 0 w 483503"/>
              <a:gd name="connsiteY4" fmla="*/ 707915 h 1415842"/>
              <a:gd name="connsiteX0" fmla="*/ 0 w 483810"/>
              <a:gd name="connsiteY0" fmla="*/ 707915 h 1415882"/>
              <a:gd name="connsiteX1" fmla="*/ 356848 w 483810"/>
              <a:gd name="connsiteY1" fmla="*/ 68 h 1415882"/>
              <a:gd name="connsiteX2" fmla="*/ 428612 w 483810"/>
              <a:gd name="connsiteY2" fmla="*/ 740792 h 1415882"/>
              <a:gd name="connsiteX3" fmla="*/ 356848 w 483810"/>
              <a:gd name="connsiteY3" fmla="*/ 1415762 h 1415882"/>
              <a:gd name="connsiteX4" fmla="*/ 0 w 483810"/>
              <a:gd name="connsiteY4" fmla="*/ 707915 h 141588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83810" h="1415882">
                <a:moveTo>
                  <a:pt x="0" y="707915"/>
                </a:moveTo>
                <a:cubicBezTo>
                  <a:pt x="0" y="316982"/>
                  <a:pt x="285413" y="-5411"/>
                  <a:pt x="356848" y="68"/>
                </a:cubicBezTo>
                <a:cubicBezTo>
                  <a:pt x="428283" y="5547"/>
                  <a:pt x="527445" y="315833"/>
                  <a:pt x="428612" y="740792"/>
                </a:cubicBezTo>
                <a:cubicBezTo>
                  <a:pt x="558249" y="1240666"/>
                  <a:pt x="428283" y="1421241"/>
                  <a:pt x="356848" y="1415762"/>
                </a:cubicBezTo>
                <a:cubicBezTo>
                  <a:pt x="285413" y="1410283"/>
                  <a:pt x="0" y="1098848"/>
                  <a:pt x="0" y="707915"/>
                </a:cubicBezTo>
                <a:close/>
              </a:path>
            </a:pathLst>
          </a:custGeom>
          <a:solidFill>
            <a:schemeClr val="tx1">
              <a:lumMod val="65000"/>
              <a:lumOff val="3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Oval 16">
            <a:extLst>
              <a:ext uri="{FF2B5EF4-FFF2-40B4-BE49-F238E27FC236}">
                <a16:creationId xmlns:a16="http://schemas.microsoft.com/office/drawing/2014/main" id="{44F6BDCA-D377-4941-92BA-87394D39C014}"/>
              </a:ext>
            </a:extLst>
          </p:cNvPr>
          <p:cNvSpPr/>
          <p:nvPr/>
        </p:nvSpPr>
        <p:spPr>
          <a:xfrm rot="3044853">
            <a:off x="8252814" y="2268151"/>
            <a:ext cx="221042" cy="727879"/>
          </a:xfrm>
          <a:custGeom>
            <a:avLst/>
            <a:gdLst>
              <a:gd name="connsiteX0" fmla="*/ 0 w 713696"/>
              <a:gd name="connsiteY0" fmla="*/ 707847 h 1415693"/>
              <a:gd name="connsiteX1" fmla="*/ 356848 w 713696"/>
              <a:gd name="connsiteY1" fmla="*/ 0 h 1415693"/>
              <a:gd name="connsiteX2" fmla="*/ 713696 w 713696"/>
              <a:gd name="connsiteY2" fmla="*/ 707847 h 1415693"/>
              <a:gd name="connsiteX3" fmla="*/ 356848 w 713696"/>
              <a:gd name="connsiteY3" fmla="*/ 1415694 h 1415693"/>
              <a:gd name="connsiteX4" fmla="*/ 0 w 713696"/>
              <a:gd name="connsiteY4" fmla="*/ 707847 h 1415693"/>
              <a:gd name="connsiteX0" fmla="*/ 0 w 519487"/>
              <a:gd name="connsiteY0" fmla="*/ 707893 h 1415790"/>
              <a:gd name="connsiteX1" fmla="*/ 356848 w 519487"/>
              <a:gd name="connsiteY1" fmla="*/ 46 h 1415790"/>
              <a:gd name="connsiteX2" fmla="*/ 519487 w 519487"/>
              <a:gd name="connsiteY2" fmla="*/ 734731 h 1415790"/>
              <a:gd name="connsiteX3" fmla="*/ 356848 w 519487"/>
              <a:gd name="connsiteY3" fmla="*/ 1415740 h 1415790"/>
              <a:gd name="connsiteX4" fmla="*/ 0 w 519487"/>
              <a:gd name="connsiteY4" fmla="*/ 707893 h 1415790"/>
              <a:gd name="connsiteX0" fmla="*/ 0 w 578883"/>
              <a:gd name="connsiteY0" fmla="*/ 707893 h 1415790"/>
              <a:gd name="connsiteX1" fmla="*/ 356848 w 578883"/>
              <a:gd name="connsiteY1" fmla="*/ 46 h 1415790"/>
              <a:gd name="connsiteX2" fmla="*/ 519487 w 578883"/>
              <a:gd name="connsiteY2" fmla="*/ 734731 h 1415790"/>
              <a:gd name="connsiteX3" fmla="*/ 356848 w 578883"/>
              <a:gd name="connsiteY3" fmla="*/ 1415740 h 1415790"/>
              <a:gd name="connsiteX4" fmla="*/ 0 w 578883"/>
              <a:gd name="connsiteY4" fmla="*/ 707893 h 1415790"/>
              <a:gd name="connsiteX0" fmla="*/ 0 w 578883"/>
              <a:gd name="connsiteY0" fmla="*/ 707893 h 1415792"/>
              <a:gd name="connsiteX1" fmla="*/ 356848 w 578883"/>
              <a:gd name="connsiteY1" fmla="*/ 46 h 1415792"/>
              <a:gd name="connsiteX2" fmla="*/ 519487 w 578883"/>
              <a:gd name="connsiteY2" fmla="*/ 734731 h 1415792"/>
              <a:gd name="connsiteX3" fmla="*/ 356848 w 578883"/>
              <a:gd name="connsiteY3" fmla="*/ 1415740 h 1415792"/>
              <a:gd name="connsiteX4" fmla="*/ 0 w 578883"/>
              <a:gd name="connsiteY4" fmla="*/ 707893 h 1415792"/>
              <a:gd name="connsiteX0" fmla="*/ 0 w 496946"/>
              <a:gd name="connsiteY0" fmla="*/ 707888 h 1415781"/>
              <a:gd name="connsiteX1" fmla="*/ 356848 w 496946"/>
              <a:gd name="connsiteY1" fmla="*/ 41 h 1415781"/>
              <a:gd name="connsiteX2" fmla="*/ 421472 w 496946"/>
              <a:gd name="connsiteY2" fmla="*/ 733136 h 1415781"/>
              <a:gd name="connsiteX3" fmla="*/ 356848 w 496946"/>
              <a:gd name="connsiteY3" fmla="*/ 1415735 h 1415781"/>
              <a:gd name="connsiteX4" fmla="*/ 0 w 496946"/>
              <a:gd name="connsiteY4" fmla="*/ 707888 h 1415781"/>
              <a:gd name="connsiteX0" fmla="*/ 0 w 502638"/>
              <a:gd name="connsiteY0" fmla="*/ 707915 h 1415842"/>
              <a:gd name="connsiteX1" fmla="*/ 356848 w 502638"/>
              <a:gd name="connsiteY1" fmla="*/ 68 h 1415842"/>
              <a:gd name="connsiteX2" fmla="*/ 428612 w 502638"/>
              <a:gd name="connsiteY2" fmla="*/ 740792 h 1415842"/>
              <a:gd name="connsiteX3" fmla="*/ 356848 w 502638"/>
              <a:gd name="connsiteY3" fmla="*/ 1415762 h 1415842"/>
              <a:gd name="connsiteX4" fmla="*/ 0 w 502638"/>
              <a:gd name="connsiteY4" fmla="*/ 707915 h 1415842"/>
              <a:gd name="connsiteX0" fmla="*/ 0 w 483503"/>
              <a:gd name="connsiteY0" fmla="*/ 707915 h 1415842"/>
              <a:gd name="connsiteX1" fmla="*/ 356848 w 483503"/>
              <a:gd name="connsiteY1" fmla="*/ 68 h 1415842"/>
              <a:gd name="connsiteX2" fmla="*/ 428612 w 483503"/>
              <a:gd name="connsiteY2" fmla="*/ 740792 h 1415842"/>
              <a:gd name="connsiteX3" fmla="*/ 356848 w 483503"/>
              <a:gd name="connsiteY3" fmla="*/ 1415762 h 1415842"/>
              <a:gd name="connsiteX4" fmla="*/ 0 w 483503"/>
              <a:gd name="connsiteY4" fmla="*/ 707915 h 1415842"/>
              <a:gd name="connsiteX0" fmla="*/ 0 w 483810"/>
              <a:gd name="connsiteY0" fmla="*/ 707915 h 1415882"/>
              <a:gd name="connsiteX1" fmla="*/ 356848 w 483810"/>
              <a:gd name="connsiteY1" fmla="*/ 68 h 1415882"/>
              <a:gd name="connsiteX2" fmla="*/ 428612 w 483810"/>
              <a:gd name="connsiteY2" fmla="*/ 740792 h 1415882"/>
              <a:gd name="connsiteX3" fmla="*/ 356848 w 483810"/>
              <a:gd name="connsiteY3" fmla="*/ 1415762 h 1415882"/>
              <a:gd name="connsiteX4" fmla="*/ 0 w 483810"/>
              <a:gd name="connsiteY4" fmla="*/ 707915 h 141588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83810" h="1415882">
                <a:moveTo>
                  <a:pt x="0" y="707915"/>
                </a:moveTo>
                <a:cubicBezTo>
                  <a:pt x="0" y="316982"/>
                  <a:pt x="285413" y="-5411"/>
                  <a:pt x="356848" y="68"/>
                </a:cubicBezTo>
                <a:cubicBezTo>
                  <a:pt x="428283" y="5547"/>
                  <a:pt x="527445" y="315833"/>
                  <a:pt x="428612" y="740792"/>
                </a:cubicBezTo>
                <a:cubicBezTo>
                  <a:pt x="558249" y="1240666"/>
                  <a:pt x="428283" y="1421241"/>
                  <a:pt x="356848" y="1415762"/>
                </a:cubicBezTo>
                <a:cubicBezTo>
                  <a:pt x="285413" y="1410283"/>
                  <a:pt x="0" y="1098848"/>
                  <a:pt x="0" y="707915"/>
                </a:cubicBezTo>
                <a:close/>
              </a:path>
            </a:pathLst>
          </a:custGeom>
          <a:solidFill>
            <a:schemeClr val="bg1">
              <a:lumMod val="85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Snip Same Side Corner Rectangle 27">
            <a:extLst>
              <a:ext uri="{FF2B5EF4-FFF2-40B4-BE49-F238E27FC236}">
                <a16:creationId xmlns:a16="http://schemas.microsoft.com/office/drawing/2014/main" id="{07919AD9-8CB1-9CC6-42F0-023EB952ECE4}"/>
              </a:ext>
            </a:extLst>
          </p:cNvPr>
          <p:cNvSpPr/>
          <p:nvPr/>
        </p:nvSpPr>
        <p:spPr>
          <a:xfrm rot="6506859">
            <a:off x="8024229" y="2745185"/>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Snip Same Side Corner Rectangle 28">
            <a:extLst>
              <a:ext uri="{FF2B5EF4-FFF2-40B4-BE49-F238E27FC236}">
                <a16:creationId xmlns:a16="http://schemas.microsoft.com/office/drawing/2014/main" id="{33D05A93-6BF8-D510-8458-BDA5B560C741}"/>
              </a:ext>
            </a:extLst>
          </p:cNvPr>
          <p:cNvSpPr/>
          <p:nvPr/>
        </p:nvSpPr>
        <p:spPr>
          <a:xfrm rot="7512513">
            <a:off x="8084822" y="2582400"/>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Snip Same Side Corner Rectangle 29">
            <a:extLst>
              <a:ext uri="{FF2B5EF4-FFF2-40B4-BE49-F238E27FC236}">
                <a16:creationId xmlns:a16="http://schemas.microsoft.com/office/drawing/2014/main" id="{7B8B6F6F-4D6B-0692-BA7F-4951672FC5EE}"/>
              </a:ext>
            </a:extLst>
          </p:cNvPr>
          <p:cNvSpPr/>
          <p:nvPr/>
        </p:nvSpPr>
        <p:spPr>
          <a:xfrm rot="8653007">
            <a:off x="8215274" y="2433756"/>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Snip Same Side Corner Rectangle 30">
            <a:extLst>
              <a:ext uri="{FF2B5EF4-FFF2-40B4-BE49-F238E27FC236}">
                <a16:creationId xmlns:a16="http://schemas.microsoft.com/office/drawing/2014/main" id="{0351CDC8-D18B-90DD-E714-9C45349E353A}"/>
              </a:ext>
            </a:extLst>
          </p:cNvPr>
          <p:cNvSpPr/>
          <p:nvPr/>
        </p:nvSpPr>
        <p:spPr>
          <a:xfrm rot="10260642">
            <a:off x="8375984" y="2356041"/>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Snip Same Side Corner Rectangle 32">
            <a:extLst>
              <a:ext uri="{FF2B5EF4-FFF2-40B4-BE49-F238E27FC236}">
                <a16:creationId xmlns:a16="http://schemas.microsoft.com/office/drawing/2014/main" id="{27F5CD66-692A-F76D-827D-F6C833BEA7C3}"/>
              </a:ext>
            </a:extLst>
          </p:cNvPr>
          <p:cNvSpPr/>
          <p:nvPr/>
        </p:nvSpPr>
        <p:spPr>
          <a:xfrm rot="20853396">
            <a:off x="8172804" y="2864532"/>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Snip Same Side Corner Rectangle 33">
            <a:extLst>
              <a:ext uri="{FF2B5EF4-FFF2-40B4-BE49-F238E27FC236}">
                <a16:creationId xmlns:a16="http://schemas.microsoft.com/office/drawing/2014/main" id="{C97855E4-76C4-A371-8461-B8D1AA49564D}"/>
              </a:ext>
            </a:extLst>
          </p:cNvPr>
          <p:cNvSpPr/>
          <p:nvPr/>
        </p:nvSpPr>
        <p:spPr>
          <a:xfrm rot="11093128">
            <a:off x="8542961" y="2334136"/>
            <a:ext cx="119750" cy="126286"/>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Snip Same Side Corner Rectangle 34">
            <a:extLst>
              <a:ext uri="{FF2B5EF4-FFF2-40B4-BE49-F238E27FC236}">
                <a16:creationId xmlns:a16="http://schemas.microsoft.com/office/drawing/2014/main" id="{01A56FEA-58B5-7214-D301-32EACAEA3E2F}"/>
              </a:ext>
            </a:extLst>
          </p:cNvPr>
          <p:cNvSpPr/>
          <p:nvPr/>
        </p:nvSpPr>
        <p:spPr>
          <a:xfrm rot="18306357">
            <a:off x="8302815" y="2751928"/>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Snip Same Side Corner Rectangle 35">
            <a:extLst>
              <a:ext uri="{FF2B5EF4-FFF2-40B4-BE49-F238E27FC236}">
                <a16:creationId xmlns:a16="http://schemas.microsoft.com/office/drawing/2014/main" id="{D5D1E5DC-8EE1-C63E-49B4-3173F0303431}"/>
              </a:ext>
            </a:extLst>
          </p:cNvPr>
          <p:cNvSpPr/>
          <p:nvPr/>
        </p:nvSpPr>
        <p:spPr>
          <a:xfrm rot="19604826">
            <a:off x="8458112" y="2623377"/>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Snip Same Side Corner Rectangle 36">
            <a:extLst>
              <a:ext uri="{FF2B5EF4-FFF2-40B4-BE49-F238E27FC236}">
                <a16:creationId xmlns:a16="http://schemas.microsoft.com/office/drawing/2014/main" id="{A7368838-E467-C8AB-97C2-EA8FC520CC9E}"/>
              </a:ext>
            </a:extLst>
          </p:cNvPr>
          <p:cNvSpPr/>
          <p:nvPr/>
        </p:nvSpPr>
        <p:spPr>
          <a:xfrm rot="17624662">
            <a:off x="8606864" y="2515075"/>
            <a:ext cx="114423" cy="109119"/>
          </a:xfrm>
          <a:prstGeom prst="snip2Same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Oval 16">
            <a:extLst>
              <a:ext uri="{FF2B5EF4-FFF2-40B4-BE49-F238E27FC236}">
                <a16:creationId xmlns:a16="http://schemas.microsoft.com/office/drawing/2014/main" id="{E9F509EB-6D14-4742-72F0-01A6D7E9F81C}"/>
              </a:ext>
            </a:extLst>
          </p:cNvPr>
          <p:cNvSpPr/>
          <p:nvPr/>
        </p:nvSpPr>
        <p:spPr>
          <a:xfrm rot="3044853">
            <a:off x="7404732" y="1492680"/>
            <a:ext cx="923909" cy="1590978"/>
          </a:xfrm>
          <a:custGeom>
            <a:avLst/>
            <a:gdLst>
              <a:gd name="connsiteX0" fmla="*/ 0 w 713696"/>
              <a:gd name="connsiteY0" fmla="*/ 707847 h 1415693"/>
              <a:gd name="connsiteX1" fmla="*/ 356848 w 713696"/>
              <a:gd name="connsiteY1" fmla="*/ 0 h 1415693"/>
              <a:gd name="connsiteX2" fmla="*/ 713696 w 713696"/>
              <a:gd name="connsiteY2" fmla="*/ 707847 h 1415693"/>
              <a:gd name="connsiteX3" fmla="*/ 356848 w 713696"/>
              <a:gd name="connsiteY3" fmla="*/ 1415694 h 1415693"/>
              <a:gd name="connsiteX4" fmla="*/ 0 w 713696"/>
              <a:gd name="connsiteY4" fmla="*/ 707847 h 1415693"/>
              <a:gd name="connsiteX0" fmla="*/ 0 w 519487"/>
              <a:gd name="connsiteY0" fmla="*/ 707893 h 1415790"/>
              <a:gd name="connsiteX1" fmla="*/ 356848 w 519487"/>
              <a:gd name="connsiteY1" fmla="*/ 46 h 1415790"/>
              <a:gd name="connsiteX2" fmla="*/ 519487 w 519487"/>
              <a:gd name="connsiteY2" fmla="*/ 734731 h 1415790"/>
              <a:gd name="connsiteX3" fmla="*/ 356848 w 519487"/>
              <a:gd name="connsiteY3" fmla="*/ 1415740 h 1415790"/>
              <a:gd name="connsiteX4" fmla="*/ 0 w 519487"/>
              <a:gd name="connsiteY4" fmla="*/ 707893 h 1415790"/>
              <a:gd name="connsiteX0" fmla="*/ 0 w 578883"/>
              <a:gd name="connsiteY0" fmla="*/ 707893 h 1415790"/>
              <a:gd name="connsiteX1" fmla="*/ 356848 w 578883"/>
              <a:gd name="connsiteY1" fmla="*/ 46 h 1415790"/>
              <a:gd name="connsiteX2" fmla="*/ 519487 w 578883"/>
              <a:gd name="connsiteY2" fmla="*/ 734731 h 1415790"/>
              <a:gd name="connsiteX3" fmla="*/ 356848 w 578883"/>
              <a:gd name="connsiteY3" fmla="*/ 1415740 h 1415790"/>
              <a:gd name="connsiteX4" fmla="*/ 0 w 578883"/>
              <a:gd name="connsiteY4" fmla="*/ 707893 h 1415790"/>
              <a:gd name="connsiteX0" fmla="*/ 0 w 578883"/>
              <a:gd name="connsiteY0" fmla="*/ 707893 h 1415792"/>
              <a:gd name="connsiteX1" fmla="*/ 356848 w 578883"/>
              <a:gd name="connsiteY1" fmla="*/ 46 h 1415792"/>
              <a:gd name="connsiteX2" fmla="*/ 519487 w 578883"/>
              <a:gd name="connsiteY2" fmla="*/ 734731 h 1415792"/>
              <a:gd name="connsiteX3" fmla="*/ 356848 w 578883"/>
              <a:gd name="connsiteY3" fmla="*/ 1415740 h 1415792"/>
              <a:gd name="connsiteX4" fmla="*/ 0 w 578883"/>
              <a:gd name="connsiteY4" fmla="*/ 707893 h 1415792"/>
              <a:gd name="connsiteX0" fmla="*/ 0 w 496946"/>
              <a:gd name="connsiteY0" fmla="*/ 707888 h 1415781"/>
              <a:gd name="connsiteX1" fmla="*/ 356848 w 496946"/>
              <a:gd name="connsiteY1" fmla="*/ 41 h 1415781"/>
              <a:gd name="connsiteX2" fmla="*/ 421472 w 496946"/>
              <a:gd name="connsiteY2" fmla="*/ 733136 h 1415781"/>
              <a:gd name="connsiteX3" fmla="*/ 356848 w 496946"/>
              <a:gd name="connsiteY3" fmla="*/ 1415735 h 1415781"/>
              <a:gd name="connsiteX4" fmla="*/ 0 w 496946"/>
              <a:gd name="connsiteY4" fmla="*/ 707888 h 1415781"/>
              <a:gd name="connsiteX0" fmla="*/ 0 w 502638"/>
              <a:gd name="connsiteY0" fmla="*/ 707915 h 1415842"/>
              <a:gd name="connsiteX1" fmla="*/ 356848 w 502638"/>
              <a:gd name="connsiteY1" fmla="*/ 68 h 1415842"/>
              <a:gd name="connsiteX2" fmla="*/ 428612 w 502638"/>
              <a:gd name="connsiteY2" fmla="*/ 740792 h 1415842"/>
              <a:gd name="connsiteX3" fmla="*/ 356848 w 502638"/>
              <a:gd name="connsiteY3" fmla="*/ 1415762 h 1415842"/>
              <a:gd name="connsiteX4" fmla="*/ 0 w 502638"/>
              <a:gd name="connsiteY4" fmla="*/ 707915 h 1415842"/>
              <a:gd name="connsiteX0" fmla="*/ 0 w 483503"/>
              <a:gd name="connsiteY0" fmla="*/ 707915 h 1415842"/>
              <a:gd name="connsiteX1" fmla="*/ 356848 w 483503"/>
              <a:gd name="connsiteY1" fmla="*/ 68 h 1415842"/>
              <a:gd name="connsiteX2" fmla="*/ 428612 w 483503"/>
              <a:gd name="connsiteY2" fmla="*/ 740792 h 1415842"/>
              <a:gd name="connsiteX3" fmla="*/ 356848 w 483503"/>
              <a:gd name="connsiteY3" fmla="*/ 1415762 h 1415842"/>
              <a:gd name="connsiteX4" fmla="*/ 0 w 483503"/>
              <a:gd name="connsiteY4" fmla="*/ 707915 h 1415842"/>
              <a:gd name="connsiteX0" fmla="*/ 0 w 483810"/>
              <a:gd name="connsiteY0" fmla="*/ 707915 h 1415882"/>
              <a:gd name="connsiteX1" fmla="*/ 356848 w 483810"/>
              <a:gd name="connsiteY1" fmla="*/ 68 h 1415882"/>
              <a:gd name="connsiteX2" fmla="*/ 428612 w 483810"/>
              <a:gd name="connsiteY2" fmla="*/ 740792 h 1415882"/>
              <a:gd name="connsiteX3" fmla="*/ 356848 w 483810"/>
              <a:gd name="connsiteY3" fmla="*/ 1415762 h 1415882"/>
              <a:gd name="connsiteX4" fmla="*/ 0 w 483810"/>
              <a:gd name="connsiteY4" fmla="*/ 707915 h 1415882"/>
              <a:gd name="connsiteX0" fmla="*/ 0 w 511577"/>
              <a:gd name="connsiteY0" fmla="*/ 709945 h 1418909"/>
              <a:gd name="connsiteX1" fmla="*/ 356848 w 511577"/>
              <a:gd name="connsiteY1" fmla="*/ 2098 h 1418909"/>
              <a:gd name="connsiteX2" fmla="*/ 462210 w 511577"/>
              <a:gd name="connsiteY2" fmla="*/ 571010 h 1418909"/>
              <a:gd name="connsiteX3" fmla="*/ 356848 w 511577"/>
              <a:gd name="connsiteY3" fmla="*/ 1417792 h 1418909"/>
              <a:gd name="connsiteX4" fmla="*/ 0 w 511577"/>
              <a:gd name="connsiteY4" fmla="*/ 709945 h 1418909"/>
              <a:gd name="connsiteX0" fmla="*/ 0 w 480134"/>
              <a:gd name="connsiteY0" fmla="*/ 714806 h 1425265"/>
              <a:gd name="connsiteX1" fmla="*/ 356848 w 480134"/>
              <a:gd name="connsiteY1" fmla="*/ 6959 h 1425265"/>
              <a:gd name="connsiteX2" fmla="*/ 424040 w 480134"/>
              <a:gd name="connsiteY2" fmla="*/ 495214 h 1425265"/>
              <a:gd name="connsiteX3" fmla="*/ 356848 w 480134"/>
              <a:gd name="connsiteY3" fmla="*/ 1422653 h 1425265"/>
              <a:gd name="connsiteX4" fmla="*/ 0 w 480134"/>
              <a:gd name="connsiteY4" fmla="*/ 714806 h 1425265"/>
              <a:gd name="connsiteX0" fmla="*/ 0 w 548526"/>
              <a:gd name="connsiteY0" fmla="*/ 770685 h 1429730"/>
              <a:gd name="connsiteX1" fmla="*/ 422951 w 548526"/>
              <a:gd name="connsiteY1" fmla="*/ 9588 h 1429730"/>
              <a:gd name="connsiteX2" fmla="*/ 490143 w 548526"/>
              <a:gd name="connsiteY2" fmla="*/ 497843 h 1429730"/>
              <a:gd name="connsiteX3" fmla="*/ 422951 w 548526"/>
              <a:gd name="connsiteY3" fmla="*/ 1425282 h 1429730"/>
              <a:gd name="connsiteX4" fmla="*/ 0 w 548526"/>
              <a:gd name="connsiteY4" fmla="*/ 770685 h 1429730"/>
              <a:gd name="connsiteX0" fmla="*/ 805 w 598388"/>
              <a:gd name="connsiteY0" fmla="*/ 770685 h 1453218"/>
              <a:gd name="connsiteX1" fmla="*/ 423756 w 598388"/>
              <a:gd name="connsiteY1" fmla="*/ 9588 h 1453218"/>
              <a:gd name="connsiteX2" fmla="*/ 490948 w 598388"/>
              <a:gd name="connsiteY2" fmla="*/ 497843 h 1453218"/>
              <a:gd name="connsiteX3" fmla="*/ 544255 w 598388"/>
              <a:gd name="connsiteY3" fmla="*/ 1450230 h 1453218"/>
              <a:gd name="connsiteX4" fmla="*/ 805 w 598388"/>
              <a:gd name="connsiteY4" fmla="*/ 770685 h 1453218"/>
              <a:gd name="connsiteX0" fmla="*/ 811 w 606800"/>
              <a:gd name="connsiteY0" fmla="*/ 762772 h 1443162"/>
              <a:gd name="connsiteX1" fmla="*/ 423762 w 606800"/>
              <a:gd name="connsiteY1" fmla="*/ 1675 h 1443162"/>
              <a:gd name="connsiteX2" fmla="*/ 508050 w 606800"/>
              <a:gd name="connsiteY2" fmla="*/ 623181 h 1443162"/>
              <a:gd name="connsiteX3" fmla="*/ 544261 w 606800"/>
              <a:gd name="connsiteY3" fmla="*/ 1442317 h 1443162"/>
              <a:gd name="connsiteX4" fmla="*/ 811 w 606800"/>
              <a:gd name="connsiteY4" fmla="*/ 762772 h 1443162"/>
              <a:gd name="connsiteX0" fmla="*/ 541 w 606530"/>
              <a:gd name="connsiteY0" fmla="*/ 827243 h 1507652"/>
              <a:gd name="connsiteX1" fmla="*/ 443748 w 606530"/>
              <a:gd name="connsiteY1" fmla="*/ 1327 h 1507652"/>
              <a:gd name="connsiteX2" fmla="*/ 507780 w 606530"/>
              <a:gd name="connsiteY2" fmla="*/ 687652 h 1507652"/>
              <a:gd name="connsiteX3" fmla="*/ 543991 w 606530"/>
              <a:gd name="connsiteY3" fmla="*/ 1506788 h 1507652"/>
              <a:gd name="connsiteX4" fmla="*/ 541 w 606530"/>
              <a:gd name="connsiteY4" fmla="*/ 827243 h 1507652"/>
              <a:gd name="connsiteX0" fmla="*/ 1580 w 607569"/>
              <a:gd name="connsiteY0" fmla="*/ 870134 h 1550556"/>
              <a:gd name="connsiteX1" fmla="*/ 383610 w 607569"/>
              <a:gd name="connsiteY1" fmla="*/ 1166 h 1550556"/>
              <a:gd name="connsiteX2" fmla="*/ 508819 w 607569"/>
              <a:gd name="connsiteY2" fmla="*/ 730543 h 1550556"/>
              <a:gd name="connsiteX3" fmla="*/ 545030 w 607569"/>
              <a:gd name="connsiteY3" fmla="*/ 1549679 h 1550556"/>
              <a:gd name="connsiteX4" fmla="*/ 1580 w 607569"/>
              <a:gd name="connsiteY4" fmla="*/ 870134 h 1550556"/>
              <a:gd name="connsiteX0" fmla="*/ 1547 w 586900"/>
              <a:gd name="connsiteY0" fmla="*/ 873640 h 1555792"/>
              <a:gd name="connsiteX1" fmla="*/ 383577 w 586900"/>
              <a:gd name="connsiteY1" fmla="*/ 4672 h 1555792"/>
              <a:gd name="connsiteX2" fmla="*/ 462581 w 586900"/>
              <a:gd name="connsiteY2" fmla="*/ 624881 h 1555792"/>
              <a:gd name="connsiteX3" fmla="*/ 544997 w 586900"/>
              <a:gd name="connsiteY3" fmla="*/ 1553185 h 1555792"/>
              <a:gd name="connsiteX4" fmla="*/ 1547 w 586900"/>
              <a:gd name="connsiteY4" fmla="*/ 873640 h 1555792"/>
              <a:gd name="connsiteX0" fmla="*/ 1547 w 586900"/>
              <a:gd name="connsiteY0" fmla="*/ 874031 h 1556183"/>
              <a:gd name="connsiteX1" fmla="*/ 383577 w 586900"/>
              <a:gd name="connsiteY1" fmla="*/ 5063 h 1556183"/>
              <a:gd name="connsiteX2" fmla="*/ 462581 w 586900"/>
              <a:gd name="connsiteY2" fmla="*/ 625272 h 1556183"/>
              <a:gd name="connsiteX3" fmla="*/ 544997 w 586900"/>
              <a:gd name="connsiteY3" fmla="*/ 1553576 h 1556183"/>
              <a:gd name="connsiteX4" fmla="*/ 1547 w 586900"/>
              <a:gd name="connsiteY4" fmla="*/ 874031 h 1556183"/>
              <a:gd name="connsiteX0" fmla="*/ 1567 w 599033"/>
              <a:gd name="connsiteY0" fmla="*/ 872837 h 1554528"/>
              <a:gd name="connsiteX1" fmla="*/ 383597 w 599033"/>
              <a:gd name="connsiteY1" fmla="*/ 3869 h 1554528"/>
              <a:gd name="connsiteX2" fmla="*/ 491460 w 599033"/>
              <a:gd name="connsiteY2" fmla="*/ 648766 h 1554528"/>
              <a:gd name="connsiteX3" fmla="*/ 545017 w 599033"/>
              <a:gd name="connsiteY3" fmla="*/ 1552382 h 1554528"/>
              <a:gd name="connsiteX4" fmla="*/ 1567 w 599033"/>
              <a:gd name="connsiteY4" fmla="*/ 872837 h 1554528"/>
              <a:gd name="connsiteX0" fmla="*/ 1567 w 581909"/>
              <a:gd name="connsiteY0" fmla="*/ 872837 h 1554528"/>
              <a:gd name="connsiteX1" fmla="*/ 383597 w 581909"/>
              <a:gd name="connsiteY1" fmla="*/ 3869 h 1554528"/>
              <a:gd name="connsiteX2" fmla="*/ 491460 w 581909"/>
              <a:gd name="connsiteY2" fmla="*/ 648766 h 1554528"/>
              <a:gd name="connsiteX3" fmla="*/ 545017 w 581909"/>
              <a:gd name="connsiteY3" fmla="*/ 1552382 h 1554528"/>
              <a:gd name="connsiteX4" fmla="*/ 1567 w 581909"/>
              <a:gd name="connsiteY4" fmla="*/ 872837 h 1554528"/>
              <a:gd name="connsiteX0" fmla="*/ 1549 w 574735"/>
              <a:gd name="connsiteY0" fmla="*/ 877969 h 1561362"/>
              <a:gd name="connsiteX1" fmla="*/ 383579 w 574735"/>
              <a:gd name="connsiteY1" fmla="*/ 9001 h 1561362"/>
              <a:gd name="connsiteX2" fmla="*/ 466404 w 574735"/>
              <a:gd name="connsiteY2" fmla="*/ 570577 h 1561362"/>
              <a:gd name="connsiteX3" fmla="*/ 544999 w 574735"/>
              <a:gd name="connsiteY3" fmla="*/ 1557514 h 1561362"/>
              <a:gd name="connsiteX4" fmla="*/ 1549 w 574735"/>
              <a:gd name="connsiteY4" fmla="*/ 877969 h 1561362"/>
              <a:gd name="connsiteX0" fmla="*/ 2451 w 614437"/>
              <a:gd name="connsiteY0" fmla="*/ 877969 h 1543043"/>
              <a:gd name="connsiteX1" fmla="*/ 384481 w 614437"/>
              <a:gd name="connsiteY1" fmla="*/ 9001 h 1543043"/>
              <a:gd name="connsiteX2" fmla="*/ 467306 w 614437"/>
              <a:gd name="connsiteY2" fmla="*/ 570577 h 1543043"/>
              <a:gd name="connsiteX3" fmla="*/ 591282 w 614437"/>
              <a:gd name="connsiteY3" fmla="*/ 1539077 h 1543043"/>
              <a:gd name="connsiteX4" fmla="*/ 2451 w 614437"/>
              <a:gd name="connsiteY4" fmla="*/ 877969 h 1543043"/>
              <a:gd name="connsiteX0" fmla="*/ 2451 w 647187"/>
              <a:gd name="connsiteY0" fmla="*/ 877969 h 1562846"/>
              <a:gd name="connsiteX1" fmla="*/ 384481 w 647187"/>
              <a:gd name="connsiteY1" fmla="*/ 9001 h 1562846"/>
              <a:gd name="connsiteX2" fmla="*/ 467306 w 647187"/>
              <a:gd name="connsiteY2" fmla="*/ 570577 h 1562846"/>
              <a:gd name="connsiteX3" fmla="*/ 591282 w 647187"/>
              <a:gd name="connsiteY3" fmla="*/ 1539077 h 1562846"/>
              <a:gd name="connsiteX4" fmla="*/ 2451 w 647187"/>
              <a:gd name="connsiteY4" fmla="*/ 877969 h 1562846"/>
              <a:gd name="connsiteX0" fmla="*/ 2451 w 647187"/>
              <a:gd name="connsiteY0" fmla="*/ 883028 h 1567903"/>
              <a:gd name="connsiteX1" fmla="*/ 384481 w 647187"/>
              <a:gd name="connsiteY1" fmla="*/ 14060 h 1567903"/>
              <a:gd name="connsiteX2" fmla="*/ 467306 w 647187"/>
              <a:gd name="connsiteY2" fmla="*/ 575636 h 1567903"/>
              <a:gd name="connsiteX3" fmla="*/ 591282 w 647187"/>
              <a:gd name="connsiteY3" fmla="*/ 1544136 h 1567903"/>
              <a:gd name="connsiteX4" fmla="*/ 2451 w 647187"/>
              <a:gd name="connsiteY4" fmla="*/ 883028 h 1567903"/>
              <a:gd name="connsiteX0" fmla="*/ 2451 w 653463"/>
              <a:gd name="connsiteY0" fmla="*/ 883028 h 1567904"/>
              <a:gd name="connsiteX1" fmla="*/ 384481 w 653463"/>
              <a:gd name="connsiteY1" fmla="*/ 14060 h 1567904"/>
              <a:gd name="connsiteX2" fmla="*/ 467306 w 653463"/>
              <a:gd name="connsiteY2" fmla="*/ 575636 h 1567904"/>
              <a:gd name="connsiteX3" fmla="*/ 591282 w 653463"/>
              <a:gd name="connsiteY3" fmla="*/ 1544136 h 1567904"/>
              <a:gd name="connsiteX4" fmla="*/ 2451 w 653463"/>
              <a:gd name="connsiteY4" fmla="*/ 883028 h 156790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653463" h="1567904">
                <a:moveTo>
                  <a:pt x="2451" y="883028"/>
                </a:moveTo>
                <a:cubicBezTo>
                  <a:pt x="-32016" y="628015"/>
                  <a:pt x="307005" y="65292"/>
                  <a:pt x="384481" y="14060"/>
                </a:cubicBezTo>
                <a:cubicBezTo>
                  <a:pt x="461957" y="-37172"/>
                  <a:pt x="631861" y="30481"/>
                  <a:pt x="467306" y="575636"/>
                </a:cubicBezTo>
                <a:cubicBezTo>
                  <a:pt x="571593" y="1160605"/>
                  <a:pt x="747955" y="1399710"/>
                  <a:pt x="591282" y="1544136"/>
                </a:cubicBezTo>
                <a:cubicBezTo>
                  <a:pt x="434609" y="1688562"/>
                  <a:pt x="36918" y="1138041"/>
                  <a:pt x="2451" y="883028"/>
                </a:cubicBezTo>
                <a:close/>
              </a:path>
            </a:pathLst>
          </a:custGeom>
          <a:solidFill>
            <a:schemeClr val="bg1">
              <a:lumMod val="50000"/>
            </a:schemeClr>
          </a:solid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Arc 45">
            <a:extLst>
              <a:ext uri="{FF2B5EF4-FFF2-40B4-BE49-F238E27FC236}">
                <a16:creationId xmlns:a16="http://schemas.microsoft.com/office/drawing/2014/main" id="{49219FD6-0D88-6766-0FB7-02B3660B01B6}"/>
              </a:ext>
            </a:extLst>
          </p:cNvPr>
          <p:cNvSpPr/>
          <p:nvPr/>
        </p:nvSpPr>
        <p:spPr>
          <a:xfrm rot="12172620">
            <a:off x="7072339" y="1978489"/>
            <a:ext cx="771748" cy="1129785"/>
          </a:xfrm>
          <a:custGeom>
            <a:avLst/>
            <a:gdLst>
              <a:gd name="connsiteX0" fmla="*/ 1506511 w 3013023"/>
              <a:gd name="connsiteY0" fmla="*/ 0 h 2518348"/>
              <a:gd name="connsiteX1" fmla="*/ 3013023 w 3013023"/>
              <a:gd name="connsiteY1" fmla="*/ 1259174 h 2518348"/>
              <a:gd name="connsiteX2" fmla="*/ 1506512 w 3013023"/>
              <a:gd name="connsiteY2" fmla="*/ 1259174 h 2518348"/>
              <a:gd name="connsiteX3" fmla="*/ 1506511 w 3013023"/>
              <a:gd name="connsiteY3" fmla="*/ 0 h 2518348"/>
              <a:gd name="connsiteX0" fmla="*/ 1506511 w 3013023"/>
              <a:gd name="connsiteY0" fmla="*/ 0 h 2518348"/>
              <a:gd name="connsiteX1" fmla="*/ 3013023 w 3013023"/>
              <a:gd name="connsiteY1" fmla="*/ 1259174 h 2518348"/>
              <a:gd name="connsiteX0" fmla="*/ 0 w 1565865"/>
              <a:gd name="connsiteY0" fmla="*/ 0 h 1380560"/>
              <a:gd name="connsiteX1" fmla="*/ 1506512 w 1565865"/>
              <a:gd name="connsiteY1" fmla="*/ 1259174 h 1380560"/>
              <a:gd name="connsiteX2" fmla="*/ 1 w 1565865"/>
              <a:gd name="connsiteY2" fmla="*/ 1259174 h 1380560"/>
              <a:gd name="connsiteX3" fmla="*/ 0 w 1565865"/>
              <a:gd name="connsiteY3" fmla="*/ 0 h 1380560"/>
              <a:gd name="connsiteX0" fmla="*/ 0 w 1565865"/>
              <a:gd name="connsiteY0" fmla="*/ 0 h 1380560"/>
              <a:gd name="connsiteX1" fmla="*/ 1565865 w 1565865"/>
              <a:gd name="connsiteY1" fmla="*/ 1380560 h 1380560"/>
              <a:gd name="connsiteX0" fmla="*/ 69610 w 1635475"/>
              <a:gd name="connsiteY0" fmla="*/ 222812 h 1603372"/>
              <a:gd name="connsiteX1" fmla="*/ 1576122 w 1635475"/>
              <a:gd name="connsiteY1" fmla="*/ 1481986 h 1603372"/>
              <a:gd name="connsiteX2" fmla="*/ 69611 w 1635475"/>
              <a:gd name="connsiteY2" fmla="*/ 1481986 h 1603372"/>
              <a:gd name="connsiteX3" fmla="*/ 69610 w 1635475"/>
              <a:gd name="connsiteY3" fmla="*/ 222812 h 1603372"/>
              <a:gd name="connsiteX0" fmla="*/ 0 w 1635475"/>
              <a:gd name="connsiteY0" fmla="*/ 0 h 1603372"/>
              <a:gd name="connsiteX1" fmla="*/ 1635475 w 1635475"/>
              <a:gd name="connsiteY1" fmla="*/ 1603372 h 1603372"/>
              <a:gd name="connsiteX0" fmla="*/ 58711 w 1624576"/>
              <a:gd name="connsiteY0" fmla="*/ 235545 h 1616105"/>
              <a:gd name="connsiteX1" fmla="*/ 1565223 w 1624576"/>
              <a:gd name="connsiteY1" fmla="*/ 1494719 h 1616105"/>
              <a:gd name="connsiteX2" fmla="*/ 58712 w 1624576"/>
              <a:gd name="connsiteY2" fmla="*/ 1494719 h 1616105"/>
              <a:gd name="connsiteX3" fmla="*/ 58711 w 1624576"/>
              <a:gd name="connsiteY3" fmla="*/ 235545 h 1616105"/>
              <a:gd name="connsiteX0" fmla="*/ 0 w 1624576"/>
              <a:gd name="connsiteY0" fmla="*/ 0 h 1616105"/>
              <a:gd name="connsiteX1" fmla="*/ 1624576 w 1624576"/>
              <a:gd name="connsiteY1" fmla="*/ 1616105 h 1616105"/>
              <a:gd name="connsiteX0" fmla="*/ 58711 w 1586057"/>
              <a:gd name="connsiteY0" fmla="*/ 235545 h 1640492"/>
              <a:gd name="connsiteX1" fmla="*/ 1565223 w 1586057"/>
              <a:gd name="connsiteY1" fmla="*/ 1494719 h 1640492"/>
              <a:gd name="connsiteX2" fmla="*/ 58712 w 1586057"/>
              <a:gd name="connsiteY2" fmla="*/ 1494719 h 1640492"/>
              <a:gd name="connsiteX3" fmla="*/ 58711 w 1586057"/>
              <a:gd name="connsiteY3" fmla="*/ 235545 h 1640492"/>
              <a:gd name="connsiteX0" fmla="*/ 0 w 1586057"/>
              <a:gd name="connsiteY0" fmla="*/ 0 h 1640492"/>
              <a:gd name="connsiteX1" fmla="*/ 1586057 w 1586057"/>
              <a:gd name="connsiteY1" fmla="*/ 1640492 h 1640492"/>
              <a:gd name="connsiteX0" fmla="*/ 0 w 1612049"/>
              <a:gd name="connsiteY0" fmla="*/ 246879 h 1640492"/>
              <a:gd name="connsiteX1" fmla="*/ 1591215 w 1612049"/>
              <a:gd name="connsiteY1" fmla="*/ 1494719 h 1640492"/>
              <a:gd name="connsiteX2" fmla="*/ 84704 w 1612049"/>
              <a:gd name="connsiteY2" fmla="*/ 1494719 h 1640492"/>
              <a:gd name="connsiteX3" fmla="*/ 0 w 1612049"/>
              <a:gd name="connsiteY3" fmla="*/ 246879 h 1640492"/>
              <a:gd name="connsiteX0" fmla="*/ 25992 w 1612049"/>
              <a:gd name="connsiteY0" fmla="*/ 0 h 1640492"/>
              <a:gd name="connsiteX1" fmla="*/ 1612049 w 1612049"/>
              <a:gd name="connsiteY1" fmla="*/ 1640492 h 1640492"/>
            </a:gdLst>
            <a:ahLst/>
            <a:cxnLst>
              <a:cxn ang="0">
                <a:pos x="connsiteX0" y="connsiteY0"/>
              </a:cxn>
              <a:cxn ang="0">
                <a:pos x="connsiteX1" y="connsiteY1"/>
              </a:cxn>
            </a:cxnLst>
            <a:rect l="l" t="t" r="r" b="b"/>
            <a:pathLst>
              <a:path w="1612049" h="1640492" stroke="0" extrusionOk="0">
                <a:moveTo>
                  <a:pt x="0" y="246879"/>
                </a:moveTo>
                <a:cubicBezTo>
                  <a:pt x="832024" y="246879"/>
                  <a:pt x="1591215" y="799296"/>
                  <a:pt x="1591215" y="1494719"/>
                </a:cubicBezTo>
                <a:lnTo>
                  <a:pt x="84704" y="1494719"/>
                </a:lnTo>
                <a:cubicBezTo>
                  <a:pt x="84704" y="1074994"/>
                  <a:pt x="0" y="666604"/>
                  <a:pt x="0" y="246879"/>
                </a:cubicBezTo>
                <a:close/>
              </a:path>
              <a:path w="1612049" h="1640492" fill="none">
                <a:moveTo>
                  <a:pt x="25992" y="0"/>
                </a:moveTo>
                <a:cubicBezTo>
                  <a:pt x="858016" y="0"/>
                  <a:pt x="1612049" y="945069"/>
                  <a:pt x="1612049" y="1640492"/>
                </a:cubicBezTo>
              </a:path>
            </a:pathLst>
          </a:custGeom>
          <a:ln w="76200">
            <a:solidFill>
              <a:schemeClr val="bg1">
                <a:lumMod val="8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8" name="Arc 45">
            <a:extLst>
              <a:ext uri="{FF2B5EF4-FFF2-40B4-BE49-F238E27FC236}">
                <a16:creationId xmlns:a16="http://schemas.microsoft.com/office/drawing/2014/main" id="{3A53DACD-B539-5764-C3D0-0FC3C167518C}"/>
              </a:ext>
            </a:extLst>
          </p:cNvPr>
          <p:cNvSpPr/>
          <p:nvPr/>
        </p:nvSpPr>
        <p:spPr>
          <a:xfrm rot="8965298">
            <a:off x="7480791" y="2557924"/>
            <a:ext cx="2148813" cy="555102"/>
          </a:xfrm>
          <a:custGeom>
            <a:avLst/>
            <a:gdLst>
              <a:gd name="connsiteX0" fmla="*/ 1506511 w 3013023"/>
              <a:gd name="connsiteY0" fmla="*/ 0 h 2518348"/>
              <a:gd name="connsiteX1" fmla="*/ 3013023 w 3013023"/>
              <a:gd name="connsiteY1" fmla="*/ 1259174 h 2518348"/>
              <a:gd name="connsiteX2" fmla="*/ 1506512 w 3013023"/>
              <a:gd name="connsiteY2" fmla="*/ 1259174 h 2518348"/>
              <a:gd name="connsiteX3" fmla="*/ 1506511 w 3013023"/>
              <a:gd name="connsiteY3" fmla="*/ 0 h 2518348"/>
              <a:gd name="connsiteX0" fmla="*/ 1506511 w 3013023"/>
              <a:gd name="connsiteY0" fmla="*/ 0 h 2518348"/>
              <a:gd name="connsiteX1" fmla="*/ 3013023 w 3013023"/>
              <a:gd name="connsiteY1" fmla="*/ 1259174 h 2518348"/>
              <a:gd name="connsiteX0" fmla="*/ 0 w 1565865"/>
              <a:gd name="connsiteY0" fmla="*/ 0 h 1380560"/>
              <a:gd name="connsiteX1" fmla="*/ 1506512 w 1565865"/>
              <a:gd name="connsiteY1" fmla="*/ 1259174 h 1380560"/>
              <a:gd name="connsiteX2" fmla="*/ 1 w 1565865"/>
              <a:gd name="connsiteY2" fmla="*/ 1259174 h 1380560"/>
              <a:gd name="connsiteX3" fmla="*/ 0 w 1565865"/>
              <a:gd name="connsiteY3" fmla="*/ 0 h 1380560"/>
              <a:gd name="connsiteX0" fmla="*/ 0 w 1565865"/>
              <a:gd name="connsiteY0" fmla="*/ 0 h 1380560"/>
              <a:gd name="connsiteX1" fmla="*/ 1565865 w 1565865"/>
              <a:gd name="connsiteY1" fmla="*/ 1380560 h 1380560"/>
              <a:gd name="connsiteX0" fmla="*/ 69610 w 1635475"/>
              <a:gd name="connsiteY0" fmla="*/ 222812 h 1603372"/>
              <a:gd name="connsiteX1" fmla="*/ 1576122 w 1635475"/>
              <a:gd name="connsiteY1" fmla="*/ 1481986 h 1603372"/>
              <a:gd name="connsiteX2" fmla="*/ 69611 w 1635475"/>
              <a:gd name="connsiteY2" fmla="*/ 1481986 h 1603372"/>
              <a:gd name="connsiteX3" fmla="*/ 69610 w 1635475"/>
              <a:gd name="connsiteY3" fmla="*/ 222812 h 1603372"/>
              <a:gd name="connsiteX0" fmla="*/ 0 w 1635475"/>
              <a:gd name="connsiteY0" fmla="*/ 0 h 1603372"/>
              <a:gd name="connsiteX1" fmla="*/ 1635475 w 1635475"/>
              <a:gd name="connsiteY1" fmla="*/ 1603372 h 1603372"/>
              <a:gd name="connsiteX0" fmla="*/ 58711 w 1624576"/>
              <a:gd name="connsiteY0" fmla="*/ 235545 h 1616105"/>
              <a:gd name="connsiteX1" fmla="*/ 1565223 w 1624576"/>
              <a:gd name="connsiteY1" fmla="*/ 1494719 h 1616105"/>
              <a:gd name="connsiteX2" fmla="*/ 58712 w 1624576"/>
              <a:gd name="connsiteY2" fmla="*/ 1494719 h 1616105"/>
              <a:gd name="connsiteX3" fmla="*/ 58711 w 1624576"/>
              <a:gd name="connsiteY3" fmla="*/ 235545 h 1616105"/>
              <a:gd name="connsiteX0" fmla="*/ 0 w 1624576"/>
              <a:gd name="connsiteY0" fmla="*/ 0 h 1616105"/>
              <a:gd name="connsiteX1" fmla="*/ 1624576 w 1624576"/>
              <a:gd name="connsiteY1" fmla="*/ 1616105 h 1616105"/>
              <a:gd name="connsiteX0" fmla="*/ 58711 w 1586057"/>
              <a:gd name="connsiteY0" fmla="*/ 235545 h 1640492"/>
              <a:gd name="connsiteX1" fmla="*/ 1565223 w 1586057"/>
              <a:gd name="connsiteY1" fmla="*/ 1494719 h 1640492"/>
              <a:gd name="connsiteX2" fmla="*/ 58712 w 1586057"/>
              <a:gd name="connsiteY2" fmla="*/ 1494719 h 1640492"/>
              <a:gd name="connsiteX3" fmla="*/ 58711 w 1586057"/>
              <a:gd name="connsiteY3" fmla="*/ 235545 h 1640492"/>
              <a:gd name="connsiteX0" fmla="*/ 0 w 1586057"/>
              <a:gd name="connsiteY0" fmla="*/ 0 h 1640492"/>
              <a:gd name="connsiteX1" fmla="*/ 1586057 w 1586057"/>
              <a:gd name="connsiteY1" fmla="*/ 1640492 h 1640492"/>
              <a:gd name="connsiteX0" fmla="*/ 0 w 1612049"/>
              <a:gd name="connsiteY0" fmla="*/ 246879 h 1640492"/>
              <a:gd name="connsiteX1" fmla="*/ 1591215 w 1612049"/>
              <a:gd name="connsiteY1" fmla="*/ 1494719 h 1640492"/>
              <a:gd name="connsiteX2" fmla="*/ 84704 w 1612049"/>
              <a:gd name="connsiteY2" fmla="*/ 1494719 h 1640492"/>
              <a:gd name="connsiteX3" fmla="*/ 0 w 1612049"/>
              <a:gd name="connsiteY3" fmla="*/ 246879 h 1640492"/>
              <a:gd name="connsiteX0" fmla="*/ 25992 w 1612049"/>
              <a:gd name="connsiteY0" fmla="*/ 0 h 1640492"/>
              <a:gd name="connsiteX1" fmla="*/ 1612049 w 1612049"/>
              <a:gd name="connsiteY1" fmla="*/ 1640492 h 1640492"/>
              <a:gd name="connsiteX0" fmla="*/ 0 w 1612049"/>
              <a:gd name="connsiteY0" fmla="*/ 1 h 1393614"/>
              <a:gd name="connsiteX1" fmla="*/ 1591215 w 1612049"/>
              <a:gd name="connsiteY1" fmla="*/ 1247841 h 1393614"/>
              <a:gd name="connsiteX2" fmla="*/ 84704 w 1612049"/>
              <a:gd name="connsiteY2" fmla="*/ 1247841 h 1393614"/>
              <a:gd name="connsiteX3" fmla="*/ 0 w 1612049"/>
              <a:gd name="connsiteY3" fmla="*/ 1 h 1393614"/>
              <a:gd name="connsiteX0" fmla="*/ 3404 w 1612049"/>
              <a:gd name="connsiteY0" fmla="*/ 147328 h 1393614"/>
              <a:gd name="connsiteX1" fmla="*/ 1612049 w 1612049"/>
              <a:gd name="connsiteY1" fmla="*/ 1393614 h 1393614"/>
            </a:gdLst>
            <a:ahLst/>
            <a:cxnLst>
              <a:cxn ang="0">
                <a:pos x="connsiteX0" y="connsiteY0"/>
              </a:cxn>
              <a:cxn ang="0">
                <a:pos x="connsiteX1" y="connsiteY1"/>
              </a:cxn>
            </a:cxnLst>
            <a:rect l="l" t="t" r="r" b="b"/>
            <a:pathLst>
              <a:path w="1612049" h="1393614" stroke="0" extrusionOk="0">
                <a:moveTo>
                  <a:pt x="0" y="1"/>
                </a:moveTo>
                <a:cubicBezTo>
                  <a:pt x="832024" y="1"/>
                  <a:pt x="1591215" y="552418"/>
                  <a:pt x="1591215" y="1247841"/>
                </a:cubicBezTo>
                <a:lnTo>
                  <a:pt x="84704" y="1247841"/>
                </a:lnTo>
                <a:cubicBezTo>
                  <a:pt x="84704" y="828116"/>
                  <a:pt x="0" y="419726"/>
                  <a:pt x="0" y="1"/>
                </a:cubicBezTo>
                <a:close/>
              </a:path>
              <a:path w="1612049" h="1393614" fill="none">
                <a:moveTo>
                  <a:pt x="3404" y="147328"/>
                </a:moveTo>
                <a:cubicBezTo>
                  <a:pt x="835428" y="147328"/>
                  <a:pt x="1612049" y="698191"/>
                  <a:pt x="1612049" y="1393614"/>
                </a:cubicBezTo>
              </a:path>
            </a:pathLst>
          </a:custGeom>
          <a:ln w="76200">
            <a:solidFill>
              <a:schemeClr val="bg1">
                <a:lumMod val="8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9" name="Arc 45">
            <a:extLst>
              <a:ext uri="{FF2B5EF4-FFF2-40B4-BE49-F238E27FC236}">
                <a16:creationId xmlns:a16="http://schemas.microsoft.com/office/drawing/2014/main" id="{5FE1155B-5DD0-2B73-7D43-E54E0FE94383}"/>
              </a:ext>
            </a:extLst>
          </p:cNvPr>
          <p:cNvSpPr/>
          <p:nvPr/>
        </p:nvSpPr>
        <p:spPr>
          <a:xfrm rot="17043712">
            <a:off x="7501813" y="2637828"/>
            <a:ext cx="973141" cy="239146"/>
          </a:xfrm>
          <a:custGeom>
            <a:avLst/>
            <a:gdLst>
              <a:gd name="connsiteX0" fmla="*/ 1506511 w 3013023"/>
              <a:gd name="connsiteY0" fmla="*/ 0 h 2518348"/>
              <a:gd name="connsiteX1" fmla="*/ 3013023 w 3013023"/>
              <a:gd name="connsiteY1" fmla="*/ 1259174 h 2518348"/>
              <a:gd name="connsiteX2" fmla="*/ 1506512 w 3013023"/>
              <a:gd name="connsiteY2" fmla="*/ 1259174 h 2518348"/>
              <a:gd name="connsiteX3" fmla="*/ 1506511 w 3013023"/>
              <a:gd name="connsiteY3" fmla="*/ 0 h 2518348"/>
              <a:gd name="connsiteX0" fmla="*/ 1506511 w 3013023"/>
              <a:gd name="connsiteY0" fmla="*/ 0 h 2518348"/>
              <a:gd name="connsiteX1" fmla="*/ 3013023 w 3013023"/>
              <a:gd name="connsiteY1" fmla="*/ 1259174 h 2518348"/>
              <a:gd name="connsiteX0" fmla="*/ 0 w 1565865"/>
              <a:gd name="connsiteY0" fmla="*/ 0 h 1380560"/>
              <a:gd name="connsiteX1" fmla="*/ 1506512 w 1565865"/>
              <a:gd name="connsiteY1" fmla="*/ 1259174 h 1380560"/>
              <a:gd name="connsiteX2" fmla="*/ 1 w 1565865"/>
              <a:gd name="connsiteY2" fmla="*/ 1259174 h 1380560"/>
              <a:gd name="connsiteX3" fmla="*/ 0 w 1565865"/>
              <a:gd name="connsiteY3" fmla="*/ 0 h 1380560"/>
              <a:gd name="connsiteX0" fmla="*/ 0 w 1565865"/>
              <a:gd name="connsiteY0" fmla="*/ 0 h 1380560"/>
              <a:gd name="connsiteX1" fmla="*/ 1565865 w 1565865"/>
              <a:gd name="connsiteY1" fmla="*/ 1380560 h 1380560"/>
              <a:gd name="connsiteX0" fmla="*/ 69610 w 1635475"/>
              <a:gd name="connsiteY0" fmla="*/ 222812 h 1603372"/>
              <a:gd name="connsiteX1" fmla="*/ 1576122 w 1635475"/>
              <a:gd name="connsiteY1" fmla="*/ 1481986 h 1603372"/>
              <a:gd name="connsiteX2" fmla="*/ 69611 w 1635475"/>
              <a:gd name="connsiteY2" fmla="*/ 1481986 h 1603372"/>
              <a:gd name="connsiteX3" fmla="*/ 69610 w 1635475"/>
              <a:gd name="connsiteY3" fmla="*/ 222812 h 1603372"/>
              <a:gd name="connsiteX0" fmla="*/ 0 w 1635475"/>
              <a:gd name="connsiteY0" fmla="*/ 0 h 1603372"/>
              <a:gd name="connsiteX1" fmla="*/ 1635475 w 1635475"/>
              <a:gd name="connsiteY1" fmla="*/ 1603372 h 1603372"/>
              <a:gd name="connsiteX0" fmla="*/ 58711 w 1624576"/>
              <a:gd name="connsiteY0" fmla="*/ 235545 h 1616105"/>
              <a:gd name="connsiteX1" fmla="*/ 1565223 w 1624576"/>
              <a:gd name="connsiteY1" fmla="*/ 1494719 h 1616105"/>
              <a:gd name="connsiteX2" fmla="*/ 58712 w 1624576"/>
              <a:gd name="connsiteY2" fmla="*/ 1494719 h 1616105"/>
              <a:gd name="connsiteX3" fmla="*/ 58711 w 1624576"/>
              <a:gd name="connsiteY3" fmla="*/ 235545 h 1616105"/>
              <a:gd name="connsiteX0" fmla="*/ 0 w 1624576"/>
              <a:gd name="connsiteY0" fmla="*/ 0 h 1616105"/>
              <a:gd name="connsiteX1" fmla="*/ 1624576 w 1624576"/>
              <a:gd name="connsiteY1" fmla="*/ 1616105 h 1616105"/>
              <a:gd name="connsiteX0" fmla="*/ 58711 w 1586057"/>
              <a:gd name="connsiteY0" fmla="*/ 235545 h 1640492"/>
              <a:gd name="connsiteX1" fmla="*/ 1565223 w 1586057"/>
              <a:gd name="connsiteY1" fmla="*/ 1494719 h 1640492"/>
              <a:gd name="connsiteX2" fmla="*/ 58712 w 1586057"/>
              <a:gd name="connsiteY2" fmla="*/ 1494719 h 1640492"/>
              <a:gd name="connsiteX3" fmla="*/ 58711 w 1586057"/>
              <a:gd name="connsiteY3" fmla="*/ 235545 h 1640492"/>
              <a:gd name="connsiteX0" fmla="*/ 0 w 1586057"/>
              <a:gd name="connsiteY0" fmla="*/ 0 h 1640492"/>
              <a:gd name="connsiteX1" fmla="*/ 1586057 w 1586057"/>
              <a:gd name="connsiteY1" fmla="*/ 1640492 h 1640492"/>
              <a:gd name="connsiteX0" fmla="*/ 0 w 1612049"/>
              <a:gd name="connsiteY0" fmla="*/ 246879 h 1640492"/>
              <a:gd name="connsiteX1" fmla="*/ 1591215 w 1612049"/>
              <a:gd name="connsiteY1" fmla="*/ 1494719 h 1640492"/>
              <a:gd name="connsiteX2" fmla="*/ 84704 w 1612049"/>
              <a:gd name="connsiteY2" fmla="*/ 1494719 h 1640492"/>
              <a:gd name="connsiteX3" fmla="*/ 0 w 1612049"/>
              <a:gd name="connsiteY3" fmla="*/ 246879 h 1640492"/>
              <a:gd name="connsiteX0" fmla="*/ 25992 w 1612049"/>
              <a:gd name="connsiteY0" fmla="*/ 0 h 1640492"/>
              <a:gd name="connsiteX1" fmla="*/ 1612049 w 1612049"/>
              <a:gd name="connsiteY1" fmla="*/ 1640492 h 1640492"/>
            </a:gdLst>
            <a:ahLst/>
            <a:cxnLst>
              <a:cxn ang="0">
                <a:pos x="connsiteX0" y="connsiteY0"/>
              </a:cxn>
              <a:cxn ang="0">
                <a:pos x="connsiteX1" y="connsiteY1"/>
              </a:cxn>
            </a:cxnLst>
            <a:rect l="l" t="t" r="r" b="b"/>
            <a:pathLst>
              <a:path w="1612049" h="1640492" stroke="0" extrusionOk="0">
                <a:moveTo>
                  <a:pt x="0" y="246879"/>
                </a:moveTo>
                <a:cubicBezTo>
                  <a:pt x="832024" y="246879"/>
                  <a:pt x="1591215" y="799296"/>
                  <a:pt x="1591215" y="1494719"/>
                </a:cubicBezTo>
                <a:lnTo>
                  <a:pt x="84704" y="1494719"/>
                </a:lnTo>
                <a:cubicBezTo>
                  <a:pt x="84704" y="1074994"/>
                  <a:pt x="0" y="666604"/>
                  <a:pt x="0" y="246879"/>
                </a:cubicBezTo>
                <a:close/>
              </a:path>
              <a:path w="1612049" h="1640492" fill="none">
                <a:moveTo>
                  <a:pt x="25992" y="0"/>
                </a:moveTo>
                <a:cubicBezTo>
                  <a:pt x="858016" y="0"/>
                  <a:pt x="1612049" y="945069"/>
                  <a:pt x="1612049" y="1640492"/>
                </a:cubicBezTo>
              </a:path>
            </a:pathLst>
          </a:custGeom>
          <a:ln w="38100">
            <a:solidFill>
              <a:schemeClr val="bg1">
                <a:lumMod val="8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0" name="Arc 45">
            <a:extLst>
              <a:ext uri="{FF2B5EF4-FFF2-40B4-BE49-F238E27FC236}">
                <a16:creationId xmlns:a16="http://schemas.microsoft.com/office/drawing/2014/main" id="{069F5A59-4CD4-9C4A-E348-3801A9E98B85}"/>
              </a:ext>
            </a:extLst>
          </p:cNvPr>
          <p:cNvSpPr/>
          <p:nvPr/>
        </p:nvSpPr>
        <p:spPr>
          <a:xfrm rot="19969065">
            <a:off x="8181386" y="2177442"/>
            <a:ext cx="629432" cy="239146"/>
          </a:xfrm>
          <a:custGeom>
            <a:avLst/>
            <a:gdLst>
              <a:gd name="connsiteX0" fmla="*/ 1506511 w 3013023"/>
              <a:gd name="connsiteY0" fmla="*/ 0 h 2518348"/>
              <a:gd name="connsiteX1" fmla="*/ 3013023 w 3013023"/>
              <a:gd name="connsiteY1" fmla="*/ 1259174 h 2518348"/>
              <a:gd name="connsiteX2" fmla="*/ 1506512 w 3013023"/>
              <a:gd name="connsiteY2" fmla="*/ 1259174 h 2518348"/>
              <a:gd name="connsiteX3" fmla="*/ 1506511 w 3013023"/>
              <a:gd name="connsiteY3" fmla="*/ 0 h 2518348"/>
              <a:gd name="connsiteX0" fmla="*/ 1506511 w 3013023"/>
              <a:gd name="connsiteY0" fmla="*/ 0 h 2518348"/>
              <a:gd name="connsiteX1" fmla="*/ 3013023 w 3013023"/>
              <a:gd name="connsiteY1" fmla="*/ 1259174 h 2518348"/>
              <a:gd name="connsiteX0" fmla="*/ 0 w 1565865"/>
              <a:gd name="connsiteY0" fmla="*/ 0 h 1380560"/>
              <a:gd name="connsiteX1" fmla="*/ 1506512 w 1565865"/>
              <a:gd name="connsiteY1" fmla="*/ 1259174 h 1380560"/>
              <a:gd name="connsiteX2" fmla="*/ 1 w 1565865"/>
              <a:gd name="connsiteY2" fmla="*/ 1259174 h 1380560"/>
              <a:gd name="connsiteX3" fmla="*/ 0 w 1565865"/>
              <a:gd name="connsiteY3" fmla="*/ 0 h 1380560"/>
              <a:gd name="connsiteX0" fmla="*/ 0 w 1565865"/>
              <a:gd name="connsiteY0" fmla="*/ 0 h 1380560"/>
              <a:gd name="connsiteX1" fmla="*/ 1565865 w 1565865"/>
              <a:gd name="connsiteY1" fmla="*/ 1380560 h 1380560"/>
              <a:gd name="connsiteX0" fmla="*/ 69610 w 1635475"/>
              <a:gd name="connsiteY0" fmla="*/ 222812 h 1603372"/>
              <a:gd name="connsiteX1" fmla="*/ 1576122 w 1635475"/>
              <a:gd name="connsiteY1" fmla="*/ 1481986 h 1603372"/>
              <a:gd name="connsiteX2" fmla="*/ 69611 w 1635475"/>
              <a:gd name="connsiteY2" fmla="*/ 1481986 h 1603372"/>
              <a:gd name="connsiteX3" fmla="*/ 69610 w 1635475"/>
              <a:gd name="connsiteY3" fmla="*/ 222812 h 1603372"/>
              <a:gd name="connsiteX0" fmla="*/ 0 w 1635475"/>
              <a:gd name="connsiteY0" fmla="*/ 0 h 1603372"/>
              <a:gd name="connsiteX1" fmla="*/ 1635475 w 1635475"/>
              <a:gd name="connsiteY1" fmla="*/ 1603372 h 1603372"/>
              <a:gd name="connsiteX0" fmla="*/ 58711 w 1624576"/>
              <a:gd name="connsiteY0" fmla="*/ 235545 h 1616105"/>
              <a:gd name="connsiteX1" fmla="*/ 1565223 w 1624576"/>
              <a:gd name="connsiteY1" fmla="*/ 1494719 h 1616105"/>
              <a:gd name="connsiteX2" fmla="*/ 58712 w 1624576"/>
              <a:gd name="connsiteY2" fmla="*/ 1494719 h 1616105"/>
              <a:gd name="connsiteX3" fmla="*/ 58711 w 1624576"/>
              <a:gd name="connsiteY3" fmla="*/ 235545 h 1616105"/>
              <a:gd name="connsiteX0" fmla="*/ 0 w 1624576"/>
              <a:gd name="connsiteY0" fmla="*/ 0 h 1616105"/>
              <a:gd name="connsiteX1" fmla="*/ 1624576 w 1624576"/>
              <a:gd name="connsiteY1" fmla="*/ 1616105 h 1616105"/>
              <a:gd name="connsiteX0" fmla="*/ 58711 w 1586057"/>
              <a:gd name="connsiteY0" fmla="*/ 235545 h 1640492"/>
              <a:gd name="connsiteX1" fmla="*/ 1565223 w 1586057"/>
              <a:gd name="connsiteY1" fmla="*/ 1494719 h 1640492"/>
              <a:gd name="connsiteX2" fmla="*/ 58712 w 1586057"/>
              <a:gd name="connsiteY2" fmla="*/ 1494719 h 1640492"/>
              <a:gd name="connsiteX3" fmla="*/ 58711 w 1586057"/>
              <a:gd name="connsiteY3" fmla="*/ 235545 h 1640492"/>
              <a:gd name="connsiteX0" fmla="*/ 0 w 1586057"/>
              <a:gd name="connsiteY0" fmla="*/ 0 h 1640492"/>
              <a:gd name="connsiteX1" fmla="*/ 1586057 w 1586057"/>
              <a:gd name="connsiteY1" fmla="*/ 1640492 h 1640492"/>
              <a:gd name="connsiteX0" fmla="*/ 0 w 1612049"/>
              <a:gd name="connsiteY0" fmla="*/ 246879 h 1640492"/>
              <a:gd name="connsiteX1" fmla="*/ 1591215 w 1612049"/>
              <a:gd name="connsiteY1" fmla="*/ 1494719 h 1640492"/>
              <a:gd name="connsiteX2" fmla="*/ 84704 w 1612049"/>
              <a:gd name="connsiteY2" fmla="*/ 1494719 h 1640492"/>
              <a:gd name="connsiteX3" fmla="*/ 0 w 1612049"/>
              <a:gd name="connsiteY3" fmla="*/ 246879 h 1640492"/>
              <a:gd name="connsiteX0" fmla="*/ 25992 w 1612049"/>
              <a:gd name="connsiteY0" fmla="*/ 0 h 1640492"/>
              <a:gd name="connsiteX1" fmla="*/ 1612049 w 1612049"/>
              <a:gd name="connsiteY1" fmla="*/ 1640492 h 1640492"/>
            </a:gdLst>
            <a:ahLst/>
            <a:cxnLst>
              <a:cxn ang="0">
                <a:pos x="connsiteX0" y="connsiteY0"/>
              </a:cxn>
              <a:cxn ang="0">
                <a:pos x="connsiteX1" y="connsiteY1"/>
              </a:cxn>
            </a:cxnLst>
            <a:rect l="l" t="t" r="r" b="b"/>
            <a:pathLst>
              <a:path w="1612049" h="1640492" stroke="0" extrusionOk="0">
                <a:moveTo>
                  <a:pt x="0" y="246879"/>
                </a:moveTo>
                <a:cubicBezTo>
                  <a:pt x="832024" y="246879"/>
                  <a:pt x="1591215" y="799296"/>
                  <a:pt x="1591215" y="1494719"/>
                </a:cubicBezTo>
                <a:lnTo>
                  <a:pt x="84704" y="1494719"/>
                </a:lnTo>
                <a:cubicBezTo>
                  <a:pt x="84704" y="1074994"/>
                  <a:pt x="0" y="666604"/>
                  <a:pt x="0" y="246879"/>
                </a:cubicBezTo>
                <a:close/>
              </a:path>
              <a:path w="1612049" h="1640492" fill="none">
                <a:moveTo>
                  <a:pt x="25992" y="0"/>
                </a:moveTo>
                <a:cubicBezTo>
                  <a:pt x="858016" y="0"/>
                  <a:pt x="1612049" y="945069"/>
                  <a:pt x="1612049" y="1640492"/>
                </a:cubicBezTo>
              </a:path>
            </a:pathLst>
          </a:custGeom>
          <a:ln w="38100">
            <a:solidFill>
              <a:schemeClr val="bg1">
                <a:lumMod val="8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1" name="Right Triangle 50">
            <a:extLst>
              <a:ext uri="{FF2B5EF4-FFF2-40B4-BE49-F238E27FC236}">
                <a16:creationId xmlns:a16="http://schemas.microsoft.com/office/drawing/2014/main" id="{C9BD7337-A8F9-3D03-FFB7-C8C96D31E3A9}"/>
              </a:ext>
            </a:extLst>
          </p:cNvPr>
          <p:cNvSpPr/>
          <p:nvPr/>
        </p:nvSpPr>
        <p:spPr>
          <a:xfrm rot="16494997">
            <a:off x="7560130" y="2911779"/>
            <a:ext cx="339511" cy="234237"/>
          </a:xfrm>
          <a:prstGeom prst="rtTriangle">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Rectangle 53">
            <a:extLst>
              <a:ext uri="{FF2B5EF4-FFF2-40B4-BE49-F238E27FC236}">
                <a16:creationId xmlns:a16="http://schemas.microsoft.com/office/drawing/2014/main" id="{18774625-92FE-4E10-CD75-52F5ECD19E8F}"/>
              </a:ext>
            </a:extLst>
          </p:cNvPr>
          <p:cNvSpPr/>
          <p:nvPr/>
        </p:nvSpPr>
        <p:spPr>
          <a:xfrm rot="2946711">
            <a:off x="7895865" y="1722428"/>
            <a:ext cx="2264864" cy="8504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a:extLst>
              <a:ext uri="{FF2B5EF4-FFF2-40B4-BE49-F238E27FC236}">
                <a16:creationId xmlns:a16="http://schemas.microsoft.com/office/drawing/2014/main" id="{0A115DB0-2798-3A01-F8D1-C9AE2AD73ED8}"/>
              </a:ext>
            </a:extLst>
          </p:cNvPr>
          <p:cNvSpPr/>
          <p:nvPr/>
        </p:nvSpPr>
        <p:spPr>
          <a:xfrm rot="7800145">
            <a:off x="5609399" y="1726530"/>
            <a:ext cx="2264864" cy="8504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Top Corners Snipped 4">
            <a:extLst>
              <a:ext uri="{FF2B5EF4-FFF2-40B4-BE49-F238E27FC236}">
                <a16:creationId xmlns:a16="http://schemas.microsoft.com/office/drawing/2014/main" id="{FDCBE3D7-5AF3-5041-B7B6-C98351ECD5E5}"/>
              </a:ext>
            </a:extLst>
          </p:cNvPr>
          <p:cNvSpPr/>
          <p:nvPr/>
        </p:nvSpPr>
        <p:spPr>
          <a:xfrm rot="10800000">
            <a:off x="7589708" y="-1"/>
            <a:ext cx="581654" cy="1650036"/>
          </a:xfrm>
          <a:prstGeom prst="snip2SameRect">
            <a:avLst>
              <a:gd name="adj1" fmla="val 16667"/>
              <a:gd name="adj2" fmla="val 0"/>
            </a:avLst>
          </a:prstGeom>
          <a:solidFill>
            <a:schemeClr val="tx1">
              <a:lumMod val="65000"/>
              <a:lumOff val="35000"/>
            </a:schemeClr>
          </a:solidFill>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Block Arc 57">
            <a:extLst>
              <a:ext uri="{FF2B5EF4-FFF2-40B4-BE49-F238E27FC236}">
                <a16:creationId xmlns:a16="http://schemas.microsoft.com/office/drawing/2014/main" id="{1E3D0E37-6464-B87A-58D1-52B850BC4169}"/>
              </a:ext>
            </a:extLst>
          </p:cNvPr>
          <p:cNvSpPr/>
          <p:nvPr/>
        </p:nvSpPr>
        <p:spPr>
          <a:xfrm rot="10800000">
            <a:off x="6114682" y="2034664"/>
            <a:ext cx="3506704" cy="1768854"/>
          </a:xfrm>
          <a:prstGeom prst="blockArc">
            <a:avLst>
              <a:gd name="adj1" fmla="val 10804600"/>
              <a:gd name="adj2" fmla="val 0"/>
              <a:gd name="adj3" fmla="val 25000"/>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59" name="TextBox 58">
            <a:extLst>
              <a:ext uri="{FF2B5EF4-FFF2-40B4-BE49-F238E27FC236}">
                <a16:creationId xmlns:a16="http://schemas.microsoft.com/office/drawing/2014/main" id="{D73BABB4-74A7-BF0A-EFAC-D8411BE6B79E}"/>
              </a:ext>
            </a:extLst>
          </p:cNvPr>
          <p:cNvSpPr txBox="1"/>
          <p:nvPr/>
        </p:nvSpPr>
        <p:spPr>
          <a:xfrm>
            <a:off x="8324436" y="1518068"/>
            <a:ext cx="1291031" cy="369332"/>
          </a:xfrm>
          <a:prstGeom prst="rect">
            <a:avLst/>
          </a:prstGeom>
          <a:noFill/>
        </p:spPr>
        <p:txBody>
          <a:bodyPr wrap="square" rtlCol="0">
            <a:spAutoFit/>
          </a:bodyPr>
          <a:lstStyle/>
          <a:p>
            <a:r>
              <a:rPr lang="en-US" dirty="0"/>
              <a:t>Spleen</a:t>
            </a:r>
          </a:p>
        </p:txBody>
      </p:sp>
      <p:sp>
        <p:nvSpPr>
          <p:cNvPr id="60" name="TextBox 59">
            <a:extLst>
              <a:ext uri="{FF2B5EF4-FFF2-40B4-BE49-F238E27FC236}">
                <a16:creationId xmlns:a16="http://schemas.microsoft.com/office/drawing/2014/main" id="{BACBB4B9-0283-CED3-0662-B4250BB3CD3E}"/>
              </a:ext>
            </a:extLst>
          </p:cNvPr>
          <p:cNvSpPr txBox="1"/>
          <p:nvPr/>
        </p:nvSpPr>
        <p:spPr>
          <a:xfrm>
            <a:off x="8850232" y="2245879"/>
            <a:ext cx="1291031" cy="369332"/>
          </a:xfrm>
          <a:prstGeom prst="rect">
            <a:avLst/>
          </a:prstGeom>
          <a:noFill/>
        </p:spPr>
        <p:txBody>
          <a:bodyPr wrap="square" rtlCol="0">
            <a:spAutoFit/>
          </a:bodyPr>
          <a:lstStyle/>
          <a:p>
            <a:r>
              <a:rPr lang="en-US" dirty="0"/>
              <a:t>Kidney</a:t>
            </a:r>
          </a:p>
        </p:txBody>
      </p:sp>
      <p:sp>
        <p:nvSpPr>
          <p:cNvPr id="61" name="TextBox 60">
            <a:extLst>
              <a:ext uri="{FF2B5EF4-FFF2-40B4-BE49-F238E27FC236}">
                <a16:creationId xmlns:a16="http://schemas.microsoft.com/office/drawing/2014/main" id="{BF8F3DDD-5833-BACE-0F1D-56DF5183AC4E}"/>
              </a:ext>
            </a:extLst>
          </p:cNvPr>
          <p:cNvSpPr txBox="1"/>
          <p:nvPr/>
        </p:nvSpPr>
        <p:spPr>
          <a:xfrm>
            <a:off x="8678737" y="1842671"/>
            <a:ext cx="2084912" cy="369332"/>
          </a:xfrm>
          <a:prstGeom prst="rect">
            <a:avLst/>
          </a:prstGeom>
          <a:noFill/>
        </p:spPr>
        <p:txBody>
          <a:bodyPr wrap="square" rtlCol="0">
            <a:spAutoFit/>
          </a:bodyPr>
          <a:lstStyle/>
          <a:p>
            <a:r>
              <a:rPr lang="en-US" dirty="0"/>
              <a:t>Splenorenal recess</a:t>
            </a:r>
          </a:p>
        </p:txBody>
      </p:sp>
      <p:sp>
        <p:nvSpPr>
          <p:cNvPr id="62" name="TextBox 61">
            <a:extLst>
              <a:ext uri="{FF2B5EF4-FFF2-40B4-BE49-F238E27FC236}">
                <a16:creationId xmlns:a16="http://schemas.microsoft.com/office/drawing/2014/main" id="{B2593475-294B-958C-DC62-4B9C54ED0CEC}"/>
              </a:ext>
            </a:extLst>
          </p:cNvPr>
          <p:cNvSpPr txBox="1"/>
          <p:nvPr/>
        </p:nvSpPr>
        <p:spPr>
          <a:xfrm>
            <a:off x="5965796" y="1612409"/>
            <a:ext cx="1291031" cy="369332"/>
          </a:xfrm>
          <a:prstGeom prst="rect">
            <a:avLst/>
          </a:prstGeom>
          <a:noFill/>
        </p:spPr>
        <p:txBody>
          <a:bodyPr wrap="square" rtlCol="0">
            <a:spAutoFit/>
          </a:bodyPr>
          <a:lstStyle/>
          <a:p>
            <a:r>
              <a:rPr lang="en-US" dirty="0"/>
              <a:t>Diaphragm</a:t>
            </a:r>
          </a:p>
        </p:txBody>
      </p:sp>
      <p:cxnSp>
        <p:nvCxnSpPr>
          <p:cNvPr id="1024" name="Straight Arrow Connector 1023">
            <a:extLst>
              <a:ext uri="{FF2B5EF4-FFF2-40B4-BE49-F238E27FC236}">
                <a16:creationId xmlns:a16="http://schemas.microsoft.com/office/drawing/2014/main" id="{03336882-6ACD-F79C-D243-F56DC14D003A}"/>
              </a:ext>
            </a:extLst>
          </p:cNvPr>
          <p:cNvCxnSpPr>
            <a:cxnSpLocks/>
          </p:cNvCxnSpPr>
          <p:nvPr/>
        </p:nvCxnSpPr>
        <p:spPr>
          <a:xfrm>
            <a:off x="6911158" y="1978636"/>
            <a:ext cx="293545" cy="32935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8" name="Straight Arrow Connector 1027">
            <a:extLst>
              <a:ext uri="{FF2B5EF4-FFF2-40B4-BE49-F238E27FC236}">
                <a16:creationId xmlns:a16="http://schemas.microsoft.com/office/drawing/2014/main" id="{1907B9CA-132B-1C9D-1CD1-13BA7AF82BD5}"/>
              </a:ext>
            </a:extLst>
          </p:cNvPr>
          <p:cNvCxnSpPr>
            <a:stCxn id="59" idx="1"/>
          </p:cNvCxnSpPr>
          <p:nvPr/>
        </p:nvCxnSpPr>
        <p:spPr>
          <a:xfrm flipH="1">
            <a:off x="8069428" y="1702734"/>
            <a:ext cx="255008" cy="41082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9" name="Straight Arrow Connector 1028">
            <a:extLst>
              <a:ext uri="{FF2B5EF4-FFF2-40B4-BE49-F238E27FC236}">
                <a16:creationId xmlns:a16="http://schemas.microsoft.com/office/drawing/2014/main" id="{2B1D08DA-3309-98FF-6392-9F055441622D}"/>
              </a:ext>
            </a:extLst>
          </p:cNvPr>
          <p:cNvCxnSpPr>
            <a:cxnSpLocks/>
            <a:stCxn id="61" idx="1"/>
          </p:cNvCxnSpPr>
          <p:nvPr/>
        </p:nvCxnSpPr>
        <p:spPr>
          <a:xfrm flipH="1">
            <a:off x="8386873" y="2027337"/>
            <a:ext cx="291864" cy="22014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3" name="Straight Arrow Connector 1032">
            <a:extLst>
              <a:ext uri="{FF2B5EF4-FFF2-40B4-BE49-F238E27FC236}">
                <a16:creationId xmlns:a16="http://schemas.microsoft.com/office/drawing/2014/main" id="{79468BE5-2F1A-D157-3288-A6DE5CE51B49}"/>
              </a:ext>
            </a:extLst>
          </p:cNvPr>
          <p:cNvCxnSpPr>
            <a:cxnSpLocks/>
            <a:stCxn id="60" idx="1"/>
          </p:cNvCxnSpPr>
          <p:nvPr/>
        </p:nvCxnSpPr>
        <p:spPr>
          <a:xfrm flipH="1">
            <a:off x="8477681" y="2430545"/>
            <a:ext cx="372551" cy="11133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4" name="Audio Recording Oct 18, 2022 at 8:23:28 PM">
            <a:hlinkClick r:id="" action="ppaction://media"/>
            <a:extLst>
              <a:ext uri="{FF2B5EF4-FFF2-40B4-BE49-F238E27FC236}">
                <a16:creationId xmlns:a16="http://schemas.microsoft.com/office/drawing/2014/main" id="{853BF8F0-6DD6-371A-B098-F0130CEAD54B}"/>
              </a:ext>
            </a:extLst>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1178629" y="6045199"/>
            <a:ext cx="812800" cy="812800"/>
          </a:xfrm>
          <a:prstGeom prst="rect">
            <a:avLst/>
          </a:prstGeom>
        </p:spPr>
      </p:pic>
    </p:spTree>
    <p:extLst>
      <p:ext uri="{BB962C8B-B14F-4D97-AF65-F5344CB8AC3E}">
        <p14:creationId xmlns:p14="http://schemas.microsoft.com/office/powerpoint/2010/main" val="27014880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p:tmPct val="10000"/>
                                  </p:iterate>
                                  <p:childTnLst>
                                    <p:set>
                                      <p:cBhvr>
                                        <p:cTn id="6" dur="1" fill="hold">
                                          <p:stCondLst>
                                            <p:cond delay="0"/>
                                          </p:stCondLst>
                                        </p:cTn>
                                        <p:tgtEl>
                                          <p:spTgt spid="26"/>
                                        </p:tgtEl>
                                        <p:attrNameLst>
                                          <p:attrName>style.visibility</p:attrName>
                                        </p:attrNameLst>
                                      </p:cBhvr>
                                      <p:to>
                                        <p:strVal val="visible"/>
                                      </p:to>
                                    </p:set>
                                    <p:animEffect transition="in" filter="fade">
                                      <p:cBhvr>
                                        <p:cTn id="7" dur="700"/>
                                        <p:tgtEl>
                                          <p:spTgt spid="26"/>
                                        </p:tgtEl>
                                      </p:cBhvr>
                                    </p:animEffect>
                                  </p:childTnLst>
                                </p:cTn>
                              </p:par>
                            </p:childTnLst>
                          </p:cTn>
                        </p:par>
                      </p:childTnLst>
                    </p:cTn>
                  </p:par>
                  <p:par>
                    <p:cTn id="8" fill="hold">
                      <p:stCondLst>
                        <p:cond delay="indefinite"/>
                      </p:stCondLst>
                      <p:childTnLst>
                        <p:par>
                          <p:cTn id="9" fill="hold">
                            <p:stCondLst>
                              <p:cond delay="0"/>
                            </p:stCondLst>
                            <p:childTnLst>
                              <p:par>
                                <p:cTn id="10" presetID="1" presetClass="mediacall" presetSubtype="0" fill="hold" nodeType="clickEffect">
                                  <p:stCondLst>
                                    <p:cond delay="0"/>
                                  </p:stCondLst>
                                  <p:childTnLst>
                                    <p:cmd type="call" cmd="playFrom(0.0)">
                                      <p:cBhvr>
                                        <p:cTn id="11" dur="70080"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12" fill="hold" display="0">
                  <p:stCondLst>
                    <p:cond delay="indefinite"/>
                  </p:stCondLst>
                  <p:endCondLst>
                    <p:cond evt="onStopAudio" delay="0">
                      <p:tgtEl>
                        <p:sldTgt/>
                      </p:tgtEl>
                    </p:cond>
                  </p:endCondLst>
                </p:cTn>
                <p:tgtEl>
                  <p:spTgt spid="4"/>
                </p:tgtEl>
              </p:cMediaNode>
            </p:audio>
          </p:childTnLst>
        </p:cTn>
      </p:par>
    </p:tnLst>
    <p:bldLst>
      <p:bldP spid="26"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ABCBD2B-E519-A1E1-EB10-B595B49717B3}"/>
              </a:ext>
            </a:extLst>
          </p:cNvPr>
          <p:cNvPicPr>
            <a:picLocks noChangeAspect="1"/>
          </p:cNvPicPr>
          <p:nvPr/>
        </p:nvPicPr>
        <p:blipFill rotWithShape="1">
          <a:blip r:embed="rId5"/>
          <a:srcRect t="27786" b="14209"/>
          <a:stretch/>
        </p:blipFill>
        <p:spPr>
          <a:xfrm>
            <a:off x="-236197" y="17425"/>
            <a:ext cx="7681156" cy="6085490"/>
          </a:xfrm>
          <a:prstGeom prst="rect">
            <a:avLst/>
          </a:prstGeom>
        </p:spPr>
      </p:pic>
      <p:pic>
        <p:nvPicPr>
          <p:cNvPr id="1026" name="Picture 2">
            <a:extLst>
              <a:ext uri="{FF2B5EF4-FFF2-40B4-BE49-F238E27FC236}">
                <a16:creationId xmlns:a16="http://schemas.microsoft.com/office/drawing/2014/main" id="{2B1F7336-78F8-4C3D-4F7F-F78AD27A4121}"/>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626873" y="5855396"/>
            <a:ext cx="563680" cy="197288"/>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5">
            <a:extLst>
              <a:ext uri="{FF2B5EF4-FFF2-40B4-BE49-F238E27FC236}">
                <a16:creationId xmlns:a16="http://schemas.microsoft.com/office/drawing/2014/main" id="{639DB5BF-E0BA-39B7-2D90-C8FA6554CA41}"/>
              </a:ext>
            </a:extLst>
          </p:cNvPr>
          <p:cNvPicPr>
            <a:picLocks noChangeAspect="1"/>
          </p:cNvPicPr>
          <p:nvPr/>
        </p:nvPicPr>
        <p:blipFill>
          <a:blip r:embed="rId7">
            <a:extLst>
              <a:ext uri="{BEBA8EAE-BF5A-486C-A8C5-ECC9F3942E4B}">
                <a14:imgProps xmlns:a14="http://schemas.microsoft.com/office/drawing/2010/main">
                  <a14:imgLayer r:embed="rId8">
                    <a14:imgEffect>
                      <a14:backgroundRemoval t="10000" b="97840" l="1616" r="96379">
                        <a14:foregroundMark x1="23565" y1="45988" x2="23343" y2="38889"/>
                        <a14:foregroundMark x1="23343" y1="38889" x2="18607" y2="34012"/>
                        <a14:foregroundMark x1="18607" y1="34012" x2="12033" y2="36790"/>
                        <a14:foregroundMark x1="12033" y1="36790" x2="5460" y2="43210"/>
                        <a14:foregroundMark x1="578" y1="56760" x2="167" y2="57901"/>
                        <a14:foregroundMark x1="1051" y1="55446" x2="645" y2="56574"/>
                        <a14:foregroundMark x1="5460" y1="43210" x2="1332" y2="54667"/>
                        <a14:foregroundMark x1="167" y1="57901" x2="6852" y2="77346"/>
                        <a14:foregroundMark x1="6852" y1="77346" x2="12256" y2="82593"/>
                        <a14:foregroundMark x1="12256" y1="82593" x2="18997" y2="81605"/>
                        <a14:foregroundMark x1="18997" y1="81605" x2="19833" y2="80617"/>
                        <a14:foregroundMark x1="3510" y1="45988" x2="2080" y2="49561"/>
                        <a14:foregroundMark x1="1052" y1="55446" x2="1671" y2="66667"/>
                        <a14:foregroundMark x1="1671" y1="66667" x2="3900" y2="75247"/>
                        <a14:foregroundMark x1="94540" y1="49630" x2="98273" y2="35741"/>
                        <a14:foregroundMark x1="98273" y1="35741" x2="97382" y2="26296"/>
                        <a14:foregroundMark x1="97382" y1="26296" x2="93370" y2="20185"/>
                        <a14:foregroundMark x1="93370" y1="20185" x2="87521" y2="16852"/>
                        <a14:foregroundMark x1="87521" y1="16852" x2="87521" y2="16852"/>
                        <a14:foregroundMark x1="95265" y1="52407" x2="99276" y2="38765"/>
                        <a14:foregroundMark x1="99276" y1="38765" x2="96379" y2="25000"/>
                        <a14:foregroundMark x1="96379" y1="25000" x2="96100" y2="24506"/>
                        <a14:foregroundMark x1="54540" y1="90617" x2="41337" y2="93272"/>
                        <a14:foregroundMark x1="30300" y1="91984" x2="28635" y2="91790"/>
                        <a14:foregroundMark x1="41337" y1="93272" x2="30508" y2="92009"/>
                        <a14:foregroundMark x1="28635" y1="91790" x2="26908" y2="89691"/>
                        <a14:foregroundMark x1="77549" y1="90926" x2="78496" y2="97840"/>
                        <a14:foregroundMark x1="78496" y1="97840" x2="85404" y2="98580"/>
                        <a14:foregroundMark x1="85404" y1="98580" x2="91811" y2="97840"/>
                        <a14:foregroundMark x1="91811" y1="97840" x2="92368" y2="90617"/>
                        <a14:backgroundMark x1="1281" y1="48457" x2="279" y2="55309"/>
                        <a14:backgroundMark x1="279" y1="55309" x2="167" y2="50247"/>
                        <a14:backgroundMark x1="26462" y1="91235" x2="26741" y2="90802"/>
                        <a14:backgroundMark x1="31588" y1="93395" x2="30641" y2="92778"/>
                      </a14:backgroundRemoval>
                    </a14:imgEffect>
                  </a14:imgLayer>
                </a14:imgProps>
              </a:ext>
            </a:extLst>
          </a:blip>
          <a:stretch>
            <a:fillRect/>
          </a:stretch>
        </p:blipFill>
        <p:spPr>
          <a:xfrm>
            <a:off x="2549662" y="2457536"/>
            <a:ext cx="2418742" cy="2184148"/>
          </a:xfrm>
          <a:prstGeom prst="rect">
            <a:avLst/>
          </a:prstGeom>
        </p:spPr>
      </p:pic>
      <mc:AlternateContent xmlns:mc="http://schemas.openxmlformats.org/markup-compatibility/2006" xmlns:p14="http://schemas.microsoft.com/office/powerpoint/2010/main">
        <mc:Choice Requires="p14">
          <p:contentPart p14:bwMode="auto" r:id="rId9">
            <p14:nvContentPartPr>
              <p14:cNvPr id="2" name="Ink 1">
                <a:extLst>
                  <a:ext uri="{FF2B5EF4-FFF2-40B4-BE49-F238E27FC236}">
                    <a16:creationId xmlns:a16="http://schemas.microsoft.com/office/drawing/2014/main" id="{6E34951C-479A-DD03-8CCB-E8B5752E6FC0}"/>
                  </a:ext>
                </a:extLst>
              </p14:cNvPr>
              <p14:cNvContentPartPr/>
              <p14:nvPr/>
            </p14:nvContentPartPr>
            <p14:xfrm>
              <a:off x="4244553" y="2741804"/>
              <a:ext cx="715680" cy="839880"/>
            </p14:xfrm>
          </p:contentPart>
        </mc:Choice>
        <mc:Fallback xmlns="">
          <p:pic>
            <p:nvPicPr>
              <p:cNvPr id="2" name="Ink 1">
                <a:extLst>
                  <a:ext uri="{FF2B5EF4-FFF2-40B4-BE49-F238E27FC236}">
                    <a16:creationId xmlns:a16="http://schemas.microsoft.com/office/drawing/2014/main" id="{6E34951C-479A-DD03-8CCB-E8B5752E6FC0}"/>
                  </a:ext>
                </a:extLst>
              </p:cNvPr>
              <p:cNvPicPr/>
              <p:nvPr/>
            </p:nvPicPr>
            <p:blipFill>
              <a:blip r:embed="rId10"/>
              <a:stretch>
                <a:fillRect/>
              </a:stretch>
            </p:blipFill>
            <p:spPr>
              <a:xfrm>
                <a:off x="4226913" y="2724164"/>
                <a:ext cx="751320" cy="875520"/>
              </a:xfrm>
              <a:prstGeom prst="rect">
                <a:avLst/>
              </a:prstGeom>
            </p:spPr>
          </p:pic>
        </mc:Fallback>
      </mc:AlternateContent>
      <mc:AlternateContent xmlns:mc="http://schemas.openxmlformats.org/markup-compatibility/2006" xmlns:p14="http://schemas.microsoft.com/office/powerpoint/2010/main">
        <mc:Choice Requires="p14">
          <p:contentPart p14:bwMode="auto" r:id="rId11">
            <p14:nvContentPartPr>
              <p14:cNvPr id="8" name="Ink 7">
                <a:extLst>
                  <a:ext uri="{FF2B5EF4-FFF2-40B4-BE49-F238E27FC236}">
                    <a16:creationId xmlns:a16="http://schemas.microsoft.com/office/drawing/2014/main" id="{28EE6100-4B36-3F37-96CE-BA8EEB732D32}"/>
                  </a:ext>
                </a:extLst>
              </p14:cNvPr>
              <p14:cNvContentPartPr/>
              <p14:nvPr/>
            </p14:nvContentPartPr>
            <p14:xfrm>
              <a:off x="3916233" y="2977604"/>
              <a:ext cx="710640" cy="1072080"/>
            </p14:xfrm>
          </p:contentPart>
        </mc:Choice>
        <mc:Fallback xmlns="">
          <p:pic>
            <p:nvPicPr>
              <p:cNvPr id="8" name="Ink 7">
                <a:extLst>
                  <a:ext uri="{FF2B5EF4-FFF2-40B4-BE49-F238E27FC236}">
                    <a16:creationId xmlns:a16="http://schemas.microsoft.com/office/drawing/2014/main" id="{28EE6100-4B36-3F37-96CE-BA8EEB732D32}"/>
                  </a:ext>
                </a:extLst>
              </p:cNvPr>
              <p:cNvPicPr/>
              <p:nvPr/>
            </p:nvPicPr>
            <p:blipFill>
              <a:blip r:embed="rId12"/>
              <a:stretch>
                <a:fillRect/>
              </a:stretch>
            </p:blipFill>
            <p:spPr>
              <a:xfrm>
                <a:off x="3898233" y="2959964"/>
                <a:ext cx="746280" cy="1107720"/>
              </a:xfrm>
              <a:prstGeom prst="rect">
                <a:avLst/>
              </a:prstGeom>
            </p:spPr>
          </p:pic>
        </mc:Fallback>
      </mc:AlternateContent>
      <p:grpSp>
        <p:nvGrpSpPr>
          <p:cNvPr id="1068" name="Group 1067">
            <a:extLst>
              <a:ext uri="{FF2B5EF4-FFF2-40B4-BE49-F238E27FC236}">
                <a16:creationId xmlns:a16="http://schemas.microsoft.com/office/drawing/2014/main" id="{4A38F0BD-97D1-BD49-3314-3EC46F149585}"/>
              </a:ext>
            </a:extLst>
          </p:cNvPr>
          <p:cNvGrpSpPr/>
          <p:nvPr/>
        </p:nvGrpSpPr>
        <p:grpSpPr>
          <a:xfrm>
            <a:off x="2134173" y="78655"/>
            <a:ext cx="2940416" cy="3475921"/>
            <a:chOff x="663381" y="200791"/>
            <a:chExt cx="3184082" cy="3228209"/>
          </a:xfrm>
        </p:grpSpPr>
        <p:grpSp>
          <p:nvGrpSpPr>
            <p:cNvPr id="1065" name="Group 1064">
              <a:extLst>
                <a:ext uri="{FF2B5EF4-FFF2-40B4-BE49-F238E27FC236}">
                  <a16:creationId xmlns:a16="http://schemas.microsoft.com/office/drawing/2014/main" id="{870F3AEF-BFF1-0226-1FB1-978E26CB985F}"/>
                </a:ext>
              </a:extLst>
            </p:cNvPr>
            <p:cNvGrpSpPr/>
            <p:nvPr/>
          </p:nvGrpSpPr>
          <p:grpSpPr>
            <a:xfrm>
              <a:off x="663381" y="200791"/>
              <a:ext cx="3184082" cy="3228209"/>
              <a:chOff x="846201" y="0"/>
              <a:chExt cx="2818441" cy="3657600"/>
            </a:xfrm>
          </p:grpSpPr>
          <p:grpSp>
            <p:nvGrpSpPr>
              <p:cNvPr id="1027" name="Group 1026">
                <a:extLst>
                  <a:ext uri="{FF2B5EF4-FFF2-40B4-BE49-F238E27FC236}">
                    <a16:creationId xmlns:a16="http://schemas.microsoft.com/office/drawing/2014/main" id="{4EBC8A37-E588-4E15-9B54-52AF6FC2FEA9}"/>
                  </a:ext>
                </a:extLst>
              </p:cNvPr>
              <p:cNvGrpSpPr/>
              <p:nvPr/>
            </p:nvGrpSpPr>
            <p:grpSpPr>
              <a:xfrm>
                <a:off x="846201" y="0"/>
                <a:ext cx="2818441" cy="3657600"/>
                <a:chOff x="4101745" y="653002"/>
                <a:chExt cx="4059360" cy="5189040"/>
              </a:xfrm>
            </p:grpSpPr>
            <mc:AlternateContent xmlns:mc="http://schemas.openxmlformats.org/markup-compatibility/2006" xmlns:p14="http://schemas.microsoft.com/office/powerpoint/2010/main">
              <mc:Choice Requires="p14">
                <p:contentPart p14:bwMode="auto" r:id="rId13">
                  <p14:nvContentPartPr>
                    <p14:cNvPr id="1029" name="Ink 1028">
                      <a:extLst>
                        <a:ext uri="{FF2B5EF4-FFF2-40B4-BE49-F238E27FC236}">
                          <a16:creationId xmlns:a16="http://schemas.microsoft.com/office/drawing/2014/main" id="{E4042D38-7D68-6303-01FE-0D5B763F0A97}"/>
                        </a:ext>
                      </a:extLst>
                    </p14:cNvPr>
                    <p14:cNvContentPartPr/>
                    <p14:nvPr/>
                  </p14:nvContentPartPr>
                  <p14:xfrm>
                    <a:off x="5677105" y="1174642"/>
                    <a:ext cx="968400" cy="659160"/>
                  </p14:xfrm>
                </p:contentPart>
              </mc:Choice>
              <mc:Fallback xmlns="">
                <p:pic>
                  <p:nvPicPr>
                    <p:cNvPr id="1029" name="Ink 1028">
                      <a:extLst>
                        <a:ext uri="{FF2B5EF4-FFF2-40B4-BE49-F238E27FC236}">
                          <a16:creationId xmlns:a16="http://schemas.microsoft.com/office/drawing/2014/main" id="{E4042D38-7D68-6303-01FE-0D5B763F0A97}"/>
                        </a:ext>
                      </a:extLst>
                    </p:cNvPr>
                    <p:cNvPicPr/>
                    <p:nvPr/>
                  </p:nvPicPr>
                  <p:blipFill>
                    <a:blip r:embed="rId14"/>
                    <a:stretch>
                      <a:fillRect/>
                    </a:stretch>
                  </p:blipFill>
                  <p:spPr>
                    <a:xfrm>
                      <a:off x="5610692" y="1100170"/>
                      <a:ext cx="1100754" cy="807577"/>
                    </a:xfrm>
                    <a:prstGeom prst="rect">
                      <a:avLst/>
                    </a:prstGeom>
                  </p:spPr>
                </p:pic>
              </mc:Fallback>
            </mc:AlternateContent>
            <mc:AlternateContent xmlns:mc="http://schemas.openxmlformats.org/markup-compatibility/2006" xmlns:p14="http://schemas.microsoft.com/office/powerpoint/2010/main">
              <mc:Choice Requires="p14">
                <p:contentPart p14:bwMode="auto" r:id="rId15">
                  <p14:nvContentPartPr>
                    <p14:cNvPr id="1031" name="Ink 1030">
                      <a:extLst>
                        <a:ext uri="{FF2B5EF4-FFF2-40B4-BE49-F238E27FC236}">
                          <a16:creationId xmlns:a16="http://schemas.microsoft.com/office/drawing/2014/main" id="{D48CE18D-5872-3A8F-9D96-5596DD866026}"/>
                        </a:ext>
                      </a:extLst>
                    </p14:cNvPr>
                    <p14:cNvContentPartPr/>
                    <p14:nvPr/>
                  </p14:nvContentPartPr>
                  <p14:xfrm>
                    <a:off x="5812825" y="1879522"/>
                    <a:ext cx="196200" cy="1943640"/>
                  </p14:xfrm>
                </p:contentPart>
              </mc:Choice>
              <mc:Fallback xmlns="">
                <p:pic>
                  <p:nvPicPr>
                    <p:cNvPr id="1031" name="Ink 1030">
                      <a:extLst>
                        <a:ext uri="{FF2B5EF4-FFF2-40B4-BE49-F238E27FC236}">
                          <a16:creationId xmlns:a16="http://schemas.microsoft.com/office/drawing/2014/main" id="{D48CE18D-5872-3A8F-9D96-5596DD866026}"/>
                        </a:ext>
                      </a:extLst>
                    </p:cNvPr>
                    <p:cNvPicPr/>
                    <p:nvPr/>
                  </p:nvPicPr>
                  <p:blipFill>
                    <a:blip r:embed="rId16"/>
                    <a:stretch>
                      <a:fillRect/>
                    </a:stretch>
                  </p:blipFill>
                  <p:spPr>
                    <a:xfrm>
                      <a:off x="5746484" y="1805071"/>
                      <a:ext cx="328412" cy="2092013"/>
                    </a:xfrm>
                    <a:prstGeom prst="rect">
                      <a:avLst/>
                    </a:prstGeom>
                  </p:spPr>
                </p:pic>
              </mc:Fallback>
            </mc:AlternateContent>
            <mc:AlternateContent xmlns:mc="http://schemas.openxmlformats.org/markup-compatibility/2006" xmlns:p14="http://schemas.microsoft.com/office/powerpoint/2010/main">
              <mc:Choice Requires="p14">
                <p:contentPart p14:bwMode="auto" r:id="rId17">
                  <p14:nvContentPartPr>
                    <p14:cNvPr id="1033" name="Ink 1032">
                      <a:extLst>
                        <a:ext uri="{FF2B5EF4-FFF2-40B4-BE49-F238E27FC236}">
                          <a16:creationId xmlns:a16="http://schemas.microsoft.com/office/drawing/2014/main" id="{39DE14F4-8C0C-52B2-14E7-E65918AD21ED}"/>
                        </a:ext>
                      </a:extLst>
                    </p14:cNvPr>
                    <p14:cNvContentPartPr/>
                    <p14:nvPr/>
                  </p14:nvContentPartPr>
                  <p14:xfrm>
                    <a:off x="6006145" y="1855402"/>
                    <a:ext cx="453240" cy="2187000"/>
                  </p14:xfrm>
                </p:contentPart>
              </mc:Choice>
              <mc:Fallback xmlns="">
                <p:pic>
                  <p:nvPicPr>
                    <p:cNvPr id="1033" name="Ink 1032">
                      <a:extLst>
                        <a:ext uri="{FF2B5EF4-FFF2-40B4-BE49-F238E27FC236}">
                          <a16:creationId xmlns:a16="http://schemas.microsoft.com/office/drawing/2014/main" id="{39DE14F4-8C0C-52B2-14E7-E65918AD21ED}"/>
                        </a:ext>
                      </a:extLst>
                    </p:cNvPr>
                    <p:cNvPicPr/>
                    <p:nvPr/>
                  </p:nvPicPr>
                  <p:blipFill>
                    <a:blip r:embed="rId18"/>
                    <a:stretch>
                      <a:fillRect/>
                    </a:stretch>
                  </p:blipFill>
                  <p:spPr>
                    <a:xfrm>
                      <a:off x="5939714" y="1780953"/>
                      <a:ext cx="586102" cy="2335370"/>
                    </a:xfrm>
                    <a:prstGeom prst="rect">
                      <a:avLst/>
                    </a:prstGeom>
                  </p:spPr>
                </p:pic>
              </mc:Fallback>
            </mc:AlternateContent>
            <mc:AlternateContent xmlns:mc="http://schemas.openxmlformats.org/markup-compatibility/2006" xmlns:p14="http://schemas.microsoft.com/office/powerpoint/2010/main">
              <mc:Choice Requires="p14">
                <p:contentPart p14:bwMode="auto" r:id="rId19">
                  <p14:nvContentPartPr>
                    <p14:cNvPr id="1035" name="Ink 1034">
                      <a:extLst>
                        <a:ext uri="{FF2B5EF4-FFF2-40B4-BE49-F238E27FC236}">
                          <a16:creationId xmlns:a16="http://schemas.microsoft.com/office/drawing/2014/main" id="{6805A43C-F5D7-E046-AEB7-1EB06BBCFC81}"/>
                        </a:ext>
                      </a:extLst>
                    </p14:cNvPr>
                    <p14:cNvContentPartPr/>
                    <p14:nvPr/>
                  </p14:nvContentPartPr>
                  <p14:xfrm>
                    <a:off x="6493945" y="653002"/>
                    <a:ext cx="804240" cy="721080"/>
                  </p14:xfrm>
                </p:contentPart>
              </mc:Choice>
              <mc:Fallback xmlns="">
                <p:pic>
                  <p:nvPicPr>
                    <p:cNvPr id="1035" name="Ink 1034">
                      <a:extLst>
                        <a:ext uri="{FF2B5EF4-FFF2-40B4-BE49-F238E27FC236}">
                          <a16:creationId xmlns:a16="http://schemas.microsoft.com/office/drawing/2014/main" id="{6805A43C-F5D7-E046-AEB7-1EB06BBCFC81}"/>
                        </a:ext>
                      </a:extLst>
                    </p:cNvPr>
                    <p:cNvPicPr/>
                    <p:nvPr/>
                  </p:nvPicPr>
                  <p:blipFill>
                    <a:blip r:embed="rId20"/>
                    <a:stretch>
                      <a:fillRect/>
                    </a:stretch>
                  </p:blipFill>
                  <p:spPr>
                    <a:xfrm>
                      <a:off x="6427553" y="578571"/>
                      <a:ext cx="936553" cy="869413"/>
                    </a:xfrm>
                    <a:prstGeom prst="rect">
                      <a:avLst/>
                    </a:prstGeom>
                  </p:spPr>
                </p:pic>
              </mc:Fallback>
            </mc:AlternateContent>
            <mc:AlternateContent xmlns:mc="http://schemas.openxmlformats.org/markup-compatibility/2006" xmlns:p14="http://schemas.microsoft.com/office/powerpoint/2010/main">
              <mc:Choice Requires="p14">
                <p:contentPart p14:bwMode="auto" r:id="rId21">
                  <p14:nvContentPartPr>
                    <p14:cNvPr id="1037" name="Ink 1036">
                      <a:extLst>
                        <a:ext uri="{FF2B5EF4-FFF2-40B4-BE49-F238E27FC236}">
                          <a16:creationId xmlns:a16="http://schemas.microsoft.com/office/drawing/2014/main" id="{798A6204-8091-CD9A-E345-29187BF1D31C}"/>
                        </a:ext>
                      </a:extLst>
                    </p14:cNvPr>
                    <p14:cNvContentPartPr/>
                    <p14:nvPr/>
                  </p14:nvContentPartPr>
                  <p14:xfrm>
                    <a:off x="4995265" y="678562"/>
                    <a:ext cx="772920" cy="718560"/>
                  </p14:xfrm>
                </p:contentPart>
              </mc:Choice>
              <mc:Fallback xmlns="">
                <p:pic>
                  <p:nvPicPr>
                    <p:cNvPr id="1037" name="Ink 1036">
                      <a:extLst>
                        <a:ext uri="{FF2B5EF4-FFF2-40B4-BE49-F238E27FC236}">
                          <a16:creationId xmlns:a16="http://schemas.microsoft.com/office/drawing/2014/main" id="{798A6204-8091-CD9A-E345-29187BF1D31C}"/>
                        </a:ext>
                      </a:extLst>
                    </p:cNvPr>
                    <p:cNvPicPr/>
                    <p:nvPr/>
                  </p:nvPicPr>
                  <p:blipFill>
                    <a:blip r:embed="rId22"/>
                    <a:stretch>
                      <a:fillRect/>
                    </a:stretch>
                  </p:blipFill>
                  <p:spPr>
                    <a:xfrm>
                      <a:off x="4928853" y="604119"/>
                      <a:ext cx="905273" cy="866918"/>
                    </a:xfrm>
                    <a:prstGeom prst="rect">
                      <a:avLst/>
                    </a:prstGeom>
                  </p:spPr>
                </p:pic>
              </mc:Fallback>
            </mc:AlternateContent>
            <mc:AlternateContent xmlns:mc="http://schemas.openxmlformats.org/markup-compatibility/2006" xmlns:p14="http://schemas.microsoft.com/office/powerpoint/2010/main">
              <mc:Choice Requires="p14">
                <p:contentPart p14:bwMode="auto" r:id="rId23">
                  <p14:nvContentPartPr>
                    <p14:cNvPr id="1039" name="Ink 1038">
                      <a:extLst>
                        <a:ext uri="{FF2B5EF4-FFF2-40B4-BE49-F238E27FC236}">
                          <a16:creationId xmlns:a16="http://schemas.microsoft.com/office/drawing/2014/main" id="{5BF24691-6E31-F20A-F7CA-BB6F7DF4FBAB}"/>
                        </a:ext>
                      </a:extLst>
                    </p14:cNvPr>
                    <p14:cNvContentPartPr/>
                    <p14:nvPr/>
                  </p14:nvContentPartPr>
                  <p14:xfrm>
                    <a:off x="6447145" y="1232602"/>
                    <a:ext cx="1170360" cy="661320"/>
                  </p14:xfrm>
                </p:contentPart>
              </mc:Choice>
              <mc:Fallback xmlns="">
                <p:pic>
                  <p:nvPicPr>
                    <p:cNvPr id="1039" name="Ink 1038">
                      <a:extLst>
                        <a:ext uri="{FF2B5EF4-FFF2-40B4-BE49-F238E27FC236}">
                          <a16:creationId xmlns:a16="http://schemas.microsoft.com/office/drawing/2014/main" id="{5BF24691-6E31-F20A-F7CA-BB6F7DF4FBAB}"/>
                        </a:ext>
                      </a:extLst>
                    </p:cNvPr>
                    <p:cNvPicPr/>
                    <p:nvPr/>
                  </p:nvPicPr>
                  <p:blipFill>
                    <a:blip r:embed="rId24"/>
                    <a:stretch>
                      <a:fillRect/>
                    </a:stretch>
                  </p:blipFill>
                  <p:spPr>
                    <a:xfrm>
                      <a:off x="6380738" y="1158184"/>
                      <a:ext cx="1302703" cy="809629"/>
                    </a:xfrm>
                    <a:prstGeom prst="rect">
                      <a:avLst/>
                    </a:prstGeom>
                  </p:spPr>
                </p:pic>
              </mc:Fallback>
            </mc:AlternateContent>
            <mc:AlternateContent xmlns:mc="http://schemas.openxmlformats.org/markup-compatibility/2006" xmlns:p14="http://schemas.microsoft.com/office/powerpoint/2010/main">
              <mc:Choice Requires="p14">
                <p:contentPart p14:bwMode="auto" r:id="rId25">
                  <p14:nvContentPartPr>
                    <p14:cNvPr id="1041" name="Ink 1040">
                      <a:extLst>
                        <a:ext uri="{FF2B5EF4-FFF2-40B4-BE49-F238E27FC236}">
                          <a16:creationId xmlns:a16="http://schemas.microsoft.com/office/drawing/2014/main" id="{13E67A90-A45A-75AC-7A4C-B8A9D05AEE74}"/>
                        </a:ext>
                      </a:extLst>
                    </p14:cNvPr>
                    <p14:cNvContentPartPr/>
                    <p14:nvPr/>
                  </p14:nvContentPartPr>
                  <p14:xfrm>
                    <a:off x="6500785" y="1705642"/>
                    <a:ext cx="1288080" cy="733320"/>
                  </p14:xfrm>
                </p:contentPart>
              </mc:Choice>
              <mc:Fallback xmlns="">
                <p:pic>
                  <p:nvPicPr>
                    <p:cNvPr id="1041" name="Ink 1040">
                      <a:extLst>
                        <a:ext uri="{FF2B5EF4-FFF2-40B4-BE49-F238E27FC236}">
                          <a16:creationId xmlns:a16="http://schemas.microsoft.com/office/drawing/2014/main" id="{13E67A90-A45A-75AC-7A4C-B8A9D05AEE74}"/>
                        </a:ext>
                      </a:extLst>
                    </p:cNvPr>
                    <p:cNvPicPr/>
                    <p:nvPr/>
                  </p:nvPicPr>
                  <p:blipFill>
                    <a:blip r:embed="rId26"/>
                    <a:stretch>
                      <a:fillRect/>
                    </a:stretch>
                  </p:blipFill>
                  <p:spPr>
                    <a:xfrm>
                      <a:off x="6434379" y="1631201"/>
                      <a:ext cx="1420420" cy="881673"/>
                    </a:xfrm>
                    <a:prstGeom prst="rect">
                      <a:avLst/>
                    </a:prstGeom>
                  </p:spPr>
                </p:pic>
              </mc:Fallback>
            </mc:AlternateContent>
            <mc:AlternateContent xmlns:mc="http://schemas.openxmlformats.org/markup-compatibility/2006" xmlns:p14="http://schemas.microsoft.com/office/powerpoint/2010/main">
              <mc:Choice Requires="p14">
                <p:contentPart p14:bwMode="auto" r:id="rId27">
                  <p14:nvContentPartPr>
                    <p14:cNvPr id="1043" name="Ink 1042">
                      <a:extLst>
                        <a:ext uri="{FF2B5EF4-FFF2-40B4-BE49-F238E27FC236}">
                          <a16:creationId xmlns:a16="http://schemas.microsoft.com/office/drawing/2014/main" id="{EBFCCA41-3D95-C2EE-B037-0936CA39D2F9}"/>
                        </a:ext>
                      </a:extLst>
                    </p14:cNvPr>
                    <p14:cNvContentPartPr/>
                    <p14:nvPr/>
                  </p14:nvContentPartPr>
                  <p14:xfrm>
                    <a:off x="6518065" y="2147722"/>
                    <a:ext cx="1497240" cy="856440"/>
                  </p14:xfrm>
                </p:contentPart>
              </mc:Choice>
              <mc:Fallback xmlns="">
                <p:pic>
                  <p:nvPicPr>
                    <p:cNvPr id="1043" name="Ink 1042">
                      <a:extLst>
                        <a:ext uri="{FF2B5EF4-FFF2-40B4-BE49-F238E27FC236}">
                          <a16:creationId xmlns:a16="http://schemas.microsoft.com/office/drawing/2014/main" id="{EBFCCA41-3D95-C2EE-B037-0936CA39D2F9}"/>
                        </a:ext>
                      </a:extLst>
                    </p:cNvPr>
                    <p:cNvPicPr/>
                    <p:nvPr/>
                  </p:nvPicPr>
                  <p:blipFill>
                    <a:blip r:embed="rId28"/>
                    <a:stretch>
                      <a:fillRect/>
                    </a:stretch>
                  </p:blipFill>
                  <p:spPr>
                    <a:xfrm>
                      <a:off x="6451657" y="2073272"/>
                      <a:ext cx="1629585" cy="1004812"/>
                    </a:xfrm>
                    <a:prstGeom prst="rect">
                      <a:avLst/>
                    </a:prstGeom>
                  </p:spPr>
                </p:pic>
              </mc:Fallback>
            </mc:AlternateContent>
            <mc:AlternateContent xmlns:mc="http://schemas.openxmlformats.org/markup-compatibility/2006" xmlns:p14="http://schemas.microsoft.com/office/powerpoint/2010/main">
              <mc:Choice Requires="p14">
                <p:contentPart p14:bwMode="auto" r:id="rId29">
                  <p14:nvContentPartPr>
                    <p14:cNvPr id="1044" name="Ink 1043">
                      <a:extLst>
                        <a:ext uri="{FF2B5EF4-FFF2-40B4-BE49-F238E27FC236}">
                          <a16:creationId xmlns:a16="http://schemas.microsoft.com/office/drawing/2014/main" id="{23CB9440-EA01-26A8-8BDC-6678D22FC333}"/>
                        </a:ext>
                      </a:extLst>
                    </p14:cNvPr>
                    <p14:cNvContentPartPr/>
                    <p14:nvPr/>
                  </p14:nvContentPartPr>
                  <p14:xfrm>
                    <a:off x="6478105" y="2726602"/>
                    <a:ext cx="1609920" cy="837360"/>
                  </p14:xfrm>
                </p:contentPart>
              </mc:Choice>
              <mc:Fallback xmlns="">
                <p:pic>
                  <p:nvPicPr>
                    <p:cNvPr id="1044" name="Ink 1043">
                      <a:extLst>
                        <a:ext uri="{FF2B5EF4-FFF2-40B4-BE49-F238E27FC236}">
                          <a16:creationId xmlns:a16="http://schemas.microsoft.com/office/drawing/2014/main" id="{23CB9440-EA01-26A8-8BDC-6678D22FC333}"/>
                        </a:ext>
                      </a:extLst>
                    </p:cNvPr>
                    <p:cNvPicPr/>
                    <p:nvPr/>
                  </p:nvPicPr>
                  <p:blipFill>
                    <a:blip r:embed="rId30"/>
                    <a:stretch>
                      <a:fillRect/>
                    </a:stretch>
                  </p:blipFill>
                  <p:spPr>
                    <a:xfrm>
                      <a:off x="6411692" y="2652158"/>
                      <a:ext cx="1742274" cy="985719"/>
                    </a:xfrm>
                    <a:prstGeom prst="rect">
                      <a:avLst/>
                    </a:prstGeom>
                  </p:spPr>
                </p:pic>
              </mc:Fallback>
            </mc:AlternateContent>
            <mc:AlternateContent xmlns:mc="http://schemas.openxmlformats.org/markup-compatibility/2006" xmlns:p14="http://schemas.microsoft.com/office/powerpoint/2010/main">
              <mc:Choice Requires="p14">
                <p:contentPart p14:bwMode="auto" r:id="rId31">
                  <p14:nvContentPartPr>
                    <p14:cNvPr id="1045" name="Ink 1044">
                      <a:extLst>
                        <a:ext uri="{FF2B5EF4-FFF2-40B4-BE49-F238E27FC236}">
                          <a16:creationId xmlns:a16="http://schemas.microsoft.com/office/drawing/2014/main" id="{729EEDED-C1E6-5E4D-2B0B-69C1E3B3B681}"/>
                        </a:ext>
                      </a:extLst>
                    </p14:cNvPr>
                    <p14:cNvContentPartPr/>
                    <p14:nvPr/>
                  </p14:nvContentPartPr>
                  <p14:xfrm>
                    <a:off x="4679185" y="1296322"/>
                    <a:ext cx="1182600" cy="605160"/>
                  </p14:xfrm>
                </p:contentPart>
              </mc:Choice>
              <mc:Fallback xmlns="">
                <p:pic>
                  <p:nvPicPr>
                    <p:cNvPr id="1045" name="Ink 1044">
                      <a:extLst>
                        <a:ext uri="{FF2B5EF4-FFF2-40B4-BE49-F238E27FC236}">
                          <a16:creationId xmlns:a16="http://schemas.microsoft.com/office/drawing/2014/main" id="{729EEDED-C1E6-5E4D-2B0B-69C1E3B3B681}"/>
                        </a:ext>
                      </a:extLst>
                    </p:cNvPr>
                    <p:cNvPicPr/>
                    <p:nvPr/>
                  </p:nvPicPr>
                  <p:blipFill>
                    <a:blip r:embed="rId32"/>
                    <a:stretch>
                      <a:fillRect/>
                    </a:stretch>
                  </p:blipFill>
                  <p:spPr>
                    <a:xfrm>
                      <a:off x="4612779" y="1221865"/>
                      <a:ext cx="1314942" cy="753546"/>
                    </a:xfrm>
                    <a:prstGeom prst="rect">
                      <a:avLst/>
                    </a:prstGeom>
                  </p:spPr>
                </p:pic>
              </mc:Fallback>
            </mc:AlternateContent>
            <mc:AlternateContent xmlns:mc="http://schemas.openxmlformats.org/markup-compatibility/2006" xmlns:p14="http://schemas.microsoft.com/office/powerpoint/2010/main">
              <mc:Choice Requires="p14">
                <p:contentPart p14:bwMode="auto" r:id="rId33">
                  <p14:nvContentPartPr>
                    <p14:cNvPr id="1046" name="Ink 1045">
                      <a:extLst>
                        <a:ext uri="{FF2B5EF4-FFF2-40B4-BE49-F238E27FC236}">
                          <a16:creationId xmlns:a16="http://schemas.microsoft.com/office/drawing/2014/main" id="{46BC872E-E429-0207-621C-948D0CDBFC12}"/>
                        </a:ext>
                      </a:extLst>
                    </p14:cNvPr>
                    <p14:cNvContentPartPr/>
                    <p14:nvPr/>
                  </p14:nvContentPartPr>
                  <p14:xfrm>
                    <a:off x="4515745" y="1671082"/>
                    <a:ext cx="1289880" cy="698040"/>
                  </p14:xfrm>
                </p:contentPart>
              </mc:Choice>
              <mc:Fallback xmlns="">
                <p:pic>
                  <p:nvPicPr>
                    <p:cNvPr id="1046" name="Ink 1045">
                      <a:extLst>
                        <a:ext uri="{FF2B5EF4-FFF2-40B4-BE49-F238E27FC236}">
                          <a16:creationId xmlns:a16="http://schemas.microsoft.com/office/drawing/2014/main" id="{46BC872E-E429-0207-621C-948D0CDBFC12}"/>
                        </a:ext>
                      </a:extLst>
                    </p:cNvPr>
                    <p:cNvPicPr/>
                    <p:nvPr/>
                  </p:nvPicPr>
                  <p:blipFill>
                    <a:blip r:embed="rId34"/>
                    <a:stretch>
                      <a:fillRect/>
                    </a:stretch>
                  </p:blipFill>
                  <p:spPr>
                    <a:xfrm>
                      <a:off x="4449344" y="1596631"/>
                      <a:ext cx="1422212" cy="846413"/>
                    </a:xfrm>
                    <a:prstGeom prst="rect">
                      <a:avLst/>
                    </a:prstGeom>
                  </p:spPr>
                </p:pic>
              </mc:Fallback>
            </mc:AlternateContent>
            <mc:AlternateContent xmlns:mc="http://schemas.openxmlformats.org/markup-compatibility/2006" xmlns:p14="http://schemas.microsoft.com/office/powerpoint/2010/main">
              <mc:Choice Requires="p14">
                <p:contentPart p14:bwMode="auto" r:id="rId35">
                  <p14:nvContentPartPr>
                    <p14:cNvPr id="1047" name="Ink 1046">
                      <a:extLst>
                        <a:ext uri="{FF2B5EF4-FFF2-40B4-BE49-F238E27FC236}">
                          <a16:creationId xmlns:a16="http://schemas.microsoft.com/office/drawing/2014/main" id="{149984B5-FD21-B3ED-52CE-F66158A0986E}"/>
                        </a:ext>
                      </a:extLst>
                    </p14:cNvPr>
                    <p14:cNvContentPartPr/>
                    <p14:nvPr/>
                  </p14:nvContentPartPr>
                  <p14:xfrm>
                    <a:off x="4312705" y="2116042"/>
                    <a:ext cx="1491480" cy="830880"/>
                  </p14:xfrm>
                </p:contentPart>
              </mc:Choice>
              <mc:Fallback xmlns="">
                <p:pic>
                  <p:nvPicPr>
                    <p:cNvPr id="1047" name="Ink 1046">
                      <a:extLst>
                        <a:ext uri="{FF2B5EF4-FFF2-40B4-BE49-F238E27FC236}">
                          <a16:creationId xmlns:a16="http://schemas.microsoft.com/office/drawing/2014/main" id="{149984B5-FD21-B3ED-52CE-F66158A0986E}"/>
                        </a:ext>
                      </a:extLst>
                    </p:cNvPr>
                    <p:cNvPicPr/>
                    <p:nvPr/>
                  </p:nvPicPr>
                  <p:blipFill>
                    <a:blip r:embed="rId36"/>
                    <a:stretch>
                      <a:fillRect/>
                    </a:stretch>
                  </p:blipFill>
                  <p:spPr>
                    <a:xfrm>
                      <a:off x="4246302" y="2041611"/>
                      <a:ext cx="1623815" cy="979214"/>
                    </a:xfrm>
                    <a:prstGeom prst="rect">
                      <a:avLst/>
                    </a:prstGeom>
                  </p:spPr>
                </p:pic>
              </mc:Fallback>
            </mc:AlternateContent>
            <mc:AlternateContent xmlns:mc="http://schemas.openxmlformats.org/markup-compatibility/2006" xmlns:p14="http://schemas.microsoft.com/office/powerpoint/2010/main">
              <mc:Choice Requires="p14">
                <p:contentPart p14:bwMode="auto" r:id="rId37">
                  <p14:nvContentPartPr>
                    <p14:cNvPr id="1048" name="Ink 1047">
                      <a:extLst>
                        <a:ext uri="{FF2B5EF4-FFF2-40B4-BE49-F238E27FC236}">
                          <a16:creationId xmlns:a16="http://schemas.microsoft.com/office/drawing/2014/main" id="{DD68B7DC-3D44-0CA9-57A9-ADAAEEBC066B}"/>
                        </a:ext>
                      </a:extLst>
                    </p14:cNvPr>
                    <p14:cNvContentPartPr/>
                    <p14:nvPr/>
                  </p14:nvContentPartPr>
                  <p14:xfrm>
                    <a:off x="4211185" y="2748562"/>
                    <a:ext cx="1557720" cy="763560"/>
                  </p14:xfrm>
                </p:contentPart>
              </mc:Choice>
              <mc:Fallback xmlns="">
                <p:pic>
                  <p:nvPicPr>
                    <p:cNvPr id="1048" name="Ink 1047">
                      <a:extLst>
                        <a:ext uri="{FF2B5EF4-FFF2-40B4-BE49-F238E27FC236}">
                          <a16:creationId xmlns:a16="http://schemas.microsoft.com/office/drawing/2014/main" id="{DD68B7DC-3D44-0CA9-57A9-ADAAEEBC066B}"/>
                        </a:ext>
                      </a:extLst>
                    </p:cNvPr>
                    <p:cNvPicPr/>
                    <p:nvPr/>
                  </p:nvPicPr>
                  <p:blipFill>
                    <a:blip r:embed="rId38"/>
                    <a:stretch>
                      <a:fillRect/>
                    </a:stretch>
                  </p:blipFill>
                  <p:spPr>
                    <a:xfrm>
                      <a:off x="4144769" y="2674107"/>
                      <a:ext cx="1690552" cy="911942"/>
                    </a:xfrm>
                    <a:prstGeom prst="rect">
                      <a:avLst/>
                    </a:prstGeom>
                  </p:spPr>
                </p:pic>
              </mc:Fallback>
            </mc:AlternateContent>
            <mc:AlternateContent xmlns:mc="http://schemas.openxmlformats.org/markup-compatibility/2006" xmlns:p14="http://schemas.microsoft.com/office/powerpoint/2010/main">
              <mc:Choice Requires="p14">
                <p:contentPart p14:bwMode="auto" r:id="rId39">
                  <p14:nvContentPartPr>
                    <p14:cNvPr id="1049" name="Ink 1048">
                      <a:extLst>
                        <a:ext uri="{FF2B5EF4-FFF2-40B4-BE49-F238E27FC236}">
                          <a16:creationId xmlns:a16="http://schemas.microsoft.com/office/drawing/2014/main" id="{267D7D4F-290A-42EB-F8FB-79DF30BB82F1}"/>
                        </a:ext>
                      </a:extLst>
                    </p14:cNvPr>
                    <p14:cNvContentPartPr/>
                    <p14:nvPr/>
                  </p14:nvContentPartPr>
                  <p14:xfrm>
                    <a:off x="4101745" y="3260482"/>
                    <a:ext cx="1715760" cy="768240"/>
                  </p14:xfrm>
                </p:contentPart>
              </mc:Choice>
              <mc:Fallback xmlns="">
                <p:pic>
                  <p:nvPicPr>
                    <p:cNvPr id="1049" name="Ink 1048">
                      <a:extLst>
                        <a:ext uri="{FF2B5EF4-FFF2-40B4-BE49-F238E27FC236}">
                          <a16:creationId xmlns:a16="http://schemas.microsoft.com/office/drawing/2014/main" id="{267D7D4F-290A-42EB-F8FB-79DF30BB82F1}"/>
                        </a:ext>
                      </a:extLst>
                    </p:cNvPr>
                    <p:cNvPicPr/>
                    <p:nvPr/>
                  </p:nvPicPr>
                  <p:blipFill>
                    <a:blip r:embed="rId40"/>
                    <a:stretch>
                      <a:fillRect/>
                    </a:stretch>
                  </p:blipFill>
                  <p:spPr>
                    <a:xfrm>
                      <a:off x="4035338" y="3186034"/>
                      <a:ext cx="1848104" cy="916608"/>
                    </a:xfrm>
                    <a:prstGeom prst="rect">
                      <a:avLst/>
                    </a:prstGeom>
                  </p:spPr>
                </p:pic>
              </mc:Fallback>
            </mc:AlternateContent>
            <mc:AlternateContent xmlns:mc="http://schemas.openxmlformats.org/markup-compatibility/2006" xmlns:p14="http://schemas.microsoft.com/office/powerpoint/2010/main">
              <mc:Choice Requires="p14">
                <p:contentPart p14:bwMode="auto" r:id="rId41">
                  <p14:nvContentPartPr>
                    <p14:cNvPr id="1050" name="Ink 1049">
                      <a:extLst>
                        <a:ext uri="{FF2B5EF4-FFF2-40B4-BE49-F238E27FC236}">
                          <a16:creationId xmlns:a16="http://schemas.microsoft.com/office/drawing/2014/main" id="{A8BE3FD1-E0E2-90EB-11D6-758C3A51E428}"/>
                        </a:ext>
                      </a:extLst>
                    </p14:cNvPr>
                    <p14:cNvContentPartPr/>
                    <p14:nvPr/>
                  </p14:nvContentPartPr>
                  <p14:xfrm>
                    <a:off x="4920745" y="3729202"/>
                    <a:ext cx="1047240" cy="1375560"/>
                  </p14:xfrm>
                </p:contentPart>
              </mc:Choice>
              <mc:Fallback xmlns="">
                <p:pic>
                  <p:nvPicPr>
                    <p:cNvPr id="1050" name="Ink 1049">
                      <a:extLst>
                        <a:ext uri="{FF2B5EF4-FFF2-40B4-BE49-F238E27FC236}">
                          <a16:creationId xmlns:a16="http://schemas.microsoft.com/office/drawing/2014/main" id="{A8BE3FD1-E0E2-90EB-11D6-758C3A51E428}"/>
                        </a:ext>
                      </a:extLst>
                    </p:cNvPr>
                    <p:cNvPicPr/>
                    <p:nvPr/>
                  </p:nvPicPr>
                  <p:blipFill>
                    <a:blip r:embed="rId42"/>
                    <a:stretch>
                      <a:fillRect/>
                    </a:stretch>
                  </p:blipFill>
                  <p:spPr>
                    <a:xfrm>
                      <a:off x="4854351" y="3654748"/>
                      <a:ext cx="1179558" cy="1523941"/>
                    </a:xfrm>
                    <a:prstGeom prst="rect">
                      <a:avLst/>
                    </a:prstGeom>
                  </p:spPr>
                </p:pic>
              </mc:Fallback>
            </mc:AlternateContent>
            <mc:AlternateContent xmlns:mc="http://schemas.openxmlformats.org/markup-compatibility/2006" xmlns:p14="http://schemas.microsoft.com/office/powerpoint/2010/main">
              <mc:Choice Requires="p14">
                <p:contentPart p14:bwMode="auto" r:id="rId43">
                  <p14:nvContentPartPr>
                    <p14:cNvPr id="1051" name="Ink 1050">
                      <a:extLst>
                        <a:ext uri="{FF2B5EF4-FFF2-40B4-BE49-F238E27FC236}">
                          <a16:creationId xmlns:a16="http://schemas.microsoft.com/office/drawing/2014/main" id="{55281479-E8C3-F8DC-FD74-FD1C3015F8DC}"/>
                        </a:ext>
                      </a:extLst>
                    </p14:cNvPr>
                    <p14:cNvContentPartPr/>
                    <p14:nvPr/>
                  </p14:nvContentPartPr>
                  <p14:xfrm>
                    <a:off x="4239265" y="5104762"/>
                    <a:ext cx="681480" cy="694800"/>
                  </p14:xfrm>
                </p:contentPart>
              </mc:Choice>
              <mc:Fallback xmlns="">
                <p:pic>
                  <p:nvPicPr>
                    <p:cNvPr id="1051" name="Ink 1050">
                      <a:extLst>
                        <a:ext uri="{FF2B5EF4-FFF2-40B4-BE49-F238E27FC236}">
                          <a16:creationId xmlns:a16="http://schemas.microsoft.com/office/drawing/2014/main" id="{55281479-E8C3-F8DC-FD74-FD1C3015F8DC}"/>
                        </a:ext>
                      </a:extLst>
                    </p:cNvPr>
                    <p:cNvPicPr/>
                    <p:nvPr/>
                  </p:nvPicPr>
                  <p:blipFill>
                    <a:blip r:embed="rId44"/>
                    <a:stretch>
                      <a:fillRect/>
                    </a:stretch>
                  </p:blipFill>
                  <p:spPr>
                    <a:xfrm>
                      <a:off x="4172860" y="5030319"/>
                      <a:ext cx="813820" cy="843158"/>
                    </a:xfrm>
                    <a:prstGeom prst="rect">
                      <a:avLst/>
                    </a:prstGeom>
                  </p:spPr>
                </p:pic>
              </mc:Fallback>
            </mc:AlternateContent>
            <mc:AlternateContent xmlns:mc="http://schemas.openxmlformats.org/markup-compatibility/2006" xmlns:p14="http://schemas.microsoft.com/office/powerpoint/2010/main">
              <mc:Choice Requires="p14">
                <p:contentPart p14:bwMode="auto" r:id="rId45">
                  <p14:nvContentPartPr>
                    <p14:cNvPr id="1052" name="Ink 1051">
                      <a:extLst>
                        <a:ext uri="{FF2B5EF4-FFF2-40B4-BE49-F238E27FC236}">
                          <a16:creationId xmlns:a16="http://schemas.microsoft.com/office/drawing/2014/main" id="{74BC17E1-45F4-22E0-49C4-748B1D5C77F4}"/>
                        </a:ext>
                      </a:extLst>
                    </p14:cNvPr>
                    <p14:cNvContentPartPr/>
                    <p14:nvPr/>
                  </p14:nvContentPartPr>
                  <p14:xfrm>
                    <a:off x="4178785" y="4958962"/>
                    <a:ext cx="587520" cy="480600"/>
                  </p14:xfrm>
                </p:contentPart>
              </mc:Choice>
              <mc:Fallback xmlns="">
                <p:pic>
                  <p:nvPicPr>
                    <p:cNvPr id="1052" name="Ink 1051">
                      <a:extLst>
                        <a:ext uri="{FF2B5EF4-FFF2-40B4-BE49-F238E27FC236}">
                          <a16:creationId xmlns:a16="http://schemas.microsoft.com/office/drawing/2014/main" id="{74BC17E1-45F4-22E0-49C4-748B1D5C77F4}"/>
                        </a:ext>
                      </a:extLst>
                    </p:cNvPr>
                    <p:cNvPicPr/>
                    <p:nvPr/>
                  </p:nvPicPr>
                  <p:blipFill>
                    <a:blip r:embed="rId46"/>
                    <a:stretch>
                      <a:fillRect/>
                    </a:stretch>
                  </p:blipFill>
                  <p:spPr>
                    <a:xfrm>
                      <a:off x="4112407" y="4884577"/>
                      <a:ext cx="719806" cy="628842"/>
                    </a:xfrm>
                    <a:prstGeom prst="rect">
                      <a:avLst/>
                    </a:prstGeom>
                  </p:spPr>
                </p:pic>
              </mc:Fallback>
            </mc:AlternateContent>
            <mc:AlternateContent xmlns:mc="http://schemas.openxmlformats.org/markup-compatibility/2006" xmlns:p14="http://schemas.microsoft.com/office/powerpoint/2010/main">
              <mc:Choice Requires="p14">
                <p:contentPart p14:bwMode="auto" r:id="rId47">
                  <p14:nvContentPartPr>
                    <p14:cNvPr id="1053" name="Ink 1052">
                      <a:extLst>
                        <a:ext uri="{FF2B5EF4-FFF2-40B4-BE49-F238E27FC236}">
                          <a16:creationId xmlns:a16="http://schemas.microsoft.com/office/drawing/2014/main" id="{2B67393D-A7F8-86C4-3D79-7099154F17CB}"/>
                        </a:ext>
                      </a:extLst>
                    </p14:cNvPr>
                    <p14:cNvContentPartPr/>
                    <p14:nvPr/>
                  </p14:nvContentPartPr>
                  <p14:xfrm>
                    <a:off x="4128745" y="4386562"/>
                    <a:ext cx="999720" cy="569160"/>
                  </p14:xfrm>
                </p:contentPart>
              </mc:Choice>
              <mc:Fallback xmlns="">
                <p:pic>
                  <p:nvPicPr>
                    <p:cNvPr id="1053" name="Ink 1052">
                      <a:extLst>
                        <a:ext uri="{FF2B5EF4-FFF2-40B4-BE49-F238E27FC236}">
                          <a16:creationId xmlns:a16="http://schemas.microsoft.com/office/drawing/2014/main" id="{2B67393D-A7F8-86C4-3D79-7099154F17CB}"/>
                        </a:ext>
                      </a:extLst>
                    </p:cNvPr>
                    <p:cNvPicPr/>
                    <p:nvPr/>
                  </p:nvPicPr>
                  <p:blipFill>
                    <a:blip r:embed="rId48"/>
                    <a:stretch>
                      <a:fillRect/>
                    </a:stretch>
                  </p:blipFill>
                  <p:spPr>
                    <a:xfrm>
                      <a:off x="4062317" y="4312117"/>
                      <a:ext cx="1132105" cy="717522"/>
                    </a:xfrm>
                    <a:prstGeom prst="rect">
                      <a:avLst/>
                    </a:prstGeom>
                  </p:spPr>
                </p:pic>
              </mc:Fallback>
            </mc:AlternateContent>
            <mc:AlternateContent xmlns:mc="http://schemas.openxmlformats.org/markup-compatibility/2006" xmlns:p14="http://schemas.microsoft.com/office/powerpoint/2010/main">
              <mc:Choice Requires="p14">
                <p:contentPart p14:bwMode="auto" r:id="rId49">
                  <p14:nvContentPartPr>
                    <p14:cNvPr id="1054" name="Ink 1053">
                      <a:extLst>
                        <a:ext uri="{FF2B5EF4-FFF2-40B4-BE49-F238E27FC236}">
                          <a16:creationId xmlns:a16="http://schemas.microsoft.com/office/drawing/2014/main" id="{76FDBB25-0AE6-D1F7-9C95-5B1E8D60C305}"/>
                        </a:ext>
                      </a:extLst>
                    </p14:cNvPr>
                    <p14:cNvContentPartPr/>
                    <p14:nvPr/>
                  </p14:nvContentPartPr>
                  <p14:xfrm>
                    <a:off x="4122265" y="3876442"/>
                    <a:ext cx="1384200" cy="653400"/>
                  </p14:xfrm>
                </p:contentPart>
              </mc:Choice>
              <mc:Fallback xmlns="">
                <p:pic>
                  <p:nvPicPr>
                    <p:cNvPr id="1054" name="Ink 1053">
                      <a:extLst>
                        <a:ext uri="{FF2B5EF4-FFF2-40B4-BE49-F238E27FC236}">
                          <a16:creationId xmlns:a16="http://schemas.microsoft.com/office/drawing/2014/main" id="{76FDBB25-0AE6-D1F7-9C95-5B1E8D60C305}"/>
                        </a:ext>
                      </a:extLst>
                    </p:cNvPr>
                    <p:cNvPicPr/>
                    <p:nvPr/>
                  </p:nvPicPr>
                  <p:blipFill>
                    <a:blip r:embed="rId50"/>
                    <a:stretch>
                      <a:fillRect/>
                    </a:stretch>
                  </p:blipFill>
                  <p:spPr>
                    <a:xfrm>
                      <a:off x="4055857" y="3802024"/>
                      <a:ext cx="1516544" cy="801708"/>
                    </a:xfrm>
                    <a:prstGeom prst="rect">
                      <a:avLst/>
                    </a:prstGeom>
                  </p:spPr>
                </p:pic>
              </mc:Fallback>
            </mc:AlternateContent>
            <mc:AlternateContent xmlns:mc="http://schemas.openxmlformats.org/markup-compatibility/2006" xmlns:p14="http://schemas.microsoft.com/office/powerpoint/2010/main">
              <mc:Choice Requires="p14">
                <p:contentPart p14:bwMode="auto" r:id="rId51">
                  <p14:nvContentPartPr>
                    <p14:cNvPr id="1055" name="Ink 1054">
                      <a:extLst>
                        <a:ext uri="{FF2B5EF4-FFF2-40B4-BE49-F238E27FC236}">
                          <a16:creationId xmlns:a16="http://schemas.microsoft.com/office/drawing/2014/main" id="{7CCFC400-FF99-0EB0-4348-FCF2A08DCCF3}"/>
                        </a:ext>
                      </a:extLst>
                    </p14:cNvPr>
                    <p14:cNvContentPartPr/>
                    <p14:nvPr/>
                  </p14:nvContentPartPr>
                  <p14:xfrm>
                    <a:off x="5213065" y="3848002"/>
                    <a:ext cx="358560" cy="478800"/>
                  </p14:xfrm>
                </p:contentPart>
              </mc:Choice>
              <mc:Fallback xmlns="">
                <p:pic>
                  <p:nvPicPr>
                    <p:cNvPr id="1055" name="Ink 1054">
                      <a:extLst>
                        <a:ext uri="{FF2B5EF4-FFF2-40B4-BE49-F238E27FC236}">
                          <a16:creationId xmlns:a16="http://schemas.microsoft.com/office/drawing/2014/main" id="{7CCFC400-FF99-0EB0-4348-FCF2A08DCCF3}"/>
                        </a:ext>
                      </a:extLst>
                    </p:cNvPr>
                    <p:cNvPicPr/>
                    <p:nvPr/>
                  </p:nvPicPr>
                  <p:blipFill>
                    <a:blip r:embed="rId52"/>
                    <a:stretch>
                      <a:fillRect/>
                    </a:stretch>
                  </p:blipFill>
                  <p:spPr>
                    <a:xfrm>
                      <a:off x="5146630" y="3773569"/>
                      <a:ext cx="490959" cy="627138"/>
                    </a:xfrm>
                    <a:prstGeom prst="rect">
                      <a:avLst/>
                    </a:prstGeom>
                  </p:spPr>
                </p:pic>
              </mc:Fallback>
            </mc:AlternateContent>
            <mc:AlternateContent xmlns:mc="http://schemas.openxmlformats.org/markup-compatibility/2006" xmlns:p14="http://schemas.microsoft.com/office/powerpoint/2010/main">
              <mc:Choice Requires="p14">
                <p:contentPart p14:bwMode="auto" r:id="rId53">
                  <p14:nvContentPartPr>
                    <p14:cNvPr id="1056" name="Ink 1055">
                      <a:extLst>
                        <a:ext uri="{FF2B5EF4-FFF2-40B4-BE49-F238E27FC236}">
                          <a16:creationId xmlns:a16="http://schemas.microsoft.com/office/drawing/2014/main" id="{A4ED0B24-3192-3931-D9B5-89EFCA988BD4}"/>
                        </a:ext>
                      </a:extLst>
                    </p14:cNvPr>
                    <p14:cNvContentPartPr/>
                    <p14:nvPr/>
                  </p14:nvContentPartPr>
                  <p14:xfrm>
                    <a:off x="5499265" y="3639922"/>
                    <a:ext cx="300240" cy="259560"/>
                  </p14:xfrm>
                </p:contentPart>
              </mc:Choice>
              <mc:Fallback xmlns="">
                <p:pic>
                  <p:nvPicPr>
                    <p:cNvPr id="1056" name="Ink 1055">
                      <a:extLst>
                        <a:ext uri="{FF2B5EF4-FFF2-40B4-BE49-F238E27FC236}">
                          <a16:creationId xmlns:a16="http://schemas.microsoft.com/office/drawing/2014/main" id="{A4ED0B24-3192-3931-D9B5-89EFCA988BD4}"/>
                        </a:ext>
                      </a:extLst>
                    </p:cNvPr>
                    <p:cNvPicPr/>
                    <p:nvPr/>
                  </p:nvPicPr>
                  <p:blipFill>
                    <a:blip r:embed="rId54"/>
                    <a:stretch>
                      <a:fillRect/>
                    </a:stretch>
                  </p:blipFill>
                  <p:spPr>
                    <a:xfrm>
                      <a:off x="5432807" y="3565536"/>
                      <a:ext cx="432685" cy="407805"/>
                    </a:xfrm>
                    <a:prstGeom prst="rect">
                      <a:avLst/>
                    </a:prstGeom>
                  </p:spPr>
                </p:pic>
              </mc:Fallback>
            </mc:AlternateContent>
            <mc:AlternateContent xmlns:mc="http://schemas.openxmlformats.org/markup-compatibility/2006" xmlns:p14="http://schemas.microsoft.com/office/powerpoint/2010/main">
              <mc:Choice Requires="p14">
                <p:contentPart p14:bwMode="auto" r:id="rId55">
                  <p14:nvContentPartPr>
                    <p14:cNvPr id="1057" name="Ink 1056">
                      <a:extLst>
                        <a:ext uri="{FF2B5EF4-FFF2-40B4-BE49-F238E27FC236}">
                          <a16:creationId xmlns:a16="http://schemas.microsoft.com/office/drawing/2014/main" id="{BE045E1D-7552-E341-6DA7-D11C11ECC87A}"/>
                        </a:ext>
                      </a:extLst>
                    </p14:cNvPr>
                    <p14:cNvContentPartPr/>
                    <p14:nvPr/>
                  </p14:nvContentPartPr>
                  <p14:xfrm>
                    <a:off x="6441025" y="3191722"/>
                    <a:ext cx="1705320" cy="897120"/>
                  </p14:xfrm>
                </p:contentPart>
              </mc:Choice>
              <mc:Fallback xmlns="">
                <p:pic>
                  <p:nvPicPr>
                    <p:cNvPr id="1057" name="Ink 1056">
                      <a:extLst>
                        <a:ext uri="{FF2B5EF4-FFF2-40B4-BE49-F238E27FC236}">
                          <a16:creationId xmlns:a16="http://schemas.microsoft.com/office/drawing/2014/main" id="{BE045E1D-7552-E341-6DA7-D11C11ECC87A}"/>
                        </a:ext>
                      </a:extLst>
                    </p:cNvPr>
                    <p:cNvPicPr/>
                    <p:nvPr/>
                  </p:nvPicPr>
                  <p:blipFill>
                    <a:blip r:embed="rId56"/>
                    <a:stretch>
                      <a:fillRect/>
                    </a:stretch>
                  </p:blipFill>
                  <p:spPr>
                    <a:xfrm>
                      <a:off x="6374621" y="3117270"/>
                      <a:ext cx="1837658" cy="1045496"/>
                    </a:xfrm>
                    <a:prstGeom prst="rect">
                      <a:avLst/>
                    </a:prstGeom>
                  </p:spPr>
                </p:pic>
              </mc:Fallback>
            </mc:AlternateContent>
            <mc:AlternateContent xmlns:mc="http://schemas.openxmlformats.org/markup-compatibility/2006" xmlns:p14="http://schemas.microsoft.com/office/powerpoint/2010/main">
              <mc:Choice Requires="p14">
                <p:contentPart p14:bwMode="auto" r:id="rId57">
                  <p14:nvContentPartPr>
                    <p14:cNvPr id="1058" name="Ink 1057">
                      <a:extLst>
                        <a:ext uri="{FF2B5EF4-FFF2-40B4-BE49-F238E27FC236}">
                          <a16:creationId xmlns:a16="http://schemas.microsoft.com/office/drawing/2014/main" id="{222BA941-964E-AC78-CE1D-F35CF3745DAF}"/>
                        </a:ext>
                      </a:extLst>
                    </p14:cNvPr>
                    <p14:cNvContentPartPr/>
                    <p14:nvPr/>
                  </p14:nvContentPartPr>
                  <p14:xfrm>
                    <a:off x="6353185" y="3780682"/>
                    <a:ext cx="1159200" cy="1837800"/>
                  </p14:xfrm>
                </p:contentPart>
              </mc:Choice>
              <mc:Fallback xmlns="">
                <p:pic>
                  <p:nvPicPr>
                    <p:cNvPr id="1058" name="Ink 1057">
                      <a:extLst>
                        <a:ext uri="{FF2B5EF4-FFF2-40B4-BE49-F238E27FC236}">
                          <a16:creationId xmlns:a16="http://schemas.microsoft.com/office/drawing/2014/main" id="{222BA941-964E-AC78-CE1D-F35CF3745DAF}"/>
                        </a:ext>
                      </a:extLst>
                    </p:cNvPr>
                    <p:cNvPicPr/>
                    <p:nvPr/>
                  </p:nvPicPr>
                  <p:blipFill>
                    <a:blip r:embed="rId58"/>
                    <a:stretch>
                      <a:fillRect/>
                    </a:stretch>
                  </p:blipFill>
                  <p:spPr>
                    <a:xfrm>
                      <a:off x="6286770" y="3706219"/>
                      <a:ext cx="1291559" cy="1986725"/>
                    </a:xfrm>
                    <a:prstGeom prst="rect">
                      <a:avLst/>
                    </a:prstGeom>
                  </p:spPr>
                </p:pic>
              </mc:Fallback>
            </mc:AlternateContent>
            <mc:AlternateContent xmlns:mc="http://schemas.openxmlformats.org/markup-compatibility/2006" xmlns:p14="http://schemas.microsoft.com/office/powerpoint/2010/main">
              <mc:Choice Requires="p14">
                <p:contentPart p14:bwMode="auto" r:id="rId59">
                  <p14:nvContentPartPr>
                    <p14:cNvPr id="1059" name="Ink 1058">
                      <a:extLst>
                        <a:ext uri="{FF2B5EF4-FFF2-40B4-BE49-F238E27FC236}">
                          <a16:creationId xmlns:a16="http://schemas.microsoft.com/office/drawing/2014/main" id="{8B4B1C5B-1B70-64F1-14F8-7366C8AAF7C5}"/>
                        </a:ext>
                      </a:extLst>
                    </p14:cNvPr>
                    <p14:cNvContentPartPr/>
                    <p14:nvPr/>
                  </p14:nvContentPartPr>
                  <p14:xfrm>
                    <a:off x="7512385" y="5585362"/>
                    <a:ext cx="540720" cy="256680"/>
                  </p14:xfrm>
                </p:contentPart>
              </mc:Choice>
              <mc:Fallback xmlns="">
                <p:pic>
                  <p:nvPicPr>
                    <p:cNvPr id="1059" name="Ink 1058">
                      <a:extLst>
                        <a:ext uri="{FF2B5EF4-FFF2-40B4-BE49-F238E27FC236}">
                          <a16:creationId xmlns:a16="http://schemas.microsoft.com/office/drawing/2014/main" id="{8B4B1C5B-1B70-64F1-14F8-7366C8AAF7C5}"/>
                        </a:ext>
                      </a:extLst>
                    </p:cNvPr>
                    <p:cNvPicPr/>
                    <p:nvPr/>
                  </p:nvPicPr>
                  <p:blipFill>
                    <a:blip r:embed="rId60"/>
                    <a:stretch>
                      <a:fillRect/>
                    </a:stretch>
                  </p:blipFill>
                  <p:spPr>
                    <a:xfrm>
                      <a:off x="7445973" y="5510893"/>
                      <a:ext cx="673074" cy="405618"/>
                    </a:xfrm>
                    <a:prstGeom prst="rect">
                      <a:avLst/>
                    </a:prstGeom>
                  </p:spPr>
                </p:pic>
              </mc:Fallback>
            </mc:AlternateContent>
            <mc:AlternateContent xmlns:mc="http://schemas.openxmlformats.org/markup-compatibility/2006" xmlns:p14="http://schemas.microsoft.com/office/powerpoint/2010/main">
              <mc:Choice Requires="p14">
                <p:contentPart p14:bwMode="auto" r:id="rId61">
                  <p14:nvContentPartPr>
                    <p14:cNvPr id="1060" name="Ink 1059">
                      <a:extLst>
                        <a:ext uri="{FF2B5EF4-FFF2-40B4-BE49-F238E27FC236}">
                          <a16:creationId xmlns:a16="http://schemas.microsoft.com/office/drawing/2014/main" id="{8C076040-2634-EBE8-FF3D-2592D58A4CD4}"/>
                        </a:ext>
                      </a:extLst>
                    </p14:cNvPr>
                    <p14:cNvContentPartPr/>
                    <p14:nvPr/>
                  </p14:nvContentPartPr>
                  <p14:xfrm>
                    <a:off x="7402945" y="4954282"/>
                    <a:ext cx="711000" cy="447480"/>
                  </p14:xfrm>
                </p:contentPart>
              </mc:Choice>
              <mc:Fallback xmlns="">
                <p:pic>
                  <p:nvPicPr>
                    <p:cNvPr id="1060" name="Ink 1059">
                      <a:extLst>
                        <a:ext uri="{FF2B5EF4-FFF2-40B4-BE49-F238E27FC236}">
                          <a16:creationId xmlns:a16="http://schemas.microsoft.com/office/drawing/2014/main" id="{8C076040-2634-EBE8-FF3D-2592D58A4CD4}"/>
                        </a:ext>
                      </a:extLst>
                    </p:cNvPr>
                    <p:cNvPicPr/>
                    <p:nvPr/>
                  </p:nvPicPr>
                  <p:blipFill>
                    <a:blip r:embed="rId62"/>
                    <a:stretch>
                      <a:fillRect/>
                    </a:stretch>
                  </p:blipFill>
                  <p:spPr>
                    <a:xfrm>
                      <a:off x="7336554" y="4879878"/>
                      <a:ext cx="843312" cy="595761"/>
                    </a:xfrm>
                    <a:prstGeom prst="rect">
                      <a:avLst/>
                    </a:prstGeom>
                  </p:spPr>
                </p:pic>
              </mc:Fallback>
            </mc:AlternateContent>
            <mc:AlternateContent xmlns:mc="http://schemas.openxmlformats.org/markup-compatibility/2006" xmlns:p14="http://schemas.microsoft.com/office/powerpoint/2010/main">
              <mc:Choice Requires="p14">
                <p:contentPart p14:bwMode="auto" r:id="rId63">
                  <p14:nvContentPartPr>
                    <p14:cNvPr id="1061" name="Ink 1060">
                      <a:extLst>
                        <a:ext uri="{FF2B5EF4-FFF2-40B4-BE49-F238E27FC236}">
                          <a16:creationId xmlns:a16="http://schemas.microsoft.com/office/drawing/2014/main" id="{7460FE4B-493A-6D01-6082-340D2E53E596}"/>
                        </a:ext>
                      </a:extLst>
                    </p14:cNvPr>
                    <p14:cNvContentPartPr/>
                    <p14:nvPr/>
                  </p14:nvContentPartPr>
                  <p14:xfrm>
                    <a:off x="6966265" y="4418962"/>
                    <a:ext cx="1194840" cy="561960"/>
                  </p14:xfrm>
                </p:contentPart>
              </mc:Choice>
              <mc:Fallback xmlns="">
                <p:pic>
                  <p:nvPicPr>
                    <p:cNvPr id="1061" name="Ink 1060">
                      <a:extLst>
                        <a:ext uri="{FF2B5EF4-FFF2-40B4-BE49-F238E27FC236}">
                          <a16:creationId xmlns:a16="http://schemas.microsoft.com/office/drawing/2014/main" id="{7460FE4B-493A-6D01-6082-340D2E53E596}"/>
                        </a:ext>
                      </a:extLst>
                    </p:cNvPr>
                    <p:cNvPicPr/>
                    <p:nvPr/>
                  </p:nvPicPr>
                  <p:blipFill>
                    <a:blip r:embed="rId64"/>
                    <a:stretch>
                      <a:fillRect/>
                    </a:stretch>
                  </p:blipFill>
                  <p:spPr>
                    <a:xfrm>
                      <a:off x="6899859" y="4344492"/>
                      <a:ext cx="1327181" cy="710901"/>
                    </a:xfrm>
                    <a:prstGeom prst="rect">
                      <a:avLst/>
                    </a:prstGeom>
                  </p:spPr>
                </p:pic>
              </mc:Fallback>
            </mc:AlternateContent>
            <mc:AlternateContent xmlns:mc="http://schemas.openxmlformats.org/markup-compatibility/2006" xmlns:p14="http://schemas.microsoft.com/office/powerpoint/2010/main">
              <mc:Choice Requires="p14">
                <p:contentPart p14:bwMode="auto" r:id="rId65">
                  <p14:nvContentPartPr>
                    <p14:cNvPr id="1062" name="Ink 1061">
                      <a:extLst>
                        <a:ext uri="{FF2B5EF4-FFF2-40B4-BE49-F238E27FC236}">
                          <a16:creationId xmlns:a16="http://schemas.microsoft.com/office/drawing/2014/main" id="{A09E4D82-DAD5-143A-23D9-DA814879F85B}"/>
                        </a:ext>
                      </a:extLst>
                    </p14:cNvPr>
                    <p14:cNvContentPartPr/>
                    <p14:nvPr/>
                  </p14:nvContentPartPr>
                  <p14:xfrm>
                    <a:off x="6650905" y="3901642"/>
                    <a:ext cx="1502280" cy="675360"/>
                  </p14:xfrm>
                </p:contentPart>
              </mc:Choice>
              <mc:Fallback xmlns="">
                <p:pic>
                  <p:nvPicPr>
                    <p:cNvPr id="1062" name="Ink 1061">
                      <a:extLst>
                        <a:ext uri="{FF2B5EF4-FFF2-40B4-BE49-F238E27FC236}">
                          <a16:creationId xmlns:a16="http://schemas.microsoft.com/office/drawing/2014/main" id="{A09E4D82-DAD5-143A-23D9-DA814879F85B}"/>
                        </a:ext>
                      </a:extLst>
                    </p:cNvPr>
                    <p:cNvPicPr/>
                    <p:nvPr/>
                  </p:nvPicPr>
                  <p:blipFill>
                    <a:blip r:embed="rId66"/>
                    <a:stretch>
                      <a:fillRect/>
                    </a:stretch>
                  </p:blipFill>
                  <p:spPr>
                    <a:xfrm>
                      <a:off x="6584503" y="3827189"/>
                      <a:ext cx="1634613" cy="823739"/>
                    </a:xfrm>
                    <a:prstGeom prst="rect">
                      <a:avLst/>
                    </a:prstGeom>
                  </p:spPr>
                </p:pic>
              </mc:Fallback>
            </mc:AlternateContent>
            <mc:AlternateContent xmlns:mc="http://schemas.openxmlformats.org/markup-compatibility/2006" xmlns:p14="http://schemas.microsoft.com/office/powerpoint/2010/main">
              <mc:Choice Requires="p14">
                <p:contentPart p14:bwMode="auto" r:id="rId67">
                  <p14:nvContentPartPr>
                    <p14:cNvPr id="1063" name="Ink 1062">
                      <a:extLst>
                        <a:ext uri="{FF2B5EF4-FFF2-40B4-BE49-F238E27FC236}">
                          <a16:creationId xmlns:a16="http://schemas.microsoft.com/office/drawing/2014/main" id="{BF118777-726B-6C7C-8D9B-5A32B35E6198}"/>
                        </a:ext>
                      </a:extLst>
                    </p14:cNvPr>
                    <p14:cNvContentPartPr/>
                    <p14:nvPr/>
                  </p14:nvContentPartPr>
                  <p14:xfrm>
                    <a:off x="6717505" y="3985162"/>
                    <a:ext cx="420840" cy="465480"/>
                  </p14:xfrm>
                </p:contentPart>
              </mc:Choice>
              <mc:Fallback xmlns="">
                <p:pic>
                  <p:nvPicPr>
                    <p:cNvPr id="1063" name="Ink 1062">
                      <a:extLst>
                        <a:ext uri="{FF2B5EF4-FFF2-40B4-BE49-F238E27FC236}">
                          <a16:creationId xmlns:a16="http://schemas.microsoft.com/office/drawing/2014/main" id="{BF118777-726B-6C7C-8D9B-5A32B35E6198}"/>
                        </a:ext>
                      </a:extLst>
                    </p:cNvPr>
                    <p:cNvPicPr/>
                    <p:nvPr/>
                  </p:nvPicPr>
                  <p:blipFill>
                    <a:blip r:embed="rId68"/>
                    <a:stretch>
                      <a:fillRect/>
                    </a:stretch>
                  </p:blipFill>
                  <p:spPr>
                    <a:xfrm>
                      <a:off x="6651057" y="3910749"/>
                      <a:ext cx="553266" cy="613779"/>
                    </a:xfrm>
                    <a:prstGeom prst="rect">
                      <a:avLst/>
                    </a:prstGeom>
                  </p:spPr>
                </p:pic>
              </mc:Fallback>
            </mc:AlternateContent>
          </p:grpSp>
          <mc:AlternateContent xmlns:mc="http://schemas.openxmlformats.org/markup-compatibility/2006" xmlns:p14="http://schemas.microsoft.com/office/powerpoint/2010/main">
            <mc:Choice Requires="p14">
              <p:contentPart p14:bwMode="auto" r:id="rId69">
                <p14:nvContentPartPr>
                  <p14:cNvPr id="1064" name="Ink 1063">
                    <a:extLst>
                      <a:ext uri="{FF2B5EF4-FFF2-40B4-BE49-F238E27FC236}">
                        <a16:creationId xmlns:a16="http://schemas.microsoft.com/office/drawing/2014/main" id="{6F3C8A50-1EE7-E927-B730-4EBCC5DCD144}"/>
                      </a:ext>
                    </a:extLst>
                  </p14:cNvPr>
                  <p14:cNvContentPartPr/>
                  <p14:nvPr/>
                </p14:nvContentPartPr>
                <p14:xfrm>
                  <a:off x="2075514" y="481282"/>
                  <a:ext cx="452160" cy="1652040"/>
                </p14:xfrm>
              </p:contentPart>
            </mc:Choice>
            <mc:Fallback xmlns="">
              <p:pic>
                <p:nvPicPr>
                  <p:cNvPr id="1064" name="Ink 1063">
                    <a:extLst>
                      <a:ext uri="{FF2B5EF4-FFF2-40B4-BE49-F238E27FC236}">
                        <a16:creationId xmlns:a16="http://schemas.microsoft.com/office/drawing/2014/main" id="{6F3C8A50-1EE7-E927-B730-4EBCC5DCD144}"/>
                      </a:ext>
                    </a:extLst>
                  </p:cNvPr>
                  <p:cNvPicPr/>
                  <p:nvPr/>
                </p:nvPicPr>
                <p:blipFill>
                  <a:blip r:embed="rId70"/>
                  <a:stretch>
                    <a:fillRect/>
                  </a:stretch>
                </p:blipFill>
                <p:spPr>
                  <a:xfrm>
                    <a:off x="2018299" y="416138"/>
                    <a:ext cx="566263" cy="1781955"/>
                  </a:xfrm>
                  <a:prstGeom prst="rect">
                    <a:avLst/>
                  </a:prstGeom>
                </p:spPr>
              </p:pic>
            </mc:Fallback>
          </mc:AlternateContent>
        </p:grpSp>
        <mc:AlternateContent xmlns:mc="http://schemas.openxmlformats.org/markup-compatibility/2006" xmlns:p14="http://schemas.microsoft.com/office/powerpoint/2010/main">
          <mc:Choice Requires="p14">
            <p:contentPart p14:bwMode="auto" r:id="rId71">
              <p14:nvContentPartPr>
                <p14:cNvPr id="1067" name="Ink 1066">
                  <a:extLst>
                    <a:ext uri="{FF2B5EF4-FFF2-40B4-BE49-F238E27FC236}">
                      <a16:creationId xmlns:a16="http://schemas.microsoft.com/office/drawing/2014/main" id="{21AD111D-71CC-473B-F7C3-7040358E8E25}"/>
                    </a:ext>
                  </a:extLst>
                </p14:cNvPr>
                <p14:cNvContentPartPr/>
                <p14:nvPr/>
              </p14:nvContentPartPr>
              <p14:xfrm>
                <a:off x="1975434" y="632122"/>
                <a:ext cx="507600" cy="1271520"/>
              </p14:xfrm>
            </p:contentPart>
          </mc:Choice>
          <mc:Fallback xmlns="">
            <p:pic>
              <p:nvPicPr>
                <p:cNvPr id="1067" name="Ink 1066">
                  <a:extLst>
                    <a:ext uri="{FF2B5EF4-FFF2-40B4-BE49-F238E27FC236}">
                      <a16:creationId xmlns:a16="http://schemas.microsoft.com/office/drawing/2014/main" id="{21AD111D-71CC-473B-F7C3-7040358E8E25}"/>
                    </a:ext>
                  </a:extLst>
                </p:cNvPr>
                <p:cNvPicPr/>
                <p:nvPr/>
              </p:nvPicPr>
              <p:blipFill>
                <a:blip r:embed="rId72"/>
                <a:stretch>
                  <a:fillRect/>
                </a:stretch>
              </p:blipFill>
              <p:spPr>
                <a:xfrm>
                  <a:off x="1911153" y="574624"/>
                  <a:ext cx="636532" cy="1386187"/>
                </a:xfrm>
                <a:prstGeom prst="rect">
                  <a:avLst/>
                </a:prstGeom>
              </p:spPr>
            </p:pic>
          </mc:Fallback>
        </mc:AlternateContent>
      </p:grpSp>
      <p:sp>
        <p:nvSpPr>
          <p:cNvPr id="1072" name="Block Arc 1071">
            <a:extLst>
              <a:ext uri="{FF2B5EF4-FFF2-40B4-BE49-F238E27FC236}">
                <a16:creationId xmlns:a16="http://schemas.microsoft.com/office/drawing/2014/main" id="{1A6BB81C-ED88-A514-FBE5-186065759D49}"/>
              </a:ext>
            </a:extLst>
          </p:cNvPr>
          <p:cNvSpPr/>
          <p:nvPr/>
        </p:nvSpPr>
        <p:spPr>
          <a:xfrm rot="17074548">
            <a:off x="3595928" y="2634489"/>
            <a:ext cx="1552852" cy="870149"/>
          </a:xfrm>
          <a:prstGeom prst="blockArc">
            <a:avLst>
              <a:gd name="adj1" fmla="val 10800000"/>
              <a:gd name="adj2" fmla="val 6"/>
              <a:gd name="adj3" fmla="val 26334"/>
            </a:avLst>
          </a:prstGeom>
          <a:effectLst>
            <a:softEdge rad="635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71" name="Block Arc 1070">
            <a:extLst>
              <a:ext uri="{FF2B5EF4-FFF2-40B4-BE49-F238E27FC236}">
                <a16:creationId xmlns:a16="http://schemas.microsoft.com/office/drawing/2014/main" id="{667E5F83-872A-6FAD-CAE3-00F086E50CEC}"/>
              </a:ext>
            </a:extLst>
          </p:cNvPr>
          <p:cNvSpPr/>
          <p:nvPr/>
        </p:nvSpPr>
        <p:spPr>
          <a:xfrm rot="17074548">
            <a:off x="4162508" y="2751999"/>
            <a:ext cx="1241095" cy="870149"/>
          </a:xfrm>
          <a:prstGeom prst="blockArc">
            <a:avLst>
              <a:gd name="adj1" fmla="val 10800000"/>
              <a:gd name="adj2" fmla="val 6"/>
              <a:gd name="adj3" fmla="val 26334"/>
            </a:avLst>
          </a:prstGeom>
          <a:effectLst>
            <a:softEdge rad="635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1073" name="Picture 1072">
            <a:extLst>
              <a:ext uri="{FF2B5EF4-FFF2-40B4-BE49-F238E27FC236}">
                <a16:creationId xmlns:a16="http://schemas.microsoft.com/office/drawing/2014/main" id="{9840C8D2-6B77-ADD6-825E-29EC40882016}"/>
              </a:ext>
            </a:extLst>
          </p:cNvPr>
          <p:cNvPicPr>
            <a:picLocks noChangeAspect="1"/>
          </p:cNvPicPr>
          <p:nvPr/>
        </p:nvPicPr>
        <p:blipFill>
          <a:blip r:embed="rId73"/>
          <a:stretch>
            <a:fillRect/>
          </a:stretch>
        </p:blipFill>
        <p:spPr>
          <a:xfrm>
            <a:off x="6787866" y="1729300"/>
            <a:ext cx="4093591" cy="2894578"/>
          </a:xfrm>
          <a:prstGeom prst="rect">
            <a:avLst/>
          </a:prstGeom>
        </p:spPr>
      </p:pic>
      <p:sp>
        <p:nvSpPr>
          <p:cNvPr id="1070" name="Block Arc 1069">
            <a:extLst>
              <a:ext uri="{FF2B5EF4-FFF2-40B4-BE49-F238E27FC236}">
                <a16:creationId xmlns:a16="http://schemas.microsoft.com/office/drawing/2014/main" id="{236D8058-EB83-34D6-CB19-F818399BF775}"/>
              </a:ext>
            </a:extLst>
          </p:cNvPr>
          <p:cNvSpPr/>
          <p:nvPr/>
        </p:nvSpPr>
        <p:spPr>
          <a:xfrm rot="17074548">
            <a:off x="4614308" y="2881630"/>
            <a:ext cx="1012634" cy="870149"/>
          </a:xfrm>
          <a:prstGeom prst="blockArc">
            <a:avLst>
              <a:gd name="adj1" fmla="val 10800000"/>
              <a:gd name="adj2" fmla="val 6"/>
              <a:gd name="adj3" fmla="val 26334"/>
            </a:avLst>
          </a:prstGeom>
          <a:effectLst>
            <a:softEdge rad="635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mc:AlternateContent xmlns:mc="http://schemas.openxmlformats.org/markup-compatibility/2006" xmlns:p14="http://schemas.microsoft.com/office/powerpoint/2010/main">
        <mc:Choice Requires="p14">
          <p:contentPart p14:bwMode="auto" r:id="rId74">
            <p14:nvContentPartPr>
              <p14:cNvPr id="9" name="Ink 8">
                <a:extLst>
                  <a:ext uri="{FF2B5EF4-FFF2-40B4-BE49-F238E27FC236}">
                    <a16:creationId xmlns:a16="http://schemas.microsoft.com/office/drawing/2014/main" id="{9499AA95-1659-05B4-2161-4579A2EB6B70}"/>
                  </a:ext>
                </a:extLst>
              </p14:cNvPr>
              <p14:cNvContentPartPr/>
              <p14:nvPr/>
            </p14:nvContentPartPr>
            <p14:xfrm>
              <a:off x="8588126" y="2679394"/>
              <a:ext cx="1458360" cy="1132920"/>
            </p14:xfrm>
          </p:contentPart>
        </mc:Choice>
        <mc:Fallback xmlns="">
          <p:pic>
            <p:nvPicPr>
              <p:cNvPr id="9" name="Ink 8">
                <a:extLst>
                  <a:ext uri="{FF2B5EF4-FFF2-40B4-BE49-F238E27FC236}">
                    <a16:creationId xmlns:a16="http://schemas.microsoft.com/office/drawing/2014/main" id="{9499AA95-1659-05B4-2161-4579A2EB6B70}"/>
                  </a:ext>
                </a:extLst>
              </p:cNvPr>
              <p:cNvPicPr/>
              <p:nvPr/>
            </p:nvPicPr>
            <p:blipFill>
              <a:blip r:embed="rId75"/>
              <a:stretch>
                <a:fillRect/>
              </a:stretch>
            </p:blipFill>
            <p:spPr>
              <a:xfrm>
                <a:off x="8570126" y="2661754"/>
                <a:ext cx="1494000" cy="1168560"/>
              </a:xfrm>
              <a:prstGeom prst="rect">
                <a:avLst/>
              </a:prstGeom>
            </p:spPr>
          </p:pic>
        </mc:Fallback>
      </mc:AlternateContent>
      <p:sp>
        <p:nvSpPr>
          <p:cNvPr id="10" name="Rectangle: Top Corners Snipped 4">
            <a:extLst>
              <a:ext uri="{FF2B5EF4-FFF2-40B4-BE49-F238E27FC236}">
                <a16:creationId xmlns:a16="http://schemas.microsoft.com/office/drawing/2014/main" id="{7BCE6ACF-E4A7-0972-A49B-1DFCC89D80C5}"/>
              </a:ext>
            </a:extLst>
          </p:cNvPr>
          <p:cNvSpPr/>
          <p:nvPr/>
        </p:nvSpPr>
        <p:spPr>
          <a:xfrm rot="10800000">
            <a:off x="8518276" y="387562"/>
            <a:ext cx="804246" cy="1341472"/>
          </a:xfrm>
          <a:prstGeom prst="snip2SameRect">
            <a:avLst/>
          </a:prstGeom>
          <a:solidFill>
            <a:schemeClr val="tx1">
              <a:lumMod val="65000"/>
              <a:lumOff val="35000"/>
            </a:schemeClr>
          </a:solidFill>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mc:AlternateContent xmlns:mc="http://schemas.openxmlformats.org/markup-compatibility/2006" xmlns:p14="http://schemas.microsoft.com/office/powerpoint/2010/main">
        <mc:Choice Requires="p14">
          <p:contentPart p14:bwMode="auto" r:id="rId76">
            <p14:nvContentPartPr>
              <p14:cNvPr id="12" name="Ink 11">
                <a:extLst>
                  <a:ext uri="{FF2B5EF4-FFF2-40B4-BE49-F238E27FC236}">
                    <a16:creationId xmlns:a16="http://schemas.microsoft.com/office/drawing/2014/main" id="{F6B79AF0-7EF6-E18D-B720-C028FF1980EA}"/>
                  </a:ext>
                </a:extLst>
              </p14:cNvPr>
              <p14:cNvContentPartPr/>
              <p14:nvPr/>
            </p14:nvContentPartPr>
            <p14:xfrm>
              <a:off x="8027966" y="2374474"/>
              <a:ext cx="1203840" cy="1116360"/>
            </p14:xfrm>
          </p:contentPart>
        </mc:Choice>
        <mc:Fallback xmlns="">
          <p:pic>
            <p:nvPicPr>
              <p:cNvPr id="12" name="Ink 11">
                <a:extLst>
                  <a:ext uri="{FF2B5EF4-FFF2-40B4-BE49-F238E27FC236}">
                    <a16:creationId xmlns:a16="http://schemas.microsoft.com/office/drawing/2014/main" id="{F6B79AF0-7EF6-E18D-B720-C028FF1980EA}"/>
                  </a:ext>
                </a:extLst>
              </p:cNvPr>
              <p:cNvPicPr/>
              <p:nvPr/>
            </p:nvPicPr>
            <p:blipFill>
              <a:blip r:embed="rId77"/>
              <a:stretch>
                <a:fillRect/>
              </a:stretch>
            </p:blipFill>
            <p:spPr>
              <a:xfrm>
                <a:off x="8009966" y="2356834"/>
                <a:ext cx="1239480" cy="1152000"/>
              </a:xfrm>
              <a:prstGeom prst="rect">
                <a:avLst/>
              </a:prstGeom>
            </p:spPr>
          </p:pic>
        </mc:Fallback>
      </mc:AlternateContent>
      <p:grpSp>
        <p:nvGrpSpPr>
          <p:cNvPr id="14" name="Group 13">
            <a:extLst>
              <a:ext uri="{FF2B5EF4-FFF2-40B4-BE49-F238E27FC236}">
                <a16:creationId xmlns:a16="http://schemas.microsoft.com/office/drawing/2014/main" id="{9BEA310F-8F9F-36CC-CE54-7606EA73277B}"/>
              </a:ext>
            </a:extLst>
          </p:cNvPr>
          <p:cNvGrpSpPr/>
          <p:nvPr/>
        </p:nvGrpSpPr>
        <p:grpSpPr>
          <a:xfrm>
            <a:off x="5052989" y="3238864"/>
            <a:ext cx="843265" cy="423981"/>
            <a:chOff x="5052989" y="3238864"/>
            <a:chExt cx="843265" cy="423981"/>
          </a:xfrm>
        </p:grpSpPr>
        <p:sp>
          <p:nvSpPr>
            <p:cNvPr id="1069" name="Rectangle: Top Corners Snipped 4">
              <a:extLst>
                <a:ext uri="{FF2B5EF4-FFF2-40B4-BE49-F238E27FC236}">
                  <a16:creationId xmlns:a16="http://schemas.microsoft.com/office/drawing/2014/main" id="{2488A876-705F-EAC6-3950-35331124C7B9}"/>
                </a:ext>
              </a:extLst>
            </p:cNvPr>
            <p:cNvSpPr/>
            <p:nvPr/>
          </p:nvSpPr>
          <p:spPr>
            <a:xfrm rot="17074548">
              <a:off x="5282074" y="3048665"/>
              <a:ext cx="385095" cy="843265"/>
            </a:xfrm>
            <a:prstGeom prst="snip2SameRect">
              <a:avLst/>
            </a:prstGeom>
            <a:solidFill>
              <a:schemeClr val="tx1">
                <a:lumMod val="65000"/>
                <a:lumOff val="35000"/>
              </a:schemeClr>
            </a:solidFill>
            <a:ln>
              <a:noFill/>
            </a:ln>
            <a:effectLst>
              <a:outerShdw blurRad="44450" dist="27940" dir="5400000" algn="ctr">
                <a:srgbClr val="000000">
                  <a:alpha val="32000"/>
                </a:srgbClr>
              </a:outerShdw>
            </a:effectLst>
            <a:scene3d>
              <a:camera prst="orthographicFront">
                <a:rot lat="0" lon="0" rev="0"/>
              </a:camera>
              <a:lightRig rig="balanced" dir="t">
                <a:rot lat="0" lon="0" rev="8700000"/>
              </a:lightRig>
            </a:scene3d>
            <a:sp3d>
              <a:bevelT w="190500" h="381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a:extLst>
                <a:ext uri="{FF2B5EF4-FFF2-40B4-BE49-F238E27FC236}">
                  <a16:creationId xmlns:a16="http://schemas.microsoft.com/office/drawing/2014/main" id="{39EF1760-8CF2-33C7-F17C-8C077C8290FB}"/>
                </a:ext>
              </a:extLst>
            </p:cNvPr>
            <p:cNvSpPr/>
            <p:nvPr/>
          </p:nvSpPr>
          <p:spPr>
            <a:xfrm flipH="1" flipV="1">
              <a:off x="5193550" y="3238864"/>
              <a:ext cx="55712" cy="46107"/>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3" name="Audio Recording Sep 27, 2022 at 7:19:39 PM" descr="Audio Recording Sep 27, 2022 at 7:19:39 PM">
            <a:hlinkClick r:id="" action="ppaction://media"/>
            <a:extLst>
              <a:ext uri="{FF2B5EF4-FFF2-40B4-BE49-F238E27FC236}">
                <a16:creationId xmlns:a16="http://schemas.microsoft.com/office/drawing/2014/main" id="{48C7620D-FCD1-67F5-2219-5BE4650353A9}"/>
              </a:ext>
            </a:extLst>
          </p:cNvPr>
          <p:cNvPicPr>
            <a:picLocks noChangeAspect="1"/>
          </p:cNvPicPr>
          <p:nvPr>
            <a:audioFile r:link="rId2"/>
            <p:extLst>
              <p:ext uri="{DAA4B4D4-6D71-4841-9C94-3DE7FCFB9230}">
                <p14:media xmlns:p14="http://schemas.microsoft.com/office/powerpoint/2010/main" r:embed="rId1"/>
              </p:ext>
            </p:extLst>
          </p:nvPr>
        </p:nvPicPr>
        <p:blipFill>
          <a:blip r:embed="rId78"/>
          <a:stretch>
            <a:fillRect/>
          </a:stretch>
        </p:blipFill>
        <p:spPr>
          <a:xfrm>
            <a:off x="10881457" y="5239884"/>
            <a:ext cx="812800" cy="812800"/>
          </a:xfrm>
          <a:prstGeom prst="rect">
            <a:avLst/>
          </a:prstGeom>
        </p:spPr>
      </p:pic>
    </p:spTree>
    <p:extLst>
      <p:ext uri="{BB962C8B-B14F-4D97-AF65-F5344CB8AC3E}">
        <p14:creationId xmlns:p14="http://schemas.microsoft.com/office/powerpoint/2010/main" val="14122330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94912" fill="hold"/>
                                        <p:tgtEl>
                                          <p:spTgt spid="3"/>
                                        </p:tgtEl>
                                      </p:cBhvr>
                                    </p:cmd>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68"/>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nodeType="clickEffect">
                                  <p:stCondLst>
                                    <p:cond delay="0"/>
                                  </p:stCondLst>
                                  <p:childTnLst>
                                    <p:set>
                                      <p:cBhvr>
                                        <p:cTn id="26" dur="1" fill="hold">
                                          <p:stCondLst>
                                            <p:cond delay="0"/>
                                          </p:stCondLst>
                                        </p:cTn>
                                        <p:tgtEl>
                                          <p:spTgt spid="14"/>
                                        </p:tgtEl>
                                        <p:attrNameLst>
                                          <p:attrName>style.visibility</p:attrName>
                                        </p:attrNameLst>
                                      </p:cBhvr>
                                      <p:to>
                                        <p:strVal val="visible"/>
                                      </p:to>
                                    </p:set>
                                    <p:animEffect transition="in" filter="dissolve">
                                      <p:cBhvr>
                                        <p:cTn id="27" dur="500"/>
                                        <p:tgtEl>
                                          <p:spTgt spid="14"/>
                                        </p:tgtEl>
                                      </p:cBhvr>
                                    </p:animEffect>
                                  </p:childTnLst>
                                </p:cTn>
                              </p:par>
                            </p:childTnLst>
                          </p:cTn>
                        </p:par>
                        <p:par>
                          <p:cTn id="28" fill="hold">
                            <p:stCondLst>
                              <p:cond delay="500"/>
                            </p:stCondLst>
                            <p:childTnLst>
                              <p:par>
                                <p:cTn id="29" presetID="9" presetClass="entr" presetSubtype="0" fill="hold" grpId="0" nodeType="afterEffect">
                                  <p:stCondLst>
                                    <p:cond delay="0"/>
                                  </p:stCondLst>
                                  <p:childTnLst>
                                    <p:set>
                                      <p:cBhvr>
                                        <p:cTn id="30" dur="1" fill="hold">
                                          <p:stCondLst>
                                            <p:cond delay="0"/>
                                          </p:stCondLst>
                                        </p:cTn>
                                        <p:tgtEl>
                                          <p:spTgt spid="1070"/>
                                        </p:tgtEl>
                                        <p:attrNameLst>
                                          <p:attrName>style.visibility</p:attrName>
                                        </p:attrNameLst>
                                      </p:cBhvr>
                                      <p:to>
                                        <p:strVal val="visible"/>
                                      </p:to>
                                    </p:set>
                                    <p:animEffect transition="in" filter="dissolve">
                                      <p:cBhvr>
                                        <p:cTn id="31" dur="500"/>
                                        <p:tgtEl>
                                          <p:spTgt spid="1070"/>
                                        </p:tgtEl>
                                      </p:cBhvr>
                                    </p:animEffect>
                                  </p:childTnLst>
                                </p:cTn>
                              </p:par>
                            </p:childTnLst>
                          </p:cTn>
                        </p:par>
                        <p:par>
                          <p:cTn id="32" fill="hold">
                            <p:stCondLst>
                              <p:cond delay="1000"/>
                            </p:stCondLst>
                            <p:childTnLst>
                              <p:par>
                                <p:cTn id="33" presetID="9" presetClass="entr" presetSubtype="0" fill="hold" grpId="0" nodeType="afterEffect">
                                  <p:stCondLst>
                                    <p:cond delay="0"/>
                                  </p:stCondLst>
                                  <p:childTnLst>
                                    <p:set>
                                      <p:cBhvr>
                                        <p:cTn id="34" dur="1" fill="hold">
                                          <p:stCondLst>
                                            <p:cond delay="0"/>
                                          </p:stCondLst>
                                        </p:cTn>
                                        <p:tgtEl>
                                          <p:spTgt spid="1071"/>
                                        </p:tgtEl>
                                        <p:attrNameLst>
                                          <p:attrName>style.visibility</p:attrName>
                                        </p:attrNameLst>
                                      </p:cBhvr>
                                      <p:to>
                                        <p:strVal val="visible"/>
                                      </p:to>
                                    </p:set>
                                    <p:animEffect transition="in" filter="dissolve">
                                      <p:cBhvr>
                                        <p:cTn id="35" dur="500"/>
                                        <p:tgtEl>
                                          <p:spTgt spid="1071"/>
                                        </p:tgtEl>
                                      </p:cBhvr>
                                    </p:animEffect>
                                  </p:childTnLst>
                                </p:cTn>
                              </p:par>
                            </p:childTnLst>
                          </p:cTn>
                        </p:par>
                        <p:par>
                          <p:cTn id="36" fill="hold">
                            <p:stCondLst>
                              <p:cond delay="1500"/>
                            </p:stCondLst>
                            <p:childTnLst>
                              <p:par>
                                <p:cTn id="37" presetID="9" presetClass="entr" presetSubtype="0" fill="hold" grpId="0" nodeType="afterEffect">
                                  <p:stCondLst>
                                    <p:cond delay="0"/>
                                  </p:stCondLst>
                                  <p:childTnLst>
                                    <p:set>
                                      <p:cBhvr>
                                        <p:cTn id="38" dur="1" fill="hold">
                                          <p:stCondLst>
                                            <p:cond delay="0"/>
                                          </p:stCondLst>
                                        </p:cTn>
                                        <p:tgtEl>
                                          <p:spTgt spid="1072"/>
                                        </p:tgtEl>
                                        <p:attrNameLst>
                                          <p:attrName>style.visibility</p:attrName>
                                        </p:attrNameLst>
                                      </p:cBhvr>
                                      <p:to>
                                        <p:strVal val="visible"/>
                                      </p:to>
                                    </p:set>
                                    <p:animEffect transition="in" filter="dissolve">
                                      <p:cBhvr>
                                        <p:cTn id="39" dur="500"/>
                                        <p:tgtEl>
                                          <p:spTgt spid="1072"/>
                                        </p:tgtEl>
                                      </p:cBhvr>
                                    </p:animEffect>
                                  </p:childTnLst>
                                </p:cTn>
                              </p:par>
                            </p:childTnLst>
                          </p:cTn>
                        </p:par>
                      </p:childTnLst>
                    </p:cTn>
                  </p:par>
                  <p:par>
                    <p:cTn id="40" fill="hold">
                      <p:stCondLst>
                        <p:cond delay="indefinite"/>
                      </p:stCondLst>
                      <p:childTnLst>
                        <p:par>
                          <p:cTn id="41" fill="hold">
                            <p:stCondLst>
                              <p:cond delay="0"/>
                            </p:stCondLst>
                            <p:childTnLst>
                              <p:par>
                                <p:cTn id="42" presetID="9" presetClass="entr" presetSubtype="0" fill="hold" nodeType="clickEffect">
                                  <p:stCondLst>
                                    <p:cond delay="0"/>
                                  </p:stCondLst>
                                  <p:childTnLst>
                                    <p:set>
                                      <p:cBhvr>
                                        <p:cTn id="43" dur="1" fill="hold">
                                          <p:stCondLst>
                                            <p:cond delay="0"/>
                                          </p:stCondLst>
                                        </p:cTn>
                                        <p:tgtEl>
                                          <p:spTgt spid="1073"/>
                                        </p:tgtEl>
                                        <p:attrNameLst>
                                          <p:attrName>style.visibility</p:attrName>
                                        </p:attrNameLst>
                                      </p:cBhvr>
                                      <p:to>
                                        <p:strVal val="visible"/>
                                      </p:to>
                                    </p:set>
                                    <p:animEffect transition="in" filter="dissolve">
                                      <p:cBhvr>
                                        <p:cTn id="44" dur="500"/>
                                        <p:tgtEl>
                                          <p:spTgt spid="1073"/>
                                        </p:tgtEl>
                                      </p:cBhvr>
                                    </p:animEffect>
                                  </p:childTnLst>
                                </p:cTn>
                              </p:par>
                              <p:par>
                                <p:cTn id="45" presetID="1" presetClass="entr" presetSubtype="0" fill="hold" grpId="0" nodeType="withEffect">
                                  <p:stCondLst>
                                    <p:cond delay="0"/>
                                  </p:stCondLst>
                                  <p:childTnLst>
                                    <p:set>
                                      <p:cBhvr>
                                        <p:cTn id="46" dur="1" fill="hold">
                                          <p:stCondLst>
                                            <p:cond delay="0"/>
                                          </p:stCondLst>
                                        </p:cTn>
                                        <p:tgtEl>
                                          <p:spTgt spid="10"/>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9"/>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p:cMediaNode vol="80000">
                <p:cTn id="55" fill="hold" display="0">
                  <p:stCondLst>
                    <p:cond delay="indefinite"/>
                  </p:stCondLst>
                  <p:endCondLst>
                    <p:cond evt="onStopAudio" delay="0">
                      <p:tgtEl>
                        <p:sldTgt/>
                      </p:tgtEl>
                    </p:cond>
                  </p:endCondLst>
                </p:cTn>
                <p:tgtEl>
                  <p:spTgt spid="3"/>
                </p:tgtEl>
              </p:cMediaNode>
            </p:audio>
          </p:childTnLst>
        </p:cTn>
      </p:par>
    </p:tnLst>
    <p:bldLst>
      <p:bldP spid="1072" grpId="0" animBg="1"/>
      <p:bldP spid="1071" grpId="0" animBg="1"/>
      <p:bldP spid="1070" grpId="0" animBg="1"/>
      <p:bldP spid="10"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01CEA82-7AEB-10CA-FCA3-D0992EEAEA23}"/>
              </a:ext>
            </a:extLst>
          </p:cNvPr>
          <p:cNvGrpSpPr/>
          <p:nvPr/>
        </p:nvGrpSpPr>
        <p:grpSpPr>
          <a:xfrm>
            <a:off x="4101745" y="653002"/>
            <a:ext cx="4059360" cy="5189040"/>
            <a:chOff x="4101745" y="653002"/>
            <a:chExt cx="4059360" cy="5189040"/>
          </a:xfrm>
        </p:grpSpPr>
        <mc:AlternateContent xmlns:mc="http://schemas.openxmlformats.org/markup-compatibility/2006" xmlns:p14="http://schemas.microsoft.com/office/powerpoint/2010/main">
          <mc:Choice Requires="p14">
            <p:contentPart p14:bwMode="auto" r:id="rId5">
              <p14:nvContentPartPr>
                <p14:cNvPr id="36" name="Ink 35">
                  <a:extLst>
                    <a:ext uri="{FF2B5EF4-FFF2-40B4-BE49-F238E27FC236}">
                      <a16:creationId xmlns:a16="http://schemas.microsoft.com/office/drawing/2014/main" id="{DB77B19F-3997-F2D7-1117-8C2689BC3745}"/>
                    </a:ext>
                  </a:extLst>
                </p14:cNvPr>
                <p14:cNvContentPartPr/>
                <p14:nvPr/>
              </p14:nvContentPartPr>
              <p14:xfrm>
                <a:off x="5677105" y="1174642"/>
                <a:ext cx="968400" cy="659160"/>
              </p14:xfrm>
            </p:contentPart>
          </mc:Choice>
          <mc:Fallback xmlns="">
            <p:pic>
              <p:nvPicPr>
                <p:cNvPr id="36" name="Ink 35">
                  <a:extLst>
                    <a:ext uri="{FF2B5EF4-FFF2-40B4-BE49-F238E27FC236}">
                      <a16:creationId xmlns:a16="http://schemas.microsoft.com/office/drawing/2014/main" id="{DB77B19F-3997-F2D7-1117-8C2689BC3745}"/>
                    </a:ext>
                  </a:extLst>
                </p:cNvPr>
                <p:cNvPicPr/>
                <p:nvPr/>
              </p:nvPicPr>
              <p:blipFill>
                <a:blip r:embed="rId8"/>
                <a:stretch>
                  <a:fillRect/>
                </a:stretch>
              </p:blipFill>
              <p:spPr>
                <a:xfrm>
                  <a:off x="5641105" y="1138622"/>
                  <a:ext cx="1040040" cy="730839"/>
                </a:xfrm>
                <a:prstGeom prst="rect">
                  <a:avLst/>
                </a:prstGeom>
              </p:spPr>
            </p:pic>
          </mc:Fallback>
        </mc:AlternateContent>
        <mc:AlternateContent xmlns:mc="http://schemas.openxmlformats.org/markup-compatibility/2006" xmlns:p14="http://schemas.microsoft.com/office/powerpoint/2010/main">
          <mc:Choice Requires="p14">
            <p:contentPart p14:bwMode="auto" r:id="rId9">
              <p14:nvContentPartPr>
                <p14:cNvPr id="37" name="Ink 36">
                  <a:extLst>
                    <a:ext uri="{FF2B5EF4-FFF2-40B4-BE49-F238E27FC236}">
                      <a16:creationId xmlns:a16="http://schemas.microsoft.com/office/drawing/2014/main" id="{03FFD99A-6B3C-3CD1-6179-1322032D0AA7}"/>
                    </a:ext>
                  </a:extLst>
                </p14:cNvPr>
                <p14:cNvContentPartPr/>
                <p14:nvPr/>
              </p14:nvContentPartPr>
              <p14:xfrm>
                <a:off x="5812825" y="1879522"/>
                <a:ext cx="196200" cy="1943640"/>
              </p14:xfrm>
            </p:contentPart>
          </mc:Choice>
          <mc:Fallback xmlns="">
            <p:pic>
              <p:nvPicPr>
                <p:cNvPr id="37" name="Ink 36">
                  <a:extLst>
                    <a:ext uri="{FF2B5EF4-FFF2-40B4-BE49-F238E27FC236}">
                      <a16:creationId xmlns:a16="http://schemas.microsoft.com/office/drawing/2014/main" id="{03FFD99A-6B3C-3CD1-6179-1322032D0AA7}"/>
                    </a:ext>
                  </a:extLst>
                </p:cNvPr>
                <p:cNvPicPr/>
                <p:nvPr/>
              </p:nvPicPr>
              <p:blipFill>
                <a:blip r:embed="rId10"/>
                <a:stretch>
                  <a:fillRect/>
                </a:stretch>
              </p:blipFill>
              <p:spPr>
                <a:xfrm>
                  <a:off x="5776825" y="1843522"/>
                  <a:ext cx="267840" cy="2015280"/>
                </a:xfrm>
                <a:prstGeom prst="rect">
                  <a:avLst/>
                </a:prstGeom>
              </p:spPr>
            </p:pic>
          </mc:Fallback>
        </mc:AlternateContent>
        <mc:AlternateContent xmlns:mc="http://schemas.openxmlformats.org/markup-compatibility/2006" xmlns:p14="http://schemas.microsoft.com/office/powerpoint/2010/main">
          <mc:Choice Requires="p14">
            <p:contentPart p14:bwMode="auto" r:id="rId11">
              <p14:nvContentPartPr>
                <p14:cNvPr id="38" name="Ink 37">
                  <a:extLst>
                    <a:ext uri="{FF2B5EF4-FFF2-40B4-BE49-F238E27FC236}">
                      <a16:creationId xmlns:a16="http://schemas.microsoft.com/office/drawing/2014/main" id="{3FD2A4E1-3443-C691-E599-6A5B121E8E2F}"/>
                    </a:ext>
                  </a:extLst>
                </p14:cNvPr>
                <p14:cNvContentPartPr/>
                <p14:nvPr/>
              </p14:nvContentPartPr>
              <p14:xfrm>
                <a:off x="6006145" y="1855402"/>
                <a:ext cx="453240" cy="2187000"/>
              </p14:xfrm>
            </p:contentPart>
          </mc:Choice>
          <mc:Fallback xmlns="">
            <p:pic>
              <p:nvPicPr>
                <p:cNvPr id="38" name="Ink 37">
                  <a:extLst>
                    <a:ext uri="{FF2B5EF4-FFF2-40B4-BE49-F238E27FC236}">
                      <a16:creationId xmlns:a16="http://schemas.microsoft.com/office/drawing/2014/main" id="{3FD2A4E1-3443-C691-E599-6A5B121E8E2F}"/>
                    </a:ext>
                  </a:extLst>
                </p:cNvPr>
                <p:cNvPicPr/>
                <p:nvPr/>
              </p:nvPicPr>
              <p:blipFill>
                <a:blip r:embed="rId12"/>
                <a:stretch>
                  <a:fillRect/>
                </a:stretch>
              </p:blipFill>
              <p:spPr>
                <a:xfrm>
                  <a:off x="5970145" y="1819402"/>
                  <a:ext cx="524880" cy="2258640"/>
                </a:xfrm>
                <a:prstGeom prst="rect">
                  <a:avLst/>
                </a:prstGeom>
              </p:spPr>
            </p:pic>
          </mc:Fallback>
        </mc:AlternateContent>
        <mc:AlternateContent xmlns:mc="http://schemas.openxmlformats.org/markup-compatibility/2006" xmlns:p14="http://schemas.microsoft.com/office/powerpoint/2010/main">
          <mc:Choice Requires="p14">
            <p:contentPart p14:bwMode="auto" r:id="rId13">
              <p14:nvContentPartPr>
                <p14:cNvPr id="39" name="Ink 38">
                  <a:extLst>
                    <a:ext uri="{FF2B5EF4-FFF2-40B4-BE49-F238E27FC236}">
                      <a16:creationId xmlns:a16="http://schemas.microsoft.com/office/drawing/2014/main" id="{C624697E-6D80-4624-3D04-D82A1873DBB6}"/>
                    </a:ext>
                  </a:extLst>
                </p14:cNvPr>
                <p14:cNvContentPartPr/>
                <p14:nvPr/>
              </p14:nvContentPartPr>
              <p14:xfrm>
                <a:off x="6493945" y="653002"/>
                <a:ext cx="804240" cy="721080"/>
              </p14:xfrm>
            </p:contentPart>
          </mc:Choice>
          <mc:Fallback xmlns="">
            <p:pic>
              <p:nvPicPr>
                <p:cNvPr id="39" name="Ink 38">
                  <a:extLst>
                    <a:ext uri="{FF2B5EF4-FFF2-40B4-BE49-F238E27FC236}">
                      <a16:creationId xmlns:a16="http://schemas.microsoft.com/office/drawing/2014/main" id="{C624697E-6D80-4624-3D04-D82A1873DBB6}"/>
                    </a:ext>
                  </a:extLst>
                </p:cNvPr>
                <p:cNvPicPr/>
                <p:nvPr/>
              </p:nvPicPr>
              <p:blipFill>
                <a:blip r:embed="rId14"/>
                <a:stretch>
                  <a:fillRect/>
                </a:stretch>
              </p:blipFill>
              <p:spPr>
                <a:xfrm>
                  <a:off x="6430945" y="590002"/>
                  <a:ext cx="929880" cy="846720"/>
                </a:xfrm>
                <a:prstGeom prst="rect">
                  <a:avLst/>
                </a:prstGeom>
              </p:spPr>
            </p:pic>
          </mc:Fallback>
        </mc:AlternateContent>
        <mc:AlternateContent xmlns:mc="http://schemas.openxmlformats.org/markup-compatibility/2006" xmlns:p14="http://schemas.microsoft.com/office/powerpoint/2010/main">
          <mc:Choice Requires="p14">
            <p:contentPart p14:bwMode="auto" r:id="rId15">
              <p14:nvContentPartPr>
                <p14:cNvPr id="40" name="Ink 39">
                  <a:extLst>
                    <a:ext uri="{FF2B5EF4-FFF2-40B4-BE49-F238E27FC236}">
                      <a16:creationId xmlns:a16="http://schemas.microsoft.com/office/drawing/2014/main" id="{F889DBB1-4ADD-D4D3-A6A0-02334E3C45DF}"/>
                    </a:ext>
                  </a:extLst>
                </p14:cNvPr>
                <p14:cNvContentPartPr/>
                <p14:nvPr/>
              </p14:nvContentPartPr>
              <p14:xfrm>
                <a:off x="4995265" y="678562"/>
                <a:ext cx="772920" cy="718560"/>
              </p14:xfrm>
            </p:contentPart>
          </mc:Choice>
          <mc:Fallback xmlns="">
            <p:pic>
              <p:nvPicPr>
                <p:cNvPr id="40" name="Ink 39">
                  <a:extLst>
                    <a:ext uri="{FF2B5EF4-FFF2-40B4-BE49-F238E27FC236}">
                      <a16:creationId xmlns:a16="http://schemas.microsoft.com/office/drawing/2014/main" id="{F889DBB1-4ADD-D4D3-A6A0-02334E3C45DF}"/>
                    </a:ext>
                  </a:extLst>
                </p:cNvPr>
                <p:cNvPicPr/>
                <p:nvPr/>
              </p:nvPicPr>
              <p:blipFill>
                <a:blip r:embed="rId16"/>
                <a:stretch>
                  <a:fillRect/>
                </a:stretch>
              </p:blipFill>
              <p:spPr>
                <a:xfrm>
                  <a:off x="4932265" y="615562"/>
                  <a:ext cx="898560" cy="844200"/>
                </a:xfrm>
                <a:prstGeom prst="rect">
                  <a:avLst/>
                </a:prstGeom>
              </p:spPr>
            </p:pic>
          </mc:Fallback>
        </mc:AlternateContent>
        <mc:AlternateContent xmlns:mc="http://schemas.openxmlformats.org/markup-compatibility/2006" xmlns:p14="http://schemas.microsoft.com/office/powerpoint/2010/main">
          <mc:Choice Requires="p14">
            <p:contentPart p14:bwMode="auto" r:id="rId17">
              <p14:nvContentPartPr>
                <p14:cNvPr id="41" name="Ink 40">
                  <a:extLst>
                    <a:ext uri="{FF2B5EF4-FFF2-40B4-BE49-F238E27FC236}">
                      <a16:creationId xmlns:a16="http://schemas.microsoft.com/office/drawing/2014/main" id="{8D9AE009-E0E4-F732-C47F-7C901EFE87F5}"/>
                    </a:ext>
                  </a:extLst>
                </p14:cNvPr>
                <p14:cNvContentPartPr/>
                <p14:nvPr/>
              </p14:nvContentPartPr>
              <p14:xfrm>
                <a:off x="6447145" y="1232602"/>
                <a:ext cx="1170360" cy="661320"/>
              </p14:xfrm>
            </p:contentPart>
          </mc:Choice>
          <mc:Fallback xmlns="">
            <p:pic>
              <p:nvPicPr>
                <p:cNvPr id="41" name="Ink 40">
                  <a:extLst>
                    <a:ext uri="{FF2B5EF4-FFF2-40B4-BE49-F238E27FC236}">
                      <a16:creationId xmlns:a16="http://schemas.microsoft.com/office/drawing/2014/main" id="{8D9AE009-E0E4-F732-C47F-7C901EFE87F5}"/>
                    </a:ext>
                  </a:extLst>
                </p:cNvPr>
                <p:cNvPicPr/>
                <p:nvPr/>
              </p:nvPicPr>
              <p:blipFill>
                <a:blip r:embed="rId18"/>
                <a:stretch>
                  <a:fillRect/>
                </a:stretch>
              </p:blipFill>
              <p:spPr>
                <a:xfrm>
                  <a:off x="6384145" y="1169602"/>
                  <a:ext cx="1296000" cy="786960"/>
                </a:xfrm>
                <a:prstGeom prst="rect">
                  <a:avLst/>
                </a:prstGeom>
              </p:spPr>
            </p:pic>
          </mc:Fallback>
        </mc:AlternateContent>
        <mc:AlternateContent xmlns:mc="http://schemas.openxmlformats.org/markup-compatibility/2006" xmlns:p14="http://schemas.microsoft.com/office/powerpoint/2010/main">
          <mc:Choice Requires="p14">
            <p:contentPart p14:bwMode="auto" r:id="rId19">
              <p14:nvContentPartPr>
                <p14:cNvPr id="42" name="Ink 41">
                  <a:extLst>
                    <a:ext uri="{FF2B5EF4-FFF2-40B4-BE49-F238E27FC236}">
                      <a16:creationId xmlns:a16="http://schemas.microsoft.com/office/drawing/2014/main" id="{3863E03A-9249-F623-47A5-B99022B6D8D3}"/>
                    </a:ext>
                  </a:extLst>
                </p14:cNvPr>
                <p14:cNvContentPartPr/>
                <p14:nvPr/>
              </p14:nvContentPartPr>
              <p14:xfrm>
                <a:off x="6500785" y="1705642"/>
                <a:ext cx="1288080" cy="733320"/>
              </p14:xfrm>
            </p:contentPart>
          </mc:Choice>
          <mc:Fallback xmlns="">
            <p:pic>
              <p:nvPicPr>
                <p:cNvPr id="42" name="Ink 41">
                  <a:extLst>
                    <a:ext uri="{FF2B5EF4-FFF2-40B4-BE49-F238E27FC236}">
                      <a16:creationId xmlns:a16="http://schemas.microsoft.com/office/drawing/2014/main" id="{3863E03A-9249-F623-47A5-B99022B6D8D3}"/>
                    </a:ext>
                  </a:extLst>
                </p:cNvPr>
                <p:cNvPicPr/>
                <p:nvPr/>
              </p:nvPicPr>
              <p:blipFill>
                <a:blip r:embed="rId20"/>
                <a:stretch>
                  <a:fillRect/>
                </a:stretch>
              </p:blipFill>
              <p:spPr>
                <a:xfrm>
                  <a:off x="6437785" y="1642642"/>
                  <a:ext cx="1413720" cy="858960"/>
                </a:xfrm>
                <a:prstGeom prst="rect">
                  <a:avLst/>
                </a:prstGeom>
              </p:spPr>
            </p:pic>
          </mc:Fallback>
        </mc:AlternateContent>
        <mc:AlternateContent xmlns:mc="http://schemas.openxmlformats.org/markup-compatibility/2006" xmlns:p14="http://schemas.microsoft.com/office/powerpoint/2010/main">
          <mc:Choice Requires="p14">
            <p:contentPart p14:bwMode="auto" r:id="rId21">
              <p14:nvContentPartPr>
                <p14:cNvPr id="43" name="Ink 42">
                  <a:extLst>
                    <a:ext uri="{FF2B5EF4-FFF2-40B4-BE49-F238E27FC236}">
                      <a16:creationId xmlns:a16="http://schemas.microsoft.com/office/drawing/2014/main" id="{55D53B92-3387-F27F-3041-F63698134C32}"/>
                    </a:ext>
                  </a:extLst>
                </p14:cNvPr>
                <p14:cNvContentPartPr/>
                <p14:nvPr/>
              </p14:nvContentPartPr>
              <p14:xfrm>
                <a:off x="6518065" y="2147722"/>
                <a:ext cx="1497240" cy="856440"/>
              </p14:xfrm>
            </p:contentPart>
          </mc:Choice>
          <mc:Fallback xmlns="">
            <p:pic>
              <p:nvPicPr>
                <p:cNvPr id="43" name="Ink 42">
                  <a:extLst>
                    <a:ext uri="{FF2B5EF4-FFF2-40B4-BE49-F238E27FC236}">
                      <a16:creationId xmlns:a16="http://schemas.microsoft.com/office/drawing/2014/main" id="{55D53B92-3387-F27F-3041-F63698134C32}"/>
                    </a:ext>
                  </a:extLst>
                </p:cNvPr>
                <p:cNvPicPr/>
                <p:nvPr/>
              </p:nvPicPr>
              <p:blipFill>
                <a:blip r:embed="rId22"/>
                <a:stretch>
                  <a:fillRect/>
                </a:stretch>
              </p:blipFill>
              <p:spPr>
                <a:xfrm>
                  <a:off x="6455065" y="2084722"/>
                  <a:ext cx="1622880" cy="982080"/>
                </a:xfrm>
                <a:prstGeom prst="rect">
                  <a:avLst/>
                </a:prstGeom>
              </p:spPr>
            </p:pic>
          </mc:Fallback>
        </mc:AlternateContent>
        <mc:AlternateContent xmlns:mc="http://schemas.openxmlformats.org/markup-compatibility/2006" xmlns:p14="http://schemas.microsoft.com/office/powerpoint/2010/main">
          <mc:Choice Requires="p14">
            <p:contentPart p14:bwMode="auto" r:id="rId23">
              <p14:nvContentPartPr>
                <p14:cNvPr id="44" name="Ink 43">
                  <a:extLst>
                    <a:ext uri="{FF2B5EF4-FFF2-40B4-BE49-F238E27FC236}">
                      <a16:creationId xmlns:a16="http://schemas.microsoft.com/office/drawing/2014/main" id="{8A717FFB-4C50-0A3B-7AA2-9B29B8D0CB81}"/>
                    </a:ext>
                  </a:extLst>
                </p14:cNvPr>
                <p14:cNvContentPartPr/>
                <p14:nvPr/>
              </p14:nvContentPartPr>
              <p14:xfrm>
                <a:off x="6478105" y="2726602"/>
                <a:ext cx="1609920" cy="837360"/>
              </p14:xfrm>
            </p:contentPart>
          </mc:Choice>
          <mc:Fallback xmlns="">
            <p:pic>
              <p:nvPicPr>
                <p:cNvPr id="44" name="Ink 43">
                  <a:extLst>
                    <a:ext uri="{FF2B5EF4-FFF2-40B4-BE49-F238E27FC236}">
                      <a16:creationId xmlns:a16="http://schemas.microsoft.com/office/drawing/2014/main" id="{8A717FFB-4C50-0A3B-7AA2-9B29B8D0CB81}"/>
                    </a:ext>
                  </a:extLst>
                </p:cNvPr>
                <p:cNvPicPr/>
                <p:nvPr/>
              </p:nvPicPr>
              <p:blipFill>
                <a:blip r:embed="rId24"/>
                <a:stretch>
                  <a:fillRect/>
                </a:stretch>
              </p:blipFill>
              <p:spPr>
                <a:xfrm>
                  <a:off x="6415105" y="2663602"/>
                  <a:ext cx="1735560" cy="963000"/>
                </a:xfrm>
                <a:prstGeom prst="rect">
                  <a:avLst/>
                </a:prstGeom>
              </p:spPr>
            </p:pic>
          </mc:Fallback>
        </mc:AlternateContent>
        <mc:AlternateContent xmlns:mc="http://schemas.openxmlformats.org/markup-compatibility/2006" xmlns:p14="http://schemas.microsoft.com/office/powerpoint/2010/main">
          <mc:Choice Requires="p14">
            <p:contentPart p14:bwMode="auto" r:id="rId25">
              <p14:nvContentPartPr>
                <p14:cNvPr id="45" name="Ink 44">
                  <a:extLst>
                    <a:ext uri="{FF2B5EF4-FFF2-40B4-BE49-F238E27FC236}">
                      <a16:creationId xmlns:a16="http://schemas.microsoft.com/office/drawing/2014/main" id="{5AFF0123-8F93-70E4-8B78-F0400A8C329F}"/>
                    </a:ext>
                  </a:extLst>
                </p14:cNvPr>
                <p14:cNvContentPartPr/>
                <p14:nvPr/>
              </p14:nvContentPartPr>
              <p14:xfrm>
                <a:off x="4679185" y="1296322"/>
                <a:ext cx="1182600" cy="605160"/>
              </p14:xfrm>
            </p:contentPart>
          </mc:Choice>
          <mc:Fallback xmlns="">
            <p:pic>
              <p:nvPicPr>
                <p:cNvPr id="45" name="Ink 44">
                  <a:extLst>
                    <a:ext uri="{FF2B5EF4-FFF2-40B4-BE49-F238E27FC236}">
                      <a16:creationId xmlns:a16="http://schemas.microsoft.com/office/drawing/2014/main" id="{5AFF0123-8F93-70E4-8B78-F0400A8C329F}"/>
                    </a:ext>
                  </a:extLst>
                </p:cNvPr>
                <p:cNvPicPr/>
                <p:nvPr/>
              </p:nvPicPr>
              <p:blipFill>
                <a:blip r:embed="rId26"/>
                <a:stretch>
                  <a:fillRect/>
                </a:stretch>
              </p:blipFill>
              <p:spPr>
                <a:xfrm>
                  <a:off x="4616185" y="1233284"/>
                  <a:ext cx="1308240" cy="730875"/>
                </a:xfrm>
                <a:prstGeom prst="rect">
                  <a:avLst/>
                </a:prstGeom>
              </p:spPr>
            </p:pic>
          </mc:Fallback>
        </mc:AlternateContent>
        <mc:AlternateContent xmlns:mc="http://schemas.openxmlformats.org/markup-compatibility/2006" xmlns:p14="http://schemas.microsoft.com/office/powerpoint/2010/main">
          <mc:Choice Requires="p14">
            <p:contentPart p14:bwMode="auto" r:id="rId27">
              <p14:nvContentPartPr>
                <p14:cNvPr id="46" name="Ink 45">
                  <a:extLst>
                    <a:ext uri="{FF2B5EF4-FFF2-40B4-BE49-F238E27FC236}">
                      <a16:creationId xmlns:a16="http://schemas.microsoft.com/office/drawing/2014/main" id="{6F2525C9-59AB-479D-FCC9-FD33621289AD}"/>
                    </a:ext>
                  </a:extLst>
                </p14:cNvPr>
                <p14:cNvContentPartPr/>
                <p14:nvPr/>
              </p14:nvContentPartPr>
              <p14:xfrm>
                <a:off x="4515745" y="1671082"/>
                <a:ext cx="1289880" cy="698040"/>
              </p14:xfrm>
            </p:contentPart>
          </mc:Choice>
          <mc:Fallback xmlns="">
            <p:pic>
              <p:nvPicPr>
                <p:cNvPr id="46" name="Ink 45">
                  <a:extLst>
                    <a:ext uri="{FF2B5EF4-FFF2-40B4-BE49-F238E27FC236}">
                      <a16:creationId xmlns:a16="http://schemas.microsoft.com/office/drawing/2014/main" id="{6F2525C9-59AB-479D-FCC9-FD33621289AD}"/>
                    </a:ext>
                  </a:extLst>
                </p:cNvPr>
                <p:cNvPicPr/>
                <p:nvPr/>
              </p:nvPicPr>
              <p:blipFill>
                <a:blip r:embed="rId28"/>
                <a:stretch>
                  <a:fillRect/>
                </a:stretch>
              </p:blipFill>
              <p:spPr>
                <a:xfrm>
                  <a:off x="4452745" y="1608082"/>
                  <a:ext cx="1415520" cy="823680"/>
                </a:xfrm>
                <a:prstGeom prst="rect">
                  <a:avLst/>
                </a:prstGeom>
              </p:spPr>
            </p:pic>
          </mc:Fallback>
        </mc:AlternateContent>
        <mc:AlternateContent xmlns:mc="http://schemas.openxmlformats.org/markup-compatibility/2006" xmlns:p14="http://schemas.microsoft.com/office/powerpoint/2010/main">
          <mc:Choice Requires="p14">
            <p:contentPart p14:bwMode="auto" r:id="rId29">
              <p14:nvContentPartPr>
                <p14:cNvPr id="47" name="Ink 46">
                  <a:extLst>
                    <a:ext uri="{FF2B5EF4-FFF2-40B4-BE49-F238E27FC236}">
                      <a16:creationId xmlns:a16="http://schemas.microsoft.com/office/drawing/2014/main" id="{0A67CD69-80AE-73BF-BEB6-017FA28BD0B1}"/>
                    </a:ext>
                  </a:extLst>
                </p14:cNvPr>
                <p14:cNvContentPartPr/>
                <p14:nvPr/>
              </p14:nvContentPartPr>
              <p14:xfrm>
                <a:off x="4312705" y="2116042"/>
                <a:ext cx="1491480" cy="830880"/>
              </p14:xfrm>
            </p:contentPart>
          </mc:Choice>
          <mc:Fallback xmlns="">
            <p:pic>
              <p:nvPicPr>
                <p:cNvPr id="47" name="Ink 46">
                  <a:extLst>
                    <a:ext uri="{FF2B5EF4-FFF2-40B4-BE49-F238E27FC236}">
                      <a16:creationId xmlns:a16="http://schemas.microsoft.com/office/drawing/2014/main" id="{0A67CD69-80AE-73BF-BEB6-017FA28BD0B1}"/>
                    </a:ext>
                  </a:extLst>
                </p:cNvPr>
                <p:cNvPicPr/>
                <p:nvPr/>
              </p:nvPicPr>
              <p:blipFill>
                <a:blip r:embed="rId30"/>
                <a:stretch>
                  <a:fillRect/>
                </a:stretch>
              </p:blipFill>
              <p:spPr>
                <a:xfrm>
                  <a:off x="4249705" y="2053042"/>
                  <a:ext cx="1617120" cy="956520"/>
                </a:xfrm>
                <a:prstGeom prst="rect">
                  <a:avLst/>
                </a:prstGeom>
              </p:spPr>
            </p:pic>
          </mc:Fallback>
        </mc:AlternateContent>
        <mc:AlternateContent xmlns:mc="http://schemas.openxmlformats.org/markup-compatibility/2006" xmlns:p14="http://schemas.microsoft.com/office/powerpoint/2010/main">
          <mc:Choice Requires="p14">
            <p:contentPart p14:bwMode="auto" r:id="rId31">
              <p14:nvContentPartPr>
                <p14:cNvPr id="48" name="Ink 47">
                  <a:extLst>
                    <a:ext uri="{FF2B5EF4-FFF2-40B4-BE49-F238E27FC236}">
                      <a16:creationId xmlns:a16="http://schemas.microsoft.com/office/drawing/2014/main" id="{379A0D60-D13B-C1E1-09E0-C459B090D183}"/>
                    </a:ext>
                  </a:extLst>
                </p14:cNvPr>
                <p14:cNvContentPartPr/>
                <p14:nvPr/>
              </p14:nvContentPartPr>
              <p14:xfrm>
                <a:off x="4211185" y="2748562"/>
                <a:ext cx="1557720" cy="763560"/>
              </p14:xfrm>
            </p:contentPart>
          </mc:Choice>
          <mc:Fallback xmlns="">
            <p:pic>
              <p:nvPicPr>
                <p:cNvPr id="48" name="Ink 47">
                  <a:extLst>
                    <a:ext uri="{FF2B5EF4-FFF2-40B4-BE49-F238E27FC236}">
                      <a16:creationId xmlns:a16="http://schemas.microsoft.com/office/drawing/2014/main" id="{379A0D60-D13B-C1E1-09E0-C459B090D183}"/>
                    </a:ext>
                  </a:extLst>
                </p:cNvPr>
                <p:cNvPicPr/>
                <p:nvPr/>
              </p:nvPicPr>
              <p:blipFill>
                <a:blip r:embed="rId32"/>
                <a:stretch>
                  <a:fillRect/>
                </a:stretch>
              </p:blipFill>
              <p:spPr>
                <a:xfrm>
                  <a:off x="4148185" y="2685562"/>
                  <a:ext cx="1683360" cy="889200"/>
                </a:xfrm>
                <a:prstGeom prst="rect">
                  <a:avLst/>
                </a:prstGeom>
              </p:spPr>
            </p:pic>
          </mc:Fallback>
        </mc:AlternateContent>
        <mc:AlternateContent xmlns:mc="http://schemas.openxmlformats.org/markup-compatibility/2006" xmlns:p14="http://schemas.microsoft.com/office/powerpoint/2010/main">
          <mc:Choice Requires="p14">
            <p:contentPart p14:bwMode="auto" r:id="rId33">
              <p14:nvContentPartPr>
                <p14:cNvPr id="49" name="Ink 48">
                  <a:extLst>
                    <a:ext uri="{FF2B5EF4-FFF2-40B4-BE49-F238E27FC236}">
                      <a16:creationId xmlns:a16="http://schemas.microsoft.com/office/drawing/2014/main" id="{40CFBA3B-7527-530F-A687-2A7538E84A4D}"/>
                    </a:ext>
                  </a:extLst>
                </p14:cNvPr>
                <p14:cNvContentPartPr/>
                <p14:nvPr/>
              </p14:nvContentPartPr>
              <p14:xfrm>
                <a:off x="4101745" y="3260482"/>
                <a:ext cx="1715760" cy="768240"/>
              </p14:xfrm>
            </p:contentPart>
          </mc:Choice>
          <mc:Fallback xmlns="">
            <p:pic>
              <p:nvPicPr>
                <p:cNvPr id="49" name="Ink 48">
                  <a:extLst>
                    <a:ext uri="{FF2B5EF4-FFF2-40B4-BE49-F238E27FC236}">
                      <a16:creationId xmlns:a16="http://schemas.microsoft.com/office/drawing/2014/main" id="{40CFBA3B-7527-530F-A687-2A7538E84A4D}"/>
                    </a:ext>
                  </a:extLst>
                </p:cNvPr>
                <p:cNvPicPr/>
                <p:nvPr/>
              </p:nvPicPr>
              <p:blipFill>
                <a:blip r:embed="rId34"/>
                <a:stretch>
                  <a:fillRect/>
                </a:stretch>
              </p:blipFill>
              <p:spPr>
                <a:xfrm>
                  <a:off x="4038745" y="3197482"/>
                  <a:ext cx="1841400" cy="893880"/>
                </a:xfrm>
                <a:prstGeom prst="rect">
                  <a:avLst/>
                </a:prstGeom>
              </p:spPr>
            </p:pic>
          </mc:Fallback>
        </mc:AlternateContent>
        <mc:AlternateContent xmlns:mc="http://schemas.openxmlformats.org/markup-compatibility/2006" xmlns:p14="http://schemas.microsoft.com/office/powerpoint/2010/main">
          <mc:Choice Requires="p14">
            <p:contentPart p14:bwMode="auto" r:id="rId35">
              <p14:nvContentPartPr>
                <p14:cNvPr id="50" name="Ink 49">
                  <a:extLst>
                    <a:ext uri="{FF2B5EF4-FFF2-40B4-BE49-F238E27FC236}">
                      <a16:creationId xmlns:a16="http://schemas.microsoft.com/office/drawing/2014/main" id="{CCB462E5-E6E2-43D4-1C79-3C5AD93A7A6F}"/>
                    </a:ext>
                  </a:extLst>
                </p14:cNvPr>
                <p14:cNvContentPartPr/>
                <p14:nvPr/>
              </p14:nvContentPartPr>
              <p14:xfrm>
                <a:off x="4920745" y="3729202"/>
                <a:ext cx="1047240" cy="1375560"/>
              </p14:xfrm>
            </p:contentPart>
          </mc:Choice>
          <mc:Fallback xmlns="">
            <p:pic>
              <p:nvPicPr>
                <p:cNvPr id="50" name="Ink 49">
                  <a:extLst>
                    <a:ext uri="{FF2B5EF4-FFF2-40B4-BE49-F238E27FC236}">
                      <a16:creationId xmlns:a16="http://schemas.microsoft.com/office/drawing/2014/main" id="{CCB462E5-E6E2-43D4-1C79-3C5AD93A7A6F}"/>
                    </a:ext>
                  </a:extLst>
                </p:cNvPr>
                <p:cNvPicPr/>
                <p:nvPr/>
              </p:nvPicPr>
              <p:blipFill>
                <a:blip r:embed="rId36"/>
                <a:stretch>
                  <a:fillRect/>
                </a:stretch>
              </p:blipFill>
              <p:spPr>
                <a:xfrm>
                  <a:off x="4857745" y="3666202"/>
                  <a:ext cx="1172880" cy="1501200"/>
                </a:xfrm>
                <a:prstGeom prst="rect">
                  <a:avLst/>
                </a:prstGeom>
              </p:spPr>
            </p:pic>
          </mc:Fallback>
        </mc:AlternateContent>
        <mc:AlternateContent xmlns:mc="http://schemas.openxmlformats.org/markup-compatibility/2006" xmlns:p14="http://schemas.microsoft.com/office/powerpoint/2010/main">
          <mc:Choice Requires="p14">
            <p:contentPart p14:bwMode="auto" r:id="rId37">
              <p14:nvContentPartPr>
                <p14:cNvPr id="51" name="Ink 50">
                  <a:extLst>
                    <a:ext uri="{FF2B5EF4-FFF2-40B4-BE49-F238E27FC236}">
                      <a16:creationId xmlns:a16="http://schemas.microsoft.com/office/drawing/2014/main" id="{783866D0-87F4-9370-A22A-53DC24B43422}"/>
                    </a:ext>
                  </a:extLst>
                </p14:cNvPr>
                <p14:cNvContentPartPr/>
                <p14:nvPr/>
              </p14:nvContentPartPr>
              <p14:xfrm>
                <a:off x="4239265" y="5104762"/>
                <a:ext cx="681480" cy="694800"/>
              </p14:xfrm>
            </p:contentPart>
          </mc:Choice>
          <mc:Fallback xmlns="">
            <p:pic>
              <p:nvPicPr>
                <p:cNvPr id="51" name="Ink 50">
                  <a:extLst>
                    <a:ext uri="{FF2B5EF4-FFF2-40B4-BE49-F238E27FC236}">
                      <a16:creationId xmlns:a16="http://schemas.microsoft.com/office/drawing/2014/main" id="{783866D0-87F4-9370-A22A-53DC24B43422}"/>
                    </a:ext>
                  </a:extLst>
                </p:cNvPr>
                <p:cNvPicPr/>
                <p:nvPr/>
              </p:nvPicPr>
              <p:blipFill>
                <a:blip r:embed="rId38"/>
                <a:stretch>
                  <a:fillRect/>
                </a:stretch>
              </p:blipFill>
              <p:spPr>
                <a:xfrm>
                  <a:off x="4176265" y="5041762"/>
                  <a:ext cx="807120" cy="820440"/>
                </a:xfrm>
                <a:prstGeom prst="rect">
                  <a:avLst/>
                </a:prstGeom>
              </p:spPr>
            </p:pic>
          </mc:Fallback>
        </mc:AlternateContent>
        <mc:AlternateContent xmlns:mc="http://schemas.openxmlformats.org/markup-compatibility/2006" xmlns:p14="http://schemas.microsoft.com/office/powerpoint/2010/main">
          <mc:Choice Requires="p14">
            <p:contentPart p14:bwMode="auto" r:id="rId39">
              <p14:nvContentPartPr>
                <p14:cNvPr id="52" name="Ink 51">
                  <a:extLst>
                    <a:ext uri="{FF2B5EF4-FFF2-40B4-BE49-F238E27FC236}">
                      <a16:creationId xmlns:a16="http://schemas.microsoft.com/office/drawing/2014/main" id="{09AEB23A-6158-D542-E91C-B486B6A43FE6}"/>
                    </a:ext>
                  </a:extLst>
                </p14:cNvPr>
                <p14:cNvContentPartPr/>
                <p14:nvPr/>
              </p14:nvContentPartPr>
              <p14:xfrm>
                <a:off x="4178785" y="4958962"/>
                <a:ext cx="587520" cy="480600"/>
              </p14:xfrm>
            </p:contentPart>
          </mc:Choice>
          <mc:Fallback xmlns="">
            <p:pic>
              <p:nvPicPr>
                <p:cNvPr id="52" name="Ink 51">
                  <a:extLst>
                    <a:ext uri="{FF2B5EF4-FFF2-40B4-BE49-F238E27FC236}">
                      <a16:creationId xmlns:a16="http://schemas.microsoft.com/office/drawing/2014/main" id="{09AEB23A-6158-D542-E91C-B486B6A43FE6}"/>
                    </a:ext>
                  </a:extLst>
                </p:cNvPr>
                <p:cNvPicPr/>
                <p:nvPr/>
              </p:nvPicPr>
              <p:blipFill>
                <a:blip r:embed="rId40"/>
                <a:stretch>
                  <a:fillRect/>
                </a:stretch>
              </p:blipFill>
              <p:spPr>
                <a:xfrm>
                  <a:off x="4115785" y="4896009"/>
                  <a:ext cx="713160" cy="606146"/>
                </a:xfrm>
                <a:prstGeom prst="rect">
                  <a:avLst/>
                </a:prstGeom>
              </p:spPr>
            </p:pic>
          </mc:Fallback>
        </mc:AlternateContent>
        <mc:AlternateContent xmlns:mc="http://schemas.openxmlformats.org/markup-compatibility/2006" xmlns:p14="http://schemas.microsoft.com/office/powerpoint/2010/main">
          <mc:Choice Requires="p14">
            <p:contentPart p14:bwMode="auto" r:id="rId41">
              <p14:nvContentPartPr>
                <p14:cNvPr id="53" name="Ink 52">
                  <a:extLst>
                    <a:ext uri="{FF2B5EF4-FFF2-40B4-BE49-F238E27FC236}">
                      <a16:creationId xmlns:a16="http://schemas.microsoft.com/office/drawing/2014/main" id="{25185725-8D47-89EF-8DE9-87D9D03146E0}"/>
                    </a:ext>
                  </a:extLst>
                </p14:cNvPr>
                <p14:cNvContentPartPr/>
                <p14:nvPr/>
              </p14:nvContentPartPr>
              <p14:xfrm>
                <a:off x="4128745" y="4386562"/>
                <a:ext cx="999720" cy="569160"/>
              </p14:xfrm>
            </p:contentPart>
          </mc:Choice>
          <mc:Fallback xmlns="">
            <p:pic>
              <p:nvPicPr>
                <p:cNvPr id="53" name="Ink 52">
                  <a:extLst>
                    <a:ext uri="{FF2B5EF4-FFF2-40B4-BE49-F238E27FC236}">
                      <a16:creationId xmlns:a16="http://schemas.microsoft.com/office/drawing/2014/main" id="{25185725-8D47-89EF-8DE9-87D9D03146E0}"/>
                    </a:ext>
                  </a:extLst>
                </p:cNvPr>
                <p:cNvPicPr/>
                <p:nvPr/>
              </p:nvPicPr>
              <p:blipFill>
                <a:blip r:embed="rId42"/>
                <a:stretch>
                  <a:fillRect/>
                </a:stretch>
              </p:blipFill>
              <p:spPr>
                <a:xfrm>
                  <a:off x="4065722" y="4323562"/>
                  <a:ext cx="1125405" cy="694800"/>
                </a:xfrm>
                <a:prstGeom prst="rect">
                  <a:avLst/>
                </a:prstGeom>
              </p:spPr>
            </p:pic>
          </mc:Fallback>
        </mc:AlternateContent>
        <mc:AlternateContent xmlns:mc="http://schemas.openxmlformats.org/markup-compatibility/2006" xmlns:p14="http://schemas.microsoft.com/office/powerpoint/2010/main">
          <mc:Choice Requires="p14">
            <p:contentPart p14:bwMode="auto" r:id="rId43">
              <p14:nvContentPartPr>
                <p14:cNvPr id="54" name="Ink 53">
                  <a:extLst>
                    <a:ext uri="{FF2B5EF4-FFF2-40B4-BE49-F238E27FC236}">
                      <a16:creationId xmlns:a16="http://schemas.microsoft.com/office/drawing/2014/main" id="{930AE05E-0022-F7EF-F160-91334207D305}"/>
                    </a:ext>
                  </a:extLst>
                </p14:cNvPr>
                <p14:cNvContentPartPr/>
                <p14:nvPr/>
              </p14:nvContentPartPr>
              <p14:xfrm>
                <a:off x="4122265" y="3876442"/>
                <a:ext cx="1384200" cy="653400"/>
              </p14:xfrm>
            </p:contentPart>
          </mc:Choice>
          <mc:Fallback xmlns="">
            <p:pic>
              <p:nvPicPr>
                <p:cNvPr id="54" name="Ink 53">
                  <a:extLst>
                    <a:ext uri="{FF2B5EF4-FFF2-40B4-BE49-F238E27FC236}">
                      <a16:creationId xmlns:a16="http://schemas.microsoft.com/office/drawing/2014/main" id="{930AE05E-0022-F7EF-F160-91334207D305}"/>
                    </a:ext>
                  </a:extLst>
                </p:cNvPr>
                <p:cNvPicPr/>
                <p:nvPr/>
              </p:nvPicPr>
              <p:blipFill>
                <a:blip r:embed="rId44"/>
                <a:stretch>
                  <a:fillRect/>
                </a:stretch>
              </p:blipFill>
              <p:spPr>
                <a:xfrm>
                  <a:off x="4059265" y="3813442"/>
                  <a:ext cx="1509840" cy="779040"/>
                </a:xfrm>
                <a:prstGeom prst="rect">
                  <a:avLst/>
                </a:prstGeom>
              </p:spPr>
            </p:pic>
          </mc:Fallback>
        </mc:AlternateContent>
        <mc:AlternateContent xmlns:mc="http://schemas.openxmlformats.org/markup-compatibility/2006" xmlns:p14="http://schemas.microsoft.com/office/powerpoint/2010/main">
          <mc:Choice Requires="p14">
            <p:contentPart p14:bwMode="auto" r:id="rId45">
              <p14:nvContentPartPr>
                <p14:cNvPr id="55" name="Ink 54">
                  <a:extLst>
                    <a:ext uri="{FF2B5EF4-FFF2-40B4-BE49-F238E27FC236}">
                      <a16:creationId xmlns:a16="http://schemas.microsoft.com/office/drawing/2014/main" id="{B5630393-32C6-555D-6570-BAC19D2182B4}"/>
                    </a:ext>
                  </a:extLst>
                </p14:cNvPr>
                <p14:cNvContentPartPr/>
                <p14:nvPr/>
              </p14:nvContentPartPr>
              <p14:xfrm>
                <a:off x="5213065" y="3848002"/>
                <a:ext cx="358560" cy="478800"/>
              </p14:xfrm>
            </p:contentPart>
          </mc:Choice>
          <mc:Fallback xmlns="">
            <p:pic>
              <p:nvPicPr>
                <p:cNvPr id="55" name="Ink 54">
                  <a:extLst>
                    <a:ext uri="{FF2B5EF4-FFF2-40B4-BE49-F238E27FC236}">
                      <a16:creationId xmlns:a16="http://schemas.microsoft.com/office/drawing/2014/main" id="{B5630393-32C6-555D-6570-BAC19D2182B4}"/>
                    </a:ext>
                  </a:extLst>
                </p:cNvPr>
                <p:cNvPicPr/>
                <p:nvPr/>
              </p:nvPicPr>
              <p:blipFill>
                <a:blip r:embed="rId46"/>
                <a:stretch>
                  <a:fillRect/>
                </a:stretch>
              </p:blipFill>
              <p:spPr>
                <a:xfrm>
                  <a:off x="5150002" y="3785002"/>
                  <a:ext cx="484326" cy="604440"/>
                </a:xfrm>
                <a:prstGeom prst="rect">
                  <a:avLst/>
                </a:prstGeom>
              </p:spPr>
            </p:pic>
          </mc:Fallback>
        </mc:AlternateContent>
        <mc:AlternateContent xmlns:mc="http://schemas.openxmlformats.org/markup-compatibility/2006" xmlns:p14="http://schemas.microsoft.com/office/powerpoint/2010/main">
          <mc:Choice Requires="p14">
            <p:contentPart p14:bwMode="auto" r:id="rId47">
              <p14:nvContentPartPr>
                <p14:cNvPr id="58" name="Ink 57">
                  <a:extLst>
                    <a:ext uri="{FF2B5EF4-FFF2-40B4-BE49-F238E27FC236}">
                      <a16:creationId xmlns:a16="http://schemas.microsoft.com/office/drawing/2014/main" id="{09042EE0-8778-3FA0-8F71-2766A54CA417}"/>
                    </a:ext>
                  </a:extLst>
                </p14:cNvPr>
                <p14:cNvContentPartPr/>
                <p14:nvPr/>
              </p14:nvContentPartPr>
              <p14:xfrm>
                <a:off x="5499265" y="3639922"/>
                <a:ext cx="300240" cy="259560"/>
              </p14:xfrm>
            </p:contentPart>
          </mc:Choice>
          <mc:Fallback xmlns="">
            <p:pic>
              <p:nvPicPr>
                <p:cNvPr id="58" name="Ink 57">
                  <a:extLst>
                    <a:ext uri="{FF2B5EF4-FFF2-40B4-BE49-F238E27FC236}">
                      <a16:creationId xmlns:a16="http://schemas.microsoft.com/office/drawing/2014/main" id="{09042EE0-8778-3FA0-8F71-2766A54CA417}"/>
                    </a:ext>
                  </a:extLst>
                </p:cNvPr>
                <p:cNvPicPr/>
                <p:nvPr/>
              </p:nvPicPr>
              <p:blipFill>
                <a:blip r:embed="rId48"/>
                <a:stretch>
                  <a:fillRect/>
                </a:stretch>
              </p:blipFill>
              <p:spPr>
                <a:xfrm>
                  <a:off x="5436189" y="3576922"/>
                  <a:ext cx="426031" cy="385200"/>
                </a:xfrm>
                <a:prstGeom prst="rect">
                  <a:avLst/>
                </a:prstGeom>
              </p:spPr>
            </p:pic>
          </mc:Fallback>
        </mc:AlternateContent>
        <mc:AlternateContent xmlns:mc="http://schemas.openxmlformats.org/markup-compatibility/2006" xmlns:p14="http://schemas.microsoft.com/office/powerpoint/2010/main">
          <mc:Choice Requires="p14">
            <p:contentPart p14:bwMode="auto" r:id="rId49">
              <p14:nvContentPartPr>
                <p14:cNvPr id="59" name="Ink 58">
                  <a:extLst>
                    <a:ext uri="{FF2B5EF4-FFF2-40B4-BE49-F238E27FC236}">
                      <a16:creationId xmlns:a16="http://schemas.microsoft.com/office/drawing/2014/main" id="{93CBC600-E043-53E8-BAAF-56EAA5BA50B7}"/>
                    </a:ext>
                  </a:extLst>
                </p14:cNvPr>
                <p14:cNvContentPartPr/>
                <p14:nvPr/>
              </p14:nvContentPartPr>
              <p14:xfrm>
                <a:off x="6441025" y="3191722"/>
                <a:ext cx="1705320" cy="897120"/>
              </p14:xfrm>
            </p:contentPart>
          </mc:Choice>
          <mc:Fallback xmlns="">
            <p:pic>
              <p:nvPicPr>
                <p:cNvPr id="59" name="Ink 58">
                  <a:extLst>
                    <a:ext uri="{FF2B5EF4-FFF2-40B4-BE49-F238E27FC236}">
                      <a16:creationId xmlns:a16="http://schemas.microsoft.com/office/drawing/2014/main" id="{93CBC600-E043-53E8-BAAF-56EAA5BA50B7}"/>
                    </a:ext>
                  </a:extLst>
                </p:cNvPr>
                <p:cNvPicPr/>
                <p:nvPr/>
              </p:nvPicPr>
              <p:blipFill>
                <a:blip r:embed="rId50"/>
                <a:stretch>
                  <a:fillRect/>
                </a:stretch>
              </p:blipFill>
              <p:spPr>
                <a:xfrm>
                  <a:off x="6378025" y="3128722"/>
                  <a:ext cx="1830960" cy="1022760"/>
                </a:xfrm>
                <a:prstGeom prst="rect">
                  <a:avLst/>
                </a:prstGeom>
              </p:spPr>
            </p:pic>
          </mc:Fallback>
        </mc:AlternateContent>
        <mc:AlternateContent xmlns:mc="http://schemas.openxmlformats.org/markup-compatibility/2006" xmlns:p14="http://schemas.microsoft.com/office/powerpoint/2010/main">
          <mc:Choice Requires="p14">
            <p:contentPart p14:bwMode="auto" r:id="rId51">
              <p14:nvContentPartPr>
                <p14:cNvPr id="60" name="Ink 59">
                  <a:extLst>
                    <a:ext uri="{FF2B5EF4-FFF2-40B4-BE49-F238E27FC236}">
                      <a16:creationId xmlns:a16="http://schemas.microsoft.com/office/drawing/2014/main" id="{85E0F25C-996A-6FBF-1A21-6A5F3D6A9063}"/>
                    </a:ext>
                  </a:extLst>
                </p14:cNvPr>
                <p14:cNvContentPartPr/>
                <p14:nvPr/>
              </p14:nvContentPartPr>
              <p14:xfrm>
                <a:off x="6353185" y="3780682"/>
                <a:ext cx="1159200" cy="1837800"/>
              </p14:xfrm>
            </p:contentPart>
          </mc:Choice>
          <mc:Fallback xmlns="">
            <p:pic>
              <p:nvPicPr>
                <p:cNvPr id="60" name="Ink 59">
                  <a:extLst>
                    <a:ext uri="{FF2B5EF4-FFF2-40B4-BE49-F238E27FC236}">
                      <a16:creationId xmlns:a16="http://schemas.microsoft.com/office/drawing/2014/main" id="{85E0F25C-996A-6FBF-1A21-6A5F3D6A9063}"/>
                    </a:ext>
                  </a:extLst>
                </p:cNvPr>
                <p:cNvPicPr/>
                <p:nvPr/>
              </p:nvPicPr>
              <p:blipFill>
                <a:blip r:embed="rId52"/>
                <a:stretch>
                  <a:fillRect/>
                </a:stretch>
              </p:blipFill>
              <p:spPr>
                <a:xfrm>
                  <a:off x="6290185" y="3717682"/>
                  <a:ext cx="1284840" cy="1963440"/>
                </a:xfrm>
                <a:prstGeom prst="rect">
                  <a:avLst/>
                </a:prstGeom>
              </p:spPr>
            </p:pic>
          </mc:Fallback>
        </mc:AlternateContent>
        <mc:AlternateContent xmlns:mc="http://schemas.openxmlformats.org/markup-compatibility/2006" xmlns:p14="http://schemas.microsoft.com/office/powerpoint/2010/main">
          <mc:Choice Requires="p14">
            <p:contentPart p14:bwMode="auto" r:id="rId53">
              <p14:nvContentPartPr>
                <p14:cNvPr id="61" name="Ink 60">
                  <a:extLst>
                    <a:ext uri="{FF2B5EF4-FFF2-40B4-BE49-F238E27FC236}">
                      <a16:creationId xmlns:a16="http://schemas.microsoft.com/office/drawing/2014/main" id="{9CBEB30B-99ED-9C64-5AA5-FC4263F73DFD}"/>
                    </a:ext>
                  </a:extLst>
                </p14:cNvPr>
                <p14:cNvContentPartPr/>
                <p14:nvPr/>
              </p14:nvContentPartPr>
              <p14:xfrm>
                <a:off x="7512385" y="5585362"/>
                <a:ext cx="540720" cy="256680"/>
              </p14:xfrm>
            </p:contentPart>
          </mc:Choice>
          <mc:Fallback xmlns="">
            <p:pic>
              <p:nvPicPr>
                <p:cNvPr id="61" name="Ink 60">
                  <a:extLst>
                    <a:ext uri="{FF2B5EF4-FFF2-40B4-BE49-F238E27FC236}">
                      <a16:creationId xmlns:a16="http://schemas.microsoft.com/office/drawing/2014/main" id="{9CBEB30B-99ED-9C64-5AA5-FC4263F73DFD}"/>
                    </a:ext>
                  </a:extLst>
                </p:cNvPr>
                <p:cNvPicPr/>
                <p:nvPr/>
              </p:nvPicPr>
              <p:blipFill>
                <a:blip r:embed="rId54"/>
                <a:stretch>
                  <a:fillRect/>
                </a:stretch>
              </p:blipFill>
              <p:spPr>
                <a:xfrm>
                  <a:off x="7449385" y="5522362"/>
                  <a:ext cx="666360" cy="382320"/>
                </a:xfrm>
                <a:prstGeom prst="rect">
                  <a:avLst/>
                </a:prstGeom>
              </p:spPr>
            </p:pic>
          </mc:Fallback>
        </mc:AlternateContent>
        <mc:AlternateContent xmlns:mc="http://schemas.openxmlformats.org/markup-compatibility/2006" xmlns:p14="http://schemas.microsoft.com/office/powerpoint/2010/main">
          <mc:Choice Requires="p14">
            <p:contentPart p14:bwMode="auto" r:id="rId55">
              <p14:nvContentPartPr>
                <p14:cNvPr id="62" name="Ink 61">
                  <a:extLst>
                    <a:ext uri="{FF2B5EF4-FFF2-40B4-BE49-F238E27FC236}">
                      <a16:creationId xmlns:a16="http://schemas.microsoft.com/office/drawing/2014/main" id="{38994EDA-C430-C0AE-C18A-1BF4E35BBC9F}"/>
                    </a:ext>
                  </a:extLst>
                </p14:cNvPr>
                <p14:cNvContentPartPr/>
                <p14:nvPr/>
              </p14:nvContentPartPr>
              <p14:xfrm>
                <a:off x="7402945" y="4954282"/>
                <a:ext cx="711000" cy="447480"/>
              </p14:xfrm>
            </p:contentPart>
          </mc:Choice>
          <mc:Fallback xmlns="">
            <p:pic>
              <p:nvPicPr>
                <p:cNvPr id="62" name="Ink 61">
                  <a:extLst>
                    <a:ext uri="{FF2B5EF4-FFF2-40B4-BE49-F238E27FC236}">
                      <a16:creationId xmlns:a16="http://schemas.microsoft.com/office/drawing/2014/main" id="{38994EDA-C430-C0AE-C18A-1BF4E35BBC9F}"/>
                    </a:ext>
                  </a:extLst>
                </p:cNvPr>
                <p:cNvPicPr/>
                <p:nvPr/>
              </p:nvPicPr>
              <p:blipFill>
                <a:blip r:embed="rId56"/>
                <a:stretch>
                  <a:fillRect/>
                </a:stretch>
              </p:blipFill>
              <p:spPr>
                <a:xfrm>
                  <a:off x="7339945" y="4891282"/>
                  <a:ext cx="836640" cy="573120"/>
                </a:xfrm>
                <a:prstGeom prst="rect">
                  <a:avLst/>
                </a:prstGeom>
              </p:spPr>
            </p:pic>
          </mc:Fallback>
        </mc:AlternateContent>
        <mc:AlternateContent xmlns:mc="http://schemas.openxmlformats.org/markup-compatibility/2006" xmlns:p14="http://schemas.microsoft.com/office/powerpoint/2010/main">
          <mc:Choice Requires="p14">
            <p:contentPart p14:bwMode="auto" r:id="rId57">
              <p14:nvContentPartPr>
                <p14:cNvPr id="63" name="Ink 62">
                  <a:extLst>
                    <a:ext uri="{FF2B5EF4-FFF2-40B4-BE49-F238E27FC236}">
                      <a16:creationId xmlns:a16="http://schemas.microsoft.com/office/drawing/2014/main" id="{88B20989-0CAE-19DF-CEA7-AD118A683589}"/>
                    </a:ext>
                  </a:extLst>
                </p14:cNvPr>
                <p14:cNvContentPartPr/>
                <p14:nvPr/>
              </p14:nvContentPartPr>
              <p14:xfrm>
                <a:off x="6966265" y="4418962"/>
                <a:ext cx="1194840" cy="561960"/>
              </p14:xfrm>
            </p:contentPart>
          </mc:Choice>
          <mc:Fallback xmlns="">
            <p:pic>
              <p:nvPicPr>
                <p:cNvPr id="63" name="Ink 62">
                  <a:extLst>
                    <a:ext uri="{FF2B5EF4-FFF2-40B4-BE49-F238E27FC236}">
                      <a16:creationId xmlns:a16="http://schemas.microsoft.com/office/drawing/2014/main" id="{88B20989-0CAE-19DF-CEA7-AD118A683589}"/>
                    </a:ext>
                  </a:extLst>
                </p:cNvPr>
                <p:cNvPicPr/>
                <p:nvPr/>
              </p:nvPicPr>
              <p:blipFill>
                <a:blip r:embed="rId58"/>
                <a:stretch>
                  <a:fillRect/>
                </a:stretch>
              </p:blipFill>
              <p:spPr>
                <a:xfrm>
                  <a:off x="6903265" y="4355962"/>
                  <a:ext cx="1320480" cy="687600"/>
                </a:xfrm>
                <a:prstGeom prst="rect">
                  <a:avLst/>
                </a:prstGeom>
              </p:spPr>
            </p:pic>
          </mc:Fallback>
        </mc:AlternateContent>
        <mc:AlternateContent xmlns:mc="http://schemas.openxmlformats.org/markup-compatibility/2006" xmlns:p14="http://schemas.microsoft.com/office/powerpoint/2010/main">
          <mc:Choice Requires="p14">
            <p:contentPart p14:bwMode="auto" r:id="rId59">
              <p14:nvContentPartPr>
                <p14:cNvPr id="1024" name="Ink 1023">
                  <a:extLst>
                    <a:ext uri="{FF2B5EF4-FFF2-40B4-BE49-F238E27FC236}">
                      <a16:creationId xmlns:a16="http://schemas.microsoft.com/office/drawing/2014/main" id="{689C4709-0020-D1F7-2D47-4200B4E30087}"/>
                    </a:ext>
                  </a:extLst>
                </p14:cNvPr>
                <p14:cNvContentPartPr/>
                <p14:nvPr/>
              </p14:nvContentPartPr>
              <p14:xfrm>
                <a:off x="6650905" y="3901642"/>
                <a:ext cx="1502280" cy="675360"/>
              </p14:xfrm>
            </p:contentPart>
          </mc:Choice>
          <mc:Fallback xmlns="">
            <p:pic>
              <p:nvPicPr>
                <p:cNvPr id="1024" name="Ink 1023">
                  <a:extLst>
                    <a:ext uri="{FF2B5EF4-FFF2-40B4-BE49-F238E27FC236}">
                      <a16:creationId xmlns:a16="http://schemas.microsoft.com/office/drawing/2014/main" id="{689C4709-0020-D1F7-2D47-4200B4E30087}"/>
                    </a:ext>
                  </a:extLst>
                </p:cNvPr>
                <p:cNvPicPr/>
                <p:nvPr/>
              </p:nvPicPr>
              <p:blipFill>
                <a:blip r:embed="rId60"/>
                <a:stretch>
                  <a:fillRect/>
                </a:stretch>
              </p:blipFill>
              <p:spPr>
                <a:xfrm>
                  <a:off x="6587905" y="3838642"/>
                  <a:ext cx="1627920" cy="801000"/>
                </a:xfrm>
                <a:prstGeom prst="rect">
                  <a:avLst/>
                </a:prstGeom>
              </p:spPr>
            </p:pic>
          </mc:Fallback>
        </mc:AlternateContent>
        <mc:AlternateContent xmlns:mc="http://schemas.openxmlformats.org/markup-compatibility/2006" xmlns:p14="http://schemas.microsoft.com/office/powerpoint/2010/main">
          <mc:Choice Requires="p14">
            <p:contentPart p14:bwMode="auto" r:id="rId61">
              <p14:nvContentPartPr>
                <p14:cNvPr id="1025" name="Ink 1024">
                  <a:extLst>
                    <a:ext uri="{FF2B5EF4-FFF2-40B4-BE49-F238E27FC236}">
                      <a16:creationId xmlns:a16="http://schemas.microsoft.com/office/drawing/2014/main" id="{ED1D80F5-B07D-1FCC-942E-E9E011E9401F}"/>
                    </a:ext>
                  </a:extLst>
                </p14:cNvPr>
                <p14:cNvContentPartPr/>
                <p14:nvPr/>
              </p14:nvContentPartPr>
              <p14:xfrm>
                <a:off x="6717505" y="3985162"/>
                <a:ext cx="420840" cy="465480"/>
              </p14:xfrm>
            </p:contentPart>
          </mc:Choice>
          <mc:Fallback xmlns="">
            <p:pic>
              <p:nvPicPr>
                <p:cNvPr id="1025" name="Ink 1024">
                  <a:extLst>
                    <a:ext uri="{FF2B5EF4-FFF2-40B4-BE49-F238E27FC236}">
                      <a16:creationId xmlns:a16="http://schemas.microsoft.com/office/drawing/2014/main" id="{ED1D80F5-B07D-1FCC-942E-E9E011E9401F}"/>
                    </a:ext>
                  </a:extLst>
                </p:cNvPr>
                <p:cNvPicPr/>
                <p:nvPr/>
              </p:nvPicPr>
              <p:blipFill>
                <a:blip r:embed="rId62"/>
                <a:stretch>
                  <a:fillRect/>
                </a:stretch>
              </p:blipFill>
              <p:spPr>
                <a:xfrm>
                  <a:off x="6654451" y="3922162"/>
                  <a:ext cx="546588" cy="591120"/>
                </a:xfrm>
                <a:prstGeom prst="rect">
                  <a:avLst/>
                </a:prstGeom>
              </p:spPr>
            </p:pic>
          </mc:Fallback>
        </mc:AlternateContent>
      </p:grpSp>
      <p:pic>
        <p:nvPicPr>
          <p:cNvPr id="5" name="Picture 4" descr="Peritoneal lining in transverse section abdomen (caudal view)">
            <a:extLst>
              <a:ext uri="{FF2B5EF4-FFF2-40B4-BE49-F238E27FC236}">
                <a16:creationId xmlns:a16="http://schemas.microsoft.com/office/drawing/2014/main" id="{CF6E9CA2-0C48-233B-70B7-775C4F9D926B}"/>
              </a:ext>
            </a:extLst>
          </p:cNvPr>
          <p:cNvPicPr>
            <a:picLocks noChangeAspect="1" noChangeArrowheads="1"/>
          </p:cNvPicPr>
          <p:nvPr/>
        </p:nvPicPr>
        <p:blipFill>
          <a:blip r:embed="rId63">
            <a:extLst>
              <a:ext uri="{28A0092B-C50C-407E-A947-70E740481C1C}">
                <a14:useLocalDpi xmlns:a14="http://schemas.microsoft.com/office/drawing/2010/main" val="0"/>
              </a:ext>
            </a:extLst>
          </a:blip>
          <a:srcRect/>
          <a:stretch>
            <a:fillRect/>
          </a:stretch>
        </p:blipFill>
        <p:spPr bwMode="auto">
          <a:xfrm>
            <a:off x="3057662" y="653002"/>
            <a:ext cx="5896965" cy="4797531"/>
          </a:xfrm>
          <a:prstGeom prst="rect">
            <a:avLst/>
          </a:prstGeom>
          <a:noFill/>
          <a:extLst>
            <a:ext uri="{909E8E84-426E-40DD-AFC4-6F175D3DCCD1}">
              <a14:hiddenFill xmlns:a14="http://schemas.microsoft.com/office/drawing/2010/main">
                <a:solidFill>
                  <a:srgbClr val="FFFFFF"/>
                </a:solidFill>
              </a14:hiddenFill>
            </a:ext>
          </a:extLst>
        </p:spPr>
      </p:pic>
      <mc:AlternateContent xmlns:mc="http://schemas.openxmlformats.org/markup-compatibility/2006" xmlns:p14="http://schemas.microsoft.com/office/powerpoint/2010/main">
        <mc:Choice Requires="p14">
          <p:contentPart p14:bwMode="auto" r:id="rId64">
            <p14:nvContentPartPr>
              <p14:cNvPr id="7" name="Ink 6">
                <a:extLst>
                  <a:ext uri="{FF2B5EF4-FFF2-40B4-BE49-F238E27FC236}">
                    <a16:creationId xmlns:a16="http://schemas.microsoft.com/office/drawing/2014/main" id="{877F70A8-883A-E516-B741-7F572566A20C}"/>
                  </a:ext>
                </a:extLst>
              </p14:cNvPr>
              <p14:cNvContentPartPr/>
              <p14:nvPr/>
            </p14:nvContentPartPr>
            <p14:xfrm>
              <a:off x="7374926" y="3084394"/>
              <a:ext cx="1019160" cy="1305720"/>
            </p14:xfrm>
          </p:contentPart>
        </mc:Choice>
        <mc:Fallback xmlns="">
          <p:pic>
            <p:nvPicPr>
              <p:cNvPr id="7" name="Ink 6">
                <a:extLst>
                  <a:ext uri="{FF2B5EF4-FFF2-40B4-BE49-F238E27FC236}">
                    <a16:creationId xmlns:a16="http://schemas.microsoft.com/office/drawing/2014/main" id="{877F70A8-883A-E516-B741-7F572566A20C}"/>
                  </a:ext>
                </a:extLst>
              </p:cNvPr>
              <p:cNvPicPr/>
              <p:nvPr/>
            </p:nvPicPr>
            <p:blipFill>
              <a:blip r:embed="rId65"/>
              <a:stretch>
                <a:fillRect/>
              </a:stretch>
            </p:blipFill>
            <p:spPr>
              <a:xfrm>
                <a:off x="7356926" y="3066394"/>
                <a:ext cx="1054800" cy="1341360"/>
              </a:xfrm>
              <a:prstGeom prst="rect">
                <a:avLst/>
              </a:prstGeom>
            </p:spPr>
          </p:pic>
        </mc:Fallback>
      </mc:AlternateContent>
      <p:pic>
        <p:nvPicPr>
          <p:cNvPr id="1030" name="Picture 6">
            <a:extLst>
              <a:ext uri="{FF2B5EF4-FFF2-40B4-BE49-F238E27FC236}">
                <a16:creationId xmlns:a16="http://schemas.microsoft.com/office/drawing/2014/main" id="{3AA349F4-940E-7934-C1B3-2FC5EAF7E7CC}"/>
              </a:ext>
            </a:extLst>
          </p:cNvPr>
          <p:cNvPicPr>
            <a:picLocks noChangeAspect="1" noChangeArrowheads="1"/>
          </p:cNvPicPr>
          <p:nvPr/>
        </p:nvPicPr>
        <p:blipFill>
          <a:blip r:embed="rId66">
            <a:extLst>
              <a:ext uri="{28A0092B-C50C-407E-A947-70E740481C1C}">
                <a14:useLocalDpi xmlns:a14="http://schemas.microsoft.com/office/drawing/2010/main" val="0"/>
              </a:ext>
            </a:extLst>
          </a:blip>
          <a:srcRect/>
          <a:stretch>
            <a:fillRect/>
          </a:stretch>
        </p:blipFill>
        <p:spPr bwMode="auto">
          <a:xfrm>
            <a:off x="7563685" y="5217853"/>
            <a:ext cx="830401" cy="290640"/>
          </a:xfrm>
          <a:prstGeom prst="rect">
            <a:avLst/>
          </a:prstGeom>
          <a:noFill/>
          <a:extLst>
            <a:ext uri="{909E8E84-426E-40DD-AFC4-6F175D3DCCD1}">
              <a14:hiddenFill xmlns:a14="http://schemas.microsoft.com/office/drawing/2010/main">
                <a:solidFill>
                  <a:srgbClr val="FFFFFF"/>
                </a:solidFill>
              </a14:hiddenFill>
            </a:ext>
          </a:extLst>
        </p:spPr>
      </p:pic>
      <mc:AlternateContent xmlns:mc="http://schemas.openxmlformats.org/markup-compatibility/2006" xmlns:p14="http://schemas.microsoft.com/office/powerpoint/2010/main">
        <mc:Choice Requires="p14">
          <p:contentPart p14:bwMode="auto" r:id="rId67">
            <p14:nvContentPartPr>
              <p14:cNvPr id="8" name="Ink 7">
                <a:extLst>
                  <a:ext uri="{FF2B5EF4-FFF2-40B4-BE49-F238E27FC236}">
                    <a16:creationId xmlns:a16="http://schemas.microsoft.com/office/drawing/2014/main" id="{DD5CF5E9-27FF-1401-24E1-4B32CC1351B3}"/>
                  </a:ext>
                </a:extLst>
              </p14:cNvPr>
              <p14:cNvContentPartPr/>
              <p14:nvPr/>
            </p14:nvContentPartPr>
            <p14:xfrm>
              <a:off x="6714326" y="3872074"/>
              <a:ext cx="360" cy="360"/>
            </p14:xfrm>
          </p:contentPart>
        </mc:Choice>
        <mc:Fallback xmlns="">
          <p:pic>
            <p:nvPicPr>
              <p:cNvPr id="8" name="Ink 7">
                <a:extLst>
                  <a:ext uri="{FF2B5EF4-FFF2-40B4-BE49-F238E27FC236}">
                    <a16:creationId xmlns:a16="http://schemas.microsoft.com/office/drawing/2014/main" id="{DD5CF5E9-27FF-1401-24E1-4B32CC1351B3}"/>
                  </a:ext>
                </a:extLst>
              </p:cNvPr>
              <p:cNvPicPr/>
              <p:nvPr/>
            </p:nvPicPr>
            <p:blipFill>
              <a:blip r:embed="rId68"/>
              <a:stretch>
                <a:fillRect/>
              </a:stretch>
            </p:blipFill>
            <p:spPr>
              <a:xfrm>
                <a:off x="6696326" y="3854074"/>
                <a:ext cx="36000" cy="36000"/>
              </a:xfrm>
              <a:prstGeom prst="rect">
                <a:avLst/>
              </a:prstGeom>
            </p:spPr>
          </p:pic>
        </mc:Fallback>
      </mc:AlternateContent>
      <mc:AlternateContent xmlns:mc="http://schemas.openxmlformats.org/markup-compatibility/2006" xmlns:p14="http://schemas.microsoft.com/office/powerpoint/2010/main">
        <mc:Choice Requires="p14">
          <p:contentPart p14:bwMode="auto" r:id="rId69">
            <p14:nvContentPartPr>
              <p14:cNvPr id="10" name="Ink 9">
                <a:extLst>
                  <a:ext uri="{FF2B5EF4-FFF2-40B4-BE49-F238E27FC236}">
                    <a16:creationId xmlns:a16="http://schemas.microsoft.com/office/drawing/2014/main" id="{5ECC0A3E-CC50-A76D-38DA-C0353C520379}"/>
                  </a:ext>
                </a:extLst>
              </p14:cNvPr>
              <p14:cNvContentPartPr/>
              <p14:nvPr/>
            </p14:nvContentPartPr>
            <p14:xfrm>
              <a:off x="6384566" y="3685234"/>
              <a:ext cx="939240" cy="881280"/>
            </p14:xfrm>
          </p:contentPart>
        </mc:Choice>
        <mc:Fallback xmlns="">
          <p:pic>
            <p:nvPicPr>
              <p:cNvPr id="10" name="Ink 9">
                <a:extLst>
                  <a:ext uri="{FF2B5EF4-FFF2-40B4-BE49-F238E27FC236}">
                    <a16:creationId xmlns:a16="http://schemas.microsoft.com/office/drawing/2014/main" id="{5ECC0A3E-CC50-A76D-38DA-C0353C520379}"/>
                  </a:ext>
                </a:extLst>
              </p:cNvPr>
              <p:cNvPicPr/>
              <p:nvPr/>
            </p:nvPicPr>
            <p:blipFill>
              <a:blip r:embed="rId70"/>
              <a:stretch>
                <a:fillRect/>
              </a:stretch>
            </p:blipFill>
            <p:spPr>
              <a:xfrm>
                <a:off x="6366566" y="3667234"/>
                <a:ext cx="974880" cy="916920"/>
              </a:xfrm>
              <a:prstGeom prst="rect">
                <a:avLst/>
              </a:prstGeom>
            </p:spPr>
          </p:pic>
        </mc:Fallback>
      </mc:AlternateContent>
      <mc:AlternateContent xmlns:mc="http://schemas.openxmlformats.org/markup-compatibility/2006" xmlns:p14="http://schemas.microsoft.com/office/powerpoint/2010/main">
        <mc:Choice Requires="p14">
          <p:contentPart p14:bwMode="auto" r:id="rId71">
            <p14:nvContentPartPr>
              <p14:cNvPr id="13" name="Ink 12">
                <a:extLst>
                  <a:ext uri="{FF2B5EF4-FFF2-40B4-BE49-F238E27FC236}">
                    <a16:creationId xmlns:a16="http://schemas.microsoft.com/office/drawing/2014/main" id="{DDADF3DA-15A0-BC94-A392-1C11F48899F0}"/>
                  </a:ext>
                </a:extLst>
              </p14:cNvPr>
              <p14:cNvContentPartPr/>
              <p14:nvPr/>
            </p14:nvContentPartPr>
            <p14:xfrm>
              <a:off x="7190246" y="3673714"/>
              <a:ext cx="910080" cy="794880"/>
            </p14:xfrm>
          </p:contentPart>
        </mc:Choice>
        <mc:Fallback xmlns="">
          <p:pic>
            <p:nvPicPr>
              <p:cNvPr id="13" name="Ink 12">
                <a:extLst>
                  <a:ext uri="{FF2B5EF4-FFF2-40B4-BE49-F238E27FC236}">
                    <a16:creationId xmlns:a16="http://schemas.microsoft.com/office/drawing/2014/main" id="{DDADF3DA-15A0-BC94-A392-1C11F48899F0}"/>
                  </a:ext>
                </a:extLst>
              </p:cNvPr>
              <p:cNvPicPr/>
              <p:nvPr/>
            </p:nvPicPr>
            <p:blipFill>
              <a:blip r:embed="rId72"/>
              <a:stretch>
                <a:fillRect/>
              </a:stretch>
            </p:blipFill>
            <p:spPr>
              <a:xfrm>
                <a:off x="7154606" y="3637714"/>
                <a:ext cx="981720" cy="866520"/>
              </a:xfrm>
              <a:prstGeom prst="rect">
                <a:avLst/>
              </a:prstGeom>
            </p:spPr>
          </p:pic>
        </mc:Fallback>
      </mc:AlternateContent>
      <p:pic>
        <p:nvPicPr>
          <p:cNvPr id="3" name="Audio Recording Sep 27, 2022 at 7:31:50 PM" descr="Audio Recording Sep 27, 2022 at 7:31:50 PM">
            <a:hlinkClick r:id="" action="ppaction://media"/>
            <a:extLst>
              <a:ext uri="{FF2B5EF4-FFF2-40B4-BE49-F238E27FC236}">
                <a16:creationId xmlns:a16="http://schemas.microsoft.com/office/drawing/2014/main" id="{ED82A564-2EB3-67B6-E4C8-AF378F9ED3F5}"/>
              </a:ext>
            </a:extLst>
          </p:cNvPr>
          <p:cNvPicPr>
            <a:picLocks noChangeAspect="1"/>
          </p:cNvPicPr>
          <p:nvPr>
            <a:audioFile r:link="rId2"/>
            <p:extLst>
              <p:ext uri="{DAA4B4D4-6D71-4841-9C94-3DE7FCFB9230}">
                <p14:media xmlns:p14="http://schemas.microsoft.com/office/powerpoint/2010/main" r:embed="rId1"/>
              </p:ext>
            </p:extLst>
          </p:nvPr>
        </p:nvPicPr>
        <p:blipFill>
          <a:blip r:embed="rId73"/>
          <a:stretch>
            <a:fillRect/>
          </a:stretch>
        </p:blipFill>
        <p:spPr>
          <a:xfrm>
            <a:off x="10902868" y="5307302"/>
            <a:ext cx="812800" cy="812800"/>
          </a:xfrm>
          <a:prstGeom prst="rect">
            <a:avLst/>
          </a:prstGeom>
        </p:spPr>
      </p:pic>
      <p:sp>
        <p:nvSpPr>
          <p:cNvPr id="4" name="TextBox 3">
            <a:extLst>
              <a:ext uri="{FF2B5EF4-FFF2-40B4-BE49-F238E27FC236}">
                <a16:creationId xmlns:a16="http://schemas.microsoft.com/office/drawing/2014/main" id="{28CAFC75-F8E4-151F-CD7E-FFCB3A563B11}"/>
              </a:ext>
            </a:extLst>
          </p:cNvPr>
          <p:cNvSpPr txBox="1"/>
          <p:nvPr/>
        </p:nvSpPr>
        <p:spPr>
          <a:xfrm>
            <a:off x="1775602" y="2726602"/>
            <a:ext cx="1520042" cy="369332"/>
          </a:xfrm>
          <a:prstGeom prst="rect">
            <a:avLst/>
          </a:prstGeom>
          <a:noFill/>
        </p:spPr>
        <p:txBody>
          <a:bodyPr wrap="square" rtlCol="0">
            <a:spAutoFit/>
          </a:bodyPr>
          <a:lstStyle/>
          <a:p>
            <a:r>
              <a:rPr lang="en-US" dirty="0"/>
              <a:t>Right</a:t>
            </a:r>
          </a:p>
        </p:txBody>
      </p:sp>
      <p:sp>
        <p:nvSpPr>
          <p:cNvPr id="6" name="TextBox 5">
            <a:extLst>
              <a:ext uri="{FF2B5EF4-FFF2-40B4-BE49-F238E27FC236}">
                <a16:creationId xmlns:a16="http://schemas.microsoft.com/office/drawing/2014/main" id="{3E83D91E-F0E9-31EF-C20D-5D2E408D13FA}"/>
              </a:ext>
            </a:extLst>
          </p:cNvPr>
          <p:cNvSpPr txBox="1"/>
          <p:nvPr/>
        </p:nvSpPr>
        <p:spPr>
          <a:xfrm>
            <a:off x="9348129" y="2720089"/>
            <a:ext cx="1520042" cy="369332"/>
          </a:xfrm>
          <a:prstGeom prst="rect">
            <a:avLst/>
          </a:prstGeom>
          <a:noFill/>
        </p:spPr>
        <p:txBody>
          <a:bodyPr wrap="square" rtlCol="0">
            <a:spAutoFit/>
          </a:bodyPr>
          <a:lstStyle/>
          <a:p>
            <a:r>
              <a:rPr lang="en-US" dirty="0"/>
              <a:t>Left</a:t>
            </a:r>
          </a:p>
        </p:txBody>
      </p:sp>
    </p:spTree>
    <p:extLst>
      <p:ext uri="{BB962C8B-B14F-4D97-AF65-F5344CB8AC3E}">
        <p14:creationId xmlns:p14="http://schemas.microsoft.com/office/powerpoint/2010/main" val="19897522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75264" fill="hold"/>
                                        <p:tgtEl>
                                          <p:spTgt spid="3"/>
                                        </p:tgtEl>
                                      </p:cBhvr>
                                    </p:cmd>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audio>
              <p:cMediaNode vol="80000">
                <p:cTn id="19" fill="hold" display="0">
                  <p:stCondLst>
                    <p:cond delay="indefinite"/>
                  </p:stCondLst>
                  <p:endCondLst>
                    <p:cond evt="onStopAudio" delay="0">
                      <p:tgtEl>
                        <p:sldTgt/>
                      </p:tgtEl>
                    </p:cond>
                  </p:endCondLst>
                </p:cTn>
                <p:tgtEl>
                  <p:spTgt spid="3"/>
                </p:tgtEl>
              </p:cMediaNode>
            </p:audio>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6262FDA-482B-2D18-B37A-F7F3FE872F94}"/>
              </a:ext>
            </a:extLst>
          </p:cNvPr>
          <p:cNvPicPr>
            <a:picLocks noChangeAspect="1"/>
          </p:cNvPicPr>
          <p:nvPr/>
        </p:nvPicPr>
        <p:blipFill>
          <a:blip r:embed="rId5"/>
          <a:stretch>
            <a:fillRect/>
          </a:stretch>
        </p:blipFill>
        <p:spPr>
          <a:xfrm>
            <a:off x="6054760" y="1289318"/>
            <a:ext cx="5799642" cy="4100926"/>
          </a:xfrm>
          <a:prstGeom prst="rect">
            <a:avLst/>
          </a:prstGeom>
        </p:spPr>
      </p:pic>
      <p:pic>
        <p:nvPicPr>
          <p:cNvPr id="5" name="Picture 4">
            <a:extLst>
              <a:ext uri="{FF2B5EF4-FFF2-40B4-BE49-F238E27FC236}">
                <a16:creationId xmlns:a16="http://schemas.microsoft.com/office/drawing/2014/main" id="{1BAD90BB-8CEF-4830-2DE4-56123F3150D6}"/>
              </a:ext>
            </a:extLst>
          </p:cNvPr>
          <p:cNvPicPr>
            <a:picLocks noChangeAspect="1"/>
          </p:cNvPicPr>
          <p:nvPr/>
        </p:nvPicPr>
        <p:blipFill>
          <a:blip r:embed="rId6"/>
          <a:stretch>
            <a:fillRect/>
          </a:stretch>
        </p:blipFill>
        <p:spPr>
          <a:xfrm>
            <a:off x="337599" y="1289318"/>
            <a:ext cx="5540687" cy="4129380"/>
          </a:xfrm>
          <a:prstGeom prst="rect">
            <a:avLst/>
          </a:prstGeom>
        </p:spPr>
      </p:pic>
      <p:sp>
        <p:nvSpPr>
          <p:cNvPr id="6" name="TextBox 5">
            <a:extLst>
              <a:ext uri="{FF2B5EF4-FFF2-40B4-BE49-F238E27FC236}">
                <a16:creationId xmlns:a16="http://schemas.microsoft.com/office/drawing/2014/main" id="{0C2F6DCF-C0DC-EBAE-A12B-BA043CFEE51D}"/>
              </a:ext>
            </a:extLst>
          </p:cNvPr>
          <p:cNvSpPr txBox="1"/>
          <p:nvPr/>
        </p:nvSpPr>
        <p:spPr>
          <a:xfrm>
            <a:off x="1979588" y="859580"/>
            <a:ext cx="2256708" cy="369332"/>
          </a:xfrm>
          <a:prstGeom prst="rect">
            <a:avLst/>
          </a:prstGeom>
          <a:noFill/>
        </p:spPr>
        <p:txBody>
          <a:bodyPr wrap="none" rtlCol="0">
            <a:spAutoFit/>
          </a:bodyPr>
          <a:lstStyle/>
          <a:p>
            <a:pPr algn="ctr"/>
            <a:r>
              <a:rPr lang="en-US" dirty="0"/>
              <a:t>Right upper quadrant</a:t>
            </a:r>
          </a:p>
        </p:txBody>
      </p:sp>
      <p:sp>
        <p:nvSpPr>
          <p:cNvPr id="7" name="TextBox 6">
            <a:extLst>
              <a:ext uri="{FF2B5EF4-FFF2-40B4-BE49-F238E27FC236}">
                <a16:creationId xmlns:a16="http://schemas.microsoft.com/office/drawing/2014/main" id="{530052C3-B391-48EE-0FE6-D6BE6B70A814}"/>
              </a:ext>
            </a:extLst>
          </p:cNvPr>
          <p:cNvSpPr txBox="1"/>
          <p:nvPr/>
        </p:nvSpPr>
        <p:spPr>
          <a:xfrm>
            <a:off x="7887943" y="859580"/>
            <a:ext cx="2133276" cy="369332"/>
          </a:xfrm>
          <a:prstGeom prst="rect">
            <a:avLst/>
          </a:prstGeom>
          <a:noFill/>
        </p:spPr>
        <p:txBody>
          <a:bodyPr wrap="none" rtlCol="0">
            <a:spAutoFit/>
          </a:bodyPr>
          <a:lstStyle/>
          <a:p>
            <a:pPr algn="ctr"/>
            <a:r>
              <a:rPr lang="en-US" dirty="0"/>
              <a:t>Left upper quadrant</a:t>
            </a:r>
          </a:p>
        </p:txBody>
      </p:sp>
      <p:pic>
        <p:nvPicPr>
          <p:cNvPr id="2" name="Audio Recording Sep 27, 2022 at 7:53:22 PM" descr="Audio Recording Sep 27, 2022 at 7:53:22 PM">
            <a:hlinkClick r:id="" action="ppaction://media"/>
            <a:extLst>
              <a:ext uri="{FF2B5EF4-FFF2-40B4-BE49-F238E27FC236}">
                <a16:creationId xmlns:a16="http://schemas.microsoft.com/office/drawing/2014/main" id="{8B0EA4F9-C0D3-3ABF-1EE1-1170E14BEEB7}"/>
              </a:ext>
            </a:extLst>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11041602" y="5601339"/>
            <a:ext cx="812800" cy="812800"/>
          </a:xfrm>
          <a:prstGeom prst="rect">
            <a:avLst/>
          </a:prstGeom>
        </p:spPr>
      </p:pic>
      <p:sp>
        <p:nvSpPr>
          <p:cNvPr id="3" name="TextBox 2">
            <a:extLst>
              <a:ext uri="{FF2B5EF4-FFF2-40B4-BE49-F238E27FC236}">
                <a16:creationId xmlns:a16="http://schemas.microsoft.com/office/drawing/2014/main" id="{E2B37A69-2373-3BDF-B739-C69F27856238}"/>
              </a:ext>
            </a:extLst>
          </p:cNvPr>
          <p:cNvSpPr txBox="1"/>
          <p:nvPr/>
        </p:nvSpPr>
        <p:spPr>
          <a:xfrm>
            <a:off x="7707514" y="2423024"/>
            <a:ext cx="857927" cy="369332"/>
          </a:xfrm>
          <a:prstGeom prst="rect">
            <a:avLst/>
          </a:prstGeom>
          <a:solidFill>
            <a:schemeClr val="bg1"/>
          </a:solidFill>
        </p:spPr>
        <p:txBody>
          <a:bodyPr wrap="none" rtlCol="0">
            <a:spAutoFit/>
          </a:bodyPr>
          <a:lstStyle/>
          <a:p>
            <a:r>
              <a:rPr lang="en-US" dirty="0"/>
              <a:t>Spleen</a:t>
            </a:r>
          </a:p>
        </p:txBody>
      </p:sp>
      <p:sp>
        <p:nvSpPr>
          <p:cNvPr id="8" name="TextBox 7">
            <a:extLst>
              <a:ext uri="{FF2B5EF4-FFF2-40B4-BE49-F238E27FC236}">
                <a16:creationId xmlns:a16="http://schemas.microsoft.com/office/drawing/2014/main" id="{D7526F87-3F39-8611-CBF0-AE7E4B30E965}"/>
              </a:ext>
            </a:extLst>
          </p:cNvPr>
          <p:cNvSpPr txBox="1"/>
          <p:nvPr/>
        </p:nvSpPr>
        <p:spPr>
          <a:xfrm>
            <a:off x="9988320" y="3525450"/>
            <a:ext cx="844590" cy="369332"/>
          </a:xfrm>
          <a:prstGeom prst="rect">
            <a:avLst/>
          </a:prstGeom>
          <a:solidFill>
            <a:schemeClr val="bg1"/>
          </a:solidFill>
        </p:spPr>
        <p:txBody>
          <a:bodyPr wrap="none" rtlCol="0">
            <a:spAutoFit/>
          </a:bodyPr>
          <a:lstStyle/>
          <a:p>
            <a:r>
              <a:rPr lang="en-US" dirty="0"/>
              <a:t>Kidney</a:t>
            </a:r>
          </a:p>
        </p:txBody>
      </p:sp>
      <p:sp>
        <p:nvSpPr>
          <p:cNvPr id="9" name="TextBox 8">
            <a:extLst>
              <a:ext uri="{FF2B5EF4-FFF2-40B4-BE49-F238E27FC236}">
                <a16:creationId xmlns:a16="http://schemas.microsoft.com/office/drawing/2014/main" id="{FBC026A7-A4EC-12D8-B2D7-7527713F6238}"/>
              </a:ext>
            </a:extLst>
          </p:cNvPr>
          <p:cNvSpPr txBox="1"/>
          <p:nvPr/>
        </p:nvSpPr>
        <p:spPr>
          <a:xfrm>
            <a:off x="4236296" y="2843542"/>
            <a:ext cx="844590" cy="369332"/>
          </a:xfrm>
          <a:prstGeom prst="rect">
            <a:avLst/>
          </a:prstGeom>
          <a:solidFill>
            <a:schemeClr val="bg1"/>
          </a:solidFill>
        </p:spPr>
        <p:txBody>
          <a:bodyPr wrap="none" rtlCol="0">
            <a:spAutoFit/>
          </a:bodyPr>
          <a:lstStyle/>
          <a:p>
            <a:r>
              <a:rPr lang="en-US" dirty="0"/>
              <a:t>Kidney</a:t>
            </a:r>
          </a:p>
        </p:txBody>
      </p:sp>
      <p:sp>
        <p:nvSpPr>
          <p:cNvPr id="10" name="TextBox 9">
            <a:extLst>
              <a:ext uri="{FF2B5EF4-FFF2-40B4-BE49-F238E27FC236}">
                <a16:creationId xmlns:a16="http://schemas.microsoft.com/office/drawing/2014/main" id="{DCD27A1E-4AEA-798C-B774-27A4AA3A2EC5}"/>
              </a:ext>
            </a:extLst>
          </p:cNvPr>
          <p:cNvSpPr txBox="1"/>
          <p:nvPr/>
        </p:nvSpPr>
        <p:spPr>
          <a:xfrm>
            <a:off x="1864653" y="2477895"/>
            <a:ext cx="647678" cy="369332"/>
          </a:xfrm>
          <a:prstGeom prst="rect">
            <a:avLst/>
          </a:prstGeom>
          <a:solidFill>
            <a:schemeClr val="bg1"/>
          </a:solidFill>
        </p:spPr>
        <p:txBody>
          <a:bodyPr wrap="none" rtlCol="0">
            <a:spAutoFit/>
          </a:bodyPr>
          <a:lstStyle/>
          <a:p>
            <a:r>
              <a:rPr lang="en-US" dirty="0"/>
              <a:t>Liver</a:t>
            </a:r>
          </a:p>
        </p:txBody>
      </p:sp>
    </p:spTree>
    <p:extLst>
      <p:ext uri="{BB962C8B-B14F-4D97-AF65-F5344CB8AC3E}">
        <p14:creationId xmlns:p14="http://schemas.microsoft.com/office/powerpoint/2010/main" val="31959219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27232"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7" fill="hold" display="0">
                  <p:stCondLst>
                    <p:cond delay="indefinite"/>
                  </p:stCondLst>
                  <p:endCondLst>
                    <p:cond evt="onStopAudio" delay="0">
                      <p:tgtEl>
                        <p:sldTgt/>
                      </p:tgtEl>
                    </p:cond>
                  </p:endCondLst>
                </p:cTn>
                <p:tgtEl>
                  <p:spTgt spid="2"/>
                </p:tgtEl>
              </p:cMediaNode>
            </p:audio>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Splenorenalblood.mp4" descr="Splenorenalblood.mp4">
            <a:hlinkClick r:id="" action="ppaction://media"/>
            <a:extLst>
              <a:ext uri="{FF2B5EF4-FFF2-40B4-BE49-F238E27FC236}">
                <a16:creationId xmlns:a16="http://schemas.microsoft.com/office/drawing/2014/main" id="{CDF5252F-F46E-818C-96AB-44C14AE55FFC}"/>
              </a:ext>
            </a:extLst>
          </p:cNvPr>
          <p:cNvPicPr>
            <a:picLocks noChangeAspect="1"/>
          </p:cNvPicPr>
          <p:nvPr>
            <a:videoFile r:link="rId2"/>
            <p:extLst>
              <p:ext uri="{DAA4B4D4-6D71-4841-9C94-3DE7FCFB9230}">
                <p14:media xmlns:p14="http://schemas.microsoft.com/office/powerpoint/2010/main" r:embed="rId1"/>
              </p:ext>
            </p:extLst>
          </p:nvPr>
        </p:nvPicPr>
        <p:blipFill>
          <a:blip r:embed="rId7"/>
          <a:stretch>
            <a:fillRect/>
          </a:stretch>
        </p:blipFill>
        <p:spPr>
          <a:xfrm>
            <a:off x="2730500" y="676275"/>
            <a:ext cx="6731000" cy="5048250"/>
          </a:xfrm>
          <a:prstGeom prst="rect">
            <a:avLst/>
          </a:prstGeom>
        </p:spPr>
      </p:pic>
      <p:pic>
        <p:nvPicPr>
          <p:cNvPr id="2" name="Audio Recording Sep 27, 2022 at 8:01:02 PM" descr="Audio Recording Sep 27, 2022 at 8:01:02 PM">
            <a:hlinkClick r:id="" action="ppaction://media"/>
            <a:extLst>
              <a:ext uri="{FF2B5EF4-FFF2-40B4-BE49-F238E27FC236}">
                <a16:creationId xmlns:a16="http://schemas.microsoft.com/office/drawing/2014/main" id="{4D9B9A13-20A0-203F-910D-20F33D2AB789}"/>
              </a:ext>
            </a:extLst>
          </p:cNvPr>
          <p:cNvPicPr>
            <a:picLocks noChangeAspect="1"/>
          </p:cNvPicPr>
          <p:nvPr>
            <a:audioFile r:link="rId4"/>
            <p:extLst>
              <p:ext uri="{DAA4B4D4-6D71-4841-9C94-3DE7FCFB9230}">
                <p14:media xmlns:p14="http://schemas.microsoft.com/office/powerpoint/2010/main" r:embed="rId3"/>
              </p:ext>
            </p:extLst>
          </p:nvPr>
        </p:nvPicPr>
        <p:blipFill>
          <a:blip r:embed="rId8"/>
          <a:stretch>
            <a:fillRect/>
          </a:stretch>
        </p:blipFill>
        <p:spPr>
          <a:xfrm>
            <a:off x="10926618" y="5005779"/>
            <a:ext cx="812800" cy="812800"/>
          </a:xfrm>
          <a:prstGeom prst="rect">
            <a:avLst/>
          </a:prstGeom>
        </p:spPr>
      </p:pic>
    </p:spTree>
    <p:extLst>
      <p:ext uri="{BB962C8B-B14F-4D97-AF65-F5344CB8AC3E}">
        <p14:creationId xmlns:p14="http://schemas.microsoft.com/office/powerpoint/2010/main" val="7092755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4000" fill="hold"/>
                                        <p:tgtEl>
                                          <p:spTgt spid="3"/>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76288"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fill="hold" display="0">
                  <p:stCondLst>
                    <p:cond delay="indefinite"/>
                  </p:stCondLst>
                </p:cTn>
                <p:tgtEl>
                  <p:spTgt spid="3"/>
                </p:tgtEl>
              </p:cMediaNode>
            </p:video>
            <p:seq concurrent="1" nextAc="seek">
              <p:cTn id="12" restart="whenNotActive" fill="hold" evtFilter="cancelBubble" nodeType="interactiveSeq">
                <p:stCondLst>
                  <p:cond evt="onClick" delay="0">
                    <p:tgtEl>
                      <p:spTgt spid="3"/>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3"/>
                                        </p:tgtEl>
                                      </p:cBhvr>
                                    </p:cmd>
                                  </p:childTnLst>
                                </p:cTn>
                              </p:par>
                            </p:childTnLst>
                          </p:cTn>
                        </p:par>
                      </p:childTnLst>
                    </p:cTn>
                  </p:par>
                </p:childTnLst>
              </p:cTn>
              <p:nextCondLst>
                <p:cond evt="onClick" delay="0">
                  <p:tgtEl>
                    <p:spTgt spid="3"/>
                  </p:tgtEl>
                </p:cond>
              </p:nextCondLst>
            </p:seq>
            <p:audio>
              <p:cMediaNode vol="80000">
                <p:cTn id="17" fill="hold" display="0">
                  <p:stCondLst>
                    <p:cond delay="indefinite"/>
                  </p:stCondLst>
                  <p:endCondLst>
                    <p:cond evt="onStopAudio" delay="0">
                      <p:tgtEl>
                        <p:sldTgt/>
                      </p:tgtEl>
                    </p:cond>
                  </p:endCondLst>
                </p:cTn>
                <p:tgtEl>
                  <p:spTgt spid="2"/>
                </p:tgtEl>
              </p:cMediaNode>
            </p:audio>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01CEA82-7AEB-10CA-FCA3-D0992EEAEA23}"/>
              </a:ext>
            </a:extLst>
          </p:cNvPr>
          <p:cNvGrpSpPr/>
          <p:nvPr/>
        </p:nvGrpSpPr>
        <p:grpSpPr>
          <a:xfrm>
            <a:off x="4101745" y="653002"/>
            <a:ext cx="4059360" cy="5189040"/>
            <a:chOff x="4101745" y="653002"/>
            <a:chExt cx="4059360" cy="5189040"/>
          </a:xfrm>
        </p:grpSpPr>
        <mc:AlternateContent xmlns:mc="http://schemas.openxmlformats.org/markup-compatibility/2006" xmlns:p14="http://schemas.microsoft.com/office/powerpoint/2010/main">
          <mc:Choice Requires="p14">
            <p:contentPart p14:bwMode="auto" r:id="rId7">
              <p14:nvContentPartPr>
                <p14:cNvPr id="36" name="Ink 35">
                  <a:extLst>
                    <a:ext uri="{FF2B5EF4-FFF2-40B4-BE49-F238E27FC236}">
                      <a16:creationId xmlns:a16="http://schemas.microsoft.com/office/drawing/2014/main" id="{DB77B19F-3997-F2D7-1117-8C2689BC3745}"/>
                    </a:ext>
                  </a:extLst>
                </p14:cNvPr>
                <p14:cNvContentPartPr/>
                <p14:nvPr/>
              </p14:nvContentPartPr>
              <p14:xfrm>
                <a:off x="5677105" y="1174642"/>
                <a:ext cx="968400" cy="659160"/>
              </p14:xfrm>
            </p:contentPart>
          </mc:Choice>
          <mc:Fallback xmlns="">
            <p:pic>
              <p:nvPicPr>
                <p:cNvPr id="36" name="Ink 35">
                  <a:extLst>
                    <a:ext uri="{FF2B5EF4-FFF2-40B4-BE49-F238E27FC236}">
                      <a16:creationId xmlns:a16="http://schemas.microsoft.com/office/drawing/2014/main" id="{DB77B19F-3997-F2D7-1117-8C2689BC3745}"/>
                    </a:ext>
                  </a:extLst>
                </p:cNvPr>
                <p:cNvPicPr/>
                <p:nvPr/>
              </p:nvPicPr>
              <p:blipFill>
                <a:blip r:embed="rId8"/>
                <a:stretch>
                  <a:fillRect/>
                </a:stretch>
              </p:blipFill>
              <p:spPr>
                <a:xfrm>
                  <a:off x="5641105" y="1138622"/>
                  <a:ext cx="1040040" cy="730839"/>
                </a:xfrm>
                <a:prstGeom prst="rect">
                  <a:avLst/>
                </a:prstGeom>
              </p:spPr>
            </p:pic>
          </mc:Fallback>
        </mc:AlternateContent>
        <mc:AlternateContent xmlns:mc="http://schemas.openxmlformats.org/markup-compatibility/2006" xmlns:p14="http://schemas.microsoft.com/office/powerpoint/2010/main">
          <mc:Choice Requires="p14">
            <p:contentPart p14:bwMode="auto" r:id="rId9">
              <p14:nvContentPartPr>
                <p14:cNvPr id="37" name="Ink 36">
                  <a:extLst>
                    <a:ext uri="{FF2B5EF4-FFF2-40B4-BE49-F238E27FC236}">
                      <a16:creationId xmlns:a16="http://schemas.microsoft.com/office/drawing/2014/main" id="{03FFD99A-6B3C-3CD1-6179-1322032D0AA7}"/>
                    </a:ext>
                  </a:extLst>
                </p14:cNvPr>
                <p14:cNvContentPartPr/>
                <p14:nvPr/>
              </p14:nvContentPartPr>
              <p14:xfrm>
                <a:off x="5812825" y="1879522"/>
                <a:ext cx="196200" cy="1943640"/>
              </p14:xfrm>
            </p:contentPart>
          </mc:Choice>
          <mc:Fallback xmlns="">
            <p:pic>
              <p:nvPicPr>
                <p:cNvPr id="37" name="Ink 36">
                  <a:extLst>
                    <a:ext uri="{FF2B5EF4-FFF2-40B4-BE49-F238E27FC236}">
                      <a16:creationId xmlns:a16="http://schemas.microsoft.com/office/drawing/2014/main" id="{03FFD99A-6B3C-3CD1-6179-1322032D0AA7}"/>
                    </a:ext>
                  </a:extLst>
                </p:cNvPr>
                <p:cNvPicPr/>
                <p:nvPr/>
              </p:nvPicPr>
              <p:blipFill>
                <a:blip r:embed="rId10"/>
                <a:stretch>
                  <a:fillRect/>
                </a:stretch>
              </p:blipFill>
              <p:spPr>
                <a:xfrm>
                  <a:off x="5776825" y="1843522"/>
                  <a:ext cx="267840" cy="2015280"/>
                </a:xfrm>
                <a:prstGeom prst="rect">
                  <a:avLst/>
                </a:prstGeom>
              </p:spPr>
            </p:pic>
          </mc:Fallback>
        </mc:AlternateContent>
        <mc:AlternateContent xmlns:mc="http://schemas.openxmlformats.org/markup-compatibility/2006" xmlns:p14="http://schemas.microsoft.com/office/powerpoint/2010/main">
          <mc:Choice Requires="p14">
            <p:contentPart p14:bwMode="auto" r:id="rId11">
              <p14:nvContentPartPr>
                <p14:cNvPr id="38" name="Ink 37">
                  <a:extLst>
                    <a:ext uri="{FF2B5EF4-FFF2-40B4-BE49-F238E27FC236}">
                      <a16:creationId xmlns:a16="http://schemas.microsoft.com/office/drawing/2014/main" id="{3FD2A4E1-3443-C691-E599-6A5B121E8E2F}"/>
                    </a:ext>
                  </a:extLst>
                </p14:cNvPr>
                <p14:cNvContentPartPr/>
                <p14:nvPr/>
              </p14:nvContentPartPr>
              <p14:xfrm>
                <a:off x="6006145" y="1855402"/>
                <a:ext cx="453240" cy="2187000"/>
              </p14:xfrm>
            </p:contentPart>
          </mc:Choice>
          <mc:Fallback xmlns="">
            <p:pic>
              <p:nvPicPr>
                <p:cNvPr id="38" name="Ink 37">
                  <a:extLst>
                    <a:ext uri="{FF2B5EF4-FFF2-40B4-BE49-F238E27FC236}">
                      <a16:creationId xmlns:a16="http://schemas.microsoft.com/office/drawing/2014/main" id="{3FD2A4E1-3443-C691-E599-6A5B121E8E2F}"/>
                    </a:ext>
                  </a:extLst>
                </p:cNvPr>
                <p:cNvPicPr/>
                <p:nvPr/>
              </p:nvPicPr>
              <p:blipFill>
                <a:blip r:embed="rId12"/>
                <a:stretch>
                  <a:fillRect/>
                </a:stretch>
              </p:blipFill>
              <p:spPr>
                <a:xfrm>
                  <a:off x="5970145" y="1819402"/>
                  <a:ext cx="524880" cy="2258640"/>
                </a:xfrm>
                <a:prstGeom prst="rect">
                  <a:avLst/>
                </a:prstGeom>
              </p:spPr>
            </p:pic>
          </mc:Fallback>
        </mc:AlternateContent>
        <mc:AlternateContent xmlns:mc="http://schemas.openxmlformats.org/markup-compatibility/2006" xmlns:p14="http://schemas.microsoft.com/office/powerpoint/2010/main">
          <mc:Choice Requires="p14">
            <p:contentPart p14:bwMode="auto" r:id="rId13">
              <p14:nvContentPartPr>
                <p14:cNvPr id="39" name="Ink 38">
                  <a:extLst>
                    <a:ext uri="{FF2B5EF4-FFF2-40B4-BE49-F238E27FC236}">
                      <a16:creationId xmlns:a16="http://schemas.microsoft.com/office/drawing/2014/main" id="{C624697E-6D80-4624-3D04-D82A1873DBB6}"/>
                    </a:ext>
                  </a:extLst>
                </p14:cNvPr>
                <p14:cNvContentPartPr/>
                <p14:nvPr/>
              </p14:nvContentPartPr>
              <p14:xfrm>
                <a:off x="6493945" y="653002"/>
                <a:ext cx="804240" cy="721080"/>
              </p14:xfrm>
            </p:contentPart>
          </mc:Choice>
          <mc:Fallback xmlns="">
            <p:pic>
              <p:nvPicPr>
                <p:cNvPr id="39" name="Ink 38">
                  <a:extLst>
                    <a:ext uri="{FF2B5EF4-FFF2-40B4-BE49-F238E27FC236}">
                      <a16:creationId xmlns:a16="http://schemas.microsoft.com/office/drawing/2014/main" id="{C624697E-6D80-4624-3D04-D82A1873DBB6}"/>
                    </a:ext>
                  </a:extLst>
                </p:cNvPr>
                <p:cNvPicPr/>
                <p:nvPr/>
              </p:nvPicPr>
              <p:blipFill>
                <a:blip r:embed="rId14"/>
                <a:stretch>
                  <a:fillRect/>
                </a:stretch>
              </p:blipFill>
              <p:spPr>
                <a:xfrm>
                  <a:off x="6430945" y="590002"/>
                  <a:ext cx="929880" cy="846720"/>
                </a:xfrm>
                <a:prstGeom prst="rect">
                  <a:avLst/>
                </a:prstGeom>
              </p:spPr>
            </p:pic>
          </mc:Fallback>
        </mc:AlternateContent>
        <mc:AlternateContent xmlns:mc="http://schemas.openxmlformats.org/markup-compatibility/2006" xmlns:p14="http://schemas.microsoft.com/office/powerpoint/2010/main">
          <mc:Choice Requires="p14">
            <p:contentPart p14:bwMode="auto" r:id="rId15">
              <p14:nvContentPartPr>
                <p14:cNvPr id="40" name="Ink 39">
                  <a:extLst>
                    <a:ext uri="{FF2B5EF4-FFF2-40B4-BE49-F238E27FC236}">
                      <a16:creationId xmlns:a16="http://schemas.microsoft.com/office/drawing/2014/main" id="{F889DBB1-4ADD-D4D3-A6A0-02334E3C45DF}"/>
                    </a:ext>
                  </a:extLst>
                </p14:cNvPr>
                <p14:cNvContentPartPr/>
                <p14:nvPr/>
              </p14:nvContentPartPr>
              <p14:xfrm>
                <a:off x="4995265" y="678562"/>
                <a:ext cx="772920" cy="718560"/>
              </p14:xfrm>
            </p:contentPart>
          </mc:Choice>
          <mc:Fallback xmlns="">
            <p:pic>
              <p:nvPicPr>
                <p:cNvPr id="40" name="Ink 39">
                  <a:extLst>
                    <a:ext uri="{FF2B5EF4-FFF2-40B4-BE49-F238E27FC236}">
                      <a16:creationId xmlns:a16="http://schemas.microsoft.com/office/drawing/2014/main" id="{F889DBB1-4ADD-D4D3-A6A0-02334E3C45DF}"/>
                    </a:ext>
                  </a:extLst>
                </p:cNvPr>
                <p:cNvPicPr/>
                <p:nvPr/>
              </p:nvPicPr>
              <p:blipFill>
                <a:blip r:embed="rId16"/>
                <a:stretch>
                  <a:fillRect/>
                </a:stretch>
              </p:blipFill>
              <p:spPr>
                <a:xfrm>
                  <a:off x="4932265" y="615562"/>
                  <a:ext cx="898560" cy="844200"/>
                </a:xfrm>
                <a:prstGeom prst="rect">
                  <a:avLst/>
                </a:prstGeom>
              </p:spPr>
            </p:pic>
          </mc:Fallback>
        </mc:AlternateContent>
        <mc:AlternateContent xmlns:mc="http://schemas.openxmlformats.org/markup-compatibility/2006" xmlns:p14="http://schemas.microsoft.com/office/powerpoint/2010/main">
          <mc:Choice Requires="p14">
            <p:contentPart p14:bwMode="auto" r:id="rId17">
              <p14:nvContentPartPr>
                <p14:cNvPr id="41" name="Ink 40">
                  <a:extLst>
                    <a:ext uri="{FF2B5EF4-FFF2-40B4-BE49-F238E27FC236}">
                      <a16:creationId xmlns:a16="http://schemas.microsoft.com/office/drawing/2014/main" id="{8D9AE009-E0E4-F732-C47F-7C901EFE87F5}"/>
                    </a:ext>
                  </a:extLst>
                </p14:cNvPr>
                <p14:cNvContentPartPr/>
                <p14:nvPr/>
              </p14:nvContentPartPr>
              <p14:xfrm>
                <a:off x="6447145" y="1232602"/>
                <a:ext cx="1170360" cy="661320"/>
              </p14:xfrm>
            </p:contentPart>
          </mc:Choice>
          <mc:Fallback xmlns="">
            <p:pic>
              <p:nvPicPr>
                <p:cNvPr id="41" name="Ink 40">
                  <a:extLst>
                    <a:ext uri="{FF2B5EF4-FFF2-40B4-BE49-F238E27FC236}">
                      <a16:creationId xmlns:a16="http://schemas.microsoft.com/office/drawing/2014/main" id="{8D9AE009-E0E4-F732-C47F-7C901EFE87F5}"/>
                    </a:ext>
                  </a:extLst>
                </p:cNvPr>
                <p:cNvPicPr/>
                <p:nvPr/>
              </p:nvPicPr>
              <p:blipFill>
                <a:blip r:embed="rId18"/>
                <a:stretch>
                  <a:fillRect/>
                </a:stretch>
              </p:blipFill>
              <p:spPr>
                <a:xfrm>
                  <a:off x="6384145" y="1169602"/>
                  <a:ext cx="1296000" cy="786960"/>
                </a:xfrm>
                <a:prstGeom prst="rect">
                  <a:avLst/>
                </a:prstGeom>
              </p:spPr>
            </p:pic>
          </mc:Fallback>
        </mc:AlternateContent>
        <mc:AlternateContent xmlns:mc="http://schemas.openxmlformats.org/markup-compatibility/2006" xmlns:p14="http://schemas.microsoft.com/office/powerpoint/2010/main">
          <mc:Choice Requires="p14">
            <p:contentPart p14:bwMode="auto" r:id="rId19">
              <p14:nvContentPartPr>
                <p14:cNvPr id="42" name="Ink 41">
                  <a:extLst>
                    <a:ext uri="{FF2B5EF4-FFF2-40B4-BE49-F238E27FC236}">
                      <a16:creationId xmlns:a16="http://schemas.microsoft.com/office/drawing/2014/main" id="{3863E03A-9249-F623-47A5-B99022B6D8D3}"/>
                    </a:ext>
                  </a:extLst>
                </p14:cNvPr>
                <p14:cNvContentPartPr/>
                <p14:nvPr/>
              </p14:nvContentPartPr>
              <p14:xfrm>
                <a:off x="6500785" y="1705642"/>
                <a:ext cx="1288080" cy="733320"/>
              </p14:xfrm>
            </p:contentPart>
          </mc:Choice>
          <mc:Fallback xmlns="">
            <p:pic>
              <p:nvPicPr>
                <p:cNvPr id="42" name="Ink 41">
                  <a:extLst>
                    <a:ext uri="{FF2B5EF4-FFF2-40B4-BE49-F238E27FC236}">
                      <a16:creationId xmlns:a16="http://schemas.microsoft.com/office/drawing/2014/main" id="{3863E03A-9249-F623-47A5-B99022B6D8D3}"/>
                    </a:ext>
                  </a:extLst>
                </p:cNvPr>
                <p:cNvPicPr/>
                <p:nvPr/>
              </p:nvPicPr>
              <p:blipFill>
                <a:blip r:embed="rId20"/>
                <a:stretch>
                  <a:fillRect/>
                </a:stretch>
              </p:blipFill>
              <p:spPr>
                <a:xfrm>
                  <a:off x="6437785" y="1642642"/>
                  <a:ext cx="1413720" cy="858960"/>
                </a:xfrm>
                <a:prstGeom prst="rect">
                  <a:avLst/>
                </a:prstGeom>
              </p:spPr>
            </p:pic>
          </mc:Fallback>
        </mc:AlternateContent>
        <mc:AlternateContent xmlns:mc="http://schemas.openxmlformats.org/markup-compatibility/2006" xmlns:p14="http://schemas.microsoft.com/office/powerpoint/2010/main">
          <mc:Choice Requires="p14">
            <p:contentPart p14:bwMode="auto" r:id="rId21">
              <p14:nvContentPartPr>
                <p14:cNvPr id="43" name="Ink 42">
                  <a:extLst>
                    <a:ext uri="{FF2B5EF4-FFF2-40B4-BE49-F238E27FC236}">
                      <a16:creationId xmlns:a16="http://schemas.microsoft.com/office/drawing/2014/main" id="{55D53B92-3387-F27F-3041-F63698134C32}"/>
                    </a:ext>
                  </a:extLst>
                </p14:cNvPr>
                <p14:cNvContentPartPr/>
                <p14:nvPr/>
              </p14:nvContentPartPr>
              <p14:xfrm>
                <a:off x="6518065" y="2147722"/>
                <a:ext cx="1497240" cy="856440"/>
              </p14:xfrm>
            </p:contentPart>
          </mc:Choice>
          <mc:Fallback xmlns="">
            <p:pic>
              <p:nvPicPr>
                <p:cNvPr id="43" name="Ink 42">
                  <a:extLst>
                    <a:ext uri="{FF2B5EF4-FFF2-40B4-BE49-F238E27FC236}">
                      <a16:creationId xmlns:a16="http://schemas.microsoft.com/office/drawing/2014/main" id="{55D53B92-3387-F27F-3041-F63698134C32}"/>
                    </a:ext>
                  </a:extLst>
                </p:cNvPr>
                <p:cNvPicPr/>
                <p:nvPr/>
              </p:nvPicPr>
              <p:blipFill>
                <a:blip r:embed="rId22"/>
                <a:stretch>
                  <a:fillRect/>
                </a:stretch>
              </p:blipFill>
              <p:spPr>
                <a:xfrm>
                  <a:off x="6455065" y="2084722"/>
                  <a:ext cx="1622880" cy="982080"/>
                </a:xfrm>
                <a:prstGeom prst="rect">
                  <a:avLst/>
                </a:prstGeom>
              </p:spPr>
            </p:pic>
          </mc:Fallback>
        </mc:AlternateContent>
        <mc:AlternateContent xmlns:mc="http://schemas.openxmlformats.org/markup-compatibility/2006" xmlns:p14="http://schemas.microsoft.com/office/powerpoint/2010/main">
          <mc:Choice Requires="p14">
            <p:contentPart p14:bwMode="auto" r:id="rId23">
              <p14:nvContentPartPr>
                <p14:cNvPr id="44" name="Ink 43">
                  <a:extLst>
                    <a:ext uri="{FF2B5EF4-FFF2-40B4-BE49-F238E27FC236}">
                      <a16:creationId xmlns:a16="http://schemas.microsoft.com/office/drawing/2014/main" id="{8A717FFB-4C50-0A3B-7AA2-9B29B8D0CB81}"/>
                    </a:ext>
                  </a:extLst>
                </p14:cNvPr>
                <p14:cNvContentPartPr/>
                <p14:nvPr/>
              </p14:nvContentPartPr>
              <p14:xfrm>
                <a:off x="6478105" y="2726602"/>
                <a:ext cx="1609920" cy="837360"/>
              </p14:xfrm>
            </p:contentPart>
          </mc:Choice>
          <mc:Fallback xmlns="">
            <p:pic>
              <p:nvPicPr>
                <p:cNvPr id="44" name="Ink 43">
                  <a:extLst>
                    <a:ext uri="{FF2B5EF4-FFF2-40B4-BE49-F238E27FC236}">
                      <a16:creationId xmlns:a16="http://schemas.microsoft.com/office/drawing/2014/main" id="{8A717FFB-4C50-0A3B-7AA2-9B29B8D0CB81}"/>
                    </a:ext>
                  </a:extLst>
                </p:cNvPr>
                <p:cNvPicPr/>
                <p:nvPr/>
              </p:nvPicPr>
              <p:blipFill>
                <a:blip r:embed="rId24"/>
                <a:stretch>
                  <a:fillRect/>
                </a:stretch>
              </p:blipFill>
              <p:spPr>
                <a:xfrm>
                  <a:off x="6415105" y="2663602"/>
                  <a:ext cx="1735560" cy="963000"/>
                </a:xfrm>
                <a:prstGeom prst="rect">
                  <a:avLst/>
                </a:prstGeom>
              </p:spPr>
            </p:pic>
          </mc:Fallback>
        </mc:AlternateContent>
        <mc:AlternateContent xmlns:mc="http://schemas.openxmlformats.org/markup-compatibility/2006" xmlns:p14="http://schemas.microsoft.com/office/powerpoint/2010/main">
          <mc:Choice Requires="p14">
            <p:contentPart p14:bwMode="auto" r:id="rId25">
              <p14:nvContentPartPr>
                <p14:cNvPr id="45" name="Ink 44">
                  <a:extLst>
                    <a:ext uri="{FF2B5EF4-FFF2-40B4-BE49-F238E27FC236}">
                      <a16:creationId xmlns:a16="http://schemas.microsoft.com/office/drawing/2014/main" id="{5AFF0123-8F93-70E4-8B78-F0400A8C329F}"/>
                    </a:ext>
                  </a:extLst>
                </p14:cNvPr>
                <p14:cNvContentPartPr/>
                <p14:nvPr/>
              </p14:nvContentPartPr>
              <p14:xfrm>
                <a:off x="4679185" y="1296322"/>
                <a:ext cx="1182600" cy="605160"/>
              </p14:xfrm>
            </p:contentPart>
          </mc:Choice>
          <mc:Fallback xmlns="">
            <p:pic>
              <p:nvPicPr>
                <p:cNvPr id="45" name="Ink 44">
                  <a:extLst>
                    <a:ext uri="{FF2B5EF4-FFF2-40B4-BE49-F238E27FC236}">
                      <a16:creationId xmlns:a16="http://schemas.microsoft.com/office/drawing/2014/main" id="{5AFF0123-8F93-70E4-8B78-F0400A8C329F}"/>
                    </a:ext>
                  </a:extLst>
                </p:cNvPr>
                <p:cNvPicPr/>
                <p:nvPr/>
              </p:nvPicPr>
              <p:blipFill>
                <a:blip r:embed="rId26"/>
                <a:stretch>
                  <a:fillRect/>
                </a:stretch>
              </p:blipFill>
              <p:spPr>
                <a:xfrm>
                  <a:off x="4616185" y="1233284"/>
                  <a:ext cx="1308240" cy="730875"/>
                </a:xfrm>
                <a:prstGeom prst="rect">
                  <a:avLst/>
                </a:prstGeom>
              </p:spPr>
            </p:pic>
          </mc:Fallback>
        </mc:AlternateContent>
        <mc:AlternateContent xmlns:mc="http://schemas.openxmlformats.org/markup-compatibility/2006" xmlns:p14="http://schemas.microsoft.com/office/powerpoint/2010/main">
          <mc:Choice Requires="p14">
            <p:contentPart p14:bwMode="auto" r:id="rId27">
              <p14:nvContentPartPr>
                <p14:cNvPr id="46" name="Ink 45">
                  <a:extLst>
                    <a:ext uri="{FF2B5EF4-FFF2-40B4-BE49-F238E27FC236}">
                      <a16:creationId xmlns:a16="http://schemas.microsoft.com/office/drawing/2014/main" id="{6F2525C9-59AB-479D-FCC9-FD33621289AD}"/>
                    </a:ext>
                  </a:extLst>
                </p14:cNvPr>
                <p14:cNvContentPartPr/>
                <p14:nvPr/>
              </p14:nvContentPartPr>
              <p14:xfrm>
                <a:off x="4515745" y="1671082"/>
                <a:ext cx="1289880" cy="698040"/>
              </p14:xfrm>
            </p:contentPart>
          </mc:Choice>
          <mc:Fallback xmlns="">
            <p:pic>
              <p:nvPicPr>
                <p:cNvPr id="46" name="Ink 45">
                  <a:extLst>
                    <a:ext uri="{FF2B5EF4-FFF2-40B4-BE49-F238E27FC236}">
                      <a16:creationId xmlns:a16="http://schemas.microsoft.com/office/drawing/2014/main" id="{6F2525C9-59AB-479D-FCC9-FD33621289AD}"/>
                    </a:ext>
                  </a:extLst>
                </p:cNvPr>
                <p:cNvPicPr/>
                <p:nvPr/>
              </p:nvPicPr>
              <p:blipFill>
                <a:blip r:embed="rId28"/>
                <a:stretch>
                  <a:fillRect/>
                </a:stretch>
              </p:blipFill>
              <p:spPr>
                <a:xfrm>
                  <a:off x="4452745" y="1608082"/>
                  <a:ext cx="1415520" cy="823680"/>
                </a:xfrm>
                <a:prstGeom prst="rect">
                  <a:avLst/>
                </a:prstGeom>
              </p:spPr>
            </p:pic>
          </mc:Fallback>
        </mc:AlternateContent>
        <mc:AlternateContent xmlns:mc="http://schemas.openxmlformats.org/markup-compatibility/2006" xmlns:p14="http://schemas.microsoft.com/office/powerpoint/2010/main">
          <mc:Choice Requires="p14">
            <p:contentPart p14:bwMode="auto" r:id="rId29">
              <p14:nvContentPartPr>
                <p14:cNvPr id="47" name="Ink 46">
                  <a:extLst>
                    <a:ext uri="{FF2B5EF4-FFF2-40B4-BE49-F238E27FC236}">
                      <a16:creationId xmlns:a16="http://schemas.microsoft.com/office/drawing/2014/main" id="{0A67CD69-80AE-73BF-BEB6-017FA28BD0B1}"/>
                    </a:ext>
                  </a:extLst>
                </p14:cNvPr>
                <p14:cNvContentPartPr/>
                <p14:nvPr/>
              </p14:nvContentPartPr>
              <p14:xfrm>
                <a:off x="4312705" y="2116042"/>
                <a:ext cx="1491480" cy="830880"/>
              </p14:xfrm>
            </p:contentPart>
          </mc:Choice>
          <mc:Fallback xmlns="">
            <p:pic>
              <p:nvPicPr>
                <p:cNvPr id="47" name="Ink 46">
                  <a:extLst>
                    <a:ext uri="{FF2B5EF4-FFF2-40B4-BE49-F238E27FC236}">
                      <a16:creationId xmlns:a16="http://schemas.microsoft.com/office/drawing/2014/main" id="{0A67CD69-80AE-73BF-BEB6-017FA28BD0B1}"/>
                    </a:ext>
                  </a:extLst>
                </p:cNvPr>
                <p:cNvPicPr/>
                <p:nvPr/>
              </p:nvPicPr>
              <p:blipFill>
                <a:blip r:embed="rId30"/>
                <a:stretch>
                  <a:fillRect/>
                </a:stretch>
              </p:blipFill>
              <p:spPr>
                <a:xfrm>
                  <a:off x="4249705" y="2053042"/>
                  <a:ext cx="1617120" cy="956520"/>
                </a:xfrm>
                <a:prstGeom prst="rect">
                  <a:avLst/>
                </a:prstGeom>
              </p:spPr>
            </p:pic>
          </mc:Fallback>
        </mc:AlternateContent>
        <mc:AlternateContent xmlns:mc="http://schemas.openxmlformats.org/markup-compatibility/2006" xmlns:p14="http://schemas.microsoft.com/office/powerpoint/2010/main">
          <mc:Choice Requires="p14">
            <p:contentPart p14:bwMode="auto" r:id="rId31">
              <p14:nvContentPartPr>
                <p14:cNvPr id="48" name="Ink 47">
                  <a:extLst>
                    <a:ext uri="{FF2B5EF4-FFF2-40B4-BE49-F238E27FC236}">
                      <a16:creationId xmlns:a16="http://schemas.microsoft.com/office/drawing/2014/main" id="{379A0D60-D13B-C1E1-09E0-C459B090D183}"/>
                    </a:ext>
                  </a:extLst>
                </p14:cNvPr>
                <p14:cNvContentPartPr/>
                <p14:nvPr/>
              </p14:nvContentPartPr>
              <p14:xfrm>
                <a:off x="4211185" y="2748562"/>
                <a:ext cx="1557720" cy="763560"/>
              </p14:xfrm>
            </p:contentPart>
          </mc:Choice>
          <mc:Fallback xmlns="">
            <p:pic>
              <p:nvPicPr>
                <p:cNvPr id="48" name="Ink 47">
                  <a:extLst>
                    <a:ext uri="{FF2B5EF4-FFF2-40B4-BE49-F238E27FC236}">
                      <a16:creationId xmlns:a16="http://schemas.microsoft.com/office/drawing/2014/main" id="{379A0D60-D13B-C1E1-09E0-C459B090D183}"/>
                    </a:ext>
                  </a:extLst>
                </p:cNvPr>
                <p:cNvPicPr/>
                <p:nvPr/>
              </p:nvPicPr>
              <p:blipFill>
                <a:blip r:embed="rId32"/>
                <a:stretch>
                  <a:fillRect/>
                </a:stretch>
              </p:blipFill>
              <p:spPr>
                <a:xfrm>
                  <a:off x="4148185" y="2685562"/>
                  <a:ext cx="1683360" cy="889200"/>
                </a:xfrm>
                <a:prstGeom prst="rect">
                  <a:avLst/>
                </a:prstGeom>
              </p:spPr>
            </p:pic>
          </mc:Fallback>
        </mc:AlternateContent>
        <mc:AlternateContent xmlns:mc="http://schemas.openxmlformats.org/markup-compatibility/2006" xmlns:p14="http://schemas.microsoft.com/office/powerpoint/2010/main">
          <mc:Choice Requires="p14">
            <p:contentPart p14:bwMode="auto" r:id="rId33">
              <p14:nvContentPartPr>
                <p14:cNvPr id="49" name="Ink 48">
                  <a:extLst>
                    <a:ext uri="{FF2B5EF4-FFF2-40B4-BE49-F238E27FC236}">
                      <a16:creationId xmlns:a16="http://schemas.microsoft.com/office/drawing/2014/main" id="{40CFBA3B-7527-530F-A687-2A7538E84A4D}"/>
                    </a:ext>
                  </a:extLst>
                </p14:cNvPr>
                <p14:cNvContentPartPr/>
                <p14:nvPr/>
              </p14:nvContentPartPr>
              <p14:xfrm>
                <a:off x="4101745" y="3260482"/>
                <a:ext cx="1715760" cy="768240"/>
              </p14:xfrm>
            </p:contentPart>
          </mc:Choice>
          <mc:Fallback xmlns="">
            <p:pic>
              <p:nvPicPr>
                <p:cNvPr id="49" name="Ink 48">
                  <a:extLst>
                    <a:ext uri="{FF2B5EF4-FFF2-40B4-BE49-F238E27FC236}">
                      <a16:creationId xmlns:a16="http://schemas.microsoft.com/office/drawing/2014/main" id="{40CFBA3B-7527-530F-A687-2A7538E84A4D}"/>
                    </a:ext>
                  </a:extLst>
                </p:cNvPr>
                <p:cNvPicPr/>
                <p:nvPr/>
              </p:nvPicPr>
              <p:blipFill>
                <a:blip r:embed="rId34"/>
                <a:stretch>
                  <a:fillRect/>
                </a:stretch>
              </p:blipFill>
              <p:spPr>
                <a:xfrm>
                  <a:off x="4038745" y="3197482"/>
                  <a:ext cx="1841400" cy="893880"/>
                </a:xfrm>
                <a:prstGeom prst="rect">
                  <a:avLst/>
                </a:prstGeom>
              </p:spPr>
            </p:pic>
          </mc:Fallback>
        </mc:AlternateContent>
        <mc:AlternateContent xmlns:mc="http://schemas.openxmlformats.org/markup-compatibility/2006" xmlns:p14="http://schemas.microsoft.com/office/powerpoint/2010/main">
          <mc:Choice Requires="p14">
            <p:contentPart p14:bwMode="auto" r:id="rId35">
              <p14:nvContentPartPr>
                <p14:cNvPr id="50" name="Ink 49">
                  <a:extLst>
                    <a:ext uri="{FF2B5EF4-FFF2-40B4-BE49-F238E27FC236}">
                      <a16:creationId xmlns:a16="http://schemas.microsoft.com/office/drawing/2014/main" id="{CCB462E5-E6E2-43D4-1C79-3C5AD93A7A6F}"/>
                    </a:ext>
                  </a:extLst>
                </p14:cNvPr>
                <p14:cNvContentPartPr/>
                <p14:nvPr/>
              </p14:nvContentPartPr>
              <p14:xfrm>
                <a:off x="4920745" y="3729202"/>
                <a:ext cx="1047240" cy="1375560"/>
              </p14:xfrm>
            </p:contentPart>
          </mc:Choice>
          <mc:Fallback xmlns="">
            <p:pic>
              <p:nvPicPr>
                <p:cNvPr id="50" name="Ink 49">
                  <a:extLst>
                    <a:ext uri="{FF2B5EF4-FFF2-40B4-BE49-F238E27FC236}">
                      <a16:creationId xmlns:a16="http://schemas.microsoft.com/office/drawing/2014/main" id="{CCB462E5-E6E2-43D4-1C79-3C5AD93A7A6F}"/>
                    </a:ext>
                  </a:extLst>
                </p:cNvPr>
                <p:cNvPicPr/>
                <p:nvPr/>
              </p:nvPicPr>
              <p:blipFill>
                <a:blip r:embed="rId36"/>
                <a:stretch>
                  <a:fillRect/>
                </a:stretch>
              </p:blipFill>
              <p:spPr>
                <a:xfrm>
                  <a:off x="4857745" y="3666202"/>
                  <a:ext cx="1172880" cy="1501200"/>
                </a:xfrm>
                <a:prstGeom prst="rect">
                  <a:avLst/>
                </a:prstGeom>
              </p:spPr>
            </p:pic>
          </mc:Fallback>
        </mc:AlternateContent>
        <mc:AlternateContent xmlns:mc="http://schemas.openxmlformats.org/markup-compatibility/2006" xmlns:p14="http://schemas.microsoft.com/office/powerpoint/2010/main">
          <mc:Choice Requires="p14">
            <p:contentPart p14:bwMode="auto" r:id="rId37">
              <p14:nvContentPartPr>
                <p14:cNvPr id="51" name="Ink 50">
                  <a:extLst>
                    <a:ext uri="{FF2B5EF4-FFF2-40B4-BE49-F238E27FC236}">
                      <a16:creationId xmlns:a16="http://schemas.microsoft.com/office/drawing/2014/main" id="{783866D0-87F4-9370-A22A-53DC24B43422}"/>
                    </a:ext>
                  </a:extLst>
                </p14:cNvPr>
                <p14:cNvContentPartPr/>
                <p14:nvPr/>
              </p14:nvContentPartPr>
              <p14:xfrm>
                <a:off x="4239265" y="5104762"/>
                <a:ext cx="681480" cy="694800"/>
              </p14:xfrm>
            </p:contentPart>
          </mc:Choice>
          <mc:Fallback xmlns="">
            <p:pic>
              <p:nvPicPr>
                <p:cNvPr id="51" name="Ink 50">
                  <a:extLst>
                    <a:ext uri="{FF2B5EF4-FFF2-40B4-BE49-F238E27FC236}">
                      <a16:creationId xmlns:a16="http://schemas.microsoft.com/office/drawing/2014/main" id="{783866D0-87F4-9370-A22A-53DC24B43422}"/>
                    </a:ext>
                  </a:extLst>
                </p:cNvPr>
                <p:cNvPicPr/>
                <p:nvPr/>
              </p:nvPicPr>
              <p:blipFill>
                <a:blip r:embed="rId38"/>
                <a:stretch>
                  <a:fillRect/>
                </a:stretch>
              </p:blipFill>
              <p:spPr>
                <a:xfrm>
                  <a:off x="4176265" y="5041762"/>
                  <a:ext cx="807120" cy="820440"/>
                </a:xfrm>
                <a:prstGeom prst="rect">
                  <a:avLst/>
                </a:prstGeom>
              </p:spPr>
            </p:pic>
          </mc:Fallback>
        </mc:AlternateContent>
        <mc:AlternateContent xmlns:mc="http://schemas.openxmlformats.org/markup-compatibility/2006" xmlns:p14="http://schemas.microsoft.com/office/powerpoint/2010/main">
          <mc:Choice Requires="p14">
            <p:contentPart p14:bwMode="auto" r:id="rId39">
              <p14:nvContentPartPr>
                <p14:cNvPr id="52" name="Ink 51">
                  <a:extLst>
                    <a:ext uri="{FF2B5EF4-FFF2-40B4-BE49-F238E27FC236}">
                      <a16:creationId xmlns:a16="http://schemas.microsoft.com/office/drawing/2014/main" id="{09AEB23A-6158-D542-E91C-B486B6A43FE6}"/>
                    </a:ext>
                  </a:extLst>
                </p14:cNvPr>
                <p14:cNvContentPartPr/>
                <p14:nvPr/>
              </p14:nvContentPartPr>
              <p14:xfrm>
                <a:off x="4178785" y="4958962"/>
                <a:ext cx="587520" cy="480600"/>
              </p14:xfrm>
            </p:contentPart>
          </mc:Choice>
          <mc:Fallback xmlns="">
            <p:pic>
              <p:nvPicPr>
                <p:cNvPr id="52" name="Ink 51">
                  <a:extLst>
                    <a:ext uri="{FF2B5EF4-FFF2-40B4-BE49-F238E27FC236}">
                      <a16:creationId xmlns:a16="http://schemas.microsoft.com/office/drawing/2014/main" id="{09AEB23A-6158-D542-E91C-B486B6A43FE6}"/>
                    </a:ext>
                  </a:extLst>
                </p:cNvPr>
                <p:cNvPicPr/>
                <p:nvPr/>
              </p:nvPicPr>
              <p:blipFill>
                <a:blip r:embed="rId40"/>
                <a:stretch>
                  <a:fillRect/>
                </a:stretch>
              </p:blipFill>
              <p:spPr>
                <a:xfrm>
                  <a:off x="4115785" y="4896009"/>
                  <a:ext cx="713160" cy="606146"/>
                </a:xfrm>
                <a:prstGeom prst="rect">
                  <a:avLst/>
                </a:prstGeom>
              </p:spPr>
            </p:pic>
          </mc:Fallback>
        </mc:AlternateContent>
        <mc:AlternateContent xmlns:mc="http://schemas.openxmlformats.org/markup-compatibility/2006" xmlns:p14="http://schemas.microsoft.com/office/powerpoint/2010/main">
          <mc:Choice Requires="p14">
            <p:contentPart p14:bwMode="auto" r:id="rId41">
              <p14:nvContentPartPr>
                <p14:cNvPr id="53" name="Ink 52">
                  <a:extLst>
                    <a:ext uri="{FF2B5EF4-FFF2-40B4-BE49-F238E27FC236}">
                      <a16:creationId xmlns:a16="http://schemas.microsoft.com/office/drawing/2014/main" id="{25185725-8D47-89EF-8DE9-87D9D03146E0}"/>
                    </a:ext>
                  </a:extLst>
                </p14:cNvPr>
                <p14:cNvContentPartPr/>
                <p14:nvPr/>
              </p14:nvContentPartPr>
              <p14:xfrm>
                <a:off x="4128745" y="4386562"/>
                <a:ext cx="999720" cy="569160"/>
              </p14:xfrm>
            </p:contentPart>
          </mc:Choice>
          <mc:Fallback xmlns="">
            <p:pic>
              <p:nvPicPr>
                <p:cNvPr id="53" name="Ink 52">
                  <a:extLst>
                    <a:ext uri="{FF2B5EF4-FFF2-40B4-BE49-F238E27FC236}">
                      <a16:creationId xmlns:a16="http://schemas.microsoft.com/office/drawing/2014/main" id="{25185725-8D47-89EF-8DE9-87D9D03146E0}"/>
                    </a:ext>
                  </a:extLst>
                </p:cNvPr>
                <p:cNvPicPr/>
                <p:nvPr/>
              </p:nvPicPr>
              <p:blipFill>
                <a:blip r:embed="rId42"/>
                <a:stretch>
                  <a:fillRect/>
                </a:stretch>
              </p:blipFill>
              <p:spPr>
                <a:xfrm>
                  <a:off x="4065722" y="4323562"/>
                  <a:ext cx="1125405" cy="694800"/>
                </a:xfrm>
                <a:prstGeom prst="rect">
                  <a:avLst/>
                </a:prstGeom>
              </p:spPr>
            </p:pic>
          </mc:Fallback>
        </mc:AlternateContent>
        <mc:AlternateContent xmlns:mc="http://schemas.openxmlformats.org/markup-compatibility/2006" xmlns:p14="http://schemas.microsoft.com/office/powerpoint/2010/main">
          <mc:Choice Requires="p14">
            <p:contentPart p14:bwMode="auto" r:id="rId43">
              <p14:nvContentPartPr>
                <p14:cNvPr id="54" name="Ink 53">
                  <a:extLst>
                    <a:ext uri="{FF2B5EF4-FFF2-40B4-BE49-F238E27FC236}">
                      <a16:creationId xmlns:a16="http://schemas.microsoft.com/office/drawing/2014/main" id="{930AE05E-0022-F7EF-F160-91334207D305}"/>
                    </a:ext>
                  </a:extLst>
                </p14:cNvPr>
                <p14:cNvContentPartPr/>
                <p14:nvPr/>
              </p14:nvContentPartPr>
              <p14:xfrm>
                <a:off x="4122265" y="3876442"/>
                <a:ext cx="1384200" cy="653400"/>
              </p14:xfrm>
            </p:contentPart>
          </mc:Choice>
          <mc:Fallback xmlns="">
            <p:pic>
              <p:nvPicPr>
                <p:cNvPr id="54" name="Ink 53">
                  <a:extLst>
                    <a:ext uri="{FF2B5EF4-FFF2-40B4-BE49-F238E27FC236}">
                      <a16:creationId xmlns:a16="http://schemas.microsoft.com/office/drawing/2014/main" id="{930AE05E-0022-F7EF-F160-91334207D305}"/>
                    </a:ext>
                  </a:extLst>
                </p:cNvPr>
                <p:cNvPicPr/>
                <p:nvPr/>
              </p:nvPicPr>
              <p:blipFill>
                <a:blip r:embed="rId44"/>
                <a:stretch>
                  <a:fillRect/>
                </a:stretch>
              </p:blipFill>
              <p:spPr>
                <a:xfrm>
                  <a:off x="4059265" y="3813442"/>
                  <a:ext cx="1509840" cy="779040"/>
                </a:xfrm>
                <a:prstGeom prst="rect">
                  <a:avLst/>
                </a:prstGeom>
              </p:spPr>
            </p:pic>
          </mc:Fallback>
        </mc:AlternateContent>
        <mc:AlternateContent xmlns:mc="http://schemas.openxmlformats.org/markup-compatibility/2006" xmlns:p14="http://schemas.microsoft.com/office/powerpoint/2010/main">
          <mc:Choice Requires="p14">
            <p:contentPart p14:bwMode="auto" r:id="rId45">
              <p14:nvContentPartPr>
                <p14:cNvPr id="55" name="Ink 54">
                  <a:extLst>
                    <a:ext uri="{FF2B5EF4-FFF2-40B4-BE49-F238E27FC236}">
                      <a16:creationId xmlns:a16="http://schemas.microsoft.com/office/drawing/2014/main" id="{B5630393-32C6-555D-6570-BAC19D2182B4}"/>
                    </a:ext>
                  </a:extLst>
                </p14:cNvPr>
                <p14:cNvContentPartPr/>
                <p14:nvPr/>
              </p14:nvContentPartPr>
              <p14:xfrm>
                <a:off x="5213065" y="3848002"/>
                <a:ext cx="358560" cy="478800"/>
              </p14:xfrm>
            </p:contentPart>
          </mc:Choice>
          <mc:Fallback xmlns="">
            <p:pic>
              <p:nvPicPr>
                <p:cNvPr id="55" name="Ink 54">
                  <a:extLst>
                    <a:ext uri="{FF2B5EF4-FFF2-40B4-BE49-F238E27FC236}">
                      <a16:creationId xmlns:a16="http://schemas.microsoft.com/office/drawing/2014/main" id="{B5630393-32C6-555D-6570-BAC19D2182B4}"/>
                    </a:ext>
                  </a:extLst>
                </p:cNvPr>
                <p:cNvPicPr/>
                <p:nvPr/>
              </p:nvPicPr>
              <p:blipFill>
                <a:blip r:embed="rId46"/>
                <a:stretch>
                  <a:fillRect/>
                </a:stretch>
              </p:blipFill>
              <p:spPr>
                <a:xfrm>
                  <a:off x="5150002" y="3785002"/>
                  <a:ext cx="484326" cy="604440"/>
                </a:xfrm>
                <a:prstGeom prst="rect">
                  <a:avLst/>
                </a:prstGeom>
              </p:spPr>
            </p:pic>
          </mc:Fallback>
        </mc:AlternateContent>
        <mc:AlternateContent xmlns:mc="http://schemas.openxmlformats.org/markup-compatibility/2006" xmlns:p14="http://schemas.microsoft.com/office/powerpoint/2010/main">
          <mc:Choice Requires="p14">
            <p:contentPart p14:bwMode="auto" r:id="rId47">
              <p14:nvContentPartPr>
                <p14:cNvPr id="58" name="Ink 57">
                  <a:extLst>
                    <a:ext uri="{FF2B5EF4-FFF2-40B4-BE49-F238E27FC236}">
                      <a16:creationId xmlns:a16="http://schemas.microsoft.com/office/drawing/2014/main" id="{09042EE0-8778-3FA0-8F71-2766A54CA417}"/>
                    </a:ext>
                  </a:extLst>
                </p14:cNvPr>
                <p14:cNvContentPartPr/>
                <p14:nvPr/>
              </p14:nvContentPartPr>
              <p14:xfrm>
                <a:off x="5499265" y="3639922"/>
                <a:ext cx="300240" cy="259560"/>
              </p14:xfrm>
            </p:contentPart>
          </mc:Choice>
          <mc:Fallback xmlns="">
            <p:pic>
              <p:nvPicPr>
                <p:cNvPr id="58" name="Ink 57">
                  <a:extLst>
                    <a:ext uri="{FF2B5EF4-FFF2-40B4-BE49-F238E27FC236}">
                      <a16:creationId xmlns:a16="http://schemas.microsoft.com/office/drawing/2014/main" id="{09042EE0-8778-3FA0-8F71-2766A54CA417}"/>
                    </a:ext>
                  </a:extLst>
                </p:cNvPr>
                <p:cNvPicPr/>
                <p:nvPr/>
              </p:nvPicPr>
              <p:blipFill>
                <a:blip r:embed="rId48"/>
                <a:stretch>
                  <a:fillRect/>
                </a:stretch>
              </p:blipFill>
              <p:spPr>
                <a:xfrm>
                  <a:off x="5436189" y="3576922"/>
                  <a:ext cx="426031" cy="385200"/>
                </a:xfrm>
                <a:prstGeom prst="rect">
                  <a:avLst/>
                </a:prstGeom>
              </p:spPr>
            </p:pic>
          </mc:Fallback>
        </mc:AlternateContent>
        <mc:AlternateContent xmlns:mc="http://schemas.openxmlformats.org/markup-compatibility/2006" xmlns:p14="http://schemas.microsoft.com/office/powerpoint/2010/main">
          <mc:Choice Requires="p14">
            <p:contentPart p14:bwMode="auto" r:id="rId49">
              <p14:nvContentPartPr>
                <p14:cNvPr id="59" name="Ink 58">
                  <a:extLst>
                    <a:ext uri="{FF2B5EF4-FFF2-40B4-BE49-F238E27FC236}">
                      <a16:creationId xmlns:a16="http://schemas.microsoft.com/office/drawing/2014/main" id="{93CBC600-E043-53E8-BAAF-56EAA5BA50B7}"/>
                    </a:ext>
                  </a:extLst>
                </p14:cNvPr>
                <p14:cNvContentPartPr/>
                <p14:nvPr/>
              </p14:nvContentPartPr>
              <p14:xfrm>
                <a:off x="6441025" y="3191722"/>
                <a:ext cx="1705320" cy="897120"/>
              </p14:xfrm>
            </p:contentPart>
          </mc:Choice>
          <mc:Fallback xmlns="">
            <p:pic>
              <p:nvPicPr>
                <p:cNvPr id="59" name="Ink 58">
                  <a:extLst>
                    <a:ext uri="{FF2B5EF4-FFF2-40B4-BE49-F238E27FC236}">
                      <a16:creationId xmlns:a16="http://schemas.microsoft.com/office/drawing/2014/main" id="{93CBC600-E043-53E8-BAAF-56EAA5BA50B7}"/>
                    </a:ext>
                  </a:extLst>
                </p:cNvPr>
                <p:cNvPicPr/>
                <p:nvPr/>
              </p:nvPicPr>
              <p:blipFill>
                <a:blip r:embed="rId50"/>
                <a:stretch>
                  <a:fillRect/>
                </a:stretch>
              </p:blipFill>
              <p:spPr>
                <a:xfrm>
                  <a:off x="6378025" y="3128722"/>
                  <a:ext cx="1830960" cy="1022760"/>
                </a:xfrm>
                <a:prstGeom prst="rect">
                  <a:avLst/>
                </a:prstGeom>
              </p:spPr>
            </p:pic>
          </mc:Fallback>
        </mc:AlternateContent>
        <mc:AlternateContent xmlns:mc="http://schemas.openxmlformats.org/markup-compatibility/2006" xmlns:p14="http://schemas.microsoft.com/office/powerpoint/2010/main">
          <mc:Choice Requires="p14">
            <p:contentPart p14:bwMode="auto" r:id="rId51">
              <p14:nvContentPartPr>
                <p14:cNvPr id="60" name="Ink 59">
                  <a:extLst>
                    <a:ext uri="{FF2B5EF4-FFF2-40B4-BE49-F238E27FC236}">
                      <a16:creationId xmlns:a16="http://schemas.microsoft.com/office/drawing/2014/main" id="{85E0F25C-996A-6FBF-1A21-6A5F3D6A9063}"/>
                    </a:ext>
                  </a:extLst>
                </p14:cNvPr>
                <p14:cNvContentPartPr/>
                <p14:nvPr/>
              </p14:nvContentPartPr>
              <p14:xfrm>
                <a:off x="6353185" y="3780682"/>
                <a:ext cx="1159200" cy="1837800"/>
              </p14:xfrm>
            </p:contentPart>
          </mc:Choice>
          <mc:Fallback xmlns="">
            <p:pic>
              <p:nvPicPr>
                <p:cNvPr id="60" name="Ink 59">
                  <a:extLst>
                    <a:ext uri="{FF2B5EF4-FFF2-40B4-BE49-F238E27FC236}">
                      <a16:creationId xmlns:a16="http://schemas.microsoft.com/office/drawing/2014/main" id="{85E0F25C-996A-6FBF-1A21-6A5F3D6A9063}"/>
                    </a:ext>
                  </a:extLst>
                </p:cNvPr>
                <p:cNvPicPr/>
                <p:nvPr/>
              </p:nvPicPr>
              <p:blipFill>
                <a:blip r:embed="rId52"/>
                <a:stretch>
                  <a:fillRect/>
                </a:stretch>
              </p:blipFill>
              <p:spPr>
                <a:xfrm>
                  <a:off x="6290185" y="3717682"/>
                  <a:ext cx="1284840" cy="1963440"/>
                </a:xfrm>
                <a:prstGeom prst="rect">
                  <a:avLst/>
                </a:prstGeom>
              </p:spPr>
            </p:pic>
          </mc:Fallback>
        </mc:AlternateContent>
        <mc:AlternateContent xmlns:mc="http://schemas.openxmlformats.org/markup-compatibility/2006" xmlns:p14="http://schemas.microsoft.com/office/powerpoint/2010/main">
          <mc:Choice Requires="p14">
            <p:contentPart p14:bwMode="auto" r:id="rId53">
              <p14:nvContentPartPr>
                <p14:cNvPr id="61" name="Ink 60">
                  <a:extLst>
                    <a:ext uri="{FF2B5EF4-FFF2-40B4-BE49-F238E27FC236}">
                      <a16:creationId xmlns:a16="http://schemas.microsoft.com/office/drawing/2014/main" id="{9CBEB30B-99ED-9C64-5AA5-FC4263F73DFD}"/>
                    </a:ext>
                  </a:extLst>
                </p14:cNvPr>
                <p14:cNvContentPartPr/>
                <p14:nvPr/>
              </p14:nvContentPartPr>
              <p14:xfrm>
                <a:off x="7512385" y="5585362"/>
                <a:ext cx="540720" cy="256680"/>
              </p14:xfrm>
            </p:contentPart>
          </mc:Choice>
          <mc:Fallback xmlns="">
            <p:pic>
              <p:nvPicPr>
                <p:cNvPr id="61" name="Ink 60">
                  <a:extLst>
                    <a:ext uri="{FF2B5EF4-FFF2-40B4-BE49-F238E27FC236}">
                      <a16:creationId xmlns:a16="http://schemas.microsoft.com/office/drawing/2014/main" id="{9CBEB30B-99ED-9C64-5AA5-FC4263F73DFD}"/>
                    </a:ext>
                  </a:extLst>
                </p:cNvPr>
                <p:cNvPicPr/>
                <p:nvPr/>
              </p:nvPicPr>
              <p:blipFill>
                <a:blip r:embed="rId54"/>
                <a:stretch>
                  <a:fillRect/>
                </a:stretch>
              </p:blipFill>
              <p:spPr>
                <a:xfrm>
                  <a:off x="7449385" y="5522362"/>
                  <a:ext cx="666360" cy="382320"/>
                </a:xfrm>
                <a:prstGeom prst="rect">
                  <a:avLst/>
                </a:prstGeom>
              </p:spPr>
            </p:pic>
          </mc:Fallback>
        </mc:AlternateContent>
        <mc:AlternateContent xmlns:mc="http://schemas.openxmlformats.org/markup-compatibility/2006" xmlns:p14="http://schemas.microsoft.com/office/powerpoint/2010/main">
          <mc:Choice Requires="p14">
            <p:contentPart p14:bwMode="auto" r:id="rId55">
              <p14:nvContentPartPr>
                <p14:cNvPr id="62" name="Ink 61">
                  <a:extLst>
                    <a:ext uri="{FF2B5EF4-FFF2-40B4-BE49-F238E27FC236}">
                      <a16:creationId xmlns:a16="http://schemas.microsoft.com/office/drawing/2014/main" id="{38994EDA-C430-C0AE-C18A-1BF4E35BBC9F}"/>
                    </a:ext>
                  </a:extLst>
                </p14:cNvPr>
                <p14:cNvContentPartPr/>
                <p14:nvPr/>
              </p14:nvContentPartPr>
              <p14:xfrm>
                <a:off x="7402945" y="4954282"/>
                <a:ext cx="711000" cy="447480"/>
              </p14:xfrm>
            </p:contentPart>
          </mc:Choice>
          <mc:Fallback xmlns="">
            <p:pic>
              <p:nvPicPr>
                <p:cNvPr id="62" name="Ink 61">
                  <a:extLst>
                    <a:ext uri="{FF2B5EF4-FFF2-40B4-BE49-F238E27FC236}">
                      <a16:creationId xmlns:a16="http://schemas.microsoft.com/office/drawing/2014/main" id="{38994EDA-C430-C0AE-C18A-1BF4E35BBC9F}"/>
                    </a:ext>
                  </a:extLst>
                </p:cNvPr>
                <p:cNvPicPr/>
                <p:nvPr/>
              </p:nvPicPr>
              <p:blipFill>
                <a:blip r:embed="rId56"/>
                <a:stretch>
                  <a:fillRect/>
                </a:stretch>
              </p:blipFill>
              <p:spPr>
                <a:xfrm>
                  <a:off x="7339945" y="4891282"/>
                  <a:ext cx="836640" cy="573120"/>
                </a:xfrm>
                <a:prstGeom prst="rect">
                  <a:avLst/>
                </a:prstGeom>
              </p:spPr>
            </p:pic>
          </mc:Fallback>
        </mc:AlternateContent>
        <mc:AlternateContent xmlns:mc="http://schemas.openxmlformats.org/markup-compatibility/2006" xmlns:p14="http://schemas.microsoft.com/office/powerpoint/2010/main">
          <mc:Choice Requires="p14">
            <p:contentPart p14:bwMode="auto" r:id="rId57">
              <p14:nvContentPartPr>
                <p14:cNvPr id="63" name="Ink 62">
                  <a:extLst>
                    <a:ext uri="{FF2B5EF4-FFF2-40B4-BE49-F238E27FC236}">
                      <a16:creationId xmlns:a16="http://schemas.microsoft.com/office/drawing/2014/main" id="{88B20989-0CAE-19DF-CEA7-AD118A683589}"/>
                    </a:ext>
                  </a:extLst>
                </p14:cNvPr>
                <p14:cNvContentPartPr/>
                <p14:nvPr/>
              </p14:nvContentPartPr>
              <p14:xfrm>
                <a:off x="6966265" y="4418962"/>
                <a:ext cx="1194840" cy="561960"/>
              </p14:xfrm>
            </p:contentPart>
          </mc:Choice>
          <mc:Fallback xmlns="">
            <p:pic>
              <p:nvPicPr>
                <p:cNvPr id="63" name="Ink 62">
                  <a:extLst>
                    <a:ext uri="{FF2B5EF4-FFF2-40B4-BE49-F238E27FC236}">
                      <a16:creationId xmlns:a16="http://schemas.microsoft.com/office/drawing/2014/main" id="{88B20989-0CAE-19DF-CEA7-AD118A683589}"/>
                    </a:ext>
                  </a:extLst>
                </p:cNvPr>
                <p:cNvPicPr/>
                <p:nvPr/>
              </p:nvPicPr>
              <p:blipFill>
                <a:blip r:embed="rId58"/>
                <a:stretch>
                  <a:fillRect/>
                </a:stretch>
              </p:blipFill>
              <p:spPr>
                <a:xfrm>
                  <a:off x="6903265" y="4355962"/>
                  <a:ext cx="1320480" cy="687600"/>
                </a:xfrm>
                <a:prstGeom prst="rect">
                  <a:avLst/>
                </a:prstGeom>
              </p:spPr>
            </p:pic>
          </mc:Fallback>
        </mc:AlternateContent>
        <mc:AlternateContent xmlns:mc="http://schemas.openxmlformats.org/markup-compatibility/2006" xmlns:p14="http://schemas.microsoft.com/office/powerpoint/2010/main">
          <mc:Choice Requires="p14">
            <p:contentPart p14:bwMode="auto" r:id="rId59">
              <p14:nvContentPartPr>
                <p14:cNvPr id="1024" name="Ink 1023">
                  <a:extLst>
                    <a:ext uri="{FF2B5EF4-FFF2-40B4-BE49-F238E27FC236}">
                      <a16:creationId xmlns:a16="http://schemas.microsoft.com/office/drawing/2014/main" id="{689C4709-0020-D1F7-2D47-4200B4E30087}"/>
                    </a:ext>
                  </a:extLst>
                </p14:cNvPr>
                <p14:cNvContentPartPr/>
                <p14:nvPr/>
              </p14:nvContentPartPr>
              <p14:xfrm>
                <a:off x="6650905" y="3901642"/>
                <a:ext cx="1502280" cy="675360"/>
              </p14:xfrm>
            </p:contentPart>
          </mc:Choice>
          <mc:Fallback xmlns="">
            <p:pic>
              <p:nvPicPr>
                <p:cNvPr id="1024" name="Ink 1023">
                  <a:extLst>
                    <a:ext uri="{FF2B5EF4-FFF2-40B4-BE49-F238E27FC236}">
                      <a16:creationId xmlns:a16="http://schemas.microsoft.com/office/drawing/2014/main" id="{689C4709-0020-D1F7-2D47-4200B4E30087}"/>
                    </a:ext>
                  </a:extLst>
                </p:cNvPr>
                <p:cNvPicPr/>
                <p:nvPr/>
              </p:nvPicPr>
              <p:blipFill>
                <a:blip r:embed="rId60"/>
                <a:stretch>
                  <a:fillRect/>
                </a:stretch>
              </p:blipFill>
              <p:spPr>
                <a:xfrm>
                  <a:off x="6587905" y="3838642"/>
                  <a:ext cx="1627920" cy="801000"/>
                </a:xfrm>
                <a:prstGeom prst="rect">
                  <a:avLst/>
                </a:prstGeom>
              </p:spPr>
            </p:pic>
          </mc:Fallback>
        </mc:AlternateContent>
        <mc:AlternateContent xmlns:mc="http://schemas.openxmlformats.org/markup-compatibility/2006" xmlns:p14="http://schemas.microsoft.com/office/powerpoint/2010/main">
          <mc:Choice Requires="p14">
            <p:contentPart p14:bwMode="auto" r:id="rId61">
              <p14:nvContentPartPr>
                <p14:cNvPr id="1025" name="Ink 1024">
                  <a:extLst>
                    <a:ext uri="{FF2B5EF4-FFF2-40B4-BE49-F238E27FC236}">
                      <a16:creationId xmlns:a16="http://schemas.microsoft.com/office/drawing/2014/main" id="{ED1D80F5-B07D-1FCC-942E-E9E011E9401F}"/>
                    </a:ext>
                  </a:extLst>
                </p14:cNvPr>
                <p14:cNvContentPartPr/>
                <p14:nvPr/>
              </p14:nvContentPartPr>
              <p14:xfrm>
                <a:off x="6717505" y="3985162"/>
                <a:ext cx="420840" cy="465480"/>
              </p14:xfrm>
            </p:contentPart>
          </mc:Choice>
          <mc:Fallback xmlns="">
            <p:pic>
              <p:nvPicPr>
                <p:cNvPr id="1025" name="Ink 1024">
                  <a:extLst>
                    <a:ext uri="{FF2B5EF4-FFF2-40B4-BE49-F238E27FC236}">
                      <a16:creationId xmlns:a16="http://schemas.microsoft.com/office/drawing/2014/main" id="{ED1D80F5-B07D-1FCC-942E-E9E011E9401F}"/>
                    </a:ext>
                  </a:extLst>
                </p:cNvPr>
                <p:cNvPicPr/>
                <p:nvPr/>
              </p:nvPicPr>
              <p:blipFill>
                <a:blip r:embed="rId62"/>
                <a:stretch>
                  <a:fillRect/>
                </a:stretch>
              </p:blipFill>
              <p:spPr>
                <a:xfrm>
                  <a:off x="6654451" y="3922162"/>
                  <a:ext cx="546588" cy="591120"/>
                </a:xfrm>
                <a:prstGeom prst="rect">
                  <a:avLst/>
                </a:prstGeom>
              </p:spPr>
            </p:pic>
          </mc:Fallback>
        </mc:AlternateContent>
      </p:grpSp>
      <mc:AlternateContent xmlns:mc="http://schemas.openxmlformats.org/markup-compatibility/2006" xmlns:p14="http://schemas.microsoft.com/office/powerpoint/2010/main">
        <mc:Choice Requires="p14">
          <p:contentPart p14:bwMode="auto" r:id="rId63">
            <p14:nvContentPartPr>
              <p14:cNvPr id="8" name="Ink 7">
                <a:extLst>
                  <a:ext uri="{FF2B5EF4-FFF2-40B4-BE49-F238E27FC236}">
                    <a16:creationId xmlns:a16="http://schemas.microsoft.com/office/drawing/2014/main" id="{DD5CF5E9-27FF-1401-24E1-4B32CC1351B3}"/>
                  </a:ext>
                </a:extLst>
              </p14:cNvPr>
              <p14:cNvContentPartPr/>
              <p14:nvPr/>
            </p14:nvContentPartPr>
            <p14:xfrm>
              <a:off x="6714326" y="3872074"/>
              <a:ext cx="360" cy="360"/>
            </p14:xfrm>
          </p:contentPart>
        </mc:Choice>
        <mc:Fallback xmlns="">
          <p:pic>
            <p:nvPicPr>
              <p:cNvPr id="8" name="Ink 7">
                <a:extLst>
                  <a:ext uri="{FF2B5EF4-FFF2-40B4-BE49-F238E27FC236}">
                    <a16:creationId xmlns:a16="http://schemas.microsoft.com/office/drawing/2014/main" id="{DD5CF5E9-27FF-1401-24E1-4B32CC1351B3}"/>
                  </a:ext>
                </a:extLst>
              </p:cNvPr>
              <p:cNvPicPr/>
              <p:nvPr/>
            </p:nvPicPr>
            <p:blipFill>
              <a:blip r:embed="rId64"/>
              <a:stretch>
                <a:fillRect/>
              </a:stretch>
            </p:blipFill>
            <p:spPr>
              <a:xfrm>
                <a:off x="6696326" y="3854074"/>
                <a:ext cx="36000" cy="36000"/>
              </a:xfrm>
              <a:prstGeom prst="rect">
                <a:avLst/>
              </a:prstGeom>
            </p:spPr>
          </p:pic>
        </mc:Fallback>
      </mc:AlternateContent>
      <p:pic>
        <p:nvPicPr>
          <p:cNvPr id="3" name="Spleorenallargefluid.mp4" descr="Spleorenallargefluid.mp4">
            <a:hlinkClick r:id="" action="ppaction://media"/>
            <a:extLst>
              <a:ext uri="{FF2B5EF4-FFF2-40B4-BE49-F238E27FC236}">
                <a16:creationId xmlns:a16="http://schemas.microsoft.com/office/drawing/2014/main" id="{EF255890-5BF5-B41B-05F5-1CD9DEC31941}"/>
              </a:ext>
            </a:extLst>
          </p:cNvPr>
          <p:cNvPicPr>
            <a:picLocks noChangeAspect="1"/>
          </p:cNvPicPr>
          <p:nvPr>
            <a:videoFile r:link="rId2"/>
            <p:extLst>
              <p:ext uri="{DAA4B4D4-6D71-4841-9C94-3DE7FCFB9230}">
                <p14:media xmlns:p14="http://schemas.microsoft.com/office/powerpoint/2010/main" r:embed="rId1"/>
              </p:ext>
            </p:extLst>
          </p:nvPr>
        </p:nvPicPr>
        <p:blipFill>
          <a:blip r:embed="rId65"/>
          <a:stretch>
            <a:fillRect/>
          </a:stretch>
        </p:blipFill>
        <p:spPr>
          <a:xfrm>
            <a:off x="2636480" y="614478"/>
            <a:ext cx="6919040" cy="5189280"/>
          </a:xfrm>
          <a:prstGeom prst="rect">
            <a:avLst/>
          </a:prstGeom>
        </p:spPr>
      </p:pic>
      <p:pic>
        <p:nvPicPr>
          <p:cNvPr id="4" name="Audio Recording Oct 18, 2022 at 8:45:08 PM">
            <a:hlinkClick r:id="" action="ppaction://media"/>
            <a:extLst>
              <a:ext uri="{FF2B5EF4-FFF2-40B4-BE49-F238E27FC236}">
                <a16:creationId xmlns:a16="http://schemas.microsoft.com/office/drawing/2014/main" id="{75B50539-3A04-842C-98FC-478F1F185B48}"/>
              </a:ext>
            </a:extLst>
          </p:cNvPr>
          <p:cNvPicPr>
            <a:picLocks noChangeAspect="1"/>
          </p:cNvPicPr>
          <p:nvPr>
            <a:audioFile r:link="rId4"/>
            <p:extLst>
              <p:ext uri="{DAA4B4D4-6D71-4841-9C94-3DE7FCFB9230}">
                <p14:media xmlns:p14="http://schemas.microsoft.com/office/powerpoint/2010/main" r:embed="rId3"/>
              </p:ext>
            </p:extLst>
          </p:nvPr>
        </p:nvPicPr>
        <p:blipFill>
          <a:blip r:embed="rId66"/>
          <a:stretch>
            <a:fillRect/>
          </a:stretch>
        </p:blipFill>
        <p:spPr>
          <a:xfrm>
            <a:off x="10987960" y="4994162"/>
            <a:ext cx="812800" cy="812800"/>
          </a:xfrm>
          <a:prstGeom prst="rect">
            <a:avLst/>
          </a:prstGeom>
        </p:spPr>
      </p:pic>
    </p:spTree>
    <p:extLst>
      <p:ext uri="{BB962C8B-B14F-4D97-AF65-F5344CB8AC3E}">
        <p14:creationId xmlns:p14="http://schemas.microsoft.com/office/powerpoint/2010/main" val="10695709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4000" fill="hold"/>
                                        <p:tgtEl>
                                          <p:spTgt spid="3"/>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53824"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1" fill="hold" display="0">
                  <p:stCondLst>
                    <p:cond delay="indefinite"/>
                  </p:stCondLst>
                </p:cTn>
                <p:tgtEl>
                  <p:spTgt spid="3"/>
                </p:tgtEl>
              </p:cMediaNode>
            </p:video>
            <p:seq concurrent="1" nextAc="seek">
              <p:cTn id="12" restart="whenNotActive" fill="hold" evtFilter="cancelBubble" nodeType="interactiveSeq">
                <p:stCondLst>
                  <p:cond evt="onClick" delay="0">
                    <p:tgtEl>
                      <p:spTgt spid="3"/>
                    </p:tgtEl>
                  </p:cond>
                </p:stCondLst>
                <p:endSync evt="end" delay="0">
                  <p:rtn val="all"/>
                </p:endSync>
                <p:childTnLst>
                  <p:par>
                    <p:cTn id="13" fill="hold">
                      <p:stCondLst>
                        <p:cond delay="0"/>
                      </p:stCondLst>
                      <p:childTnLst>
                        <p:par>
                          <p:cTn id="14" fill="hold">
                            <p:stCondLst>
                              <p:cond delay="0"/>
                            </p:stCondLst>
                            <p:childTnLst>
                              <p:par>
                                <p:cTn id="15" presetID="2" presetClass="mediacall" presetSubtype="0" fill="hold" nodeType="clickEffect">
                                  <p:stCondLst>
                                    <p:cond delay="0"/>
                                  </p:stCondLst>
                                  <p:childTnLst>
                                    <p:cmd type="call" cmd="togglePause">
                                      <p:cBhvr>
                                        <p:cTn id="16" dur="1" fill="hold"/>
                                        <p:tgtEl>
                                          <p:spTgt spid="3"/>
                                        </p:tgtEl>
                                      </p:cBhvr>
                                    </p:cmd>
                                  </p:childTnLst>
                                </p:cTn>
                              </p:par>
                            </p:childTnLst>
                          </p:cTn>
                        </p:par>
                      </p:childTnLst>
                    </p:cTn>
                  </p:par>
                </p:childTnLst>
              </p:cTn>
              <p:nextCondLst>
                <p:cond evt="onClick" delay="0">
                  <p:tgtEl>
                    <p:spTgt spid="3"/>
                  </p:tgtEl>
                </p:cond>
              </p:nextCondLst>
            </p:seq>
            <p:audio>
              <p:cMediaNode vol="80000">
                <p:cTn id="17" fill="hold" display="0">
                  <p:stCondLst>
                    <p:cond delay="indefinite"/>
                  </p:stCondLst>
                  <p:endCondLst>
                    <p:cond evt="onStopAudio" delay="0">
                      <p:tgtEl>
                        <p:sldTgt/>
                      </p:tgtEl>
                    </p:cond>
                  </p:endCondLst>
                </p:cTn>
                <p:tgtEl>
                  <p:spTgt spid="4"/>
                </p:tgtEl>
              </p:cMediaNode>
            </p:audio>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62C33B-CFA6-0239-4799-6A1FBFB30284}"/>
              </a:ext>
            </a:extLst>
          </p:cNvPr>
          <p:cNvSpPr>
            <a:spLocks noGrp="1"/>
          </p:cNvSpPr>
          <p:nvPr>
            <p:ph type="ctrTitle"/>
          </p:nvPr>
        </p:nvSpPr>
        <p:spPr>
          <a:xfrm>
            <a:off x="1586753" y="950258"/>
            <a:ext cx="9144000" cy="753035"/>
          </a:xfrm>
        </p:spPr>
        <p:txBody>
          <a:bodyPr>
            <a:normAutofit/>
          </a:bodyPr>
          <a:lstStyle/>
          <a:p>
            <a:r>
              <a:rPr lang="en-US" u="sng" dirty="0"/>
              <a:t>Summary - LUQ</a:t>
            </a:r>
          </a:p>
        </p:txBody>
      </p:sp>
      <p:sp>
        <p:nvSpPr>
          <p:cNvPr id="3" name="Subtitle 2">
            <a:extLst>
              <a:ext uri="{FF2B5EF4-FFF2-40B4-BE49-F238E27FC236}">
                <a16:creationId xmlns:a16="http://schemas.microsoft.com/office/drawing/2014/main" id="{BFAC2473-7008-2500-F21B-391A8B2B175C}"/>
              </a:ext>
            </a:extLst>
          </p:cNvPr>
          <p:cNvSpPr>
            <a:spLocks noGrp="1"/>
          </p:cNvSpPr>
          <p:nvPr>
            <p:ph type="subTitle" idx="1"/>
          </p:nvPr>
        </p:nvSpPr>
        <p:spPr>
          <a:xfrm>
            <a:off x="1461247" y="2013688"/>
            <a:ext cx="9511553" cy="3616147"/>
          </a:xfrm>
        </p:spPr>
        <p:txBody>
          <a:bodyPr>
            <a:normAutofit/>
          </a:bodyPr>
          <a:lstStyle/>
          <a:p>
            <a:pPr marL="342900" indent="-342900">
              <a:buFont typeface="Arial" panose="020B0604020202020204" pitchFamily="34" charset="0"/>
              <a:buChar char="•"/>
            </a:pPr>
            <a:r>
              <a:rPr lang="en-US" sz="3200" b="1" dirty="0"/>
              <a:t>Understand the anatomy of the left kidney in relation to the spleen, diaphragm, and rib cage. </a:t>
            </a:r>
          </a:p>
          <a:p>
            <a:pPr marL="342900" indent="-342900">
              <a:buFont typeface="Arial" panose="020B0604020202020204" pitchFamily="34" charset="0"/>
              <a:buChar char="•"/>
            </a:pPr>
            <a:r>
              <a:rPr lang="en-US" sz="3200" b="1" dirty="0"/>
              <a:t>Identify the left kidney, spleen, and diaphragm. </a:t>
            </a:r>
          </a:p>
          <a:p>
            <a:pPr marL="342900" indent="-342900">
              <a:buFont typeface="Arial" panose="020B0604020202020204" pitchFamily="34" charset="0"/>
              <a:buChar char="•"/>
            </a:pPr>
            <a:r>
              <a:rPr lang="en-US" sz="3200" b="1" dirty="0"/>
              <a:t>Recognize a positive FAST exam. </a:t>
            </a:r>
          </a:p>
        </p:txBody>
      </p:sp>
      <p:pic>
        <p:nvPicPr>
          <p:cNvPr id="5" name="Audio Recording Sep 27, 2022 at 8:06:33 PM" descr="Audio Recording Sep 27, 2022 at 8:06:33 PM">
            <a:hlinkClick r:id="" action="ppaction://media"/>
            <a:extLst>
              <a:ext uri="{FF2B5EF4-FFF2-40B4-BE49-F238E27FC236}">
                <a16:creationId xmlns:a16="http://schemas.microsoft.com/office/drawing/2014/main" id="{8006EFEA-8A05-80DE-5E13-F72A016DE292}"/>
              </a:ext>
            </a:extLst>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10972800" y="5629835"/>
            <a:ext cx="812800" cy="812800"/>
          </a:xfrm>
          <a:prstGeom prst="rect">
            <a:avLst/>
          </a:prstGeom>
        </p:spPr>
      </p:pic>
    </p:spTree>
    <p:extLst>
      <p:ext uri="{BB962C8B-B14F-4D97-AF65-F5344CB8AC3E}">
        <p14:creationId xmlns:p14="http://schemas.microsoft.com/office/powerpoint/2010/main" val="2488362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36032"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audio>
              <p:cMediaNode vol="80000">
                <p:cTn id="7" fill="hold" display="0">
                  <p:stCondLst>
                    <p:cond delay="indefinite"/>
                  </p:stCondLst>
                  <p:endCondLst>
                    <p:cond evt="onStopAudio" delay="0">
                      <p:tgtEl>
                        <p:sldTgt/>
                      </p:tgtEl>
                    </p:cond>
                  </p:endCondLst>
                </p:cTn>
                <p:tgtEl>
                  <p:spTgt spid="5"/>
                </p:tgtEl>
              </p:cMediaNode>
            </p:audio>
          </p:childTnLst>
        </p:cTn>
      </p:par>
    </p:tnLst>
  </p:timing>
</p:sld>
</file>

<file path=ppt/theme/theme1.xml><?xml version="1.0" encoding="utf-8"?>
<a:theme xmlns:a="http://schemas.openxmlformats.org/drawingml/2006/main" name="Office Theme">
  <a:themeElements>
    <a:clrScheme name="PA Palette">
      <a:dk1>
        <a:srgbClr val="000000"/>
      </a:dk1>
      <a:lt1>
        <a:srgbClr val="FFFFFF"/>
      </a:lt1>
      <a:dk2>
        <a:srgbClr val="041E41"/>
      </a:dk2>
      <a:lt2>
        <a:srgbClr val="B8D6E6"/>
      </a:lt2>
      <a:accent1>
        <a:srgbClr val="009CDE"/>
      </a:accent1>
      <a:accent2>
        <a:srgbClr val="1E407C"/>
      </a:accent2>
      <a:accent3>
        <a:srgbClr val="A3AAAD"/>
      </a:accent3>
      <a:accent4>
        <a:srgbClr val="83B1D4"/>
      </a:accent4>
      <a:accent5>
        <a:srgbClr val="3EA39E"/>
      </a:accent5>
      <a:accent6>
        <a:srgbClr val="305470"/>
      </a:accent6>
      <a:hlink>
        <a:srgbClr val="64B8B6"/>
      </a:hlink>
      <a:folHlink>
        <a:srgbClr val="7D4C7C"/>
      </a:folHlink>
    </a:clrScheme>
    <a:fontScheme name="Franklin Gothic">
      <a:majorFont>
        <a:latin typeface="Franklin Gothic Medium" panose="020B0603020102020204"/>
        <a:ea typeface=""/>
        <a:cs typeface=""/>
        <a:font script="Jpan" typeface="HG創英角ｺﾞｼｯｸUB"/>
        <a:font script="Hang" typeface="돋움"/>
        <a:font script="Hans" typeface="隶书"/>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Franklin Gothic Book" panose="020B0503020102020204"/>
        <a:ea typeface=""/>
        <a:cs typeface=""/>
        <a:font script="Jpan" typeface="HGｺﾞｼｯｸE"/>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SharedWithUsers xmlns="542b8847-f5d4-4c9f-bd30-657d16e5db1d">
      <UserInfo>
        <DisplayName>SharingLinks.fbaea811-671e-4f37-b677-a2b510205813.OrganizationEdit.a0f3e262-4087-45ce-9207-f143fa734173</DisplayName>
        <AccountId>24</AccountId>
        <AccountType/>
      </UserInfo>
      <UserInfo>
        <DisplayName>SharingLinks.1bd6d71e-3df5-449b-9aa8-5e919b3d88bc.OrganizationEdit.e1a2a2cf-c433-48ff-870c-19c9ef8ea587</DisplayName>
        <AccountId>25</AccountId>
        <AccountType/>
      </UserInfo>
      <UserInfo>
        <DisplayName>Olson, Samantha N</DisplayName>
        <AccountId>4305</AccountId>
        <AccountType/>
      </UserInfo>
    </SharedWithUser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9204A49901785041AF741C157FF60EBA" ma:contentTypeVersion="12" ma:contentTypeDescription="Create a new document." ma:contentTypeScope="" ma:versionID="2dc561ac532b927686394fff98d3cec6">
  <xsd:schema xmlns:xsd="http://www.w3.org/2001/XMLSchema" xmlns:xs="http://www.w3.org/2001/XMLSchema" xmlns:p="http://schemas.microsoft.com/office/2006/metadata/properties" xmlns:ns2="c7c738f6-68ec-422e-b0e4-3523873f7adf" xmlns:ns3="542b8847-f5d4-4c9f-bd30-657d16e5db1d" targetNamespace="http://schemas.microsoft.com/office/2006/metadata/properties" ma:root="true" ma:fieldsID="37215006c6ba2f10ad2271fcfa8576ba" ns2:_="" ns3:_="">
    <xsd:import namespace="c7c738f6-68ec-422e-b0e4-3523873f7adf"/>
    <xsd:import namespace="542b8847-f5d4-4c9f-bd30-657d16e5db1d"/>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2:MediaLengthInSecond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7c738f6-68ec-422e-b0e4-3523873f7ad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element name="MediaLengthInSeconds" ma:index="17" nillable="true" ma:displayName="Length (seconds)"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542b8847-f5d4-4c9f-bd30-657d16e5db1d"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6EE8212F-472D-486A-9E3D-EC119BF771F9}">
  <ds:schemaRefs>
    <ds:schemaRef ds:uri="http://schemas.microsoft.com/sharepoint/v3/contenttype/forms"/>
  </ds:schemaRefs>
</ds:datastoreItem>
</file>

<file path=customXml/itemProps2.xml><?xml version="1.0" encoding="utf-8"?>
<ds:datastoreItem xmlns:ds="http://schemas.openxmlformats.org/officeDocument/2006/customXml" ds:itemID="{B0872EE0-2104-452E-9839-3EC9728C0A3E}">
  <ds:schemaRefs>
    <ds:schemaRef ds:uri="http://schemas.microsoft.com/office/2006/documentManagement/types"/>
    <ds:schemaRef ds:uri="http://purl.org/dc/elements/1.1/"/>
    <ds:schemaRef ds:uri="http://purl.org/dc/terms/"/>
    <ds:schemaRef ds:uri="http://purl.org/dc/dcmitype/"/>
    <ds:schemaRef ds:uri="a01248ac-76f1-4f58-bd61-bb5ad5b08742"/>
    <ds:schemaRef ds:uri="http://schemas.microsoft.com/office/infopath/2007/PartnerControls"/>
    <ds:schemaRef ds:uri="http://www.w3.org/XML/1998/namespace"/>
    <ds:schemaRef ds:uri="http://schemas.openxmlformats.org/package/2006/metadata/core-properties"/>
    <ds:schemaRef ds:uri="7e353704-68ee-4592-8419-7aec398fa0ef"/>
    <ds:schemaRef ds:uri="http://schemas.microsoft.com/office/2006/metadata/properties"/>
    <ds:schemaRef ds:uri="3c8fd356-1280-4d00-a910-3bff90828a90"/>
    <ds:schemaRef ds:uri="542b8847-f5d4-4c9f-bd30-657d16e5db1d"/>
  </ds:schemaRefs>
</ds:datastoreItem>
</file>

<file path=customXml/itemProps3.xml><?xml version="1.0" encoding="utf-8"?>
<ds:datastoreItem xmlns:ds="http://schemas.openxmlformats.org/officeDocument/2006/customXml" ds:itemID="{EE49368D-A9E8-45BF-9DE1-9DF71906CB3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7c738f6-68ec-422e-b0e4-3523873f7adf"/>
    <ds:schemaRef ds:uri="542b8847-f5d4-4c9f-bd30-657d16e5db1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5523</TotalTime>
  <Words>1172</Words>
  <Application>Microsoft Macintosh PowerPoint</Application>
  <PresentationFormat>Widescreen</PresentationFormat>
  <Paragraphs>101</Paragraphs>
  <Slides>10</Slides>
  <Notes>9</Notes>
  <HiddenSlides>0</HiddenSlides>
  <MMClips>12</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0</vt:i4>
      </vt:variant>
    </vt:vector>
  </HeadingPairs>
  <TitlesOfParts>
    <vt:vector size="18" baseType="lpstr">
      <vt:lpstr>Arial</vt:lpstr>
      <vt:lpstr>Calibri</vt:lpstr>
      <vt:lpstr>Franklin Gothic Book</vt:lpstr>
      <vt:lpstr>Franklin Gothic Medium</vt:lpstr>
      <vt:lpstr>Open Sans</vt:lpstr>
      <vt:lpstr>proxima</vt:lpstr>
      <vt:lpstr>Times New Roman</vt:lpstr>
      <vt:lpstr>Office Theme</vt:lpstr>
      <vt:lpstr>PowerPoint Presentation</vt:lpstr>
      <vt:lpstr>EFAST Exam Components</vt:lpstr>
      <vt:lpstr>Left Upper Quadrant View aka Perisplenic View</vt:lpstr>
      <vt:lpstr>PowerPoint Presentation</vt:lpstr>
      <vt:lpstr>PowerPoint Presentation</vt:lpstr>
      <vt:lpstr>PowerPoint Presentation</vt:lpstr>
      <vt:lpstr>PowerPoint Presentation</vt:lpstr>
      <vt:lpstr>PowerPoint Presentation</vt:lpstr>
      <vt:lpstr>Summary - LUQ</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Wray, Alisa</cp:lastModifiedBy>
  <cp:revision>49</cp:revision>
  <dcterms:created xsi:type="dcterms:W3CDTF">2018-03-19T17:38:41Z</dcterms:created>
  <dcterms:modified xsi:type="dcterms:W3CDTF">2024-01-24T19:04:1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204A49901785041AF741C157FF60EBA</vt:lpwstr>
  </property>
</Properties>
</file>